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 id="2147483648" r:id="rId5"/>
  </p:sldMasterIdLst>
  <p:notesMasterIdLst>
    <p:notesMasterId r:id="rId24"/>
  </p:notesMasterIdLst>
  <p:sldIdLst>
    <p:sldId id="256" r:id="rId6"/>
    <p:sldId id="305" r:id="rId7"/>
    <p:sldId id="299" r:id="rId8"/>
    <p:sldId id="311" r:id="rId9"/>
    <p:sldId id="306" r:id="rId10"/>
    <p:sldId id="297" r:id="rId11"/>
    <p:sldId id="257" r:id="rId12"/>
    <p:sldId id="309" r:id="rId13"/>
    <p:sldId id="258" r:id="rId14"/>
    <p:sldId id="307" r:id="rId15"/>
    <p:sldId id="300" r:id="rId16"/>
    <p:sldId id="265" r:id="rId17"/>
    <p:sldId id="301" r:id="rId18"/>
    <p:sldId id="302" r:id="rId19"/>
    <p:sldId id="314" r:id="rId20"/>
    <p:sldId id="310" r:id="rId21"/>
    <p:sldId id="316" r:id="rId22"/>
    <p:sldId id="315" r:id="rId2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89D5830-7D20-EF43-9790-B7D919905F98}" v="4798" dt="2023-06-02T19:02:30.17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81"/>
  </p:normalViewPr>
  <p:slideViewPr>
    <p:cSldViewPr snapToGrid="0">
      <p:cViewPr varScale="1">
        <p:scale>
          <a:sx n="107" d="100"/>
          <a:sy n="107" d="100"/>
        </p:scale>
        <p:origin x="736"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viewProps" Target="viewProps.xml"/><Relationship Id="rId3" Type="http://schemas.openxmlformats.org/officeDocument/2006/relationships/customXml" Target="../customXml/item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29"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notesMaster" Target="notesMasters/notesMaster1.xml"/><Relationship Id="rId5" Type="http://schemas.openxmlformats.org/officeDocument/2006/relationships/slideMaster" Target="slideMasters/slideMaster2.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tableStyles" Target="tableStyles.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theme" Target="theme/theme1.xml"/><Relationship Id="rId30"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bambo, Gillian" userId="59bfad07-67e3-47a4-ac55-04ee0a07a20e" providerId="ADAL" clId="{A158153C-3B67-3340-8E9C-993ED0421912}"/>
    <pc:docChg chg="addSld delSld modSld">
      <pc:chgData name="Mbambo, Gillian" userId="59bfad07-67e3-47a4-ac55-04ee0a07a20e" providerId="ADAL" clId="{A158153C-3B67-3340-8E9C-993ED0421912}" dt="2023-05-23T22:18:49.093" v="2"/>
      <pc:docMkLst>
        <pc:docMk/>
      </pc:docMkLst>
      <pc:sldChg chg="addSp modSp">
        <pc:chgData name="Mbambo, Gillian" userId="59bfad07-67e3-47a4-ac55-04ee0a07a20e" providerId="ADAL" clId="{A158153C-3B67-3340-8E9C-993ED0421912}" dt="2023-05-23T13:14:37.203" v="0"/>
        <pc:sldMkLst>
          <pc:docMk/>
          <pc:sldMk cId="1103200321" sldId="310"/>
        </pc:sldMkLst>
        <pc:spChg chg="add mod">
          <ac:chgData name="Mbambo, Gillian" userId="59bfad07-67e3-47a4-ac55-04ee0a07a20e" providerId="ADAL" clId="{A158153C-3B67-3340-8E9C-993ED0421912}" dt="2023-05-23T13:14:37.203" v="0"/>
          <ac:spMkLst>
            <pc:docMk/>
            <pc:sldMk cId="1103200321" sldId="310"/>
            <ac:spMk id="2" creationId="{C54CCC29-F8A9-8426-80CD-1C39157772CA}"/>
          </ac:spMkLst>
        </pc:spChg>
        <pc:spChg chg="add mod">
          <ac:chgData name="Mbambo, Gillian" userId="59bfad07-67e3-47a4-ac55-04ee0a07a20e" providerId="ADAL" clId="{A158153C-3B67-3340-8E9C-993ED0421912}" dt="2023-05-23T13:14:37.203" v="0"/>
          <ac:spMkLst>
            <pc:docMk/>
            <pc:sldMk cId="1103200321" sldId="310"/>
            <ac:spMk id="3" creationId="{8B81AAF7-C549-B564-229D-AC363264209A}"/>
          </ac:spMkLst>
        </pc:spChg>
        <pc:spChg chg="add mod">
          <ac:chgData name="Mbambo, Gillian" userId="59bfad07-67e3-47a4-ac55-04ee0a07a20e" providerId="ADAL" clId="{A158153C-3B67-3340-8E9C-993ED0421912}" dt="2023-05-23T13:14:37.203" v="0"/>
          <ac:spMkLst>
            <pc:docMk/>
            <pc:sldMk cId="1103200321" sldId="310"/>
            <ac:spMk id="4" creationId="{FD3B019F-9ED4-22AC-1CF1-3F024AD78AF6}"/>
          </ac:spMkLst>
        </pc:spChg>
        <pc:spChg chg="add mod">
          <ac:chgData name="Mbambo, Gillian" userId="59bfad07-67e3-47a4-ac55-04ee0a07a20e" providerId="ADAL" clId="{A158153C-3B67-3340-8E9C-993ED0421912}" dt="2023-05-23T13:14:37.203" v="0"/>
          <ac:spMkLst>
            <pc:docMk/>
            <pc:sldMk cId="1103200321" sldId="310"/>
            <ac:spMk id="5" creationId="{CFEADEE8-AB07-CE1F-9F02-A2207263E3F3}"/>
          </ac:spMkLst>
        </pc:spChg>
        <pc:spChg chg="add mod">
          <ac:chgData name="Mbambo, Gillian" userId="59bfad07-67e3-47a4-ac55-04ee0a07a20e" providerId="ADAL" clId="{A158153C-3B67-3340-8E9C-993ED0421912}" dt="2023-05-23T13:14:37.203" v="0"/>
          <ac:spMkLst>
            <pc:docMk/>
            <pc:sldMk cId="1103200321" sldId="310"/>
            <ac:spMk id="6" creationId="{C30C7FA0-690C-6219-3A50-74045D3EBC43}"/>
          </ac:spMkLst>
        </pc:spChg>
        <pc:spChg chg="add mod">
          <ac:chgData name="Mbambo, Gillian" userId="59bfad07-67e3-47a4-ac55-04ee0a07a20e" providerId="ADAL" clId="{A158153C-3B67-3340-8E9C-993ED0421912}" dt="2023-05-23T13:14:37.203" v="0"/>
          <ac:spMkLst>
            <pc:docMk/>
            <pc:sldMk cId="1103200321" sldId="310"/>
            <ac:spMk id="8" creationId="{549687BF-9FF3-80BA-999F-7D4CCB4776C6}"/>
          </ac:spMkLst>
        </pc:spChg>
        <pc:spChg chg="add mod">
          <ac:chgData name="Mbambo, Gillian" userId="59bfad07-67e3-47a4-ac55-04ee0a07a20e" providerId="ADAL" clId="{A158153C-3B67-3340-8E9C-993ED0421912}" dt="2023-05-23T13:14:37.203" v="0"/>
          <ac:spMkLst>
            <pc:docMk/>
            <pc:sldMk cId="1103200321" sldId="310"/>
            <ac:spMk id="9" creationId="{DDFC1273-6673-8E26-DC02-94C84CF214A2}"/>
          </ac:spMkLst>
        </pc:spChg>
      </pc:sldChg>
      <pc:sldChg chg="add del">
        <pc:chgData name="Mbambo, Gillian" userId="59bfad07-67e3-47a4-ac55-04ee0a07a20e" providerId="ADAL" clId="{A158153C-3B67-3340-8E9C-993ED0421912}" dt="2023-05-23T22:18:49.093" v="2"/>
        <pc:sldMkLst>
          <pc:docMk/>
          <pc:sldMk cId="3245131350" sldId="312"/>
        </pc:sldMkLst>
      </pc:sldChg>
    </pc:docChg>
  </pc:docChgLst>
  <pc:docChgLst>
    <pc:chgData name="Mbambo, Gillian" userId="59bfad07-67e3-47a4-ac55-04ee0a07a20e" providerId="ADAL" clId="{9EAD9B1B-79BC-B343-8A19-A5CE3C4E3D97}"/>
    <pc:docChg chg="undo custSel addSld delSld modSld sldOrd">
      <pc:chgData name="Mbambo, Gillian" userId="59bfad07-67e3-47a4-ac55-04ee0a07a20e" providerId="ADAL" clId="{9EAD9B1B-79BC-B343-8A19-A5CE3C4E3D97}" dt="2023-03-15T14:33:34.211" v="877" actId="20577"/>
      <pc:docMkLst>
        <pc:docMk/>
      </pc:docMkLst>
      <pc:sldChg chg="addSp delSp modSp mod">
        <pc:chgData name="Mbambo, Gillian" userId="59bfad07-67e3-47a4-ac55-04ee0a07a20e" providerId="ADAL" clId="{9EAD9B1B-79BC-B343-8A19-A5CE3C4E3D97}" dt="2023-03-03T21:23:55.812" v="851" actId="113"/>
        <pc:sldMkLst>
          <pc:docMk/>
          <pc:sldMk cId="3904217217" sldId="265"/>
        </pc:sldMkLst>
        <pc:spChg chg="add del mod">
          <ac:chgData name="Mbambo, Gillian" userId="59bfad07-67e3-47a4-ac55-04ee0a07a20e" providerId="ADAL" clId="{9EAD9B1B-79BC-B343-8A19-A5CE3C4E3D97}" dt="2023-03-03T20:52:16.031" v="616" actId="478"/>
          <ac:spMkLst>
            <pc:docMk/>
            <pc:sldMk cId="3904217217" sldId="265"/>
            <ac:spMk id="3" creationId="{DAEED5C8-A7F7-034B-A0AA-CE4DE2A8ED7F}"/>
          </ac:spMkLst>
        </pc:spChg>
        <pc:spChg chg="mod">
          <ac:chgData name="Mbambo, Gillian" userId="59bfad07-67e3-47a4-ac55-04ee0a07a20e" providerId="ADAL" clId="{9EAD9B1B-79BC-B343-8A19-A5CE3C4E3D97}" dt="2023-03-03T21:23:48.438" v="849" actId="113"/>
          <ac:spMkLst>
            <pc:docMk/>
            <pc:sldMk cId="3904217217" sldId="265"/>
            <ac:spMk id="4" creationId="{7FCA64CC-00E1-9316-352F-FE075407C270}"/>
          </ac:spMkLst>
        </pc:spChg>
        <pc:spChg chg="del mod">
          <ac:chgData name="Mbambo, Gillian" userId="59bfad07-67e3-47a4-ac55-04ee0a07a20e" providerId="ADAL" clId="{9EAD9B1B-79BC-B343-8A19-A5CE3C4E3D97}" dt="2023-03-03T20:56:11.927" v="703" actId="478"/>
          <ac:spMkLst>
            <pc:docMk/>
            <pc:sldMk cId="3904217217" sldId="265"/>
            <ac:spMk id="5" creationId="{456AB476-0C00-B382-A8F6-A2187B60DF68}"/>
          </ac:spMkLst>
        </pc:spChg>
        <pc:spChg chg="add del mod">
          <ac:chgData name="Mbambo, Gillian" userId="59bfad07-67e3-47a4-ac55-04ee0a07a20e" providerId="ADAL" clId="{9EAD9B1B-79BC-B343-8A19-A5CE3C4E3D97}" dt="2023-03-03T20:55:34.310" v="694" actId="478"/>
          <ac:spMkLst>
            <pc:docMk/>
            <pc:sldMk cId="3904217217" sldId="265"/>
            <ac:spMk id="7" creationId="{F427E25A-DC71-5190-3E12-D5308690194E}"/>
          </ac:spMkLst>
        </pc:spChg>
        <pc:spChg chg="del mod">
          <ac:chgData name="Mbambo, Gillian" userId="59bfad07-67e3-47a4-ac55-04ee0a07a20e" providerId="ADAL" clId="{9EAD9B1B-79BC-B343-8A19-A5CE3C4E3D97}" dt="2023-03-03T20:56:08.806" v="702" actId="478"/>
          <ac:spMkLst>
            <pc:docMk/>
            <pc:sldMk cId="3904217217" sldId="265"/>
            <ac:spMk id="8" creationId="{FF98EBCB-9B08-5EAC-CA00-8631583AD180}"/>
          </ac:spMkLst>
        </pc:spChg>
        <pc:spChg chg="add del mod">
          <ac:chgData name="Mbambo, Gillian" userId="59bfad07-67e3-47a4-ac55-04ee0a07a20e" providerId="ADAL" clId="{9EAD9B1B-79BC-B343-8A19-A5CE3C4E3D97}" dt="2023-03-03T20:55:34.310" v="694" actId="478"/>
          <ac:spMkLst>
            <pc:docMk/>
            <pc:sldMk cId="3904217217" sldId="265"/>
            <ac:spMk id="10" creationId="{AE52E2C0-5082-F6B3-2EEA-DC6EA5CD9D11}"/>
          </ac:spMkLst>
        </pc:spChg>
        <pc:spChg chg="add del mod">
          <ac:chgData name="Mbambo, Gillian" userId="59bfad07-67e3-47a4-ac55-04ee0a07a20e" providerId="ADAL" clId="{9EAD9B1B-79BC-B343-8A19-A5CE3C4E3D97}" dt="2023-03-03T20:55:34.310" v="694" actId="478"/>
          <ac:spMkLst>
            <pc:docMk/>
            <pc:sldMk cId="3904217217" sldId="265"/>
            <ac:spMk id="11" creationId="{A5F41E0A-B89A-DF28-7011-8AB832D89D75}"/>
          </ac:spMkLst>
        </pc:spChg>
        <pc:spChg chg="add del mod">
          <ac:chgData name="Mbambo, Gillian" userId="59bfad07-67e3-47a4-ac55-04ee0a07a20e" providerId="ADAL" clId="{9EAD9B1B-79BC-B343-8A19-A5CE3C4E3D97}" dt="2023-03-03T20:55:34.310" v="694" actId="478"/>
          <ac:spMkLst>
            <pc:docMk/>
            <pc:sldMk cId="3904217217" sldId="265"/>
            <ac:spMk id="12" creationId="{B71C1F36-0D07-6315-D9DF-E04A269D8234}"/>
          </ac:spMkLst>
        </pc:spChg>
        <pc:spChg chg="add del mod">
          <ac:chgData name="Mbambo, Gillian" userId="59bfad07-67e3-47a4-ac55-04ee0a07a20e" providerId="ADAL" clId="{9EAD9B1B-79BC-B343-8A19-A5CE3C4E3D97}" dt="2023-03-03T20:55:34.310" v="694" actId="478"/>
          <ac:spMkLst>
            <pc:docMk/>
            <pc:sldMk cId="3904217217" sldId="265"/>
            <ac:spMk id="13" creationId="{534DB16E-B639-1144-F8E1-D06181BE5AED}"/>
          </ac:spMkLst>
        </pc:spChg>
        <pc:spChg chg="add del mod">
          <ac:chgData name="Mbambo, Gillian" userId="59bfad07-67e3-47a4-ac55-04ee0a07a20e" providerId="ADAL" clId="{9EAD9B1B-79BC-B343-8A19-A5CE3C4E3D97}" dt="2023-03-03T20:55:34.310" v="694" actId="478"/>
          <ac:spMkLst>
            <pc:docMk/>
            <pc:sldMk cId="3904217217" sldId="265"/>
            <ac:spMk id="14" creationId="{5753CDDE-FF0C-C377-AE94-FD189ADBB2A7}"/>
          </ac:spMkLst>
        </pc:spChg>
        <pc:spChg chg="add del mod">
          <ac:chgData name="Mbambo, Gillian" userId="59bfad07-67e3-47a4-ac55-04ee0a07a20e" providerId="ADAL" clId="{9EAD9B1B-79BC-B343-8A19-A5CE3C4E3D97}" dt="2023-03-03T20:55:34.310" v="694" actId="478"/>
          <ac:spMkLst>
            <pc:docMk/>
            <pc:sldMk cId="3904217217" sldId="265"/>
            <ac:spMk id="15" creationId="{C957FF60-F946-5215-5C24-A585D0A8A664}"/>
          </ac:spMkLst>
        </pc:spChg>
        <pc:spChg chg="add del mod">
          <ac:chgData name="Mbambo, Gillian" userId="59bfad07-67e3-47a4-ac55-04ee0a07a20e" providerId="ADAL" clId="{9EAD9B1B-79BC-B343-8A19-A5CE3C4E3D97}" dt="2023-03-03T20:55:34.310" v="694" actId="478"/>
          <ac:spMkLst>
            <pc:docMk/>
            <pc:sldMk cId="3904217217" sldId="265"/>
            <ac:spMk id="16" creationId="{646E3A4E-D4B5-488E-2B76-1F67FDC147A5}"/>
          </ac:spMkLst>
        </pc:spChg>
        <pc:spChg chg="add del mod">
          <ac:chgData name="Mbambo, Gillian" userId="59bfad07-67e3-47a4-ac55-04ee0a07a20e" providerId="ADAL" clId="{9EAD9B1B-79BC-B343-8A19-A5CE3C4E3D97}" dt="2023-03-03T20:55:34.310" v="694" actId="478"/>
          <ac:spMkLst>
            <pc:docMk/>
            <pc:sldMk cId="3904217217" sldId="265"/>
            <ac:spMk id="17" creationId="{86618E8E-9465-790C-1BEE-EB47207DD274}"/>
          </ac:spMkLst>
        </pc:spChg>
        <pc:spChg chg="add del mod">
          <ac:chgData name="Mbambo, Gillian" userId="59bfad07-67e3-47a4-ac55-04ee0a07a20e" providerId="ADAL" clId="{9EAD9B1B-79BC-B343-8A19-A5CE3C4E3D97}" dt="2023-03-03T20:55:34.310" v="694" actId="478"/>
          <ac:spMkLst>
            <pc:docMk/>
            <pc:sldMk cId="3904217217" sldId="265"/>
            <ac:spMk id="18" creationId="{20616EAD-CFFB-525A-0B6D-51ACF5479F70}"/>
          </ac:spMkLst>
        </pc:spChg>
        <pc:spChg chg="add del mod">
          <ac:chgData name="Mbambo, Gillian" userId="59bfad07-67e3-47a4-ac55-04ee0a07a20e" providerId="ADAL" clId="{9EAD9B1B-79BC-B343-8A19-A5CE3C4E3D97}" dt="2023-03-03T20:55:34.310" v="694" actId="478"/>
          <ac:spMkLst>
            <pc:docMk/>
            <pc:sldMk cId="3904217217" sldId="265"/>
            <ac:spMk id="19" creationId="{E6BB1265-BD45-2BF7-E1E1-0DAF50C54F56}"/>
          </ac:spMkLst>
        </pc:spChg>
        <pc:spChg chg="add del mod">
          <ac:chgData name="Mbambo, Gillian" userId="59bfad07-67e3-47a4-ac55-04ee0a07a20e" providerId="ADAL" clId="{9EAD9B1B-79BC-B343-8A19-A5CE3C4E3D97}" dt="2023-03-03T20:55:34.310" v="694" actId="478"/>
          <ac:spMkLst>
            <pc:docMk/>
            <pc:sldMk cId="3904217217" sldId="265"/>
            <ac:spMk id="20" creationId="{89D26C8B-B921-17B9-9E79-26FAFA4A1A53}"/>
          </ac:spMkLst>
        </pc:spChg>
        <pc:spChg chg="add del mod">
          <ac:chgData name="Mbambo, Gillian" userId="59bfad07-67e3-47a4-ac55-04ee0a07a20e" providerId="ADAL" clId="{9EAD9B1B-79BC-B343-8A19-A5CE3C4E3D97}" dt="2023-03-03T20:55:34.310" v="694" actId="478"/>
          <ac:spMkLst>
            <pc:docMk/>
            <pc:sldMk cId="3904217217" sldId="265"/>
            <ac:spMk id="21" creationId="{DE8671CD-B066-9472-A426-5DCEB19C0257}"/>
          </ac:spMkLst>
        </pc:spChg>
        <pc:spChg chg="add del mod">
          <ac:chgData name="Mbambo, Gillian" userId="59bfad07-67e3-47a4-ac55-04ee0a07a20e" providerId="ADAL" clId="{9EAD9B1B-79BC-B343-8A19-A5CE3C4E3D97}" dt="2023-03-03T20:55:34.310" v="694" actId="478"/>
          <ac:spMkLst>
            <pc:docMk/>
            <pc:sldMk cId="3904217217" sldId="265"/>
            <ac:spMk id="22" creationId="{2BABA0E8-25EE-108D-FBFB-4F56C17AE9FA}"/>
          </ac:spMkLst>
        </pc:spChg>
        <pc:spChg chg="add del mod">
          <ac:chgData name="Mbambo, Gillian" userId="59bfad07-67e3-47a4-ac55-04ee0a07a20e" providerId="ADAL" clId="{9EAD9B1B-79BC-B343-8A19-A5CE3C4E3D97}" dt="2023-03-03T20:55:34.310" v="694" actId="478"/>
          <ac:spMkLst>
            <pc:docMk/>
            <pc:sldMk cId="3904217217" sldId="265"/>
            <ac:spMk id="23" creationId="{9C38FD99-24D2-C2FD-0728-84CC97136F20}"/>
          </ac:spMkLst>
        </pc:spChg>
        <pc:spChg chg="add del mod">
          <ac:chgData name="Mbambo, Gillian" userId="59bfad07-67e3-47a4-ac55-04ee0a07a20e" providerId="ADAL" clId="{9EAD9B1B-79BC-B343-8A19-A5CE3C4E3D97}" dt="2023-03-03T20:55:34.310" v="694" actId="478"/>
          <ac:spMkLst>
            <pc:docMk/>
            <pc:sldMk cId="3904217217" sldId="265"/>
            <ac:spMk id="24" creationId="{946AB1BD-B507-674C-B797-0E8F8DE47130}"/>
          </ac:spMkLst>
        </pc:spChg>
        <pc:spChg chg="add del mod">
          <ac:chgData name="Mbambo, Gillian" userId="59bfad07-67e3-47a4-ac55-04ee0a07a20e" providerId="ADAL" clId="{9EAD9B1B-79BC-B343-8A19-A5CE3C4E3D97}" dt="2023-03-03T20:55:34.310" v="694" actId="478"/>
          <ac:spMkLst>
            <pc:docMk/>
            <pc:sldMk cId="3904217217" sldId="265"/>
            <ac:spMk id="25" creationId="{3E097E60-D7D0-9155-DF56-D0385BB95914}"/>
          </ac:spMkLst>
        </pc:spChg>
        <pc:spChg chg="add del mod">
          <ac:chgData name="Mbambo, Gillian" userId="59bfad07-67e3-47a4-ac55-04ee0a07a20e" providerId="ADAL" clId="{9EAD9B1B-79BC-B343-8A19-A5CE3C4E3D97}" dt="2023-03-03T20:55:34.310" v="694" actId="478"/>
          <ac:spMkLst>
            <pc:docMk/>
            <pc:sldMk cId="3904217217" sldId="265"/>
            <ac:spMk id="26" creationId="{B2A67DEA-2A51-4516-0207-9EF2A462B38D}"/>
          </ac:spMkLst>
        </pc:spChg>
        <pc:spChg chg="add del mod">
          <ac:chgData name="Mbambo, Gillian" userId="59bfad07-67e3-47a4-ac55-04ee0a07a20e" providerId="ADAL" clId="{9EAD9B1B-79BC-B343-8A19-A5CE3C4E3D97}" dt="2023-03-03T20:39:10.634" v="443" actId="478"/>
          <ac:spMkLst>
            <pc:docMk/>
            <pc:sldMk cId="3904217217" sldId="265"/>
            <ac:spMk id="27" creationId="{FC4CF46B-6FD5-ADA9-5810-82DBED0578B5}"/>
          </ac:spMkLst>
        </pc:spChg>
        <pc:spChg chg="add del mod">
          <ac:chgData name="Mbambo, Gillian" userId="59bfad07-67e3-47a4-ac55-04ee0a07a20e" providerId="ADAL" clId="{9EAD9B1B-79BC-B343-8A19-A5CE3C4E3D97}" dt="2023-03-03T20:39:08.226" v="442" actId="478"/>
          <ac:spMkLst>
            <pc:docMk/>
            <pc:sldMk cId="3904217217" sldId="265"/>
            <ac:spMk id="28" creationId="{045DBAB5-2F79-A8B3-B11E-C3B3E5887F73}"/>
          </ac:spMkLst>
        </pc:spChg>
        <pc:spChg chg="add del mod">
          <ac:chgData name="Mbambo, Gillian" userId="59bfad07-67e3-47a4-ac55-04ee0a07a20e" providerId="ADAL" clId="{9EAD9B1B-79BC-B343-8A19-A5CE3C4E3D97}" dt="2023-03-03T20:39:41.779" v="455"/>
          <ac:spMkLst>
            <pc:docMk/>
            <pc:sldMk cId="3904217217" sldId="265"/>
            <ac:spMk id="29" creationId="{2835EA92-3BC9-C2CB-E904-8F333AC79095}"/>
          </ac:spMkLst>
        </pc:spChg>
        <pc:spChg chg="add del mod">
          <ac:chgData name="Mbambo, Gillian" userId="59bfad07-67e3-47a4-ac55-04ee0a07a20e" providerId="ADAL" clId="{9EAD9B1B-79BC-B343-8A19-A5CE3C4E3D97}" dt="2023-03-03T20:54:33.388" v="678" actId="478"/>
          <ac:spMkLst>
            <pc:docMk/>
            <pc:sldMk cId="3904217217" sldId="265"/>
            <ac:spMk id="30" creationId="{C464D0E8-655D-ADD7-199D-1A15E3D9B766}"/>
          </ac:spMkLst>
        </pc:spChg>
        <pc:spChg chg="add del mod">
          <ac:chgData name="Mbambo, Gillian" userId="59bfad07-67e3-47a4-ac55-04ee0a07a20e" providerId="ADAL" clId="{9EAD9B1B-79BC-B343-8A19-A5CE3C4E3D97}" dt="2023-03-03T20:54:34.768" v="679" actId="478"/>
          <ac:spMkLst>
            <pc:docMk/>
            <pc:sldMk cId="3904217217" sldId="265"/>
            <ac:spMk id="31" creationId="{C1C7CEE9-18B4-5BFA-D795-886C2A85EEB6}"/>
          </ac:spMkLst>
        </pc:spChg>
        <pc:spChg chg="add del mod">
          <ac:chgData name="Mbambo, Gillian" userId="59bfad07-67e3-47a4-ac55-04ee0a07a20e" providerId="ADAL" clId="{9EAD9B1B-79BC-B343-8A19-A5CE3C4E3D97}" dt="2023-03-03T20:55:37.535" v="695" actId="478"/>
          <ac:spMkLst>
            <pc:docMk/>
            <pc:sldMk cId="3904217217" sldId="265"/>
            <ac:spMk id="37" creationId="{5EC33FB7-15D1-4B1E-F038-3347D5B38523}"/>
          </ac:spMkLst>
        </pc:spChg>
        <pc:spChg chg="add mod">
          <ac:chgData name="Mbambo, Gillian" userId="59bfad07-67e3-47a4-ac55-04ee0a07a20e" providerId="ADAL" clId="{9EAD9B1B-79BC-B343-8A19-A5CE3C4E3D97}" dt="2023-03-03T21:23:55.812" v="851" actId="113"/>
          <ac:spMkLst>
            <pc:docMk/>
            <pc:sldMk cId="3904217217" sldId="265"/>
            <ac:spMk id="38" creationId="{6873A6C1-A395-B908-82F5-AAC99220DBBF}"/>
          </ac:spMkLst>
        </pc:spChg>
        <pc:spChg chg="add mod">
          <ac:chgData name="Mbambo, Gillian" userId="59bfad07-67e3-47a4-ac55-04ee0a07a20e" providerId="ADAL" clId="{9EAD9B1B-79BC-B343-8A19-A5CE3C4E3D97}" dt="2023-03-03T21:23:53.126" v="850" actId="113"/>
          <ac:spMkLst>
            <pc:docMk/>
            <pc:sldMk cId="3904217217" sldId="265"/>
            <ac:spMk id="39" creationId="{227FCC57-C6CD-6E5C-01C4-B1D67A6B8B39}"/>
          </ac:spMkLst>
        </pc:spChg>
        <pc:picChg chg="del">
          <ac:chgData name="Mbambo, Gillian" userId="59bfad07-67e3-47a4-ac55-04ee0a07a20e" providerId="ADAL" clId="{9EAD9B1B-79BC-B343-8A19-A5CE3C4E3D97}" dt="2023-03-03T20:54:32.041" v="677" actId="478"/>
          <ac:picMkLst>
            <pc:docMk/>
            <pc:sldMk cId="3904217217" sldId="265"/>
            <ac:picMk id="6" creationId="{38958188-324E-9331-6F4A-38A4A72D2A04}"/>
          </ac:picMkLst>
        </pc:picChg>
        <pc:picChg chg="del">
          <ac:chgData name="Mbambo, Gillian" userId="59bfad07-67e3-47a4-ac55-04ee0a07a20e" providerId="ADAL" clId="{9EAD9B1B-79BC-B343-8A19-A5CE3C4E3D97}" dt="2023-03-03T20:55:34.310" v="694" actId="478"/>
          <ac:picMkLst>
            <pc:docMk/>
            <pc:sldMk cId="3904217217" sldId="265"/>
            <ac:picMk id="9" creationId="{841FF588-ADF3-3B28-3AA1-64A0F105E70B}"/>
          </ac:picMkLst>
        </pc:picChg>
        <pc:picChg chg="add mod">
          <ac:chgData name="Mbambo, Gillian" userId="59bfad07-67e3-47a4-ac55-04ee0a07a20e" providerId="ADAL" clId="{9EAD9B1B-79BC-B343-8A19-A5CE3C4E3D97}" dt="2023-03-03T20:55:11.493" v="689" actId="1076"/>
          <ac:picMkLst>
            <pc:docMk/>
            <pc:sldMk cId="3904217217" sldId="265"/>
            <ac:picMk id="33" creationId="{441273A2-36E8-39C3-7FDF-66AF8C4C0DF3}"/>
          </ac:picMkLst>
        </pc:picChg>
        <pc:picChg chg="add mod">
          <ac:chgData name="Mbambo, Gillian" userId="59bfad07-67e3-47a4-ac55-04ee0a07a20e" providerId="ADAL" clId="{9EAD9B1B-79BC-B343-8A19-A5CE3C4E3D97}" dt="2023-03-03T20:55:48.040" v="698" actId="1076"/>
          <ac:picMkLst>
            <pc:docMk/>
            <pc:sldMk cId="3904217217" sldId="265"/>
            <ac:picMk id="35" creationId="{ABD5B87A-4401-976F-6232-9B331B770E13}"/>
          </ac:picMkLst>
        </pc:picChg>
      </pc:sldChg>
      <pc:sldChg chg="modSp mod">
        <pc:chgData name="Mbambo, Gillian" userId="59bfad07-67e3-47a4-ac55-04ee0a07a20e" providerId="ADAL" clId="{9EAD9B1B-79BC-B343-8A19-A5CE3C4E3D97}" dt="2023-03-03T21:25:23.952" v="870" actId="113"/>
        <pc:sldMkLst>
          <pc:docMk/>
          <pc:sldMk cId="3466550413" sldId="268"/>
        </pc:sldMkLst>
        <pc:spChg chg="mod">
          <ac:chgData name="Mbambo, Gillian" userId="59bfad07-67e3-47a4-ac55-04ee0a07a20e" providerId="ADAL" clId="{9EAD9B1B-79BC-B343-8A19-A5CE3C4E3D97}" dt="2023-03-03T21:24:41.750" v="860" actId="113"/>
          <ac:spMkLst>
            <pc:docMk/>
            <pc:sldMk cId="3466550413" sldId="268"/>
            <ac:spMk id="10" creationId="{DE63A626-F769-C826-71BA-3EAC3F17FCA5}"/>
          </ac:spMkLst>
        </pc:spChg>
        <pc:spChg chg="mod">
          <ac:chgData name="Mbambo, Gillian" userId="59bfad07-67e3-47a4-ac55-04ee0a07a20e" providerId="ADAL" clId="{9EAD9B1B-79BC-B343-8A19-A5CE3C4E3D97}" dt="2023-03-03T21:24:43.662" v="861" actId="113"/>
          <ac:spMkLst>
            <pc:docMk/>
            <pc:sldMk cId="3466550413" sldId="268"/>
            <ac:spMk id="11" creationId="{68468EC8-250F-747E-B747-EE6D28CB72B5}"/>
          </ac:spMkLst>
        </pc:spChg>
        <pc:spChg chg="mod">
          <ac:chgData name="Mbambo, Gillian" userId="59bfad07-67e3-47a4-ac55-04ee0a07a20e" providerId="ADAL" clId="{9EAD9B1B-79BC-B343-8A19-A5CE3C4E3D97}" dt="2023-03-03T21:24:58.958" v="864" actId="1076"/>
          <ac:spMkLst>
            <pc:docMk/>
            <pc:sldMk cId="3466550413" sldId="268"/>
            <ac:spMk id="12" creationId="{565382C5-8091-E3FA-13B5-819588697C97}"/>
          </ac:spMkLst>
        </pc:spChg>
        <pc:spChg chg="mod">
          <ac:chgData name="Mbambo, Gillian" userId="59bfad07-67e3-47a4-ac55-04ee0a07a20e" providerId="ADAL" clId="{9EAD9B1B-79BC-B343-8A19-A5CE3C4E3D97}" dt="2023-03-03T21:25:23.952" v="870" actId="113"/>
          <ac:spMkLst>
            <pc:docMk/>
            <pc:sldMk cId="3466550413" sldId="268"/>
            <ac:spMk id="13" creationId="{E829DDF7-491F-44EB-EA4B-6235569A6C69}"/>
          </ac:spMkLst>
        </pc:spChg>
      </pc:sldChg>
      <pc:sldChg chg="modSp mod">
        <pc:chgData name="Mbambo, Gillian" userId="59bfad07-67e3-47a4-ac55-04ee0a07a20e" providerId="ADAL" clId="{9EAD9B1B-79BC-B343-8A19-A5CE3C4E3D97}" dt="2023-03-15T14:33:34.211" v="877" actId="20577"/>
        <pc:sldMkLst>
          <pc:docMk/>
          <pc:sldMk cId="1049619716" sldId="299"/>
        </pc:sldMkLst>
        <pc:spChg chg="mod">
          <ac:chgData name="Mbambo, Gillian" userId="59bfad07-67e3-47a4-ac55-04ee0a07a20e" providerId="ADAL" clId="{9EAD9B1B-79BC-B343-8A19-A5CE3C4E3D97}" dt="2023-03-03T21:22:24.657" v="836" actId="113"/>
          <ac:spMkLst>
            <pc:docMk/>
            <pc:sldMk cId="1049619716" sldId="299"/>
            <ac:spMk id="4" creationId="{62690187-CF85-5E15-0A42-7B5B9C90D625}"/>
          </ac:spMkLst>
        </pc:spChg>
        <pc:spChg chg="mod">
          <ac:chgData name="Mbambo, Gillian" userId="59bfad07-67e3-47a4-ac55-04ee0a07a20e" providerId="ADAL" clId="{9EAD9B1B-79BC-B343-8A19-A5CE3C4E3D97}" dt="2023-03-03T21:22:31.272" v="838" actId="113"/>
          <ac:spMkLst>
            <pc:docMk/>
            <pc:sldMk cId="1049619716" sldId="299"/>
            <ac:spMk id="7" creationId="{A08A52BD-B551-5BF6-91E4-93D35149BE3C}"/>
          </ac:spMkLst>
        </pc:spChg>
        <pc:spChg chg="mod">
          <ac:chgData name="Mbambo, Gillian" userId="59bfad07-67e3-47a4-ac55-04ee0a07a20e" providerId="ADAL" clId="{9EAD9B1B-79BC-B343-8A19-A5CE3C4E3D97}" dt="2023-03-03T21:22:29.009" v="837" actId="113"/>
          <ac:spMkLst>
            <pc:docMk/>
            <pc:sldMk cId="1049619716" sldId="299"/>
            <ac:spMk id="11" creationId="{A4F97F60-973D-81BF-82BF-28F8F09BC1BC}"/>
          </ac:spMkLst>
        </pc:spChg>
        <pc:spChg chg="mod">
          <ac:chgData name="Mbambo, Gillian" userId="59bfad07-67e3-47a4-ac55-04ee0a07a20e" providerId="ADAL" clId="{9EAD9B1B-79BC-B343-8A19-A5CE3C4E3D97}" dt="2023-03-15T14:33:34.211" v="877" actId="20577"/>
          <ac:spMkLst>
            <pc:docMk/>
            <pc:sldMk cId="1049619716" sldId="299"/>
            <ac:spMk id="36" creationId="{AC66CD19-CC85-771F-EBB1-DA9E923FCC59}"/>
          </ac:spMkLst>
        </pc:spChg>
      </pc:sldChg>
      <pc:sldChg chg="addSp delSp modSp mod">
        <pc:chgData name="Mbambo, Gillian" userId="59bfad07-67e3-47a4-ac55-04ee0a07a20e" providerId="ADAL" clId="{9EAD9B1B-79BC-B343-8A19-A5CE3C4E3D97}" dt="2023-03-03T21:24:17.295" v="855" actId="113"/>
        <pc:sldMkLst>
          <pc:docMk/>
          <pc:sldMk cId="1114371219" sldId="301"/>
        </pc:sldMkLst>
        <pc:spChg chg="add del mod">
          <ac:chgData name="Mbambo, Gillian" userId="59bfad07-67e3-47a4-ac55-04ee0a07a20e" providerId="ADAL" clId="{9EAD9B1B-79BC-B343-8A19-A5CE3C4E3D97}" dt="2023-03-03T21:00:26.521" v="709" actId="478"/>
          <ac:spMkLst>
            <pc:docMk/>
            <pc:sldMk cId="1114371219" sldId="301"/>
            <ac:spMk id="4" creationId="{01AD6370-6162-9126-63BB-D0F87A63C58B}"/>
          </ac:spMkLst>
        </pc:spChg>
        <pc:spChg chg="del mod">
          <ac:chgData name="Mbambo, Gillian" userId="59bfad07-67e3-47a4-ac55-04ee0a07a20e" providerId="ADAL" clId="{9EAD9B1B-79BC-B343-8A19-A5CE3C4E3D97}" dt="2023-03-03T21:01:40.862" v="726" actId="478"/>
          <ac:spMkLst>
            <pc:docMk/>
            <pc:sldMk cId="1114371219" sldId="301"/>
            <ac:spMk id="5" creationId="{239F4BFC-8DE3-1C59-C6EE-E9D96ECC15F2}"/>
          </ac:spMkLst>
        </pc:spChg>
        <pc:spChg chg="add del mod">
          <ac:chgData name="Mbambo, Gillian" userId="59bfad07-67e3-47a4-ac55-04ee0a07a20e" providerId="ADAL" clId="{9EAD9B1B-79BC-B343-8A19-A5CE3C4E3D97}" dt="2023-03-03T21:00:50.006" v="715" actId="478"/>
          <ac:spMkLst>
            <pc:docMk/>
            <pc:sldMk cId="1114371219" sldId="301"/>
            <ac:spMk id="6" creationId="{66C97235-0FBF-BB96-80F6-89D8B8C32168}"/>
          </ac:spMkLst>
        </pc:spChg>
        <pc:spChg chg="mod">
          <ac:chgData name="Mbambo, Gillian" userId="59bfad07-67e3-47a4-ac55-04ee0a07a20e" providerId="ADAL" clId="{9EAD9B1B-79BC-B343-8A19-A5CE3C4E3D97}" dt="2023-03-03T21:24:17.295" v="855" actId="113"/>
          <ac:spMkLst>
            <pc:docMk/>
            <pc:sldMk cId="1114371219" sldId="301"/>
            <ac:spMk id="8" creationId="{2A6FBD11-9A2A-F40F-394E-591608F42915}"/>
          </ac:spMkLst>
        </pc:spChg>
        <pc:spChg chg="del mod">
          <ac:chgData name="Mbambo, Gillian" userId="59bfad07-67e3-47a4-ac55-04ee0a07a20e" providerId="ADAL" clId="{9EAD9B1B-79BC-B343-8A19-A5CE3C4E3D97}" dt="2023-03-03T21:01:35.899" v="725" actId="478"/>
          <ac:spMkLst>
            <pc:docMk/>
            <pc:sldMk cId="1114371219" sldId="301"/>
            <ac:spMk id="9" creationId="{291ABA90-3EC0-6C9A-7CED-213528F471DA}"/>
          </ac:spMkLst>
        </pc:spChg>
        <pc:spChg chg="add del mod">
          <ac:chgData name="Mbambo, Gillian" userId="59bfad07-67e3-47a4-ac55-04ee0a07a20e" providerId="ADAL" clId="{9EAD9B1B-79BC-B343-8A19-A5CE3C4E3D97}" dt="2023-03-03T21:00:50.006" v="715" actId="478"/>
          <ac:spMkLst>
            <pc:docMk/>
            <pc:sldMk cId="1114371219" sldId="301"/>
            <ac:spMk id="10" creationId="{CB2844AD-4E8D-CA13-134C-6DECAB9D0443}"/>
          </ac:spMkLst>
        </pc:spChg>
        <pc:spChg chg="add del mod">
          <ac:chgData name="Mbambo, Gillian" userId="59bfad07-67e3-47a4-ac55-04ee0a07a20e" providerId="ADAL" clId="{9EAD9B1B-79BC-B343-8A19-A5CE3C4E3D97}" dt="2023-03-03T21:00:50.006" v="715" actId="478"/>
          <ac:spMkLst>
            <pc:docMk/>
            <pc:sldMk cId="1114371219" sldId="301"/>
            <ac:spMk id="11" creationId="{91B274F6-0688-8333-9A9E-C506E9E4C067}"/>
          </ac:spMkLst>
        </pc:spChg>
        <pc:spChg chg="add del mod">
          <ac:chgData name="Mbambo, Gillian" userId="59bfad07-67e3-47a4-ac55-04ee0a07a20e" providerId="ADAL" clId="{9EAD9B1B-79BC-B343-8A19-A5CE3C4E3D97}" dt="2023-03-03T21:00:50.006" v="715" actId="478"/>
          <ac:spMkLst>
            <pc:docMk/>
            <pc:sldMk cId="1114371219" sldId="301"/>
            <ac:spMk id="12" creationId="{5C6D3AD7-AD29-CF5A-9D44-B3497A3ADF2C}"/>
          </ac:spMkLst>
        </pc:spChg>
        <pc:spChg chg="add del mod">
          <ac:chgData name="Mbambo, Gillian" userId="59bfad07-67e3-47a4-ac55-04ee0a07a20e" providerId="ADAL" clId="{9EAD9B1B-79BC-B343-8A19-A5CE3C4E3D97}" dt="2023-03-03T21:00:50.006" v="715" actId="478"/>
          <ac:spMkLst>
            <pc:docMk/>
            <pc:sldMk cId="1114371219" sldId="301"/>
            <ac:spMk id="13" creationId="{3F3AE147-B58B-66EC-E9B9-E4AE5B3D686F}"/>
          </ac:spMkLst>
        </pc:spChg>
        <pc:spChg chg="add del mod">
          <ac:chgData name="Mbambo, Gillian" userId="59bfad07-67e3-47a4-ac55-04ee0a07a20e" providerId="ADAL" clId="{9EAD9B1B-79BC-B343-8A19-A5CE3C4E3D97}" dt="2023-03-03T21:00:50.006" v="715" actId="478"/>
          <ac:spMkLst>
            <pc:docMk/>
            <pc:sldMk cId="1114371219" sldId="301"/>
            <ac:spMk id="14" creationId="{12E896F9-62D5-DD49-1268-0968806E6735}"/>
          </ac:spMkLst>
        </pc:spChg>
        <pc:spChg chg="add del mod">
          <ac:chgData name="Mbambo, Gillian" userId="59bfad07-67e3-47a4-ac55-04ee0a07a20e" providerId="ADAL" clId="{9EAD9B1B-79BC-B343-8A19-A5CE3C4E3D97}" dt="2023-03-03T21:00:50.006" v="715" actId="478"/>
          <ac:spMkLst>
            <pc:docMk/>
            <pc:sldMk cId="1114371219" sldId="301"/>
            <ac:spMk id="15" creationId="{9D4D577F-26A3-E2BC-F258-3F03F78C6C1B}"/>
          </ac:spMkLst>
        </pc:spChg>
        <pc:spChg chg="add del mod">
          <ac:chgData name="Mbambo, Gillian" userId="59bfad07-67e3-47a4-ac55-04ee0a07a20e" providerId="ADAL" clId="{9EAD9B1B-79BC-B343-8A19-A5CE3C4E3D97}" dt="2023-03-03T21:00:50.006" v="715" actId="478"/>
          <ac:spMkLst>
            <pc:docMk/>
            <pc:sldMk cId="1114371219" sldId="301"/>
            <ac:spMk id="16" creationId="{EC8B7BA0-F510-6032-8FB6-4E85C8AAD8AA}"/>
          </ac:spMkLst>
        </pc:spChg>
        <pc:spChg chg="add del mod">
          <ac:chgData name="Mbambo, Gillian" userId="59bfad07-67e3-47a4-ac55-04ee0a07a20e" providerId="ADAL" clId="{9EAD9B1B-79BC-B343-8A19-A5CE3C4E3D97}" dt="2023-03-03T21:00:50.006" v="715" actId="478"/>
          <ac:spMkLst>
            <pc:docMk/>
            <pc:sldMk cId="1114371219" sldId="301"/>
            <ac:spMk id="17" creationId="{3432E20F-E101-ED19-82B0-F8B43D5D5583}"/>
          </ac:spMkLst>
        </pc:spChg>
        <pc:spChg chg="add del mod">
          <ac:chgData name="Mbambo, Gillian" userId="59bfad07-67e3-47a4-ac55-04ee0a07a20e" providerId="ADAL" clId="{9EAD9B1B-79BC-B343-8A19-A5CE3C4E3D97}" dt="2023-03-03T21:00:50.006" v="715" actId="478"/>
          <ac:spMkLst>
            <pc:docMk/>
            <pc:sldMk cId="1114371219" sldId="301"/>
            <ac:spMk id="18" creationId="{C3006C1D-CF43-5473-4387-9D12D2F2130D}"/>
          </ac:spMkLst>
        </pc:spChg>
        <pc:spChg chg="add del mod">
          <ac:chgData name="Mbambo, Gillian" userId="59bfad07-67e3-47a4-ac55-04ee0a07a20e" providerId="ADAL" clId="{9EAD9B1B-79BC-B343-8A19-A5CE3C4E3D97}" dt="2023-03-03T21:00:50.006" v="715" actId="478"/>
          <ac:spMkLst>
            <pc:docMk/>
            <pc:sldMk cId="1114371219" sldId="301"/>
            <ac:spMk id="19" creationId="{16BCF502-A3B5-26F0-EB3A-2F472CBFAF7B}"/>
          </ac:spMkLst>
        </pc:spChg>
        <pc:spChg chg="add del mod">
          <ac:chgData name="Mbambo, Gillian" userId="59bfad07-67e3-47a4-ac55-04ee0a07a20e" providerId="ADAL" clId="{9EAD9B1B-79BC-B343-8A19-A5CE3C4E3D97}" dt="2023-03-03T21:00:50.006" v="715" actId="478"/>
          <ac:spMkLst>
            <pc:docMk/>
            <pc:sldMk cId="1114371219" sldId="301"/>
            <ac:spMk id="20" creationId="{79B136EF-EA73-81EB-F242-5BCC280C3FFA}"/>
          </ac:spMkLst>
        </pc:spChg>
        <pc:spChg chg="add del mod">
          <ac:chgData name="Mbambo, Gillian" userId="59bfad07-67e3-47a4-ac55-04ee0a07a20e" providerId="ADAL" clId="{9EAD9B1B-79BC-B343-8A19-A5CE3C4E3D97}" dt="2023-03-03T21:00:50.006" v="715" actId="478"/>
          <ac:spMkLst>
            <pc:docMk/>
            <pc:sldMk cId="1114371219" sldId="301"/>
            <ac:spMk id="21" creationId="{FF753CA9-02DE-3D19-E43D-1C8DEC2D5D78}"/>
          </ac:spMkLst>
        </pc:spChg>
        <pc:spChg chg="add del mod">
          <ac:chgData name="Mbambo, Gillian" userId="59bfad07-67e3-47a4-ac55-04ee0a07a20e" providerId="ADAL" clId="{9EAD9B1B-79BC-B343-8A19-A5CE3C4E3D97}" dt="2023-03-03T21:00:50.006" v="715" actId="478"/>
          <ac:spMkLst>
            <pc:docMk/>
            <pc:sldMk cId="1114371219" sldId="301"/>
            <ac:spMk id="22" creationId="{30D1E2F5-D279-6544-1412-0CC1F67996A7}"/>
          </ac:spMkLst>
        </pc:spChg>
        <pc:spChg chg="add del mod">
          <ac:chgData name="Mbambo, Gillian" userId="59bfad07-67e3-47a4-ac55-04ee0a07a20e" providerId="ADAL" clId="{9EAD9B1B-79BC-B343-8A19-A5CE3C4E3D97}" dt="2023-03-03T21:00:50.006" v="715" actId="478"/>
          <ac:spMkLst>
            <pc:docMk/>
            <pc:sldMk cId="1114371219" sldId="301"/>
            <ac:spMk id="23" creationId="{5C4FE47E-1C6F-86D4-778E-ED2169AAAA3D}"/>
          </ac:spMkLst>
        </pc:spChg>
        <pc:spChg chg="add del mod">
          <ac:chgData name="Mbambo, Gillian" userId="59bfad07-67e3-47a4-ac55-04ee0a07a20e" providerId="ADAL" clId="{9EAD9B1B-79BC-B343-8A19-A5CE3C4E3D97}" dt="2023-03-03T21:00:50.006" v="715" actId="478"/>
          <ac:spMkLst>
            <pc:docMk/>
            <pc:sldMk cId="1114371219" sldId="301"/>
            <ac:spMk id="24" creationId="{27020815-6B36-64F8-452D-705F0B808575}"/>
          </ac:spMkLst>
        </pc:spChg>
        <pc:spChg chg="add del mod">
          <ac:chgData name="Mbambo, Gillian" userId="59bfad07-67e3-47a4-ac55-04ee0a07a20e" providerId="ADAL" clId="{9EAD9B1B-79BC-B343-8A19-A5CE3C4E3D97}" dt="2023-03-03T21:00:50.006" v="715" actId="478"/>
          <ac:spMkLst>
            <pc:docMk/>
            <pc:sldMk cId="1114371219" sldId="301"/>
            <ac:spMk id="25" creationId="{4FB514DC-0AF3-D4B0-423E-26E27D4BA1E7}"/>
          </ac:spMkLst>
        </pc:spChg>
        <pc:spChg chg="add del mod">
          <ac:chgData name="Mbambo, Gillian" userId="59bfad07-67e3-47a4-ac55-04ee0a07a20e" providerId="ADAL" clId="{9EAD9B1B-79BC-B343-8A19-A5CE3C4E3D97}" dt="2023-03-03T21:00:50.006" v="715" actId="478"/>
          <ac:spMkLst>
            <pc:docMk/>
            <pc:sldMk cId="1114371219" sldId="301"/>
            <ac:spMk id="26" creationId="{D16F2C2E-7438-D806-DEF9-6098A3D58994}"/>
          </ac:spMkLst>
        </pc:spChg>
        <pc:spChg chg="add del mod">
          <ac:chgData name="Mbambo, Gillian" userId="59bfad07-67e3-47a4-ac55-04ee0a07a20e" providerId="ADAL" clId="{9EAD9B1B-79BC-B343-8A19-A5CE3C4E3D97}" dt="2023-03-03T21:00:50.006" v="715" actId="478"/>
          <ac:spMkLst>
            <pc:docMk/>
            <pc:sldMk cId="1114371219" sldId="301"/>
            <ac:spMk id="27" creationId="{386F4BAE-B209-F526-728B-05354E92566C}"/>
          </ac:spMkLst>
        </pc:spChg>
        <pc:spChg chg="add del mod">
          <ac:chgData name="Mbambo, Gillian" userId="59bfad07-67e3-47a4-ac55-04ee0a07a20e" providerId="ADAL" clId="{9EAD9B1B-79BC-B343-8A19-A5CE3C4E3D97}" dt="2023-03-03T21:00:26.521" v="709" actId="478"/>
          <ac:spMkLst>
            <pc:docMk/>
            <pc:sldMk cId="1114371219" sldId="301"/>
            <ac:spMk id="28" creationId="{9736F633-D6F5-A5BB-283B-588BA5912FA5}"/>
          </ac:spMkLst>
        </pc:spChg>
        <pc:spChg chg="add del mod">
          <ac:chgData name="Mbambo, Gillian" userId="59bfad07-67e3-47a4-ac55-04ee0a07a20e" providerId="ADAL" clId="{9EAD9B1B-79BC-B343-8A19-A5CE3C4E3D97}" dt="2023-03-03T21:00:52.847" v="716" actId="478"/>
          <ac:spMkLst>
            <pc:docMk/>
            <pc:sldMk cId="1114371219" sldId="301"/>
            <ac:spMk id="34" creationId="{C6BC52F9-A8C4-7288-2E5B-E33DD4ACAE96}"/>
          </ac:spMkLst>
        </pc:spChg>
        <pc:spChg chg="add mod">
          <ac:chgData name="Mbambo, Gillian" userId="59bfad07-67e3-47a4-ac55-04ee0a07a20e" providerId="ADAL" clId="{9EAD9B1B-79BC-B343-8A19-A5CE3C4E3D97}" dt="2023-03-03T21:24:08.542" v="853" actId="113"/>
          <ac:spMkLst>
            <pc:docMk/>
            <pc:sldMk cId="1114371219" sldId="301"/>
            <ac:spMk id="35" creationId="{137025D6-600F-67CA-0ECC-8B47BB25E93C}"/>
          </ac:spMkLst>
        </pc:spChg>
        <pc:spChg chg="add mod">
          <ac:chgData name="Mbambo, Gillian" userId="59bfad07-67e3-47a4-ac55-04ee0a07a20e" providerId="ADAL" clId="{9EAD9B1B-79BC-B343-8A19-A5CE3C4E3D97}" dt="2023-03-03T21:24:02.584" v="852" actId="113"/>
          <ac:spMkLst>
            <pc:docMk/>
            <pc:sldMk cId="1114371219" sldId="301"/>
            <ac:spMk id="36" creationId="{119005C8-BB44-71ED-01E3-861FC0294FE2}"/>
          </ac:spMkLst>
        </pc:spChg>
        <pc:picChg chg="del">
          <ac:chgData name="Mbambo, Gillian" userId="59bfad07-67e3-47a4-ac55-04ee0a07a20e" providerId="ADAL" clId="{9EAD9B1B-79BC-B343-8A19-A5CE3C4E3D97}" dt="2023-03-03T21:00:26.521" v="709" actId="478"/>
          <ac:picMkLst>
            <pc:docMk/>
            <pc:sldMk cId="1114371219" sldId="301"/>
            <ac:picMk id="3" creationId="{A51FA9FA-7C96-A8FC-D336-2D90DB1CE567}"/>
          </ac:picMkLst>
        </pc:picChg>
        <pc:picChg chg="del">
          <ac:chgData name="Mbambo, Gillian" userId="59bfad07-67e3-47a4-ac55-04ee0a07a20e" providerId="ADAL" clId="{9EAD9B1B-79BC-B343-8A19-A5CE3C4E3D97}" dt="2023-03-03T21:00:50.006" v="715" actId="478"/>
          <ac:picMkLst>
            <pc:docMk/>
            <pc:sldMk cId="1114371219" sldId="301"/>
            <ac:picMk id="7" creationId="{36760360-B49A-9E1C-94E4-78C34C2F0922}"/>
          </ac:picMkLst>
        </pc:picChg>
        <pc:picChg chg="add mod">
          <ac:chgData name="Mbambo, Gillian" userId="59bfad07-67e3-47a4-ac55-04ee0a07a20e" providerId="ADAL" clId="{9EAD9B1B-79BC-B343-8A19-A5CE3C4E3D97}" dt="2023-03-03T21:01:09.090" v="722" actId="1076"/>
          <ac:picMkLst>
            <pc:docMk/>
            <pc:sldMk cId="1114371219" sldId="301"/>
            <ac:picMk id="30" creationId="{F1008594-1D0E-7738-9242-D413A31FBCD4}"/>
          </ac:picMkLst>
        </pc:picChg>
        <pc:picChg chg="add mod">
          <ac:chgData name="Mbambo, Gillian" userId="59bfad07-67e3-47a4-ac55-04ee0a07a20e" providerId="ADAL" clId="{9EAD9B1B-79BC-B343-8A19-A5CE3C4E3D97}" dt="2023-03-03T21:01:46.924" v="727" actId="1076"/>
          <ac:picMkLst>
            <pc:docMk/>
            <pc:sldMk cId="1114371219" sldId="301"/>
            <ac:picMk id="32" creationId="{7A7998F5-4858-9A95-5018-0940688A07AF}"/>
          </ac:picMkLst>
        </pc:picChg>
      </pc:sldChg>
      <pc:sldChg chg="addSp delSp modSp mod">
        <pc:chgData name="Mbambo, Gillian" userId="59bfad07-67e3-47a4-ac55-04ee0a07a20e" providerId="ADAL" clId="{9EAD9B1B-79BC-B343-8A19-A5CE3C4E3D97}" dt="2023-03-03T21:24:36.543" v="859" actId="113"/>
        <pc:sldMkLst>
          <pc:docMk/>
          <pc:sldMk cId="1334781941" sldId="302"/>
        </pc:sldMkLst>
        <pc:spChg chg="add del mod">
          <ac:chgData name="Mbambo, Gillian" userId="59bfad07-67e3-47a4-ac55-04ee0a07a20e" providerId="ADAL" clId="{9EAD9B1B-79BC-B343-8A19-A5CE3C4E3D97}" dt="2023-03-03T20:52:26.010" v="618" actId="478"/>
          <ac:spMkLst>
            <pc:docMk/>
            <pc:sldMk cId="1334781941" sldId="302"/>
            <ac:spMk id="3" creationId="{DD736130-F2EF-2117-30DC-C0707DB69A91}"/>
          </ac:spMkLst>
        </pc:spChg>
        <pc:spChg chg="mod">
          <ac:chgData name="Mbambo, Gillian" userId="59bfad07-67e3-47a4-ac55-04ee0a07a20e" providerId="ADAL" clId="{9EAD9B1B-79BC-B343-8A19-A5CE3C4E3D97}" dt="2023-03-03T21:24:27.050" v="857" actId="113"/>
          <ac:spMkLst>
            <pc:docMk/>
            <pc:sldMk cId="1334781941" sldId="302"/>
            <ac:spMk id="5" creationId="{13447F51-3053-540A-1984-E9504E51E8D7}"/>
          </ac:spMkLst>
        </pc:spChg>
        <pc:spChg chg="del mod">
          <ac:chgData name="Mbambo, Gillian" userId="59bfad07-67e3-47a4-ac55-04ee0a07a20e" providerId="ADAL" clId="{9EAD9B1B-79BC-B343-8A19-A5CE3C4E3D97}" dt="2023-03-03T21:07:36.569" v="834" actId="478"/>
          <ac:spMkLst>
            <pc:docMk/>
            <pc:sldMk cId="1334781941" sldId="302"/>
            <ac:spMk id="6" creationId="{FF711174-1651-E86B-95CF-A33870C5EC85}"/>
          </ac:spMkLst>
        </pc:spChg>
        <pc:spChg chg="add del mod">
          <ac:chgData name="Mbambo, Gillian" userId="59bfad07-67e3-47a4-ac55-04ee0a07a20e" providerId="ADAL" clId="{9EAD9B1B-79BC-B343-8A19-A5CE3C4E3D97}" dt="2023-03-03T21:06:32.808" v="770" actId="478"/>
          <ac:spMkLst>
            <pc:docMk/>
            <pc:sldMk cId="1334781941" sldId="302"/>
            <ac:spMk id="7" creationId="{32AC83B4-25E9-F62D-97C1-958DA16567F2}"/>
          </ac:spMkLst>
        </pc:spChg>
        <pc:spChg chg="del mod">
          <ac:chgData name="Mbambo, Gillian" userId="59bfad07-67e3-47a4-ac55-04ee0a07a20e" providerId="ADAL" clId="{9EAD9B1B-79BC-B343-8A19-A5CE3C4E3D97}" dt="2023-03-03T21:07:34.465" v="833" actId="478"/>
          <ac:spMkLst>
            <pc:docMk/>
            <pc:sldMk cId="1334781941" sldId="302"/>
            <ac:spMk id="9" creationId="{B457769E-BC3E-CAE2-11BD-4A4C712FE57D}"/>
          </ac:spMkLst>
        </pc:spChg>
        <pc:spChg chg="add del mod">
          <ac:chgData name="Mbambo, Gillian" userId="59bfad07-67e3-47a4-ac55-04ee0a07a20e" providerId="ADAL" clId="{9EAD9B1B-79BC-B343-8A19-A5CE3C4E3D97}" dt="2023-03-03T21:06:32.808" v="770" actId="478"/>
          <ac:spMkLst>
            <pc:docMk/>
            <pc:sldMk cId="1334781941" sldId="302"/>
            <ac:spMk id="10" creationId="{A77B4823-54D2-79BB-3765-7422B02315CE}"/>
          </ac:spMkLst>
        </pc:spChg>
        <pc:spChg chg="add del mod">
          <ac:chgData name="Mbambo, Gillian" userId="59bfad07-67e3-47a4-ac55-04ee0a07a20e" providerId="ADAL" clId="{9EAD9B1B-79BC-B343-8A19-A5CE3C4E3D97}" dt="2023-03-03T21:06:32.808" v="770" actId="478"/>
          <ac:spMkLst>
            <pc:docMk/>
            <pc:sldMk cId="1334781941" sldId="302"/>
            <ac:spMk id="11" creationId="{2B582EB4-ABF0-53C0-817E-1A7495FC5361}"/>
          </ac:spMkLst>
        </pc:spChg>
        <pc:spChg chg="add del mod">
          <ac:chgData name="Mbambo, Gillian" userId="59bfad07-67e3-47a4-ac55-04ee0a07a20e" providerId="ADAL" clId="{9EAD9B1B-79BC-B343-8A19-A5CE3C4E3D97}" dt="2023-03-03T21:06:32.808" v="770" actId="478"/>
          <ac:spMkLst>
            <pc:docMk/>
            <pc:sldMk cId="1334781941" sldId="302"/>
            <ac:spMk id="12" creationId="{4A07EF3B-A546-2026-2B31-46CDDF14FF95}"/>
          </ac:spMkLst>
        </pc:spChg>
        <pc:spChg chg="add del mod">
          <ac:chgData name="Mbambo, Gillian" userId="59bfad07-67e3-47a4-ac55-04ee0a07a20e" providerId="ADAL" clId="{9EAD9B1B-79BC-B343-8A19-A5CE3C4E3D97}" dt="2023-03-03T21:06:32.808" v="770" actId="478"/>
          <ac:spMkLst>
            <pc:docMk/>
            <pc:sldMk cId="1334781941" sldId="302"/>
            <ac:spMk id="13" creationId="{A8872A5F-7CEE-D7A8-92DE-458F0C0BF1AE}"/>
          </ac:spMkLst>
        </pc:spChg>
        <pc:spChg chg="add del mod">
          <ac:chgData name="Mbambo, Gillian" userId="59bfad07-67e3-47a4-ac55-04ee0a07a20e" providerId="ADAL" clId="{9EAD9B1B-79BC-B343-8A19-A5CE3C4E3D97}" dt="2023-03-03T21:06:32.808" v="770" actId="478"/>
          <ac:spMkLst>
            <pc:docMk/>
            <pc:sldMk cId="1334781941" sldId="302"/>
            <ac:spMk id="14" creationId="{0E17B9B0-5267-4280-F86B-13F01C2D6E08}"/>
          </ac:spMkLst>
        </pc:spChg>
        <pc:spChg chg="add del mod">
          <ac:chgData name="Mbambo, Gillian" userId="59bfad07-67e3-47a4-ac55-04ee0a07a20e" providerId="ADAL" clId="{9EAD9B1B-79BC-B343-8A19-A5CE3C4E3D97}" dt="2023-03-03T21:06:32.808" v="770" actId="478"/>
          <ac:spMkLst>
            <pc:docMk/>
            <pc:sldMk cId="1334781941" sldId="302"/>
            <ac:spMk id="15" creationId="{8A444E77-C6BD-26A0-CC66-9CA91DD11875}"/>
          </ac:spMkLst>
        </pc:spChg>
        <pc:spChg chg="add del mod">
          <ac:chgData name="Mbambo, Gillian" userId="59bfad07-67e3-47a4-ac55-04ee0a07a20e" providerId="ADAL" clId="{9EAD9B1B-79BC-B343-8A19-A5CE3C4E3D97}" dt="2023-03-03T21:06:32.808" v="770" actId="478"/>
          <ac:spMkLst>
            <pc:docMk/>
            <pc:sldMk cId="1334781941" sldId="302"/>
            <ac:spMk id="16" creationId="{AF81ABF1-7EEE-A379-8B99-FEA3DBC6E685}"/>
          </ac:spMkLst>
        </pc:spChg>
        <pc:spChg chg="add del mod">
          <ac:chgData name="Mbambo, Gillian" userId="59bfad07-67e3-47a4-ac55-04ee0a07a20e" providerId="ADAL" clId="{9EAD9B1B-79BC-B343-8A19-A5CE3C4E3D97}" dt="2023-03-03T21:06:32.808" v="770" actId="478"/>
          <ac:spMkLst>
            <pc:docMk/>
            <pc:sldMk cId="1334781941" sldId="302"/>
            <ac:spMk id="17" creationId="{2AC16E60-7D4B-4214-2E43-351464412E41}"/>
          </ac:spMkLst>
        </pc:spChg>
        <pc:spChg chg="add del mod">
          <ac:chgData name="Mbambo, Gillian" userId="59bfad07-67e3-47a4-ac55-04ee0a07a20e" providerId="ADAL" clId="{9EAD9B1B-79BC-B343-8A19-A5CE3C4E3D97}" dt="2023-03-03T21:06:32.808" v="770" actId="478"/>
          <ac:spMkLst>
            <pc:docMk/>
            <pc:sldMk cId="1334781941" sldId="302"/>
            <ac:spMk id="18" creationId="{2FA0F550-6878-79F7-D8F0-A516BBDA44CD}"/>
          </ac:spMkLst>
        </pc:spChg>
        <pc:spChg chg="add del mod">
          <ac:chgData name="Mbambo, Gillian" userId="59bfad07-67e3-47a4-ac55-04ee0a07a20e" providerId="ADAL" clId="{9EAD9B1B-79BC-B343-8A19-A5CE3C4E3D97}" dt="2023-03-03T21:06:32.808" v="770" actId="478"/>
          <ac:spMkLst>
            <pc:docMk/>
            <pc:sldMk cId="1334781941" sldId="302"/>
            <ac:spMk id="19" creationId="{4219998E-78EB-813D-CF34-E4BB4E317E90}"/>
          </ac:spMkLst>
        </pc:spChg>
        <pc:spChg chg="add del mod">
          <ac:chgData name="Mbambo, Gillian" userId="59bfad07-67e3-47a4-ac55-04ee0a07a20e" providerId="ADAL" clId="{9EAD9B1B-79BC-B343-8A19-A5CE3C4E3D97}" dt="2023-03-03T21:06:32.808" v="770" actId="478"/>
          <ac:spMkLst>
            <pc:docMk/>
            <pc:sldMk cId="1334781941" sldId="302"/>
            <ac:spMk id="20" creationId="{1C536A10-6C47-BCAB-1E2D-4A1FF047CA7A}"/>
          </ac:spMkLst>
        </pc:spChg>
        <pc:spChg chg="add del mod">
          <ac:chgData name="Mbambo, Gillian" userId="59bfad07-67e3-47a4-ac55-04ee0a07a20e" providerId="ADAL" clId="{9EAD9B1B-79BC-B343-8A19-A5CE3C4E3D97}" dt="2023-03-03T21:06:32.808" v="770" actId="478"/>
          <ac:spMkLst>
            <pc:docMk/>
            <pc:sldMk cId="1334781941" sldId="302"/>
            <ac:spMk id="21" creationId="{0BDE5A0C-3B04-E9CB-CBA1-0C12031BA92C}"/>
          </ac:spMkLst>
        </pc:spChg>
        <pc:spChg chg="add del mod">
          <ac:chgData name="Mbambo, Gillian" userId="59bfad07-67e3-47a4-ac55-04ee0a07a20e" providerId="ADAL" clId="{9EAD9B1B-79BC-B343-8A19-A5CE3C4E3D97}" dt="2023-03-03T21:06:32.808" v="770" actId="478"/>
          <ac:spMkLst>
            <pc:docMk/>
            <pc:sldMk cId="1334781941" sldId="302"/>
            <ac:spMk id="22" creationId="{462578F5-C8EF-3A92-22A6-F49BE9AFF05F}"/>
          </ac:spMkLst>
        </pc:spChg>
        <pc:spChg chg="add del mod">
          <ac:chgData name="Mbambo, Gillian" userId="59bfad07-67e3-47a4-ac55-04ee0a07a20e" providerId="ADAL" clId="{9EAD9B1B-79BC-B343-8A19-A5CE3C4E3D97}" dt="2023-03-03T21:06:32.808" v="770" actId="478"/>
          <ac:spMkLst>
            <pc:docMk/>
            <pc:sldMk cId="1334781941" sldId="302"/>
            <ac:spMk id="23" creationId="{956DAF5D-1E15-0AB4-85BE-4BD2BBB8E110}"/>
          </ac:spMkLst>
        </pc:spChg>
        <pc:spChg chg="add del mod">
          <ac:chgData name="Mbambo, Gillian" userId="59bfad07-67e3-47a4-ac55-04ee0a07a20e" providerId="ADAL" clId="{9EAD9B1B-79BC-B343-8A19-A5CE3C4E3D97}" dt="2023-03-03T21:06:32.808" v="770" actId="478"/>
          <ac:spMkLst>
            <pc:docMk/>
            <pc:sldMk cId="1334781941" sldId="302"/>
            <ac:spMk id="24" creationId="{EA16E8C3-E87A-29B3-52C5-E40DC466BB5A}"/>
          </ac:spMkLst>
        </pc:spChg>
        <pc:spChg chg="add del mod">
          <ac:chgData name="Mbambo, Gillian" userId="59bfad07-67e3-47a4-ac55-04ee0a07a20e" providerId="ADAL" clId="{9EAD9B1B-79BC-B343-8A19-A5CE3C4E3D97}" dt="2023-03-03T21:06:32.808" v="770" actId="478"/>
          <ac:spMkLst>
            <pc:docMk/>
            <pc:sldMk cId="1334781941" sldId="302"/>
            <ac:spMk id="25" creationId="{FDFF44D2-3513-8BCB-A3D9-A81C32B5054E}"/>
          </ac:spMkLst>
        </pc:spChg>
        <pc:spChg chg="add del mod">
          <ac:chgData name="Mbambo, Gillian" userId="59bfad07-67e3-47a4-ac55-04ee0a07a20e" providerId="ADAL" clId="{9EAD9B1B-79BC-B343-8A19-A5CE3C4E3D97}" dt="2023-03-03T21:06:32.808" v="770" actId="478"/>
          <ac:spMkLst>
            <pc:docMk/>
            <pc:sldMk cId="1334781941" sldId="302"/>
            <ac:spMk id="26" creationId="{0631AEA9-EAE6-FE7D-E41C-860903896BB7}"/>
          </ac:spMkLst>
        </pc:spChg>
        <pc:spChg chg="add del mod">
          <ac:chgData name="Mbambo, Gillian" userId="59bfad07-67e3-47a4-ac55-04ee0a07a20e" providerId="ADAL" clId="{9EAD9B1B-79BC-B343-8A19-A5CE3C4E3D97}" dt="2023-03-03T21:04:00.947" v="734" actId="478"/>
          <ac:spMkLst>
            <pc:docMk/>
            <pc:sldMk cId="1334781941" sldId="302"/>
            <ac:spMk id="27" creationId="{39856289-EE82-0046-5989-1A67B0B80009}"/>
          </ac:spMkLst>
        </pc:spChg>
        <pc:spChg chg="add del mod">
          <ac:chgData name="Mbambo, Gillian" userId="59bfad07-67e3-47a4-ac55-04ee0a07a20e" providerId="ADAL" clId="{9EAD9B1B-79BC-B343-8A19-A5CE3C4E3D97}" dt="2023-03-03T21:04:00.947" v="734" actId="478"/>
          <ac:spMkLst>
            <pc:docMk/>
            <pc:sldMk cId="1334781941" sldId="302"/>
            <ac:spMk id="28" creationId="{8F7F4812-4DD9-839A-77D8-F11DEBF54C27}"/>
          </ac:spMkLst>
        </pc:spChg>
        <pc:spChg chg="add del mod">
          <ac:chgData name="Mbambo, Gillian" userId="59bfad07-67e3-47a4-ac55-04ee0a07a20e" providerId="ADAL" clId="{9EAD9B1B-79BC-B343-8A19-A5CE3C4E3D97}" dt="2023-03-03T21:05:12.591" v="753" actId="478"/>
          <ac:spMkLst>
            <pc:docMk/>
            <pc:sldMk cId="1334781941" sldId="302"/>
            <ac:spMk id="34" creationId="{E3E715A8-1A7F-7040-091C-F4B7D1A1BEB6}"/>
          </ac:spMkLst>
        </pc:spChg>
        <pc:spChg chg="add del mod">
          <ac:chgData name="Mbambo, Gillian" userId="59bfad07-67e3-47a4-ac55-04ee0a07a20e" providerId="ADAL" clId="{9EAD9B1B-79BC-B343-8A19-A5CE3C4E3D97}" dt="2023-03-03T21:06:35.889" v="771" actId="478"/>
          <ac:spMkLst>
            <pc:docMk/>
            <pc:sldMk cId="1334781941" sldId="302"/>
            <ac:spMk id="38" creationId="{8FF87B02-B9DD-7808-C2A8-C5F68505C9FF}"/>
          </ac:spMkLst>
        </pc:spChg>
        <pc:spChg chg="add mod">
          <ac:chgData name="Mbambo, Gillian" userId="59bfad07-67e3-47a4-ac55-04ee0a07a20e" providerId="ADAL" clId="{9EAD9B1B-79BC-B343-8A19-A5CE3C4E3D97}" dt="2023-03-03T21:24:36.543" v="859" actId="113"/>
          <ac:spMkLst>
            <pc:docMk/>
            <pc:sldMk cId="1334781941" sldId="302"/>
            <ac:spMk id="39" creationId="{5E8D1917-1225-8A00-59B2-D09F31E0C0C7}"/>
          </ac:spMkLst>
        </pc:spChg>
        <pc:spChg chg="add mod">
          <ac:chgData name="Mbambo, Gillian" userId="59bfad07-67e3-47a4-ac55-04ee0a07a20e" providerId="ADAL" clId="{9EAD9B1B-79BC-B343-8A19-A5CE3C4E3D97}" dt="2023-03-03T21:24:34.202" v="858" actId="113"/>
          <ac:spMkLst>
            <pc:docMk/>
            <pc:sldMk cId="1334781941" sldId="302"/>
            <ac:spMk id="40" creationId="{F3DDBE72-0216-6975-65AB-40BDC7A0604A}"/>
          </ac:spMkLst>
        </pc:spChg>
        <pc:picChg chg="del">
          <ac:chgData name="Mbambo, Gillian" userId="59bfad07-67e3-47a4-ac55-04ee0a07a20e" providerId="ADAL" clId="{9EAD9B1B-79BC-B343-8A19-A5CE3C4E3D97}" dt="2023-03-03T21:04:00.947" v="734" actId="478"/>
          <ac:picMkLst>
            <pc:docMk/>
            <pc:sldMk cId="1334781941" sldId="302"/>
            <ac:picMk id="4" creationId="{062748F9-E709-66C4-6D42-B8161FAFED08}"/>
          </ac:picMkLst>
        </pc:picChg>
        <pc:picChg chg="add del">
          <ac:chgData name="Mbambo, Gillian" userId="59bfad07-67e3-47a4-ac55-04ee0a07a20e" providerId="ADAL" clId="{9EAD9B1B-79BC-B343-8A19-A5CE3C4E3D97}" dt="2023-03-03T21:06:32.808" v="770" actId="478"/>
          <ac:picMkLst>
            <pc:docMk/>
            <pc:sldMk cId="1334781941" sldId="302"/>
            <ac:picMk id="8" creationId="{9E45CED0-A138-3966-BE86-86921821E800}"/>
          </ac:picMkLst>
        </pc:picChg>
        <pc:picChg chg="add mod">
          <ac:chgData name="Mbambo, Gillian" userId="59bfad07-67e3-47a4-ac55-04ee0a07a20e" providerId="ADAL" clId="{9EAD9B1B-79BC-B343-8A19-A5CE3C4E3D97}" dt="2023-03-03T21:07:02.328" v="796" actId="1038"/>
          <ac:picMkLst>
            <pc:docMk/>
            <pc:sldMk cId="1334781941" sldId="302"/>
            <ac:picMk id="30" creationId="{0A4C7A01-96C5-18CC-BB36-A99756515E05}"/>
          </ac:picMkLst>
        </pc:picChg>
        <pc:picChg chg="add del mod">
          <ac:chgData name="Mbambo, Gillian" userId="59bfad07-67e3-47a4-ac55-04ee0a07a20e" providerId="ADAL" clId="{9EAD9B1B-79BC-B343-8A19-A5CE3C4E3D97}" dt="2023-03-03T21:05:52.822" v="761" actId="478"/>
          <ac:picMkLst>
            <pc:docMk/>
            <pc:sldMk cId="1334781941" sldId="302"/>
            <ac:picMk id="32" creationId="{EF982538-8D00-31E6-0746-356A978E6A4C}"/>
          </ac:picMkLst>
        </pc:picChg>
        <pc:picChg chg="add mod">
          <ac:chgData name="Mbambo, Gillian" userId="59bfad07-67e3-47a4-ac55-04ee0a07a20e" providerId="ADAL" clId="{9EAD9B1B-79BC-B343-8A19-A5CE3C4E3D97}" dt="2023-03-03T21:07:26.239" v="832" actId="1037"/>
          <ac:picMkLst>
            <pc:docMk/>
            <pc:sldMk cId="1334781941" sldId="302"/>
            <ac:picMk id="36" creationId="{6D1DFC10-3E2D-13FB-E350-44C32AEE665B}"/>
          </ac:picMkLst>
        </pc:picChg>
      </pc:sldChg>
      <pc:sldChg chg="addSp delSp modSp add del mod ord">
        <pc:chgData name="Mbambo, Gillian" userId="59bfad07-67e3-47a4-ac55-04ee0a07a20e" providerId="ADAL" clId="{9EAD9B1B-79BC-B343-8A19-A5CE3C4E3D97}" dt="2023-03-02T22:03:47.001" v="37" actId="20578"/>
        <pc:sldMkLst>
          <pc:docMk/>
          <pc:sldMk cId="1799949073" sldId="305"/>
        </pc:sldMkLst>
        <pc:spChg chg="del">
          <ac:chgData name="Mbambo, Gillian" userId="59bfad07-67e3-47a4-ac55-04ee0a07a20e" providerId="ADAL" clId="{9EAD9B1B-79BC-B343-8A19-A5CE3C4E3D97}" dt="2023-03-02T22:03:24.115" v="2" actId="478"/>
          <ac:spMkLst>
            <pc:docMk/>
            <pc:sldMk cId="1799949073" sldId="305"/>
            <ac:spMk id="3" creationId="{6E2E9D53-3EB2-10AA-CC6B-DA65986173FC}"/>
          </ac:spMkLst>
        </pc:spChg>
        <pc:spChg chg="mod">
          <ac:chgData name="Mbambo, Gillian" userId="59bfad07-67e3-47a4-ac55-04ee0a07a20e" providerId="ADAL" clId="{9EAD9B1B-79BC-B343-8A19-A5CE3C4E3D97}" dt="2023-03-02T22:03:43.222" v="36" actId="1035"/>
          <ac:spMkLst>
            <pc:docMk/>
            <pc:sldMk cId="1799949073" sldId="305"/>
            <ac:spMk id="4" creationId="{370BBE70-B005-07CE-8F07-112200FFAF72}"/>
          </ac:spMkLst>
        </pc:spChg>
        <pc:spChg chg="mod">
          <ac:chgData name="Mbambo, Gillian" userId="59bfad07-67e3-47a4-ac55-04ee0a07a20e" providerId="ADAL" clId="{9EAD9B1B-79BC-B343-8A19-A5CE3C4E3D97}" dt="2023-03-02T22:03:43.222" v="36" actId="1035"/>
          <ac:spMkLst>
            <pc:docMk/>
            <pc:sldMk cId="1799949073" sldId="305"/>
            <ac:spMk id="5" creationId="{B8D80A98-FB77-032E-1D4C-20971115B607}"/>
          </ac:spMkLst>
        </pc:spChg>
        <pc:spChg chg="add del mod">
          <ac:chgData name="Mbambo, Gillian" userId="59bfad07-67e3-47a4-ac55-04ee0a07a20e" providerId="ADAL" clId="{9EAD9B1B-79BC-B343-8A19-A5CE3C4E3D97}" dt="2023-03-02T22:03:26.633" v="3" actId="478"/>
          <ac:spMkLst>
            <pc:docMk/>
            <pc:sldMk cId="1799949073" sldId="305"/>
            <ac:spMk id="7" creationId="{71F73A85-4CFC-A52B-A9F3-7151BFF99F3B}"/>
          </ac:spMkLst>
        </pc:spChg>
        <pc:spChg chg="mod">
          <ac:chgData name="Mbambo, Gillian" userId="59bfad07-67e3-47a4-ac55-04ee0a07a20e" providerId="ADAL" clId="{9EAD9B1B-79BC-B343-8A19-A5CE3C4E3D97}" dt="2023-03-02T22:03:43.222" v="36" actId="1035"/>
          <ac:spMkLst>
            <pc:docMk/>
            <pc:sldMk cId="1799949073" sldId="305"/>
            <ac:spMk id="8" creationId="{164D787A-1F90-283F-C1E8-9684A8657403}"/>
          </ac:spMkLst>
        </pc:spChg>
        <pc:spChg chg="mod">
          <ac:chgData name="Mbambo, Gillian" userId="59bfad07-67e3-47a4-ac55-04ee0a07a20e" providerId="ADAL" clId="{9EAD9B1B-79BC-B343-8A19-A5CE3C4E3D97}" dt="2023-03-02T22:03:43.222" v="36" actId="1035"/>
          <ac:spMkLst>
            <pc:docMk/>
            <pc:sldMk cId="1799949073" sldId="305"/>
            <ac:spMk id="9" creationId="{9F2B83CC-013D-0F09-E3B9-97C30067C1EA}"/>
          </ac:spMkLst>
        </pc:spChg>
      </pc:sldChg>
      <pc:sldChg chg="modSp mod">
        <pc:chgData name="Mbambo, Gillian" userId="59bfad07-67e3-47a4-ac55-04ee0a07a20e" providerId="ADAL" clId="{9EAD9B1B-79BC-B343-8A19-A5CE3C4E3D97}" dt="2023-03-03T21:23:08.511" v="843" actId="114"/>
        <pc:sldMkLst>
          <pc:docMk/>
          <pc:sldMk cId="1991104181" sldId="306"/>
        </pc:sldMkLst>
        <pc:spChg chg="mod">
          <ac:chgData name="Mbambo, Gillian" userId="59bfad07-67e3-47a4-ac55-04ee0a07a20e" providerId="ADAL" clId="{9EAD9B1B-79BC-B343-8A19-A5CE3C4E3D97}" dt="2023-03-03T21:23:08.511" v="843" actId="114"/>
          <ac:spMkLst>
            <pc:docMk/>
            <pc:sldMk cId="1991104181" sldId="306"/>
            <ac:spMk id="3" creationId="{40D56CB0-8795-C618-A0E6-9E45A11BE6CA}"/>
          </ac:spMkLst>
        </pc:spChg>
        <pc:spChg chg="mod">
          <ac:chgData name="Mbambo, Gillian" userId="59bfad07-67e3-47a4-ac55-04ee0a07a20e" providerId="ADAL" clId="{9EAD9B1B-79BC-B343-8A19-A5CE3C4E3D97}" dt="2023-03-03T21:22:35.034" v="839" actId="113"/>
          <ac:spMkLst>
            <pc:docMk/>
            <pc:sldMk cId="1991104181" sldId="306"/>
            <ac:spMk id="16" creationId="{96ED90D7-9B11-84D4-F9E5-08B19B32B33F}"/>
          </ac:spMkLst>
        </pc:spChg>
        <pc:spChg chg="mod">
          <ac:chgData name="Mbambo, Gillian" userId="59bfad07-67e3-47a4-ac55-04ee0a07a20e" providerId="ADAL" clId="{9EAD9B1B-79BC-B343-8A19-A5CE3C4E3D97}" dt="2023-03-03T21:22:37.588" v="840" actId="113"/>
          <ac:spMkLst>
            <pc:docMk/>
            <pc:sldMk cId="1991104181" sldId="306"/>
            <ac:spMk id="18" creationId="{1F9B3BAB-8127-03F5-B4F6-AD5B5A41A299}"/>
          </ac:spMkLst>
        </pc:spChg>
      </pc:sldChg>
      <pc:sldChg chg="addSp modSp mod">
        <pc:chgData name="Mbambo, Gillian" userId="59bfad07-67e3-47a4-ac55-04ee0a07a20e" providerId="ADAL" clId="{9EAD9B1B-79BC-B343-8A19-A5CE3C4E3D97}" dt="2023-03-03T21:23:22.526" v="844" actId="113"/>
        <pc:sldMkLst>
          <pc:docMk/>
          <pc:sldMk cId="1237024876" sldId="308"/>
        </pc:sldMkLst>
        <pc:spChg chg="add mod">
          <ac:chgData name="Mbambo, Gillian" userId="59bfad07-67e3-47a4-ac55-04ee0a07a20e" providerId="ADAL" clId="{9EAD9B1B-79BC-B343-8A19-A5CE3C4E3D97}" dt="2023-03-02T22:06:15.298" v="100" actId="1038"/>
          <ac:spMkLst>
            <pc:docMk/>
            <pc:sldMk cId="1237024876" sldId="308"/>
            <ac:spMk id="2" creationId="{C945AAED-4A2D-BD48-E4CC-AF6B3308A68C}"/>
          </ac:spMkLst>
        </pc:spChg>
        <pc:spChg chg="mod">
          <ac:chgData name="Mbambo, Gillian" userId="59bfad07-67e3-47a4-ac55-04ee0a07a20e" providerId="ADAL" clId="{9EAD9B1B-79BC-B343-8A19-A5CE3C4E3D97}" dt="2023-03-03T21:23:22.526" v="844" actId="113"/>
          <ac:spMkLst>
            <pc:docMk/>
            <pc:sldMk cId="1237024876" sldId="308"/>
            <ac:spMk id="3" creationId="{37454A6F-B819-0934-9B9C-9FBDDD04F2D6}"/>
          </ac:spMkLst>
        </pc:spChg>
        <pc:spChg chg="mod">
          <ac:chgData name="Mbambo, Gillian" userId="59bfad07-67e3-47a4-ac55-04ee0a07a20e" providerId="ADAL" clId="{9EAD9B1B-79BC-B343-8A19-A5CE3C4E3D97}" dt="2023-03-02T22:04:17.999" v="43" actId="1076"/>
          <ac:spMkLst>
            <pc:docMk/>
            <pc:sldMk cId="1237024876" sldId="308"/>
            <ac:spMk id="6" creationId="{068A65DE-EC4E-0676-831E-BD44CCE7BF65}"/>
          </ac:spMkLst>
        </pc:spChg>
        <pc:spChg chg="add mod">
          <ac:chgData name="Mbambo, Gillian" userId="59bfad07-67e3-47a4-ac55-04ee0a07a20e" providerId="ADAL" clId="{9EAD9B1B-79BC-B343-8A19-A5CE3C4E3D97}" dt="2023-03-02T22:06:56.549" v="123" actId="113"/>
          <ac:spMkLst>
            <pc:docMk/>
            <pc:sldMk cId="1237024876" sldId="308"/>
            <ac:spMk id="8" creationId="{C745B038-92EB-18B0-25EB-0556AB7C6BD3}"/>
          </ac:spMkLst>
        </pc:spChg>
        <pc:spChg chg="add mod">
          <ac:chgData name="Mbambo, Gillian" userId="59bfad07-67e3-47a4-ac55-04ee0a07a20e" providerId="ADAL" clId="{9EAD9B1B-79BC-B343-8A19-A5CE3C4E3D97}" dt="2023-03-02T22:07:33.650" v="196" actId="14100"/>
          <ac:spMkLst>
            <pc:docMk/>
            <pc:sldMk cId="1237024876" sldId="308"/>
            <ac:spMk id="9" creationId="{18D334CD-DCEA-5454-82BC-3C0FB219F15A}"/>
          </ac:spMkLst>
        </pc:spChg>
        <pc:spChg chg="add mod">
          <ac:chgData name="Mbambo, Gillian" userId="59bfad07-67e3-47a4-ac55-04ee0a07a20e" providerId="ADAL" clId="{9EAD9B1B-79BC-B343-8A19-A5CE3C4E3D97}" dt="2023-03-02T22:07:27.307" v="195" actId="20577"/>
          <ac:spMkLst>
            <pc:docMk/>
            <pc:sldMk cId="1237024876" sldId="308"/>
            <ac:spMk id="10" creationId="{37B6087D-F513-44AF-5236-C8E19A3FDA01}"/>
          </ac:spMkLst>
        </pc:spChg>
        <pc:picChg chg="mod">
          <ac:chgData name="Mbambo, Gillian" userId="59bfad07-67e3-47a4-ac55-04ee0a07a20e" providerId="ADAL" clId="{9EAD9B1B-79BC-B343-8A19-A5CE3C4E3D97}" dt="2023-03-02T22:04:41.083" v="69" actId="1036"/>
          <ac:picMkLst>
            <pc:docMk/>
            <pc:sldMk cId="1237024876" sldId="308"/>
            <ac:picMk id="7" creationId="{3E60CF59-E7BF-FFDC-AF88-CE99CD0BF17F}"/>
          </ac:picMkLst>
        </pc:picChg>
      </pc:sldChg>
      <pc:sldChg chg="modSp mod">
        <pc:chgData name="Mbambo, Gillian" userId="59bfad07-67e3-47a4-ac55-04ee0a07a20e" providerId="ADAL" clId="{9EAD9B1B-79BC-B343-8A19-A5CE3C4E3D97}" dt="2023-03-03T21:23:35.876" v="847" actId="113"/>
        <pc:sldMkLst>
          <pc:docMk/>
          <pc:sldMk cId="1258758728" sldId="309"/>
        </pc:sldMkLst>
        <pc:spChg chg="mod">
          <ac:chgData name="Mbambo, Gillian" userId="59bfad07-67e3-47a4-ac55-04ee0a07a20e" providerId="ADAL" clId="{9EAD9B1B-79BC-B343-8A19-A5CE3C4E3D97}" dt="2023-03-03T21:23:27.213" v="845" actId="113"/>
          <ac:spMkLst>
            <pc:docMk/>
            <pc:sldMk cId="1258758728" sldId="309"/>
            <ac:spMk id="3" creationId="{C40FABF0-F246-3037-BF54-E7EE5D5A1578}"/>
          </ac:spMkLst>
        </pc:spChg>
        <pc:spChg chg="mod">
          <ac:chgData name="Mbambo, Gillian" userId="59bfad07-67e3-47a4-ac55-04ee0a07a20e" providerId="ADAL" clId="{9EAD9B1B-79BC-B343-8A19-A5CE3C4E3D97}" dt="2023-03-03T21:23:35.876" v="847" actId="113"/>
          <ac:spMkLst>
            <pc:docMk/>
            <pc:sldMk cId="1258758728" sldId="309"/>
            <ac:spMk id="8" creationId="{08AD758F-8DC8-ADDA-C8D0-04AE0D651C24}"/>
          </ac:spMkLst>
        </pc:spChg>
      </pc:sldChg>
    </pc:docChg>
  </pc:docChgLst>
  <pc:docChgLst>
    <pc:chgData name="Mbambo, Gillian" userId="59bfad07-67e3-47a4-ac55-04ee0a07a20e" providerId="ADAL" clId="{689D5830-7D20-EF43-9790-B7D919905F98}"/>
    <pc:docChg chg="undo redo custSel addSld delSld modSld sldOrd">
      <pc:chgData name="Mbambo, Gillian" userId="59bfad07-67e3-47a4-ac55-04ee0a07a20e" providerId="ADAL" clId="{689D5830-7D20-EF43-9790-B7D919905F98}" dt="2023-06-05T13:08:14.017" v="5647" actId="1036"/>
      <pc:docMkLst>
        <pc:docMk/>
      </pc:docMkLst>
      <pc:sldChg chg="addSp delSp modSp mod">
        <pc:chgData name="Mbambo, Gillian" userId="59bfad07-67e3-47a4-ac55-04ee0a07a20e" providerId="ADAL" clId="{689D5830-7D20-EF43-9790-B7D919905F98}" dt="2023-05-28T21:36:21.279" v="3940" actId="21"/>
        <pc:sldMkLst>
          <pc:docMk/>
          <pc:sldMk cId="2945594372" sldId="256"/>
        </pc:sldMkLst>
        <pc:picChg chg="add del mod">
          <ac:chgData name="Mbambo, Gillian" userId="59bfad07-67e3-47a4-ac55-04ee0a07a20e" providerId="ADAL" clId="{689D5830-7D20-EF43-9790-B7D919905F98}" dt="2023-05-28T21:36:21.279" v="3940" actId="21"/>
          <ac:picMkLst>
            <pc:docMk/>
            <pc:sldMk cId="2945594372" sldId="256"/>
            <ac:picMk id="4" creationId="{3B849C7F-7815-C93B-5A3E-B5E9581AD11E}"/>
          </ac:picMkLst>
        </pc:picChg>
      </pc:sldChg>
      <pc:sldChg chg="addSp delSp modSp add del mod ord">
        <pc:chgData name="Mbambo, Gillian" userId="59bfad07-67e3-47a4-ac55-04ee0a07a20e" providerId="ADAL" clId="{689D5830-7D20-EF43-9790-B7D919905F98}" dt="2023-06-02T19:08:04.217" v="5219" actId="1035"/>
        <pc:sldMkLst>
          <pc:docMk/>
          <pc:sldMk cId="1564891502" sldId="257"/>
        </pc:sldMkLst>
        <pc:spChg chg="add mod">
          <ac:chgData name="Mbambo, Gillian" userId="59bfad07-67e3-47a4-ac55-04ee0a07a20e" providerId="ADAL" clId="{689D5830-7D20-EF43-9790-B7D919905F98}" dt="2023-06-02T18:23:11.846" v="4942"/>
          <ac:spMkLst>
            <pc:docMk/>
            <pc:sldMk cId="1564891502" sldId="257"/>
            <ac:spMk id="2" creationId="{00D967A1-55F5-4024-E911-89F2C44767E3}"/>
          </ac:spMkLst>
        </pc:spChg>
        <pc:spChg chg="add mod">
          <ac:chgData name="Mbambo, Gillian" userId="59bfad07-67e3-47a4-ac55-04ee0a07a20e" providerId="ADAL" clId="{689D5830-7D20-EF43-9790-B7D919905F98}" dt="2023-06-02T19:07:59.058" v="5209" actId="1035"/>
          <ac:spMkLst>
            <pc:docMk/>
            <pc:sldMk cId="1564891502" sldId="257"/>
            <ac:spMk id="2" creationId="{12D181FD-18EA-0077-2DC6-51B59BE05A0F}"/>
          </ac:spMkLst>
        </pc:spChg>
        <pc:spChg chg="add mod">
          <ac:chgData name="Mbambo, Gillian" userId="59bfad07-67e3-47a4-ac55-04ee0a07a20e" providerId="ADAL" clId="{689D5830-7D20-EF43-9790-B7D919905F98}" dt="2023-06-02T18:23:11.846" v="4942"/>
          <ac:spMkLst>
            <pc:docMk/>
            <pc:sldMk cId="1564891502" sldId="257"/>
            <ac:spMk id="3" creationId="{7E39BF56-90DF-0B2F-E287-D2EF54C0B1FF}"/>
          </ac:spMkLst>
        </pc:spChg>
        <pc:spChg chg="add mod">
          <ac:chgData name="Mbambo, Gillian" userId="59bfad07-67e3-47a4-ac55-04ee0a07a20e" providerId="ADAL" clId="{689D5830-7D20-EF43-9790-B7D919905F98}" dt="2023-06-02T19:08:04.217" v="5219" actId="1035"/>
          <ac:spMkLst>
            <pc:docMk/>
            <pc:sldMk cId="1564891502" sldId="257"/>
            <ac:spMk id="3" creationId="{F9ED38C2-1692-0A2F-6485-1AAB96664794}"/>
          </ac:spMkLst>
        </pc:spChg>
        <pc:spChg chg="add mod">
          <ac:chgData name="Mbambo, Gillian" userId="59bfad07-67e3-47a4-ac55-04ee0a07a20e" providerId="ADAL" clId="{689D5830-7D20-EF43-9790-B7D919905F98}" dt="2023-06-02T18:26:07.583" v="5016" actId="1038"/>
          <ac:spMkLst>
            <pc:docMk/>
            <pc:sldMk cId="1564891502" sldId="257"/>
            <ac:spMk id="4" creationId="{E227C4B1-FC64-3399-1DF1-2D5BF3338C89}"/>
          </ac:spMkLst>
        </pc:spChg>
        <pc:spChg chg="add mod">
          <ac:chgData name="Mbambo, Gillian" userId="59bfad07-67e3-47a4-ac55-04ee0a07a20e" providerId="ADAL" clId="{689D5830-7D20-EF43-9790-B7D919905F98}" dt="2023-06-02T19:06:54.486" v="5198" actId="1037"/>
          <ac:spMkLst>
            <pc:docMk/>
            <pc:sldMk cId="1564891502" sldId="257"/>
            <ac:spMk id="4" creationId="{E66006AE-8F9E-2383-CB78-2788D1B2897F}"/>
          </ac:spMkLst>
        </pc:spChg>
        <pc:spChg chg="del">
          <ac:chgData name="Mbambo, Gillian" userId="59bfad07-67e3-47a4-ac55-04ee0a07a20e" providerId="ADAL" clId="{689D5830-7D20-EF43-9790-B7D919905F98}" dt="2023-06-02T18:58:35.220" v="5049" actId="478"/>
          <ac:spMkLst>
            <pc:docMk/>
            <pc:sldMk cId="1564891502" sldId="257"/>
            <ac:spMk id="6" creationId="{068A65DE-EC4E-0676-831E-BD44CCE7BF65}"/>
          </ac:spMkLst>
        </pc:spChg>
        <pc:spChg chg="del mod">
          <ac:chgData name="Mbambo, Gillian" userId="59bfad07-67e3-47a4-ac55-04ee0a07a20e" providerId="ADAL" clId="{689D5830-7D20-EF43-9790-B7D919905F98}" dt="2023-06-02T19:01:49.169" v="5104" actId="1038"/>
          <ac:spMkLst>
            <pc:docMk/>
            <pc:sldMk cId="1564891502" sldId="257"/>
            <ac:spMk id="8" creationId="{A5DE4A7D-BE6F-ADD6-5AD3-8ADDED372D61}"/>
          </ac:spMkLst>
        </pc:spChg>
        <pc:spChg chg="del mod">
          <ac:chgData name="Mbambo, Gillian" userId="59bfad07-67e3-47a4-ac55-04ee0a07a20e" providerId="ADAL" clId="{689D5830-7D20-EF43-9790-B7D919905F98}" dt="2023-06-02T19:01:58.025" v="5107" actId="1037"/>
          <ac:spMkLst>
            <pc:docMk/>
            <pc:sldMk cId="1564891502" sldId="257"/>
            <ac:spMk id="9" creationId="{E0804241-31CC-77E2-4BF0-100392FA770F}"/>
          </ac:spMkLst>
        </pc:spChg>
        <pc:spChg chg="del mod">
          <ac:chgData name="Mbambo, Gillian" userId="59bfad07-67e3-47a4-ac55-04ee0a07a20e" providerId="ADAL" clId="{689D5830-7D20-EF43-9790-B7D919905F98}" dt="2023-06-02T19:01:53.256" v="5106" actId="1037"/>
          <ac:spMkLst>
            <pc:docMk/>
            <pc:sldMk cId="1564891502" sldId="257"/>
            <ac:spMk id="10" creationId="{BFB9F627-A09C-EF81-4586-06E2D3EC1F36}"/>
          </ac:spMkLst>
        </pc:spChg>
        <pc:spChg chg="add mod">
          <ac:chgData name="Mbambo, Gillian" userId="59bfad07-67e3-47a4-ac55-04ee0a07a20e" providerId="ADAL" clId="{689D5830-7D20-EF43-9790-B7D919905F98}" dt="2023-06-02T18:26:06.900" v="5015" actId="1076"/>
          <ac:spMkLst>
            <pc:docMk/>
            <pc:sldMk cId="1564891502" sldId="257"/>
            <ac:spMk id="11" creationId="{71A8B256-0C3E-E54C-5693-E4C107E93B9C}"/>
          </ac:spMkLst>
        </pc:spChg>
        <pc:spChg chg="add mod">
          <ac:chgData name="Mbambo, Gillian" userId="59bfad07-67e3-47a4-ac55-04ee0a07a20e" providerId="ADAL" clId="{689D5830-7D20-EF43-9790-B7D919905F98}" dt="2023-06-02T19:03:39.827" v="5145" actId="2711"/>
          <ac:spMkLst>
            <pc:docMk/>
            <pc:sldMk cId="1564891502" sldId="257"/>
            <ac:spMk id="11" creationId="{7F723A58-A182-3FEF-89B1-F1BAC8657166}"/>
          </ac:spMkLst>
        </pc:spChg>
        <pc:spChg chg="add del mod">
          <ac:chgData name="Mbambo, Gillian" userId="59bfad07-67e3-47a4-ac55-04ee0a07a20e" providerId="ADAL" clId="{689D5830-7D20-EF43-9790-B7D919905F98}" dt="2023-06-02T18:58:35.220" v="5049" actId="478"/>
          <ac:spMkLst>
            <pc:docMk/>
            <pc:sldMk cId="1564891502" sldId="257"/>
            <ac:spMk id="12" creationId="{AB3B5DCD-F8A4-32EC-FD9A-551C689A3A24}"/>
          </ac:spMkLst>
        </pc:spChg>
        <pc:spChg chg="add mod">
          <ac:chgData name="Mbambo, Gillian" userId="59bfad07-67e3-47a4-ac55-04ee0a07a20e" providerId="ADAL" clId="{689D5830-7D20-EF43-9790-B7D919905F98}" dt="2023-06-02T19:07:35.120" v="5202" actId="14100"/>
          <ac:spMkLst>
            <pc:docMk/>
            <pc:sldMk cId="1564891502" sldId="257"/>
            <ac:spMk id="12" creationId="{C7190826-3686-F638-E663-C601D373913F}"/>
          </ac:spMkLst>
        </pc:spChg>
        <pc:spChg chg="add del mod">
          <ac:chgData name="Mbambo, Gillian" userId="59bfad07-67e3-47a4-ac55-04ee0a07a20e" providerId="ADAL" clId="{689D5830-7D20-EF43-9790-B7D919905F98}" dt="2023-06-02T18:58:35.220" v="5049" actId="478"/>
          <ac:spMkLst>
            <pc:docMk/>
            <pc:sldMk cId="1564891502" sldId="257"/>
            <ac:spMk id="13" creationId="{1D0B9AD7-F8E6-08E9-AB88-27E5FEC27429}"/>
          </ac:spMkLst>
        </pc:spChg>
        <pc:spChg chg="add mod">
          <ac:chgData name="Mbambo, Gillian" userId="59bfad07-67e3-47a4-ac55-04ee0a07a20e" providerId="ADAL" clId="{689D5830-7D20-EF43-9790-B7D919905F98}" dt="2023-06-02T19:03:34.253" v="5143" actId="255"/>
          <ac:spMkLst>
            <pc:docMk/>
            <pc:sldMk cId="1564891502" sldId="257"/>
            <ac:spMk id="13" creationId="{B01E6BFE-7330-6BA6-9A2B-3E0E09CABD3A}"/>
          </ac:spMkLst>
        </pc:spChg>
        <pc:picChg chg="del">
          <ac:chgData name="Mbambo, Gillian" userId="59bfad07-67e3-47a4-ac55-04ee0a07a20e" providerId="ADAL" clId="{689D5830-7D20-EF43-9790-B7D919905F98}" dt="2023-06-02T18:58:35.220" v="5049" actId="478"/>
          <ac:picMkLst>
            <pc:docMk/>
            <pc:sldMk cId="1564891502" sldId="257"/>
            <ac:picMk id="5" creationId="{DF0F7BF9-AF81-143F-CFAB-CC328DC50505}"/>
          </ac:picMkLst>
        </pc:picChg>
        <pc:picChg chg="del mod">
          <ac:chgData name="Mbambo, Gillian" userId="59bfad07-67e3-47a4-ac55-04ee0a07a20e" providerId="ADAL" clId="{689D5830-7D20-EF43-9790-B7D919905F98}" dt="2023-06-02T19:00:52.816" v="5057" actId="1035"/>
          <ac:picMkLst>
            <pc:docMk/>
            <pc:sldMk cId="1564891502" sldId="257"/>
            <ac:picMk id="7" creationId="{3E60CF59-E7BF-FFDC-AF88-CE99CD0BF17F}"/>
          </ac:picMkLst>
        </pc:picChg>
      </pc:sldChg>
      <pc:sldChg chg="addSp modSp add del mod setBg">
        <pc:chgData name="Mbambo, Gillian" userId="59bfad07-67e3-47a4-ac55-04ee0a07a20e" providerId="ADAL" clId="{689D5830-7D20-EF43-9790-B7D919905F98}" dt="2023-06-02T20:05:39.622" v="5319" actId="2696"/>
        <pc:sldMkLst>
          <pc:docMk/>
          <pc:sldMk cId="4283033333" sldId="258"/>
        </pc:sldMkLst>
        <pc:spChg chg="add mod">
          <ac:chgData name="Mbambo, Gillian" userId="59bfad07-67e3-47a4-ac55-04ee0a07a20e" providerId="ADAL" clId="{689D5830-7D20-EF43-9790-B7D919905F98}" dt="2023-06-02T18:58:09.086" v="5047" actId="20577"/>
          <ac:spMkLst>
            <pc:docMk/>
            <pc:sldMk cId="4283033333" sldId="258"/>
            <ac:spMk id="3" creationId="{C5E12104-2AE9-A772-E03F-1CC7647F094F}"/>
          </ac:spMkLst>
        </pc:spChg>
        <pc:spChg chg="mod">
          <ac:chgData name="Mbambo, Gillian" userId="59bfad07-67e3-47a4-ac55-04ee0a07a20e" providerId="ADAL" clId="{689D5830-7D20-EF43-9790-B7D919905F98}" dt="2023-06-02T18:32:40.752" v="5037" actId="255"/>
          <ac:spMkLst>
            <pc:docMk/>
            <pc:sldMk cId="4283033333" sldId="258"/>
            <ac:spMk id="6" creationId="{723F3CC8-37F5-F505-22A3-F3332B2DFA61}"/>
          </ac:spMkLst>
        </pc:spChg>
      </pc:sldChg>
      <pc:sldChg chg="modSp add del mod ord">
        <pc:chgData name="Mbambo, Gillian" userId="59bfad07-67e3-47a4-ac55-04ee0a07a20e" providerId="ADAL" clId="{689D5830-7D20-EF43-9790-B7D919905F98}" dt="2023-06-02T19:08:34.709" v="5221" actId="2696"/>
        <pc:sldMkLst>
          <pc:docMk/>
          <pc:sldMk cId="2787644611" sldId="259"/>
        </pc:sldMkLst>
        <pc:spChg chg="mod">
          <ac:chgData name="Mbambo, Gillian" userId="59bfad07-67e3-47a4-ac55-04ee0a07a20e" providerId="ADAL" clId="{689D5830-7D20-EF43-9790-B7D919905F98}" dt="2023-06-02T18:32:50.666" v="5039" actId="2711"/>
          <ac:spMkLst>
            <pc:docMk/>
            <pc:sldMk cId="2787644611" sldId="259"/>
            <ac:spMk id="6" creationId="{723F3CC8-37F5-F505-22A3-F3332B2DFA61}"/>
          </ac:spMkLst>
        </pc:spChg>
        <pc:spChg chg="mod">
          <ac:chgData name="Mbambo, Gillian" userId="59bfad07-67e3-47a4-ac55-04ee0a07a20e" providerId="ADAL" clId="{689D5830-7D20-EF43-9790-B7D919905F98}" dt="2023-06-02T18:32:57.136" v="5041" actId="2711"/>
          <ac:spMkLst>
            <pc:docMk/>
            <pc:sldMk cId="2787644611" sldId="259"/>
            <ac:spMk id="7" creationId="{8F28BB0A-D9E9-5AAE-44CC-1C7F252513D4}"/>
          </ac:spMkLst>
        </pc:spChg>
      </pc:sldChg>
      <pc:sldChg chg="del">
        <pc:chgData name="Mbambo, Gillian" userId="59bfad07-67e3-47a4-ac55-04ee0a07a20e" providerId="ADAL" clId="{689D5830-7D20-EF43-9790-B7D919905F98}" dt="2023-05-23T22:31:34.735" v="286" actId="2696"/>
        <pc:sldMkLst>
          <pc:docMk/>
          <pc:sldMk cId="3466550413" sldId="268"/>
        </pc:sldMkLst>
      </pc:sldChg>
      <pc:sldChg chg="modSp mod">
        <pc:chgData name="Mbambo, Gillian" userId="59bfad07-67e3-47a4-ac55-04ee0a07a20e" providerId="ADAL" clId="{689D5830-7D20-EF43-9790-B7D919905F98}" dt="2023-05-29T02:17:02.014" v="4606" actId="1035"/>
        <pc:sldMkLst>
          <pc:docMk/>
          <pc:sldMk cId="1970521506" sldId="297"/>
        </pc:sldMkLst>
        <pc:spChg chg="mod">
          <ac:chgData name="Mbambo, Gillian" userId="59bfad07-67e3-47a4-ac55-04ee0a07a20e" providerId="ADAL" clId="{689D5830-7D20-EF43-9790-B7D919905F98}" dt="2023-05-29T02:17:02.014" v="4606" actId="1035"/>
          <ac:spMkLst>
            <pc:docMk/>
            <pc:sldMk cId="1970521506" sldId="297"/>
            <ac:spMk id="6" creationId="{EC332DDA-D866-DABD-82CA-F4DD1119C2FA}"/>
          </ac:spMkLst>
        </pc:spChg>
        <pc:picChg chg="mod">
          <ac:chgData name="Mbambo, Gillian" userId="59bfad07-67e3-47a4-ac55-04ee0a07a20e" providerId="ADAL" clId="{689D5830-7D20-EF43-9790-B7D919905F98}" dt="2023-05-29T02:17:02.014" v="4606" actId="1035"/>
          <ac:picMkLst>
            <pc:docMk/>
            <pc:sldMk cId="1970521506" sldId="297"/>
            <ac:picMk id="3" creationId="{6EA82A93-BB53-954C-EA9B-00EE352FD89D}"/>
          </ac:picMkLst>
        </pc:picChg>
        <pc:picChg chg="mod">
          <ac:chgData name="Mbambo, Gillian" userId="59bfad07-67e3-47a4-ac55-04ee0a07a20e" providerId="ADAL" clId="{689D5830-7D20-EF43-9790-B7D919905F98}" dt="2023-05-29T02:17:02.014" v="4606" actId="1035"/>
          <ac:picMkLst>
            <pc:docMk/>
            <pc:sldMk cId="1970521506" sldId="297"/>
            <ac:picMk id="4" creationId="{BF7AD93F-A5DE-38F7-9301-AF3F1A9AD729}"/>
          </ac:picMkLst>
        </pc:picChg>
      </pc:sldChg>
      <pc:sldChg chg="addSp delSp modSp mod">
        <pc:chgData name="Mbambo, Gillian" userId="59bfad07-67e3-47a4-ac55-04ee0a07a20e" providerId="ADAL" clId="{689D5830-7D20-EF43-9790-B7D919905F98}" dt="2023-06-05T13:08:14.017" v="5647" actId="1036"/>
        <pc:sldMkLst>
          <pc:docMk/>
          <pc:sldMk cId="1049619716" sldId="299"/>
        </pc:sldMkLst>
        <pc:spChg chg="mod">
          <ac:chgData name="Mbambo, Gillian" userId="59bfad07-67e3-47a4-ac55-04ee0a07a20e" providerId="ADAL" clId="{689D5830-7D20-EF43-9790-B7D919905F98}" dt="2023-05-29T00:46:22.176" v="4529" actId="14100"/>
          <ac:spMkLst>
            <pc:docMk/>
            <pc:sldMk cId="1049619716" sldId="299"/>
            <ac:spMk id="2" creationId="{63A0FA2C-408D-794F-9B92-81C103CEC3CB}"/>
          </ac:spMkLst>
        </pc:spChg>
        <pc:spChg chg="mod">
          <ac:chgData name="Mbambo, Gillian" userId="59bfad07-67e3-47a4-ac55-04ee0a07a20e" providerId="ADAL" clId="{689D5830-7D20-EF43-9790-B7D919905F98}" dt="2023-06-05T13:08:14.017" v="5647" actId="1036"/>
          <ac:spMkLst>
            <pc:docMk/>
            <pc:sldMk cId="1049619716" sldId="299"/>
            <ac:spMk id="3" creationId="{2061C523-55C1-671F-647A-230B07659C74}"/>
          </ac:spMkLst>
        </pc:spChg>
        <pc:spChg chg="add del mod">
          <ac:chgData name="Mbambo, Gillian" userId="59bfad07-67e3-47a4-ac55-04ee0a07a20e" providerId="ADAL" clId="{689D5830-7D20-EF43-9790-B7D919905F98}" dt="2023-06-05T13:08:03.148" v="5640" actId="478"/>
          <ac:spMkLst>
            <pc:docMk/>
            <pc:sldMk cId="1049619716" sldId="299"/>
            <ac:spMk id="4" creationId="{3F442F5D-2C43-83FB-7808-E7FBFA0400A4}"/>
          </ac:spMkLst>
        </pc:spChg>
        <pc:spChg chg="del">
          <ac:chgData name="Mbambo, Gillian" userId="59bfad07-67e3-47a4-ac55-04ee0a07a20e" providerId="ADAL" clId="{689D5830-7D20-EF43-9790-B7D919905F98}" dt="2023-05-26T20:34:17.603" v="1721" actId="478"/>
          <ac:spMkLst>
            <pc:docMk/>
            <pc:sldMk cId="1049619716" sldId="299"/>
            <ac:spMk id="4" creationId="{62690187-CF85-5E15-0A42-7B5B9C90D625}"/>
          </ac:spMkLst>
        </pc:spChg>
        <pc:spChg chg="add del mod">
          <ac:chgData name="Mbambo, Gillian" userId="59bfad07-67e3-47a4-ac55-04ee0a07a20e" providerId="ADAL" clId="{689D5830-7D20-EF43-9790-B7D919905F98}" dt="2023-05-29T00:46:06.182" v="4517" actId="478"/>
          <ac:spMkLst>
            <pc:docMk/>
            <pc:sldMk cId="1049619716" sldId="299"/>
            <ac:spMk id="5" creationId="{27B79009-119E-BC01-357C-35ABF07CDED3}"/>
          </ac:spMkLst>
        </pc:spChg>
        <pc:spChg chg="mod">
          <ac:chgData name="Mbambo, Gillian" userId="59bfad07-67e3-47a4-ac55-04ee0a07a20e" providerId="ADAL" clId="{689D5830-7D20-EF43-9790-B7D919905F98}" dt="2023-05-29T00:46:16.841" v="4528" actId="1035"/>
          <ac:spMkLst>
            <pc:docMk/>
            <pc:sldMk cId="1049619716" sldId="299"/>
            <ac:spMk id="7" creationId="{A08A52BD-B551-5BF6-91E4-93D35149BE3C}"/>
          </ac:spMkLst>
        </pc:spChg>
        <pc:spChg chg="mod">
          <ac:chgData name="Mbambo, Gillian" userId="59bfad07-67e3-47a4-ac55-04ee0a07a20e" providerId="ADAL" clId="{689D5830-7D20-EF43-9790-B7D919905F98}" dt="2023-06-05T13:08:14.017" v="5647" actId="1036"/>
          <ac:spMkLst>
            <pc:docMk/>
            <pc:sldMk cId="1049619716" sldId="299"/>
            <ac:spMk id="9" creationId="{DA6F901F-0846-6C41-6FE6-2C4ED3C553CD}"/>
          </ac:spMkLst>
        </pc:spChg>
        <pc:spChg chg="mod">
          <ac:chgData name="Mbambo, Gillian" userId="59bfad07-67e3-47a4-ac55-04ee0a07a20e" providerId="ADAL" clId="{689D5830-7D20-EF43-9790-B7D919905F98}" dt="2023-06-05T13:08:14.017" v="5647" actId="1036"/>
          <ac:spMkLst>
            <pc:docMk/>
            <pc:sldMk cId="1049619716" sldId="299"/>
            <ac:spMk id="10" creationId="{9092F6FD-6FB9-7E06-FCCF-C0DF104AB7CA}"/>
          </ac:spMkLst>
        </pc:spChg>
        <pc:spChg chg="mod">
          <ac:chgData name="Mbambo, Gillian" userId="59bfad07-67e3-47a4-ac55-04ee0a07a20e" providerId="ADAL" clId="{689D5830-7D20-EF43-9790-B7D919905F98}" dt="2023-06-05T13:08:14.017" v="5647" actId="1036"/>
          <ac:spMkLst>
            <pc:docMk/>
            <pc:sldMk cId="1049619716" sldId="299"/>
            <ac:spMk id="11" creationId="{A4F97F60-973D-81BF-82BF-28F8F09BC1BC}"/>
          </ac:spMkLst>
        </pc:spChg>
        <pc:spChg chg="mod">
          <ac:chgData name="Mbambo, Gillian" userId="59bfad07-67e3-47a4-ac55-04ee0a07a20e" providerId="ADAL" clId="{689D5830-7D20-EF43-9790-B7D919905F98}" dt="2023-05-29T00:46:16.841" v="4528" actId="1035"/>
          <ac:spMkLst>
            <pc:docMk/>
            <pc:sldMk cId="1049619716" sldId="299"/>
            <ac:spMk id="20" creationId="{523CA850-6170-65E2-DA61-42B88B73CE7D}"/>
          </ac:spMkLst>
        </pc:spChg>
        <pc:spChg chg="mod">
          <ac:chgData name="Mbambo, Gillian" userId="59bfad07-67e3-47a4-ac55-04ee0a07a20e" providerId="ADAL" clId="{689D5830-7D20-EF43-9790-B7D919905F98}" dt="2023-05-29T00:46:16.841" v="4528" actId="1035"/>
          <ac:spMkLst>
            <pc:docMk/>
            <pc:sldMk cId="1049619716" sldId="299"/>
            <ac:spMk id="21" creationId="{74BA66AA-0EDC-D82E-5A91-00C6176DDE61}"/>
          </ac:spMkLst>
        </pc:spChg>
        <pc:spChg chg="mod">
          <ac:chgData name="Mbambo, Gillian" userId="59bfad07-67e3-47a4-ac55-04ee0a07a20e" providerId="ADAL" clId="{689D5830-7D20-EF43-9790-B7D919905F98}" dt="2023-05-29T00:46:16.841" v="4528" actId="1035"/>
          <ac:spMkLst>
            <pc:docMk/>
            <pc:sldMk cId="1049619716" sldId="299"/>
            <ac:spMk id="23" creationId="{60E77140-CE05-7221-FDE6-E7759F5AA39C}"/>
          </ac:spMkLst>
        </pc:spChg>
        <pc:spChg chg="mod">
          <ac:chgData name="Mbambo, Gillian" userId="59bfad07-67e3-47a4-ac55-04ee0a07a20e" providerId="ADAL" clId="{689D5830-7D20-EF43-9790-B7D919905F98}" dt="2023-05-29T00:46:16.841" v="4528" actId="1035"/>
          <ac:spMkLst>
            <pc:docMk/>
            <pc:sldMk cId="1049619716" sldId="299"/>
            <ac:spMk id="24" creationId="{E08D4DF6-6EBF-7B2F-F223-0577CD9D137B}"/>
          </ac:spMkLst>
        </pc:spChg>
        <pc:spChg chg="mod">
          <ac:chgData name="Mbambo, Gillian" userId="59bfad07-67e3-47a4-ac55-04ee0a07a20e" providerId="ADAL" clId="{689D5830-7D20-EF43-9790-B7D919905F98}" dt="2023-05-29T00:46:16.841" v="4528" actId="1035"/>
          <ac:spMkLst>
            <pc:docMk/>
            <pc:sldMk cId="1049619716" sldId="299"/>
            <ac:spMk id="25" creationId="{A25E5A74-1151-00D1-7075-7B116CB35759}"/>
          </ac:spMkLst>
        </pc:spChg>
        <pc:spChg chg="mod">
          <ac:chgData name="Mbambo, Gillian" userId="59bfad07-67e3-47a4-ac55-04ee0a07a20e" providerId="ADAL" clId="{689D5830-7D20-EF43-9790-B7D919905F98}" dt="2023-05-29T00:46:16.841" v="4528" actId="1035"/>
          <ac:spMkLst>
            <pc:docMk/>
            <pc:sldMk cId="1049619716" sldId="299"/>
            <ac:spMk id="26" creationId="{60BF68DF-1752-985C-7FC7-FCE0744FCA23}"/>
          </ac:spMkLst>
        </pc:spChg>
        <pc:spChg chg="mod">
          <ac:chgData name="Mbambo, Gillian" userId="59bfad07-67e3-47a4-ac55-04ee0a07a20e" providerId="ADAL" clId="{689D5830-7D20-EF43-9790-B7D919905F98}" dt="2023-05-29T00:46:16.841" v="4528" actId="1035"/>
          <ac:spMkLst>
            <pc:docMk/>
            <pc:sldMk cId="1049619716" sldId="299"/>
            <ac:spMk id="28" creationId="{57B956F4-3E75-8795-6DDA-7230CA22ED11}"/>
          </ac:spMkLst>
        </pc:spChg>
        <pc:spChg chg="mod">
          <ac:chgData name="Mbambo, Gillian" userId="59bfad07-67e3-47a4-ac55-04ee0a07a20e" providerId="ADAL" clId="{689D5830-7D20-EF43-9790-B7D919905F98}" dt="2023-05-29T00:46:16.841" v="4528" actId="1035"/>
          <ac:spMkLst>
            <pc:docMk/>
            <pc:sldMk cId="1049619716" sldId="299"/>
            <ac:spMk id="29" creationId="{06F03243-8DEE-AE80-7CF7-7AAAE71000EF}"/>
          </ac:spMkLst>
        </pc:spChg>
        <pc:spChg chg="mod">
          <ac:chgData name="Mbambo, Gillian" userId="59bfad07-67e3-47a4-ac55-04ee0a07a20e" providerId="ADAL" clId="{689D5830-7D20-EF43-9790-B7D919905F98}" dt="2023-05-29T00:46:16.841" v="4528" actId="1035"/>
          <ac:spMkLst>
            <pc:docMk/>
            <pc:sldMk cId="1049619716" sldId="299"/>
            <ac:spMk id="30" creationId="{F32F784D-527E-BDF7-909D-6520B5285CE6}"/>
          </ac:spMkLst>
        </pc:spChg>
        <pc:spChg chg="mod">
          <ac:chgData name="Mbambo, Gillian" userId="59bfad07-67e3-47a4-ac55-04ee0a07a20e" providerId="ADAL" clId="{689D5830-7D20-EF43-9790-B7D919905F98}" dt="2023-05-29T00:46:16.841" v="4528" actId="1035"/>
          <ac:spMkLst>
            <pc:docMk/>
            <pc:sldMk cId="1049619716" sldId="299"/>
            <ac:spMk id="31" creationId="{2AC12AA2-438D-276A-9492-F4DB4776D3EE}"/>
          </ac:spMkLst>
        </pc:spChg>
        <pc:spChg chg="mod">
          <ac:chgData name="Mbambo, Gillian" userId="59bfad07-67e3-47a4-ac55-04ee0a07a20e" providerId="ADAL" clId="{689D5830-7D20-EF43-9790-B7D919905F98}" dt="2023-05-29T00:46:16.841" v="4528" actId="1035"/>
          <ac:spMkLst>
            <pc:docMk/>
            <pc:sldMk cId="1049619716" sldId="299"/>
            <ac:spMk id="32" creationId="{2103EBC6-0CFC-6FD6-A001-1950B40D3A43}"/>
          </ac:spMkLst>
        </pc:spChg>
        <pc:spChg chg="mod">
          <ac:chgData name="Mbambo, Gillian" userId="59bfad07-67e3-47a4-ac55-04ee0a07a20e" providerId="ADAL" clId="{689D5830-7D20-EF43-9790-B7D919905F98}" dt="2023-05-29T00:46:16.841" v="4528" actId="1035"/>
          <ac:spMkLst>
            <pc:docMk/>
            <pc:sldMk cId="1049619716" sldId="299"/>
            <ac:spMk id="33" creationId="{42462042-95D2-BBAD-710A-69B00AB4E1D7}"/>
          </ac:spMkLst>
        </pc:spChg>
        <pc:spChg chg="mod">
          <ac:chgData name="Mbambo, Gillian" userId="59bfad07-67e3-47a4-ac55-04ee0a07a20e" providerId="ADAL" clId="{689D5830-7D20-EF43-9790-B7D919905F98}" dt="2023-05-29T00:46:16.841" v="4528" actId="1035"/>
          <ac:spMkLst>
            <pc:docMk/>
            <pc:sldMk cId="1049619716" sldId="299"/>
            <ac:spMk id="34" creationId="{91583C43-0007-B5A5-F7C1-7DFC2DBF83BE}"/>
          </ac:spMkLst>
        </pc:spChg>
        <pc:spChg chg="mod">
          <ac:chgData name="Mbambo, Gillian" userId="59bfad07-67e3-47a4-ac55-04ee0a07a20e" providerId="ADAL" clId="{689D5830-7D20-EF43-9790-B7D919905F98}" dt="2023-05-29T00:46:16.841" v="4528" actId="1035"/>
          <ac:spMkLst>
            <pc:docMk/>
            <pc:sldMk cId="1049619716" sldId="299"/>
            <ac:spMk id="35" creationId="{99658F24-C193-42B8-5607-A2A65AC61055}"/>
          </ac:spMkLst>
        </pc:spChg>
        <pc:spChg chg="mod">
          <ac:chgData name="Mbambo, Gillian" userId="59bfad07-67e3-47a4-ac55-04ee0a07a20e" providerId="ADAL" clId="{689D5830-7D20-EF43-9790-B7D919905F98}" dt="2023-05-29T00:46:16.841" v="4528" actId="1035"/>
          <ac:spMkLst>
            <pc:docMk/>
            <pc:sldMk cId="1049619716" sldId="299"/>
            <ac:spMk id="36" creationId="{AC66CD19-CC85-771F-EBB1-DA9E923FCC59}"/>
          </ac:spMkLst>
        </pc:spChg>
        <pc:spChg chg="mod">
          <ac:chgData name="Mbambo, Gillian" userId="59bfad07-67e3-47a4-ac55-04ee0a07a20e" providerId="ADAL" clId="{689D5830-7D20-EF43-9790-B7D919905F98}" dt="2023-05-29T00:46:16.841" v="4528" actId="1035"/>
          <ac:spMkLst>
            <pc:docMk/>
            <pc:sldMk cId="1049619716" sldId="299"/>
            <ac:spMk id="37" creationId="{D510343C-BFD5-8364-8FBF-689143DB1A4A}"/>
          </ac:spMkLst>
        </pc:spChg>
        <pc:graphicFrameChg chg="mod">
          <ac:chgData name="Mbambo, Gillian" userId="59bfad07-67e3-47a4-ac55-04ee0a07a20e" providerId="ADAL" clId="{689D5830-7D20-EF43-9790-B7D919905F98}" dt="2023-05-29T00:46:16.841" v="4528" actId="1035"/>
          <ac:graphicFrameMkLst>
            <pc:docMk/>
            <pc:sldMk cId="1049619716" sldId="299"/>
            <ac:graphicFrameMk id="27" creationId="{6AB445C7-29F2-1632-7FFF-F3B00FA9D7B6}"/>
          </ac:graphicFrameMkLst>
        </pc:graphicFrameChg>
        <pc:cxnChg chg="mod">
          <ac:chgData name="Mbambo, Gillian" userId="59bfad07-67e3-47a4-ac55-04ee0a07a20e" providerId="ADAL" clId="{689D5830-7D20-EF43-9790-B7D919905F98}" dt="2023-05-29T00:46:16.841" v="4528" actId="1035"/>
          <ac:cxnSpMkLst>
            <pc:docMk/>
            <pc:sldMk cId="1049619716" sldId="299"/>
            <ac:cxnSpMk id="6" creationId="{66360664-8CBF-8015-EDA2-E3A1C1E7B0C7}"/>
          </ac:cxnSpMkLst>
        </pc:cxnChg>
        <pc:cxnChg chg="mod">
          <ac:chgData name="Mbambo, Gillian" userId="59bfad07-67e3-47a4-ac55-04ee0a07a20e" providerId="ADAL" clId="{689D5830-7D20-EF43-9790-B7D919905F98}" dt="2023-06-05T13:08:14.017" v="5647" actId="1036"/>
          <ac:cxnSpMkLst>
            <pc:docMk/>
            <pc:sldMk cId="1049619716" sldId="299"/>
            <ac:cxnSpMk id="12" creationId="{F0A88F1F-9A39-9C94-25B8-E6ACF8F877D4}"/>
          </ac:cxnSpMkLst>
        </pc:cxnChg>
        <pc:cxnChg chg="mod">
          <ac:chgData name="Mbambo, Gillian" userId="59bfad07-67e3-47a4-ac55-04ee0a07a20e" providerId="ADAL" clId="{689D5830-7D20-EF43-9790-B7D919905F98}" dt="2023-06-05T13:08:14.017" v="5647" actId="1036"/>
          <ac:cxnSpMkLst>
            <pc:docMk/>
            <pc:sldMk cId="1049619716" sldId="299"/>
            <ac:cxnSpMk id="16" creationId="{C7401AC4-DD4D-70DF-DBE4-A4660780FE06}"/>
          </ac:cxnSpMkLst>
        </pc:cxnChg>
        <pc:cxnChg chg="mod">
          <ac:chgData name="Mbambo, Gillian" userId="59bfad07-67e3-47a4-ac55-04ee0a07a20e" providerId="ADAL" clId="{689D5830-7D20-EF43-9790-B7D919905F98}" dt="2023-06-05T13:08:14.017" v="5647" actId="1036"/>
          <ac:cxnSpMkLst>
            <pc:docMk/>
            <pc:sldMk cId="1049619716" sldId="299"/>
            <ac:cxnSpMk id="39" creationId="{538CE716-A411-DF48-25D3-AC1EE62FAC0B}"/>
          </ac:cxnSpMkLst>
        </pc:cxnChg>
        <pc:cxnChg chg="mod">
          <ac:chgData name="Mbambo, Gillian" userId="59bfad07-67e3-47a4-ac55-04ee0a07a20e" providerId="ADAL" clId="{689D5830-7D20-EF43-9790-B7D919905F98}" dt="2023-06-05T13:08:14.017" v="5647" actId="1036"/>
          <ac:cxnSpMkLst>
            <pc:docMk/>
            <pc:sldMk cId="1049619716" sldId="299"/>
            <ac:cxnSpMk id="40" creationId="{AC1303C9-76B4-AE4C-E66E-E003E63B6C2A}"/>
          </ac:cxnSpMkLst>
        </pc:cxnChg>
        <pc:cxnChg chg="mod">
          <ac:chgData name="Mbambo, Gillian" userId="59bfad07-67e3-47a4-ac55-04ee0a07a20e" providerId="ADAL" clId="{689D5830-7D20-EF43-9790-B7D919905F98}" dt="2023-06-05T13:08:14.017" v="5647" actId="1036"/>
          <ac:cxnSpMkLst>
            <pc:docMk/>
            <pc:sldMk cId="1049619716" sldId="299"/>
            <ac:cxnSpMk id="41" creationId="{6DE5DA54-A458-3D55-23FD-83DAD0D0BA7D}"/>
          </ac:cxnSpMkLst>
        </pc:cxnChg>
      </pc:sldChg>
      <pc:sldChg chg="addSp delSp modSp mod">
        <pc:chgData name="Mbambo, Gillian" userId="59bfad07-67e3-47a4-ac55-04ee0a07a20e" providerId="ADAL" clId="{689D5830-7D20-EF43-9790-B7D919905F98}" dt="2023-06-02T18:31:58.876" v="5033" actId="2711"/>
        <pc:sldMkLst>
          <pc:docMk/>
          <pc:sldMk cId="931761805" sldId="300"/>
        </pc:sldMkLst>
        <pc:spChg chg="add mod">
          <ac:chgData name="Mbambo, Gillian" userId="59bfad07-67e3-47a4-ac55-04ee0a07a20e" providerId="ADAL" clId="{689D5830-7D20-EF43-9790-B7D919905F98}" dt="2023-05-29T02:17:59.764" v="4618" actId="1035"/>
          <ac:spMkLst>
            <pc:docMk/>
            <pc:sldMk cId="931761805" sldId="300"/>
            <ac:spMk id="2" creationId="{0CB9DC00-A33C-9E05-1D2A-D59731784AD7}"/>
          </ac:spMkLst>
        </pc:spChg>
        <pc:spChg chg="mod">
          <ac:chgData name="Mbambo, Gillian" userId="59bfad07-67e3-47a4-ac55-04ee0a07a20e" providerId="ADAL" clId="{689D5830-7D20-EF43-9790-B7D919905F98}" dt="2023-05-29T02:18:09.629" v="4635" actId="1035"/>
          <ac:spMkLst>
            <pc:docMk/>
            <pc:sldMk cId="931761805" sldId="300"/>
            <ac:spMk id="3" creationId="{71C6125A-E93E-79A8-1055-6470D226D815}"/>
          </ac:spMkLst>
        </pc:spChg>
        <pc:spChg chg="mod">
          <ac:chgData name="Mbambo, Gillian" userId="59bfad07-67e3-47a4-ac55-04ee0a07a20e" providerId="ADAL" clId="{689D5830-7D20-EF43-9790-B7D919905F98}" dt="2023-06-02T18:31:51.461" v="5031" actId="255"/>
          <ac:spMkLst>
            <pc:docMk/>
            <pc:sldMk cId="931761805" sldId="300"/>
            <ac:spMk id="8" creationId="{B5B048C4-976B-3457-4653-27F71052E273}"/>
          </ac:spMkLst>
        </pc:spChg>
        <pc:spChg chg="add mod">
          <ac:chgData name="Mbambo, Gillian" userId="59bfad07-67e3-47a4-ac55-04ee0a07a20e" providerId="ADAL" clId="{689D5830-7D20-EF43-9790-B7D919905F98}" dt="2023-05-29T02:17:59.764" v="4618" actId="1035"/>
          <ac:spMkLst>
            <pc:docMk/>
            <pc:sldMk cId="931761805" sldId="300"/>
            <ac:spMk id="11" creationId="{0B4F264E-4B6F-1FF4-F7D6-BA78B48C54F4}"/>
          </ac:spMkLst>
        </pc:spChg>
        <pc:spChg chg="add mod">
          <ac:chgData name="Mbambo, Gillian" userId="59bfad07-67e3-47a4-ac55-04ee0a07a20e" providerId="ADAL" clId="{689D5830-7D20-EF43-9790-B7D919905F98}" dt="2023-06-02T18:31:58.876" v="5033" actId="2711"/>
          <ac:spMkLst>
            <pc:docMk/>
            <pc:sldMk cId="931761805" sldId="300"/>
            <ac:spMk id="13" creationId="{20DE4E0F-70DD-1015-F60F-F4B4B556C23A}"/>
          </ac:spMkLst>
        </pc:spChg>
        <pc:graphicFrameChg chg="add del mod">
          <ac:chgData name="Mbambo, Gillian" userId="59bfad07-67e3-47a4-ac55-04ee0a07a20e" providerId="ADAL" clId="{689D5830-7D20-EF43-9790-B7D919905F98}" dt="2023-05-23T21:38:25.901" v="41" actId="478"/>
          <ac:graphicFrameMkLst>
            <pc:docMk/>
            <pc:sldMk cId="931761805" sldId="300"/>
            <ac:graphicFrameMk id="4" creationId="{E5DE64BF-DFCF-0C7E-A2B7-8706B8875B74}"/>
          </ac:graphicFrameMkLst>
        </pc:graphicFrameChg>
        <pc:picChg chg="del">
          <ac:chgData name="Mbambo, Gillian" userId="59bfad07-67e3-47a4-ac55-04ee0a07a20e" providerId="ADAL" clId="{689D5830-7D20-EF43-9790-B7D919905F98}" dt="2023-05-27T02:20:33.148" v="2530" actId="478"/>
          <ac:picMkLst>
            <pc:docMk/>
            <pc:sldMk cId="931761805" sldId="300"/>
            <ac:picMk id="5" creationId="{AF2EB61D-20BC-9949-CD3B-AFB6872C7E64}"/>
          </ac:picMkLst>
        </pc:picChg>
        <pc:picChg chg="mod">
          <ac:chgData name="Mbambo, Gillian" userId="59bfad07-67e3-47a4-ac55-04ee0a07a20e" providerId="ADAL" clId="{689D5830-7D20-EF43-9790-B7D919905F98}" dt="2023-05-29T02:17:59.764" v="4618" actId="1035"/>
          <ac:picMkLst>
            <pc:docMk/>
            <pc:sldMk cId="931761805" sldId="300"/>
            <ac:picMk id="6" creationId="{E1964A91-1D9F-6418-4A95-45F84D2C4C25}"/>
          </ac:picMkLst>
        </pc:picChg>
        <pc:picChg chg="add mod">
          <ac:chgData name="Mbambo, Gillian" userId="59bfad07-67e3-47a4-ac55-04ee0a07a20e" providerId="ADAL" clId="{689D5830-7D20-EF43-9790-B7D919905F98}" dt="2023-05-29T02:17:59.764" v="4618" actId="1035"/>
          <ac:picMkLst>
            <pc:docMk/>
            <pc:sldMk cId="931761805" sldId="300"/>
            <ac:picMk id="10" creationId="{CF7BE7C6-1332-2986-2E9B-C3B06906CC46}"/>
          </ac:picMkLst>
        </pc:picChg>
        <pc:picChg chg="add mod">
          <ac:chgData name="Mbambo, Gillian" userId="59bfad07-67e3-47a4-ac55-04ee0a07a20e" providerId="ADAL" clId="{689D5830-7D20-EF43-9790-B7D919905F98}" dt="2023-05-29T02:17:59.764" v="4618" actId="1035"/>
          <ac:picMkLst>
            <pc:docMk/>
            <pc:sldMk cId="931761805" sldId="300"/>
            <ac:picMk id="12" creationId="{8B1469A2-0162-BD45-4A6D-79DF1C76B071}"/>
          </ac:picMkLst>
        </pc:picChg>
      </pc:sldChg>
      <pc:sldChg chg="modSp mod">
        <pc:chgData name="Mbambo, Gillian" userId="59bfad07-67e3-47a4-ac55-04ee0a07a20e" providerId="ADAL" clId="{689D5830-7D20-EF43-9790-B7D919905F98}" dt="2023-05-29T02:15:04.711" v="4563" actId="20577"/>
        <pc:sldMkLst>
          <pc:docMk/>
          <pc:sldMk cId="1799949073" sldId="305"/>
        </pc:sldMkLst>
        <pc:spChg chg="mod">
          <ac:chgData name="Mbambo, Gillian" userId="59bfad07-67e3-47a4-ac55-04ee0a07a20e" providerId="ADAL" clId="{689D5830-7D20-EF43-9790-B7D919905F98}" dt="2023-05-29T02:14:55.498" v="4557" actId="20577"/>
          <ac:spMkLst>
            <pc:docMk/>
            <pc:sldMk cId="1799949073" sldId="305"/>
            <ac:spMk id="4" creationId="{370BBE70-B005-07CE-8F07-112200FFAF72}"/>
          </ac:spMkLst>
        </pc:spChg>
        <pc:spChg chg="mod">
          <ac:chgData name="Mbambo, Gillian" userId="59bfad07-67e3-47a4-ac55-04ee0a07a20e" providerId="ADAL" clId="{689D5830-7D20-EF43-9790-B7D919905F98}" dt="2023-05-29T02:15:02.650" v="4561" actId="20577"/>
          <ac:spMkLst>
            <pc:docMk/>
            <pc:sldMk cId="1799949073" sldId="305"/>
            <ac:spMk id="5" creationId="{B8D80A98-FB77-032E-1D4C-20971115B607}"/>
          </ac:spMkLst>
        </pc:spChg>
        <pc:spChg chg="mod">
          <ac:chgData name="Mbambo, Gillian" userId="59bfad07-67e3-47a4-ac55-04ee0a07a20e" providerId="ADAL" clId="{689D5830-7D20-EF43-9790-B7D919905F98}" dt="2023-05-29T02:15:04.711" v="4563" actId="20577"/>
          <ac:spMkLst>
            <pc:docMk/>
            <pc:sldMk cId="1799949073" sldId="305"/>
            <ac:spMk id="8" creationId="{164D787A-1F90-283F-C1E8-9684A8657403}"/>
          </ac:spMkLst>
        </pc:spChg>
        <pc:spChg chg="mod">
          <ac:chgData name="Mbambo, Gillian" userId="59bfad07-67e3-47a4-ac55-04ee0a07a20e" providerId="ADAL" clId="{689D5830-7D20-EF43-9790-B7D919905F98}" dt="2023-05-29T02:14:59.890" v="4559" actId="20577"/>
          <ac:spMkLst>
            <pc:docMk/>
            <pc:sldMk cId="1799949073" sldId="305"/>
            <ac:spMk id="9" creationId="{9F2B83CC-013D-0F09-E3B9-97C30067C1EA}"/>
          </ac:spMkLst>
        </pc:spChg>
      </pc:sldChg>
      <pc:sldChg chg="addSp delSp modSp mod">
        <pc:chgData name="Mbambo, Gillian" userId="59bfad07-67e3-47a4-ac55-04ee0a07a20e" providerId="ADAL" clId="{689D5830-7D20-EF43-9790-B7D919905F98}" dt="2023-06-02T18:58:02.743" v="5045"/>
        <pc:sldMkLst>
          <pc:docMk/>
          <pc:sldMk cId="1069009606" sldId="307"/>
        </pc:sldMkLst>
        <pc:spChg chg="add del mod">
          <ac:chgData name="Mbambo, Gillian" userId="59bfad07-67e3-47a4-ac55-04ee0a07a20e" providerId="ADAL" clId="{689D5830-7D20-EF43-9790-B7D919905F98}" dt="2023-06-02T18:58:02.743" v="5045"/>
          <ac:spMkLst>
            <pc:docMk/>
            <pc:sldMk cId="1069009606" sldId="307"/>
            <ac:spMk id="2" creationId="{6EF30C1B-4C91-FFDC-36E0-956E84730F56}"/>
          </ac:spMkLst>
        </pc:spChg>
        <pc:spChg chg="mod">
          <ac:chgData name="Mbambo, Gillian" userId="59bfad07-67e3-47a4-ac55-04ee0a07a20e" providerId="ADAL" clId="{689D5830-7D20-EF43-9790-B7D919905F98}" dt="2023-05-25T20:47:24.945" v="1355" actId="20577"/>
          <ac:spMkLst>
            <pc:docMk/>
            <pc:sldMk cId="1069009606" sldId="307"/>
            <ac:spMk id="6" creationId="{31784ECF-8C7A-6FC9-5EE3-EC1798A7E9C2}"/>
          </ac:spMkLst>
        </pc:spChg>
        <pc:spChg chg="add mod">
          <ac:chgData name="Mbambo, Gillian" userId="59bfad07-67e3-47a4-ac55-04ee0a07a20e" providerId="ADAL" clId="{689D5830-7D20-EF43-9790-B7D919905F98}" dt="2023-06-02T18:32:08.875" v="5035" actId="2711"/>
          <ac:spMkLst>
            <pc:docMk/>
            <pc:sldMk cId="1069009606" sldId="307"/>
            <ac:spMk id="7" creationId="{C99B25CD-E89D-431F-BD35-EB0B242135D6}"/>
          </ac:spMkLst>
        </pc:spChg>
        <pc:spChg chg="del">
          <ac:chgData name="Mbambo, Gillian" userId="59bfad07-67e3-47a4-ac55-04ee0a07a20e" providerId="ADAL" clId="{689D5830-7D20-EF43-9790-B7D919905F98}" dt="2023-05-25T19:33:54.732" v="1207" actId="478"/>
          <ac:spMkLst>
            <pc:docMk/>
            <pc:sldMk cId="1069009606" sldId="307"/>
            <ac:spMk id="10" creationId="{AA873B5D-E358-1899-0298-764124BF7F31}"/>
          </ac:spMkLst>
        </pc:spChg>
        <pc:spChg chg="add del mod">
          <ac:chgData name="Mbambo, Gillian" userId="59bfad07-67e3-47a4-ac55-04ee0a07a20e" providerId="ADAL" clId="{689D5830-7D20-EF43-9790-B7D919905F98}" dt="2023-05-25T19:33:50.065" v="1205" actId="478"/>
          <ac:spMkLst>
            <pc:docMk/>
            <pc:sldMk cId="1069009606" sldId="307"/>
            <ac:spMk id="14" creationId="{3E8F5768-FBBC-D05A-41FB-AFD832B504C4}"/>
          </ac:spMkLst>
        </pc:spChg>
        <pc:picChg chg="add del mod">
          <ac:chgData name="Mbambo, Gillian" userId="59bfad07-67e3-47a4-ac55-04ee0a07a20e" providerId="ADAL" clId="{689D5830-7D20-EF43-9790-B7D919905F98}" dt="2023-05-25T14:05:05.456" v="800" actId="478"/>
          <ac:picMkLst>
            <pc:docMk/>
            <pc:sldMk cId="1069009606" sldId="307"/>
            <ac:picMk id="3" creationId="{8309C8FC-ADF3-4915-B658-1AE84F8FBF84}"/>
          </ac:picMkLst>
        </pc:picChg>
        <pc:picChg chg="add del mod">
          <ac:chgData name="Mbambo, Gillian" userId="59bfad07-67e3-47a4-ac55-04ee0a07a20e" providerId="ADAL" clId="{689D5830-7D20-EF43-9790-B7D919905F98}" dt="2023-05-25T19:16:07.343" v="842" actId="478"/>
          <ac:picMkLst>
            <pc:docMk/>
            <pc:sldMk cId="1069009606" sldId="307"/>
            <ac:picMk id="5" creationId="{417FFB65-F347-A0D1-7206-BDAB0CF94DCF}"/>
          </ac:picMkLst>
        </pc:picChg>
        <pc:picChg chg="add del mod">
          <ac:chgData name="Mbambo, Gillian" userId="59bfad07-67e3-47a4-ac55-04ee0a07a20e" providerId="ADAL" clId="{689D5830-7D20-EF43-9790-B7D919905F98}" dt="2023-05-25T20:19:15.459" v="1297" actId="478"/>
          <ac:picMkLst>
            <pc:docMk/>
            <pc:sldMk cId="1069009606" sldId="307"/>
            <ac:picMk id="11" creationId="{96D1A2EA-A16A-72D0-D82C-C2F66FE609B9}"/>
          </ac:picMkLst>
        </pc:picChg>
        <pc:picChg chg="del">
          <ac:chgData name="Mbambo, Gillian" userId="59bfad07-67e3-47a4-ac55-04ee0a07a20e" providerId="ADAL" clId="{689D5830-7D20-EF43-9790-B7D919905F98}" dt="2023-05-25T19:33:48.221" v="1204" actId="478"/>
          <ac:picMkLst>
            <pc:docMk/>
            <pc:sldMk cId="1069009606" sldId="307"/>
            <ac:picMk id="13" creationId="{56172875-A179-0DE4-9A69-4A3B335687FA}"/>
          </ac:picMkLst>
        </pc:picChg>
        <pc:picChg chg="add mod">
          <ac:chgData name="Mbambo, Gillian" userId="59bfad07-67e3-47a4-ac55-04ee0a07a20e" providerId="ADAL" clId="{689D5830-7D20-EF43-9790-B7D919905F98}" dt="2023-05-25T20:19:20.511" v="1298" actId="1076"/>
          <ac:picMkLst>
            <pc:docMk/>
            <pc:sldMk cId="1069009606" sldId="307"/>
            <ac:picMk id="16" creationId="{6D2B1C26-4825-2B5B-222F-2D3CDD240122}"/>
          </ac:picMkLst>
        </pc:picChg>
      </pc:sldChg>
      <pc:sldChg chg="addSp delSp modSp del mod">
        <pc:chgData name="Mbambo, Gillian" userId="59bfad07-67e3-47a4-ac55-04ee0a07a20e" providerId="ADAL" clId="{689D5830-7D20-EF43-9790-B7D919905F98}" dt="2023-06-02T19:08:05.829" v="5220" actId="2696"/>
        <pc:sldMkLst>
          <pc:docMk/>
          <pc:sldMk cId="1237024876" sldId="308"/>
        </pc:sldMkLst>
        <pc:spChg chg="mod">
          <ac:chgData name="Mbambo, Gillian" userId="59bfad07-67e3-47a4-ac55-04ee0a07a20e" providerId="ADAL" clId="{689D5830-7D20-EF43-9790-B7D919905F98}" dt="2023-06-02T19:00:36.920" v="5056" actId="1076"/>
          <ac:spMkLst>
            <pc:docMk/>
            <pc:sldMk cId="1237024876" sldId="308"/>
            <ac:spMk id="2" creationId="{C945AAED-4A2D-BD48-E4CC-AF6B3308A68C}"/>
          </ac:spMkLst>
        </pc:spChg>
        <pc:spChg chg="mod">
          <ac:chgData name="Mbambo, Gillian" userId="59bfad07-67e3-47a4-ac55-04ee0a07a20e" providerId="ADAL" clId="{689D5830-7D20-EF43-9790-B7D919905F98}" dt="2023-06-02T19:00:36.920" v="5056" actId="1076"/>
          <ac:spMkLst>
            <pc:docMk/>
            <pc:sldMk cId="1237024876" sldId="308"/>
            <ac:spMk id="3" creationId="{37454A6F-B819-0934-9B9C-9FBDDD04F2D6}"/>
          </ac:spMkLst>
        </pc:spChg>
        <pc:spChg chg="mod">
          <ac:chgData name="Mbambo, Gillian" userId="59bfad07-67e3-47a4-ac55-04ee0a07a20e" providerId="ADAL" clId="{689D5830-7D20-EF43-9790-B7D919905F98}" dt="2023-06-02T19:00:36.920" v="5056" actId="1076"/>
          <ac:spMkLst>
            <pc:docMk/>
            <pc:sldMk cId="1237024876" sldId="308"/>
            <ac:spMk id="4" creationId="{5F16E416-D29A-920C-C799-DBAFF5CD8EDE}"/>
          </ac:spMkLst>
        </pc:spChg>
        <pc:spChg chg="mod">
          <ac:chgData name="Mbambo, Gillian" userId="59bfad07-67e3-47a4-ac55-04ee0a07a20e" providerId="ADAL" clId="{689D5830-7D20-EF43-9790-B7D919905F98}" dt="2023-06-02T19:00:36.920" v="5056" actId="1076"/>
          <ac:spMkLst>
            <pc:docMk/>
            <pc:sldMk cId="1237024876" sldId="308"/>
            <ac:spMk id="9" creationId="{18D334CD-DCEA-5454-82BC-3C0FB219F15A}"/>
          </ac:spMkLst>
        </pc:spChg>
        <pc:picChg chg="add del mod">
          <ac:chgData name="Mbambo, Gillian" userId="59bfad07-67e3-47a4-ac55-04ee0a07a20e" providerId="ADAL" clId="{689D5830-7D20-EF43-9790-B7D919905F98}" dt="2023-05-30T18:43:01.120" v="4751" actId="21"/>
          <ac:picMkLst>
            <pc:docMk/>
            <pc:sldMk cId="1237024876" sldId="308"/>
            <ac:picMk id="12" creationId="{153A1164-3358-BC86-6975-61ACBC9963DB}"/>
          </ac:picMkLst>
        </pc:picChg>
      </pc:sldChg>
      <pc:sldChg chg="modSp add del mod">
        <pc:chgData name="Mbambo, Gillian" userId="59bfad07-67e3-47a4-ac55-04ee0a07a20e" providerId="ADAL" clId="{689D5830-7D20-EF43-9790-B7D919905F98}" dt="2023-06-02T20:14:33.184" v="5639" actId="1035"/>
        <pc:sldMkLst>
          <pc:docMk/>
          <pc:sldMk cId="1258758728" sldId="309"/>
        </pc:sldMkLst>
        <pc:spChg chg="mod">
          <ac:chgData name="Mbambo, Gillian" userId="59bfad07-67e3-47a4-ac55-04ee0a07a20e" providerId="ADAL" clId="{689D5830-7D20-EF43-9790-B7D919905F98}" dt="2023-06-02T19:08:43.510" v="5223" actId="2711"/>
          <ac:spMkLst>
            <pc:docMk/>
            <pc:sldMk cId="1258758728" sldId="309"/>
            <ac:spMk id="6" creationId="{723F3CC8-37F5-F505-22A3-F3332B2DFA61}"/>
          </ac:spMkLst>
        </pc:spChg>
        <pc:spChg chg="mod">
          <ac:chgData name="Mbambo, Gillian" userId="59bfad07-67e3-47a4-ac55-04ee0a07a20e" providerId="ADAL" clId="{689D5830-7D20-EF43-9790-B7D919905F98}" dt="2023-06-02T19:08:49.905" v="5225" actId="255"/>
          <ac:spMkLst>
            <pc:docMk/>
            <pc:sldMk cId="1258758728" sldId="309"/>
            <ac:spMk id="7" creationId="{8F28BB0A-D9E9-5AAE-44CC-1C7F252513D4}"/>
          </ac:spMkLst>
        </pc:spChg>
        <pc:spChg chg="mod">
          <ac:chgData name="Mbambo, Gillian" userId="59bfad07-67e3-47a4-ac55-04ee0a07a20e" providerId="ADAL" clId="{689D5830-7D20-EF43-9790-B7D919905F98}" dt="2023-06-02T20:14:33.184" v="5639" actId="1035"/>
          <ac:spMkLst>
            <pc:docMk/>
            <pc:sldMk cId="1258758728" sldId="309"/>
            <ac:spMk id="8" creationId="{08AD758F-8DC8-ADDA-C8D0-04AE0D651C24}"/>
          </ac:spMkLst>
        </pc:spChg>
      </pc:sldChg>
      <pc:sldChg chg="addSp delSp modSp new mod">
        <pc:chgData name="Mbambo, Gillian" userId="59bfad07-67e3-47a4-ac55-04ee0a07a20e" providerId="ADAL" clId="{689D5830-7D20-EF43-9790-B7D919905F98}" dt="2023-06-02T18:30:49.467" v="5023" actId="2711"/>
        <pc:sldMkLst>
          <pc:docMk/>
          <pc:sldMk cId="1103200321" sldId="310"/>
        </pc:sldMkLst>
        <pc:spChg chg="del">
          <ac:chgData name="Mbambo, Gillian" userId="59bfad07-67e3-47a4-ac55-04ee0a07a20e" providerId="ADAL" clId="{689D5830-7D20-EF43-9790-B7D919905F98}" dt="2023-05-05T18:08:36.723" v="4" actId="478"/>
          <ac:spMkLst>
            <pc:docMk/>
            <pc:sldMk cId="1103200321" sldId="310"/>
            <ac:spMk id="2" creationId="{3B917DAE-2A33-0E89-567E-6A47B557BCD6}"/>
          </ac:spMkLst>
        </pc:spChg>
        <pc:spChg chg="mod">
          <ac:chgData name="Mbambo, Gillian" userId="59bfad07-67e3-47a4-ac55-04ee0a07a20e" providerId="ADAL" clId="{689D5830-7D20-EF43-9790-B7D919905F98}" dt="2023-05-26T23:53:46.752" v="2509" actId="20577"/>
          <ac:spMkLst>
            <pc:docMk/>
            <pc:sldMk cId="1103200321" sldId="310"/>
            <ac:spMk id="2" creationId="{C54CCC29-F8A9-8426-80CD-1C39157772CA}"/>
          </ac:spMkLst>
        </pc:spChg>
        <pc:spChg chg="del">
          <ac:chgData name="Mbambo, Gillian" userId="59bfad07-67e3-47a4-ac55-04ee0a07a20e" providerId="ADAL" clId="{689D5830-7D20-EF43-9790-B7D919905F98}" dt="2023-05-23T22:02:49.249" v="274" actId="478"/>
          <ac:spMkLst>
            <pc:docMk/>
            <pc:sldMk cId="1103200321" sldId="310"/>
            <ac:spMk id="3" creationId="{8B81AAF7-C549-B564-229D-AC363264209A}"/>
          </ac:spMkLst>
        </pc:spChg>
        <pc:spChg chg="add del mod">
          <ac:chgData name="Mbambo, Gillian" userId="59bfad07-67e3-47a4-ac55-04ee0a07a20e" providerId="ADAL" clId="{689D5830-7D20-EF43-9790-B7D919905F98}" dt="2023-05-28T01:56:14.598" v="3938" actId="767"/>
          <ac:spMkLst>
            <pc:docMk/>
            <pc:sldMk cId="1103200321" sldId="310"/>
            <ac:spMk id="3" creationId="{A6EB6B01-B710-5FE5-84E1-2B9A96601741}"/>
          </ac:spMkLst>
        </pc:spChg>
        <pc:spChg chg="del">
          <ac:chgData name="Mbambo, Gillian" userId="59bfad07-67e3-47a4-ac55-04ee0a07a20e" providerId="ADAL" clId="{689D5830-7D20-EF43-9790-B7D919905F98}" dt="2023-05-05T18:08:26.166" v="1"/>
          <ac:spMkLst>
            <pc:docMk/>
            <pc:sldMk cId="1103200321" sldId="310"/>
            <ac:spMk id="3" creationId="{B7FDE603-C2D5-198A-5244-6288EFE9A245}"/>
          </ac:spMkLst>
        </pc:spChg>
        <pc:spChg chg="add del mod">
          <ac:chgData name="Mbambo, Gillian" userId="59bfad07-67e3-47a4-ac55-04ee0a07a20e" providerId="ADAL" clId="{689D5830-7D20-EF43-9790-B7D919905F98}" dt="2023-05-05T18:08:32.358" v="2" actId="478"/>
          <ac:spMkLst>
            <pc:docMk/>
            <pc:sldMk cId="1103200321" sldId="310"/>
            <ac:spMk id="4" creationId="{23F2DA3E-170E-8B55-E756-F75DEC9CE4F7}"/>
          </ac:spMkLst>
        </pc:spChg>
        <pc:spChg chg="add del mod">
          <ac:chgData name="Mbambo, Gillian" userId="59bfad07-67e3-47a4-ac55-04ee0a07a20e" providerId="ADAL" clId="{689D5830-7D20-EF43-9790-B7D919905F98}" dt="2023-05-28T01:56:12.422" v="3935"/>
          <ac:spMkLst>
            <pc:docMk/>
            <pc:sldMk cId="1103200321" sldId="310"/>
            <ac:spMk id="4" creationId="{D5AEE12C-FF70-441B-5F0C-AA8FFCF2C535}"/>
          </ac:spMkLst>
        </pc:spChg>
        <pc:spChg chg="del">
          <ac:chgData name="Mbambo, Gillian" userId="59bfad07-67e3-47a4-ac55-04ee0a07a20e" providerId="ADAL" clId="{689D5830-7D20-EF43-9790-B7D919905F98}" dt="2023-05-23T22:02:49.249" v="274" actId="478"/>
          <ac:spMkLst>
            <pc:docMk/>
            <pc:sldMk cId="1103200321" sldId="310"/>
            <ac:spMk id="4" creationId="{FD3B019F-9ED4-22AC-1CF1-3F024AD78AF6}"/>
          </ac:spMkLst>
        </pc:spChg>
        <pc:spChg chg="add del mod">
          <ac:chgData name="Mbambo, Gillian" userId="59bfad07-67e3-47a4-ac55-04ee0a07a20e" providerId="ADAL" clId="{689D5830-7D20-EF43-9790-B7D919905F98}" dt="2023-05-28T01:56:11.248" v="3933"/>
          <ac:spMkLst>
            <pc:docMk/>
            <pc:sldMk cId="1103200321" sldId="310"/>
            <ac:spMk id="5" creationId="{2D5216B8-BDC3-7AAF-4B26-0A58786BCE7C}"/>
          </ac:spMkLst>
        </pc:spChg>
        <pc:spChg chg="del">
          <ac:chgData name="Mbambo, Gillian" userId="59bfad07-67e3-47a4-ac55-04ee0a07a20e" providerId="ADAL" clId="{689D5830-7D20-EF43-9790-B7D919905F98}" dt="2023-05-23T22:02:49.249" v="274" actId="478"/>
          <ac:spMkLst>
            <pc:docMk/>
            <pc:sldMk cId="1103200321" sldId="310"/>
            <ac:spMk id="5" creationId="{CFEADEE8-AB07-CE1F-9F02-A2207263E3F3}"/>
          </ac:spMkLst>
        </pc:spChg>
        <pc:spChg chg="add del mod">
          <ac:chgData name="Mbambo, Gillian" userId="59bfad07-67e3-47a4-ac55-04ee0a07a20e" providerId="ADAL" clId="{689D5830-7D20-EF43-9790-B7D919905F98}" dt="2023-05-05T18:08:35.063" v="3" actId="478"/>
          <ac:spMkLst>
            <pc:docMk/>
            <pc:sldMk cId="1103200321" sldId="310"/>
            <ac:spMk id="6" creationId="{122B7D7E-0813-C493-0E03-D5E859734547}"/>
          </ac:spMkLst>
        </pc:spChg>
        <pc:spChg chg="del mod">
          <ac:chgData name="Mbambo, Gillian" userId="59bfad07-67e3-47a4-ac55-04ee0a07a20e" providerId="ADAL" clId="{689D5830-7D20-EF43-9790-B7D919905F98}" dt="2023-05-23T22:02:49.249" v="274" actId="478"/>
          <ac:spMkLst>
            <pc:docMk/>
            <pc:sldMk cId="1103200321" sldId="310"/>
            <ac:spMk id="6" creationId="{C30C7FA0-690C-6219-3A50-74045D3EBC43}"/>
          </ac:spMkLst>
        </pc:spChg>
        <pc:spChg chg="add mod">
          <ac:chgData name="Mbambo, Gillian" userId="59bfad07-67e3-47a4-ac55-04ee0a07a20e" providerId="ADAL" clId="{689D5830-7D20-EF43-9790-B7D919905F98}" dt="2023-05-27T11:49:31.901" v="2979" actId="1076"/>
          <ac:spMkLst>
            <pc:docMk/>
            <pc:sldMk cId="1103200321" sldId="310"/>
            <ac:spMk id="7" creationId="{7E446341-0DB1-0F87-C8FB-0BF4BAE7D571}"/>
          </ac:spMkLst>
        </pc:spChg>
        <pc:spChg chg="del mod">
          <ac:chgData name="Mbambo, Gillian" userId="59bfad07-67e3-47a4-ac55-04ee0a07a20e" providerId="ADAL" clId="{689D5830-7D20-EF43-9790-B7D919905F98}" dt="2023-05-23T22:02:49.249" v="274" actId="478"/>
          <ac:spMkLst>
            <pc:docMk/>
            <pc:sldMk cId="1103200321" sldId="310"/>
            <ac:spMk id="8" creationId="{549687BF-9FF3-80BA-999F-7D4CCB4776C6}"/>
          </ac:spMkLst>
        </pc:spChg>
        <pc:spChg chg="del">
          <ac:chgData name="Mbambo, Gillian" userId="59bfad07-67e3-47a4-ac55-04ee0a07a20e" providerId="ADAL" clId="{689D5830-7D20-EF43-9790-B7D919905F98}" dt="2023-05-23T22:02:49.249" v="274" actId="478"/>
          <ac:spMkLst>
            <pc:docMk/>
            <pc:sldMk cId="1103200321" sldId="310"/>
            <ac:spMk id="9" creationId="{DDFC1273-6673-8E26-DC02-94C84CF214A2}"/>
          </ac:spMkLst>
        </pc:spChg>
        <pc:spChg chg="add del mod">
          <ac:chgData name="Mbambo, Gillian" userId="59bfad07-67e3-47a4-ac55-04ee0a07a20e" providerId="ADAL" clId="{689D5830-7D20-EF43-9790-B7D919905F98}" dt="2023-05-27T11:43:57.472" v="2941"/>
          <ac:spMkLst>
            <pc:docMk/>
            <pc:sldMk cId="1103200321" sldId="310"/>
            <ac:spMk id="10" creationId="{219B6B6B-944B-218B-0252-D70BE13BCA13}"/>
          </ac:spMkLst>
        </pc:spChg>
        <pc:spChg chg="add del mod">
          <ac:chgData name="Mbambo, Gillian" userId="59bfad07-67e3-47a4-ac55-04ee0a07a20e" providerId="ADAL" clId="{689D5830-7D20-EF43-9790-B7D919905F98}" dt="2023-05-27T11:43:57.472" v="2941"/>
          <ac:spMkLst>
            <pc:docMk/>
            <pc:sldMk cId="1103200321" sldId="310"/>
            <ac:spMk id="12" creationId="{C8857705-8499-447D-D2B3-7E4D2473F41F}"/>
          </ac:spMkLst>
        </pc:spChg>
        <pc:spChg chg="add del mod">
          <ac:chgData name="Mbambo, Gillian" userId="59bfad07-67e3-47a4-ac55-04ee0a07a20e" providerId="ADAL" clId="{689D5830-7D20-EF43-9790-B7D919905F98}" dt="2023-05-27T11:43:57.472" v="2941"/>
          <ac:spMkLst>
            <pc:docMk/>
            <pc:sldMk cId="1103200321" sldId="310"/>
            <ac:spMk id="14" creationId="{CF8BD41E-D413-A032-E81B-91905698DD83}"/>
          </ac:spMkLst>
        </pc:spChg>
        <pc:spChg chg="add del mod">
          <ac:chgData name="Mbambo, Gillian" userId="59bfad07-67e3-47a4-ac55-04ee0a07a20e" providerId="ADAL" clId="{689D5830-7D20-EF43-9790-B7D919905F98}" dt="2023-05-27T11:44:16.015" v="2944" actId="478"/>
          <ac:spMkLst>
            <pc:docMk/>
            <pc:sldMk cId="1103200321" sldId="310"/>
            <ac:spMk id="16" creationId="{824FAB89-59DA-3E43-4722-E0BDF449E80D}"/>
          </ac:spMkLst>
        </pc:spChg>
        <pc:spChg chg="add del mod">
          <ac:chgData name="Mbambo, Gillian" userId="59bfad07-67e3-47a4-ac55-04ee0a07a20e" providerId="ADAL" clId="{689D5830-7D20-EF43-9790-B7D919905F98}" dt="2023-05-27T11:44:16.015" v="2944" actId="478"/>
          <ac:spMkLst>
            <pc:docMk/>
            <pc:sldMk cId="1103200321" sldId="310"/>
            <ac:spMk id="17" creationId="{33798967-7389-3AF2-D0D9-DEA5AD0AA44B}"/>
          </ac:spMkLst>
        </pc:spChg>
        <pc:spChg chg="add del mod">
          <ac:chgData name="Mbambo, Gillian" userId="59bfad07-67e3-47a4-ac55-04ee0a07a20e" providerId="ADAL" clId="{689D5830-7D20-EF43-9790-B7D919905F98}" dt="2023-05-27T11:44:18.729" v="2945" actId="478"/>
          <ac:spMkLst>
            <pc:docMk/>
            <pc:sldMk cId="1103200321" sldId="310"/>
            <ac:spMk id="18" creationId="{4AE3ABDE-D223-5406-2864-70F2F7AC5071}"/>
          </ac:spMkLst>
        </pc:spChg>
        <pc:spChg chg="add del mod">
          <ac:chgData name="Mbambo, Gillian" userId="59bfad07-67e3-47a4-ac55-04ee0a07a20e" providerId="ADAL" clId="{689D5830-7D20-EF43-9790-B7D919905F98}" dt="2023-05-27T11:44:16.015" v="2944" actId="478"/>
          <ac:spMkLst>
            <pc:docMk/>
            <pc:sldMk cId="1103200321" sldId="310"/>
            <ac:spMk id="19" creationId="{248557D3-1BF1-EF9C-89A6-07953571FD75}"/>
          </ac:spMkLst>
        </pc:spChg>
        <pc:spChg chg="add del mod">
          <ac:chgData name="Mbambo, Gillian" userId="59bfad07-67e3-47a4-ac55-04ee0a07a20e" providerId="ADAL" clId="{689D5830-7D20-EF43-9790-B7D919905F98}" dt="2023-05-27T11:44:16.015" v="2944" actId="478"/>
          <ac:spMkLst>
            <pc:docMk/>
            <pc:sldMk cId="1103200321" sldId="310"/>
            <ac:spMk id="20" creationId="{DEBCB2EC-F818-E736-A200-8D401BF38664}"/>
          </ac:spMkLst>
        </pc:spChg>
        <pc:spChg chg="add del mod">
          <ac:chgData name="Mbambo, Gillian" userId="59bfad07-67e3-47a4-ac55-04ee0a07a20e" providerId="ADAL" clId="{689D5830-7D20-EF43-9790-B7D919905F98}" dt="2023-05-27T11:44:16.015" v="2944" actId="478"/>
          <ac:spMkLst>
            <pc:docMk/>
            <pc:sldMk cId="1103200321" sldId="310"/>
            <ac:spMk id="21" creationId="{E88C8CFA-121B-82CF-7B4D-B131C2AA0EBC}"/>
          </ac:spMkLst>
        </pc:spChg>
        <pc:spChg chg="add del mod">
          <ac:chgData name="Mbambo, Gillian" userId="59bfad07-67e3-47a4-ac55-04ee0a07a20e" providerId="ADAL" clId="{689D5830-7D20-EF43-9790-B7D919905F98}" dt="2023-05-27T11:43:57.472" v="2941"/>
          <ac:spMkLst>
            <pc:docMk/>
            <pc:sldMk cId="1103200321" sldId="310"/>
            <ac:spMk id="22" creationId="{88A22EB6-C48B-705A-BC57-0B37FFB27ABC}"/>
          </ac:spMkLst>
        </pc:spChg>
        <pc:spChg chg="add del mod">
          <ac:chgData name="Mbambo, Gillian" userId="59bfad07-67e3-47a4-ac55-04ee0a07a20e" providerId="ADAL" clId="{689D5830-7D20-EF43-9790-B7D919905F98}" dt="2023-05-27T11:43:57.472" v="2941"/>
          <ac:spMkLst>
            <pc:docMk/>
            <pc:sldMk cId="1103200321" sldId="310"/>
            <ac:spMk id="23" creationId="{0579FC03-6EA1-18F7-AF7B-D66F37FDD64C}"/>
          </ac:spMkLst>
        </pc:spChg>
        <pc:spChg chg="add del mod">
          <ac:chgData name="Mbambo, Gillian" userId="59bfad07-67e3-47a4-ac55-04ee0a07a20e" providerId="ADAL" clId="{689D5830-7D20-EF43-9790-B7D919905F98}" dt="2023-05-27T11:43:57.472" v="2941"/>
          <ac:spMkLst>
            <pc:docMk/>
            <pc:sldMk cId="1103200321" sldId="310"/>
            <ac:spMk id="24" creationId="{4899A93D-9ED7-C3EC-C325-5DBC476216BA}"/>
          </ac:spMkLst>
        </pc:spChg>
        <pc:spChg chg="add mod">
          <ac:chgData name="Mbambo, Gillian" userId="59bfad07-67e3-47a4-ac55-04ee0a07a20e" providerId="ADAL" clId="{689D5830-7D20-EF43-9790-B7D919905F98}" dt="2023-06-02T18:30:43.320" v="5021" actId="255"/>
          <ac:spMkLst>
            <pc:docMk/>
            <pc:sldMk cId="1103200321" sldId="310"/>
            <ac:spMk id="25" creationId="{91A656DC-4D78-42F8-F0DB-8602E44F306F}"/>
          </ac:spMkLst>
        </pc:spChg>
        <pc:spChg chg="add mod">
          <ac:chgData name="Mbambo, Gillian" userId="59bfad07-67e3-47a4-ac55-04ee0a07a20e" providerId="ADAL" clId="{689D5830-7D20-EF43-9790-B7D919905F98}" dt="2023-06-02T18:30:37.726" v="5020" actId="2711"/>
          <ac:spMkLst>
            <pc:docMk/>
            <pc:sldMk cId="1103200321" sldId="310"/>
            <ac:spMk id="26" creationId="{79B86359-5E90-1C2C-A7A7-B0545B7EB915}"/>
          </ac:spMkLst>
        </pc:spChg>
        <pc:spChg chg="add mod">
          <ac:chgData name="Mbambo, Gillian" userId="59bfad07-67e3-47a4-ac55-04ee0a07a20e" providerId="ADAL" clId="{689D5830-7D20-EF43-9790-B7D919905F98}" dt="2023-06-02T18:30:49.467" v="5023" actId="2711"/>
          <ac:spMkLst>
            <pc:docMk/>
            <pc:sldMk cId="1103200321" sldId="310"/>
            <ac:spMk id="27" creationId="{E3DD5883-31CB-EA39-513D-F3CAD1DD3135}"/>
          </ac:spMkLst>
        </pc:spChg>
        <pc:spChg chg="add mod">
          <ac:chgData name="Mbambo, Gillian" userId="59bfad07-67e3-47a4-ac55-04ee0a07a20e" providerId="ADAL" clId="{689D5830-7D20-EF43-9790-B7D919905F98}" dt="2023-05-27T11:54:50.423" v="3089" actId="1037"/>
          <ac:spMkLst>
            <pc:docMk/>
            <pc:sldMk cId="1103200321" sldId="310"/>
            <ac:spMk id="28" creationId="{B1C4FBCC-04B4-A60C-761A-378256DD5BDC}"/>
          </ac:spMkLst>
        </pc:spChg>
        <pc:spChg chg="add mod">
          <ac:chgData name="Mbambo, Gillian" userId="59bfad07-67e3-47a4-ac55-04ee0a07a20e" providerId="ADAL" clId="{689D5830-7D20-EF43-9790-B7D919905F98}" dt="2023-05-27T11:54:50.423" v="3089" actId="1037"/>
          <ac:spMkLst>
            <pc:docMk/>
            <pc:sldMk cId="1103200321" sldId="310"/>
            <ac:spMk id="29" creationId="{E747FE25-5CF0-A7C5-15B9-86CE22D4D2CC}"/>
          </ac:spMkLst>
        </pc:spChg>
        <pc:spChg chg="add mod">
          <ac:chgData name="Mbambo, Gillian" userId="59bfad07-67e3-47a4-ac55-04ee0a07a20e" providerId="ADAL" clId="{689D5830-7D20-EF43-9790-B7D919905F98}" dt="2023-05-27T11:54:50.423" v="3089" actId="1037"/>
          <ac:spMkLst>
            <pc:docMk/>
            <pc:sldMk cId="1103200321" sldId="310"/>
            <ac:spMk id="30" creationId="{32B884EE-5D44-327C-F5D1-F6B1520CECB2}"/>
          </ac:spMkLst>
        </pc:spChg>
        <pc:picChg chg="add del mod">
          <ac:chgData name="Mbambo, Gillian" userId="59bfad07-67e3-47a4-ac55-04ee0a07a20e" providerId="ADAL" clId="{689D5830-7D20-EF43-9790-B7D919905F98}" dt="2023-05-27T16:12:25.385" v="3132" actId="478"/>
          <ac:picMkLst>
            <pc:docMk/>
            <pc:sldMk cId="1103200321" sldId="310"/>
            <ac:picMk id="4" creationId="{A06B435D-0D21-0053-665E-2CA489BB7A29}"/>
          </ac:picMkLst>
        </pc:picChg>
        <pc:picChg chg="add del mod">
          <ac:chgData name="Mbambo, Gillian" userId="59bfad07-67e3-47a4-ac55-04ee0a07a20e" providerId="ADAL" clId="{689D5830-7D20-EF43-9790-B7D919905F98}" dt="2023-05-27T11:48:06.024" v="2963" actId="478"/>
          <ac:picMkLst>
            <pc:docMk/>
            <pc:sldMk cId="1103200321" sldId="310"/>
            <ac:picMk id="6" creationId="{D56D9E99-5864-80DE-5CBD-3E7B863930E0}"/>
          </ac:picMkLst>
        </pc:picChg>
        <pc:picChg chg="add mod">
          <ac:chgData name="Mbambo, Gillian" userId="59bfad07-67e3-47a4-ac55-04ee0a07a20e" providerId="ADAL" clId="{689D5830-7D20-EF43-9790-B7D919905F98}" dt="2023-05-27T11:54:50.423" v="3089" actId="1037"/>
          <ac:picMkLst>
            <pc:docMk/>
            <pc:sldMk cId="1103200321" sldId="310"/>
            <ac:picMk id="9" creationId="{F5463806-9733-8824-33B0-5D481B74C1F3}"/>
          </ac:picMkLst>
        </pc:picChg>
        <pc:picChg chg="add del mod">
          <ac:chgData name="Mbambo, Gillian" userId="59bfad07-67e3-47a4-ac55-04ee0a07a20e" providerId="ADAL" clId="{689D5830-7D20-EF43-9790-B7D919905F98}" dt="2023-05-27T11:44:51.720" v="2948" actId="478"/>
          <ac:picMkLst>
            <pc:docMk/>
            <pc:sldMk cId="1103200321" sldId="310"/>
            <ac:picMk id="11" creationId="{FE9FD22B-FFFF-0DA7-D1B1-D921CFD473ED}"/>
          </ac:picMkLst>
        </pc:picChg>
        <pc:picChg chg="add del mod">
          <ac:chgData name="Mbambo, Gillian" userId="59bfad07-67e3-47a4-ac55-04ee0a07a20e" providerId="ADAL" clId="{689D5830-7D20-EF43-9790-B7D919905F98}" dt="2023-05-27T11:44:51.720" v="2948" actId="478"/>
          <ac:picMkLst>
            <pc:docMk/>
            <pc:sldMk cId="1103200321" sldId="310"/>
            <ac:picMk id="13" creationId="{9DD91F86-78A9-59D0-BB53-8060D9A853C6}"/>
          </ac:picMkLst>
        </pc:picChg>
        <pc:picChg chg="add del mod">
          <ac:chgData name="Mbambo, Gillian" userId="59bfad07-67e3-47a4-ac55-04ee0a07a20e" providerId="ADAL" clId="{689D5830-7D20-EF43-9790-B7D919905F98}" dt="2023-05-27T11:44:51.720" v="2948" actId="478"/>
          <ac:picMkLst>
            <pc:docMk/>
            <pc:sldMk cId="1103200321" sldId="310"/>
            <ac:picMk id="15" creationId="{4F1B9235-CC6F-2770-67FE-3EE537D86E67}"/>
          </ac:picMkLst>
        </pc:picChg>
        <pc:picChg chg="add del mod">
          <ac:chgData name="Mbambo, Gillian" userId="59bfad07-67e3-47a4-ac55-04ee0a07a20e" providerId="ADAL" clId="{689D5830-7D20-EF43-9790-B7D919905F98}" dt="2023-05-26T22:50:14.063" v="2207" actId="21"/>
          <ac:picMkLst>
            <pc:docMk/>
            <pc:sldMk cId="1103200321" sldId="310"/>
            <ac:picMk id="23" creationId="{6B0B41B1-04E3-2CC5-5E9E-B4B80DF3DDDD}"/>
          </ac:picMkLst>
        </pc:picChg>
        <pc:picChg chg="add del mod">
          <ac:chgData name="Mbambo, Gillian" userId="59bfad07-67e3-47a4-ac55-04ee0a07a20e" providerId="ADAL" clId="{689D5830-7D20-EF43-9790-B7D919905F98}" dt="2023-05-27T16:12:59.834" v="3138" actId="478"/>
          <ac:picMkLst>
            <pc:docMk/>
            <pc:sldMk cId="1103200321" sldId="310"/>
            <ac:picMk id="32" creationId="{D3246FCF-08BE-8EAC-A1B3-C9F7E5B11F2C}"/>
          </ac:picMkLst>
        </pc:picChg>
        <pc:picChg chg="add del mod">
          <ac:chgData name="Mbambo, Gillian" userId="59bfad07-67e3-47a4-ac55-04ee0a07a20e" providerId="ADAL" clId="{689D5830-7D20-EF43-9790-B7D919905F98}" dt="2023-05-27T16:13:50.318" v="3151" actId="478"/>
          <ac:picMkLst>
            <pc:docMk/>
            <pc:sldMk cId="1103200321" sldId="310"/>
            <ac:picMk id="33" creationId="{655D84FF-4FCF-9035-9344-5626E32B8DF4}"/>
          </ac:picMkLst>
        </pc:picChg>
        <pc:picChg chg="add mod">
          <ac:chgData name="Mbambo, Gillian" userId="59bfad07-67e3-47a4-ac55-04ee0a07a20e" providerId="ADAL" clId="{689D5830-7D20-EF43-9790-B7D919905F98}" dt="2023-05-27T16:12:31.110" v="3133" actId="1076"/>
          <ac:picMkLst>
            <pc:docMk/>
            <pc:sldMk cId="1103200321" sldId="310"/>
            <ac:picMk id="34" creationId="{A4A8A901-7D14-E8A4-30BB-57FCF0EC805E}"/>
          </ac:picMkLst>
        </pc:picChg>
        <pc:picChg chg="add mod">
          <ac:chgData name="Mbambo, Gillian" userId="59bfad07-67e3-47a4-ac55-04ee0a07a20e" providerId="ADAL" clId="{689D5830-7D20-EF43-9790-B7D919905F98}" dt="2023-05-27T16:13:24.227" v="3147" actId="14100"/>
          <ac:picMkLst>
            <pc:docMk/>
            <pc:sldMk cId="1103200321" sldId="310"/>
            <ac:picMk id="36" creationId="{0A6199D0-0FED-2508-5B3D-4A69F64184F0}"/>
          </ac:picMkLst>
        </pc:picChg>
        <pc:picChg chg="add mod">
          <ac:chgData name="Mbambo, Gillian" userId="59bfad07-67e3-47a4-ac55-04ee0a07a20e" providerId="ADAL" clId="{689D5830-7D20-EF43-9790-B7D919905F98}" dt="2023-05-27T16:13:57.643" v="3153" actId="1076"/>
          <ac:picMkLst>
            <pc:docMk/>
            <pc:sldMk cId="1103200321" sldId="310"/>
            <ac:picMk id="38" creationId="{4E930D0B-C98D-A216-4607-A13E508BA6EE}"/>
          </ac:picMkLst>
        </pc:picChg>
      </pc:sldChg>
      <pc:sldChg chg="addSp delSp modSp new mod">
        <pc:chgData name="Mbambo, Gillian" userId="59bfad07-67e3-47a4-ac55-04ee0a07a20e" providerId="ADAL" clId="{689D5830-7D20-EF43-9790-B7D919905F98}" dt="2023-05-30T18:45:37.081" v="4823" actId="20577"/>
        <pc:sldMkLst>
          <pc:docMk/>
          <pc:sldMk cId="2699323040" sldId="311"/>
        </pc:sldMkLst>
        <pc:spChg chg="del">
          <ac:chgData name="Mbambo, Gillian" userId="59bfad07-67e3-47a4-ac55-04ee0a07a20e" providerId="ADAL" clId="{689D5830-7D20-EF43-9790-B7D919905F98}" dt="2023-05-25T20:47:58.576" v="1356" actId="478"/>
          <ac:spMkLst>
            <pc:docMk/>
            <pc:sldMk cId="2699323040" sldId="311"/>
            <ac:spMk id="2" creationId="{FDE516FA-EF6E-72FD-D70C-EF80ABD78874}"/>
          </ac:spMkLst>
        </pc:spChg>
        <pc:spChg chg="del">
          <ac:chgData name="Mbambo, Gillian" userId="59bfad07-67e3-47a4-ac55-04ee0a07a20e" providerId="ADAL" clId="{689D5830-7D20-EF43-9790-B7D919905F98}" dt="2023-05-25T20:48:00.390" v="1357" actId="478"/>
          <ac:spMkLst>
            <pc:docMk/>
            <pc:sldMk cId="2699323040" sldId="311"/>
            <ac:spMk id="3" creationId="{439ED3CF-CAC0-3CED-8F27-A6C15B8AF22C}"/>
          </ac:spMkLst>
        </pc:spChg>
        <pc:spChg chg="add del mod">
          <ac:chgData name="Mbambo, Gillian" userId="59bfad07-67e3-47a4-ac55-04ee0a07a20e" providerId="ADAL" clId="{689D5830-7D20-EF43-9790-B7D919905F98}" dt="2023-05-29T00:06:20.290" v="3981" actId="478"/>
          <ac:spMkLst>
            <pc:docMk/>
            <pc:sldMk cId="2699323040" sldId="311"/>
            <ac:spMk id="3" creationId="{CD9287F7-AD3C-B030-00A0-8FB57F4A2385}"/>
          </ac:spMkLst>
        </pc:spChg>
        <pc:spChg chg="add mod">
          <ac:chgData name="Mbambo, Gillian" userId="59bfad07-67e3-47a4-ac55-04ee0a07a20e" providerId="ADAL" clId="{689D5830-7D20-EF43-9790-B7D919905F98}" dt="2023-05-26T20:29:47.553" v="1366" actId="20577"/>
          <ac:spMkLst>
            <pc:docMk/>
            <pc:sldMk cId="2699323040" sldId="311"/>
            <ac:spMk id="4" creationId="{CB49DE12-9150-E1A7-5904-48AFAD98CDAD}"/>
          </ac:spMkLst>
        </pc:spChg>
        <pc:spChg chg="add mod">
          <ac:chgData name="Mbambo, Gillian" userId="59bfad07-67e3-47a4-ac55-04ee0a07a20e" providerId="ADAL" clId="{689D5830-7D20-EF43-9790-B7D919905F98}" dt="2023-05-30T18:45:37.081" v="4823" actId="20577"/>
          <ac:spMkLst>
            <pc:docMk/>
            <pc:sldMk cId="2699323040" sldId="311"/>
            <ac:spMk id="5" creationId="{A6B9EA57-7F74-5D11-BEB0-FD607F966B41}"/>
          </ac:spMkLst>
        </pc:spChg>
        <pc:spChg chg="add del mod">
          <ac:chgData name="Mbambo, Gillian" userId="59bfad07-67e3-47a4-ac55-04ee0a07a20e" providerId="ADAL" clId="{689D5830-7D20-EF43-9790-B7D919905F98}" dt="2023-05-26T20:29:51.061" v="1368"/>
          <ac:spMkLst>
            <pc:docMk/>
            <pc:sldMk cId="2699323040" sldId="311"/>
            <ac:spMk id="6" creationId="{D3AE5726-269F-E1A0-D677-2B6BBA7A10A8}"/>
          </ac:spMkLst>
        </pc:spChg>
        <pc:spChg chg="add mod">
          <ac:chgData name="Mbambo, Gillian" userId="59bfad07-67e3-47a4-ac55-04ee0a07a20e" providerId="ADAL" clId="{689D5830-7D20-EF43-9790-B7D919905F98}" dt="2023-05-29T02:23:35.918" v="4715" actId="1035"/>
          <ac:spMkLst>
            <pc:docMk/>
            <pc:sldMk cId="2699323040" sldId="311"/>
            <ac:spMk id="7" creationId="{103F65B4-F691-5482-3889-8F68751F0F47}"/>
          </ac:spMkLst>
        </pc:spChg>
        <pc:spChg chg="add mod">
          <ac:chgData name="Mbambo, Gillian" userId="59bfad07-67e3-47a4-ac55-04ee0a07a20e" providerId="ADAL" clId="{689D5830-7D20-EF43-9790-B7D919905F98}" dt="2023-05-30T18:45:05.123" v="4795" actId="1036"/>
          <ac:spMkLst>
            <pc:docMk/>
            <pc:sldMk cId="2699323040" sldId="311"/>
            <ac:spMk id="13" creationId="{960EA638-2666-6617-F419-EE85AEA4858A}"/>
          </ac:spMkLst>
        </pc:spChg>
        <pc:picChg chg="add mod">
          <ac:chgData name="Mbambo, Gillian" userId="59bfad07-67e3-47a4-ac55-04ee0a07a20e" providerId="ADAL" clId="{689D5830-7D20-EF43-9790-B7D919905F98}" dt="2023-05-29T00:58:34.370" v="4555" actId="1036"/>
          <ac:picMkLst>
            <pc:docMk/>
            <pc:sldMk cId="2699323040" sldId="311"/>
            <ac:picMk id="2" creationId="{5CF7881F-B4E6-596C-AB86-08CF6E3456FE}"/>
          </ac:picMkLst>
        </pc:picChg>
        <pc:picChg chg="add mod">
          <ac:chgData name="Mbambo, Gillian" userId="59bfad07-67e3-47a4-ac55-04ee0a07a20e" providerId="ADAL" clId="{689D5830-7D20-EF43-9790-B7D919905F98}" dt="2023-05-30T18:43:20.134" v="4756" actId="1076"/>
          <ac:picMkLst>
            <pc:docMk/>
            <pc:sldMk cId="2699323040" sldId="311"/>
            <ac:picMk id="3" creationId="{BADEF415-5465-411E-CF0B-7EACFE30D9FF}"/>
          </ac:picMkLst>
        </pc:picChg>
        <pc:picChg chg="add mod">
          <ac:chgData name="Mbambo, Gillian" userId="59bfad07-67e3-47a4-ac55-04ee0a07a20e" providerId="ADAL" clId="{689D5830-7D20-EF43-9790-B7D919905F98}" dt="2023-05-30T18:44:55.799" v="4784" actId="1037"/>
          <ac:picMkLst>
            <pc:docMk/>
            <pc:sldMk cId="2699323040" sldId="311"/>
            <ac:picMk id="8" creationId="{6D28DEB2-C50D-7E33-8A10-C7481E2450A2}"/>
          </ac:picMkLst>
        </pc:picChg>
        <pc:picChg chg="add del mod">
          <ac:chgData name="Mbambo, Gillian" userId="59bfad07-67e3-47a4-ac55-04ee0a07a20e" providerId="ADAL" clId="{689D5830-7D20-EF43-9790-B7D919905F98}" dt="2023-05-29T00:27:00.856" v="3993" actId="478"/>
          <ac:picMkLst>
            <pc:docMk/>
            <pc:sldMk cId="2699323040" sldId="311"/>
            <ac:picMk id="8" creationId="{95966189-5E16-8E4F-11B1-E3937E08FC7E}"/>
          </ac:picMkLst>
        </pc:picChg>
        <pc:picChg chg="add del mod">
          <ac:chgData name="Mbambo, Gillian" userId="59bfad07-67e3-47a4-ac55-04ee0a07a20e" providerId="ADAL" clId="{689D5830-7D20-EF43-9790-B7D919905F98}" dt="2023-05-30T18:43:12.666" v="4754" actId="478"/>
          <ac:picMkLst>
            <pc:docMk/>
            <pc:sldMk cId="2699323040" sldId="311"/>
            <ac:picMk id="10" creationId="{459278A8-D5C1-FA1F-F1DF-C53AA6592CC0}"/>
          </ac:picMkLst>
        </pc:picChg>
        <pc:picChg chg="add del mod">
          <ac:chgData name="Mbambo, Gillian" userId="59bfad07-67e3-47a4-ac55-04ee0a07a20e" providerId="ADAL" clId="{689D5830-7D20-EF43-9790-B7D919905F98}" dt="2023-05-30T18:43:25.374" v="4757" actId="478"/>
          <ac:picMkLst>
            <pc:docMk/>
            <pc:sldMk cId="2699323040" sldId="311"/>
            <ac:picMk id="12" creationId="{52606D5F-6B7B-9B2F-B2D9-9F2A078BD75C}"/>
          </ac:picMkLst>
        </pc:picChg>
      </pc:sldChg>
      <pc:sldChg chg="addSp delSp modSp new del mod">
        <pc:chgData name="Mbambo, Gillian" userId="59bfad07-67e3-47a4-ac55-04ee0a07a20e" providerId="ADAL" clId="{689D5830-7D20-EF43-9790-B7D919905F98}" dt="2023-05-27T21:50:33.713" v="3912" actId="2696"/>
        <pc:sldMkLst>
          <pc:docMk/>
          <pc:sldMk cId="2411453857" sldId="312"/>
        </pc:sldMkLst>
        <pc:spChg chg="add del mod">
          <ac:chgData name="Mbambo, Gillian" userId="59bfad07-67e3-47a4-ac55-04ee0a07a20e" providerId="ADAL" clId="{689D5830-7D20-EF43-9790-B7D919905F98}" dt="2023-05-27T21:04:03.663" v="3211"/>
          <ac:spMkLst>
            <pc:docMk/>
            <pc:sldMk cId="2411453857" sldId="312"/>
            <ac:spMk id="2" creationId="{A078FE92-9CDE-DC8F-489F-11FE2916E964}"/>
          </ac:spMkLst>
        </pc:spChg>
        <pc:spChg chg="del">
          <ac:chgData name="Mbambo, Gillian" userId="59bfad07-67e3-47a4-ac55-04ee0a07a20e" providerId="ADAL" clId="{689D5830-7D20-EF43-9790-B7D919905F98}" dt="2023-05-24T17:00:25.184" v="615" actId="478"/>
          <ac:spMkLst>
            <pc:docMk/>
            <pc:sldMk cId="2411453857" sldId="312"/>
            <ac:spMk id="2" creationId="{FB730A7F-5008-9903-8D8B-1BD686A60DEB}"/>
          </ac:spMkLst>
        </pc:spChg>
        <pc:spChg chg="del">
          <ac:chgData name="Mbambo, Gillian" userId="59bfad07-67e3-47a4-ac55-04ee0a07a20e" providerId="ADAL" clId="{689D5830-7D20-EF43-9790-B7D919905F98}" dt="2023-05-24T17:00:26.890" v="616" actId="478"/>
          <ac:spMkLst>
            <pc:docMk/>
            <pc:sldMk cId="2411453857" sldId="312"/>
            <ac:spMk id="3" creationId="{0D81BC8A-2BC9-8504-BD5B-20A6685A222B}"/>
          </ac:spMkLst>
        </pc:spChg>
        <pc:spChg chg="add del mod">
          <ac:chgData name="Mbambo, Gillian" userId="59bfad07-67e3-47a4-ac55-04ee0a07a20e" providerId="ADAL" clId="{689D5830-7D20-EF43-9790-B7D919905F98}" dt="2023-05-27T21:04:52.724" v="3216" actId="478"/>
          <ac:spMkLst>
            <pc:docMk/>
            <pc:sldMk cId="2411453857" sldId="312"/>
            <ac:spMk id="4" creationId="{825CDFDD-8D50-8927-860F-831517FA84C2}"/>
          </ac:spMkLst>
        </pc:spChg>
        <pc:spChg chg="add mod">
          <ac:chgData name="Mbambo, Gillian" userId="59bfad07-67e3-47a4-ac55-04ee0a07a20e" providerId="ADAL" clId="{689D5830-7D20-EF43-9790-B7D919905F98}" dt="2023-05-26T23:54:23.478" v="2520" actId="20577"/>
          <ac:spMkLst>
            <pc:docMk/>
            <pc:sldMk cId="2411453857" sldId="312"/>
            <ac:spMk id="5" creationId="{94CE87A6-6D12-EC1A-B1F4-D4FCEB284F38}"/>
          </ac:spMkLst>
        </pc:spChg>
        <pc:spChg chg="add mod">
          <ac:chgData name="Mbambo, Gillian" userId="59bfad07-67e3-47a4-ac55-04ee0a07a20e" providerId="ADAL" clId="{689D5830-7D20-EF43-9790-B7D919905F98}" dt="2023-05-27T10:07:43.631" v="2892" actId="1037"/>
          <ac:spMkLst>
            <pc:docMk/>
            <pc:sldMk cId="2411453857" sldId="312"/>
            <ac:spMk id="6" creationId="{C489D173-9D0C-96C4-E494-DE627DDCEA80}"/>
          </ac:spMkLst>
        </pc:spChg>
        <pc:spChg chg="add mod">
          <ac:chgData name="Mbambo, Gillian" userId="59bfad07-67e3-47a4-ac55-04ee0a07a20e" providerId="ADAL" clId="{689D5830-7D20-EF43-9790-B7D919905F98}" dt="2023-05-27T21:03:28.270" v="3210" actId="571"/>
          <ac:spMkLst>
            <pc:docMk/>
            <pc:sldMk cId="2411453857" sldId="312"/>
            <ac:spMk id="7" creationId="{D792951B-16B4-F5CE-003E-FC932FF0E8D1}"/>
          </ac:spMkLst>
        </pc:spChg>
        <pc:spChg chg="add mod">
          <ac:chgData name="Mbambo, Gillian" userId="59bfad07-67e3-47a4-ac55-04ee0a07a20e" providerId="ADAL" clId="{689D5830-7D20-EF43-9790-B7D919905F98}" dt="2023-05-27T21:04:53.609" v="3217"/>
          <ac:spMkLst>
            <pc:docMk/>
            <pc:sldMk cId="2411453857" sldId="312"/>
            <ac:spMk id="8" creationId="{D498D8F3-EA53-D7E0-4A86-94027ED98F66}"/>
          </ac:spMkLst>
        </pc:spChg>
        <pc:spChg chg="add mod">
          <ac:chgData name="Mbambo, Gillian" userId="59bfad07-67e3-47a4-ac55-04ee0a07a20e" providerId="ADAL" clId="{689D5830-7D20-EF43-9790-B7D919905F98}" dt="2023-05-26T23:51:27.410" v="2491" actId="20577"/>
          <ac:spMkLst>
            <pc:docMk/>
            <pc:sldMk cId="2411453857" sldId="312"/>
            <ac:spMk id="9" creationId="{B4CB693D-93FA-14B4-54CD-B5ED0CB91756}"/>
          </ac:spMkLst>
        </pc:spChg>
        <pc:spChg chg="add del mod">
          <ac:chgData name="Mbambo, Gillian" userId="59bfad07-67e3-47a4-ac55-04ee0a07a20e" providerId="ADAL" clId="{689D5830-7D20-EF43-9790-B7D919905F98}" dt="2023-05-26T21:10:34.507" v="2048" actId="21"/>
          <ac:spMkLst>
            <pc:docMk/>
            <pc:sldMk cId="2411453857" sldId="312"/>
            <ac:spMk id="16" creationId="{10A23BD5-C16A-D15E-E0D9-46334BC019A4}"/>
          </ac:spMkLst>
        </pc:spChg>
        <pc:spChg chg="add del mod">
          <ac:chgData name="Mbambo, Gillian" userId="59bfad07-67e3-47a4-ac55-04ee0a07a20e" providerId="ADAL" clId="{689D5830-7D20-EF43-9790-B7D919905F98}" dt="2023-05-26T23:50:48.199" v="2478" actId="478"/>
          <ac:spMkLst>
            <pc:docMk/>
            <pc:sldMk cId="2411453857" sldId="312"/>
            <ac:spMk id="19" creationId="{9D1DF0FC-37E9-C138-C26E-B2A0E2BD7FC8}"/>
          </ac:spMkLst>
        </pc:spChg>
        <pc:spChg chg="add del mod">
          <ac:chgData name="Mbambo, Gillian" userId="59bfad07-67e3-47a4-ac55-04ee0a07a20e" providerId="ADAL" clId="{689D5830-7D20-EF43-9790-B7D919905F98}" dt="2023-05-26T23:50:48.199" v="2478" actId="478"/>
          <ac:spMkLst>
            <pc:docMk/>
            <pc:sldMk cId="2411453857" sldId="312"/>
            <ac:spMk id="20" creationId="{68EE7861-4ADB-DE4F-0AD8-D93BD5D1D6CA}"/>
          </ac:spMkLst>
        </pc:spChg>
        <pc:spChg chg="add del mod">
          <ac:chgData name="Mbambo, Gillian" userId="59bfad07-67e3-47a4-ac55-04ee0a07a20e" providerId="ADAL" clId="{689D5830-7D20-EF43-9790-B7D919905F98}" dt="2023-05-26T23:50:48.199" v="2478" actId="478"/>
          <ac:spMkLst>
            <pc:docMk/>
            <pc:sldMk cId="2411453857" sldId="312"/>
            <ac:spMk id="21" creationId="{ED1F4771-2329-1CB5-D651-A95684C4B717}"/>
          </ac:spMkLst>
        </pc:spChg>
        <pc:spChg chg="add mod">
          <ac:chgData name="Mbambo, Gillian" userId="59bfad07-67e3-47a4-ac55-04ee0a07a20e" providerId="ADAL" clId="{689D5830-7D20-EF43-9790-B7D919905F98}" dt="2023-05-26T23:52:23.614" v="2504" actId="1076"/>
          <ac:spMkLst>
            <pc:docMk/>
            <pc:sldMk cId="2411453857" sldId="312"/>
            <ac:spMk id="28" creationId="{F21872E9-C619-3037-D619-DF86A690DC6E}"/>
          </ac:spMkLst>
        </pc:spChg>
        <pc:spChg chg="add mod">
          <ac:chgData name="Mbambo, Gillian" userId="59bfad07-67e3-47a4-ac55-04ee0a07a20e" providerId="ADAL" clId="{689D5830-7D20-EF43-9790-B7D919905F98}" dt="2023-05-26T23:52:23.614" v="2504" actId="1076"/>
          <ac:spMkLst>
            <pc:docMk/>
            <pc:sldMk cId="2411453857" sldId="312"/>
            <ac:spMk id="29" creationId="{6B09EF87-29B9-9BF7-EF8D-F904DE5FDA54}"/>
          </ac:spMkLst>
        </pc:spChg>
        <pc:spChg chg="add del mod">
          <ac:chgData name="Mbambo, Gillian" userId="59bfad07-67e3-47a4-ac55-04ee0a07a20e" providerId="ADAL" clId="{689D5830-7D20-EF43-9790-B7D919905F98}" dt="2023-05-27T10:07:37.312" v="2879" actId="478"/>
          <ac:spMkLst>
            <pc:docMk/>
            <pc:sldMk cId="2411453857" sldId="312"/>
            <ac:spMk id="30" creationId="{2E8BBFBD-9603-5662-CF9B-434F101E9010}"/>
          </ac:spMkLst>
        </pc:spChg>
        <pc:spChg chg="add mod">
          <ac:chgData name="Mbambo, Gillian" userId="59bfad07-67e3-47a4-ac55-04ee0a07a20e" providerId="ADAL" clId="{689D5830-7D20-EF43-9790-B7D919905F98}" dt="2023-05-26T23:51:48.613" v="2500" actId="14100"/>
          <ac:spMkLst>
            <pc:docMk/>
            <pc:sldMk cId="2411453857" sldId="312"/>
            <ac:spMk id="31" creationId="{4F1D02FC-4F3A-71D3-E287-245D6A4680D8}"/>
          </ac:spMkLst>
        </pc:spChg>
        <pc:spChg chg="add mod">
          <ac:chgData name="Mbambo, Gillian" userId="59bfad07-67e3-47a4-ac55-04ee0a07a20e" providerId="ADAL" clId="{689D5830-7D20-EF43-9790-B7D919905F98}" dt="2023-05-26T23:51:38.995" v="2497" actId="14100"/>
          <ac:spMkLst>
            <pc:docMk/>
            <pc:sldMk cId="2411453857" sldId="312"/>
            <ac:spMk id="32" creationId="{31CFFB0F-AAE2-6FA3-A09B-6DA3F3C6AFFC}"/>
          </ac:spMkLst>
        </pc:spChg>
        <pc:picChg chg="add mod">
          <ac:chgData name="Mbambo, Gillian" userId="59bfad07-67e3-47a4-ac55-04ee0a07a20e" providerId="ADAL" clId="{689D5830-7D20-EF43-9790-B7D919905F98}" dt="2023-05-27T10:07:47.947" v="2905" actId="1035"/>
          <ac:picMkLst>
            <pc:docMk/>
            <pc:sldMk cId="2411453857" sldId="312"/>
            <ac:picMk id="3" creationId="{F2F33824-28BE-B52E-940E-FDAB90BE79BB}"/>
          </ac:picMkLst>
        </pc:picChg>
        <pc:picChg chg="add del mod">
          <ac:chgData name="Mbambo, Gillian" userId="59bfad07-67e3-47a4-ac55-04ee0a07a20e" providerId="ADAL" clId="{689D5830-7D20-EF43-9790-B7D919905F98}" dt="2023-05-24T17:44:14.527" v="626" actId="478"/>
          <ac:picMkLst>
            <pc:docMk/>
            <pc:sldMk cId="2411453857" sldId="312"/>
            <ac:picMk id="6" creationId="{F1D92F59-DC4F-3F29-7CC4-242A2AF7C21C}"/>
          </ac:picMkLst>
        </pc:picChg>
        <pc:picChg chg="add del mod">
          <ac:chgData name="Mbambo, Gillian" userId="59bfad07-67e3-47a4-ac55-04ee0a07a20e" providerId="ADAL" clId="{689D5830-7D20-EF43-9790-B7D919905F98}" dt="2023-05-24T17:47:42.937" v="668" actId="478"/>
          <ac:picMkLst>
            <pc:docMk/>
            <pc:sldMk cId="2411453857" sldId="312"/>
            <ac:picMk id="8" creationId="{C0A63670-6C2E-7992-0809-2694F34D0F1C}"/>
          </ac:picMkLst>
        </pc:picChg>
        <pc:picChg chg="add del mod">
          <ac:chgData name="Mbambo, Gillian" userId="59bfad07-67e3-47a4-ac55-04ee0a07a20e" providerId="ADAL" clId="{689D5830-7D20-EF43-9790-B7D919905F98}" dt="2023-05-27T16:11:47.493" v="3122" actId="21"/>
          <ac:picMkLst>
            <pc:docMk/>
            <pc:sldMk cId="2411453857" sldId="312"/>
            <ac:picMk id="8" creationId="{CFFAF813-5BF7-7DCA-B9E7-080D773174E9}"/>
          </ac:picMkLst>
        </pc:picChg>
        <pc:picChg chg="add del mod">
          <ac:chgData name="Mbambo, Gillian" userId="59bfad07-67e3-47a4-ac55-04ee0a07a20e" providerId="ADAL" clId="{689D5830-7D20-EF43-9790-B7D919905F98}" dt="2023-05-26T22:32:55.501" v="2203" actId="478"/>
          <ac:picMkLst>
            <pc:docMk/>
            <pc:sldMk cId="2411453857" sldId="312"/>
            <ac:picMk id="11" creationId="{7AF9D4FC-F68F-87C1-0945-5BC3A4676684}"/>
          </ac:picMkLst>
        </pc:picChg>
        <pc:picChg chg="add del mod">
          <ac:chgData name="Mbambo, Gillian" userId="59bfad07-67e3-47a4-ac55-04ee0a07a20e" providerId="ADAL" clId="{689D5830-7D20-EF43-9790-B7D919905F98}" dt="2023-05-27T16:11:30.510" v="3112"/>
          <ac:picMkLst>
            <pc:docMk/>
            <pc:sldMk cId="2411453857" sldId="312"/>
            <ac:picMk id="11" creationId="{93C5615A-95F0-9D7B-7553-D48DC1D89085}"/>
          </ac:picMkLst>
        </pc:picChg>
        <pc:picChg chg="add mod">
          <ac:chgData name="Mbambo, Gillian" userId="59bfad07-67e3-47a4-ac55-04ee0a07a20e" providerId="ADAL" clId="{689D5830-7D20-EF43-9790-B7D919905F98}" dt="2023-05-27T11:54:27.475" v="3067" actId="1037"/>
          <ac:picMkLst>
            <pc:docMk/>
            <pc:sldMk cId="2411453857" sldId="312"/>
            <ac:picMk id="13" creationId="{D9F9A648-E1BF-2A15-78A6-4A51BC3E1106}"/>
          </ac:picMkLst>
        </pc:picChg>
        <pc:picChg chg="add del mod">
          <ac:chgData name="Mbambo, Gillian" userId="59bfad07-67e3-47a4-ac55-04ee0a07a20e" providerId="ADAL" clId="{689D5830-7D20-EF43-9790-B7D919905F98}" dt="2023-05-26T21:10:34.507" v="2048" actId="21"/>
          <ac:picMkLst>
            <pc:docMk/>
            <pc:sldMk cId="2411453857" sldId="312"/>
            <ac:picMk id="15" creationId="{19F8B8ED-6F4C-8CC5-49D7-453533C46BC9}"/>
          </ac:picMkLst>
        </pc:picChg>
        <pc:picChg chg="add del mod">
          <ac:chgData name="Mbambo, Gillian" userId="59bfad07-67e3-47a4-ac55-04ee0a07a20e" providerId="ADAL" clId="{689D5830-7D20-EF43-9790-B7D919905F98}" dt="2023-05-26T22:19:55.230" v="2078" actId="21"/>
          <ac:picMkLst>
            <pc:docMk/>
            <pc:sldMk cId="2411453857" sldId="312"/>
            <ac:picMk id="18" creationId="{639D4EB2-8D94-CAB5-4FFD-F670FB68D009}"/>
          </ac:picMkLst>
        </pc:picChg>
        <pc:picChg chg="add del mod">
          <ac:chgData name="Mbambo, Gillian" userId="59bfad07-67e3-47a4-ac55-04ee0a07a20e" providerId="ADAL" clId="{689D5830-7D20-EF43-9790-B7D919905F98}" dt="2023-05-27T16:11:44.512" v="3121" actId="478"/>
          <ac:picMkLst>
            <pc:docMk/>
            <pc:sldMk cId="2411453857" sldId="312"/>
            <ac:picMk id="23" creationId="{0AA224F4-6F67-1138-633C-784BCF96E9F6}"/>
          </ac:picMkLst>
        </pc:picChg>
        <pc:picChg chg="add mod">
          <ac:chgData name="Mbambo, Gillian" userId="59bfad07-67e3-47a4-ac55-04ee0a07a20e" providerId="ADAL" clId="{689D5830-7D20-EF43-9790-B7D919905F98}" dt="2023-05-26T23:51:12.643" v="2485" actId="1037"/>
          <ac:picMkLst>
            <pc:docMk/>
            <pc:sldMk cId="2411453857" sldId="312"/>
            <ac:picMk id="25" creationId="{1E6A85F8-DBE4-4A0F-FC0C-D2E753040F3B}"/>
          </ac:picMkLst>
        </pc:picChg>
        <pc:picChg chg="add del mod">
          <ac:chgData name="Mbambo, Gillian" userId="59bfad07-67e3-47a4-ac55-04ee0a07a20e" providerId="ADAL" clId="{689D5830-7D20-EF43-9790-B7D919905F98}" dt="2023-05-27T10:07:04.074" v="2851" actId="478"/>
          <ac:picMkLst>
            <pc:docMk/>
            <pc:sldMk cId="2411453857" sldId="312"/>
            <ac:picMk id="27" creationId="{E53A41E0-BFEC-DDC4-95ED-459CDA6D0313}"/>
          </ac:picMkLst>
        </pc:picChg>
      </pc:sldChg>
      <pc:sldChg chg="addSp delSp modSp new del mod ord">
        <pc:chgData name="Mbambo, Gillian" userId="59bfad07-67e3-47a4-ac55-04ee0a07a20e" providerId="ADAL" clId="{689D5830-7D20-EF43-9790-B7D919905F98}" dt="2023-05-27T21:30:22.256" v="3674" actId="2696"/>
        <pc:sldMkLst>
          <pc:docMk/>
          <pc:sldMk cId="2556373764" sldId="313"/>
        </pc:sldMkLst>
        <pc:spChg chg="del">
          <ac:chgData name="Mbambo, Gillian" userId="59bfad07-67e3-47a4-ac55-04ee0a07a20e" providerId="ADAL" clId="{689D5830-7D20-EF43-9790-B7D919905F98}" dt="2023-05-24T17:52:27.248" v="680" actId="478"/>
          <ac:spMkLst>
            <pc:docMk/>
            <pc:sldMk cId="2556373764" sldId="313"/>
            <ac:spMk id="2" creationId="{50CD0249-2307-EA84-C70E-1B3E5FBFB136}"/>
          </ac:spMkLst>
        </pc:spChg>
        <pc:spChg chg="add mod">
          <ac:chgData name="Mbambo, Gillian" userId="59bfad07-67e3-47a4-ac55-04ee0a07a20e" providerId="ADAL" clId="{689D5830-7D20-EF43-9790-B7D919905F98}" dt="2023-05-27T21:04:43.274" v="3215"/>
          <ac:spMkLst>
            <pc:docMk/>
            <pc:sldMk cId="2556373764" sldId="313"/>
            <ac:spMk id="2" creationId="{CBB0C64E-1F3E-4C10-4505-5EDBC8809E2A}"/>
          </ac:spMkLst>
        </pc:spChg>
        <pc:spChg chg="del">
          <ac:chgData name="Mbambo, Gillian" userId="59bfad07-67e3-47a4-ac55-04ee0a07a20e" providerId="ADAL" clId="{689D5830-7D20-EF43-9790-B7D919905F98}" dt="2023-05-24T17:52:22.714" v="678"/>
          <ac:spMkLst>
            <pc:docMk/>
            <pc:sldMk cId="2556373764" sldId="313"/>
            <ac:spMk id="3" creationId="{EE5434CB-1E32-62FB-288F-2134512709F0}"/>
          </ac:spMkLst>
        </pc:spChg>
        <pc:spChg chg="add del mod">
          <ac:chgData name="Mbambo, Gillian" userId="59bfad07-67e3-47a4-ac55-04ee0a07a20e" providerId="ADAL" clId="{689D5830-7D20-EF43-9790-B7D919905F98}" dt="2023-05-26T21:08:25.589" v="1989" actId="478"/>
          <ac:spMkLst>
            <pc:docMk/>
            <pc:sldMk cId="2556373764" sldId="313"/>
            <ac:spMk id="5" creationId="{5A5B3F29-224A-A559-3B04-272F4DD3222B}"/>
          </ac:spMkLst>
        </pc:spChg>
        <pc:spChg chg="add mod">
          <ac:chgData name="Mbambo, Gillian" userId="59bfad07-67e3-47a4-ac55-04ee0a07a20e" providerId="ADAL" clId="{689D5830-7D20-EF43-9790-B7D919905F98}" dt="2023-05-26T23:54:29.042" v="2523" actId="20577"/>
          <ac:spMkLst>
            <pc:docMk/>
            <pc:sldMk cId="2556373764" sldId="313"/>
            <ac:spMk id="6" creationId="{354B093C-BF4A-EDAA-72F2-A766BB4F86BD}"/>
          </ac:spMkLst>
        </pc:spChg>
        <pc:spChg chg="add del mod">
          <ac:chgData name="Mbambo, Gillian" userId="59bfad07-67e3-47a4-ac55-04ee0a07a20e" providerId="ADAL" clId="{689D5830-7D20-EF43-9790-B7D919905F98}" dt="2023-05-27T21:04:42.447" v="3214" actId="478"/>
          <ac:spMkLst>
            <pc:docMk/>
            <pc:sldMk cId="2556373764" sldId="313"/>
            <ac:spMk id="7" creationId="{C40FF799-6783-7CCE-2D58-F16ABE4FAC43}"/>
          </ac:spMkLst>
        </pc:spChg>
        <pc:spChg chg="add mod">
          <ac:chgData name="Mbambo, Gillian" userId="59bfad07-67e3-47a4-ac55-04ee0a07a20e" providerId="ADAL" clId="{689D5830-7D20-EF43-9790-B7D919905F98}" dt="2023-05-27T11:54:17.858" v="3062" actId="1076"/>
          <ac:spMkLst>
            <pc:docMk/>
            <pc:sldMk cId="2556373764" sldId="313"/>
            <ac:spMk id="9" creationId="{6E8A74D4-C628-51E3-BB5C-56689AC772FE}"/>
          </ac:spMkLst>
        </pc:spChg>
        <pc:spChg chg="add mod">
          <ac:chgData name="Mbambo, Gillian" userId="59bfad07-67e3-47a4-ac55-04ee0a07a20e" providerId="ADAL" clId="{689D5830-7D20-EF43-9790-B7D919905F98}" dt="2023-05-27T11:52:54.004" v="3053" actId="1037"/>
          <ac:spMkLst>
            <pc:docMk/>
            <pc:sldMk cId="2556373764" sldId="313"/>
            <ac:spMk id="17" creationId="{6402CEC5-151B-605A-8966-FD98B1B30E14}"/>
          </ac:spMkLst>
        </pc:spChg>
        <pc:spChg chg="add mod">
          <ac:chgData name="Mbambo, Gillian" userId="59bfad07-67e3-47a4-ac55-04ee0a07a20e" providerId="ADAL" clId="{689D5830-7D20-EF43-9790-B7D919905F98}" dt="2023-05-27T11:53:53.364" v="3058" actId="20577"/>
          <ac:spMkLst>
            <pc:docMk/>
            <pc:sldMk cId="2556373764" sldId="313"/>
            <ac:spMk id="23" creationId="{DB66C3D2-A118-2663-94B1-5BBFD9C4764E}"/>
          </ac:spMkLst>
        </pc:spChg>
        <pc:spChg chg="add mod">
          <ac:chgData name="Mbambo, Gillian" userId="59bfad07-67e3-47a4-ac55-04ee0a07a20e" providerId="ADAL" clId="{689D5830-7D20-EF43-9790-B7D919905F98}" dt="2023-05-27T11:53:55.881" v="3059" actId="20577"/>
          <ac:spMkLst>
            <pc:docMk/>
            <pc:sldMk cId="2556373764" sldId="313"/>
            <ac:spMk id="24" creationId="{DBDECF43-C788-EAB3-60A7-0EDDEB1C4DC8}"/>
          </ac:spMkLst>
        </pc:spChg>
        <pc:spChg chg="add mod">
          <ac:chgData name="Mbambo, Gillian" userId="59bfad07-67e3-47a4-ac55-04ee0a07a20e" providerId="ADAL" clId="{689D5830-7D20-EF43-9790-B7D919905F98}" dt="2023-05-27T11:53:58.377" v="3060" actId="20577"/>
          <ac:spMkLst>
            <pc:docMk/>
            <pc:sldMk cId="2556373764" sldId="313"/>
            <ac:spMk id="25" creationId="{5C384892-7C12-D28E-0E85-4C8FB625E399}"/>
          </ac:spMkLst>
        </pc:spChg>
        <pc:spChg chg="add mod">
          <ac:chgData name="Mbambo, Gillian" userId="59bfad07-67e3-47a4-ac55-04ee0a07a20e" providerId="ADAL" clId="{689D5830-7D20-EF43-9790-B7D919905F98}" dt="2023-05-27T11:54:12.176" v="3061" actId="1076"/>
          <ac:spMkLst>
            <pc:docMk/>
            <pc:sldMk cId="2556373764" sldId="313"/>
            <ac:spMk id="32" creationId="{AEC7A72C-BC3E-8C60-CB4E-42D9FF3C7458}"/>
          </ac:spMkLst>
        </pc:spChg>
        <pc:picChg chg="add mod">
          <ac:chgData name="Mbambo, Gillian" userId="59bfad07-67e3-47a4-ac55-04ee0a07a20e" providerId="ADAL" clId="{689D5830-7D20-EF43-9790-B7D919905F98}" dt="2023-05-27T02:22:52.469" v="2535" actId="14100"/>
          <ac:picMkLst>
            <pc:docMk/>
            <pc:sldMk cId="2556373764" sldId="313"/>
            <ac:picMk id="4" creationId="{50CE70BF-1756-DDF7-2FBF-D5B765E4DF36}"/>
          </ac:picMkLst>
        </pc:picChg>
        <pc:picChg chg="add del mod">
          <ac:chgData name="Mbambo, Gillian" userId="59bfad07-67e3-47a4-ac55-04ee0a07a20e" providerId="ADAL" clId="{689D5830-7D20-EF43-9790-B7D919905F98}" dt="2023-05-26T22:20:09.792" v="2082" actId="478"/>
          <ac:picMkLst>
            <pc:docMk/>
            <pc:sldMk cId="2556373764" sldId="313"/>
            <ac:picMk id="8" creationId="{34C41982-6E1A-5EDE-2AE2-E91523BFB999}"/>
          </ac:picMkLst>
        </pc:picChg>
        <pc:picChg chg="add del mod">
          <ac:chgData name="Mbambo, Gillian" userId="59bfad07-67e3-47a4-ac55-04ee0a07a20e" providerId="ADAL" clId="{689D5830-7D20-EF43-9790-B7D919905F98}" dt="2023-05-26T22:21:06.272" v="2092" actId="478"/>
          <ac:picMkLst>
            <pc:docMk/>
            <pc:sldMk cId="2556373764" sldId="313"/>
            <ac:picMk id="10" creationId="{E5003BD8-8B20-B3F9-E6E3-4489354C833A}"/>
          </ac:picMkLst>
        </pc:picChg>
        <pc:picChg chg="add del mod">
          <ac:chgData name="Mbambo, Gillian" userId="59bfad07-67e3-47a4-ac55-04ee0a07a20e" providerId="ADAL" clId="{689D5830-7D20-EF43-9790-B7D919905F98}" dt="2023-05-26T22:22:55.667" v="2102" actId="478"/>
          <ac:picMkLst>
            <pc:docMk/>
            <pc:sldMk cId="2556373764" sldId="313"/>
            <ac:picMk id="12" creationId="{5463E4C3-DF40-9F83-3A3C-501B8952BEF4}"/>
          </ac:picMkLst>
        </pc:picChg>
        <pc:picChg chg="add del mod">
          <ac:chgData name="Mbambo, Gillian" userId="59bfad07-67e3-47a4-ac55-04ee0a07a20e" providerId="ADAL" clId="{689D5830-7D20-EF43-9790-B7D919905F98}" dt="2023-05-26T22:59:04.161" v="2237" actId="478"/>
          <ac:picMkLst>
            <pc:docMk/>
            <pc:sldMk cId="2556373764" sldId="313"/>
            <ac:picMk id="14" creationId="{50D9506A-FD9E-EF61-B07C-534471003B24}"/>
          </ac:picMkLst>
        </pc:picChg>
        <pc:picChg chg="add del mod">
          <ac:chgData name="Mbambo, Gillian" userId="59bfad07-67e3-47a4-ac55-04ee0a07a20e" providerId="ADAL" clId="{689D5830-7D20-EF43-9790-B7D919905F98}" dt="2023-05-26T22:51:42.781" v="2233" actId="478"/>
          <ac:picMkLst>
            <pc:docMk/>
            <pc:sldMk cId="2556373764" sldId="313"/>
            <ac:picMk id="16" creationId="{1986E9A5-874E-A807-9D61-5F59D8547862}"/>
          </ac:picMkLst>
        </pc:picChg>
        <pc:picChg chg="add del mod">
          <ac:chgData name="Mbambo, Gillian" userId="59bfad07-67e3-47a4-ac55-04ee0a07a20e" providerId="ADAL" clId="{689D5830-7D20-EF43-9790-B7D919905F98}" dt="2023-05-26T23:00:00.725" v="2245" actId="478"/>
          <ac:picMkLst>
            <pc:docMk/>
            <pc:sldMk cId="2556373764" sldId="313"/>
            <ac:picMk id="18" creationId="{27FD311D-5315-AE19-52BD-3723E48A84E2}"/>
          </ac:picMkLst>
        </pc:picChg>
        <pc:picChg chg="add del mod">
          <ac:chgData name="Mbambo, Gillian" userId="59bfad07-67e3-47a4-ac55-04ee0a07a20e" providerId="ADAL" clId="{689D5830-7D20-EF43-9790-B7D919905F98}" dt="2023-05-26T23:05:29.892" v="2301" actId="478"/>
          <ac:picMkLst>
            <pc:docMk/>
            <pc:sldMk cId="2556373764" sldId="313"/>
            <ac:picMk id="20" creationId="{3E88C44B-AC57-24B0-FF7D-E2415CC8B1FF}"/>
          </ac:picMkLst>
        </pc:picChg>
        <pc:picChg chg="add del mod">
          <ac:chgData name="Mbambo, Gillian" userId="59bfad07-67e3-47a4-ac55-04ee0a07a20e" providerId="ADAL" clId="{689D5830-7D20-EF43-9790-B7D919905F98}" dt="2023-05-26T23:05:32.548" v="2303" actId="478"/>
          <ac:picMkLst>
            <pc:docMk/>
            <pc:sldMk cId="2556373764" sldId="313"/>
            <ac:picMk id="22" creationId="{8E89EE37-F189-8F7A-D7E0-B73515145278}"/>
          </ac:picMkLst>
        </pc:picChg>
        <pc:picChg chg="add mod">
          <ac:chgData name="Mbambo, Gillian" userId="59bfad07-67e3-47a4-ac55-04ee0a07a20e" providerId="ADAL" clId="{689D5830-7D20-EF43-9790-B7D919905F98}" dt="2023-05-27T02:22:59.921" v="2536" actId="14100"/>
          <ac:picMkLst>
            <pc:docMk/>
            <pc:sldMk cId="2556373764" sldId="313"/>
            <ac:picMk id="27" creationId="{733261ED-53A6-6B81-F6BE-B421DAACBB5E}"/>
          </ac:picMkLst>
        </pc:picChg>
        <pc:picChg chg="add mod">
          <ac:chgData name="Mbambo, Gillian" userId="59bfad07-67e3-47a4-ac55-04ee0a07a20e" providerId="ADAL" clId="{689D5830-7D20-EF43-9790-B7D919905F98}" dt="2023-05-27T02:22:59.921" v="2536" actId="14100"/>
          <ac:picMkLst>
            <pc:docMk/>
            <pc:sldMk cId="2556373764" sldId="313"/>
            <ac:picMk id="29" creationId="{2D1C3AAC-FE7C-C1D4-AE2B-716623033F6A}"/>
          </ac:picMkLst>
        </pc:picChg>
        <pc:picChg chg="add mod">
          <ac:chgData name="Mbambo, Gillian" userId="59bfad07-67e3-47a4-ac55-04ee0a07a20e" providerId="ADAL" clId="{689D5830-7D20-EF43-9790-B7D919905F98}" dt="2023-05-27T02:22:59.921" v="2536" actId="14100"/>
          <ac:picMkLst>
            <pc:docMk/>
            <pc:sldMk cId="2556373764" sldId="313"/>
            <ac:picMk id="31" creationId="{B465814E-C969-19D1-8C11-94596FCFEAB0}"/>
          </ac:picMkLst>
        </pc:picChg>
      </pc:sldChg>
      <pc:sldChg chg="addSp delSp modSp add mod">
        <pc:chgData name="Mbambo, Gillian" userId="59bfad07-67e3-47a4-ac55-04ee0a07a20e" providerId="ADAL" clId="{689D5830-7D20-EF43-9790-B7D919905F98}" dt="2023-05-27T11:49:19.352" v="2975" actId="21"/>
        <pc:sldMkLst>
          <pc:docMk/>
          <pc:sldMk cId="483346332" sldId="314"/>
        </pc:sldMkLst>
        <pc:spChg chg="add mod">
          <ac:chgData name="Mbambo, Gillian" userId="59bfad07-67e3-47a4-ac55-04ee0a07a20e" providerId="ADAL" clId="{689D5830-7D20-EF43-9790-B7D919905F98}" dt="2023-05-26T23:53:42.344" v="2507"/>
          <ac:spMkLst>
            <pc:docMk/>
            <pc:sldMk cId="483346332" sldId="314"/>
            <ac:spMk id="2" creationId="{82667F74-2893-BFE2-A5E7-2FBEB5E8B53B}"/>
          </ac:spMkLst>
        </pc:spChg>
        <pc:spChg chg="add del mod">
          <ac:chgData name="Mbambo, Gillian" userId="59bfad07-67e3-47a4-ac55-04ee0a07a20e" providerId="ADAL" clId="{689D5830-7D20-EF43-9790-B7D919905F98}" dt="2023-05-27T02:23:44.227" v="2559" actId="478"/>
          <ac:spMkLst>
            <pc:docMk/>
            <pc:sldMk cId="483346332" sldId="314"/>
            <ac:spMk id="3" creationId="{A18C8760-EE8E-FE10-AA32-30777A6A273B}"/>
          </ac:spMkLst>
        </pc:spChg>
        <pc:spChg chg="add mod">
          <ac:chgData name="Mbambo, Gillian" userId="59bfad07-67e3-47a4-ac55-04ee0a07a20e" providerId="ADAL" clId="{689D5830-7D20-EF43-9790-B7D919905F98}" dt="2023-05-27T02:29:29.508" v="2841" actId="20577"/>
          <ac:spMkLst>
            <pc:docMk/>
            <pc:sldMk cId="483346332" sldId="314"/>
            <ac:spMk id="4" creationId="{E3664156-874B-2D91-E149-1CABE8A0A5AB}"/>
          </ac:spMkLst>
        </pc:spChg>
        <pc:spChg chg="add del mod">
          <ac:chgData name="Mbambo, Gillian" userId="59bfad07-67e3-47a4-ac55-04ee0a07a20e" providerId="ADAL" clId="{689D5830-7D20-EF43-9790-B7D919905F98}" dt="2023-05-27T02:28:01.861" v="2714"/>
          <ac:spMkLst>
            <pc:docMk/>
            <pc:sldMk cId="483346332" sldId="314"/>
            <ac:spMk id="5" creationId="{8916118E-52E0-ABBB-A575-1764BBD49626}"/>
          </ac:spMkLst>
        </pc:spChg>
        <pc:spChg chg="add del mod">
          <ac:chgData name="Mbambo, Gillian" userId="59bfad07-67e3-47a4-ac55-04ee0a07a20e" providerId="ADAL" clId="{689D5830-7D20-EF43-9790-B7D919905F98}" dt="2023-05-27T02:28:01.861" v="2714"/>
          <ac:spMkLst>
            <pc:docMk/>
            <pc:sldMk cId="483346332" sldId="314"/>
            <ac:spMk id="6" creationId="{3885DB49-2BBB-8073-8099-2B99D0E0B474}"/>
          </ac:spMkLst>
        </pc:spChg>
        <pc:spChg chg="add del mod">
          <ac:chgData name="Mbambo, Gillian" userId="59bfad07-67e3-47a4-ac55-04ee0a07a20e" providerId="ADAL" clId="{689D5830-7D20-EF43-9790-B7D919905F98}" dt="2023-05-27T02:28:01.861" v="2714"/>
          <ac:spMkLst>
            <pc:docMk/>
            <pc:sldMk cId="483346332" sldId="314"/>
            <ac:spMk id="7" creationId="{DF537AA0-CEF4-CA80-78BE-43FFA16DF54D}"/>
          </ac:spMkLst>
        </pc:spChg>
        <pc:spChg chg="add mod">
          <ac:chgData name="Mbambo, Gillian" userId="59bfad07-67e3-47a4-ac55-04ee0a07a20e" providerId="ADAL" clId="{689D5830-7D20-EF43-9790-B7D919905F98}" dt="2023-05-27T02:28:12.196" v="2716" actId="1076"/>
          <ac:spMkLst>
            <pc:docMk/>
            <pc:sldMk cId="483346332" sldId="314"/>
            <ac:spMk id="8" creationId="{29B103E6-E9D2-6089-7B55-E768637DA6FC}"/>
          </ac:spMkLst>
        </pc:spChg>
        <pc:spChg chg="add mod">
          <ac:chgData name="Mbambo, Gillian" userId="59bfad07-67e3-47a4-ac55-04ee0a07a20e" providerId="ADAL" clId="{689D5830-7D20-EF43-9790-B7D919905F98}" dt="2023-05-27T02:28:12.196" v="2716" actId="1076"/>
          <ac:spMkLst>
            <pc:docMk/>
            <pc:sldMk cId="483346332" sldId="314"/>
            <ac:spMk id="9" creationId="{6668E0E3-71B6-8D49-D603-6D3E798F690A}"/>
          </ac:spMkLst>
        </pc:spChg>
        <pc:spChg chg="add mod">
          <ac:chgData name="Mbambo, Gillian" userId="59bfad07-67e3-47a4-ac55-04ee0a07a20e" providerId="ADAL" clId="{689D5830-7D20-EF43-9790-B7D919905F98}" dt="2023-05-27T02:28:12.196" v="2716" actId="1076"/>
          <ac:spMkLst>
            <pc:docMk/>
            <pc:sldMk cId="483346332" sldId="314"/>
            <ac:spMk id="10" creationId="{56FB164F-8D67-D8E2-9C0F-8F4C64FBD289}"/>
          </ac:spMkLst>
        </pc:spChg>
        <pc:spChg chg="add mod">
          <ac:chgData name="Mbambo, Gillian" userId="59bfad07-67e3-47a4-ac55-04ee0a07a20e" providerId="ADAL" clId="{689D5830-7D20-EF43-9790-B7D919905F98}" dt="2023-05-27T02:28:37.366" v="2722" actId="20577"/>
          <ac:spMkLst>
            <pc:docMk/>
            <pc:sldMk cId="483346332" sldId="314"/>
            <ac:spMk id="11" creationId="{69123EC7-43F6-AED8-DE60-F4DEE35C1004}"/>
          </ac:spMkLst>
        </pc:spChg>
        <pc:spChg chg="add mod">
          <ac:chgData name="Mbambo, Gillian" userId="59bfad07-67e3-47a4-ac55-04ee0a07a20e" providerId="ADAL" clId="{689D5830-7D20-EF43-9790-B7D919905F98}" dt="2023-05-27T02:28:40.952" v="2724" actId="20577"/>
          <ac:spMkLst>
            <pc:docMk/>
            <pc:sldMk cId="483346332" sldId="314"/>
            <ac:spMk id="12" creationId="{5F4077B9-9BFB-26F2-0A24-1C658BA39C20}"/>
          </ac:spMkLst>
        </pc:spChg>
        <pc:spChg chg="add mod">
          <ac:chgData name="Mbambo, Gillian" userId="59bfad07-67e3-47a4-ac55-04ee0a07a20e" providerId="ADAL" clId="{689D5830-7D20-EF43-9790-B7D919905F98}" dt="2023-05-27T02:28:43.855" v="2725" actId="20577"/>
          <ac:spMkLst>
            <pc:docMk/>
            <pc:sldMk cId="483346332" sldId="314"/>
            <ac:spMk id="13" creationId="{65DAB209-E56D-1DAE-0378-3DF837C878AC}"/>
          </ac:spMkLst>
        </pc:spChg>
        <pc:spChg chg="mod">
          <ac:chgData name="Mbambo, Gillian" userId="59bfad07-67e3-47a4-ac55-04ee0a07a20e" providerId="ADAL" clId="{689D5830-7D20-EF43-9790-B7D919905F98}" dt="2023-05-27T02:23:31.490" v="2557" actId="1035"/>
          <ac:spMkLst>
            <pc:docMk/>
            <pc:sldMk cId="483346332" sldId="314"/>
            <ac:spMk id="15" creationId="{FDE80C30-08A8-5E4C-006B-FC85E00DA56D}"/>
          </ac:spMkLst>
        </pc:spChg>
        <pc:spChg chg="mod">
          <ac:chgData name="Mbambo, Gillian" userId="59bfad07-67e3-47a4-ac55-04ee0a07a20e" providerId="ADAL" clId="{689D5830-7D20-EF43-9790-B7D919905F98}" dt="2023-05-27T02:23:31.490" v="2557" actId="1035"/>
          <ac:spMkLst>
            <pc:docMk/>
            <pc:sldMk cId="483346332" sldId="314"/>
            <ac:spMk id="17" creationId="{AD360D52-3B39-61E6-E62E-27B076A92788}"/>
          </ac:spMkLst>
        </pc:spChg>
        <pc:spChg chg="mod">
          <ac:chgData name="Mbambo, Gillian" userId="59bfad07-67e3-47a4-ac55-04ee0a07a20e" providerId="ADAL" clId="{689D5830-7D20-EF43-9790-B7D919905F98}" dt="2023-05-27T02:23:31.490" v="2557" actId="1035"/>
          <ac:spMkLst>
            <pc:docMk/>
            <pc:sldMk cId="483346332" sldId="314"/>
            <ac:spMk id="20" creationId="{D112320A-F946-555E-D438-E570DDAFA6A6}"/>
          </ac:spMkLst>
        </pc:spChg>
        <pc:spChg chg="mod">
          <ac:chgData name="Mbambo, Gillian" userId="59bfad07-67e3-47a4-ac55-04ee0a07a20e" providerId="ADAL" clId="{689D5830-7D20-EF43-9790-B7D919905F98}" dt="2023-05-27T02:23:31.490" v="2557" actId="1035"/>
          <ac:spMkLst>
            <pc:docMk/>
            <pc:sldMk cId="483346332" sldId="314"/>
            <ac:spMk id="22" creationId="{2AFB3728-B12E-9697-7B8D-15A9A90AA745}"/>
          </ac:spMkLst>
        </pc:spChg>
        <pc:spChg chg="mod">
          <ac:chgData name="Mbambo, Gillian" userId="59bfad07-67e3-47a4-ac55-04ee0a07a20e" providerId="ADAL" clId="{689D5830-7D20-EF43-9790-B7D919905F98}" dt="2023-05-27T02:23:31.490" v="2557" actId="1035"/>
          <ac:spMkLst>
            <pc:docMk/>
            <pc:sldMk cId="483346332" sldId="314"/>
            <ac:spMk id="24" creationId="{E1E41FD8-50E8-966A-8B1C-0426AFFBD036}"/>
          </ac:spMkLst>
        </pc:spChg>
        <pc:picChg chg="add del mod">
          <ac:chgData name="Mbambo, Gillian" userId="59bfad07-67e3-47a4-ac55-04ee0a07a20e" providerId="ADAL" clId="{689D5830-7D20-EF43-9790-B7D919905F98}" dt="2023-05-27T11:49:19.352" v="2975" actId="21"/>
          <ac:picMkLst>
            <pc:docMk/>
            <pc:sldMk cId="483346332" sldId="314"/>
            <ac:picMk id="5" creationId="{FEABB66D-C3AF-F682-5E80-8529B1F24291}"/>
          </ac:picMkLst>
        </pc:picChg>
        <pc:picChg chg="mod">
          <ac:chgData name="Mbambo, Gillian" userId="59bfad07-67e3-47a4-ac55-04ee0a07a20e" providerId="ADAL" clId="{689D5830-7D20-EF43-9790-B7D919905F98}" dt="2023-05-27T02:23:31.490" v="2557" actId="1035"/>
          <ac:picMkLst>
            <pc:docMk/>
            <pc:sldMk cId="483346332" sldId="314"/>
            <ac:picMk id="14" creationId="{9A8C3B3F-2BB3-A6A6-DEB4-E8E44B51710B}"/>
          </ac:picMkLst>
        </pc:picChg>
        <pc:picChg chg="mod">
          <ac:chgData name="Mbambo, Gillian" userId="59bfad07-67e3-47a4-ac55-04ee0a07a20e" providerId="ADAL" clId="{689D5830-7D20-EF43-9790-B7D919905F98}" dt="2023-05-27T02:23:31.490" v="2557" actId="1035"/>
          <ac:picMkLst>
            <pc:docMk/>
            <pc:sldMk cId="483346332" sldId="314"/>
            <ac:picMk id="16" creationId="{7394E871-54B0-8BD8-857E-BF0F70364EB6}"/>
          </ac:picMkLst>
        </pc:picChg>
        <pc:picChg chg="mod">
          <ac:chgData name="Mbambo, Gillian" userId="59bfad07-67e3-47a4-ac55-04ee0a07a20e" providerId="ADAL" clId="{689D5830-7D20-EF43-9790-B7D919905F98}" dt="2023-05-27T02:23:31.490" v="2557" actId="1035"/>
          <ac:picMkLst>
            <pc:docMk/>
            <pc:sldMk cId="483346332" sldId="314"/>
            <ac:picMk id="18" creationId="{18803DB5-8069-B5FA-1C1D-B2EDD5C8F646}"/>
          </ac:picMkLst>
        </pc:picChg>
        <pc:picChg chg="mod">
          <ac:chgData name="Mbambo, Gillian" userId="59bfad07-67e3-47a4-ac55-04ee0a07a20e" providerId="ADAL" clId="{689D5830-7D20-EF43-9790-B7D919905F98}" dt="2023-05-27T02:23:31.490" v="2557" actId="1035"/>
          <ac:picMkLst>
            <pc:docMk/>
            <pc:sldMk cId="483346332" sldId="314"/>
            <ac:picMk id="19" creationId="{10189A94-AE92-12DD-C520-4AE5C2F7D018}"/>
          </ac:picMkLst>
        </pc:picChg>
        <pc:picChg chg="mod">
          <ac:chgData name="Mbambo, Gillian" userId="59bfad07-67e3-47a4-ac55-04ee0a07a20e" providerId="ADAL" clId="{689D5830-7D20-EF43-9790-B7D919905F98}" dt="2023-05-27T02:23:31.490" v="2557" actId="1035"/>
          <ac:picMkLst>
            <pc:docMk/>
            <pc:sldMk cId="483346332" sldId="314"/>
            <ac:picMk id="21" creationId="{AA10A6CE-CE7F-EC05-6315-03D3B868FA6D}"/>
          </ac:picMkLst>
        </pc:picChg>
        <pc:picChg chg="mod">
          <ac:chgData name="Mbambo, Gillian" userId="59bfad07-67e3-47a4-ac55-04ee0a07a20e" providerId="ADAL" clId="{689D5830-7D20-EF43-9790-B7D919905F98}" dt="2023-05-27T02:27:58.707" v="2713" actId="1076"/>
          <ac:picMkLst>
            <pc:docMk/>
            <pc:sldMk cId="483346332" sldId="314"/>
            <ac:picMk id="23" creationId="{8698AF6E-F3A0-6B33-158D-4FC2028BAD95}"/>
          </ac:picMkLst>
        </pc:picChg>
      </pc:sldChg>
      <pc:sldChg chg="addSp delSp modSp new del mod">
        <pc:chgData name="Mbambo, Gillian" userId="59bfad07-67e3-47a4-ac55-04ee0a07a20e" providerId="ADAL" clId="{689D5830-7D20-EF43-9790-B7D919905F98}" dt="2023-05-26T23:53:30.521" v="2505" actId="2696"/>
        <pc:sldMkLst>
          <pc:docMk/>
          <pc:sldMk cId="872973856" sldId="314"/>
        </pc:sldMkLst>
        <pc:spChg chg="add del mod">
          <ac:chgData name="Mbambo, Gillian" userId="59bfad07-67e3-47a4-ac55-04ee0a07a20e" providerId="ADAL" clId="{689D5830-7D20-EF43-9790-B7D919905F98}" dt="2023-05-24T20:21:42.435" v="780" actId="478"/>
          <ac:spMkLst>
            <pc:docMk/>
            <pc:sldMk cId="872973856" sldId="314"/>
            <ac:spMk id="2" creationId="{8957E66D-C5AC-DEC6-4C5E-9DEAFBB38882}"/>
          </ac:spMkLst>
        </pc:spChg>
        <pc:spChg chg="add del">
          <ac:chgData name="Mbambo, Gillian" userId="59bfad07-67e3-47a4-ac55-04ee0a07a20e" providerId="ADAL" clId="{689D5830-7D20-EF43-9790-B7D919905F98}" dt="2023-05-24T20:21:48.056" v="782" actId="478"/>
          <ac:spMkLst>
            <pc:docMk/>
            <pc:sldMk cId="872973856" sldId="314"/>
            <ac:spMk id="3" creationId="{D1949F41-61A0-2B0D-724D-9EF4DD4732C5}"/>
          </ac:spMkLst>
        </pc:spChg>
        <pc:spChg chg="add del mod">
          <ac:chgData name="Mbambo, Gillian" userId="59bfad07-67e3-47a4-ac55-04ee0a07a20e" providerId="ADAL" clId="{689D5830-7D20-EF43-9790-B7D919905F98}" dt="2023-05-24T20:21:32.211" v="774" actId="478"/>
          <ac:spMkLst>
            <pc:docMk/>
            <pc:sldMk cId="872973856" sldId="314"/>
            <ac:spMk id="11" creationId="{0FE68FCC-E0EB-3694-4F5C-7D7D71811976}"/>
          </ac:spMkLst>
        </pc:spChg>
        <pc:spChg chg="add del mod">
          <ac:chgData name="Mbambo, Gillian" userId="59bfad07-67e3-47a4-ac55-04ee0a07a20e" providerId="ADAL" clId="{689D5830-7D20-EF43-9790-B7D919905F98}" dt="2023-05-24T20:21:45.761" v="781" actId="478"/>
          <ac:spMkLst>
            <pc:docMk/>
            <pc:sldMk cId="872973856" sldId="314"/>
            <ac:spMk id="13" creationId="{9EC2965E-6918-0073-A1BC-218E431FC862}"/>
          </ac:spMkLst>
        </pc:spChg>
        <pc:spChg chg="add mod">
          <ac:chgData name="Mbambo, Gillian" userId="59bfad07-67e3-47a4-ac55-04ee0a07a20e" providerId="ADAL" clId="{689D5830-7D20-EF43-9790-B7D919905F98}" dt="2023-05-24T20:22:13.543" v="784" actId="1076"/>
          <ac:spMkLst>
            <pc:docMk/>
            <pc:sldMk cId="872973856" sldId="314"/>
            <ac:spMk id="15" creationId="{FDE80C30-08A8-5E4C-006B-FC85E00DA56D}"/>
          </ac:spMkLst>
        </pc:spChg>
        <pc:spChg chg="add mod">
          <ac:chgData name="Mbambo, Gillian" userId="59bfad07-67e3-47a4-ac55-04ee0a07a20e" providerId="ADAL" clId="{689D5830-7D20-EF43-9790-B7D919905F98}" dt="2023-05-24T20:22:13.543" v="784" actId="1076"/>
          <ac:spMkLst>
            <pc:docMk/>
            <pc:sldMk cId="872973856" sldId="314"/>
            <ac:spMk id="17" creationId="{AD360D52-3B39-61E6-E62E-27B076A92788}"/>
          </ac:spMkLst>
        </pc:spChg>
        <pc:spChg chg="add mod">
          <ac:chgData name="Mbambo, Gillian" userId="59bfad07-67e3-47a4-ac55-04ee0a07a20e" providerId="ADAL" clId="{689D5830-7D20-EF43-9790-B7D919905F98}" dt="2023-05-24T20:22:34.426" v="786" actId="1076"/>
          <ac:spMkLst>
            <pc:docMk/>
            <pc:sldMk cId="872973856" sldId="314"/>
            <ac:spMk id="20" creationId="{D112320A-F946-555E-D438-E570DDAFA6A6}"/>
          </ac:spMkLst>
        </pc:spChg>
        <pc:spChg chg="add mod">
          <ac:chgData name="Mbambo, Gillian" userId="59bfad07-67e3-47a4-ac55-04ee0a07a20e" providerId="ADAL" clId="{689D5830-7D20-EF43-9790-B7D919905F98}" dt="2023-05-24T20:22:34.426" v="786" actId="1076"/>
          <ac:spMkLst>
            <pc:docMk/>
            <pc:sldMk cId="872973856" sldId="314"/>
            <ac:spMk id="22" creationId="{2AFB3728-B12E-9697-7B8D-15A9A90AA745}"/>
          </ac:spMkLst>
        </pc:spChg>
        <pc:spChg chg="add mod">
          <ac:chgData name="Mbambo, Gillian" userId="59bfad07-67e3-47a4-ac55-04ee0a07a20e" providerId="ADAL" clId="{689D5830-7D20-EF43-9790-B7D919905F98}" dt="2023-05-24T20:22:45.293" v="787" actId="1076"/>
          <ac:spMkLst>
            <pc:docMk/>
            <pc:sldMk cId="872973856" sldId="314"/>
            <ac:spMk id="24" creationId="{E1E41FD8-50E8-966A-8B1C-0426AFFBD036}"/>
          </ac:spMkLst>
        </pc:spChg>
        <pc:picChg chg="add del mod">
          <ac:chgData name="Mbambo, Gillian" userId="59bfad07-67e3-47a4-ac55-04ee0a07a20e" providerId="ADAL" clId="{689D5830-7D20-EF43-9790-B7D919905F98}" dt="2023-05-24T20:21:38.462" v="778"/>
          <ac:picMkLst>
            <pc:docMk/>
            <pc:sldMk cId="872973856" sldId="314"/>
            <ac:picMk id="4" creationId="{FC18EFD7-B201-8A56-BE86-538022ADCC46}"/>
          </ac:picMkLst>
        </pc:picChg>
        <pc:picChg chg="add del mod">
          <ac:chgData name="Mbambo, Gillian" userId="59bfad07-67e3-47a4-ac55-04ee0a07a20e" providerId="ADAL" clId="{689D5830-7D20-EF43-9790-B7D919905F98}" dt="2023-05-24T20:21:38.462" v="778"/>
          <ac:picMkLst>
            <pc:docMk/>
            <pc:sldMk cId="872973856" sldId="314"/>
            <ac:picMk id="5" creationId="{B2984FDC-10F3-FF26-385E-157EABE08AFF}"/>
          </ac:picMkLst>
        </pc:picChg>
        <pc:picChg chg="add del mod">
          <ac:chgData name="Mbambo, Gillian" userId="59bfad07-67e3-47a4-ac55-04ee0a07a20e" providerId="ADAL" clId="{689D5830-7D20-EF43-9790-B7D919905F98}" dt="2023-05-24T20:21:38.462" v="778"/>
          <ac:picMkLst>
            <pc:docMk/>
            <pc:sldMk cId="872973856" sldId="314"/>
            <ac:picMk id="6" creationId="{D7D7B8A9-5461-D21F-701A-67BE3DA462B7}"/>
          </ac:picMkLst>
        </pc:picChg>
        <pc:picChg chg="add del mod">
          <ac:chgData name="Mbambo, Gillian" userId="59bfad07-67e3-47a4-ac55-04ee0a07a20e" providerId="ADAL" clId="{689D5830-7D20-EF43-9790-B7D919905F98}" dt="2023-05-24T20:21:35.302" v="776"/>
          <ac:picMkLst>
            <pc:docMk/>
            <pc:sldMk cId="872973856" sldId="314"/>
            <ac:picMk id="7" creationId="{981C3451-325C-A545-AA77-383215366AE3}"/>
          </ac:picMkLst>
        </pc:picChg>
        <pc:picChg chg="add del mod">
          <ac:chgData name="Mbambo, Gillian" userId="59bfad07-67e3-47a4-ac55-04ee0a07a20e" providerId="ADAL" clId="{689D5830-7D20-EF43-9790-B7D919905F98}" dt="2023-05-24T20:21:35.302" v="776"/>
          <ac:picMkLst>
            <pc:docMk/>
            <pc:sldMk cId="872973856" sldId="314"/>
            <ac:picMk id="8" creationId="{FD79265B-DCA2-1F52-D5C7-A8D421456C51}"/>
          </ac:picMkLst>
        </pc:picChg>
        <pc:picChg chg="add del mod">
          <ac:chgData name="Mbambo, Gillian" userId="59bfad07-67e3-47a4-ac55-04ee0a07a20e" providerId="ADAL" clId="{689D5830-7D20-EF43-9790-B7D919905F98}" dt="2023-05-24T20:21:35.302" v="776"/>
          <ac:picMkLst>
            <pc:docMk/>
            <pc:sldMk cId="872973856" sldId="314"/>
            <ac:picMk id="9" creationId="{25026C42-3CD6-D792-8599-483998B788FC}"/>
          </ac:picMkLst>
        </pc:picChg>
        <pc:picChg chg="add mod">
          <ac:chgData name="Mbambo, Gillian" userId="59bfad07-67e3-47a4-ac55-04ee0a07a20e" providerId="ADAL" clId="{689D5830-7D20-EF43-9790-B7D919905F98}" dt="2023-05-24T20:22:13.543" v="784" actId="1076"/>
          <ac:picMkLst>
            <pc:docMk/>
            <pc:sldMk cId="872973856" sldId="314"/>
            <ac:picMk id="14" creationId="{9A8C3B3F-2BB3-A6A6-DEB4-E8E44B51710B}"/>
          </ac:picMkLst>
        </pc:picChg>
        <pc:picChg chg="add mod">
          <ac:chgData name="Mbambo, Gillian" userId="59bfad07-67e3-47a4-ac55-04ee0a07a20e" providerId="ADAL" clId="{689D5830-7D20-EF43-9790-B7D919905F98}" dt="2023-05-24T20:22:13.543" v="784" actId="1076"/>
          <ac:picMkLst>
            <pc:docMk/>
            <pc:sldMk cId="872973856" sldId="314"/>
            <ac:picMk id="16" creationId="{7394E871-54B0-8BD8-857E-BF0F70364EB6}"/>
          </ac:picMkLst>
        </pc:picChg>
        <pc:picChg chg="add mod">
          <ac:chgData name="Mbambo, Gillian" userId="59bfad07-67e3-47a4-ac55-04ee0a07a20e" providerId="ADAL" clId="{689D5830-7D20-EF43-9790-B7D919905F98}" dt="2023-05-24T20:22:13.543" v="784" actId="1076"/>
          <ac:picMkLst>
            <pc:docMk/>
            <pc:sldMk cId="872973856" sldId="314"/>
            <ac:picMk id="18" creationId="{18803DB5-8069-B5FA-1C1D-B2EDD5C8F646}"/>
          </ac:picMkLst>
        </pc:picChg>
        <pc:picChg chg="add mod">
          <ac:chgData name="Mbambo, Gillian" userId="59bfad07-67e3-47a4-ac55-04ee0a07a20e" providerId="ADAL" clId="{689D5830-7D20-EF43-9790-B7D919905F98}" dt="2023-05-24T20:22:34.426" v="786" actId="1076"/>
          <ac:picMkLst>
            <pc:docMk/>
            <pc:sldMk cId="872973856" sldId="314"/>
            <ac:picMk id="19" creationId="{10189A94-AE92-12DD-C520-4AE5C2F7D018}"/>
          </ac:picMkLst>
        </pc:picChg>
        <pc:picChg chg="add mod">
          <ac:chgData name="Mbambo, Gillian" userId="59bfad07-67e3-47a4-ac55-04ee0a07a20e" providerId="ADAL" clId="{689D5830-7D20-EF43-9790-B7D919905F98}" dt="2023-05-24T20:22:34.426" v="786" actId="1076"/>
          <ac:picMkLst>
            <pc:docMk/>
            <pc:sldMk cId="872973856" sldId="314"/>
            <ac:picMk id="21" creationId="{AA10A6CE-CE7F-EC05-6315-03D3B868FA6D}"/>
          </ac:picMkLst>
        </pc:picChg>
        <pc:picChg chg="add mod">
          <ac:chgData name="Mbambo, Gillian" userId="59bfad07-67e3-47a4-ac55-04ee0a07a20e" providerId="ADAL" clId="{689D5830-7D20-EF43-9790-B7D919905F98}" dt="2023-05-24T20:22:49.856" v="791" actId="1037"/>
          <ac:picMkLst>
            <pc:docMk/>
            <pc:sldMk cId="872973856" sldId="314"/>
            <ac:picMk id="23" creationId="{8698AF6E-F3A0-6B33-158D-4FC2028BAD95}"/>
          </ac:picMkLst>
        </pc:picChg>
      </pc:sldChg>
      <pc:sldChg chg="add del">
        <pc:chgData name="Mbambo, Gillian" userId="59bfad07-67e3-47a4-ac55-04ee0a07a20e" providerId="ADAL" clId="{689D5830-7D20-EF43-9790-B7D919905F98}" dt="2023-05-27T12:06:41.261" v="3093"/>
        <pc:sldMkLst>
          <pc:docMk/>
          <pc:sldMk cId="3237220648" sldId="315"/>
        </pc:sldMkLst>
      </pc:sldChg>
      <pc:sldChg chg="addSp delSp modSp add mod">
        <pc:chgData name="Mbambo, Gillian" userId="59bfad07-67e3-47a4-ac55-04ee0a07a20e" providerId="ADAL" clId="{689D5830-7D20-EF43-9790-B7D919905F98}" dt="2023-06-02T18:31:29.462" v="5026" actId="113"/>
        <pc:sldMkLst>
          <pc:docMk/>
          <pc:sldMk cId="3641570371" sldId="315"/>
        </pc:sldMkLst>
        <pc:spChg chg="mod">
          <ac:chgData name="Mbambo, Gillian" userId="59bfad07-67e3-47a4-ac55-04ee0a07a20e" providerId="ADAL" clId="{689D5830-7D20-EF43-9790-B7D919905F98}" dt="2023-05-27T21:26:55.037" v="3512" actId="1076"/>
          <ac:spMkLst>
            <pc:docMk/>
            <pc:sldMk cId="3641570371" sldId="315"/>
            <ac:spMk id="6" creationId="{354B093C-BF4A-EDAA-72F2-A766BB4F86BD}"/>
          </ac:spMkLst>
        </pc:spChg>
        <pc:spChg chg="mod">
          <ac:chgData name="Mbambo, Gillian" userId="59bfad07-67e3-47a4-ac55-04ee0a07a20e" providerId="ADAL" clId="{689D5830-7D20-EF43-9790-B7D919905F98}" dt="2023-05-27T21:04:20.438" v="3213"/>
          <ac:spMkLst>
            <pc:docMk/>
            <pc:sldMk cId="3641570371" sldId="315"/>
            <ac:spMk id="7" creationId="{C40FF799-6783-7CCE-2D58-F16ABE4FAC43}"/>
          </ac:spMkLst>
        </pc:spChg>
        <pc:spChg chg="del mod">
          <ac:chgData name="Mbambo, Gillian" userId="59bfad07-67e3-47a4-ac55-04ee0a07a20e" providerId="ADAL" clId="{689D5830-7D20-EF43-9790-B7D919905F98}" dt="2023-05-27T21:27:31.369" v="3572" actId="478"/>
          <ac:spMkLst>
            <pc:docMk/>
            <pc:sldMk cId="3641570371" sldId="315"/>
            <ac:spMk id="9" creationId="{6E8A74D4-C628-51E3-BB5C-56689AC772FE}"/>
          </ac:spMkLst>
        </pc:spChg>
        <pc:spChg chg="add del mod">
          <ac:chgData name="Mbambo, Gillian" userId="59bfad07-67e3-47a4-ac55-04ee0a07a20e" providerId="ADAL" clId="{689D5830-7D20-EF43-9790-B7D919905F98}" dt="2023-05-27T20:49:56.652" v="3194" actId="478"/>
          <ac:spMkLst>
            <pc:docMk/>
            <pc:sldMk cId="3641570371" sldId="315"/>
            <ac:spMk id="13" creationId="{86134EBE-0603-7009-3E33-2B61FDC05A68}"/>
          </ac:spMkLst>
        </pc:spChg>
        <pc:spChg chg="del mod">
          <ac:chgData name="Mbambo, Gillian" userId="59bfad07-67e3-47a4-ac55-04ee0a07a20e" providerId="ADAL" clId="{689D5830-7D20-EF43-9790-B7D919905F98}" dt="2023-05-27T21:12:23.225" v="3273" actId="478"/>
          <ac:spMkLst>
            <pc:docMk/>
            <pc:sldMk cId="3641570371" sldId="315"/>
            <ac:spMk id="17" creationId="{6402CEC5-151B-605A-8966-FD98B1B30E14}"/>
          </ac:spMkLst>
        </pc:spChg>
        <pc:spChg chg="add del mod">
          <ac:chgData name="Mbambo, Gillian" userId="59bfad07-67e3-47a4-ac55-04ee0a07a20e" providerId="ADAL" clId="{689D5830-7D20-EF43-9790-B7D919905F98}" dt="2023-05-27T21:27:26.274" v="3570" actId="478"/>
          <ac:spMkLst>
            <pc:docMk/>
            <pc:sldMk cId="3641570371" sldId="315"/>
            <ac:spMk id="21" creationId="{5DF6AC81-5083-137F-5EF7-858B58272B9F}"/>
          </ac:spMkLst>
        </pc:spChg>
        <pc:spChg chg="add del mod">
          <ac:chgData name="Mbambo, Gillian" userId="59bfad07-67e3-47a4-ac55-04ee0a07a20e" providerId="ADAL" clId="{689D5830-7D20-EF43-9790-B7D919905F98}" dt="2023-05-27T21:27:20.529" v="3568" actId="478"/>
          <ac:spMkLst>
            <pc:docMk/>
            <pc:sldMk cId="3641570371" sldId="315"/>
            <ac:spMk id="22" creationId="{FF54DDBF-B06D-BA07-E303-A0B4BD593DDF}"/>
          </ac:spMkLst>
        </pc:spChg>
        <pc:spChg chg="del mod">
          <ac:chgData name="Mbambo, Gillian" userId="59bfad07-67e3-47a4-ac55-04ee0a07a20e" providerId="ADAL" clId="{689D5830-7D20-EF43-9790-B7D919905F98}" dt="2023-05-27T21:27:34.557" v="3573" actId="478"/>
          <ac:spMkLst>
            <pc:docMk/>
            <pc:sldMk cId="3641570371" sldId="315"/>
            <ac:spMk id="23" creationId="{DB66C3D2-A118-2663-94B1-5BBFD9C4764E}"/>
          </ac:spMkLst>
        </pc:spChg>
        <pc:spChg chg="del mod">
          <ac:chgData name="Mbambo, Gillian" userId="59bfad07-67e3-47a4-ac55-04ee0a07a20e" providerId="ADAL" clId="{689D5830-7D20-EF43-9790-B7D919905F98}" dt="2023-05-27T21:27:28.587" v="3571" actId="478"/>
          <ac:spMkLst>
            <pc:docMk/>
            <pc:sldMk cId="3641570371" sldId="315"/>
            <ac:spMk id="24" creationId="{DBDECF43-C788-EAB3-60A7-0EDDEB1C4DC8}"/>
          </ac:spMkLst>
        </pc:spChg>
        <pc:spChg chg="del mod">
          <ac:chgData name="Mbambo, Gillian" userId="59bfad07-67e3-47a4-ac55-04ee0a07a20e" providerId="ADAL" clId="{689D5830-7D20-EF43-9790-B7D919905F98}" dt="2023-05-27T21:27:24.213" v="3569" actId="478"/>
          <ac:spMkLst>
            <pc:docMk/>
            <pc:sldMk cId="3641570371" sldId="315"/>
            <ac:spMk id="25" creationId="{5C384892-7C12-D28E-0E85-4C8FB625E399}"/>
          </ac:spMkLst>
        </pc:spChg>
        <pc:spChg chg="add mod">
          <ac:chgData name="Mbambo, Gillian" userId="59bfad07-67e3-47a4-ac55-04ee0a07a20e" providerId="ADAL" clId="{689D5830-7D20-EF43-9790-B7D919905F98}" dt="2023-05-27T21:13:40.562" v="3320" actId="1038"/>
          <ac:spMkLst>
            <pc:docMk/>
            <pc:sldMk cId="3641570371" sldId="315"/>
            <ac:spMk id="26" creationId="{004820D5-3AE3-D929-4CA7-2538DB85961A}"/>
          </ac:spMkLst>
        </pc:spChg>
        <pc:spChg chg="add mod">
          <ac:chgData name="Mbambo, Gillian" userId="59bfad07-67e3-47a4-ac55-04ee0a07a20e" providerId="ADAL" clId="{689D5830-7D20-EF43-9790-B7D919905F98}" dt="2023-05-27T21:13:33.328" v="3317" actId="1076"/>
          <ac:spMkLst>
            <pc:docMk/>
            <pc:sldMk cId="3641570371" sldId="315"/>
            <ac:spMk id="28" creationId="{BCCA7770-08D6-452B-DF83-6174C3AEB62F}"/>
          </ac:spMkLst>
        </pc:spChg>
        <pc:spChg chg="del mod">
          <ac:chgData name="Mbambo, Gillian" userId="59bfad07-67e3-47a4-ac55-04ee0a07a20e" providerId="ADAL" clId="{689D5830-7D20-EF43-9790-B7D919905F98}" dt="2023-05-27T21:12:25.041" v="3274" actId="478"/>
          <ac:spMkLst>
            <pc:docMk/>
            <pc:sldMk cId="3641570371" sldId="315"/>
            <ac:spMk id="32" creationId="{AEC7A72C-BC3E-8C60-CB4E-42D9FF3C7458}"/>
          </ac:spMkLst>
        </pc:spChg>
        <pc:spChg chg="add mod">
          <ac:chgData name="Mbambo, Gillian" userId="59bfad07-67e3-47a4-ac55-04ee0a07a20e" providerId="ADAL" clId="{689D5830-7D20-EF43-9790-B7D919905F98}" dt="2023-06-02T18:31:25.292" v="5024" actId="113"/>
          <ac:spMkLst>
            <pc:docMk/>
            <pc:sldMk cId="3641570371" sldId="315"/>
            <ac:spMk id="41" creationId="{4498E95E-8740-36DC-7386-03E628B14FA7}"/>
          </ac:spMkLst>
        </pc:spChg>
        <pc:spChg chg="add mod">
          <ac:chgData name="Mbambo, Gillian" userId="59bfad07-67e3-47a4-ac55-04ee0a07a20e" providerId="ADAL" clId="{689D5830-7D20-EF43-9790-B7D919905F98}" dt="2023-05-27T21:28:08.923" v="3648" actId="1036"/>
          <ac:spMkLst>
            <pc:docMk/>
            <pc:sldMk cId="3641570371" sldId="315"/>
            <ac:spMk id="42" creationId="{7EFFFCFE-0B2D-3540-A17F-7C9026979709}"/>
          </ac:spMkLst>
        </pc:spChg>
        <pc:spChg chg="add mod">
          <ac:chgData name="Mbambo, Gillian" userId="59bfad07-67e3-47a4-ac55-04ee0a07a20e" providerId="ADAL" clId="{689D5830-7D20-EF43-9790-B7D919905F98}" dt="2023-05-27T21:28:14.245" v="3653" actId="1038"/>
          <ac:spMkLst>
            <pc:docMk/>
            <pc:sldMk cId="3641570371" sldId="315"/>
            <ac:spMk id="43" creationId="{93D5ACC8-1AA0-46E3-DA1D-C5F54AB73E2C}"/>
          </ac:spMkLst>
        </pc:spChg>
        <pc:spChg chg="add mod">
          <ac:chgData name="Mbambo, Gillian" userId="59bfad07-67e3-47a4-ac55-04ee0a07a20e" providerId="ADAL" clId="{689D5830-7D20-EF43-9790-B7D919905F98}" dt="2023-05-27T21:28:19.155" v="3672" actId="1035"/>
          <ac:spMkLst>
            <pc:docMk/>
            <pc:sldMk cId="3641570371" sldId="315"/>
            <ac:spMk id="44" creationId="{FD9F1C3F-0FA5-603B-8470-F7EDB4AC5DBD}"/>
          </ac:spMkLst>
        </pc:spChg>
        <pc:spChg chg="add mod">
          <ac:chgData name="Mbambo, Gillian" userId="59bfad07-67e3-47a4-ac55-04ee0a07a20e" providerId="ADAL" clId="{689D5830-7D20-EF43-9790-B7D919905F98}" dt="2023-06-02T18:31:27.128" v="5025" actId="113"/>
          <ac:spMkLst>
            <pc:docMk/>
            <pc:sldMk cId="3641570371" sldId="315"/>
            <ac:spMk id="45" creationId="{46924A1E-AC79-E776-87B7-273A47B24978}"/>
          </ac:spMkLst>
        </pc:spChg>
        <pc:spChg chg="add mod">
          <ac:chgData name="Mbambo, Gillian" userId="59bfad07-67e3-47a4-ac55-04ee0a07a20e" providerId="ADAL" clId="{689D5830-7D20-EF43-9790-B7D919905F98}" dt="2023-06-02T18:31:29.462" v="5026" actId="113"/>
          <ac:spMkLst>
            <pc:docMk/>
            <pc:sldMk cId="3641570371" sldId="315"/>
            <ac:spMk id="46" creationId="{5D29A370-C027-841B-9A78-9C4013A456AB}"/>
          </ac:spMkLst>
        </pc:spChg>
        <pc:picChg chg="add del mod">
          <ac:chgData name="Mbambo, Gillian" userId="59bfad07-67e3-47a4-ac55-04ee0a07a20e" providerId="ADAL" clId="{689D5830-7D20-EF43-9790-B7D919905F98}" dt="2023-05-27T20:49:25.064" v="3175" actId="478"/>
          <ac:picMkLst>
            <pc:docMk/>
            <pc:sldMk cId="3641570371" sldId="315"/>
            <ac:picMk id="3" creationId="{7D70E555-CE0E-6E8F-21BA-AC0B6A703403}"/>
          </ac:picMkLst>
        </pc:picChg>
        <pc:picChg chg="del">
          <ac:chgData name="Mbambo, Gillian" userId="59bfad07-67e3-47a4-ac55-04ee0a07a20e" providerId="ADAL" clId="{689D5830-7D20-EF43-9790-B7D919905F98}" dt="2023-05-27T20:49:54.490" v="3193" actId="478"/>
          <ac:picMkLst>
            <pc:docMk/>
            <pc:sldMk cId="3641570371" sldId="315"/>
            <ac:picMk id="4" creationId="{50CE70BF-1756-DDF7-2FBF-D5B765E4DF36}"/>
          </ac:picMkLst>
        </pc:picChg>
        <pc:picChg chg="add del mod">
          <ac:chgData name="Mbambo, Gillian" userId="59bfad07-67e3-47a4-ac55-04ee0a07a20e" providerId="ADAL" clId="{689D5830-7D20-EF43-9790-B7D919905F98}" dt="2023-05-27T20:49:24.026" v="3174" actId="478"/>
          <ac:picMkLst>
            <pc:docMk/>
            <pc:sldMk cId="3641570371" sldId="315"/>
            <ac:picMk id="8" creationId="{D2F49E77-B660-5570-2AA4-0702424015D3}"/>
          </ac:picMkLst>
        </pc:picChg>
        <pc:picChg chg="add del mod">
          <ac:chgData name="Mbambo, Gillian" userId="59bfad07-67e3-47a4-ac55-04ee0a07a20e" providerId="ADAL" clId="{689D5830-7D20-EF43-9790-B7D919905F98}" dt="2023-05-27T20:49:26.480" v="3176" actId="478"/>
          <ac:picMkLst>
            <pc:docMk/>
            <pc:sldMk cId="3641570371" sldId="315"/>
            <ac:picMk id="11" creationId="{21B8A00D-A2A9-C0CE-B852-DDE28C31F13D}"/>
          </ac:picMkLst>
        </pc:picChg>
        <pc:picChg chg="add del mod">
          <ac:chgData name="Mbambo, Gillian" userId="59bfad07-67e3-47a4-ac55-04ee0a07a20e" providerId="ADAL" clId="{689D5830-7D20-EF43-9790-B7D919905F98}" dt="2023-05-27T21:25:06.777" v="3459" actId="478"/>
          <ac:picMkLst>
            <pc:docMk/>
            <pc:sldMk cId="3641570371" sldId="315"/>
            <ac:picMk id="15" creationId="{686CEB44-E130-EBF4-376B-A029ED3841E6}"/>
          </ac:picMkLst>
        </pc:picChg>
        <pc:picChg chg="add del mod">
          <ac:chgData name="Mbambo, Gillian" userId="59bfad07-67e3-47a4-ac55-04ee0a07a20e" providerId="ADAL" clId="{689D5830-7D20-EF43-9790-B7D919905F98}" dt="2023-05-27T21:25:05.651" v="3458" actId="478"/>
          <ac:picMkLst>
            <pc:docMk/>
            <pc:sldMk cId="3641570371" sldId="315"/>
            <ac:picMk id="18" creationId="{61FB217E-E8EC-3AA2-700B-3D0E75BB9E81}"/>
          </ac:picMkLst>
        </pc:picChg>
        <pc:picChg chg="add del mod">
          <ac:chgData name="Mbambo, Gillian" userId="59bfad07-67e3-47a4-ac55-04ee0a07a20e" providerId="ADAL" clId="{689D5830-7D20-EF43-9790-B7D919905F98}" dt="2023-05-27T21:18:55.185" v="3407" actId="478"/>
          <ac:picMkLst>
            <pc:docMk/>
            <pc:sldMk cId="3641570371" sldId="315"/>
            <ac:picMk id="20" creationId="{FA62BFBD-EE50-9332-196A-5802ACA73A46}"/>
          </ac:picMkLst>
        </pc:picChg>
        <pc:picChg chg="del">
          <ac:chgData name="Mbambo, Gillian" userId="59bfad07-67e3-47a4-ac55-04ee0a07a20e" providerId="ADAL" clId="{689D5830-7D20-EF43-9790-B7D919905F98}" dt="2023-05-27T20:49:36.844" v="3190" actId="478"/>
          <ac:picMkLst>
            <pc:docMk/>
            <pc:sldMk cId="3641570371" sldId="315"/>
            <ac:picMk id="27" creationId="{733261ED-53A6-6B81-F6BE-B421DAACBB5E}"/>
          </ac:picMkLst>
        </pc:picChg>
        <pc:picChg chg="del">
          <ac:chgData name="Mbambo, Gillian" userId="59bfad07-67e3-47a4-ac55-04ee0a07a20e" providerId="ADAL" clId="{689D5830-7D20-EF43-9790-B7D919905F98}" dt="2023-05-27T20:49:37.887" v="3191" actId="478"/>
          <ac:picMkLst>
            <pc:docMk/>
            <pc:sldMk cId="3641570371" sldId="315"/>
            <ac:picMk id="29" creationId="{2D1C3AAC-FE7C-C1D4-AE2B-716623033F6A}"/>
          </ac:picMkLst>
        </pc:picChg>
        <pc:picChg chg="del">
          <ac:chgData name="Mbambo, Gillian" userId="59bfad07-67e3-47a4-ac55-04ee0a07a20e" providerId="ADAL" clId="{689D5830-7D20-EF43-9790-B7D919905F98}" dt="2023-05-27T20:49:39.386" v="3192" actId="478"/>
          <ac:picMkLst>
            <pc:docMk/>
            <pc:sldMk cId="3641570371" sldId="315"/>
            <ac:picMk id="31" creationId="{B465814E-C969-19D1-8C11-94596FCFEAB0}"/>
          </ac:picMkLst>
        </pc:picChg>
        <pc:picChg chg="add mod">
          <ac:chgData name="Mbambo, Gillian" userId="59bfad07-67e3-47a4-ac55-04ee0a07a20e" providerId="ADAL" clId="{689D5830-7D20-EF43-9790-B7D919905F98}" dt="2023-05-29T02:22:15.052" v="4694" actId="1035"/>
          <ac:picMkLst>
            <pc:docMk/>
            <pc:sldMk cId="3641570371" sldId="315"/>
            <ac:picMk id="33" creationId="{C2F120F2-61D8-60B6-7417-422BBBAA12A0}"/>
          </ac:picMkLst>
        </pc:picChg>
        <pc:picChg chg="add mod">
          <ac:chgData name="Mbambo, Gillian" userId="59bfad07-67e3-47a4-ac55-04ee0a07a20e" providerId="ADAL" clId="{689D5830-7D20-EF43-9790-B7D919905F98}" dt="2023-05-29T02:22:15.052" v="4694" actId="1035"/>
          <ac:picMkLst>
            <pc:docMk/>
            <pc:sldMk cId="3641570371" sldId="315"/>
            <ac:picMk id="35" creationId="{1BBD7CB2-C430-8743-FA53-260E99FCFE09}"/>
          </ac:picMkLst>
        </pc:picChg>
        <pc:picChg chg="add mod">
          <ac:chgData name="Mbambo, Gillian" userId="59bfad07-67e3-47a4-ac55-04ee0a07a20e" providerId="ADAL" clId="{689D5830-7D20-EF43-9790-B7D919905F98}" dt="2023-05-27T21:26:46.840" v="3511" actId="1035"/>
          <ac:picMkLst>
            <pc:docMk/>
            <pc:sldMk cId="3641570371" sldId="315"/>
            <ac:picMk id="37" creationId="{2A856C26-1D00-C127-14B0-7E31DA8B6D76}"/>
          </ac:picMkLst>
        </pc:picChg>
        <pc:picChg chg="add mod">
          <ac:chgData name="Mbambo, Gillian" userId="59bfad07-67e3-47a4-ac55-04ee0a07a20e" providerId="ADAL" clId="{689D5830-7D20-EF43-9790-B7D919905F98}" dt="2023-05-27T21:26:46.840" v="3511" actId="1035"/>
          <ac:picMkLst>
            <pc:docMk/>
            <pc:sldMk cId="3641570371" sldId="315"/>
            <ac:picMk id="38" creationId="{167D054B-9149-5F97-B558-6419BD860765}"/>
          </ac:picMkLst>
        </pc:picChg>
        <pc:picChg chg="add mod">
          <ac:chgData name="Mbambo, Gillian" userId="59bfad07-67e3-47a4-ac55-04ee0a07a20e" providerId="ADAL" clId="{689D5830-7D20-EF43-9790-B7D919905F98}" dt="2023-05-27T21:26:46.840" v="3511" actId="1035"/>
          <ac:picMkLst>
            <pc:docMk/>
            <pc:sldMk cId="3641570371" sldId="315"/>
            <ac:picMk id="40" creationId="{82907A3E-3432-6F27-D236-1E0629C2B927}"/>
          </ac:picMkLst>
        </pc:picChg>
      </pc:sldChg>
      <pc:sldChg chg="addSp delSp modSp add mod">
        <pc:chgData name="Mbambo, Gillian" userId="59bfad07-67e3-47a4-ac55-04ee0a07a20e" providerId="ADAL" clId="{689D5830-7D20-EF43-9790-B7D919905F98}" dt="2023-06-02T18:31:38.990" v="5029" actId="113"/>
        <pc:sldMkLst>
          <pc:docMk/>
          <pc:sldMk cId="3447025821" sldId="316"/>
        </pc:sldMkLst>
        <pc:spChg chg="mod">
          <ac:chgData name="Mbambo, Gillian" userId="59bfad07-67e3-47a4-ac55-04ee0a07a20e" providerId="ADAL" clId="{689D5830-7D20-EF43-9790-B7D919905F98}" dt="2023-05-27T21:34:23.240" v="3803" actId="1076"/>
          <ac:spMkLst>
            <pc:docMk/>
            <pc:sldMk cId="3447025821" sldId="316"/>
            <ac:spMk id="5" creationId="{94CE87A6-6D12-EC1A-B1F4-D4FCEB284F38}"/>
          </ac:spMkLst>
        </pc:spChg>
        <pc:spChg chg="del mod">
          <ac:chgData name="Mbambo, Gillian" userId="59bfad07-67e3-47a4-ac55-04ee0a07a20e" providerId="ADAL" clId="{689D5830-7D20-EF43-9790-B7D919905F98}" dt="2023-05-27T21:34:41.986" v="3807" actId="478"/>
          <ac:spMkLst>
            <pc:docMk/>
            <pc:sldMk cId="3447025821" sldId="316"/>
            <ac:spMk id="6" creationId="{C489D173-9D0C-96C4-E494-DE627DDCEA80}"/>
          </ac:spMkLst>
        </pc:spChg>
        <pc:spChg chg="del mod">
          <ac:chgData name="Mbambo, Gillian" userId="59bfad07-67e3-47a4-ac55-04ee0a07a20e" providerId="ADAL" clId="{689D5830-7D20-EF43-9790-B7D919905F98}" dt="2023-05-27T21:34:50.278" v="3810" actId="478"/>
          <ac:spMkLst>
            <pc:docMk/>
            <pc:sldMk cId="3447025821" sldId="316"/>
            <ac:spMk id="9" creationId="{B4CB693D-93FA-14B4-54CD-B5ED0CB91756}"/>
          </ac:spMkLst>
        </pc:spChg>
        <pc:spChg chg="add del mod">
          <ac:chgData name="Mbambo, Gillian" userId="59bfad07-67e3-47a4-ac55-04ee0a07a20e" providerId="ADAL" clId="{689D5830-7D20-EF43-9790-B7D919905F98}" dt="2023-05-27T21:35:22.861" v="3841" actId="478"/>
          <ac:spMkLst>
            <pc:docMk/>
            <pc:sldMk cId="3447025821" sldId="316"/>
            <ac:spMk id="19" creationId="{3AB784B1-64B3-793A-7D06-59CC256F721D}"/>
          </ac:spMkLst>
        </pc:spChg>
        <pc:spChg chg="add del mod">
          <ac:chgData name="Mbambo, Gillian" userId="59bfad07-67e3-47a4-ac55-04ee0a07a20e" providerId="ADAL" clId="{689D5830-7D20-EF43-9790-B7D919905F98}" dt="2023-05-27T21:35:25.027" v="3842" actId="478"/>
          <ac:spMkLst>
            <pc:docMk/>
            <pc:sldMk cId="3447025821" sldId="316"/>
            <ac:spMk id="20" creationId="{DD815B09-B8E9-C2D8-B9F0-54F9B3EA2902}"/>
          </ac:spMkLst>
        </pc:spChg>
        <pc:spChg chg="add del mod">
          <ac:chgData name="Mbambo, Gillian" userId="59bfad07-67e3-47a4-ac55-04ee0a07a20e" providerId="ADAL" clId="{689D5830-7D20-EF43-9790-B7D919905F98}" dt="2023-05-27T21:35:59.852" v="3872" actId="478"/>
          <ac:spMkLst>
            <pc:docMk/>
            <pc:sldMk cId="3447025821" sldId="316"/>
            <ac:spMk id="21" creationId="{D6B6A9E8-B2E5-54A5-712E-A272825B979E}"/>
          </ac:spMkLst>
        </pc:spChg>
        <pc:spChg chg="add del mod">
          <ac:chgData name="Mbambo, Gillian" userId="59bfad07-67e3-47a4-ac55-04ee0a07a20e" providerId="ADAL" clId="{689D5830-7D20-EF43-9790-B7D919905F98}" dt="2023-05-27T21:35:57.429" v="3871" actId="478"/>
          <ac:spMkLst>
            <pc:docMk/>
            <pc:sldMk cId="3447025821" sldId="316"/>
            <ac:spMk id="22" creationId="{F23F7B07-8524-E208-10DF-3B5787A55986}"/>
          </ac:spMkLst>
        </pc:spChg>
        <pc:spChg chg="add del mod">
          <ac:chgData name="Mbambo, Gillian" userId="59bfad07-67e3-47a4-ac55-04ee0a07a20e" providerId="ADAL" clId="{689D5830-7D20-EF43-9790-B7D919905F98}" dt="2023-05-27T21:36:02.314" v="3873" actId="478"/>
          <ac:spMkLst>
            <pc:docMk/>
            <pc:sldMk cId="3447025821" sldId="316"/>
            <ac:spMk id="24" creationId="{1D00D819-1BF1-EEDA-F5D9-CDA77FA0EA02}"/>
          </ac:spMkLst>
        </pc:spChg>
        <pc:spChg chg="add del mod">
          <ac:chgData name="Mbambo, Gillian" userId="59bfad07-67e3-47a4-ac55-04ee0a07a20e" providerId="ADAL" clId="{689D5830-7D20-EF43-9790-B7D919905F98}" dt="2023-05-27T21:36:04.328" v="3874" actId="478"/>
          <ac:spMkLst>
            <pc:docMk/>
            <pc:sldMk cId="3447025821" sldId="316"/>
            <ac:spMk id="26" creationId="{561E759D-72EC-FB4B-914E-7EAA7167B887}"/>
          </ac:spMkLst>
        </pc:spChg>
        <pc:spChg chg="add del mod">
          <ac:chgData name="Mbambo, Gillian" userId="59bfad07-67e3-47a4-ac55-04ee0a07a20e" providerId="ADAL" clId="{689D5830-7D20-EF43-9790-B7D919905F98}" dt="2023-05-27T21:36:09.233" v="3876" actId="478"/>
          <ac:spMkLst>
            <pc:docMk/>
            <pc:sldMk cId="3447025821" sldId="316"/>
            <ac:spMk id="27" creationId="{BC2C51E1-8D97-D8EF-941A-C28207ECC6E9}"/>
          </ac:spMkLst>
        </pc:spChg>
        <pc:spChg chg="del mod">
          <ac:chgData name="Mbambo, Gillian" userId="59bfad07-67e3-47a4-ac55-04ee0a07a20e" providerId="ADAL" clId="{689D5830-7D20-EF43-9790-B7D919905F98}" dt="2023-05-27T21:34:53.131" v="3811" actId="478"/>
          <ac:spMkLst>
            <pc:docMk/>
            <pc:sldMk cId="3447025821" sldId="316"/>
            <ac:spMk id="28" creationId="{F21872E9-C619-3037-D619-DF86A690DC6E}"/>
          </ac:spMkLst>
        </pc:spChg>
        <pc:spChg chg="del mod">
          <ac:chgData name="Mbambo, Gillian" userId="59bfad07-67e3-47a4-ac55-04ee0a07a20e" providerId="ADAL" clId="{689D5830-7D20-EF43-9790-B7D919905F98}" dt="2023-05-27T21:34:47.643" v="3809" actId="478"/>
          <ac:spMkLst>
            <pc:docMk/>
            <pc:sldMk cId="3447025821" sldId="316"/>
            <ac:spMk id="29" creationId="{6B09EF87-29B9-9BF7-EF8D-F904DE5FDA54}"/>
          </ac:spMkLst>
        </pc:spChg>
        <pc:spChg chg="add del mod">
          <ac:chgData name="Mbambo, Gillian" userId="59bfad07-67e3-47a4-ac55-04ee0a07a20e" providerId="ADAL" clId="{689D5830-7D20-EF43-9790-B7D919905F98}" dt="2023-05-27T21:36:06.712" v="3875" actId="478"/>
          <ac:spMkLst>
            <pc:docMk/>
            <pc:sldMk cId="3447025821" sldId="316"/>
            <ac:spMk id="30" creationId="{9DC3AE10-185A-FC66-72FD-764E8E029D34}"/>
          </ac:spMkLst>
        </pc:spChg>
        <pc:spChg chg="del mod">
          <ac:chgData name="Mbambo, Gillian" userId="59bfad07-67e3-47a4-ac55-04ee0a07a20e" providerId="ADAL" clId="{689D5830-7D20-EF43-9790-B7D919905F98}" dt="2023-05-27T21:34:44.498" v="3808" actId="478"/>
          <ac:spMkLst>
            <pc:docMk/>
            <pc:sldMk cId="3447025821" sldId="316"/>
            <ac:spMk id="31" creationId="{4F1D02FC-4F3A-71D3-E287-245D6A4680D8}"/>
          </ac:spMkLst>
        </pc:spChg>
        <pc:spChg chg="del mod">
          <ac:chgData name="Mbambo, Gillian" userId="59bfad07-67e3-47a4-ac55-04ee0a07a20e" providerId="ADAL" clId="{689D5830-7D20-EF43-9790-B7D919905F98}" dt="2023-05-27T21:34:39.410" v="3806" actId="478"/>
          <ac:spMkLst>
            <pc:docMk/>
            <pc:sldMk cId="3447025821" sldId="316"/>
            <ac:spMk id="32" creationId="{31CFFB0F-AAE2-6FA3-A09B-6DA3F3C6AFFC}"/>
          </ac:spMkLst>
        </pc:spChg>
        <pc:spChg chg="add mod">
          <ac:chgData name="Mbambo, Gillian" userId="59bfad07-67e3-47a4-ac55-04ee0a07a20e" providerId="ADAL" clId="{689D5830-7D20-EF43-9790-B7D919905F98}" dt="2023-05-27T21:36:20.361" v="3877"/>
          <ac:spMkLst>
            <pc:docMk/>
            <pc:sldMk cId="3447025821" sldId="316"/>
            <ac:spMk id="33" creationId="{7BDA99A6-7C28-FD21-9546-CA5EC74FDD2C}"/>
          </ac:spMkLst>
        </pc:spChg>
        <pc:spChg chg="add mod">
          <ac:chgData name="Mbambo, Gillian" userId="59bfad07-67e3-47a4-ac55-04ee0a07a20e" providerId="ADAL" clId="{689D5830-7D20-EF43-9790-B7D919905F98}" dt="2023-05-27T21:36:20.361" v="3877"/>
          <ac:spMkLst>
            <pc:docMk/>
            <pc:sldMk cId="3447025821" sldId="316"/>
            <ac:spMk id="34" creationId="{68CE9A4D-BAD6-132A-3A09-803B027563C9}"/>
          </ac:spMkLst>
        </pc:spChg>
        <pc:spChg chg="add mod">
          <ac:chgData name="Mbambo, Gillian" userId="59bfad07-67e3-47a4-ac55-04ee0a07a20e" providerId="ADAL" clId="{689D5830-7D20-EF43-9790-B7D919905F98}" dt="2023-06-02T18:31:34.889" v="5027" actId="113"/>
          <ac:spMkLst>
            <pc:docMk/>
            <pc:sldMk cId="3447025821" sldId="316"/>
            <ac:spMk id="35" creationId="{FD024F63-EB7E-0317-7DD2-C295E7CF5AED}"/>
          </ac:spMkLst>
        </pc:spChg>
        <pc:spChg chg="add mod">
          <ac:chgData name="Mbambo, Gillian" userId="59bfad07-67e3-47a4-ac55-04ee0a07a20e" providerId="ADAL" clId="{689D5830-7D20-EF43-9790-B7D919905F98}" dt="2023-05-27T21:36:59.740" v="3909" actId="20577"/>
          <ac:spMkLst>
            <pc:docMk/>
            <pc:sldMk cId="3447025821" sldId="316"/>
            <ac:spMk id="36" creationId="{F45AB62A-AD18-364F-1A69-BC7CE92B9AA2}"/>
          </ac:spMkLst>
        </pc:spChg>
        <pc:spChg chg="add mod">
          <ac:chgData name="Mbambo, Gillian" userId="59bfad07-67e3-47a4-ac55-04ee0a07a20e" providerId="ADAL" clId="{689D5830-7D20-EF43-9790-B7D919905F98}" dt="2023-05-27T21:37:01.893" v="3910" actId="20577"/>
          <ac:spMkLst>
            <pc:docMk/>
            <pc:sldMk cId="3447025821" sldId="316"/>
            <ac:spMk id="37" creationId="{DDC3FA11-521B-3757-AE40-3FEB42FFC97F}"/>
          </ac:spMkLst>
        </pc:spChg>
        <pc:spChg chg="add mod">
          <ac:chgData name="Mbambo, Gillian" userId="59bfad07-67e3-47a4-ac55-04ee0a07a20e" providerId="ADAL" clId="{689D5830-7D20-EF43-9790-B7D919905F98}" dt="2023-05-27T21:37:07.054" v="3911" actId="20577"/>
          <ac:spMkLst>
            <pc:docMk/>
            <pc:sldMk cId="3447025821" sldId="316"/>
            <ac:spMk id="38" creationId="{8C8FEBF3-8785-FBBA-7BD0-3D18CBFCBA8F}"/>
          </ac:spMkLst>
        </pc:spChg>
        <pc:spChg chg="add mod">
          <ac:chgData name="Mbambo, Gillian" userId="59bfad07-67e3-47a4-ac55-04ee0a07a20e" providerId="ADAL" clId="{689D5830-7D20-EF43-9790-B7D919905F98}" dt="2023-06-02T18:31:36.847" v="5028" actId="113"/>
          <ac:spMkLst>
            <pc:docMk/>
            <pc:sldMk cId="3447025821" sldId="316"/>
            <ac:spMk id="39" creationId="{A91F0F94-3BBA-6E55-881A-0A3BB6C5B58C}"/>
          </ac:spMkLst>
        </pc:spChg>
        <pc:spChg chg="add mod">
          <ac:chgData name="Mbambo, Gillian" userId="59bfad07-67e3-47a4-ac55-04ee0a07a20e" providerId="ADAL" clId="{689D5830-7D20-EF43-9790-B7D919905F98}" dt="2023-06-02T18:31:38.990" v="5029" actId="113"/>
          <ac:spMkLst>
            <pc:docMk/>
            <pc:sldMk cId="3447025821" sldId="316"/>
            <ac:spMk id="40" creationId="{0365F0F6-C0F4-6C9E-2BE9-439F8B82ED73}"/>
          </ac:spMkLst>
        </pc:spChg>
        <pc:picChg chg="del">
          <ac:chgData name="Mbambo, Gillian" userId="59bfad07-67e3-47a4-ac55-04ee0a07a20e" providerId="ADAL" clId="{689D5830-7D20-EF43-9790-B7D919905F98}" dt="2023-05-27T21:21:17.296" v="3436" actId="478"/>
          <ac:picMkLst>
            <pc:docMk/>
            <pc:sldMk cId="3447025821" sldId="316"/>
            <ac:picMk id="3" creationId="{F2F33824-28BE-B52E-940E-FDAB90BE79BB}"/>
          </ac:picMkLst>
        </pc:picChg>
        <pc:picChg chg="add mod">
          <ac:chgData name="Mbambo, Gillian" userId="59bfad07-67e3-47a4-ac55-04ee0a07a20e" providerId="ADAL" clId="{689D5830-7D20-EF43-9790-B7D919905F98}" dt="2023-05-29T02:21:46.262" v="4667" actId="1036"/>
          <ac:picMkLst>
            <pc:docMk/>
            <pc:sldMk cId="3447025821" sldId="316"/>
            <ac:picMk id="4" creationId="{FC8D1B52-A843-D9A7-B4EC-07CCDBF99C04}"/>
          </ac:picMkLst>
        </pc:picChg>
        <pc:picChg chg="add mod">
          <ac:chgData name="Mbambo, Gillian" userId="59bfad07-67e3-47a4-ac55-04ee0a07a20e" providerId="ADAL" clId="{689D5830-7D20-EF43-9790-B7D919905F98}" dt="2023-05-29T02:21:46.262" v="4667" actId="1036"/>
          <ac:picMkLst>
            <pc:docMk/>
            <pc:sldMk cId="3447025821" sldId="316"/>
            <ac:picMk id="7" creationId="{D0A84560-77B8-2368-64C0-C5071114341A}"/>
          </ac:picMkLst>
        </pc:picChg>
        <pc:picChg chg="add del mod">
          <ac:chgData name="Mbambo, Gillian" userId="59bfad07-67e3-47a4-ac55-04ee0a07a20e" providerId="ADAL" clId="{689D5830-7D20-EF43-9790-B7D919905F98}" dt="2023-05-27T21:23:45.031" v="3447" actId="21"/>
          <ac:picMkLst>
            <pc:docMk/>
            <pc:sldMk cId="3447025821" sldId="316"/>
            <ac:picMk id="11" creationId="{FB9BB699-1823-9364-55F1-84067A975676}"/>
          </ac:picMkLst>
        </pc:picChg>
        <pc:picChg chg="del">
          <ac:chgData name="Mbambo, Gillian" userId="59bfad07-67e3-47a4-ac55-04ee0a07a20e" providerId="ADAL" clId="{689D5830-7D20-EF43-9790-B7D919905F98}" dt="2023-05-27T21:21:18.728" v="3437" actId="478"/>
          <ac:picMkLst>
            <pc:docMk/>
            <pc:sldMk cId="3447025821" sldId="316"/>
            <ac:picMk id="13" creationId="{D9F9A648-E1BF-2A15-78A6-4A51BC3E1106}"/>
          </ac:picMkLst>
        </pc:picChg>
        <pc:picChg chg="add mod">
          <ac:chgData name="Mbambo, Gillian" userId="59bfad07-67e3-47a4-ac55-04ee0a07a20e" providerId="ADAL" clId="{689D5830-7D20-EF43-9790-B7D919905F98}" dt="2023-05-27T21:35:46.469" v="3870" actId="1035"/>
          <ac:picMkLst>
            <pc:docMk/>
            <pc:sldMk cId="3447025821" sldId="316"/>
            <ac:picMk id="14" creationId="{99743A2E-5391-3251-A00D-27014C6F1EB6}"/>
          </ac:picMkLst>
        </pc:picChg>
        <pc:picChg chg="add mod">
          <ac:chgData name="Mbambo, Gillian" userId="59bfad07-67e3-47a4-ac55-04ee0a07a20e" providerId="ADAL" clId="{689D5830-7D20-EF43-9790-B7D919905F98}" dt="2023-05-27T21:35:46.469" v="3870" actId="1035"/>
          <ac:picMkLst>
            <pc:docMk/>
            <pc:sldMk cId="3447025821" sldId="316"/>
            <ac:picMk id="16" creationId="{5870B6F0-13C1-35E5-456E-1950BAC1A00F}"/>
          </ac:picMkLst>
        </pc:picChg>
        <pc:picChg chg="add mod">
          <ac:chgData name="Mbambo, Gillian" userId="59bfad07-67e3-47a4-ac55-04ee0a07a20e" providerId="ADAL" clId="{689D5830-7D20-EF43-9790-B7D919905F98}" dt="2023-05-27T21:35:46.469" v="3870" actId="1035"/>
          <ac:picMkLst>
            <pc:docMk/>
            <pc:sldMk cId="3447025821" sldId="316"/>
            <ac:picMk id="18" creationId="{52C99325-4B55-185B-7B79-4BE062A8AE41}"/>
          </ac:picMkLst>
        </pc:picChg>
        <pc:picChg chg="del">
          <ac:chgData name="Mbambo, Gillian" userId="59bfad07-67e3-47a4-ac55-04ee0a07a20e" providerId="ADAL" clId="{689D5830-7D20-EF43-9790-B7D919905F98}" dt="2023-05-27T21:21:15.161" v="3434" actId="478"/>
          <ac:picMkLst>
            <pc:docMk/>
            <pc:sldMk cId="3447025821" sldId="316"/>
            <ac:picMk id="23" creationId="{0AA224F4-6F67-1138-633C-784BCF96E9F6}"/>
          </ac:picMkLst>
        </pc:picChg>
        <pc:picChg chg="del">
          <ac:chgData name="Mbambo, Gillian" userId="59bfad07-67e3-47a4-ac55-04ee0a07a20e" providerId="ADAL" clId="{689D5830-7D20-EF43-9790-B7D919905F98}" dt="2023-05-27T21:21:16.134" v="3435" actId="478"/>
          <ac:picMkLst>
            <pc:docMk/>
            <pc:sldMk cId="3447025821" sldId="316"/>
            <ac:picMk id="25" creationId="{1E6A85F8-DBE4-4A0F-FC0C-D2E753040F3B}"/>
          </ac:picMkLst>
        </pc:picChg>
      </pc:sldChg>
      <pc:sldChg chg="add del">
        <pc:chgData name="Mbambo, Gillian" userId="59bfad07-67e3-47a4-ac55-04ee0a07a20e" providerId="ADAL" clId="{689D5830-7D20-EF43-9790-B7D919905F98}" dt="2023-06-02T18:59:00.343" v="5052"/>
        <pc:sldMkLst>
          <pc:docMk/>
          <pc:sldMk cId="1548396653" sldId="317"/>
        </pc:sldMkLst>
      </pc:sldChg>
      <pc:sldChg chg="delSp new del mod">
        <pc:chgData name="Mbambo, Gillian" userId="59bfad07-67e3-47a4-ac55-04ee0a07a20e" providerId="ADAL" clId="{689D5830-7D20-EF43-9790-B7D919905F98}" dt="2023-06-02T18:22:34.752" v="4940" actId="2696"/>
        <pc:sldMkLst>
          <pc:docMk/>
          <pc:sldMk cId="4060474018" sldId="317"/>
        </pc:sldMkLst>
        <pc:spChg chg="del">
          <ac:chgData name="Mbambo, Gillian" userId="59bfad07-67e3-47a4-ac55-04ee0a07a20e" providerId="ADAL" clId="{689D5830-7D20-EF43-9790-B7D919905F98}" dt="2023-06-02T18:22:25.043" v="4938" actId="478"/>
          <ac:spMkLst>
            <pc:docMk/>
            <pc:sldMk cId="4060474018" sldId="317"/>
            <ac:spMk id="2" creationId="{26793743-F321-F7E2-B32E-F7E75D3D938F}"/>
          </ac:spMkLst>
        </pc:spChg>
        <pc:spChg chg="del">
          <ac:chgData name="Mbambo, Gillian" userId="59bfad07-67e3-47a4-ac55-04ee0a07a20e" providerId="ADAL" clId="{689D5830-7D20-EF43-9790-B7D919905F98}" dt="2023-06-02T18:22:23.914" v="4937" actId="478"/>
          <ac:spMkLst>
            <pc:docMk/>
            <pc:sldMk cId="4060474018" sldId="317"/>
            <ac:spMk id="3" creationId="{926727A2-5CA7-52BE-4FFE-9516094DAF35}"/>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somumaryland-my.sharepoint.com/personal/mtravass_som_umaryland_edu/Documents/Documents/Microarrays/CP3/Analyzed%20data%20using%20macro.v5.GillianData.mt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somumaryland-my.sharepoint.com/personal/mtravass_som_umaryland_edu/Documents/Documents/Microarrays/CP3/Gillian-%20Susceptibe/Analyzed%20data%20using%20macro.v5.GillianData.mt2.revision.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FinalAnalysis.Heatmap!$AL$4</c:f>
              <c:strCache>
                <c:ptCount val="1"/>
                <c:pt idx="0">
                  <c:v>Susc</c:v>
                </c:pt>
              </c:strCache>
            </c:strRef>
          </c:tx>
          <c:spPr>
            <a:solidFill>
              <a:schemeClr val="accent1"/>
            </a:solidFill>
            <a:ln>
              <a:noFill/>
            </a:ln>
            <a:effectLst/>
          </c:spPr>
          <c:invertIfNegative val="0"/>
          <c:cat>
            <c:strRef>
              <c:f>FinalAnalysis.Heatmap!$J$6:$J$272</c:f>
              <c:strCache>
                <c:ptCount val="267"/>
                <c:pt idx="0">
                  <c:v>apical membrane antigen 1</c:v>
                </c:pt>
                <c:pt idx="1">
                  <c:v>circumsporozoite (CS) protein</c:v>
                </c:pt>
                <c:pt idx="2">
                  <c:v>merozoite surface protein 1</c:v>
                </c:pt>
                <c:pt idx="3">
                  <c:v>merozoite surface protein 1</c:v>
                </c:pt>
                <c:pt idx="5">
                  <c:v>3D7|PF11_0008|DBLalpha tag Group A</c:v>
                </c:pt>
                <c:pt idx="6">
                  <c:v>3D7|PF13_0003|DBLalpha tag Group A</c:v>
                </c:pt>
                <c:pt idx="7">
                  <c:v>3D7|PFA0015c|DBLalpha tag Group A</c:v>
                </c:pt>
                <c:pt idx="8">
                  <c:v>3D7|MAL6P1.4|DBLalpha tag Group B/A</c:v>
                </c:pt>
                <c:pt idx="9">
                  <c:v>3D7|MAL6P1.252|DBLalpha tag Group C</c:v>
                </c:pt>
                <c:pt idx="10">
                  <c:v>3D7|PF07_0049|DBLalpha tags</c:v>
                </c:pt>
                <c:pt idx="11">
                  <c:v>3D7|PF08_0106|DBLalpha tags</c:v>
                </c:pt>
                <c:pt idx="12">
                  <c:v>3D7|PFB0010w|DBLalpha tags</c:v>
                </c:pt>
                <c:pt idx="13">
                  <c:v>3D7|PFL1960w|DBLalpha tags</c:v>
                </c:pt>
                <c:pt idx="15">
                  <c:v>3D7|MAL6P1.1|DBLa0.8|CIDRa4|0</c:v>
                </c:pt>
                <c:pt idx="16">
                  <c:v>3D7|MAL6P1.252|DBLa0.21|CIDRa2.1|0</c:v>
                </c:pt>
                <c:pt idx="17">
                  <c:v>3D7|MAL6P1.252|DBLb4|DBLd1|0</c:v>
                </c:pt>
                <c:pt idx="18">
                  <c:v>3D7|MAL6P1.252|DBLd1|CIDRb1|0</c:v>
                </c:pt>
                <c:pt idx="19">
                  <c:v>3D7|MAL6P1.4|DBLa0.6|CIDRa3.2|0</c:v>
                </c:pt>
                <c:pt idx="20">
                  <c:v>3D7|MAL6P1.4|DBLb5|DBLg13|0</c:v>
                </c:pt>
                <c:pt idx="21">
                  <c:v>3D7|MAL6P1.4|DBLd4|CIDRg1|0</c:v>
                </c:pt>
                <c:pt idx="22">
                  <c:v>3D7|MAL6P1.4|DBLe2|DBLe7|0</c:v>
                </c:pt>
                <c:pt idx="23">
                  <c:v>3D7|MAL6P1.4|DBLe7|DBLe3|0</c:v>
                </c:pt>
                <c:pt idx="24">
                  <c:v>3D7|MAL7P1.212|DBLa0.17|CIDRa3.1|0</c:v>
                </c:pt>
                <c:pt idx="25">
                  <c:v>3D7|MAL7P1.50|DBLd1|CIDRg10|0</c:v>
                </c:pt>
                <c:pt idx="26">
                  <c:v>3D7|MAL7P1.55|DBLa0.9|CIDRa2.4|0</c:v>
                </c:pt>
                <c:pt idx="27">
                  <c:v>3D7|MAL7P1.55|DBLd1|CIDRg5|0</c:v>
                </c:pt>
                <c:pt idx="28">
                  <c:v>3D7|MAL8P1.220|DBLd1|CIDRb1|0</c:v>
                </c:pt>
                <c:pt idx="29">
                  <c:v>3D7|PF07_0048|DBLd1|CIDRb6|0</c:v>
                </c:pt>
                <c:pt idx="30">
                  <c:v>3D7|PF07_0049|DBLa0.17|CIDRa3.1|0</c:v>
                </c:pt>
                <c:pt idx="31">
                  <c:v>3D7|PF07_0049|DBLd1|CIDRg7|0</c:v>
                </c:pt>
                <c:pt idx="32">
                  <c:v>3D7|PF07_0050|DBLa0.18|CIDRa6|0</c:v>
                </c:pt>
                <c:pt idx="33">
                  <c:v>3D7|PF07_0050|DBLb6|DBLg9|0</c:v>
                </c:pt>
                <c:pt idx="34">
                  <c:v>3D7|PF07_0051|DBLa0.1|CIDRa3.1|0</c:v>
                </c:pt>
                <c:pt idx="35">
                  <c:v>3D7|PF07_0051|DBLd1|CIDRb1|0</c:v>
                </c:pt>
                <c:pt idx="36">
                  <c:v>3D7|PF07_0139|DBLa0.16|CIDRa3.4|0</c:v>
                </c:pt>
                <c:pt idx="37">
                  <c:v>3D7|PF07_0139|DBLd1|CIDRb1|0</c:v>
                </c:pt>
                <c:pt idx="38">
                  <c:v>3D7|PF07_0139|DBLe4|ATSB1|0</c:v>
                </c:pt>
                <c:pt idx="39">
                  <c:v>3D7|PF08_0103|DBLa0.12|CIDRa2.2|0</c:v>
                </c:pt>
                <c:pt idx="40">
                  <c:v>3D7|PF08_0106|DBLa0.2|CIDRa3.1|0</c:v>
                </c:pt>
                <c:pt idx="41">
                  <c:v>3D7|PF08_0106|DBLd1|CIDRb1|0</c:v>
                </c:pt>
                <c:pt idx="42">
                  <c:v>3D7|PF08_0107|DBLd1|CIDRg2|0</c:v>
                </c:pt>
                <c:pt idx="43">
                  <c:v>3D7|PF08_0142|DBLa0.9|CIDRa2.11|0</c:v>
                </c:pt>
                <c:pt idx="44">
                  <c:v>3D7|PF10_0001|DBLd1|CIDRg4|0</c:v>
                </c:pt>
                <c:pt idx="45">
                  <c:v>3D7|PF10_0406|DBLa0.9|CIDRa2.7|0</c:v>
                </c:pt>
                <c:pt idx="46">
                  <c:v>3D7|PF10_0406|DBLd1|CIDRb1|0</c:v>
                </c:pt>
                <c:pt idx="47">
                  <c:v>3D7|PF11_0007|DBLa0.15|CIDRa3.2|0</c:v>
                </c:pt>
                <c:pt idx="48">
                  <c:v>3D7|PF11_0007|DBLd1|CIDRb1|0</c:v>
                </c:pt>
                <c:pt idx="49">
                  <c:v>3D7|PF13_0001|DBLa0.11|CIDRa2.4|0</c:v>
                </c:pt>
                <c:pt idx="50">
                  <c:v>3D7|PF13_0001|DBLd1|CIDRb1|0</c:v>
                </c:pt>
                <c:pt idx="51">
                  <c:v>3D7|PF13_0364|DBLa0.16|CIDRa3.4|0</c:v>
                </c:pt>
                <c:pt idx="52">
                  <c:v>3D7|PF13_0364|DBLd1|CIDRb6|0</c:v>
                </c:pt>
                <c:pt idx="53">
                  <c:v>3D7|PFA0005w|DBLa0.11|CIDRa2.8|0</c:v>
                </c:pt>
                <c:pt idx="54">
                  <c:v>3D7|PFA0005w|DBLd1|CIDRb1|0</c:v>
                </c:pt>
                <c:pt idx="55">
                  <c:v>3D7|PFA0765c|DBLa0.5|CIDRa2.8|0</c:v>
                </c:pt>
                <c:pt idx="56">
                  <c:v>3D7|PFB0010w|DBLa0.7|CIDRa2.2|0</c:v>
                </c:pt>
                <c:pt idx="57">
                  <c:v>3D7|PFB0010w|DBLg11|ATSB1|0</c:v>
                </c:pt>
                <c:pt idx="58">
                  <c:v>3D7|PFB1055c|DBLa0.16|CIDRa3.4|0</c:v>
                </c:pt>
                <c:pt idx="59">
                  <c:v>3D7|PFC1120c|DBLa0.9|CIDRa2.1|0</c:v>
                </c:pt>
                <c:pt idx="60">
                  <c:v>3D7|PFC1120c|DBLd1|CIDRb7|0</c:v>
                </c:pt>
                <c:pt idx="61">
                  <c:v>3D7|PFD0005w|DBLg5|DBLd1|0</c:v>
                </c:pt>
                <c:pt idx="62">
                  <c:v>3D7|PFD0615c|DBLa0.17|CIDRa3.1|0</c:v>
                </c:pt>
                <c:pt idx="63">
                  <c:v>3D7|PFD0615c|DBLd1|CIDRb1|0</c:v>
                </c:pt>
                <c:pt idx="64">
                  <c:v>3D7|PFD0625c|DBLa0.1|CIDRa3.2|0</c:v>
                </c:pt>
                <c:pt idx="65">
                  <c:v>3D7|PFD0630c|DBLa0.1|CIDRa3.1|0</c:v>
                </c:pt>
                <c:pt idx="66">
                  <c:v>3D7|PFD0630c|DBLd1|CIDRg2|0</c:v>
                </c:pt>
                <c:pt idx="67">
                  <c:v>3D7|PFD0635c|DBLa0.1|CIDRa3.1|0</c:v>
                </c:pt>
                <c:pt idx="68">
                  <c:v>3D7|PFD0995c|DBLa0.1|CIDRa3.2|0</c:v>
                </c:pt>
                <c:pt idx="69">
                  <c:v>3D7|PFD0995c|DBLd1|CIDRg6|0</c:v>
                </c:pt>
                <c:pt idx="70">
                  <c:v>3D7|PFD1005c|DBLa0.8|CIDRa4|0</c:v>
                </c:pt>
                <c:pt idx="71">
                  <c:v>3D7|PFD1005c|DBLd1|CIDRg11|0</c:v>
                </c:pt>
                <c:pt idx="72">
                  <c:v>3D7|PFD1015c|DBLa0.24|CIDRa3.4|0</c:v>
                </c:pt>
                <c:pt idx="73">
                  <c:v>3D7|PFD1015c|DBLd1|CIDRb1|0</c:v>
                </c:pt>
                <c:pt idx="74">
                  <c:v>3D7|PFD1245c|DBLa0.14|CIDRa4|0</c:v>
                </c:pt>
                <c:pt idx="75">
                  <c:v>3D7|PFD1245c|DBLd1|CIDRb1|0</c:v>
                </c:pt>
                <c:pt idx="76">
                  <c:v>3D7|PFE0005w|DBLd1|CIDRb1|0</c:v>
                </c:pt>
                <c:pt idx="77">
                  <c:v>3D7|PFI0005w|DBLd1|CIDRg12|0</c:v>
                </c:pt>
                <c:pt idx="78">
                  <c:v>3D7|PFL0005w|DBLa0.9|CIDRa2.2|0</c:v>
                </c:pt>
                <c:pt idx="79">
                  <c:v>3D7|PFL0005w|DBLd1|CIDRb1|0</c:v>
                </c:pt>
                <c:pt idx="80">
                  <c:v>3D7|PFL0020w|DBLg14|DBLz5|0</c:v>
                </c:pt>
                <c:pt idx="81">
                  <c:v>3D7|PFL0020w|DBLz5|DBLe4|0</c:v>
                </c:pt>
                <c:pt idx="82">
                  <c:v>3D7|PFL0935c|DBLa0.16|CIDRa3.4|0</c:v>
                </c:pt>
                <c:pt idx="83">
                  <c:v>3D7|PFL0935c|DBLd1|CIDRg12|0</c:v>
                </c:pt>
                <c:pt idx="84">
                  <c:v>3D7|PFL1950w|DBLa0.7|CIDRa4|0</c:v>
                </c:pt>
                <c:pt idx="85">
                  <c:v>3D7|PFL1950w|DBLd1|CIDRb1|0</c:v>
                </c:pt>
                <c:pt idx="86">
                  <c:v>3D7|PFL1955w|DBLa0.16|CIDRa3.4|0</c:v>
                </c:pt>
                <c:pt idx="87">
                  <c:v>3D7|PFL1955w|DBLd1|CIDRb1|0</c:v>
                </c:pt>
                <c:pt idx="88">
                  <c:v>3D7|PFL1960w|DBLa0.20|CIDRa3.1|0</c:v>
                </c:pt>
                <c:pt idx="89">
                  <c:v>3D7|PFL1960w|DBLd1|CIDRb1|0</c:v>
                </c:pt>
                <c:pt idx="90">
                  <c:v>3D7|PFL2665c|DBLa0.19|CIDRa2.3|0</c:v>
                </c:pt>
                <c:pt idx="91">
                  <c:v>3D7|PFL2665c|DBLd1|CIDRb1|0</c:v>
                </c:pt>
                <c:pt idx="93">
                  <c:v>3D7|MAL6P1.316|DBLa2|CIDRa1.8|0</c:v>
                </c:pt>
                <c:pt idx="94">
                  <c:v>3D7|MAL6P1.316|DBLb12|DBLg4|0</c:v>
                </c:pt>
                <c:pt idx="95">
                  <c:v>3D7|MAL6P1.316|DBLz3|DBLe12|0</c:v>
                </c:pt>
                <c:pt idx="96">
                  <c:v>3D7|PF08_0140|CIDRa1.6|DBLb12|DBLg4</c:v>
                </c:pt>
                <c:pt idx="97">
                  <c:v>3D7|PF08_0140|DBLa2|CIDRa1.6|0</c:v>
                </c:pt>
                <c:pt idx="98">
                  <c:v>3D7|PF08_0140|DBLa2|CIDRa1.6|DBLb12</c:v>
                </c:pt>
                <c:pt idx="99">
                  <c:v>3D7|PF08_0140|DBLb12|DBLg4|0</c:v>
                </c:pt>
                <c:pt idx="100">
                  <c:v>3D7|PF08_0140|DBLd1|CIDRb1|0</c:v>
                </c:pt>
                <c:pt idx="101">
                  <c:v>3D7|PF08_0141|DBLa1.6|CIDRd2|0</c:v>
                </c:pt>
                <c:pt idx="102">
                  <c:v>3D7|PF08_0141|DBLg14|DBLz5|0</c:v>
                </c:pt>
                <c:pt idx="103">
                  <c:v>3D7|PF08_0141|DBLz5|DBLe4|0</c:v>
                </c:pt>
                <c:pt idx="104">
                  <c:v>3D7|PF08_0141e1s1|PfEMP1 - Extracellular - non-CD36-binding</c:v>
                </c:pt>
                <c:pt idx="105">
                  <c:v>3D7|PF08_0141e1s2|PfEMP1 - Extracellular - non-CD36-binding</c:v>
                </c:pt>
                <c:pt idx="106">
                  <c:v>3D7|PF08_0141e1s3|PfEMP1 - Extracellular - non-CD36-binding</c:v>
                </c:pt>
                <c:pt idx="107">
                  <c:v>3D7|PF11_0008|DBLa1.5|CIDRg3|0</c:v>
                </c:pt>
                <c:pt idx="108">
                  <c:v>3D7|PF11_0008|DBLg12|DBLd5|0</c:v>
                </c:pt>
                <c:pt idx="109">
                  <c:v>3D7|PF11_0008e1s1|PfEMP1 - Extracellular - non-CD36-binding</c:v>
                </c:pt>
                <c:pt idx="110">
                  <c:v>3D7|PF11_0008e1s2|PfEMP1 - Extracellular - non-CD36-binding</c:v>
                </c:pt>
                <c:pt idx="111">
                  <c:v>3D7|PF11_0008e1s3|PfEMP1 - Extracellular - non-CD36-binding</c:v>
                </c:pt>
                <c:pt idx="112">
                  <c:v>3D7|PF11_0521|DBLb3|DBLb6|0</c:v>
                </c:pt>
                <c:pt idx="113">
                  <c:v>3D7|PF11_0521|DBLb6|DBLd3|0</c:v>
                </c:pt>
                <c:pt idx="114">
                  <c:v>3D7|PF13_0003|DBLa1.6|CIDRd1|0</c:v>
                </c:pt>
                <c:pt idx="115">
                  <c:v>3D7|PF13_0003|DBLb3|DBLg12|0</c:v>
                </c:pt>
                <c:pt idx="116">
                  <c:v>3D7|PF13_0003|DBLd5|CIDRb3|0</c:v>
                </c:pt>
                <c:pt idx="117">
                  <c:v>3D7|PF13_0003|DBLg12|DBLd5|0</c:v>
                </c:pt>
                <c:pt idx="118">
                  <c:v>3D7|PFA0015c|DBLa1.3|DBLe8|0</c:v>
                </c:pt>
                <c:pt idx="119">
                  <c:v>3D7|PFD0020c|DBLa1.2|CIDRa1.1|0</c:v>
                </c:pt>
                <c:pt idx="120">
                  <c:v>3D7|PFD0020c|DBLb12|DBLg6|0</c:v>
                </c:pt>
                <c:pt idx="121">
                  <c:v>3D7|PFD0020c|DBLd1|CIDRg8|0</c:v>
                </c:pt>
                <c:pt idx="122">
                  <c:v>3D7|PFD0020c|DBLg6|DBLg11|0</c:v>
                </c:pt>
                <c:pt idx="123">
                  <c:v>3D7|PFD1235w|DBLa1.4|CIDRa1.6|0</c:v>
                </c:pt>
                <c:pt idx="124">
                  <c:v>3D7|PFD1235w|DBLb3|DBLb3|0</c:v>
                </c:pt>
                <c:pt idx="125">
                  <c:v>3D7|PFD1235w|DBLb3|DBLg13|0</c:v>
                </c:pt>
                <c:pt idx="126">
                  <c:v>3D7|PFD1235w|DBLd1|CIDRb5|0</c:v>
                </c:pt>
                <c:pt idx="127">
                  <c:v>3D7|PFD1235w|DBLg13|DBLd1|0</c:v>
                </c:pt>
                <c:pt idx="128">
                  <c:v>3D7|PFE1640w|DBLb1|DBLg15|0</c:v>
                </c:pt>
                <c:pt idx="129">
                  <c:v>3D7|PFE1640w|DBLe1|DBLg8|0</c:v>
                </c:pt>
                <c:pt idx="130">
                  <c:v>3D7|PFE1640w|DBLg15|DBLe1|0</c:v>
                </c:pt>
                <c:pt idx="131">
                  <c:v>3D7|PFE1640w|DBLg8|DBLz1|0</c:v>
                </c:pt>
                <c:pt idx="132">
                  <c:v>3D7|PFE1640w|DBLz1|DBLe5|0</c:v>
                </c:pt>
                <c:pt idx="133">
                  <c:v>3D7|PFF0020c|DBLa1.3|DBLe8|0</c:v>
                </c:pt>
                <c:pt idx="134">
                  <c:v>3D7|PFI1820w|DBLa1.3|DBLe8|0</c:v>
                </c:pt>
                <c:pt idx="135">
                  <c:v>3D7|PFL0020w|DBLa0.18|CIDRa5|0</c:v>
                </c:pt>
                <c:pt idx="136">
                  <c:v>3D7|PFL0020w|DBLb5|DBLg14|0</c:v>
                </c:pt>
                <c:pt idx="137">
                  <c:v>3D7|PFL0030c|DBLepam4|DBLepam5|0</c:v>
                </c:pt>
                <c:pt idx="138">
                  <c:v>3D7|PFL0030c|DBLepam5|DBLe10|0</c:v>
                </c:pt>
                <c:pt idx="139">
                  <c:v>3D7|PFL0030c|DBLpam1|DBLpam2|0</c:v>
                </c:pt>
                <c:pt idx="140">
                  <c:v>3D7|PFL0030c|DBLpam2|CIDRpam|0</c:v>
                </c:pt>
                <c:pt idx="141">
                  <c:v>3D7|PFL0030c|DBLpam3|DBLepam4|0</c:v>
                </c:pt>
                <c:pt idx="143">
                  <c:v>3D7|MAL6P1.252-e2|PfEMP1 - Intracellular</c:v>
                </c:pt>
                <c:pt idx="144">
                  <c:v>3D7|MAL7P1.55|ATSB13|0|0</c:v>
                </c:pt>
                <c:pt idx="145">
                  <c:v>3D7|MAL8P1.220|ATSB1|0|0</c:v>
                </c:pt>
                <c:pt idx="146">
                  <c:v>3D7|PF07_0048|ATSB7|0|0</c:v>
                </c:pt>
                <c:pt idx="147">
                  <c:v>3D7|PF07_0048e2s1|PfEMP1 - Intracellular</c:v>
                </c:pt>
                <c:pt idx="148">
                  <c:v>3D7|PF08_0107|ATSB2|0|0</c:v>
                </c:pt>
                <c:pt idx="149">
                  <c:v>3D7|PF08_0140e2s1|PfEMP1 - Intracellular</c:v>
                </c:pt>
                <c:pt idx="150">
                  <c:v>3D7|PF08_0141|ATSA3|0|0</c:v>
                </c:pt>
                <c:pt idx="151">
                  <c:v>3D7|PF08_0141e2s1|PfEMP1 - Intracellular</c:v>
                </c:pt>
                <c:pt idx="152">
                  <c:v>3D7|PF10_0001|ATSB1|0|0</c:v>
                </c:pt>
                <c:pt idx="153">
                  <c:v>3D7|PF10_0406|ATSB1|0|0</c:v>
                </c:pt>
                <c:pt idx="154">
                  <c:v>3D7|PF11_0008e2s1|PfEMP1 - Intracellular</c:v>
                </c:pt>
                <c:pt idx="155">
                  <c:v>3D7|PF11_0521|ATSA2|0|0</c:v>
                </c:pt>
                <c:pt idx="156">
                  <c:v>3D7|PF11_0521|PfEMP1 - Intracellular</c:v>
                </c:pt>
                <c:pt idx="157">
                  <c:v>3D7|PF13_0003|ATSA2|0|0</c:v>
                </c:pt>
                <c:pt idx="158">
                  <c:v>3D7|PFC0005w|ATSB1|0|0</c:v>
                </c:pt>
                <c:pt idx="159">
                  <c:v>3D7|PFD0995ce2s1|PfEMP1 - Intracellular</c:v>
                </c:pt>
                <c:pt idx="160">
                  <c:v>3D7|PFD1000c|ATSB19|0|0</c:v>
                </c:pt>
                <c:pt idx="161">
                  <c:v>3D7|PFD1235w|ATSA2|0|0</c:v>
                </c:pt>
                <c:pt idx="162">
                  <c:v>3D7|PFL1955w|ATSB7|0|0</c:v>
                </c:pt>
                <c:pt idx="164">
                  <c:v>3D7|AMA1</c:v>
                </c:pt>
                <c:pt idx="165">
                  <c:v>3D7|MSP1 - segment 1</c:v>
                </c:pt>
                <c:pt idx="166">
                  <c:v>3D7|MSP1 - segment 2</c:v>
                </c:pt>
                <c:pt idx="168">
                  <c:v>3D7|PF07_0049</c:v>
                </c:pt>
                <c:pt idx="169">
                  <c:v>3D7|PF08_0140</c:v>
                </c:pt>
                <c:pt idx="170">
                  <c:v>3D7|PF11_0007</c:v>
                </c:pt>
                <c:pt idx="171">
                  <c:v>3D7|PF11_0521PF11_0521_1|DBL|CIDR|0</c:v>
                </c:pt>
                <c:pt idx="173">
                  <c:v>3D7|rifin|||</c:v>
                </c:pt>
                <c:pt idx="174">
                  <c:v>3D7|rifin|||</c:v>
                </c:pt>
                <c:pt idx="176">
                  <c:v>3D7|stevor|||</c:v>
                </c:pt>
                <c:pt idx="177">
                  <c:v>3D7|stevor|||</c:v>
                </c:pt>
                <c:pt idx="178">
                  <c:v>3D7|stevor|||</c:v>
                </c:pt>
                <c:pt idx="179">
                  <c:v>3D7|stevor-1|||</c:v>
                </c:pt>
                <c:pt idx="180">
                  <c:v>3D7|stevor-1|||</c:v>
                </c:pt>
                <c:pt idx="181">
                  <c:v>3D7|stevor-2|||</c:v>
                </c:pt>
                <c:pt idx="182">
                  <c:v>3D7|stevor-2|||</c:v>
                </c:pt>
                <c:pt idx="184">
                  <c:v>DD2var43|ATSA4|0|0</c:v>
                </c:pt>
                <c:pt idx="185">
                  <c:v>DD2var43|CIDRa1.5|DBLg17|0</c:v>
                </c:pt>
                <c:pt idx="186">
                  <c:v>DD2var43|CIDRb3|DBLb7|0</c:v>
                </c:pt>
                <c:pt idx="187">
                  <c:v>DD2var43|DBLa1.2|CIDRa1.5|0</c:v>
                </c:pt>
                <c:pt idx="188">
                  <c:v>DD2var43|DBLb7|DBLg9|0</c:v>
                </c:pt>
                <c:pt idx="189">
                  <c:v>DD2var43|DBLd5|CIDRb3|0</c:v>
                </c:pt>
                <c:pt idx="190">
                  <c:v>DD2var43|DBLg17|DBLd5|0</c:v>
                </c:pt>
                <c:pt idx="191">
                  <c:v>DD2var49|CIDRa1.7|DBLb3|0</c:v>
                </c:pt>
                <c:pt idx="192">
                  <c:v>DD2var49|CIDRg2|DBLg17|0</c:v>
                </c:pt>
                <c:pt idx="193">
                  <c:v>DD2var49|DBLb3|DBLg11|0</c:v>
                </c:pt>
                <c:pt idx="194">
                  <c:v>DD2var49|DBLg17|DBLz4|0</c:v>
                </c:pt>
                <c:pt idx="195">
                  <c:v>DD2var49|NTSA8|DBLa1.2|CIDRa1.7</c:v>
                </c:pt>
                <c:pt idx="196">
                  <c:v>HB3var03|CIDRa1.4|DBLb3|0</c:v>
                </c:pt>
                <c:pt idx="197">
                  <c:v>HB3var03|CIDRb3|DBLb7|0</c:v>
                </c:pt>
                <c:pt idx="198">
                  <c:v>HB3var03|DBLb3|DBLg12|0</c:v>
                </c:pt>
                <c:pt idx="199">
                  <c:v>HB3var05|ATSA2|0|0</c:v>
                </c:pt>
                <c:pt idx="200">
                  <c:v>HB3var1csa|ATS|0|0</c:v>
                </c:pt>
                <c:pt idx="201">
                  <c:v>HB3var1csa|CIDRa|DBLb|0</c:v>
                </c:pt>
                <c:pt idx="202">
                  <c:v>HB3var1csa|DBLa|CIDRa|0</c:v>
                </c:pt>
                <c:pt idx="203">
                  <c:v>HB3var1csa|DBLb|DBLg|0</c:v>
                </c:pt>
                <c:pt idx="204">
                  <c:v>HB3var1csa|DBLe|DBLg|0</c:v>
                </c:pt>
                <c:pt idx="205">
                  <c:v>HB3var1csa|DBLg|DBLe|0</c:v>
                </c:pt>
                <c:pt idx="206">
                  <c:v>HB3var1csa|DBLg|DBLz|0</c:v>
                </c:pt>
                <c:pt idx="207">
                  <c:v>HB3var1csa|DBLz|DBLe|0</c:v>
                </c:pt>
                <c:pt idx="208">
                  <c:v>IGHvar14|ATS|0|0</c:v>
                </c:pt>
                <c:pt idx="209">
                  <c:v>IGHvar14|CIDRa|DBLb|0</c:v>
                </c:pt>
                <c:pt idx="210">
                  <c:v>IGHvar14|DBLa|CIDRa|0</c:v>
                </c:pt>
                <c:pt idx="211">
                  <c:v>IGHvar14|DBLb|DBLg|0</c:v>
                </c:pt>
                <c:pt idx="212">
                  <c:v>IGHvar14|DBLe|DBLe|0</c:v>
                </c:pt>
                <c:pt idx="213">
                  <c:v>IGHvar14|DBLg|DBLe|0</c:v>
                </c:pt>
                <c:pt idx="214">
                  <c:v>IGHvar23|ATS|0|0</c:v>
                </c:pt>
                <c:pt idx="215">
                  <c:v>IGHvar23|CIDRa|DBLb|0</c:v>
                </c:pt>
                <c:pt idx="216">
                  <c:v>IGHvar23|DBLa|CIDRa|0</c:v>
                </c:pt>
                <c:pt idx="217">
                  <c:v>IGHvar23|DBLb|DBLg|0</c:v>
                </c:pt>
                <c:pt idx="218">
                  <c:v>IGHvar23|DBLd|CIDRb|0</c:v>
                </c:pt>
                <c:pt idx="219">
                  <c:v>IGHvar23|DBLg|DBLd|0</c:v>
                </c:pt>
                <c:pt idx="220">
                  <c:v>IGHvar23|DBLg|DBLg|0</c:v>
                </c:pt>
                <c:pt idx="221">
                  <c:v>IT4var06|ATS|0|0</c:v>
                </c:pt>
                <c:pt idx="222">
                  <c:v>IT4var06|CIDRa|DBLb|0</c:v>
                </c:pt>
                <c:pt idx="223">
                  <c:v>IT4var06|DBLa|CIDRa|0</c:v>
                </c:pt>
                <c:pt idx="224">
                  <c:v>IT4var06|DBLb|DBLg|0</c:v>
                </c:pt>
                <c:pt idx="225">
                  <c:v>IT4var06|DBLd|0|0</c:v>
                </c:pt>
                <c:pt idx="226">
                  <c:v>IT4var06|DBLd|CIDRb|0</c:v>
                </c:pt>
                <c:pt idx="227">
                  <c:v>IT4var07|CIDRa1.4|DBLb1|0</c:v>
                </c:pt>
                <c:pt idx="228">
                  <c:v>IT4var07|DBLb1|DBLb3|0</c:v>
                </c:pt>
                <c:pt idx="229">
                  <c:v>IT4var07|DBLb3|DBLg10|0</c:v>
                </c:pt>
                <c:pt idx="230">
                  <c:v>IT4var07|DBLd1|CIDRb1|0</c:v>
                </c:pt>
                <c:pt idx="231">
                  <c:v>IT4var07|NTSA6|DBLa1.7|CIDRa1.4</c:v>
                </c:pt>
                <c:pt idx="232">
                  <c:v>IT4var19|ATSB3|0|0</c:v>
                </c:pt>
                <c:pt idx="233">
                  <c:v>IT4var19|CIDRa1.1|DBLb12|0</c:v>
                </c:pt>
                <c:pt idx="234">
                  <c:v>IT4var19|CIDRb1|DBLg9|0</c:v>
                </c:pt>
                <c:pt idx="235">
                  <c:v>IT4var19|DBLb12|DBLg6|0</c:v>
                </c:pt>
                <c:pt idx="236">
                  <c:v>IT4var19|DBLd1|CIDRb1|0</c:v>
                </c:pt>
                <c:pt idx="237">
                  <c:v>IT4var19|DBLg6|DBLd1|0</c:v>
                </c:pt>
                <c:pt idx="238">
                  <c:v>IT4var20|ATSB16|0|0</c:v>
                </c:pt>
                <c:pt idx="239">
                  <c:v>IT4var20|CIDRa1.1|DBLb12|0</c:v>
                </c:pt>
                <c:pt idx="240">
                  <c:v>IT4var20|DBLb12|DBLg6|0</c:v>
                </c:pt>
                <c:pt idx="241">
                  <c:v>IT4var20|DBLd1|CIDRb1|0</c:v>
                </c:pt>
                <c:pt idx="242">
                  <c:v>IT4var20|DBLg6|DBLd1|0</c:v>
                </c:pt>
                <c:pt idx="243">
                  <c:v>IT4var20|NTSB3|DBLa2|CIDRa1.1</c:v>
                </c:pt>
                <c:pt idx="244">
                  <c:v>IT4var22|CIDRa1.7|DBLb3|0</c:v>
                </c:pt>
                <c:pt idx="245">
                  <c:v>IT4var22|DBLa1.4|CIDRa1.7|0</c:v>
                </c:pt>
                <c:pt idx="246">
                  <c:v>IT4var22|DBLb3|DBLg10|0</c:v>
                </c:pt>
                <c:pt idx="247">
                  <c:v>IT4var22|DBLd1|CIDRb1|0</c:v>
                </c:pt>
                <c:pt idx="248">
                  <c:v>IT4var22|DBLg10|DBLg11|0</c:v>
                </c:pt>
                <c:pt idx="249">
                  <c:v>IT4var22|DBLg11|DBLd1|0</c:v>
                </c:pt>
                <c:pt idx="250">
                  <c:v>IT4var22|NTSA2|DBLa1.4|CIDRa1.7</c:v>
                </c:pt>
                <c:pt idx="251">
                  <c:v>MaliRF327|CIDRa|DBLb|0</c:v>
                </c:pt>
                <c:pt idx="252">
                  <c:v>MaliRF327|DBLa|CIDRa|0</c:v>
                </c:pt>
                <c:pt idx="253">
                  <c:v>MaliRF327|DBLb|DBLg|0</c:v>
                </c:pt>
                <c:pt idx="254">
                  <c:v>MaliRF327|DBLd|CIDRb|0</c:v>
                </c:pt>
                <c:pt idx="255">
                  <c:v>MaliRF327|DBLg|DBLd|0</c:v>
                </c:pt>
                <c:pt idx="256">
                  <c:v>MaliRF327|DBLg|DBLg|0</c:v>
                </c:pt>
                <c:pt idx="257">
                  <c:v>MaliRF398|CIDRa|DBLb|0</c:v>
                </c:pt>
                <c:pt idx="258">
                  <c:v>MaliRF398|DBLa|CIDRa|0</c:v>
                </c:pt>
                <c:pt idx="259">
                  <c:v>MaliRF398|DBLb|DBLg|0</c:v>
                </c:pt>
                <c:pt idx="260">
                  <c:v>MaliRF398|DBLg|DBLz|0</c:v>
                </c:pt>
                <c:pt idx="261">
                  <c:v>MaliRF398|DBLz|DBLe|0</c:v>
                </c:pt>
                <c:pt idx="264">
                  <c:v>Tetanus toxin_0.01</c:v>
                </c:pt>
                <c:pt idx="265">
                  <c:v>Tetanus toxin_0.03</c:v>
                </c:pt>
                <c:pt idx="266">
                  <c:v>Tetanus toxin_0.1</c:v>
                </c:pt>
              </c:strCache>
            </c:strRef>
          </c:cat>
          <c:val>
            <c:numRef>
              <c:f>FinalAnalysis.Heatmap!$AL$5:$AL$267</c:f>
              <c:numCache>
                <c:formatCode>00000</c:formatCode>
                <c:ptCount val="263"/>
                <c:pt idx="1">
                  <c:v>1223.1666666666661</c:v>
                </c:pt>
                <c:pt idx="2">
                  <c:v>1604.1666666666661</c:v>
                </c:pt>
                <c:pt idx="3">
                  <c:v>1558.7777777777783</c:v>
                </c:pt>
                <c:pt idx="4">
                  <c:v>15152.388888888889</c:v>
                </c:pt>
                <c:pt idx="5">
                  <c:v>0</c:v>
                </c:pt>
                <c:pt idx="6">
                  <c:v>-894.11111111111131</c:v>
                </c:pt>
                <c:pt idx="7">
                  <c:v>554.77777777777737</c:v>
                </c:pt>
                <c:pt idx="8">
                  <c:v>-1610.666666666667</c:v>
                </c:pt>
                <c:pt idx="9">
                  <c:v>-134.83333333333394</c:v>
                </c:pt>
                <c:pt idx="10">
                  <c:v>-1255.4444444444443</c:v>
                </c:pt>
                <c:pt idx="11">
                  <c:v>-465</c:v>
                </c:pt>
                <c:pt idx="12">
                  <c:v>-1370.1111111111113</c:v>
                </c:pt>
                <c:pt idx="13">
                  <c:v>-1340.1111111111113</c:v>
                </c:pt>
                <c:pt idx="14">
                  <c:v>-1338.3888888888887</c:v>
                </c:pt>
                <c:pt idx="15">
                  <c:v>0</c:v>
                </c:pt>
                <c:pt idx="16">
                  <c:v>-13.555555555555657</c:v>
                </c:pt>
                <c:pt idx="17">
                  <c:v>-546</c:v>
                </c:pt>
                <c:pt idx="18">
                  <c:v>85.944444444444343</c:v>
                </c:pt>
                <c:pt idx="19">
                  <c:v>-38.444444444444343</c:v>
                </c:pt>
                <c:pt idx="20">
                  <c:v>1200.6111111111104</c:v>
                </c:pt>
                <c:pt idx="21">
                  <c:v>-362.27777777777828</c:v>
                </c:pt>
                <c:pt idx="22">
                  <c:v>-765.66666666666697</c:v>
                </c:pt>
                <c:pt idx="23">
                  <c:v>-371.94444444444434</c:v>
                </c:pt>
                <c:pt idx="24">
                  <c:v>1033.3333333333339</c:v>
                </c:pt>
                <c:pt idx="25">
                  <c:v>-78.111111111111313</c:v>
                </c:pt>
                <c:pt idx="26">
                  <c:v>-483.38888888888869</c:v>
                </c:pt>
                <c:pt idx="27">
                  <c:v>-189.5</c:v>
                </c:pt>
                <c:pt idx="28">
                  <c:v>-266.61111111111131</c:v>
                </c:pt>
                <c:pt idx="29">
                  <c:v>-212.5</c:v>
                </c:pt>
                <c:pt idx="30">
                  <c:v>225.27777777777737</c:v>
                </c:pt>
                <c:pt idx="31">
                  <c:v>-444.83333333333394</c:v>
                </c:pt>
                <c:pt idx="32">
                  <c:v>-172.77777777777828</c:v>
                </c:pt>
                <c:pt idx="33">
                  <c:v>-687.11111111111131</c:v>
                </c:pt>
                <c:pt idx="34">
                  <c:v>195.94444444444434</c:v>
                </c:pt>
                <c:pt idx="35">
                  <c:v>-728.38888888888869</c:v>
                </c:pt>
                <c:pt idx="36">
                  <c:v>-624.33333333333394</c:v>
                </c:pt>
                <c:pt idx="37">
                  <c:v>-555.55555555555566</c:v>
                </c:pt>
                <c:pt idx="38">
                  <c:v>1144.8888888888887</c:v>
                </c:pt>
                <c:pt idx="39">
                  <c:v>-557.05555555555566</c:v>
                </c:pt>
                <c:pt idx="40">
                  <c:v>-570.61111111111131</c:v>
                </c:pt>
                <c:pt idx="41">
                  <c:v>-141.33333333333394</c:v>
                </c:pt>
                <c:pt idx="42">
                  <c:v>737.77777777777828</c:v>
                </c:pt>
                <c:pt idx="43">
                  <c:v>-37.111111111111313</c:v>
                </c:pt>
                <c:pt idx="44">
                  <c:v>-865.11111111111131</c:v>
                </c:pt>
                <c:pt idx="45">
                  <c:v>-184.61111111111131</c:v>
                </c:pt>
                <c:pt idx="46">
                  <c:v>-54.388888888888687</c:v>
                </c:pt>
                <c:pt idx="47">
                  <c:v>-599.11111111111131</c:v>
                </c:pt>
                <c:pt idx="48">
                  <c:v>-304.38888888888869</c:v>
                </c:pt>
                <c:pt idx="49">
                  <c:v>-1246.6111111111113</c:v>
                </c:pt>
                <c:pt idx="50">
                  <c:v>-1428.7222222222226</c:v>
                </c:pt>
                <c:pt idx="51">
                  <c:v>128.44444444444434</c:v>
                </c:pt>
                <c:pt idx="52">
                  <c:v>-206.94444444444434</c:v>
                </c:pt>
                <c:pt idx="53">
                  <c:v>-6.2777777777782831</c:v>
                </c:pt>
                <c:pt idx="54">
                  <c:v>-924.66666666666697</c:v>
                </c:pt>
                <c:pt idx="55">
                  <c:v>-377.3888888888896</c:v>
                </c:pt>
                <c:pt idx="56">
                  <c:v>251.77777777777828</c:v>
                </c:pt>
                <c:pt idx="57">
                  <c:v>-5.8888888888895963</c:v>
                </c:pt>
                <c:pt idx="58">
                  <c:v>-422</c:v>
                </c:pt>
                <c:pt idx="59">
                  <c:v>111</c:v>
                </c:pt>
                <c:pt idx="60">
                  <c:v>-630</c:v>
                </c:pt>
                <c:pt idx="61">
                  <c:v>-560.05555555555566</c:v>
                </c:pt>
                <c:pt idx="62">
                  <c:v>783.83333333333394</c:v>
                </c:pt>
                <c:pt idx="63">
                  <c:v>95.5</c:v>
                </c:pt>
                <c:pt idx="64">
                  <c:v>280.22222222222172</c:v>
                </c:pt>
                <c:pt idx="65">
                  <c:v>-369.05555555555566</c:v>
                </c:pt>
                <c:pt idx="66">
                  <c:v>-463.61111111111131</c:v>
                </c:pt>
                <c:pt idx="67">
                  <c:v>16.888888888888687</c:v>
                </c:pt>
                <c:pt idx="68">
                  <c:v>-505.66666666666697</c:v>
                </c:pt>
                <c:pt idx="69">
                  <c:v>-171.05555555555566</c:v>
                </c:pt>
                <c:pt idx="70">
                  <c:v>-739.16666666666697</c:v>
                </c:pt>
                <c:pt idx="71">
                  <c:v>793.16666666666697</c:v>
                </c:pt>
                <c:pt idx="72">
                  <c:v>-411.11111111111131</c:v>
                </c:pt>
                <c:pt idx="73">
                  <c:v>1992.3888888888887</c:v>
                </c:pt>
                <c:pt idx="74">
                  <c:v>511.77777777777828</c:v>
                </c:pt>
                <c:pt idx="75">
                  <c:v>-452.33333333333394</c:v>
                </c:pt>
                <c:pt idx="76">
                  <c:v>1400.5</c:v>
                </c:pt>
                <c:pt idx="77">
                  <c:v>-132.05555555555566</c:v>
                </c:pt>
                <c:pt idx="78">
                  <c:v>565.83333333333394</c:v>
                </c:pt>
                <c:pt idx="79">
                  <c:v>-1795.4444444444443</c:v>
                </c:pt>
                <c:pt idx="80">
                  <c:v>-317</c:v>
                </c:pt>
                <c:pt idx="81">
                  <c:v>-716.11111111111131</c:v>
                </c:pt>
                <c:pt idx="82">
                  <c:v>-659.44444444444434</c:v>
                </c:pt>
                <c:pt idx="83">
                  <c:v>262.66666666666697</c:v>
                </c:pt>
                <c:pt idx="84">
                  <c:v>-259.5</c:v>
                </c:pt>
                <c:pt idx="85">
                  <c:v>106.16666666666606</c:v>
                </c:pt>
                <c:pt idx="86">
                  <c:v>-1320.3333333333339</c:v>
                </c:pt>
                <c:pt idx="87">
                  <c:v>-1261.5555555555557</c:v>
                </c:pt>
                <c:pt idx="88">
                  <c:v>212.66666666666697</c:v>
                </c:pt>
                <c:pt idx="89">
                  <c:v>532.16666666666606</c:v>
                </c:pt>
                <c:pt idx="90">
                  <c:v>81.444444444444343</c:v>
                </c:pt>
                <c:pt idx="91">
                  <c:v>-404.61111111111131</c:v>
                </c:pt>
                <c:pt idx="92">
                  <c:v>237.88888888888869</c:v>
                </c:pt>
                <c:pt idx="93">
                  <c:v>0</c:v>
                </c:pt>
                <c:pt idx="94">
                  <c:v>-492.55555555555566</c:v>
                </c:pt>
                <c:pt idx="95">
                  <c:v>-757.16666666666697</c:v>
                </c:pt>
                <c:pt idx="96">
                  <c:v>-162.94444444444434</c:v>
                </c:pt>
                <c:pt idx="97">
                  <c:v>4442</c:v>
                </c:pt>
                <c:pt idx="98">
                  <c:v>-129.05555555555566</c:v>
                </c:pt>
                <c:pt idx="99">
                  <c:v>277.38888888888869</c:v>
                </c:pt>
                <c:pt idx="100">
                  <c:v>1900.9444444444443</c:v>
                </c:pt>
                <c:pt idx="101">
                  <c:v>704.72222222222172</c:v>
                </c:pt>
                <c:pt idx="102">
                  <c:v>-354.05555555555566</c:v>
                </c:pt>
                <c:pt idx="103">
                  <c:v>-580</c:v>
                </c:pt>
                <c:pt idx="104">
                  <c:v>664.05555555555566</c:v>
                </c:pt>
                <c:pt idx="105">
                  <c:v>-313.33333333333394</c:v>
                </c:pt>
                <c:pt idx="106">
                  <c:v>403.16666666666606</c:v>
                </c:pt>
                <c:pt idx="107">
                  <c:v>-7.3333333333339397</c:v>
                </c:pt>
                <c:pt idx="108">
                  <c:v>-854.05555555555566</c:v>
                </c:pt>
                <c:pt idx="109">
                  <c:v>-547.77777777777828</c:v>
                </c:pt>
                <c:pt idx="110">
                  <c:v>-210.83333333333303</c:v>
                </c:pt>
                <c:pt idx="111">
                  <c:v>-605.77777777777828</c:v>
                </c:pt>
                <c:pt idx="112">
                  <c:v>1353.3888888888887</c:v>
                </c:pt>
                <c:pt idx="113">
                  <c:v>2068.6111111111104</c:v>
                </c:pt>
                <c:pt idx="114">
                  <c:v>1148.6111111111104</c:v>
                </c:pt>
                <c:pt idx="115">
                  <c:v>1180.2777777777783</c:v>
                </c:pt>
                <c:pt idx="116">
                  <c:v>958.94444444444434</c:v>
                </c:pt>
                <c:pt idx="117">
                  <c:v>-594.33333333333303</c:v>
                </c:pt>
                <c:pt idx="118">
                  <c:v>161.33333333333303</c:v>
                </c:pt>
                <c:pt idx="119">
                  <c:v>478.61111111111131</c:v>
                </c:pt>
                <c:pt idx="120">
                  <c:v>2089.166666666667</c:v>
                </c:pt>
                <c:pt idx="121">
                  <c:v>2356</c:v>
                </c:pt>
                <c:pt idx="122">
                  <c:v>1224.3888888888887</c:v>
                </c:pt>
                <c:pt idx="123">
                  <c:v>207.83333333333394</c:v>
                </c:pt>
                <c:pt idx="124">
                  <c:v>-94.555555555555657</c:v>
                </c:pt>
                <c:pt idx="125">
                  <c:v>63</c:v>
                </c:pt>
                <c:pt idx="126">
                  <c:v>1022</c:v>
                </c:pt>
                <c:pt idx="127">
                  <c:v>39.16666666666697</c:v>
                </c:pt>
                <c:pt idx="128">
                  <c:v>-721.55555555555566</c:v>
                </c:pt>
                <c:pt idx="129">
                  <c:v>1917.5</c:v>
                </c:pt>
                <c:pt idx="130">
                  <c:v>-9.5555555555556566</c:v>
                </c:pt>
                <c:pt idx="131">
                  <c:v>906.5</c:v>
                </c:pt>
                <c:pt idx="132">
                  <c:v>-273.05555555555566</c:v>
                </c:pt>
                <c:pt idx="133">
                  <c:v>-402.16666666666697</c:v>
                </c:pt>
                <c:pt idx="134">
                  <c:v>1014.2222222222226</c:v>
                </c:pt>
                <c:pt idx="135">
                  <c:v>602.94444444444434</c:v>
                </c:pt>
                <c:pt idx="136">
                  <c:v>-75.33333333333394</c:v>
                </c:pt>
                <c:pt idx="137">
                  <c:v>1493.1111111111113</c:v>
                </c:pt>
                <c:pt idx="138">
                  <c:v>-377.83333333333394</c:v>
                </c:pt>
                <c:pt idx="139">
                  <c:v>24.33333333333394</c:v>
                </c:pt>
                <c:pt idx="140">
                  <c:v>732.16666666666697</c:v>
                </c:pt>
                <c:pt idx="141">
                  <c:v>-1180.1111111111113</c:v>
                </c:pt>
                <c:pt idx="142">
                  <c:v>-962.33333333333303</c:v>
                </c:pt>
                <c:pt idx="143">
                  <c:v>0</c:v>
                </c:pt>
                <c:pt idx="144">
                  <c:v>852.94444444444434</c:v>
                </c:pt>
                <c:pt idx="145">
                  <c:v>8142.4444444444443</c:v>
                </c:pt>
                <c:pt idx="146">
                  <c:v>11002.555555555555</c:v>
                </c:pt>
                <c:pt idx="147">
                  <c:v>5253</c:v>
                </c:pt>
                <c:pt idx="148">
                  <c:v>4541.3888888888896</c:v>
                </c:pt>
                <c:pt idx="149">
                  <c:v>11218.611111111109</c:v>
                </c:pt>
                <c:pt idx="150">
                  <c:v>6342.6666666666661</c:v>
                </c:pt>
                <c:pt idx="151">
                  <c:v>8362.8888888888905</c:v>
                </c:pt>
                <c:pt idx="152">
                  <c:v>7719</c:v>
                </c:pt>
                <c:pt idx="153">
                  <c:v>1559.5</c:v>
                </c:pt>
                <c:pt idx="154">
                  <c:v>9439.5</c:v>
                </c:pt>
                <c:pt idx="155">
                  <c:v>7594</c:v>
                </c:pt>
                <c:pt idx="156">
                  <c:v>5191.0555555555557</c:v>
                </c:pt>
                <c:pt idx="157">
                  <c:v>366.72222222222263</c:v>
                </c:pt>
                <c:pt idx="158">
                  <c:v>9042.8888888888905</c:v>
                </c:pt>
                <c:pt idx="159">
                  <c:v>11371</c:v>
                </c:pt>
                <c:pt idx="160">
                  <c:v>15186.388888888889</c:v>
                </c:pt>
                <c:pt idx="161">
                  <c:v>3816.5555555555557</c:v>
                </c:pt>
                <c:pt idx="162">
                  <c:v>11518.555555555555</c:v>
                </c:pt>
                <c:pt idx="163">
                  <c:v>13775.5</c:v>
                </c:pt>
                <c:pt idx="164">
                  <c:v>0</c:v>
                </c:pt>
                <c:pt idx="165">
                  <c:v>-864.16666666666697</c:v>
                </c:pt>
                <c:pt idx="166">
                  <c:v>405.44444444444434</c:v>
                </c:pt>
                <c:pt idx="167">
                  <c:v>28232.888888888891</c:v>
                </c:pt>
                <c:pt idx="168">
                  <c:v>0</c:v>
                </c:pt>
                <c:pt idx="169">
                  <c:v>66.444444444444343</c:v>
                </c:pt>
                <c:pt idx="170">
                  <c:v>-466.33333333333303</c:v>
                </c:pt>
                <c:pt idx="171">
                  <c:v>-1957.5</c:v>
                </c:pt>
                <c:pt idx="172">
                  <c:v>-963</c:v>
                </c:pt>
                <c:pt idx="173">
                  <c:v>0</c:v>
                </c:pt>
                <c:pt idx="174">
                  <c:v>5179.2222222222226</c:v>
                </c:pt>
                <c:pt idx="175">
                  <c:v>12655.777777777777</c:v>
                </c:pt>
                <c:pt idx="176">
                  <c:v>0</c:v>
                </c:pt>
                <c:pt idx="177">
                  <c:v>6598.7777777777774</c:v>
                </c:pt>
                <c:pt idx="178">
                  <c:v>142.66666666666697</c:v>
                </c:pt>
                <c:pt idx="179">
                  <c:v>3978.7777777777774</c:v>
                </c:pt>
                <c:pt idx="180">
                  <c:v>5966.666666666667</c:v>
                </c:pt>
                <c:pt idx="181">
                  <c:v>6518.7777777777774</c:v>
                </c:pt>
                <c:pt idx="182">
                  <c:v>-945.33333333333303</c:v>
                </c:pt>
                <c:pt idx="183">
                  <c:v>10376.277777777777</c:v>
                </c:pt>
                <c:pt idx="184">
                  <c:v>0</c:v>
                </c:pt>
                <c:pt idx="185">
                  <c:v>5760</c:v>
                </c:pt>
                <c:pt idx="186">
                  <c:v>-134.8888888888896</c:v>
                </c:pt>
                <c:pt idx="187">
                  <c:v>1327.4444444444443</c:v>
                </c:pt>
                <c:pt idx="188">
                  <c:v>2123.2777777777783</c:v>
                </c:pt>
                <c:pt idx="189">
                  <c:v>1168.9444444444443</c:v>
                </c:pt>
                <c:pt idx="190">
                  <c:v>-1112.3888888888896</c:v>
                </c:pt>
                <c:pt idx="191">
                  <c:v>-97.83333333333394</c:v>
                </c:pt>
                <c:pt idx="192">
                  <c:v>235.94444444444434</c:v>
                </c:pt>
                <c:pt idx="193">
                  <c:v>-1</c:v>
                </c:pt>
                <c:pt idx="194">
                  <c:v>831.5</c:v>
                </c:pt>
                <c:pt idx="195">
                  <c:v>-770.05555555555566</c:v>
                </c:pt>
                <c:pt idx="196">
                  <c:v>-87.5</c:v>
                </c:pt>
                <c:pt idx="197">
                  <c:v>2151.166666666667</c:v>
                </c:pt>
                <c:pt idx="198">
                  <c:v>2110.1111111111113</c:v>
                </c:pt>
                <c:pt idx="199">
                  <c:v>-989.55555555555566</c:v>
                </c:pt>
                <c:pt idx="200">
                  <c:v>6848.8888888888896</c:v>
                </c:pt>
                <c:pt idx="201">
                  <c:v>1420.4444444444443</c:v>
                </c:pt>
                <c:pt idx="202">
                  <c:v>294.55555555555566</c:v>
                </c:pt>
                <c:pt idx="203">
                  <c:v>-801</c:v>
                </c:pt>
                <c:pt idx="204">
                  <c:v>331.16666666666606</c:v>
                </c:pt>
                <c:pt idx="205">
                  <c:v>-157.77777777777828</c:v>
                </c:pt>
                <c:pt idx="206">
                  <c:v>260.16666666666606</c:v>
                </c:pt>
                <c:pt idx="207">
                  <c:v>588.94444444444434</c:v>
                </c:pt>
                <c:pt idx="208">
                  <c:v>-370.11111111111131</c:v>
                </c:pt>
                <c:pt idx="209">
                  <c:v>7704</c:v>
                </c:pt>
                <c:pt idx="210">
                  <c:v>1893.666666666667</c:v>
                </c:pt>
                <c:pt idx="211">
                  <c:v>-2114.7777777777774</c:v>
                </c:pt>
                <c:pt idx="212">
                  <c:v>-367.83333333333394</c:v>
                </c:pt>
                <c:pt idx="213">
                  <c:v>158.94444444444434</c:v>
                </c:pt>
                <c:pt idx="214">
                  <c:v>1014</c:v>
                </c:pt>
                <c:pt idx="215">
                  <c:v>13467.444444444445</c:v>
                </c:pt>
                <c:pt idx="216">
                  <c:v>4290.3333333333339</c:v>
                </c:pt>
                <c:pt idx="217">
                  <c:v>-2305.1111111111113</c:v>
                </c:pt>
                <c:pt idx="218">
                  <c:v>4230.8333333333339</c:v>
                </c:pt>
                <c:pt idx="219">
                  <c:v>121.16666666666606</c:v>
                </c:pt>
                <c:pt idx="220">
                  <c:v>51.16666666666606</c:v>
                </c:pt>
                <c:pt idx="221">
                  <c:v>-423.33333333333394</c:v>
                </c:pt>
                <c:pt idx="222">
                  <c:v>9134.0555555555547</c:v>
                </c:pt>
                <c:pt idx="223">
                  <c:v>-1231.0555555555557</c:v>
                </c:pt>
                <c:pt idx="224">
                  <c:v>-2164.2222222222226</c:v>
                </c:pt>
                <c:pt idx="225">
                  <c:v>1465.1666666666661</c:v>
                </c:pt>
                <c:pt idx="226">
                  <c:v>-1010</c:v>
                </c:pt>
                <c:pt idx="227">
                  <c:v>-387.05555555555566</c:v>
                </c:pt>
                <c:pt idx="228">
                  <c:v>-43.83333333333394</c:v>
                </c:pt>
                <c:pt idx="229">
                  <c:v>714.5</c:v>
                </c:pt>
                <c:pt idx="230">
                  <c:v>972.38888888888869</c:v>
                </c:pt>
                <c:pt idx="231">
                  <c:v>215.5</c:v>
                </c:pt>
                <c:pt idx="232">
                  <c:v>-138.5</c:v>
                </c:pt>
                <c:pt idx="233">
                  <c:v>5337.1111111111104</c:v>
                </c:pt>
                <c:pt idx="234">
                  <c:v>-308.83333333333303</c:v>
                </c:pt>
                <c:pt idx="235">
                  <c:v>-904.16666666666697</c:v>
                </c:pt>
                <c:pt idx="236">
                  <c:v>310.88888888888869</c:v>
                </c:pt>
                <c:pt idx="237">
                  <c:v>-373</c:v>
                </c:pt>
                <c:pt idx="238">
                  <c:v>-586.5</c:v>
                </c:pt>
                <c:pt idx="239">
                  <c:v>9478.6666666666661</c:v>
                </c:pt>
                <c:pt idx="240">
                  <c:v>-408.77777777777828</c:v>
                </c:pt>
                <c:pt idx="241">
                  <c:v>567</c:v>
                </c:pt>
                <c:pt idx="242">
                  <c:v>47.444444444444343</c:v>
                </c:pt>
                <c:pt idx="243">
                  <c:v>-464.77777777777828</c:v>
                </c:pt>
                <c:pt idx="244">
                  <c:v>-204.77777777777828</c:v>
                </c:pt>
                <c:pt idx="245">
                  <c:v>-1063.8888888888896</c:v>
                </c:pt>
                <c:pt idx="246">
                  <c:v>3220.8333333333339</c:v>
                </c:pt>
                <c:pt idx="247">
                  <c:v>77.444444444444343</c:v>
                </c:pt>
                <c:pt idx="248">
                  <c:v>201.83333333333394</c:v>
                </c:pt>
                <c:pt idx="249">
                  <c:v>6756.9444444444443</c:v>
                </c:pt>
                <c:pt idx="250">
                  <c:v>1183.6111111111104</c:v>
                </c:pt>
                <c:pt idx="251">
                  <c:v>-105.61111111111131</c:v>
                </c:pt>
                <c:pt idx="252">
                  <c:v>3092.833333333333</c:v>
                </c:pt>
                <c:pt idx="253">
                  <c:v>-861.33333333333394</c:v>
                </c:pt>
                <c:pt idx="254">
                  <c:v>1016.6111111111104</c:v>
                </c:pt>
                <c:pt idx="255">
                  <c:v>572.66666666666606</c:v>
                </c:pt>
                <c:pt idx="256">
                  <c:v>-196.33333333333394</c:v>
                </c:pt>
                <c:pt idx="257">
                  <c:v>553.83333333333394</c:v>
                </c:pt>
                <c:pt idx="258">
                  <c:v>2369.3333333333339</c:v>
                </c:pt>
                <c:pt idx="259">
                  <c:v>206.94444444444434</c:v>
                </c:pt>
                <c:pt idx="260">
                  <c:v>-47.5</c:v>
                </c:pt>
                <c:pt idx="261">
                  <c:v>374.61111111111131</c:v>
                </c:pt>
                <c:pt idx="262">
                  <c:v>437.22222222222172</c:v>
                </c:pt>
              </c:numCache>
            </c:numRef>
          </c:val>
          <c:extLst>
            <c:ext xmlns:c16="http://schemas.microsoft.com/office/drawing/2014/chart" uri="{C3380CC4-5D6E-409C-BE32-E72D297353CC}">
              <c16:uniqueId val="{00000000-7295-449E-86E8-7DE9CE14FD5E}"/>
            </c:ext>
          </c:extLst>
        </c:ser>
        <c:ser>
          <c:idx val="1"/>
          <c:order val="1"/>
          <c:tx>
            <c:strRef>
              <c:f>FinalAnalysis.Heatmap!$AM$4</c:f>
              <c:strCache>
                <c:ptCount val="1"/>
                <c:pt idx="0">
                  <c:v>Prot</c:v>
                </c:pt>
              </c:strCache>
            </c:strRef>
          </c:tx>
          <c:spPr>
            <a:solidFill>
              <a:schemeClr val="accent2"/>
            </a:solidFill>
            <a:ln>
              <a:noFill/>
            </a:ln>
            <a:effectLst/>
          </c:spPr>
          <c:invertIfNegative val="0"/>
          <c:cat>
            <c:strRef>
              <c:f>FinalAnalysis.Heatmap!$J$6:$J$272</c:f>
              <c:strCache>
                <c:ptCount val="267"/>
                <c:pt idx="0">
                  <c:v>apical membrane antigen 1</c:v>
                </c:pt>
                <c:pt idx="1">
                  <c:v>circumsporozoite (CS) protein</c:v>
                </c:pt>
                <c:pt idx="2">
                  <c:v>merozoite surface protein 1</c:v>
                </c:pt>
                <c:pt idx="3">
                  <c:v>merozoite surface protein 1</c:v>
                </c:pt>
                <c:pt idx="5">
                  <c:v>3D7|PF11_0008|DBLalpha tag Group A</c:v>
                </c:pt>
                <c:pt idx="6">
                  <c:v>3D7|PF13_0003|DBLalpha tag Group A</c:v>
                </c:pt>
                <c:pt idx="7">
                  <c:v>3D7|PFA0015c|DBLalpha tag Group A</c:v>
                </c:pt>
                <c:pt idx="8">
                  <c:v>3D7|MAL6P1.4|DBLalpha tag Group B/A</c:v>
                </c:pt>
                <c:pt idx="9">
                  <c:v>3D7|MAL6P1.252|DBLalpha tag Group C</c:v>
                </c:pt>
                <c:pt idx="10">
                  <c:v>3D7|PF07_0049|DBLalpha tags</c:v>
                </c:pt>
                <c:pt idx="11">
                  <c:v>3D7|PF08_0106|DBLalpha tags</c:v>
                </c:pt>
                <c:pt idx="12">
                  <c:v>3D7|PFB0010w|DBLalpha tags</c:v>
                </c:pt>
                <c:pt idx="13">
                  <c:v>3D7|PFL1960w|DBLalpha tags</c:v>
                </c:pt>
                <c:pt idx="15">
                  <c:v>3D7|MAL6P1.1|DBLa0.8|CIDRa4|0</c:v>
                </c:pt>
                <c:pt idx="16">
                  <c:v>3D7|MAL6P1.252|DBLa0.21|CIDRa2.1|0</c:v>
                </c:pt>
                <c:pt idx="17">
                  <c:v>3D7|MAL6P1.252|DBLb4|DBLd1|0</c:v>
                </c:pt>
                <c:pt idx="18">
                  <c:v>3D7|MAL6P1.252|DBLd1|CIDRb1|0</c:v>
                </c:pt>
                <c:pt idx="19">
                  <c:v>3D7|MAL6P1.4|DBLa0.6|CIDRa3.2|0</c:v>
                </c:pt>
                <c:pt idx="20">
                  <c:v>3D7|MAL6P1.4|DBLb5|DBLg13|0</c:v>
                </c:pt>
                <c:pt idx="21">
                  <c:v>3D7|MAL6P1.4|DBLd4|CIDRg1|0</c:v>
                </c:pt>
                <c:pt idx="22">
                  <c:v>3D7|MAL6P1.4|DBLe2|DBLe7|0</c:v>
                </c:pt>
                <c:pt idx="23">
                  <c:v>3D7|MAL6P1.4|DBLe7|DBLe3|0</c:v>
                </c:pt>
                <c:pt idx="24">
                  <c:v>3D7|MAL7P1.212|DBLa0.17|CIDRa3.1|0</c:v>
                </c:pt>
                <c:pt idx="25">
                  <c:v>3D7|MAL7P1.50|DBLd1|CIDRg10|0</c:v>
                </c:pt>
                <c:pt idx="26">
                  <c:v>3D7|MAL7P1.55|DBLa0.9|CIDRa2.4|0</c:v>
                </c:pt>
                <c:pt idx="27">
                  <c:v>3D7|MAL7P1.55|DBLd1|CIDRg5|0</c:v>
                </c:pt>
                <c:pt idx="28">
                  <c:v>3D7|MAL8P1.220|DBLd1|CIDRb1|0</c:v>
                </c:pt>
                <c:pt idx="29">
                  <c:v>3D7|PF07_0048|DBLd1|CIDRb6|0</c:v>
                </c:pt>
                <c:pt idx="30">
                  <c:v>3D7|PF07_0049|DBLa0.17|CIDRa3.1|0</c:v>
                </c:pt>
                <c:pt idx="31">
                  <c:v>3D7|PF07_0049|DBLd1|CIDRg7|0</c:v>
                </c:pt>
                <c:pt idx="32">
                  <c:v>3D7|PF07_0050|DBLa0.18|CIDRa6|0</c:v>
                </c:pt>
                <c:pt idx="33">
                  <c:v>3D7|PF07_0050|DBLb6|DBLg9|0</c:v>
                </c:pt>
                <c:pt idx="34">
                  <c:v>3D7|PF07_0051|DBLa0.1|CIDRa3.1|0</c:v>
                </c:pt>
                <c:pt idx="35">
                  <c:v>3D7|PF07_0051|DBLd1|CIDRb1|0</c:v>
                </c:pt>
                <c:pt idx="36">
                  <c:v>3D7|PF07_0139|DBLa0.16|CIDRa3.4|0</c:v>
                </c:pt>
                <c:pt idx="37">
                  <c:v>3D7|PF07_0139|DBLd1|CIDRb1|0</c:v>
                </c:pt>
                <c:pt idx="38">
                  <c:v>3D7|PF07_0139|DBLe4|ATSB1|0</c:v>
                </c:pt>
                <c:pt idx="39">
                  <c:v>3D7|PF08_0103|DBLa0.12|CIDRa2.2|0</c:v>
                </c:pt>
                <c:pt idx="40">
                  <c:v>3D7|PF08_0106|DBLa0.2|CIDRa3.1|0</c:v>
                </c:pt>
                <c:pt idx="41">
                  <c:v>3D7|PF08_0106|DBLd1|CIDRb1|0</c:v>
                </c:pt>
                <c:pt idx="42">
                  <c:v>3D7|PF08_0107|DBLd1|CIDRg2|0</c:v>
                </c:pt>
                <c:pt idx="43">
                  <c:v>3D7|PF08_0142|DBLa0.9|CIDRa2.11|0</c:v>
                </c:pt>
                <c:pt idx="44">
                  <c:v>3D7|PF10_0001|DBLd1|CIDRg4|0</c:v>
                </c:pt>
                <c:pt idx="45">
                  <c:v>3D7|PF10_0406|DBLa0.9|CIDRa2.7|0</c:v>
                </c:pt>
                <c:pt idx="46">
                  <c:v>3D7|PF10_0406|DBLd1|CIDRb1|0</c:v>
                </c:pt>
                <c:pt idx="47">
                  <c:v>3D7|PF11_0007|DBLa0.15|CIDRa3.2|0</c:v>
                </c:pt>
                <c:pt idx="48">
                  <c:v>3D7|PF11_0007|DBLd1|CIDRb1|0</c:v>
                </c:pt>
                <c:pt idx="49">
                  <c:v>3D7|PF13_0001|DBLa0.11|CIDRa2.4|0</c:v>
                </c:pt>
                <c:pt idx="50">
                  <c:v>3D7|PF13_0001|DBLd1|CIDRb1|0</c:v>
                </c:pt>
                <c:pt idx="51">
                  <c:v>3D7|PF13_0364|DBLa0.16|CIDRa3.4|0</c:v>
                </c:pt>
                <c:pt idx="52">
                  <c:v>3D7|PF13_0364|DBLd1|CIDRb6|0</c:v>
                </c:pt>
                <c:pt idx="53">
                  <c:v>3D7|PFA0005w|DBLa0.11|CIDRa2.8|0</c:v>
                </c:pt>
                <c:pt idx="54">
                  <c:v>3D7|PFA0005w|DBLd1|CIDRb1|0</c:v>
                </c:pt>
                <c:pt idx="55">
                  <c:v>3D7|PFA0765c|DBLa0.5|CIDRa2.8|0</c:v>
                </c:pt>
                <c:pt idx="56">
                  <c:v>3D7|PFB0010w|DBLa0.7|CIDRa2.2|0</c:v>
                </c:pt>
                <c:pt idx="57">
                  <c:v>3D7|PFB0010w|DBLg11|ATSB1|0</c:v>
                </c:pt>
                <c:pt idx="58">
                  <c:v>3D7|PFB1055c|DBLa0.16|CIDRa3.4|0</c:v>
                </c:pt>
                <c:pt idx="59">
                  <c:v>3D7|PFC1120c|DBLa0.9|CIDRa2.1|0</c:v>
                </c:pt>
                <c:pt idx="60">
                  <c:v>3D7|PFC1120c|DBLd1|CIDRb7|0</c:v>
                </c:pt>
                <c:pt idx="61">
                  <c:v>3D7|PFD0005w|DBLg5|DBLd1|0</c:v>
                </c:pt>
                <c:pt idx="62">
                  <c:v>3D7|PFD0615c|DBLa0.17|CIDRa3.1|0</c:v>
                </c:pt>
                <c:pt idx="63">
                  <c:v>3D7|PFD0615c|DBLd1|CIDRb1|0</c:v>
                </c:pt>
                <c:pt idx="64">
                  <c:v>3D7|PFD0625c|DBLa0.1|CIDRa3.2|0</c:v>
                </c:pt>
                <c:pt idx="65">
                  <c:v>3D7|PFD0630c|DBLa0.1|CIDRa3.1|0</c:v>
                </c:pt>
                <c:pt idx="66">
                  <c:v>3D7|PFD0630c|DBLd1|CIDRg2|0</c:v>
                </c:pt>
                <c:pt idx="67">
                  <c:v>3D7|PFD0635c|DBLa0.1|CIDRa3.1|0</c:v>
                </c:pt>
                <c:pt idx="68">
                  <c:v>3D7|PFD0995c|DBLa0.1|CIDRa3.2|0</c:v>
                </c:pt>
                <c:pt idx="69">
                  <c:v>3D7|PFD0995c|DBLd1|CIDRg6|0</c:v>
                </c:pt>
                <c:pt idx="70">
                  <c:v>3D7|PFD1005c|DBLa0.8|CIDRa4|0</c:v>
                </c:pt>
                <c:pt idx="71">
                  <c:v>3D7|PFD1005c|DBLd1|CIDRg11|0</c:v>
                </c:pt>
                <c:pt idx="72">
                  <c:v>3D7|PFD1015c|DBLa0.24|CIDRa3.4|0</c:v>
                </c:pt>
                <c:pt idx="73">
                  <c:v>3D7|PFD1015c|DBLd1|CIDRb1|0</c:v>
                </c:pt>
                <c:pt idx="74">
                  <c:v>3D7|PFD1245c|DBLa0.14|CIDRa4|0</c:v>
                </c:pt>
                <c:pt idx="75">
                  <c:v>3D7|PFD1245c|DBLd1|CIDRb1|0</c:v>
                </c:pt>
                <c:pt idx="76">
                  <c:v>3D7|PFE0005w|DBLd1|CIDRb1|0</c:v>
                </c:pt>
                <c:pt idx="77">
                  <c:v>3D7|PFI0005w|DBLd1|CIDRg12|0</c:v>
                </c:pt>
                <c:pt idx="78">
                  <c:v>3D7|PFL0005w|DBLa0.9|CIDRa2.2|0</c:v>
                </c:pt>
                <c:pt idx="79">
                  <c:v>3D7|PFL0005w|DBLd1|CIDRb1|0</c:v>
                </c:pt>
                <c:pt idx="80">
                  <c:v>3D7|PFL0020w|DBLg14|DBLz5|0</c:v>
                </c:pt>
                <c:pt idx="81">
                  <c:v>3D7|PFL0020w|DBLz5|DBLe4|0</c:v>
                </c:pt>
                <c:pt idx="82">
                  <c:v>3D7|PFL0935c|DBLa0.16|CIDRa3.4|0</c:v>
                </c:pt>
                <c:pt idx="83">
                  <c:v>3D7|PFL0935c|DBLd1|CIDRg12|0</c:v>
                </c:pt>
                <c:pt idx="84">
                  <c:v>3D7|PFL1950w|DBLa0.7|CIDRa4|0</c:v>
                </c:pt>
                <c:pt idx="85">
                  <c:v>3D7|PFL1950w|DBLd1|CIDRb1|0</c:v>
                </c:pt>
                <c:pt idx="86">
                  <c:v>3D7|PFL1955w|DBLa0.16|CIDRa3.4|0</c:v>
                </c:pt>
                <c:pt idx="87">
                  <c:v>3D7|PFL1955w|DBLd1|CIDRb1|0</c:v>
                </c:pt>
                <c:pt idx="88">
                  <c:v>3D7|PFL1960w|DBLa0.20|CIDRa3.1|0</c:v>
                </c:pt>
                <c:pt idx="89">
                  <c:v>3D7|PFL1960w|DBLd1|CIDRb1|0</c:v>
                </c:pt>
                <c:pt idx="90">
                  <c:v>3D7|PFL2665c|DBLa0.19|CIDRa2.3|0</c:v>
                </c:pt>
                <c:pt idx="91">
                  <c:v>3D7|PFL2665c|DBLd1|CIDRb1|0</c:v>
                </c:pt>
                <c:pt idx="93">
                  <c:v>3D7|MAL6P1.316|DBLa2|CIDRa1.8|0</c:v>
                </c:pt>
                <c:pt idx="94">
                  <c:v>3D7|MAL6P1.316|DBLb12|DBLg4|0</c:v>
                </c:pt>
                <c:pt idx="95">
                  <c:v>3D7|MAL6P1.316|DBLz3|DBLe12|0</c:v>
                </c:pt>
                <c:pt idx="96">
                  <c:v>3D7|PF08_0140|CIDRa1.6|DBLb12|DBLg4</c:v>
                </c:pt>
                <c:pt idx="97">
                  <c:v>3D7|PF08_0140|DBLa2|CIDRa1.6|0</c:v>
                </c:pt>
                <c:pt idx="98">
                  <c:v>3D7|PF08_0140|DBLa2|CIDRa1.6|DBLb12</c:v>
                </c:pt>
                <c:pt idx="99">
                  <c:v>3D7|PF08_0140|DBLb12|DBLg4|0</c:v>
                </c:pt>
                <c:pt idx="100">
                  <c:v>3D7|PF08_0140|DBLd1|CIDRb1|0</c:v>
                </c:pt>
                <c:pt idx="101">
                  <c:v>3D7|PF08_0141|DBLa1.6|CIDRd2|0</c:v>
                </c:pt>
                <c:pt idx="102">
                  <c:v>3D7|PF08_0141|DBLg14|DBLz5|0</c:v>
                </c:pt>
                <c:pt idx="103">
                  <c:v>3D7|PF08_0141|DBLz5|DBLe4|0</c:v>
                </c:pt>
                <c:pt idx="104">
                  <c:v>3D7|PF08_0141e1s1|PfEMP1 - Extracellular - non-CD36-binding</c:v>
                </c:pt>
                <c:pt idx="105">
                  <c:v>3D7|PF08_0141e1s2|PfEMP1 - Extracellular - non-CD36-binding</c:v>
                </c:pt>
                <c:pt idx="106">
                  <c:v>3D7|PF08_0141e1s3|PfEMP1 - Extracellular - non-CD36-binding</c:v>
                </c:pt>
                <c:pt idx="107">
                  <c:v>3D7|PF11_0008|DBLa1.5|CIDRg3|0</c:v>
                </c:pt>
                <c:pt idx="108">
                  <c:v>3D7|PF11_0008|DBLg12|DBLd5|0</c:v>
                </c:pt>
                <c:pt idx="109">
                  <c:v>3D7|PF11_0008e1s1|PfEMP1 - Extracellular - non-CD36-binding</c:v>
                </c:pt>
                <c:pt idx="110">
                  <c:v>3D7|PF11_0008e1s2|PfEMP1 - Extracellular - non-CD36-binding</c:v>
                </c:pt>
                <c:pt idx="111">
                  <c:v>3D7|PF11_0008e1s3|PfEMP1 - Extracellular - non-CD36-binding</c:v>
                </c:pt>
                <c:pt idx="112">
                  <c:v>3D7|PF11_0521|DBLb3|DBLb6|0</c:v>
                </c:pt>
                <c:pt idx="113">
                  <c:v>3D7|PF11_0521|DBLb6|DBLd3|0</c:v>
                </c:pt>
                <c:pt idx="114">
                  <c:v>3D7|PF13_0003|DBLa1.6|CIDRd1|0</c:v>
                </c:pt>
                <c:pt idx="115">
                  <c:v>3D7|PF13_0003|DBLb3|DBLg12|0</c:v>
                </c:pt>
                <c:pt idx="116">
                  <c:v>3D7|PF13_0003|DBLd5|CIDRb3|0</c:v>
                </c:pt>
                <c:pt idx="117">
                  <c:v>3D7|PF13_0003|DBLg12|DBLd5|0</c:v>
                </c:pt>
                <c:pt idx="118">
                  <c:v>3D7|PFA0015c|DBLa1.3|DBLe8|0</c:v>
                </c:pt>
                <c:pt idx="119">
                  <c:v>3D7|PFD0020c|DBLa1.2|CIDRa1.1|0</c:v>
                </c:pt>
                <c:pt idx="120">
                  <c:v>3D7|PFD0020c|DBLb12|DBLg6|0</c:v>
                </c:pt>
                <c:pt idx="121">
                  <c:v>3D7|PFD0020c|DBLd1|CIDRg8|0</c:v>
                </c:pt>
                <c:pt idx="122">
                  <c:v>3D7|PFD0020c|DBLg6|DBLg11|0</c:v>
                </c:pt>
                <c:pt idx="123">
                  <c:v>3D7|PFD1235w|DBLa1.4|CIDRa1.6|0</c:v>
                </c:pt>
                <c:pt idx="124">
                  <c:v>3D7|PFD1235w|DBLb3|DBLb3|0</c:v>
                </c:pt>
                <c:pt idx="125">
                  <c:v>3D7|PFD1235w|DBLb3|DBLg13|0</c:v>
                </c:pt>
                <c:pt idx="126">
                  <c:v>3D7|PFD1235w|DBLd1|CIDRb5|0</c:v>
                </c:pt>
                <c:pt idx="127">
                  <c:v>3D7|PFD1235w|DBLg13|DBLd1|0</c:v>
                </c:pt>
                <c:pt idx="128">
                  <c:v>3D7|PFE1640w|DBLb1|DBLg15|0</c:v>
                </c:pt>
                <c:pt idx="129">
                  <c:v>3D7|PFE1640w|DBLe1|DBLg8|0</c:v>
                </c:pt>
                <c:pt idx="130">
                  <c:v>3D7|PFE1640w|DBLg15|DBLe1|0</c:v>
                </c:pt>
                <c:pt idx="131">
                  <c:v>3D7|PFE1640w|DBLg8|DBLz1|0</c:v>
                </c:pt>
                <c:pt idx="132">
                  <c:v>3D7|PFE1640w|DBLz1|DBLe5|0</c:v>
                </c:pt>
                <c:pt idx="133">
                  <c:v>3D7|PFF0020c|DBLa1.3|DBLe8|0</c:v>
                </c:pt>
                <c:pt idx="134">
                  <c:v>3D7|PFI1820w|DBLa1.3|DBLe8|0</c:v>
                </c:pt>
                <c:pt idx="135">
                  <c:v>3D7|PFL0020w|DBLa0.18|CIDRa5|0</c:v>
                </c:pt>
                <c:pt idx="136">
                  <c:v>3D7|PFL0020w|DBLb5|DBLg14|0</c:v>
                </c:pt>
                <c:pt idx="137">
                  <c:v>3D7|PFL0030c|DBLepam4|DBLepam5|0</c:v>
                </c:pt>
                <c:pt idx="138">
                  <c:v>3D7|PFL0030c|DBLepam5|DBLe10|0</c:v>
                </c:pt>
                <c:pt idx="139">
                  <c:v>3D7|PFL0030c|DBLpam1|DBLpam2|0</c:v>
                </c:pt>
                <c:pt idx="140">
                  <c:v>3D7|PFL0030c|DBLpam2|CIDRpam|0</c:v>
                </c:pt>
                <c:pt idx="141">
                  <c:v>3D7|PFL0030c|DBLpam3|DBLepam4|0</c:v>
                </c:pt>
                <c:pt idx="143">
                  <c:v>3D7|MAL6P1.252-e2|PfEMP1 - Intracellular</c:v>
                </c:pt>
                <c:pt idx="144">
                  <c:v>3D7|MAL7P1.55|ATSB13|0|0</c:v>
                </c:pt>
                <c:pt idx="145">
                  <c:v>3D7|MAL8P1.220|ATSB1|0|0</c:v>
                </c:pt>
                <c:pt idx="146">
                  <c:v>3D7|PF07_0048|ATSB7|0|0</c:v>
                </c:pt>
                <c:pt idx="147">
                  <c:v>3D7|PF07_0048e2s1|PfEMP1 - Intracellular</c:v>
                </c:pt>
                <c:pt idx="148">
                  <c:v>3D7|PF08_0107|ATSB2|0|0</c:v>
                </c:pt>
                <c:pt idx="149">
                  <c:v>3D7|PF08_0140e2s1|PfEMP1 - Intracellular</c:v>
                </c:pt>
                <c:pt idx="150">
                  <c:v>3D7|PF08_0141|ATSA3|0|0</c:v>
                </c:pt>
                <c:pt idx="151">
                  <c:v>3D7|PF08_0141e2s1|PfEMP1 - Intracellular</c:v>
                </c:pt>
                <c:pt idx="152">
                  <c:v>3D7|PF10_0001|ATSB1|0|0</c:v>
                </c:pt>
                <c:pt idx="153">
                  <c:v>3D7|PF10_0406|ATSB1|0|0</c:v>
                </c:pt>
                <c:pt idx="154">
                  <c:v>3D7|PF11_0008e2s1|PfEMP1 - Intracellular</c:v>
                </c:pt>
                <c:pt idx="155">
                  <c:v>3D7|PF11_0521|ATSA2|0|0</c:v>
                </c:pt>
                <c:pt idx="156">
                  <c:v>3D7|PF11_0521|PfEMP1 - Intracellular</c:v>
                </c:pt>
                <c:pt idx="157">
                  <c:v>3D7|PF13_0003|ATSA2|0|0</c:v>
                </c:pt>
                <c:pt idx="158">
                  <c:v>3D7|PFC0005w|ATSB1|0|0</c:v>
                </c:pt>
                <c:pt idx="159">
                  <c:v>3D7|PFD0995ce2s1|PfEMP1 - Intracellular</c:v>
                </c:pt>
                <c:pt idx="160">
                  <c:v>3D7|PFD1000c|ATSB19|0|0</c:v>
                </c:pt>
                <c:pt idx="161">
                  <c:v>3D7|PFD1235w|ATSA2|0|0</c:v>
                </c:pt>
                <c:pt idx="162">
                  <c:v>3D7|PFL1955w|ATSB7|0|0</c:v>
                </c:pt>
                <c:pt idx="164">
                  <c:v>3D7|AMA1</c:v>
                </c:pt>
                <c:pt idx="165">
                  <c:v>3D7|MSP1 - segment 1</c:v>
                </c:pt>
                <c:pt idx="166">
                  <c:v>3D7|MSP1 - segment 2</c:v>
                </c:pt>
                <c:pt idx="168">
                  <c:v>3D7|PF07_0049</c:v>
                </c:pt>
                <c:pt idx="169">
                  <c:v>3D7|PF08_0140</c:v>
                </c:pt>
                <c:pt idx="170">
                  <c:v>3D7|PF11_0007</c:v>
                </c:pt>
                <c:pt idx="171">
                  <c:v>3D7|PF11_0521PF11_0521_1|DBL|CIDR|0</c:v>
                </c:pt>
                <c:pt idx="173">
                  <c:v>3D7|rifin|||</c:v>
                </c:pt>
                <c:pt idx="174">
                  <c:v>3D7|rifin|||</c:v>
                </c:pt>
                <c:pt idx="176">
                  <c:v>3D7|stevor|||</c:v>
                </c:pt>
                <c:pt idx="177">
                  <c:v>3D7|stevor|||</c:v>
                </c:pt>
                <c:pt idx="178">
                  <c:v>3D7|stevor|||</c:v>
                </c:pt>
                <c:pt idx="179">
                  <c:v>3D7|stevor-1|||</c:v>
                </c:pt>
                <c:pt idx="180">
                  <c:v>3D7|stevor-1|||</c:v>
                </c:pt>
                <c:pt idx="181">
                  <c:v>3D7|stevor-2|||</c:v>
                </c:pt>
                <c:pt idx="182">
                  <c:v>3D7|stevor-2|||</c:v>
                </c:pt>
                <c:pt idx="184">
                  <c:v>DD2var43|ATSA4|0|0</c:v>
                </c:pt>
                <c:pt idx="185">
                  <c:v>DD2var43|CIDRa1.5|DBLg17|0</c:v>
                </c:pt>
                <c:pt idx="186">
                  <c:v>DD2var43|CIDRb3|DBLb7|0</c:v>
                </c:pt>
                <c:pt idx="187">
                  <c:v>DD2var43|DBLa1.2|CIDRa1.5|0</c:v>
                </c:pt>
                <c:pt idx="188">
                  <c:v>DD2var43|DBLb7|DBLg9|0</c:v>
                </c:pt>
                <c:pt idx="189">
                  <c:v>DD2var43|DBLd5|CIDRb3|0</c:v>
                </c:pt>
                <c:pt idx="190">
                  <c:v>DD2var43|DBLg17|DBLd5|0</c:v>
                </c:pt>
                <c:pt idx="191">
                  <c:v>DD2var49|CIDRa1.7|DBLb3|0</c:v>
                </c:pt>
                <c:pt idx="192">
                  <c:v>DD2var49|CIDRg2|DBLg17|0</c:v>
                </c:pt>
                <c:pt idx="193">
                  <c:v>DD2var49|DBLb3|DBLg11|0</c:v>
                </c:pt>
                <c:pt idx="194">
                  <c:v>DD2var49|DBLg17|DBLz4|0</c:v>
                </c:pt>
                <c:pt idx="195">
                  <c:v>DD2var49|NTSA8|DBLa1.2|CIDRa1.7</c:v>
                </c:pt>
                <c:pt idx="196">
                  <c:v>HB3var03|CIDRa1.4|DBLb3|0</c:v>
                </c:pt>
                <c:pt idx="197">
                  <c:v>HB3var03|CIDRb3|DBLb7|0</c:v>
                </c:pt>
                <c:pt idx="198">
                  <c:v>HB3var03|DBLb3|DBLg12|0</c:v>
                </c:pt>
                <c:pt idx="199">
                  <c:v>HB3var05|ATSA2|0|0</c:v>
                </c:pt>
                <c:pt idx="200">
                  <c:v>HB3var1csa|ATS|0|0</c:v>
                </c:pt>
                <c:pt idx="201">
                  <c:v>HB3var1csa|CIDRa|DBLb|0</c:v>
                </c:pt>
                <c:pt idx="202">
                  <c:v>HB3var1csa|DBLa|CIDRa|0</c:v>
                </c:pt>
                <c:pt idx="203">
                  <c:v>HB3var1csa|DBLb|DBLg|0</c:v>
                </c:pt>
                <c:pt idx="204">
                  <c:v>HB3var1csa|DBLe|DBLg|0</c:v>
                </c:pt>
                <c:pt idx="205">
                  <c:v>HB3var1csa|DBLg|DBLe|0</c:v>
                </c:pt>
                <c:pt idx="206">
                  <c:v>HB3var1csa|DBLg|DBLz|0</c:v>
                </c:pt>
                <c:pt idx="207">
                  <c:v>HB3var1csa|DBLz|DBLe|0</c:v>
                </c:pt>
                <c:pt idx="208">
                  <c:v>IGHvar14|ATS|0|0</c:v>
                </c:pt>
                <c:pt idx="209">
                  <c:v>IGHvar14|CIDRa|DBLb|0</c:v>
                </c:pt>
                <c:pt idx="210">
                  <c:v>IGHvar14|DBLa|CIDRa|0</c:v>
                </c:pt>
                <c:pt idx="211">
                  <c:v>IGHvar14|DBLb|DBLg|0</c:v>
                </c:pt>
                <c:pt idx="212">
                  <c:v>IGHvar14|DBLe|DBLe|0</c:v>
                </c:pt>
                <c:pt idx="213">
                  <c:v>IGHvar14|DBLg|DBLe|0</c:v>
                </c:pt>
                <c:pt idx="214">
                  <c:v>IGHvar23|ATS|0|0</c:v>
                </c:pt>
                <c:pt idx="215">
                  <c:v>IGHvar23|CIDRa|DBLb|0</c:v>
                </c:pt>
                <c:pt idx="216">
                  <c:v>IGHvar23|DBLa|CIDRa|0</c:v>
                </c:pt>
                <c:pt idx="217">
                  <c:v>IGHvar23|DBLb|DBLg|0</c:v>
                </c:pt>
                <c:pt idx="218">
                  <c:v>IGHvar23|DBLd|CIDRb|0</c:v>
                </c:pt>
                <c:pt idx="219">
                  <c:v>IGHvar23|DBLg|DBLd|0</c:v>
                </c:pt>
                <c:pt idx="220">
                  <c:v>IGHvar23|DBLg|DBLg|0</c:v>
                </c:pt>
                <c:pt idx="221">
                  <c:v>IT4var06|ATS|0|0</c:v>
                </c:pt>
                <c:pt idx="222">
                  <c:v>IT4var06|CIDRa|DBLb|0</c:v>
                </c:pt>
                <c:pt idx="223">
                  <c:v>IT4var06|DBLa|CIDRa|0</c:v>
                </c:pt>
                <c:pt idx="224">
                  <c:v>IT4var06|DBLb|DBLg|0</c:v>
                </c:pt>
                <c:pt idx="225">
                  <c:v>IT4var06|DBLd|0|0</c:v>
                </c:pt>
                <c:pt idx="226">
                  <c:v>IT4var06|DBLd|CIDRb|0</c:v>
                </c:pt>
                <c:pt idx="227">
                  <c:v>IT4var07|CIDRa1.4|DBLb1|0</c:v>
                </c:pt>
                <c:pt idx="228">
                  <c:v>IT4var07|DBLb1|DBLb3|0</c:v>
                </c:pt>
                <c:pt idx="229">
                  <c:v>IT4var07|DBLb3|DBLg10|0</c:v>
                </c:pt>
                <c:pt idx="230">
                  <c:v>IT4var07|DBLd1|CIDRb1|0</c:v>
                </c:pt>
                <c:pt idx="231">
                  <c:v>IT4var07|NTSA6|DBLa1.7|CIDRa1.4</c:v>
                </c:pt>
                <c:pt idx="232">
                  <c:v>IT4var19|ATSB3|0|0</c:v>
                </c:pt>
                <c:pt idx="233">
                  <c:v>IT4var19|CIDRa1.1|DBLb12|0</c:v>
                </c:pt>
                <c:pt idx="234">
                  <c:v>IT4var19|CIDRb1|DBLg9|0</c:v>
                </c:pt>
                <c:pt idx="235">
                  <c:v>IT4var19|DBLb12|DBLg6|0</c:v>
                </c:pt>
                <c:pt idx="236">
                  <c:v>IT4var19|DBLd1|CIDRb1|0</c:v>
                </c:pt>
                <c:pt idx="237">
                  <c:v>IT4var19|DBLg6|DBLd1|0</c:v>
                </c:pt>
                <c:pt idx="238">
                  <c:v>IT4var20|ATSB16|0|0</c:v>
                </c:pt>
                <c:pt idx="239">
                  <c:v>IT4var20|CIDRa1.1|DBLb12|0</c:v>
                </c:pt>
                <c:pt idx="240">
                  <c:v>IT4var20|DBLb12|DBLg6|0</c:v>
                </c:pt>
                <c:pt idx="241">
                  <c:v>IT4var20|DBLd1|CIDRb1|0</c:v>
                </c:pt>
                <c:pt idx="242">
                  <c:v>IT4var20|DBLg6|DBLd1|0</c:v>
                </c:pt>
                <c:pt idx="243">
                  <c:v>IT4var20|NTSB3|DBLa2|CIDRa1.1</c:v>
                </c:pt>
                <c:pt idx="244">
                  <c:v>IT4var22|CIDRa1.7|DBLb3|0</c:v>
                </c:pt>
                <c:pt idx="245">
                  <c:v>IT4var22|DBLa1.4|CIDRa1.7|0</c:v>
                </c:pt>
                <c:pt idx="246">
                  <c:v>IT4var22|DBLb3|DBLg10|0</c:v>
                </c:pt>
                <c:pt idx="247">
                  <c:v>IT4var22|DBLd1|CIDRb1|0</c:v>
                </c:pt>
                <c:pt idx="248">
                  <c:v>IT4var22|DBLg10|DBLg11|0</c:v>
                </c:pt>
                <c:pt idx="249">
                  <c:v>IT4var22|DBLg11|DBLd1|0</c:v>
                </c:pt>
                <c:pt idx="250">
                  <c:v>IT4var22|NTSA2|DBLa1.4|CIDRa1.7</c:v>
                </c:pt>
                <c:pt idx="251">
                  <c:v>MaliRF327|CIDRa|DBLb|0</c:v>
                </c:pt>
                <c:pt idx="252">
                  <c:v>MaliRF327|DBLa|CIDRa|0</c:v>
                </c:pt>
                <c:pt idx="253">
                  <c:v>MaliRF327|DBLb|DBLg|0</c:v>
                </c:pt>
                <c:pt idx="254">
                  <c:v>MaliRF327|DBLd|CIDRb|0</c:v>
                </c:pt>
                <c:pt idx="255">
                  <c:v>MaliRF327|DBLg|DBLd|0</c:v>
                </c:pt>
                <c:pt idx="256">
                  <c:v>MaliRF327|DBLg|DBLg|0</c:v>
                </c:pt>
                <c:pt idx="257">
                  <c:v>MaliRF398|CIDRa|DBLb|0</c:v>
                </c:pt>
                <c:pt idx="258">
                  <c:v>MaliRF398|DBLa|CIDRa|0</c:v>
                </c:pt>
                <c:pt idx="259">
                  <c:v>MaliRF398|DBLb|DBLg|0</c:v>
                </c:pt>
                <c:pt idx="260">
                  <c:v>MaliRF398|DBLg|DBLz|0</c:v>
                </c:pt>
                <c:pt idx="261">
                  <c:v>MaliRF398|DBLz|DBLe|0</c:v>
                </c:pt>
                <c:pt idx="264">
                  <c:v>Tetanus toxin_0.01</c:v>
                </c:pt>
                <c:pt idx="265">
                  <c:v>Tetanus toxin_0.03</c:v>
                </c:pt>
                <c:pt idx="266">
                  <c:v>Tetanus toxin_0.1</c:v>
                </c:pt>
              </c:strCache>
            </c:strRef>
          </c:cat>
          <c:val>
            <c:numRef>
              <c:f>FinalAnalysis.Heatmap!$AM$5:$AM$267</c:f>
              <c:numCache>
                <c:formatCode>00000</c:formatCode>
                <c:ptCount val="263"/>
                <c:pt idx="1">
                  <c:v>739.77777777777737</c:v>
                </c:pt>
                <c:pt idx="2">
                  <c:v>1635.4444444444443</c:v>
                </c:pt>
                <c:pt idx="3">
                  <c:v>1332.4444444444453</c:v>
                </c:pt>
                <c:pt idx="4">
                  <c:v>9331.3333333333339</c:v>
                </c:pt>
                <c:pt idx="5">
                  <c:v>0</c:v>
                </c:pt>
                <c:pt idx="6">
                  <c:v>-783.66666666666606</c:v>
                </c:pt>
                <c:pt idx="7">
                  <c:v>-204.55555555555566</c:v>
                </c:pt>
                <c:pt idx="8">
                  <c:v>-1481.4444444444453</c:v>
                </c:pt>
                <c:pt idx="9">
                  <c:v>-464.22222222222263</c:v>
                </c:pt>
                <c:pt idx="10">
                  <c:v>-1368.4444444444453</c:v>
                </c:pt>
                <c:pt idx="11">
                  <c:v>-1008.2222222222226</c:v>
                </c:pt>
                <c:pt idx="12">
                  <c:v>-1920.4444444444453</c:v>
                </c:pt>
                <c:pt idx="13">
                  <c:v>-1340.3333333333339</c:v>
                </c:pt>
                <c:pt idx="14">
                  <c:v>-1853.5555555555547</c:v>
                </c:pt>
                <c:pt idx="15">
                  <c:v>0</c:v>
                </c:pt>
                <c:pt idx="16">
                  <c:v>-108.22222222222263</c:v>
                </c:pt>
                <c:pt idx="17">
                  <c:v>-634.22222222222263</c:v>
                </c:pt>
                <c:pt idx="18">
                  <c:v>173.77777777777737</c:v>
                </c:pt>
                <c:pt idx="19">
                  <c:v>316.11111111110949</c:v>
                </c:pt>
                <c:pt idx="20">
                  <c:v>1110.4444444444443</c:v>
                </c:pt>
                <c:pt idx="21">
                  <c:v>-76.555555555554747</c:v>
                </c:pt>
                <c:pt idx="22">
                  <c:v>-791.22222222222263</c:v>
                </c:pt>
                <c:pt idx="23">
                  <c:v>-544.22222222222263</c:v>
                </c:pt>
                <c:pt idx="24">
                  <c:v>1432.1111111111095</c:v>
                </c:pt>
                <c:pt idx="25">
                  <c:v>-372.22222222222263</c:v>
                </c:pt>
                <c:pt idx="26">
                  <c:v>-590.22222222222263</c:v>
                </c:pt>
                <c:pt idx="27">
                  <c:v>158.11111111110949</c:v>
                </c:pt>
                <c:pt idx="28">
                  <c:v>919.11111111110949</c:v>
                </c:pt>
                <c:pt idx="29">
                  <c:v>-121.55555555555475</c:v>
                </c:pt>
                <c:pt idx="30">
                  <c:v>-445.22222222222263</c:v>
                </c:pt>
                <c:pt idx="31">
                  <c:v>-713.66666666666606</c:v>
                </c:pt>
                <c:pt idx="32">
                  <c:v>63.111111111109494</c:v>
                </c:pt>
                <c:pt idx="33">
                  <c:v>-470.22222222222263</c:v>
                </c:pt>
                <c:pt idx="34">
                  <c:v>557.11111111110949</c:v>
                </c:pt>
                <c:pt idx="35">
                  <c:v>-354.88888888889051</c:v>
                </c:pt>
                <c:pt idx="36">
                  <c:v>-314.22222222222263</c:v>
                </c:pt>
                <c:pt idx="37">
                  <c:v>-123.55555555555566</c:v>
                </c:pt>
                <c:pt idx="38">
                  <c:v>1681.4444444444453</c:v>
                </c:pt>
                <c:pt idx="39">
                  <c:v>-473.55555555555475</c:v>
                </c:pt>
                <c:pt idx="40">
                  <c:v>-267.88888888889051</c:v>
                </c:pt>
                <c:pt idx="41">
                  <c:v>-334.22222222222263</c:v>
                </c:pt>
                <c:pt idx="42">
                  <c:v>1147.1111111111095</c:v>
                </c:pt>
                <c:pt idx="43">
                  <c:v>537.44444444444525</c:v>
                </c:pt>
                <c:pt idx="44">
                  <c:v>-849.66666666666606</c:v>
                </c:pt>
                <c:pt idx="45">
                  <c:v>-613.22222222222263</c:v>
                </c:pt>
                <c:pt idx="46">
                  <c:v>405.11111111110949</c:v>
                </c:pt>
                <c:pt idx="47">
                  <c:v>-469.22222222222263</c:v>
                </c:pt>
                <c:pt idx="48">
                  <c:v>-708.66666666666606</c:v>
                </c:pt>
                <c:pt idx="49">
                  <c:v>-751.55555555555566</c:v>
                </c:pt>
                <c:pt idx="50">
                  <c:v>-1492.5555555555557</c:v>
                </c:pt>
                <c:pt idx="51">
                  <c:v>-114.66666666666606</c:v>
                </c:pt>
                <c:pt idx="52">
                  <c:v>-245.66666666666606</c:v>
                </c:pt>
                <c:pt idx="53">
                  <c:v>208.11111111110949</c:v>
                </c:pt>
                <c:pt idx="54">
                  <c:v>-1035.6666666666661</c:v>
                </c:pt>
                <c:pt idx="55">
                  <c:v>-293.22222222222263</c:v>
                </c:pt>
                <c:pt idx="56">
                  <c:v>750.11111111110949</c:v>
                </c:pt>
                <c:pt idx="57">
                  <c:v>306.33333333333394</c:v>
                </c:pt>
                <c:pt idx="58">
                  <c:v>-50.888888888890506</c:v>
                </c:pt>
                <c:pt idx="59">
                  <c:v>-369.66666666666606</c:v>
                </c:pt>
                <c:pt idx="60">
                  <c:v>-1352.5555555555547</c:v>
                </c:pt>
                <c:pt idx="61">
                  <c:v>-689.66666666666606</c:v>
                </c:pt>
                <c:pt idx="62">
                  <c:v>1094.4444444444453</c:v>
                </c:pt>
                <c:pt idx="63">
                  <c:v>544.44444444444525</c:v>
                </c:pt>
                <c:pt idx="64">
                  <c:v>637.77777777777737</c:v>
                </c:pt>
                <c:pt idx="65">
                  <c:v>-84.222222222222626</c:v>
                </c:pt>
                <c:pt idx="66">
                  <c:v>-218.88888888889051</c:v>
                </c:pt>
                <c:pt idx="67">
                  <c:v>239.11111111110949</c:v>
                </c:pt>
                <c:pt idx="68">
                  <c:v>-855.66666666666606</c:v>
                </c:pt>
                <c:pt idx="69">
                  <c:v>102.11111111110949</c:v>
                </c:pt>
                <c:pt idx="70">
                  <c:v>-549.88888888889051</c:v>
                </c:pt>
                <c:pt idx="71">
                  <c:v>777.77777777777737</c:v>
                </c:pt>
                <c:pt idx="72">
                  <c:v>-555.66666666666606</c:v>
                </c:pt>
                <c:pt idx="73">
                  <c:v>1647.7777777777774</c:v>
                </c:pt>
                <c:pt idx="74">
                  <c:v>826.44444444444525</c:v>
                </c:pt>
                <c:pt idx="75">
                  <c:v>-633.66666666666606</c:v>
                </c:pt>
                <c:pt idx="76">
                  <c:v>1147.4444444444443</c:v>
                </c:pt>
                <c:pt idx="77">
                  <c:v>70.444444444445253</c:v>
                </c:pt>
                <c:pt idx="78">
                  <c:v>381.11111111110949</c:v>
                </c:pt>
                <c:pt idx="79">
                  <c:v>-2209.4444444444453</c:v>
                </c:pt>
                <c:pt idx="80">
                  <c:v>21.777777777777374</c:v>
                </c:pt>
                <c:pt idx="81">
                  <c:v>-618.22222222222263</c:v>
                </c:pt>
                <c:pt idx="82">
                  <c:v>-1024.3333333333339</c:v>
                </c:pt>
                <c:pt idx="83">
                  <c:v>133.77777777777737</c:v>
                </c:pt>
                <c:pt idx="84">
                  <c:v>-491.55555555555475</c:v>
                </c:pt>
                <c:pt idx="85">
                  <c:v>80.777777777777374</c:v>
                </c:pt>
                <c:pt idx="86">
                  <c:v>-1185.8888888888905</c:v>
                </c:pt>
                <c:pt idx="87">
                  <c:v>-1041.6666666666661</c:v>
                </c:pt>
                <c:pt idx="88">
                  <c:v>2474.4444444444453</c:v>
                </c:pt>
                <c:pt idx="89">
                  <c:v>699.44444444444434</c:v>
                </c:pt>
                <c:pt idx="90">
                  <c:v>-337.88888888889051</c:v>
                </c:pt>
                <c:pt idx="91">
                  <c:v>2.1111111111094942</c:v>
                </c:pt>
                <c:pt idx="92">
                  <c:v>-57.222222222222626</c:v>
                </c:pt>
                <c:pt idx="93">
                  <c:v>0</c:v>
                </c:pt>
                <c:pt idx="94">
                  <c:v>-824.22222222222263</c:v>
                </c:pt>
                <c:pt idx="95">
                  <c:v>-959.22222222222263</c:v>
                </c:pt>
                <c:pt idx="96">
                  <c:v>65.33333333333394</c:v>
                </c:pt>
                <c:pt idx="97">
                  <c:v>3289.4444444444453</c:v>
                </c:pt>
                <c:pt idx="98">
                  <c:v>71.444444444445253</c:v>
                </c:pt>
                <c:pt idx="99">
                  <c:v>-39.555555555555657</c:v>
                </c:pt>
                <c:pt idx="100">
                  <c:v>1765.4444444444453</c:v>
                </c:pt>
                <c:pt idx="101">
                  <c:v>2341.3333333333339</c:v>
                </c:pt>
                <c:pt idx="102">
                  <c:v>-430.55555555555475</c:v>
                </c:pt>
                <c:pt idx="103">
                  <c:v>-860.22222222222263</c:v>
                </c:pt>
                <c:pt idx="104">
                  <c:v>495.33333333333394</c:v>
                </c:pt>
                <c:pt idx="105">
                  <c:v>-700.22222222222263</c:v>
                </c:pt>
                <c:pt idx="106">
                  <c:v>465.11111111110949</c:v>
                </c:pt>
                <c:pt idx="107">
                  <c:v>-217.55555555555566</c:v>
                </c:pt>
                <c:pt idx="108">
                  <c:v>-565.22222222222263</c:v>
                </c:pt>
                <c:pt idx="109">
                  <c:v>-401.55555555555475</c:v>
                </c:pt>
                <c:pt idx="110">
                  <c:v>-373.88888888889051</c:v>
                </c:pt>
                <c:pt idx="111">
                  <c:v>193.77777777777737</c:v>
                </c:pt>
                <c:pt idx="112">
                  <c:v>4524.4444444444453</c:v>
                </c:pt>
                <c:pt idx="113">
                  <c:v>2493.4444444444443</c:v>
                </c:pt>
                <c:pt idx="114">
                  <c:v>643.44444444444434</c:v>
                </c:pt>
                <c:pt idx="115">
                  <c:v>1328.1111111111095</c:v>
                </c:pt>
                <c:pt idx="116">
                  <c:v>1242.7777777777774</c:v>
                </c:pt>
                <c:pt idx="117">
                  <c:v>-333.55555555555475</c:v>
                </c:pt>
                <c:pt idx="118">
                  <c:v>1597.4444444444453</c:v>
                </c:pt>
                <c:pt idx="119">
                  <c:v>212.77777777777737</c:v>
                </c:pt>
                <c:pt idx="120">
                  <c:v>587.11111111110949</c:v>
                </c:pt>
                <c:pt idx="121">
                  <c:v>3212.1111111111095</c:v>
                </c:pt>
                <c:pt idx="122">
                  <c:v>1537.4444444444453</c:v>
                </c:pt>
                <c:pt idx="123">
                  <c:v>1371.1111111111095</c:v>
                </c:pt>
                <c:pt idx="124">
                  <c:v>94.777777777777374</c:v>
                </c:pt>
                <c:pt idx="125">
                  <c:v>214.44444444444434</c:v>
                </c:pt>
                <c:pt idx="126">
                  <c:v>1609.4444444444453</c:v>
                </c:pt>
                <c:pt idx="127">
                  <c:v>552.33333333333394</c:v>
                </c:pt>
                <c:pt idx="128">
                  <c:v>-753.88888888889051</c:v>
                </c:pt>
                <c:pt idx="129">
                  <c:v>2567.7777777777774</c:v>
                </c:pt>
                <c:pt idx="130">
                  <c:v>82.444444444445253</c:v>
                </c:pt>
                <c:pt idx="131">
                  <c:v>212.77777777777737</c:v>
                </c:pt>
                <c:pt idx="132">
                  <c:v>-404.88888888889051</c:v>
                </c:pt>
                <c:pt idx="133">
                  <c:v>-804.55555555555566</c:v>
                </c:pt>
                <c:pt idx="134">
                  <c:v>846.77777777777737</c:v>
                </c:pt>
                <c:pt idx="135">
                  <c:v>135.77777777777737</c:v>
                </c:pt>
                <c:pt idx="136">
                  <c:v>-338.66666666666606</c:v>
                </c:pt>
                <c:pt idx="137">
                  <c:v>1746.1111111111095</c:v>
                </c:pt>
                <c:pt idx="138">
                  <c:v>-169.22222222222263</c:v>
                </c:pt>
                <c:pt idx="139">
                  <c:v>-137.88888888889051</c:v>
                </c:pt>
                <c:pt idx="140">
                  <c:v>447.77777777777737</c:v>
                </c:pt>
                <c:pt idx="141">
                  <c:v>-1222.2222222222226</c:v>
                </c:pt>
                <c:pt idx="142">
                  <c:v>-1040.8888888888905</c:v>
                </c:pt>
                <c:pt idx="143">
                  <c:v>0</c:v>
                </c:pt>
                <c:pt idx="144">
                  <c:v>-303.44444444444525</c:v>
                </c:pt>
                <c:pt idx="145">
                  <c:v>2669.4444444444453</c:v>
                </c:pt>
                <c:pt idx="146">
                  <c:v>7165.1111111111095</c:v>
                </c:pt>
                <c:pt idx="147">
                  <c:v>459.44444444444525</c:v>
                </c:pt>
                <c:pt idx="148">
                  <c:v>31.33333333333394</c:v>
                </c:pt>
                <c:pt idx="149">
                  <c:v>6006.7777777777774</c:v>
                </c:pt>
                <c:pt idx="150">
                  <c:v>-326.55555555555475</c:v>
                </c:pt>
                <c:pt idx="151">
                  <c:v>1209.7777777777774</c:v>
                </c:pt>
                <c:pt idx="152">
                  <c:v>231.33333333333394</c:v>
                </c:pt>
                <c:pt idx="153">
                  <c:v>761.44444444444525</c:v>
                </c:pt>
                <c:pt idx="154">
                  <c:v>1271.4444444444453</c:v>
                </c:pt>
                <c:pt idx="155">
                  <c:v>1334.4444444444453</c:v>
                </c:pt>
                <c:pt idx="156">
                  <c:v>554.33333333333394</c:v>
                </c:pt>
                <c:pt idx="157">
                  <c:v>-5.6666666666660603</c:v>
                </c:pt>
                <c:pt idx="158">
                  <c:v>974.77777777777737</c:v>
                </c:pt>
                <c:pt idx="159">
                  <c:v>7671.4444444444453</c:v>
                </c:pt>
                <c:pt idx="160">
                  <c:v>2605.4444444444453</c:v>
                </c:pt>
                <c:pt idx="161">
                  <c:v>99.777777777777374</c:v>
                </c:pt>
                <c:pt idx="162">
                  <c:v>10297.111111111109</c:v>
                </c:pt>
                <c:pt idx="163">
                  <c:v>5933.4444444444453</c:v>
                </c:pt>
                <c:pt idx="164">
                  <c:v>0</c:v>
                </c:pt>
                <c:pt idx="165">
                  <c:v>-730.22222222222263</c:v>
                </c:pt>
                <c:pt idx="166">
                  <c:v>-216.55555555555475</c:v>
                </c:pt>
                <c:pt idx="167">
                  <c:v>15821.333333333334</c:v>
                </c:pt>
                <c:pt idx="168">
                  <c:v>0</c:v>
                </c:pt>
                <c:pt idx="169">
                  <c:v>189.44444444444525</c:v>
                </c:pt>
                <c:pt idx="170">
                  <c:v>-498.22222222222263</c:v>
                </c:pt>
                <c:pt idx="171">
                  <c:v>-1804.4444444444453</c:v>
                </c:pt>
                <c:pt idx="172">
                  <c:v>-590.55555555555475</c:v>
                </c:pt>
                <c:pt idx="173">
                  <c:v>0</c:v>
                </c:pt>
                <c:pt idx="174">
                  <c:v>3591.1111111111095</c:v>
                </c:pt>
                <c:pt idx="175">
                  <c:v>5954.4444444444453</c:v>
                </c:pt>
                <c:pt idx="176">
                  <c:v>0</c:v>
                </c:pt>
                <c:pt idx="177">
                  <c:v>2823.5555555555547</c:v>
                </c:pt>
                <c:pt idx="178">
                  <c:v>1279.1111111111095</c:v>
                </c:pt>
                <c:pt idx="179">
                  <c:v>3821.4444444444453</c:v>
                </c:pt>
                <c:pt idx="180">
                  <c:v>3534.1111111111095</c:v>
                </c:pt>
                <c:pt idx="181">
                  <c:v>1016.5555555555547</c:v>
                </c:pt>
                <c:pt idx="182">
                  <c:v>-202.55555555555475</c:v>
                </c:pt>
                <c:pt idx="183">
                  <c:v>1948.5555555555547</c:v>
                </c:pt>
                <c:pt idx="184">
                  <c:v>0</c:v>
                </c:pt>
                <c:pt idx="185">
                  <c:v>1296.3333333333339</c:v>
                </c:pt>
                <c:pt idx="186">
                  <c:v>82.111111111109494</c:v>
                </c:pt>
                <c:pt idx="187">
                  <c:v>581.33333333333394</c:v>
                </c:pt>
                <c:pt idx="188">
                  <c:v>-429.22222222222263</c:v>
                </c:pt>
                <c:pt idx="189">
                  <c:v>275.11111111110949</c:v>
                </c:pt>
                <c:pt idx="190">
                  <c:v>-1042.8888888888905</c:v>
                </c:pt>
                <c:pt idx="191">
                  <c:v>163.77777777777737</c:v>
                </c:pt>
                <c:pt idx="192">
                  <c:v>733.44444444444525</c:v>
                </c:pt>
                <c:pt idx="193">
                  <c:v>-19.222222222222626</c:v>
                </c:pt>
                <c:pt idx="194">
                  <c:v>1305.4444444444453</c:v>
                </c:pt>
                <c:pt idx="195">
                  <c:v>-460.33333333333394</c:v>
                </c:pt>
                <c:pt idx="196">
                  <c:v>297.44444444444525</c:v>
                </c:pt>
                <c:pt idx="197">
                  <c:v>289.11111111110949</c:v>
                </c:pt>
                <c:pt idx="198">
                  <c:v>2012.4444444444443</c:v>
                </c:pt>
                <c:pt idx="199">
                  <c:v>-1544.6666666666661</c:v>
                </c:pt>
                <c:pt idx="200">
                  <c:v>5573.7777777777774</c:v>
                </c:pt>
                <c:pt idx="201">
                  <c:v>894.11111111110949</c:v>
                </c:pt>
                <c:pt idx="202">
                  <c:v>1774.1111111111095</c:v>
                </c:pt>
                <c:pt idx="203">
                  <c:v>-856.55555555555475</c:v>
                </c:pt>
                <c:pt idx="204">
                  <c:v>1112.1111111111095</c:v>
                </c:pt>
                <c:pt idx="205">
                  <c:v>-470.66666666666606</c:v>
                </c:pt>
                <c:pt idx="206">
                  <c:v>30.777777777777374</c:v>
                </c:pt>
                <c:pt idx="207">
                  <c:v>-388.66666666666606</c:v>
                </c:pt>
                <c:pt idx="208">
                  <c:v>-776.22222222222263</c:v>
                </c:pt>
                <c:pt idx="209">
                  <c:v>1964.3333333333339</c:v>
                </c:pt>
                <c:pt idx="210">
                  <c:v>4974.4444444444453</c:v>
                </c:pt>
                <c:pt idx="211">
                  <c:v>-1980.2222222222226</c:v>
                </c:pt>
                <c:pt idx="212">
                  <c:v>1667.3333333333339</c:v>
                </c:pt>
                <c:pt idx="213">
                  <c:v>-267.22222222222263</c:v>
                </c:pt>
                <c:pt idx="214">
                  <c:v>814.11111111110949</c:v>
                </c:pt>
                <c:pt idx="215">
                  <c:v>12035.111111111109</c:v>
                </c:pt>
                <c:pt idx="216">
                  <c:v>1221.4444444444453</c:v>
                </c:pt>
                <c:pt idx="217">
                  <c:v>-2401.2222222222226</c:v>
                </c:pt>
                <c:pt idx="218">
                  <c:v>760.44444444444525</c:v>
                </c:pt>
                <c:pt idx="219">
                  <c:v>-163.22222222222263</c:v>
                </c:pt>
                <c:pt idx="220">
                  <c:v>1259.4444444444453</c:v>
                </c:pt>
                <c:pt idx="221">
                  <c:v>-835.88888888889051</c:v>
                </c:pt>
                <c:pt idx="222">
                  <c:v>2421.1111111111095</c:v>
                </c:pt>
                <c:pt idx="223">
                  <c:v>-1306.2222222222226</c:v>
                </c:pt>
                <c:pt idx="224">
                  <c:v>-2692.2222222222226</c:v>
                </c:pt>
                <c:pt idx="225">
                  <c:v>4836.4444444444453</c:v>
                </c:pt>
                <c:pt idx="226">
                  <c:v>-895.22222222222263</c:v>
                </c:pt>
                <c:pt idx="227">
                  <c:v>-605.55555555555475</c:v>
                </c:pt>
                <c:pt idx="228">
                  <c:v>731.44444444444525</c:v>
                </c:pt>
                <c:pt idx="229">
                  <c:v>817.11111111110949</c:v>
                </c:pt>
                <c:pt idx="230">
                  <c:v>715.44444444444525</c:v>
                </c:pt>
                <c:pt idx="231">
                  <c:v>751.11111111110949</c:v>
                </c:pt>
                <c:pt idx="232">
                  <c:v>757.44444444444525</c:v>
                </c:pt>
                <c:pt idx="233">
                  <c:v>127.33333333333394</c:v>
                </c:pt>
                <c:pt idx="234">
                  <c:v>-295.88888888889051</c:v>
                </c:pt>
                <c:pt idx="235">
                  <c:v>-642.22222222222263</c:v>
                </c:pt>
                <c:pt idx="236">
                  <c:v>409.44444444444434</c:v>
                </c:pt>
                <c:pt idx="237">
                  <c:v>164.44444444444525</c:v>
                </c:pt>
                <c:pt idx="238">
                  <c:v>-471.88888888889051</c:v>
                </c:pt>
                <c:pt idx="239">
                  <c:v>8229.1111111111095</c:v>
                </c:pt>
                <c:pt idx="240">
                  <c:v>-385.22222222222263</c:v>
                </c:pt>
                <c:pt idx="241">
                  <c:v>-442.55555555555475</c:v>
                </c:pt>
                <c:pt idx="242">
                  <c:v>670.11111111110949</c:v>
                </c:pt>
                <c:pt idx="243">
                  <c:v>-916.88888888889051</c:v>
                </c:pt>
                <c:pt idx="244">
                  <c:v>-176.22222222222263</c:v>
                </c:pt>
                <c:pt idx="245">
                  <c:v>-907.88888888889051</c:v>
                </c:pt>
                <c:pt idx="246">
                  <c:v>1691.4444444444453</c:v>
                </c:pt>
                <c:pt idx="247">
                  <c:v>-183.66666666666606</c:v>
                </c:pt>
                <c:pt idx="248">
                  <c:v>142.11111111110949</c:v>
                </c:pt>
                <c:pt idx="249">
                  <c:v>3505.3333333333339</c:v>
                </c:pt>
                <c:pt idx="250">
                  <c:v>2732.4444444444453</c:v>
                </c:pt>
                <c:pt idx="251">
                  <c:v>-262.88888888889051</c:v>
                </c:pt>
                <c:pt idx="252">
                  <c:v>2916.4444444444443</c:v>
                </c:pt>
                <c:pt idx="253">
                  <c:v>-1576.2222222222226</c:v>
                </c:pt>
                <c:pt idx="254">
                  <c:v>1367.4444444444453</c:v>
                </c:pt>
                <c:pt idx="255">
                  <c:v>289.33333333333394</c:v>
                </c:pt>
                <c:pt idx="256">
                  <c:v>-535.55555555555475</c:v>
                </c:pt>
                <c:pt idx="257">
                  <c:v>1501.4444444444453</c:v>
                </c:pt>
                <c:pt idx="258">
                  <c:v>6303.4444444444453</c:v>
                </c:pt>
                <c:pt idx="259">
                  <c:v>987.77777777777737</c:v>
                </c:pt>
                <c:pt idx="260">
                  <c:v>-628.55555555555475</c:v>
                </c:pt>
                <c:pt idx="261">
                  <c:v>1441.4444444444453</c:v>
                </c:pt>
                <c:pt idx="262">
                  <c:v>946.77777777777737</c:v>
                </c:pt>
              </c:numCache>
            </c:numRef>
          </c:val>
          <c:extLst>
            <c:ext xmlns:c16="http://schemas.microsoft.com/office/drawing/2014/chart" uri="{C3380CC4-5D6E-409C-BE32-E72D297353CC}">
              <c16:uniqueId val="{00000001-7295-449E-86E8-7DE9CE14FD5E}"/>
            </c:ext>
          </c:extLst>
        </c:ser>
        <c:dLbls>
          <c:showLegendKey val="0"/>
          <c:showVal val="0"/>
          <c:showCatName val="0"/>
          <c:showSerName val="0"/>
          <c:showPercent val="0"/>
          <c:showBubbleSize val="0"/>
        </c:dLbls>
        <c:gapWidth val="219"/>
        <c:overlap val="-27"/>
        <c:axId val="869949856"/>
        <c:axId val="869950840"/>
      </c:barChart>
      <c:barChart>
        <c:barDir val="col"/>
        <c:grouping val="clustered"/>
        <c:varyColors val="0"/>
        <c:ser>
          <c:idx val="2"/>
          <c:order val="2"/>
          <c:tx>
            <c:strRef>
              <c:f>FinalAnalysis.Heatmap!$AN$4</c:f>
              <c:strCache>
                <c:ptCount val="1"/>
                <c:pt idx="0">
                  <c:v>P-value</c:v>
                </c:pt>
              </c:strCache>
            </c:strRef>
          </c:tx>
          <c:spPr>
            <a:solidFill>
              <a:schemeClr val="accent3"/>
            </a:solidFill>
            <a:ln>
              <a:noFill/>
            </a:ln>
            <a:effectLst/>
          </c:spPr>
          <c:invertIfNegative val="0"/>
          <c:val>
            <c:numRef>
              <c:f>FinalAnalysis.Heatmap!$AN$5:$AN$267</c:f>
              <c:numCache>
                <c:formatCode>General</c:formatCode>
                <c:ptCount val="263"/>
                <c:pt idx="1">
                  <c:v>0.32718687779030547</c:v>
                </c:pt>
                <c:pt idx="2">
                  <c:v>0.93492531164211723</c:v>
                </c:pt>
                <c:pt idx="3">
                  <c:v>0.56762849926333581</c:v>
                </c:pt>
                <c:pt idx="4">
                  <c:v>0.51362911339312389</c:v>
                </c:pt>
                <c:pt idx="5">
                  <c:v>0</c:v>
                </c:pt>
                <c:pt idx="6">
                  <c:v>0.46243272645047639</c:v>
                </c:pt>
                <c:pt idx="7">
                  <c:v>0.41421617824252505</c:v>
                </c:pt>
                <c:pt idx="8">
                  <c:v>0.80649594050733997</c:v>
                </c:pt>
                <c:pt idx="9">
                  <c:v>0.28848746332348912</c:v>
                </c:pt>
                <c:pt idx="10">
                  <c:v>0.41421617824252505</c:v>
                </c:pt>
                <c:pt idx="11">
                  <c:v>0.46243272645047628</c:v>
                </c:pt>
                <c:pt idx="12">
                  <c:v>0.28848746332348912</c:v>
                </c:pt>
                <c:pt idx="13">
                  <c:v>0.87028277228103601</c:v>
                </c:pt>
                <c:pt idx="14">
                  <c:v>0.68309139830960863</c:v>
                </c:pt>
                <c:pt idx="15">
                  <c:v>0</c:v>
                </c:pt>
                <c:pt idx="16">
                  <c:v>0.80649594050733997</c:v>
                </c:pt>
                <c:pt idx="17">
                  <c:v>0.93492531164211723</c:v>
                </c:pt>
                <c:pt idx="18">
                  <c:v>0.80649594050733997</c:v>
                </c:pt>
                <c:pt idx="19">
                  <c:v>0.93492531164211723</c:v>
                </c:pt>
                <c:pt idx="20">
                  <c:v>0.74397147807505681</c:v>
                </c:pt>
                <c:pt idx="21">
                  <c:v>1</c:v>
                </c:pt>
                <c:pt idx="22">
                  <c:v>0.8702827722810359</c:v>
                </c:pt>
                <c:pt idx="23">
                  <c:v>0.93492531164211723</c:v>
                </c:pt>
                <c:pt idx="24">
                  <c:v>0.8702827722810359</c:v>
                </c:pt>
                <c:pt idx="25">
                  <c:v>0.68309139830960863</c:v>
                </c:pt>
                <c:pt idx="26">
                  <c:v>0.8702827722810359</c:v>
                </c:pt>
                <c:pt idx="27">
                  <c:v>0.25299906147468421</c:v>
                </c:pt>
                <c:pt idx="28">
                  <c:v>0.36910759043756269</c:v>
                </c:pt>
                <c:pt idx="29">
                  <c:v>0.46243272645047639</c:v>
                </c:pt>
                <c:pt idx="30">
                  <c:v>0.22067136191984668</c:v>
                </c:pt>
                <c:pt idx="31">
                  <c:v>0.80649594050733997</c:v>
                </c:pt>
                <c:pt idx="32">
                  <c:v>0.4142161782425251</c:v>
                </c:pt>
                <c:pt idx="33">
                  <c:v>0.25299906147468421</c:v>
                </c:pt>
                <c:pt idx="34">
                  <c:v>0.93492531164211723</c:v>
                </c:pt>
                <c:pt idx="35">
                  <c:v>4.1226833337163704E-2</c:v>
                </c:pt>
                <c:pt idx="36">
                  <c:v>0.12081938653567081</c:v>
                </c:pt>
                <c:pt idx="37">
                  <c:v>0.12081938653567081</c:v>
                </c:pt>
                <c:pt idx="38">
                  <c:v>0.80649594050733997</c:v>
                </c:pt>
                <c:pt idx="39">
                  <c:v>0.25299906147468421</c:v>
                </c:pt>
                <c:pt idx="40">
                  <c:v>0.36910759043756269</c:v>
                </c:pt>
                <c:pt idx="41">
                  <c:v>0.74397147807505681</c:v>
                </c:pt>
                <c:pt idx="42">
                  <c:v>1</c:v>
                </c:pt>
                <c:pt idx="43">
                  <c:v>0.93492531164211723</c:v>
                </c:pt>
                <c:pt idx="44">
                  <c:v>0.51362911339312389</c:v>
                </c:pt>
                <c:pt idx="45">
                  <c:v>0.41421617824252505</c:v>
                </c:pt>
                <c:pt idx="46">
                  <c:v>0.93492531164211723</c:v>
                </c:pt>
                <c:pt idx="47">
                  <c:v>0.93492531164211723</c:v>
                </c:pt>
                <c:pt idx="48">
                  <c:v>1</c:v>
                </c:pt>
                <c:pt idx="49">
                  <c:v>0.46243272645047639</c:v>
                </c:pt>
                <c:pt idx="50">
                  <c:v>0.68309139830960863</c:v>
                </c:pt>
                <c:pt idx="51">
                  <c:v>0.74397147807505681</c:v>
                </c:pt>
                <c:pt idx="52">
                  <c:v>1</c:v>
                </c:pt>
                <c:pt idx="53">
                  <c:v>0.68309139830960852</c:v>
                </c:pt>
                <c:pt idx="54">
                  <c:v>0.93492531164211723</c:v>
                </c:pt>
                <c:pt idx="55">
                  <c:v>0.68309139830960852</c:v>
                </c:pt>
                <c:pt idx="56">
                  <c:v>0.32718687779030553</c:v>
                </c:pt>
                <c:pt idx="57">
                  <c:v>0.16512359012839428</c:v>
                </c:pt>
                <c:pt idx="58">
                  <c:v>0.46243272645047639</c:v>
                </c:pt>
                <c:pt idx="59">
                  <c:v>0.80649594050733997</c:v>
                </c:pt>
                <c:pt idx="60">
                  <c:v>0.36910759043756264</c:v>
                </c:pt>
                <c:pt idx="61">
                  <c:v>0.80649594050733997</c:v>
                </c:pt>
                <c:pt idx="62">
                  <c:v>0.51362911339312389</c:v>
                </c:pt>
                <c:pt idx="63">
                  <c:v>7.2448013529787136E-2</c:v>
                </c:pt>
                <c:pt idx="64">
                  <c:v>0.56762849926333581</c:v>
                </c:pt>
                <c:pt idx="65">
                  <c:v>0.62420611476640597</c:v>
                </c:pt>
                <c:pt idx="66">
                  <c:v>0.19141842523760721</c:v>
                </c:pt>
                <c:pt idx="67">
                  <c:v>1</c:v>
                </c:pt>
                <c:pt idx="68">
                  <c:v>0.80649594050733997</c:v>
                </c:pt>
                <c:pt idx="69">
                  <c:v>0.4142161782425251</c:v>
                </c:pt>
                <c:pt idx="70">
                  <c:v>0.32718687779030553</c:v>
                </c:pt>
                <c:pt idx="71">
                  <c:v>0.93492531164211723</c:v>
                </c:pt>
                <c:pt idx="72">
                  <c:v>0.93492531164211723</c:v>
                </c:pt>
                <c:pt idx="73">
                  <c:v>0.80649594050733997</c:v>
                </c:pt>
                <c:pt idx="74">
                  <c:v>0.80649594050733997</c:v>
                </c:pt>
                <c:pt idx="75">
                  <c:v>0.56762849926333581</c:v>
                </c:pt>
                <c:pt idx="76">
                  <c:v>0.41421617824252505</c:v>
                </c:pt>
                <c:pt idx="77">
                  <c:v>0.46243272645047628</c:v>
                </c:pt>
                <c:pt idx="78">
                  <c:v>0.46243272645047628</c:v>
                </c:pt>
                <c:pt idx="79">
                  <c:v>0.28848746332348912</c:v>
                </c:pt>
                <c:pt idx="80">
                  <c:v>0.68309139830960852</c:v>
                </c:pt>
                <c:pt idx="81">
                  <c:v>0.80649594050733997</c:v>
                </c:pt>
                <c:pt idx="82">
                  <c:v>0.74397147807505681</c:v>
                </c:pt>
                <c:pt idx="83">
                  <c:v>0.51362911339312389</c:v>
                </c:pt>
                <c:pt idx="84">
                  <c:v>0.80649594050733997</c:v>
                </c:pt>
                <c:pt idx="85">
                  <c:v>0.68309139830960852</c:v>
                </c:pt>
                <c:pt idx="86">
                  <c:v>0.56762849926333581</c:v>
                </c:pt>
                <c:pt idx="87">
                  <c:v>6.0389081309270232E-2</c:v>
                </c:pt>
                <c:pt idx="88">
                  <c:v>0.62420611476640597</c:v>
                </c:pt>
                <c:pt idx="89">
                  <c:v>0.68309139830960852</c:v>
                </c:pt>
                <c:pt idx="90">
                  <c:v>0.51362911339312389</c:v>
                </c:pt>
                <c:pt idx="91">
                  <c:v>0.28848746332348907</c:v>
                </c:pt>
                <c:pt idx="92">
                  <c:v>0.36910759043756264</c:v>
                </c:pt>
                <c:pt idx="93">
                  <c:v>0</c:v>
                </c:pt>
                <c:pt idx="94">
                  <c:v>0.8702827722810359</c:v>
                </c:pt>
                <c:pt idx="95">
                  <c:v>0.80649594050733997</c:v>
                </c:pt>
                <c:pt idx="96">
                  <c:v>0.14164469029513671</c:v>
                </c:pt>
                <c:pt idx="97">
                  <c:v>0.74397147807505681</c:v>
                </c:pt>
                <c:pt idx="98">
                  <c:v>0.74397147807505681</c:v>
                </c:pt>
                <c:pt idx="99">
                  <c:v>0.8702827722810359</c:v>
                </c:pt>
                <c:pt idx="100">
                  <c:v>0.8702827722810359</c:v>
                </c:pt>
                <c:pt idx="101">
                  <c:v>0.87028277228103601</c:v>
                </c:pt>
                <c:pt idx="102">
                  <c:v>1</c:v>
                </c:pt>
                <c:pt idx="103">
                  <c:v>0.74397147807505681</c:v>
                </c:pt>
                <c:pt idx="104">
                  <c:v>0.56762849926333581</c:v>
                </c:pt>
                <c:pt idx="105">
                  <c:v>0.93492531164211723</c:v>
                </c:pt>
                <c:pt idx="106">
                  <c:v>0.80649594050733997</c:v>
                </c:pt>
                <c:pt idx="107">
                  <c:v>0.51362911339312389</c:v>
                </c:pt>
                <c:pt idx="108">
                  <c:v>0.46243272645047639</c:v>
                </c:pt>
                <c:pt idx="109">
                  <c:v>0.80649594050733997</c:v>
                </c:pt>
                <c:pt idx="110">
                  <c:v>0.74397147807505681</c:v>
                </c:pt>
                <c:pt idx="111">
                  <c:v>0.46243272645047639</c:v>
                </c:pt>
                <c:pt idx="112">
                  <c:v>0.2206713619198466</c:v>
                </c:pt>
                <c:pt idx="113">
                  <c:v>0.93492531164211723</c:v>
                </c:pt>
                <c:pt idx="114">
                  <c:v>0.93492531164211723</c:v>
                </c:pt>
                <c:pt idx="115">
                  <c:v>0.68309139830960852</c:v>
                </c:pt>
                <c:pt idx="116">
                  <c:v>0.8702827722810359</c:v>
                </c:pt>
                <c:pt idx="117">
                  <c:v>0.87028277228103601</c:v>
                </c:pt>
                <c:pt idx="118">
                  <c:v>1</c:v>
                </c:pt>
                <c:pt idx="119">
                  <c:v>0.32718687779030547</c:v>
                </c:pt>
                <c:pt idx="120">
                  <c:v>0.46243272645047628</c:v>
                </c:pt>
                <c:pt idx="121">
                  <c:v>0.62420611476640597</c:v>
                </c:pt>
                <c:pt idx="122">
                  <c:v>0.80649594050733997</c:v>
                </c:pt>
                <c:pt idx="123">
                  <c:v>0.93492531164211723</c:v>
                </c:pt>
                <c:pt idx="124">
                  <c:v>0.4142161782425251</c:v>
                </c:pt>
                <c:pt idx="125">
                  <c:v>0.74397147807505681</c:v>
                </c:pt>
                <c:pt idx="126">
                  <c:v>0.93492531164211723</c:v>
                </c:pt>
                <c:pt idx="127">
                  <c:v>0.87028277228103601</c:v>
                </c:pt>
                <c:pt idx="128">
                  <c:v>0.74397147807505681</c:v>
                </c:pt>
                <c:pt idx="129">
                  <c:v>0.56762849926333581</c:v>
                </c:pt>
                <c:pt idx="130">
                  <c:v>0.80649594050733997</c:v>
                </c:pt>
                <c:pt idx="131">
                  <c:v>0.41421617824252505</c:v>
                </c:pt>
                <c:pt idx="132">
                  <c:v>0.41421617824252505</c:v>
                </c:pt>
                <c:pt idx="133">
                  <c:v>0.80649594050733997</c:v>
                </c:pt>
                <c:pt idx="134">
                  <c:v>0.74397147807505681</c:v>
                </c:pt>
                <c:pt idx="135">
                  <c:v>0.41421617824252505</c:v>
                </c:pt>
                <c:pt idx="136">
                  <c:v>0.62420611476640597</c:v>
                </c:pt>
                <c:pt idx="137">
                  <c:v>0.68309139830960863</c:v>
                </c:pt>
                <c:pt idx="138">
                  <c:v>0.80649594050733997</c:v>
                </c:pt>
                <c:pt idx="139">
                  <c:v>0.22067136191984668</c:v>
                </c:pt>
                <c:pt idx="140">
                  <c:v>0.51362911339312389</c:v>
                </c:pt>
                <c:pt idx="141">
                  <c:v>0.74397147807505681</c:v>
                </c:pt>
                <c:pt idx="142">
                  <c:v>1</c:v>
                </c:pt>
                <c:pt idx="143">
                  <c:v>0</c:v>
                </c:pt>
                <c:pt idx="144">
                  <c:v>0.46243272645047628</c:v>
                </c:pt>
                <c:pt idx="145">
                  <c:v>0.36910759043756264</c:v>
                </c:pt>
                <c:pt idx="146">
                  <c:v>0.51362911339312389</c:v>
                </c:pt>
                <c:pt idx="147">
                  <c:v>0.46243272645047628</c:v>
                </c:pt>
                <c:pt idx="148">
                  <c:v>0.25299906147468426</c:v>
                </c:pt>
                <c:pt idx="149">
                  <c:v>0.51362911339312389</c:v>
                </c:pt>
                <c:pt idx="150">
                  <c:v>0.28848746332348912</c:v>
                </c:pt>
                <c:pt idx="151">
                  <c:v>0.62420611476640597</c:v>
                </c:pt>
                <c:pt idx="152">
                  <c:v>0.51362911339312389</c:v>
                </c:pt>
                <c:pt idx="153">
                  <c:v>0.46243272645047628</c:v>
                </c:pt>
                <c:pt idx="154">
                  <c:v>0.46243272645047628</c:v>
                </c:pt>
                <c:pt idx="155">
                  <c:v>1</c:v>
                </c:pt>
                <c:pt idx="156">
                  <c:v>0.56762849926333581</c:v>
                </c:pt>
                <c:pt idx="157">
                  <c:v>0.28848746332348912</c:v>
                </c:pt>
                <c:pt idx="158">
                  <c:v>0.68309139830960863</c:v>
                </c:pt>
                <c:pt idx="159">
                  <c:v>0.46243272645047628</c:v>
                </c:pt>
                <c:pt idx="160">
                  <c:v>0.46243272645047628</c:v>
                </c:pt>
                <c:pt idx="161">
                  <c:v>0.46243272645047628</c:v>
                </c:pt>
                <c:pt idx="162">
                  <c:v>0.93492531164211723</c:v>
                </c:pt>
                <c:pt idx="163">
                  <c:v>0.51362911339312389</c:v>
                </c:pt>
                <c:pt idx="164">
                  <c:v>0</c:v>
                </c:pt>
                <c:pt idx="165">
                  <c:v>0.2206713619198466</c:v>
                </c:pt>
                <c:pt idx="166">
                  <c:v>0.22067136191984668</c:v>
                </c:pt>
                <c:pt idx="167">
                  <c:v>0.36910759043756264</c:v>
                </c:pt>
                <c:pt idx="168">
                  <c:v>0</c:v>
                </c:pt>
                <c:pt idx="169">
                  <c:v>0.62420611476640597</c:v>
                </c:pt>
                <c:pt idx="170">
                  <c:v>1</c:v>
                </c:pt>
                <c:pt idx="171">
                  <c:v>0.80649594050733997</c:v>
                </c:pt>
                <c:pt idx="172">
                  <c:v>0.87028277228103601</c:v>
                </c:pt>
                <c:pt idx="173">
                  <c:v>0</c:v>
                </c:pt>
                <c:pt idx="174">
                  <c:v>0.51362911339312389</c:v>
                </c:pt>
                <c:pt idx="175">
                  <c:v>0.51362911339312389</c:v>
                </c:pt>
                <c:pt idx="176">
                  <c:v>0</c:v>
                </c:pt>
                <c:pt idx="177">
                  <c:v>0.8702827722810359</c:v>
                </c:pt>
                <c:pt idx="178">
                  <c:v>0.2206713619198466</c:v>
                </c:pt>
                <c:pt idx="179">
                  <c:v>0.80649594050733997</c:v>
                </c:pt>
                <c:pt idx="180">
                  <c:v>0.12081938653567079</c:v>
                </c:pt>
                <c:pt idx="181">
                  <c:v>1</c:v>
                </c:pt>
                <c:pt idx="182">
                  <c:v>0.12081938653567081</c:v>
                </c:pt>
                <c:pt idx="183">
                  <c:v>0.74397147807505681</c:v>
                </c:pt>
                <c:pt idx="184">
                  <c:v>0</c:v>
                </c:pt>
                <c:pt idx="185">
                  <c:v>0.80649594050733997</c:v>
                </c:pt>
                <c:pt idx="186">
                  <c:v>0.93492531164211723</c:v>
                </c:pt>
                <c:pt idx="187">
                  <c:v>1</c:v>
                </c:pt>
                <c:pt idx="188">
                  <c:v>0.41421617824252505</c:v>
                </c:pt>
                <c:pt idx="189">
                  <c:v>0.56762849926333581</c:v>
                </c:pt>
                <c:pt idx="190">
                  <c:v>0.56762849926333581</c:v>
                </c:pt>
                <c:pt idx="191">
                  <c:v>0.87028277228103601</c:v>
                </c:pt>
                <c:pt idx="192">
                  <c:v>0.87028277228103601</c:v>
                </c:pt>
                <c:pt idx="193">
                  <c:v>0.80649594050733997</c:v>
                </c:pt>
                <c:pt idx="194">
                  <c:v>0.74397147807505681</c:v>
                </c:pt>
                <c:pt idx="195">
                  <c:v>0.80649594050733997</c:v>
                </c:pt>
                <c:pt idx="196">
                  <c:v>0.74397147807505681</c:v>
                </c:pt>
                <c:pt idx="197">
                  <c:v>0.62420611476640597</c:v>
                </c:pt>
                <c:pt idx="198">
                  <c:v>0.68309139830960863</c:v>
                </c:pt>
                <c:pt idx="199">
                  <c:v>0.36910759043756264</c:v>
                </c:pt>
                <c:pt idx="200">
                  <c:v>1</c:v>
                </c:pt>
                <c:pt idx="201">
                  <c:v>0.62420611476640597</c:v>
                </c:pt>
                <c:pt idx="202">
                  <c:v>0.51362911339312389</c:v>
                </c:pt>
                <c:pt idx="203">
                  <c:v>0.56762849926333581</c:v>
                </c:pt>
                <c:pt idx="204">
                  <c:v>0.8702827722810359</c:v>
                </c:pt>
                <c:pt idx="205">
                  <c:v>0.56762849926333581</c:v>
                </c:pt>
                <c:pt idx="206">
                  <c:v>1</c:v>
                </c:pt>
                <c:pt idx="207">
                  <c:v>0.56762849926333581</c:v>
                </c:pt>
                <c:pt idx="208">
                  <c:v>0.87028277228103601</c:v>
                </c:pt>
                <c:pt idx="209">
                  <c:v>0.87028277228103601</c:v>
                </c:pt>
                <c:pt idx="210">
                  <c:v>0.56762849926333581</c:v>
                </c:pt>
                <c:pt idx="211">
                  <c:v>0.74397147807505681</c:v>
                </c:pt>
                <c:pt idx="212">
                  <c:v>0.4142161782425251</c:v>
                </c:pt>
                <c:pt idx="213">
                  <c:v>0.80649594050733997</c:v>
                </c:pt>
                <c:pt idx="214">
                  <c:v>0.56762849926333581</c:v>
                </c:pt>
                <c:pt idx="215">
                  <c:v>0.87028277228103601</c:v>
                </c:pt>
                <c:pt idx="216">
                  <c:v>0.51362911339312389</c:v>
                </c:pt>
                <c:pt idx="217">
                  <c:v>0.93492531164211723</c:v>
                </c:pt>
                <c:pt idx="218">
                  <c:v>0.8702827722810359</c:v>
                </c:pt>
                <c:pt idx="219">
                  <c:v>0.80649594050733997</c:v>
                </c:pt>
                <c:pt idx="220">
                  <c:v>0.4142161782425251</c:v>
                </c:pt>
                <c:pt idx="221">
                  <c:v>0.87028277228103601</c:v>
                </c:pt>
                <c:pt idx="222">
                  <c:v>0.36910759043756264</c:v>
                </c:pt>
                <c:pt idx="223">
                  <c:v>0.62420611476640597</c:v>
                </c:pt>
                <c:pt idx="224">
                  <c:v>0.62420611476640597</c:v>
                </c:pt>
                <c:pt idx="225">
                  <c:v>0.80649594050733997</c:v>
                </c:pt>
                <c:pt idx="226">
                  <c:v>0.80649594050733997</c:v>
                </c:pt>
                <c:pt idx="227">
                  <c:v>0.68309139830960863</c:v>
                </c:pt>
                <c:pt idx="228">
                  <c:v>0.68309139830960852</c:v>
                </c:pt>
                <c:pt idx="229">
                  <c:v>0.8702827722810359</c:v>
                </c:pt>
                <c:pt idx="230">
                  <c:v>0.80649594050733997</c:v>
                </c:pt>
                <c:pt idx="231">
                  <c:v>0.56762849926333581</c:v>
                </c:pt>
                <c:pt idx="232">
                  <c:v>0.36910759043756269</c:v>
                </c:pt>
                <c:pt idx="233">
                  <c:v>0.28848746332348912</c:v>
                </c:pt>
                <c:pt idx="234">
                  <c:v>0.87028277228103601</c:v>
                </c:pt>
                <c:pt idx="235">
                  <c:v>0.19141842523760721</c:v>
                </c:pt>
                <c:pt idx="236">
                  <c:v>0.8702827722810359</c:v>
                </c:pt>
                <c:pt idx="237">
                  <c:v>0.2206713619198466</c:v>
                </c:pt>
                <c:pt idx="238">
                  <c:v>0.80649594050733997</c:v>
                </c:pt>
                <c:pt idx="239">
                  <c:v>0.74397147807505681</c:v>
                </c:pt>
                <c:pt idx="240">
                  <c:v>0.4142161782425251</c:v>
                </c:pt>
                <c:pt idx="241">
                  <c:v>0.74397147807505681</c:v>
                </c:pt>
                <c:pt idx="242">
                  <c:v>0.80649594050733997</c:v>
                </c:pt>
                <c:pt idx="243">
                  <c:v>0.8702827722810359</c:v>
                </c:pt>
                <c:pt idx="244">
                  <c:v>0.80649594050733997</c:v>
                </c:pt>
                <c:pt idx="245">
                  <c:v>0.36910759043756269</c:v>
                </c:pt>
                <c:pt idx="246">
                  <c:v>0.62420611476640597</c:v>
                </c:pt>
                <c:pt idx="247">
                  <c:v>0.68309139830960852</c:v>
                </c:pt>
                <c:pt idx="248">
                  <c:v>0.74397147807505681</c:v>
                </c:pt>
                <c:pt idx="249">
                  <c:v>1</c:v>
                </c:pt>
                <c:pt idx="250">
                  <c:v>0.68309139830960852</c:v>
                </c:pt>
                <c:pt idx="251">
                  <c:v>0.74397147807505681</c:v>
                </c:pt>
                <c:pt idx="252">
                  <c:v>0.51362911339312389</c:v>
                </c:pt>
                <c:pt idx="253">
                  <c:v>0.68309139830960852</c:v>
                </c:pt>
                <c:pt idx="254">
                  <c:v>0.87028277228103601</c:v>
                </c:pt>
                <c:pt idx="255">
                  <c:v>0.80649594050733997</c:v>
                </c:pt>
                <c:pt idx="256">
                  <c:v>1</c:v>
                </c:pt>
                <c:pt idx="257">
                  <c:v>0.51362911339312389</c:v>
                </c:pt>
                <c:pt idx="258">
                  <c:v>0.80649594050733997</c:v>
                </c:pt>
                <c:pt idx="259">
                  <c:v>0.28848746332348907</c:v>
                </c:pt>
                <c:pt idx="260">
                  <c:v>0.93492531164211723</c:v>
                </c:pt>
                <c:pt idx="261">
                  <c:v>1</c:v>
                </c:pt>
                <c:pt idx="262">
                  <c:v>4.1226833337163704E-2</c:v>
                </c:pt>
              </c:numCache>
            </c:numRef>
          </c:val>
          <c:extLst>
            <c:ext xmlns:c16="http://schemas.microsoft.com/office/drawing/2014/chart" uri="{C3380CC4-5D6E-409C-BE32-E72D297353CC}">
              <c16:uniqueId val="{00000002-7295-449E-86E8-7DE9CE14FD5E}"/>
            </c:ext>
          </c:extLst>
        </c:ser>
        <c:dLbls>
          <c:showLegendKey val="0"/>
          <c:showVal val="0"/>
          <c:showCatName val="0"/>
          <c:showSerName val="0"/>
          <c:showPercent val="0"/>
          <c:showBubbleSize val="0"/>
        </c:dLbls>
        <c:gapWidth val="219"/>
        <c:overlap val="-27"/>
        <c:axId val="1791014191"/>
        <c:axId val="1791019183"/>
      </c:barChart>
      <c:catAx>
        <c:axId val="86994985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500" b="1" i="0" u="none" strike="noStrike" kern="1200" baseline="0">
                <a:solidFill>
                  <a:schemeClr val="tx1">
                    <a:lumMod val="65000"/>
                    <a:lumOff val="35000"/>
                  </a:schemeClr>
                </a:solidFill>
                <a:latin typeface="+mn-lt"/>
                <a:ea typeface="+mn-ea"/>
                <a:cs typeface="+mn-cs"/>
              </a:defRPr>
            </a:pPr>
            <a:endParaRPr lang="en-US"/>
          </a:p>
        </c:txPr>
        <c:crossAx val="869950840"/>
        <c:crosses val="autoZero"/>
        <c:auto val="1"/>
        <c:lblAlgn val="ctr"/>
        <c:lblOffset val="100"/>
        <c:noMultiLvlLbl val="0"/>
      </c:catAx>
      <c:valAx>
        <c:axId val="869950840"/>
        <c:scaling>
          <c:orientation val="minMax"/>
          <c:max val="30000"/>
          <c:min val="0"/>
        </c:scaling>
        <c:delete val="0"/>
        <c:axPos val="l"/>
        <c:majorGridlines>
          <c:spPr>
            <a:ln w="9525" cap="flat" cmpd="sng" algn="ctr">
              <a:solidFill>
                <a:schemeClr val="tx1">
                  <a:lumMod val="15000"/>
                  <a:lumOff val="85000"/>
                </a:schemeClr>
              </a:solidFill>
              <a:round/>
            </a:ln>
            <a:effectLst/>
          </c:spPr>
        </c:majorGridlines>
        <c:numFmt formatCode="00000" sourceLinked="1"/>
        <c:majorTickMark val="out"/>
        <c:minorTickMark val="none"/>
        <c:tickLblPos val="nextTo"/>
        <c:spPr>
          <a:noFill/>
          <a:ln>
            <a:solidFill>
              <a:schemeClr val="accent1"/>
            </a:solid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869949856"/>
        <c:crosses val="autoZero"/>
        <c:crossBetween val="between"/>
      </c:valAx>
      <c:valAx>
        <c:axId val="1791019183"/>
        <c:scaling>
          <c:logBase val="10"/>
          <c:orientation val="minMax"/>
          <c:max val="0.1"/>
          <c:min val="1.0000000000000002E-2"/>
        </c:scaling>
        <c:delete val="0"/>
        <c:axPos val="r"/>
        <c:numFmt formatCode="#,##0.00" sourceLinked="0"/>
        <c:majorTickMark val="out"/>
        <c:minorTickMark val="out"/>
        <c:tickLblPos val="nextTo"/>
        <c:spPr>
          <a:noFill/>
          <a:ln>
            <a:solidFill>
              <a:schemeClr val="tx1"/>
            </a:solidFill>
          </a:ln>
          <a:effectLst/>
        </c:spPr>
        <c:txPr>
          <a:bodyPr rot="-60000000" spcFirstLastPara="1" vertOverflow="ellipsis" vert="horz" wrap="square" anchor="ctr" anchorCtr="1"/>
          <a:lstStyle/>
          <a:p>
            <a:pPr>
              <a:defRPr sz="1100" b="1" i="0" u="none" strike="noStrike" kern="1200" baseline="0">
                <a:solidFill>
                  <a:schemeClr val="tx1">
                    <a:lumMod val="65000"/>
                    <a:lumOff val="35000"/>
                  </a:schemeClr>
                </a:solidFill>
                <a:latin typeface="+mn-lt"/>
                <a:ea typeface="+mn-ea"/>
                <a:cs typeface="+mn-cs"/>
              </a:defRPr>
            </a:pPr>
            <a:endParaRPr lang="en-US"/>
          </a:p>
        </c:txPr>
        <c:crossAx val="1791014191"/>
        <c:crosses val="max"/>
        <c:crossBetween val="between"/>
      </c:valAx>
      <c:catAx>
        <c:axId val="1791014191"/>
        <c:scaling>
          <c:orientation val="minMax"/>
        </c:scaling>
        <c:delete val="1"/>
        <c:axPos val="b"/>
        <c:majorTickMark val="out"/>
        <c:minorTickMark val="none"/>
        <c:tickLblPos val="nextTo"/>
        <c:crossAx val="1791019183"/>
        <c:crosses val="autoZero"/>
        <c:auto val="1"/>
        <c:lblAlgn val="ctr"/>
        <c:lblOffset val="100"/>
        <c:noMultiLvlLbl val="0"/>
      </c:catAx>
      <c:spPr>
        <a:noFill/>
        <a:ln>
          <a:noFill/>
        </a:ln>
        <a:effectLst/>
      </c:spPr>
    </c:plotArea>
    <c:legend>
      <c:legendPos val="b"/>
      <c:layout>
        <c:manualLayout>
          <c:xMode val="edge"/>
          <c:yMode val="edge"/>
          <c:x val="0.83648342889442395"/>
          <c:y val="3.3719393430378782E-2"/>
          <c:w val="8.6349958817305644E-2"/>
          <c:h val="0.2573140836396331"/>
        </c:manualLayout>
      </c:layout>
      <c:overlay val="0"/>
      <c:spPr>
        <a:noFill/>
        <a:ln>
          <a:noFill/>
        </a:ln>
        <a:effectLst/>
      </c:spPr>
      <c:txPr>
        <a:bodyPr rot="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Final_Analysis1 (4)'!$BH$5</c:f>
              <c:strCache>
                <c:ptCount val="1"/>
                <c:pt idx="0">
                  <c:v>Susc</c:v>
                </c:pt>
              </c:strCache>
            </c:strRef>
          </c:tx>
          <c:spPr>
            <a:solidFill>
              <a:schemeClr val="accent1"/>
            </a:solidFill>
            <a:ln>
              <a:noFill/>
            </a:ln>
            <a:effectLst/>
          </c:spPr>
          <c:invertIfNegative val="0"/>
          <c:cat>
            <c:strRef>
              <c:f>'Final_Analysis1 (4)'!$J$6:$J$272</c:f>
              <c:strCache>
                <c:ptCount val="267"/>
                <c:pt idx="0">
                  <c:v>apical membrane antigen 1</c:v>
                </c:pt>
                <c:pt idx="1">
                  <c:v>circumsporozoite (CS) protein</c:v>
                </c:pt>
                <c:pt idx="2">
                  <c:v>merozoite surface protein 1</c:v>
                </c:pt>
                <c:pt idx="3">
                  <c:v>merozoite surface protein 1</c:v>
                </c:pt>
                <c:pt idx="5">
                  <c:v>3D7|PF11_0008|DBLalpha tag Group A</c:v>
                </c:pt>
                <c:pt idx="6">
                  <c:v>3D7|PF13_0003|DBLalpha tag Group A</c:v>
                </c:pt>
                <c:pt idx="7">
                  <c:v>3D7|PFA0015c|DBLalpha tag Group A</c:v>
                </c:pt>
                <c:pt idx="8">
                  <c:v>3D7|MAL6P1.4|DBLalpha tag Group B/A</c:v>
                </c:pt>
                <c:pt idx="9">
                  <c:v>3D7|MAL6P1.252|DBLalpha tag Group C</c:v>
                </c:pt>
                <c:pt idx="10">
                  <c:v>3D7|PF07_0049|DBLalpha tags</c:v>
                </c:pt>
                <c:pt idx="11">
                  <c:v>3D7|PF08_0106|DBLalpha tags</c:v>
                </c:pt>
                <c:pt idx="12">
                  <c:v>3D7|PFB0010w|DBLalpha tags</c:v>
                </c:pt>
                <c:pt idx="13">
                  <c:v>3D7|PFL1960w|DBLalpha tags</c:v>
                </c:pt>
                <c:pt idx="15">
                  <c:v>3D7|MAL6P1.1|DBLa0.8|CIDRa4|0</c:v>
                </c:pt>
                <c:pt idx="16">
                  <c:v>3D7|MAL6P1.252|DBLa0.21|CIDRa2.1|0</c:v>
                </c:pt>
                <c:pt idx="17">
                  <c:v>3D7|MAL6P1.252|DBLb4|DBLd1|0</c:v>
                </c:pt>
                <c:pt idx="18">
                  <c:v>3D7|MAL6P1.252|DBLd1|CIDRb1|0</c:v>
                </c:pt>
                <c:pt idx="19">
                  <c:v>3D7|MAL6P1.4|DBLa0.6|CIDRa3.2|0</c:v>
                </c:pt>
                <c:pt idx="20">
                  <c:v>3D7|MAL6P1.4|DBLb5|DBLg13|0</c:v>
                </c:pt>
                <c:pt idx="21">
                  <c:v>3D7|MAL6P1.4|DBLd4|CIDRg1|0</c:v>
                </c:pt>
                <c:pt idx="22">
                  <c:v>3D7|MAL6P1.4|DBLe2|DBLe7|0</c:v>
                </c:pt>
                <c:pt idx="23">
                  <c:v>3D7|MAL6P1.4|DBLe7|DBLe3|0</c:v>
                </c:pt>
                <c:pt idx="24">
                  <c:v>3D7|MAL7P1.212|DBLa0.17|CIDRa3.1|0</c:v>
                </c:pt>
                <c:pt idx="25">
                  <c:v>3D7|MAL7P1.50|DBLd1|CIDRg10|0</c:v>
                </c:pt>
                <c:pt idx="26">
                  <c:v>3D7|MAL7P1.55|DBLa0.9|CIDRa2.4|0</c:v>
                </c:pt>
                <c:pt idx="27">
                  <c:v>3D7|MAL7P1.55|DBLd1|CIDRg5|0</c:v>
                </c:pt>
                <c:pt idx="28">
                  <c:v>3D7|MAL8P1.220|DBLd1|CIDRb1|0</c:v>
                </c:pt>
                <c:pt idx="29">
                  <c:v>3D7|PF07_0048|DBLd1|CIDRb6|0</c:v>
                </c:pt>
                <c:pt idx="30">
                  <c:v>3D7|PF07_0049|DBLa0.17|CIDRa3.1|0</c:v>
                </c:pt>
                <c:pt idx="31">
                  <c:v>3D7|PF07_0049|DBLd1|CIDRg7|0</c:v>
                </c:pt>
                <c:pt idx="32">
                  <c:v>3D7|PF07_0050|DBLa0.18|CIDRa6|0</c:v>
                </c:pt>
                <c:pt idx="33">
                  <c:v>3D7|PF07_0050|DBLb6|DBLg9|0</c:v>
                </c:pt>
                <c:pt idx="34">
                  <c:v>3D7|PF07_0051|DBLa0.1|CIDRa3.1|0</c:v>
                </c:pt>
                <c:pt idx="35">
                  <c:v>3D7|PF07_0051|DBLd1|CIDRb1|0</c:v>
                </c:pt>
                <c:pt idx="36">
                  <c:v>3D7|PF07_0139|DBLa0.16|CIDRa3.4|0</c:v>
                </c:pt>
                <c:pt idx="37">
                  <c:v>3D7|PF07_0139|DBLd1|CIDRb1|0</c:v>
                </c:pt>
                <c:pt idx="38">
                  <c:v>3D7|PF07_0139|DBLe4|ATSB1|0</c:v>
                </c:pt>
                <c:pt idx="39">
                  <c:v>3D7|PF08_0103|DBLa0.12|CIDRa2.2|0</c:v>
                </c:pt>
                <c:pt idx="40">
                  <c:v>3D7|PF08_0106|DBLa0.2|CIDRa3.1|0</c:v>
                </c:pt>
                <c:pt idx="41">
                  <c:v>3D7|PF08_0106|DBLd1|CIDRb1|0</c:v>
                </c:pt>
                <c:pt idx="42">
                  <c:v>3D7|PF08_0107|DBLd1|CIDRg2|0</c:v>
                </c:pt>
                <c:pt idx="43">
                  <c:v>3D7|PF08_0142|DBLa0.9|CIDRa2.11|0</c:v>
                </c:pt>
                <c:pt idx="44">
                  <c:v>3D7|PF10_0001|DBLd1|CIDRg4|0</c:v>
                </c:pt>
                <c:pt idx="45">
                  <c:v>3D7|PF10_0406|DBLa0.9|CIDRa2.7|0</c:v>
                </c:pt>
                <c:pt idx="46">
                  <c:v>3D7|PF10_0406|DBLd1|CIDRb1|0</c:v>
                </c:pt>
                <c:pt idx="47">
                  <c:v>3D7|PF11_0007|DBLa0.15|CIDRa3.2|0</c:v>
                </c:pt>
                <c:pt idx="48">
                  <c:v>3D7|PF11_0007|DBLd1|CIDRb1|0</c:v>
                </c:pt>
                <c:pt idx="49">
                  <c:v>3D7|PF13_0001|DBLa0.11|CIDRa2.4|0</c:v>
                </c:pt>
                <c:pt idx="50">
                  <c:v>3D7|PF13_0001|DBLd1|CIDRb1|0</c:v>
                </c:pt>
                <c:pt idx="51">
                  <c:v>3D7|PF13_0364|DBLa0.16|CIDRa3.4|0</c:v>
                </c:pt>
                <c:pt idx="52">
                  <c:v>3D7|PF13_0364|DBLd1|CIDRb6|0</c:v>
                </c:pt>
                <c:pt idx="53">
                  <c:v>3D7|PFA0005w|DBLa0.11|CIDRa2.8|0</c:v>
                </c:pt>
                <c:pt idx="54">
                  <c:v>3D7|PFA0005w|DBLd1|CIDRb1|0</c:v>
                </c:pt>
                <c:pt idx="55">
                  <c:v>3D7|PFA0765c|DBLa0.5|CIDRa2.8|0</c:v>
                </c:pt>
                <c:pt idx="56">
                  <c:v>3D7|PFB0010w|DBLa0.7|CIDRa2.2|0</c:v>
                </c:pt>
                <c:pt idx="57">
                  <c:v>3D7|PFB0010w|DBLg11|ATSB1|0</c:v>
                </c:pt>
                <c:pt idx="58">
                  <c:v>3D7|PFB1055c|DBLa0.16|CIDRa3.4|0</c:v>
                </c:pt>
                <c:pt idx="59">
                  <c:v>3D7|PFC1120c|DBLa0.9|CIDRa2.1|0</c:v>
                </c:pt>
                <c:pt idx="60">
                  <c:v>3D7|PFC1120c|DBLd1|CIDRb7|0</c:v>
                </c:pt>
                <c:pt idx="61">
                  <c:v>3D7|PFD0005w|DBLg5|DBLd1|0</c:v>
                </c:pt>
                <c:pt idx="62">
                  <c:v>3D7|PFD0615c|DBLa0.17|CIDRa3.1|0</c:v>
                </c:pt>
                <c:pt idx="63">
                  <c:v>3D7|PFD0615c|DBLd1|CIDRb1|0</c:v>
                </c:pt>
                <c:pt idx="64">
                  <c:v>3D7|PFD0625c|DBLa0.1|CIDRa3.2|0</c:v>
                </c:pt>
                <c:pt idx="65">
                  <c:v>3D7|PFD0630c|DBLa0.1|CIDRa3.1|0</c:v>
                </c:pt>
                <c:pt idx="66">
                  <c:v>3D7|PFD0630c|DBLd1|CIDRg2|0</c:v>
                </c:pt>
                <c:pt idx="67">
                  <c:v>3D7|PFD0635c|DBLa0.1|CIDRa3.1|0</c:v>
                </c:pt>
                <c:pt idx="68">
                  <c:v>3D7|PFD0995c|DBLa0.1|CIDRa3.2|0</c:v>
                </c:pt>
                <c:pt idx="69">
                  <c:v>3D7|PFD0995c|DBLd1|CIDRg6|0</c:v>
                </c:pt>
                <c:pt idx="70">
                  <c:v>3D7|PFD1005c|DBLa0.8|CIDRa4|0</c:v>
                </c:pt>
                <c:pt idx="71">
                  <c:v>3D7|PFD1005c|DBLd1|CIDRg11|0</c:v>
                </c:pt>
                <c:pt idx="72">
                  <c:v>3D7|PFD1015c|DBLa0.24|CIDRa3.4|0</c:v>
                </c:pt>
                <c:pt idx="73">
                  <c:v>3D7|PFD1015c|DBLd1|CIDRb1|0</c:v>
                </c:pt>
                <c:pt idx="74">
                  <c:v>3D7|PFD1245c|DBLa0.14|CIDRa4|0</c:v>
                </c:pt>
                <c:pt idx="75">
                  <c:v>3D7|PFD1245c|DBLd1|CIDRb1|0</c:v>
                </c:pt>
                <c:pt idx="76">
                  <c:v>3D7|PFE0005w|DBLd1|CIDRb1|0</c:v>
                </c:pt>
                <c:pt idx="77">
                  <c:v>3D7|PFI0005w|DBLd1|CIDRg12|0</c:v>
                </c:pt>
                <c:pt idx="78">
                  <c:v>3D7|PFL0005w|DBLa0.9|CIDRa2.2|0</c:v>
                </c:pt>
                <c:pt idx="79">
                  <c:v>3D7|PFL0005w|DBLd1|CIDRb1|0</c:v>
                </c:pt>
                <c:pt idx="80">
                  <c:v>3D7|PFL0020w|DBLg14|DBLz5|0</c:v>
                </c:pt>
                <c:pt idx="81">
                  <c:v>3D7|PFL0020w|DBLz5|DBLe4|0</c:v>
                </c:pt>
                <c:pt idx="82">
                  <c:v>3D7|PFL0935c|DBLa0.16|CIDRa3.4|0</c:v>
                </c:pt>
                <c:pt idx="83">
                  <c:v>3D7|PFL0935c|DBLd1|CIDRg12|0</c:v>
                </c:pt>
                <c:pt idx="84">
                  <c:v>3D7|PFL1950w|DBLa0.7|CIDRa4|0</c:v>
                </c:pt>
                <c:pt idx="85">
                  <c:v>3D7|PFL1950w|DBLd1|CIDRb1|0</c:v>
                </c:pt>
                <c:pt idx="86">
                  <c:v>3D7|PFL1955w|DBLa0.16|CIDRa3.4|0</c:v>
                </c:pt>
                <c:pt idx="87">
                  <c:v>3D7|PFL1955w|DBLd1|CIDRb1|0</c:v>
                </c:pt>
                <c:pt idx="88">
                  <c:v>3D7|PFL1960w|DBLa0.20|CIDRa3.1|0</c:v>
                </c:pt>
                <c:pt idx="89">
                  <c:v>3D7|PFL1960w|DBLd1|CIDRb1|0</c:v>
                </c:pt>
                <c:pt idx="90">
                  <c:v>3D7|PFL2665c|DBLa0.19|CIDRa2.3|0</c:v>
                </c:pt>
                <c:pt idx="91">
                  <c:v>3D7|PFL2665c|DBLd1|CIDRb1|0</c:v>
                </c:pt>
                <c:pt idx="93">
                  <c:v>3D7|MAL6P1.316|DBLa2|CIDRa1.8|0</c:v>
                </c:pt>
                <c:pt idx="94">
                  <c:v>3D7|MAL6P1.316|DBLb12|DBLg4|0</c:v>
                </c:pt>
                <c:pt idx="95">
                  <c:v>3D7|MAL6P1.316|DBLz3|DBLe12|0</c:v>
                </c:pt>
                <c:pt idx="96">
                  <c:v>3D7|PF08_0140|CIDRa1.6|DBLb12|DBLg4</c:v>
                </c:pt>
                <c:pt idx="97">
                  <c:v>3D7|PF08_0140|DBLa2|CIDRa1.6|0</c:v>
                </c:pt>
                <c:pt idx="98">
                  <c:v>3D7|PF08_0140|DBLa2|CIDRa1.6|DBLb12</c:v>
                </c:pt>
                <c:pt idx="99">
                  <c:v>3D7|PF08_0140|DBLb12|DBLg4|0</c:v>
                </c:pt>
                <c:pt idx="100">
                  <c:v>3D7|PF08_0140|DBLd1|CIDRb1|0</c:v>
                </c:pt>
                <c:pt idx="101">
                  <c:v>3D7|PF08_0141|DBLa1.6|CIDRd2|0</c:v>
                </c:pt>
                <c:pt idx="102">
                  <c:v>3D7|PF08_0141|DBLg14|DBLz5|0</c:v>
                </c:pt>
                <c:pt idx="103">
                  <c:v>3D7|PF08_0141|DBLz5|DBLe4|0</c:v>
                </c:pt>
                <c:pt idx="104">
                  <c:v>3D7|PF08_0141e1s1|PfEMP1 - Extracellular - non-CD36-binding</c:v>
                </c:pt>
                <c:pt idx="105">
                  <c:v>3D7|PF08_0141e1s2|PfEMP1 - Extracellular - non-CD36-binding</c:v>
                </c:pt>
                <c:pt idx="106">
                  <c:v>3D7|PF08_0141e1s3|PfEMP1 - Extracellular - non-CD36-binding</c:v>
                </c:pt>
                <c:pt idx="107">
                  <c:v>3D7|PF11_0008|DBLa1.5|CIDRg3|0</c:v>
                </c:pt>
                <c:pt idx="108">
                  <c:v>3D7|PF11_0008|DBLg12|DBLd5|0</c:v>
                </c:pt>
                <c:pt idx="109">
                  <c:v>3D7|PF11_0008e1s1|PfEMP1 - Extracellular - non-CD36-binding</c:v>
                </c:pt>
                <c:pt idx="110">
                  <c:v>3D7|PF11_0008e1s2|PfEMP1 - Extracellular - non-CD36-binding</c:v>
                </c:pt>
                <c:pt idx="111">
                  <c:v>3D7|PF11_0008e1s3|PfEMP1 - Extracellular - non-CD36-binding</c:v>
                </c:pt>
                <c:pt idx="112">
                  <c:v>3D7|PF11_0521|DBLb3|DBLb6|0</c:v>
                </c:pt>
                <c:pt idx="113">
                  <c:v>3D7|PF11_0521|DBLb6|DBLd3|0</c:v>
                </c:pt>
                <c:pt idx="114">
                  <c:v>3D7|PF13_0003|DBLa1.6|CIDRd1|0</c:v>
                </c:pt>
                <c:pt idx="115">
                  <c:v>3D7|PF13_0003|DBLb3|DBLg12|0</c:v>
                </c:pt>
                <c:pt idx="116">
                  <c:v>3D7|PF13_0003|DBLd5|CIDRb3|0</c:v>
                </c:pt>
                <c:pt idx="117">
                  <c:v>3D7|PF13_0003|DBLg12|DBLd5|0</c:v>
                </c:pt>
                <c:pt idx="118">
                  <c:v>3D7|PFA0015c|DBLa1.3|DBLe8|0</c:v>
                </c:pt>
                <c:pt idx="119">
                  <c:v>3D7|PFD0020c|DBLa1.2|CIDRa1.1|0</c:v>
                </c:pt>
                <c:pt idx="120">
                  <c:v>3D7|PFD0020c|DBLb12|DBLg6|0</c:v>
                </c:pt>
                <c:pt idx="121">
                  <c:v>3D7|PFD0020c|DBLd1|CIDRg8|0</c:v>
                </c:pt>
                <c:pt idx="122">
                  <c:v>3D7|PFD0020c|DBLg6|DBLg11|0</c:v>
                </c:pt>
                <c:pt idx="123">
                  <c:v>3D7|PFD1235w|DBLa1.4|CIDRa1.6|0</c:v>
                </c:pt>
                <c:pt idx="124">
                  <c:v>3D7|PFD1235w|DBLb3|DBLb3|0</c:v>
                </c:pt>
                <c:pt idx="125">
                  <c:v>3D7|PFD1235w|DBLb3|DBLg13|0</c:v>
                </c:pt>
                <c:pt idx="126">
                  <c:v>3D7|PFD1235w|DBLd1|CIDRb5|0</c:v>
                </c:pt>
                <c:pt idx="127">
                  <c:v>3D7|PFD1235w|DBLg13|DBLd1|0</c:v>
                </c:pt>
                <c:pt idx="128">
                  <c:v>3D7|PFE1640w|DBLb1|DBLg15|0</c:v>
                </c:pt>
                <c:pt idx="129">
                  <c:v>3D7|PFE1640w|DBLe1|DBLg8|0</c:v>
                </c:pt>
                <c:pt idx="130">
                  <c:v>3D7|PFE1640w|DBLg15|DBLe1|0</c:v>
                </c:pt>
                <c:pt idx="131">
                  <c:v>3D7|PFE1640w|DBLg8|DBLz1|0</c:v>
                </c:pt>
                <c:pt idx="132">
                  <c:v>3D7|PFE1640w|DBLz1|DBLe5|0</c:v>
                </c:pt>
                <c:pt idx="133">
                  <c:v>3D7|PFF0020c|DBLa1.3|DBLe8|0</c:v>
                </c:pt>
                <c:pt idx="134">
                  <c:v>3D7|PFI1820w|DBLa1.3|DBLe8|0</c:v>
                </c:pt>
                <c:pt idx="135">
                  <c:v>3D7|PFL0020w|DBLa0.18|CIDRa5|0</c:v>
                </c:pt>
                <c:pt idx="136">
                  <c:v>3D7|PFL0020w|DBLb5|DBLg14|0</c:v>
                </c:pt>
                <c:pt idx="137">
                  <c:v>3D7|PFL0030c|DBLepam4|DBLepam5|0</c:v>
                </c:pt>
                <c:pt idx="138">
                  <c:v>3D7|PFL0030c|DBLepam5|DBLe10|0</c:v>
                </c:pt>
                <c:pt idx="139">
                  <c:v>3D7|PFL0030c|DBLpam1|DBLpam2|0</c:v>
                </c:pt>
                <c:pt idx="140">
                  <c:v>3D7|PFL0030c|DBLpam2|CIDRpam|0</c:v>
                </c:pt>
                <c:pt idx="141">
                  <c:v>3D7|PFL0030c|DBLpam3|DBLepam4|0</c:v>
                </c:pt>
                <c:pt idx="143">
                  <c:v>3D7|MAL6P1.252-e2|PfEMP1 - Intracellular</c:v>
                </c:pt>
                <c:pt idx="144">
                  <c:v>3D7|MAL7P1.55|ATSB13|0|0</c:v>
                </c:pt>
                <c:pt idx="145">
                  <c:v>3D7|MAL8P1.220|ATSB1|0|0</c:v>
                </c:pt>
                <c:pt idx="146">
                  <c:v>3D7|PF07_0048|ATSB7|0|0</c:v>
                </c:pt>
                <c:pt idx="147">
                  <c:v>3D7|PF07_0048e2s1|PfEMP1 - Intracellular</c:v>
                </c:pt>
                <c:pt idx="148">
                  <c:v>3D7|PF08_0107|ATSB2|0|0</c:v>
                </c:pt>
                <c:pt idx="149">
                  <c:v>3D7|PF08_0140e2s1|PfEMP1 - Intracellular</c:v>
                </c:pt>
                <c:pt idx="150">
                  <c:v>3D7|PF08_0141|ATSA3|0|0</c:v>
                </c:pt>
                <c:pt idx="151">
                  <c:v>3D7|PF08_0141e2s1|PfEMP1 - Intracellular</c:v>
                </c:pt>
                <c:pt idx="152">
                  <c:v>3D7|PF10_0001|ATSB1|0|0</c:v>
                </c:pt>
                <c:pt idx="153">
                  <c:v>3D7|PF10_0406|ATSB1|0|0</c:v>
                </c:pt>
                <c:pt idx="154">
                  <c:v>3D7|PF11_0008e2s1|PfEMP1 - Intracellular</c:v>
                </c:pt>
                <c:pt idx="155">
                  <c:v>3D7|PF11_0521|ATSA2|0|0</c:v>
                </c:pt>
                <c:pt idx="156">
                  <c:v>3D7|PF11_0521|PfEMP1 - Intracellular</c:v>
                </c:pt>
                <c:pt idx="157">
                  <c:v>3D7|PF13_0003|ATSA2|0|0</c:v>
                </c:pt>
                <c:pt idx="158">
                  <c:v>3D7|PFC0005w|ATSB1|0|0</c:v>
                </c:pt>
                <c:pt idx="159">
                  <c:v>3D7|PFD0995ce2s1|PfEMP1 - Intracellular</c:v>
                </c:pt>
                <c:pt idx="160">
                  <c:v>3D7|PFD1000c|ATSB19|0|0</c:v>
                </c:pt>
                <c:pt idx="161">
                  <c:v>3D7|PFD1235w|ATSA2|0|0</c:v>
                </c:pt>
                <c:pt idx="162">
                  <c:v>3D7|PFL1955w|ATSB7|0|0</c:v>
                </c:pt>
                <c:pt idx="164">
                  <c:v>3D7|AMA1</c:v>
                </c:pt>
                <c:pt idx="165">
                  <c:v>3D7|MSP1 - segment 1</c:v>
                </c:pt>
                <c:pt idx="166">
                  <c:v>3D7|MSP1 - segment 2</c:v>
                </c:pt>
                <c:pt idx="168">
                  <c:v>3D7|PF07_0049</c:v>
                </c:pt>
                <c:pt idx="169">
                  <c:v>3D7|PF08_0140</c:v>
                </c:pt>
                <c:pt idx="170">
                  <c:v>3D7|PF11_0007</c:v>
                </c:pt>
                <c:pt idx="171">
                  <c:v>3D7|PF11_0521PF11_0521_1|DBL|CIDR|0</c:v>
                </c:pt>
                <c:pt idx="173">
                  <c:v>3D7|rifin|||</c:v>
                </c:pt>
                <c:pt idx="174">
                  <c:v>3D7|rifin|||</c:v>
                </c:pt>
                <c:pt idx="176">
                  <c:v>3D7|stevor|||</c:v>
                </c:pt>
                <c:pt idx="177">
                  <c:v>3D7|stevor|||</c:v>
                </c:pt>
                <c:pt idx="178">
                  <c:v>3D7|stevor|||</c:v>
                </c:pt>
                <c:pt idx="179">
                  <c:v>3D7|stevor-1|||</c:v>
                </c:pt>
                <c:pt idx="180">
                  <c:v>3D7|stevor-1|||</c:v>
                </c:pt>
                <c:pt idx="181">
                  <c:v>3D7|stevor-2|||</c:v>
                </c:pt>
                <c:pt idx="182">
                  <c:v>3D7|stevor-2|||</c:v>
                </c:pt>
                <c:pt idx="184">
                  <c:v>DD2var43|ATSA4|0|0</c:v>
                </c:pt>
                <c:pt idx="185">
                  <c:v>DD2var43|CIDRa1.5|DBLg17|0</c:v>
                </c:pt>
                <c:pt idx="186">
                  <c:v>DD2var43|CIDRb3|DBLb7|0</c:v>
                </c:pt>
                <c:pt idx="187">
                  <c:v>DD2var43|DBLa1.2|CIDRa1.5|0</c:v>
                </c:pt>
                <c:pt idx="188">
                  <c:v>DD2var43|DBLb7|DBLg9|0</c:v>
                </c:pt>
                <c:pt idx="189">
                  <c:v>DD2var43|DBLd5|CIDRb3|0</c:v>
                </c:pt>
                <c:pt idx="190">
                  <c:v>DD2var43|DBLg17|DBLd5|0</c:v>
                </c:pt>
                <c:pt idx="191">
                  <c:v>DD2var49|CIDRa1.7|DBLb3|0</c:v>
                </c:pt>
                <c:pt idx="192">
                  <c:v>DD2var49|CIDRg2|DBLg17|0</c:v>
                </c:pt>
                <c:pt idx="193">
                  <c:v>DD2var49|DBLb3|DBLg11|0</c:v>
                </c:pt>
                <c:pt idx="194">
                  <c:v>DD2var49|DBLg17|DBLz4|0</c:v>
                </c:pt>
                <c:pt idx="195">
                  <c:v>DD2var49|NTSA8|DBLa1.2|CIDRa1.7</c:v>
                </c:pt>
                <c:pt idx="196">
                  <c:v>HB3var03|CIDRa1.4|DBLb3|0</c:v>
                </c:pt>
                <c:pt idx="197">
                  <c:v>HB3var03|CIDRb3|DBLb7|0</c:v>
                </c:pt>
                <c:pt idx="198">
                  <c:v>HB3var03|DBLb3|DBLg12|0</c:v>
                </c:pt>
                <c:pt idx="199">
                  <c:v>HB3var05|ATSA2|0|0</c:v>
                </c:pt>
                <c:pt idx="200">
                  <c:v>HB3var1csa|ATS|0|0</c:v>
                </c:pt>
                <c:pt idx="201">
                  <c:v>HB3var1csa|CIDRa|DBLb|0</c:v>
                </c:pt>
                <c:pt idx="202">
                  <c:v>HB3var1csa|DBLa|CIDRa|0</c:v>
                </c:pt>
                <c:pt idx="203">
                  <c:v>HB3var1csa|DBLb|DBLg|0</c:v>
                </c:pt>
                <c:pt idx="204">
                  <c:v>HB3var1csa|DBLe|DBLg|0</c:v>
                </c:pt>
                <c:pt idx="205">
                  <c:v>HB3var1csa|DBLg|DBLe|0</c:v>
                </c:pt>
                <c:pt idx="206">
                  <c:v>HB3var1csa|DBLg|DBLz|0</c:v>
                </c:pt>
                <c:pt idx="207">
                  <c:v>HB3var1csa|DBLz|DBLe|0</c:v>
                </c:pt>
                <c:pt idx="208">
                  <c:v>IGHvar14|ATS|0|0</c:v>
                </c:pt>
                <c:pt idx="209">
                  <c:v>IGHvar14|CIDRa|DBLb|0</c:v>
                </c:pt>
                <c:pt idx="210">
                  <c:v>IGHvar14|DBLa|CIDRa|0</c:v>
                </c:pt>
                <c:pt idx="211">
                  <c:v>IGHvar14|DBLb|DBLg|0</c:v>
                </c:pt>
                <c:pt idx="212">
                  <c:v>IGHvar14|DBLe|DBLe|0</c:v>
                </c:pt>
                <c:pt idx="213">
                  <c:v>IGHvar14|DBLg|DBLe|0</c:v>
                </c:pt>
                <c:pt idx="214">
                  <c:v>IGHvar23|ATS|0|0</c:v>
                </c:pt>
                <c:pt idx="215">
                  <c:v>IGHvar23|CIDRa|DBLb|0</c:v>
                </c:pt>
                <c:pt idx="216">
                  <c:v>IGHvar23|DBLa|CIDRa|0</c:v>
                </c:pt>
                <c:pt idx="217">
                  <c:v>IGHvar23|DBLb|DBLg|0</c:v>
                </c:pt>
                <c:pt idx="218">
                  <c:v>IGHvar23|DBLd|CIDRb|0</c:v>
                </c:pt>
                <c:pt idx="219">
                  <c:v>IGHvar23|DBLg|DBLd|0</c:v>
                </c:pt>
                <c:pt idx="220">
                  <c:v>IGHvar23|DBLg|DBLg|0</c:v>
                </c:pt>
                <c:pt idx="221">
                  <c:v>IT4var06|ATS|0|0</c:v>
                </c:pt>
                <c:pt idx="222">
                  <c:v>IT4var06|CIDRa|DBLb|0</c:v>
                </c:pt>
                <c:pt idx="223">
                  <c:v>IT4var06|DBLa|CIDRa|0</c:v>
                </c:pt>
                <c:pt idx="224">
                  <c:v>IT4var06|DBLb|DBLg|0</c:v>
                </c:pt>
                <c:pt idx="225">
                  <c:v>IT4var06|DBLd|0|0</c:v>
                </c:pt>
                <c:pt idx="226">
                  <c:v>IT4var06|DBLd|CIDRb|0</c:v>
                </c:pt>
                <c:pt idx="227">
                  <c:v>IT4var07|CIDRa1.4|DBLb1|0</c:v>
                </c:pt>
                <c:pt idx="228">
                  <c:v>IT4var07|DBLb1|DBLb3|0</c:v>
                </c:pt>
                <c:pt idx="229">
                  <c:v>IT4var07|DBLb3|DBLg10|0</c:v>
                </c:pt>
                <c:pt idx="230">
                  <c:v>IT4var07|DBLd1|CIDRb1|0</c:v>
                </c:pt>
                <c:pt idx="231">
                  <c:v>IT4var07|NTSA6|DBLa1.7|CIDRa1.4</c:v>
                </c:pt>
                <c:pt idx="232">
                  <c:v>IT4var19|ATSB3|0|0</c:v>
                </c:pt>
                <c:pt idx="233">
                  <c:v>IT4var19|CIDRa1.1|DBLb12|0</c:v>
                </c:pt>
                <c:pt idx="234">
                  <c:v>IT4var19|CIDRb1|DBLg9|0</c:v>
                </c:pt>
                <c:pt idx="235">
                  <c:v>IT4var19|DBLb12|DBLg6|0</c:v>
                </c:pt>
                <c:pt idx="236">
                  <c:v>IT4var19|DBLd1|CIDRb1|0</c:v>
                </c:pt>
                <c:pt idx="237">
                  <c:v>IT4var19|DBLg6|DBLd1|0</c:v>
                </c:pt>
                <c:pt idx="238">
                  <c:v>IT4var20|ATSB16|0|0</c:v>
                </c:pt>
                <c:pt idx="239">
                  <c:v>IT4var20|CIDRa1.1|DBLb12|0</c:v>
                </c:pt>
                <c:pt idx="240">
                  <c:v>IT4var20|DBLb12|DBLg6|0</c:v>
                </c:pt>
                <c:pt idx="241">
                  <c:v>IT4var20|DBLd1|CIDRb1|0</c:v>
                </c:pt>
                <c:pt idx="242">
                  <c:v>IT4var20|DBLg6|DBLd1|0</c:v>
                </c:pt>
                <c:pt idx="243">
                  <c:v>IT4var20|NTSB3|DBLa2|CIDRa1.1</c:v>
                </c:pt>
                <c:pt idx="244">
                  <c:v>IT4var22|CIDRa1.7|DBLb3|0</c:v>
                </c:pt>
                <c:pt idx="245">
                  <c:v>IT4var22|DBLa1.4|CIDRa1.7|0</c:v>
                </c:pt>
                <c:pt idx="246">
                  <c:v>IT4var22|DBLb3|DBLg10|0</c:v>
                </c:pt>
                <c:pt idx="247">
                  <c:v>IT4var22|DBLd1|CIDRb1|0</c:v>
                </c:pt>
                <c:pt idx="248">
                  <c:v>IT4var22|DBLg10|DBLg11|0</c:v>
                </c:pt>
                <c:pt idx="249">
                  <c:v>IT4var22|DBLg11|DBLd1|0</c:v>
                </c:pt>
                <c:pt idx="250">
                  <c:v>IT4var22|NTSA2|DBLa1.4|CIDRa1.7</c:v>
                </c:pt>
                <c:pt idx="251">
                  <c:v>MaliRF327|CIDRa|DBLb|0</c:v>
                </c:pt>
                <c:pt idx="252">
                  <c:v>MaliRF327|DBLa|CIDRa|0</c:v>
                </c:pt>
                <c:pt idx="253">
                  <c:v>MaliRF327|DBLb|DBLg|0</c:v>
                </c:pt>
                <c:pt idx="254">
                  <c:v>MaliRF327|DBLd|CIDRb|0</c:v>
                </c:pt>
                <c:pt idx="255">
                  <c:v>MaliRF327|DBLg|DBLd|0</c:v>
                </c:pt>
                <c:pt idx="256">
                  <c:v>MaliRF327|DBLg|DBLg|0</c:v>
                </c:pt>
                <c:pt idx="257">
                  <c:v>MaliRF398|CIDRa|DBLb|0</c:v>
                </c:pt>
                <c:pt idx="258">
                  <c:v>MaliRF398|DBLa|CIDRa|0</c:v>
                </c:pt>
                <c:pt idx="259">
                  <c:v>MaliRF398|DBLb|DBLg|0</c:v>
                </c:pt>
                <c:pt idx="260">
                  <c:v>MaliRF398|DBLg|DBLz|0</c:v>
                </c:pt>
                <c:pt idx="261">
                  <c:v>MaliRF398|DBLz|DBLe|0</c:v>
                </c:pt>
                <c:pt idx="264">
                  <c:v>Tetanus toxin_0.01</c:v>
                </c:pt>
                <c:pt idx="265">
                  <c:v>Tetanus toxin_0.03</c:v>
                </c:pt>
                <c:pt idx="266">
                  <c:v>Tetanus toxin_0.1</c:v>
                </c:pt>
              </c:strCache>
            </c:strRef>
          </c:cat>
          <c:val>
            <c:numRef>
              <c:f>'Final_Analysis1 (4)'!$BH$6:$BH$272</c:f>
              <c:numCache>
                <c:formatCode>General</c:formatCode>
                <c:ptCount val="267"/>
                <c:pt idx="0">
                  <c:v>50</c:v>
                </c:pt>
                <c:pt idx="1">
                  <c:v>10</c:v>
                </c:pt>
                <c:pt idx="2">
                  <c:v>40</c:v>
                </c:pt>
                <c:pt idx="3">
                  <c:v>60</c:v>
                </c:pt>
                <c:pt idx="4">
                  <c:v>0</c:v>
                </c:pt>
                <c:pt idx="5">
                  <c:v>20</c:v>
                </c:pt>
                <c:pt idx="6">
                  <c:v>80</c:v>
                </c:pt>
                <c:pt idx="7">
                  <c:v>20</c:v>
                </c:pt>
                <c:pt idx="8">
                  <c:v>40</c:v>
                </c:pt>
                <c:pt idx="9">
                  <c:v>20</c:v>
                </c:pt>
                <c:pt idx="10">
                  <c:v>50</c:v>
                </c:pt>
                <c:pt idx="11">
                  <c:v>30</c:v>
                </c:pt>
                <c:pt idx="12">
                  <c:v>10</c:v>
                </c:pt>
                <c:pt idx="13">
                  <c:v>40</c:v>
                </c:pt>
                <c:pt idx="14">
                  <c:v>0</c:v>
                </c:pt>
                <c:pt idx="15">
                  <c:v>0</c:v>
                </c:pt>
                <c:pt idx="16">
                  <c:v>30</c:v>
                </c:pt>
                <c:pt idx="17">
                  <c:v>40</c:v>
                </c:pt>
                <c:pt idx="18">
                  <c:v>20</c:v>
                </c:pt>
                <c:pt idx="19">
                  <c:v>40</c:v>
                </c:pt>
                <c:pt idx="20">
                  <c:v>40</c:v>
                </c:pt>
                <c:pt idx="21">
                  <c:v>20</c:v>
                </c:pt>
                <c:pt idx="22">
                  <c:v>40</c:v>
                </c:pt>
                <c:pt idx="23">
                  <c:v>30</c:v>
                </c:pt>
                <c:pt idx="24">
                  <c:v>20</c:v>
                </c:pt>
                <c:pt idx="25">
                  <c:v>10</c:v>
                </c:pt>
                <c:pt idx="26">
                  <c:v>20</c:v>
                </c:pt>
                <c:pt idx="27">
                  <c:v>20</c:v>
                </c:pt>
                <c:pt idx="28">
                  <c:v>10</c:v>
                </c:pt>
                <c:pt idx="29">
                  <c:v>60</c:v>
                </c:pt>
                <c:pt idx="30">
                  <c:v>30</c:v>
                </c:pt>
                <c:pt idx="31">
                  <c:v>20</c:v>
                </c:pt>
                <c:pt idx="32">
                  <c:v>10</c:v>
                </c:pt>
                <c:pt idx="33">
                  <c:v>40</c:v>
                </c:pt>
                <c:pt idx="34">
                  <c:v>0</c:v>
                </c:pt>
                <c:pt idx="35">
                  <c:v>30</c:v>
                </c:pt>
                <c:pt idx="36">
                  <c:v>0</c:v>
                </c:pt>
                <c:pt idx="37">
                  <c:v>20</c:v>
                </c:pt>
                <c:pt idx="38">
                  <c:v>0</c:v>
                </c:pt>
                <c:pt idx="39">
                  <c:v>20</c:v>
                </c:pt>
                <c:pt idx="40">
                  <c:v>20</c:v>
                </c:pt>
                <c:pt idx="41">
                  <c:v>50</c:v>
                </c:pt>
                <c:pt idx="42">
                  <c:v>20</c:v>
                </c:pt>
                <c:pt idx="43">
                  <c:v>10</c:v>
                </c:pt>
                <c:pt idx="44">
                  <c:v>40</c:v>
                </c:pt>
                <c:pt idx="45">
                  <c:v>20</c:v>
                </c:pt>
                <c:pt idx="46">
                  <c:v>20</c:v>
                </c:pt>
                <c:pt idx="47">
                  <c:v>50</c:v>
                </c:pt>
                <c:pt idx="48">
                  <c:v>20</c:v>
                </c:pt>
                <c:pt idx="49">
                  <c:v>10</c:v>
                </c:pt>
                <c:pt idx="50">
                  <c:v>20</c:v>
                </c:pt>
                <c:pt idx="51">
                  <c:v>40</c:v>
                </c:pt>
                <c:pt idx="52">
                  <c:v>20</c:v>
                </c:pt>
                <c:pt idx="53">
                  <c:v>20</c:v>
                </c:pt>
                <c:pt idx="54">
                  <c:v>30</c:v>
                </c:pt>
                <c:pt idx="55">
                  <c:v>20</c:v>
                </c:pt>
                <c:pt idx="56">
                  <c:v>0</c:v>
                </c:pt>
                <c:pt idx="57">
                  <c:v>20</c:v>
                </c:pt>
                <c:pt idx="58">
                  <c:v>50</c:v>
                </c:pt>
                <c:pt idx="59">
                  <c:v>50</c:v>
                </c:pt>
                <c:pt idx="60">
                  <c:v>20</c:v>
                </c:pt>
                <c:pt idx="61">
                  <c:v>50</c:v>
                </c:pt>
                <c:pt idx="62">
                  <c:v>0</c:v>
                </c:pt>
                <c:pt idx="63">
                  <c:v>30</c:v>
                </c:pt>
                <c:pt idx="64">
                  <c:v>20</c:v>
                </c:pt>
                <c:pt idx="65">
                  <c:v>0</c:v>
                </c:pt>
                <c:pt idx="66">
                  <c:v>40</c:v>
                </c:pt>
                <c:pt idx="67">
                  <c:v>10</c:v>
                </c:pt>
                <c:pt idx="68">
                  <c:v>40</c:v>
                </c:pt>
                <c:pt idx="69">
                  <c:v>20</c:v>
                </c:pt>
                <c:pt idx="70">
                  <c:v>0</c:v>
                </c:pt>
                <c:pt idx="71">
                  <c:v>0</c:v>
                </c:pt>
                <c:pt idx="72">
                  <c:v>20</c:v>
                </c:pt>
                <c:pt idx="73">
                  <c:v>30</c:v>
                </c:pt>
                <c:pt idx="74">
                  <c:v>40</c:v>
                </c:pt>
                <c:pt idx="75">
                  <c:v>20</c:v>
                </c:pt>
                <c:pt idx="76">
                  <c:v>40</c:v>
                </c:pt>
                <c:pt idx="77">
                  <c:v>20</c:v>
                </c:pt>
                <c:pt idx="78">
                  <c:v>0</c:v>
                </c:pt>
                <c:pt idx="79">
                  <c:v>30</c:v>
                </c:pt>
                <c:pt idx="80">
                  <c:v>40</c:v>
                </c:pt>
                <c:pt idx="81">
                  <c:v>0</c:v>
                </c:pt>
                <c:pt idx="82">
                  <c:v>0</c:v>
                </c:pt>
                <c:pt idx="83">
                  <c:v>30</c:v>
                </c:pt>
                <c:pt idx="84">
                  <c:v>50</c:v>
                </c:pt>
                <c:pt idx="85">
                  <c:v>20</c:v>
                </c:pt>
                <c:pt idx="86">
                  <c:v>10</c:v>
                </c:pt>
                <c:pt idx="87">
                  <c:v>30</c:v>
                </c:pt>
                <c:pt idx="88">
                  <c:v>20</c:v>
                </c:pt>
                <c:pt idx="89">
                  <c:v>50</c:v>
                </c:pt>
                <c:pt idx="90">
                  <c:v>40</c:v>
                </c:pt>
                <c:pt idx="91">
                  <c:v>20</c:v>
                </c:pt>
                <c:pt idx="92">
                  <c:v>0</c:v>
                </c:pt>
                <c:pt idx="93">
                  <c:v>50</c:v>
                </c:pt>
                <c:pt idx="94">
                  <c:v>40</c:v>
                </c:pt>
                <c:pt idx="95">
                  <c:v>0</c:v>
                </c:pt>
                <c:pt idx="96">
                  <c:v>50</c:v>
                </c:pt>
                <c:pt idx="97">
                  <c:v>20</c:v>
                </c:pt>
                <c:pt idx="98">
                  <c:v>20</c:v>
                </c:pt>
                <c:pt idx="99">
                  <c:v>70</c:v>
                </c:pt>
                <c:pt idx="100">
                  <c:v>30</c:v>
                </c:pt>
                <c:pt idx="101">
                  <c:v>40</c:v>
                </c:pt>
                <c:pt idx="102">
                  <c:v>50</c:v>
                </c:pt>
                <c:pt idx="103">
                  <c:v>30</c:v>
                </c:pt>
                <c:pt idx="104">
                  <c:v>60</c:v>
                </c:pt>
                <c:pt idx="105">
                  <c:v>50</c:v>
                </c:pt>
                <c:pt idx="106">
                  <c:v>50</c:v>
                </c:pt>
                <c:pt idx="107">
                  <c:v>30</c:v>
                </c:pt>
                <c:pt idx="108">
                  <c:v>40</c:v>
                </c:pt>
                <c:pt idx="109">
                  <c:v>70</c:v>
                </c:pt>
                <c:pt idx="110">
                  <c:v>40</c:v>
                </c:pt>
                <c:pt idx="111">
                  <c:v>30</c:v>
                </c:pt>
                <c:pt idx="112">
                  <c:v>40</c:v>
                </c:pt>
                <c:pt idx="113">
                  <c:v>30</c:v>
                </c:pt>
                <c:pt idx="114">
                  <c:v>30</c:v>
                </c:pt>
                <c:pt idx="115">
                  <c:v>20</c:v>
                </c:pt>
                <c:pt idx="116">
                  <c:v>40</c:v>
                </c:pt>
                <c:pt idx="117">
                  <c:v>30</c:v>
                </c:pt>
                <c:pt idx="118">
                  <c:v>80</c:v>
                </c:pt>
                <c:pt idx="119">
                  <c:v>60</c:v>
                </c:pt>
                <c:pt idx="120">
                  <c:v>50</c:v>
                </c:pt>
                <c:pt idx="121">
                  <c:v>20</c:v>
                </c:pt>
                <c:pt idx="122">
                  <c:v>60</c:v>
                </c:pt>
                <c:pt idx="123">
                  <c:v>30</c:v>
                </c:pt>
                <c:pt idx="124">
                  <c:v>50</c:v>
                </c:pt>
                <c:pt idx="125">
                  <c:v>60</c:v>
                </c:pt>
                <c:pt idx="126">
                  <c:v>30</c:v>
                </c:pt>
                <c:pt idx="127">
                  <c:v>20</c:v>
                </c:pt>
                <c:pt idx="128">
                  <c:v>30</c:v>
                </c:pt>
                <c:pt idx="129">
                  <c:v>30</c:v>
                </c:pt>
                <c:pt idx="130">
                  <c:v>40</c:v>
                </c:pt>
                <c:pt idx="131">
                  <c:v>10</c:v>
                </c:pt>
                <c:pt idx="132">
                  <c:v>0</c:v>
                </c:pt>
                <c:pt idx="133">
                  <c:v>40</c:v>
                </c:pt>
                <c:pt idx="134">
                  <c:v>50</c:v>
                </c:pt>
                <c:pt idx="135">
                  <c:v>40</c:v>
                </c:pt>
                <c:pt idx="136">
                  <c:v>40</c:v>
                </c:pt>
                <c:pt idx="137">
                  <c:v>30</c:v>
                </c:pt>
                <c:pt idx="138">
                  <c:v>50</c:v>
                </c:pt>
                <c:pt idx="139">
                  <c:v>40</c:v>
                </c:pt>
                <c:pt idx="140">
                  <c:v>10</c:v>
                </c:pt>
                <c:pt idx="141">
                  <c:v>10</c:v>
                </c:pt>
                <c:pt idx="142">
                  <c:v>0</c:v>
                </c:pt>
                <c:pt idx="143">
                  <c:v>70</c:v>
                </c:pt>
                <c:pt idx="144">
                  <c:v>60</c:v>
                </c:pt>
                <c:pt idx="145">
                  <c:v>30</c:v>
                </c:pt>
                <c:pt idx="146">
                  <c:v>30</c:v>
                </c:pt>
                <c:pt idx="147">
                  <c:v>70</c:v>
                </c:pt>
                <c:pt idx="148">
                  <c:v>60</c:v>
                </c:pt>
                <c:pt idx="149">
                  <c:v>80</c:v>
                </c:pt>
                <c:pt idx="150">
                  <c:v>60</c:v>
                </c:pt>
                <c:pt idx="151">
                  <c:v>60</c:v>
                </c:pt>
                <c:pt idx="152">
                  <c:v>60</c:v>
                </c:pt>
                <c:pt idx="153">
                  <c:v>60</c:v>
                </c:pt>
                <c:pt idx="154">
                  <c:v>70</c:v>
                </c:pt>
                <c:pt idx="155">
                  <c:v>60</c:v>
                </c:pt>
                <c:pt idx="156">
                  <c:v>50</c:v>
                </c:pt>
                <c:pt idx="157">
                  <c:v>60</c:v>
                </c:pt>
                <c:pt idx="158">
                  <c:v>40</c:v>
                </c:pt>
                <c:pt idx="159">
                  <c:v>50</c:v>
                </c:pt>
                <c:pt idx="160">
                  <c:v>60</c:v>
                </c:pt>
                <c:pt idx="161">
                  <c:v>50</c:v>
                </c:pt>
                <c:pt idx="162">
                  <c:v>60</c:v>
                </c:pt>
                <c:pt idx="163">
                  <c:v>0</c:v>
                </c:pt>
                <c:pt idx="164">
                  <c:v>40</c:v>
                </c:pt>
                <c:pt idx="165">
                  <c:v>30</c:v>
                </c:pt>
                <c:pt idx="166">
                  <c:v>60</c:v>
                </c:pt>
                <c:pt idx="167">
                  <c:v>0</c:v>
                </c:pt>
                <c:pt idx="168">
                  <c:v>20</c:v>
                </c:pt>
                <c:pt idx="169">
                  <c:v>40</c:v>
                </c:pt>
                <c:pt idx="170">
                  <c:v>10</c:v>
                </c:pt>
                <c:pt idx="171">
                  <c:v>50</c:v>
                </c:pt>
                <c:pt idx="172">
                  <c:v>0</c:v>
                </c:pt>
                <c:pt idx="173">
                  <c:v>60</c:v>
                </c:pt>
                <c:pt idx="174">
                  <c:v>70</c:v>
                </c:pt>
                <c:pt idx="175">
                  <c:v>0</c:v>
                </c:pt>
                <c:pt idx="176">
                  <c:v>40</c:v>
                </c:pt>
                <c:pt idx="177">
                  <c:v>20</c:v>
                </c:pt>
                <c:pt idx="178">
                  <c:v>50</c:v>
                </c:pt>
                <c:pt idx="179">
                  <c:v>70</c:v>
                </c:pt>
                <c:pt idx="180">
                  <c:v>60</c:v>
                </c:pt>
                <c:pt idx="181">
                  <c:v>40</c:v>
                </c:pt>
                <c:pt idx="182">
                  <c:v>60</c:v>
                </c:pt>
                <c:pt idx="183">
                  <c:v>0</c:v>
                </c:pt>
                <c:pt idx="184">
                  <c:v>70</c:v>
                </c:pt>
                <c:pt idx="185">
                  <c:v>60</c:v>
                </c:pt>
                <c:pt idx="186">
                  <c:v>50</c:v>
                </c:pt>
                <c:pt idx="187">
                  <c:v>80</c:v>
                </c:pt>
                <c:pt idx="188">
                  <c:v>50</c:v>
                </c:pt>
                <c:pt idx="189">
                  <c:v>40</c:v>
                </c:pt>
                <c:pt idx="190">
                  <c:v>40</c:v>
                </c:pt>
                <c:pt idx="191">
                  <c:v>60</c:v>
                </c:pt>
                <c:pt idx="192">
                  <c:v>50</c:v>
                </c:pt>
                <c:pt idx="193">
                  <c:v>50</c:v>
                </c:pt>
                <c:pt idx="194">
                  <c:v>20</c:v>
                </c:pt>
                <c:pt idx="195">
                  <c:v>60</c:v>
                </c:pt>
                <c:pt idx="196">
                  <c:v>50</c:v>
                </c:pt>
                <c:pt idx="197">
                  <c:v>40</c:v>
                </c:pt>
                <c:pt idx="198">
                  <c:v>50</c:v>
                </c:pt>
                <c:pt idx="199">
                  <c:v>70</c:v>
                </c:pt>
                <c:pt idx="200">
                  <c:v>60</c:v>
                </c:pt>
                <c:pt idx="201">
                  <c:v>30</c:v>
                </c:pt>
                <c:pt idx="202">
                  <c:v>40</c:v>
                </c:pt>
                <c:pt idx="203">
                  <c:v>40</c:v>
                </c:pt>
                <c:pt idx="204">
                  <c:v>50</c:v>
                </c:pt>
                <c:pt idx="205">
                  <c:v>40</c:v>
                </c:pt>
                <c:pt idx="206">
                  <c:v>50</c:v>
                </c:pt>
                <c:pt idx="207">
                  <c:v>0</c:v>
                </c:pt>
                <c:pt idx="208">
                  <c:v>60</c:v>
                </c:pt>
                <c:pt idx="209">
                  <c:v>40</c:v>
                </c:pt>
                <c:pt idx="210">
                  <c:v>10</c:v>
                </c:pt>
                <c:pt idx="211">
                  <c:v>30</c:v>
                </c:pt>
                <c:pt idx="212">
                  <c:v>60</c:v>
                </c:pt>
                <c:pt idx="213">
                  <c:v>60</c:v>
                </c:pt>
                <c:pt idx="214">
                  <c:v>60</c:v>
                </c:pt>
                <c:pt idx="215">
                  <c:v>60</c:v>
                </c:pt>
                <c:pt idx="216">
                  <c:v>20</c:v>
                </c:pt>
                <c:pt idx="217">
                  <c:v>60</c:v>
                </c:pt>
                <c:pt idx="218">
                  <c:v>40</c:v>
                </c:pt>
                <c:pt idx="219">
                  <c:v>40</c:v>
                </c:pt>
                <c:pt idx="220">
                  <c:v>50</c:v>
                </c:pt>
                <c:pt idx="221">
                  <c:v>30</c:v>
                </c:pt>
                <c:pt idx="222">
                  <c:v>50</c:v>
                </c:pt>
                <c:pt idx="223">
                  <c:v>30</c:v>
                </c:pt>
                <c:pt idx="224">
                  <c:v>50</c:v>
                </c:pt>
                <c:pt idx="225">
                  <c:v>30</c:v>
                </c:pt>
                <c:pt idx="226">
                  <c:v>30</c:v>
                </c:pt>
                <c:pt idx="227">
                  <c:v>40</c:v>
                </c:pt>
                <c:pt idx="228">
                  <c:v>50</c:v>
                </c:pt>
                <c:pt idx="229">
                  <c:v>60</c:v>
                </c:pt>
                <c:pt idx="230">
                  <c:v>40</c:v>
                </c:pt>
                <c:pt idx="231">
                  <c:v>40</c:v>
                </c:pt>
                <c:pt idx="232">
                  <c:v>20</c:v>
                </c:pt>
                <c:pt idx="233">
                  <c:v>30</c:v>
                </c:pt>
                <c:pt idx="234">
                  <c:v>10</c:v>
                </c:pt>
                <c:pt idx="235">
                  <c:v>40</c:v>
                </c:pt>
                <c:pt idx="236">
                  <c:v>30</c:v>
                </c:pt>
                <c:pt idx="237">
                  <c:v>40</c:v>
                </c:pt>
                <c:pt idx="238">
                  <c:v>20</c:v>
                </c:pt>
                <c:pt idx="239">
                  <c:v>30</c:v>
                </c:pt>
                <c:pt idx="240">
                  <c:v>50</c:v>
                </c:pt>
                <c:pt idx="241">
                  <c:v>50</c:v>
                </c:pt>
                <c:pt idx="242">
                  <c:v>50</c:v>
                </c:pt>
                <c:pt idx="243">
                  <c:v>10</c:v>
                </c:pt>
                <c:pt idx="244">
                  <c:v>20</c:v>
                </c:pt>
                <c:pt idx="245">
                  <c:v>60</c:v>
                </c:pt>
                <c:pt idx="246">
                  <c:v>50</c:v>
                </c:pt>
                <c:pt idx="247">
                  <c:v>20</c:v>
                </c:pt>
                <c:pt idx="248">
                  <c:v>60</c:v>
                </c:pt>
                <c:pt idx="249">
                  <c:v>50</c:v>
                </c:pt>
                <c:pt idx="250">
                  <c:v>60</c:v>
                </c:pt>
                <c:pt idx="251">
                  <c:v>50</c:v>
                </c:pt>
                <c:pt idx="252">
                  <c:v>60</c:v>
                </c:pt>
                <c:pt idx="253">
                  <c:v>40</c:v>
                </c:pt>
                <c:pt idx="254">
                  <c:v>30</c:v>
                </c:pt>
                <c:pt idx="255">
                  <c:v>60</c:v>
                </c:pt>
                <c:pt idx="256">
                  <c:v>50</c:v>
                </c:pt>
                <c:pt idx="257">
                  <c:v>40</c:v>
                </c:pt>
                <c:pt idx="258">
                  <c:v>10</c:v>
                </c:pt>
                <c:pt idx="259">
                  <c:v>60</c:v>
                </c:pt>
                <c:pt idx="260">
                  <c:v>50</c:v>
                </c:pt>
                <c:pt idx="261">
                  <c:v>10</c:v>
                </c:pt>
                <c:pt idx="262">
                  <c:v>0</c:v>
                </c:pt>
                <c:pt idx="263">
                  <c:v>0</c:v>
                </c:pt>
                <c:pt idx="264">
                  <c:v>10</c:v>
                </c:pt>
                <c:pt idx="265">
                  <c:v>10</c:v>
                </c:pt>
                <c:pt idx="266">
                  <c:v>20</c:v>
                </c:pt>
              </c:numCache>
            </c:numRef>
          </c:val>
          <c:extLst>
            <c:ext xmlns:c16="http://schemas.microsoft.com/office/drawing/2014/chart" uri="{C3380CC4-5D6E-409C-BE32-E72D297353CC}">
              <c16:uniqueId val="{00000000-3D9E-4E90-BCFC-084D4C4D651B}"/>
            </c:ext>
          </c:extLst>
        </c:ser>
        <c:ser>
          <c:idx val="1"/>
          <c:order val="1"/>
          <c:tx>
            <c:strRef>
              <c:f>'Final_Analysis1 (4)'!$BI$5</c:f>
              <c:strCache>
                <c:ptCount val="1"/>
                <c:pt idx="0">
                  <c:v>Prot</c:v>
                </c:pt>
              </c:strCache>
            </c:strRef>
          </c:tx>
          <c:spPr>
            <a:solidFill>
              <a:schemeClr val="accent2"/>
            </a:solidFill>
            <a:ln>
              <a:noFill/>
            </a:ln>
            <a:effectLst/>
          </c:spPr>
          <c:invertIfNegative val="0"/>
          <c:cat>
            <c:strRef>
              <c:f>'Final_Analysis1 (4)'!$J$6:$J$272</c:f>
              <c:strCache>
                <c:ptCount val="267"/>
                <c:pt idx="0">
                  <c:v>apical membrane antigen 1</c:v>
                </c:pt>
                <c:pt idx="1">
                  <c:v>circumsporozoite (CS) protein</c:v>
                </c:pt>
                <c:pt idx="2">
                  <c:v>merozoite surface protein 1</c:v>
                </c:pt>
                <c:pt idx="3">
                  <c:v>merozoite surface protein 1</c:v>
                </c:pt>
                <c:pt idx="5">
                  <c:v>3D7|PF11_0008|DBLalpha tag Group A</c:v>
                </c:pt>
                <c:pt idx="6">
                  <c:v>3D7|PF13_0003|DBLalpha tag Group A</c:v>
                </c:pt>
                <c:pt idx="7">
                  <c:v>3D7|PFA0015c|DBLalpha tag Group A</c:v>
                </c:pt>
                <c:pt idx="8">
                  <c:v>3D7|MAL6P1.4|DBLalpha tag Group B/A</c:v>
                </c:pt>
                <c:pt idx="9">
                  <c:v>3D7|MAL6P1.252|DBLalpha tag Group C</c:v>
                </c:pt>
                <c:pt idx="10">
                  <c:v>3D7|PF07_0049|DBLalpha tags</c:v>
                </c:pt>
                <c:pt idx="11">
                  <c:v>3D7|PF08_0106|DBLalpha tags</c:v>
                </c:pt>
                <c:pt idx="12">
                  <c:v>3D7|PFB0010w|DBLalpha tags</c:v>
                </c:pt>
                <c:pt idx="13">
                  <c:v>3D7|PFL1960w|DBLalpha tags</c:v>
                </c:pt>
                <c:pt idx="15">
                  <c:v>3D7|MAL6P1.1|DBLa0.8|CIDRa4|0</c:v>
                </c:pt>
                <c:pt idx="16">
                  <c:v>3D7|MAL6P1.252|DBLa0.21|CIDRa2.1|0</c:v>
                </c:pt>
                <c:pt idx="17">
                  <c:v>3D7|MAL6P1.252|DBLb4|DBLd1|0</c:v>
                </c:pt>
                <c:pt idx="18">
                  <c:v>3D7|MAL6P1.252|DBLd1|CIDRb1|0</c:v>
                </c:pt>
                <c:pt idx="19">
                  <c:v>3D7|MAL6P1.4|DBLa0.6|CIDRa3.2|0</c:v>
                </c:pt>
                <c:pt idx="20">
                  <c:v>3D7|MAL6P1.4|DBLb5|DBLg13|0</c:v>
                </c:pt>
                <c:pt idx="21">
                  <c:v>3D7|MAL6P1.4|DBLd4|CIDRg1|0</c:v>
                </c:pt>
                <c:pt idx="22">
                  <c:v>3D7|MAL6P1.4|DBLe2|DBLe7|0</c:v>
                </c:pt>
                <c:pt idx="23">
                  <c:v>3D7|MAL6P1.4|DBLe7|DBLe3|0</c:v>
                </c:pt>
                <c:pt idx="24">
                  <c:v>3D7|MAL7P1.212|DBLa0.17|CIDRa3.1|0</c:v>
                </c:pt>
                <c:pt idx="25">
                  <c:v>3D7|MAL7P1.50|DBLd1|CIDRg10|0</c:v>
                </c:pt>
                <c:pt idx="26">
                  <c:v>3D7|MAL7P1.55|DBLa0.9|CIDRa2.4|0</c:v>
                </c:pt>
                <c:pt idx="27">
                  <c:v>3D7|MAL7P1.55|DBLd1|CIDRg5|0</c:v>
                </c:pt>
                <c:pt idx="28">
                  <c:v>3D7|MAL8P1.220|DBLd1|CIDRb1|0</c:v>
                </c:pt>
                <c:pt idx="29">
                  <c:v>3D7|PF07_0048|DBLd1|CIDRb6|0</c:v>
                </c:pt>
                <c:pt idx="30">
                  <c:v>3D7|PF07_0049|DBLa0.17|CIDRa3.1|0</c:v>
                </c:pt>
                <c:pt idx="31">
                  <c:v>3D7|PF07_0049|DBLd1|CIDRg7|0</c:v>
                </c:pt>
                <c:pt idx="32">
                  <c:v>3D7|PF07_0050|DBLa0.18|CIDRa6|0</c:v>
                </c:pt>
                <c:pt idx="33">
                  <c:v>3D7|PF07_0050|DBLb6|DBLg9|0</c:v>
                </c:pt>
                <c:pt idx="34">
                  <c:v>3D7|PF07_0051|DBLa0.1|CIDRa3.1|0</c:v>
                </c:pt>
                <c:pt idx="35">
                  <c:v>3D7|PF07_0051|DBLd1|CIDRb1|0</c:v>
                </c:pt>
                <c:pt idx="36">
                  <c:v>3D7|PF07_0139|DBLa0.16|CIDRa3.4|0</c:v>
                </c:pt>
                <c:pt idx="37">
                  <c:v>3D7|PF07_0139|DBLd1|CIDRb1|0</c:v>
                </c:pt>
                <c:pt idx="38">
                  <c:v>3D7|PF07_0139|DBLe4|ATSB1|0</c:v>
                </c:pt>
                <c:pt idx="39">
                  <c:v>3D7|PF08_0103|DBLa0.12|CIDRa2.2|0</c:v>
                </c:pt>
                <c:pt idx="40">
                  <c:v>3D7|PF08_0106|DBLa0.2|CIDRa3.1|0</c:v>
                </c:pt>
                <c:pt idx="41">
                  <c:v>3D7|PF08_0106|DBLd1|CIDRb1|0</c:v>
                </c:pt>
                <c:pt idx="42">
                  <c:v>3D7|PF08_0107|DBLd1|CIDRg2|0</c:v>
                </c:pt>
                <c:pt idx="43">
                  <c:v>3D7|PF08_0142|DBLa0.9|CIDRa2.11|0</c:v>
                </c:pt>
                <c:pt idx="44">
                  <c:v>3D7|PF10_0001|DBLd1|CIDRg4|0</c:v>
                </c:pt>
                <c:pt idx="45">
                  <c:v>3D7|PF10_0406|DBLa0.9|CIDRa2.7|0</c:v>
                </c:pt>
                <c:pt idx="46">
                  <c:v>3D7|PF10_0406|DBLd1|CIDRb1|0</c:v>
                </c:pt>
                <c:pt idx="47">
                  <c:v>3D7|PF11_0007|DBLa0.15|CIDRa3.2|0</c:v>
                </c:pt>
                <c:pt idx="48">
                  <c:v>3D7|PF11_0007|DBLd1|CIDRb1|0</c:v>
                </c:pt>
                <c:pt idx="49">
                  <c:v>3D7|PF13_0001|DBLa0.11|CIDRa2.4|0</c:v>
                </c:pt>
                <c:pt idx="50">
                  <c:v>3D7|PF13_0001|DBLd1|CIDRb1|0</c:v>
                </c:pt>
                <c:pt idx="51">
                  <c:v>3D7|PF13_0364|DBLa0.16|CIDRa3.4|0</c:v>
                </c:pt>
                <c:pt idx="52">
                  <c:v>3D7|PF13_0364|DBLd1|CIDRb6|0</c:v>
                </c:pt>
                <c:pt idx="53">
                  <c:v>3D7|PFA0005w|DBLa0.11|CIDRa2.8|0</c:v>
                </c:pt>
                <c:pt idx="54">
                  <c:v>3D7|PFA0005w|DBLd1|CIDRb1|0</c:v>
                </c:pt>
                <c:pt idx="55">
                  <c:v>3D7|PFA0765c|DBLa0.5|CIDRa2.8|0</c:v>
                </c:pt>
                <c:pt idx="56">
                  <c:v>3D7|PFB0010w|DBLa0.7|CIDRa2.2|0</c:v>
                </c:pt>
                <c:pt idx="57">
                  <c:v>3D7|PFB0010w|DBLg11|ATSB1|0</c:v>
                </c:pt>
                <c:pt idx="58">
                  <c:v>3D7|PFB1055c|DBLa0.16|CIDRa3.4|0</c:v>
                </c:pt>
                <c:pt idx="59">
                  <c:v>3D7|PFC1120c|DBLa0.9|CIDRa2.1|0</c:v>
                </c:pt>
                <c:pt idx="60">
                  <c:v>3D7|PFC1120c|DBLd1|CIDRb7|0</c:v>
                </c:pt>
                <c:pt idx="61">
                  <c:v>3D7|PFD0005w|DBLg5|DBLd1|0</c:v>
                </c:pt>
                <c:pt idx="62">
                  <c:v>3D7|PFD0615c|DBLa0.17|CIDRa3.1|0</c:v>
                </c:pt>
                <c:pt idx="63">
                  <c:v>3D7|PFD0615c|DBLd1|CIDRb1|0</c:v>
                </c:pt>
                <c:pt idx="64">
                  <c:v>3D7|PFD0625c|DBLa0.1|CIDRa3.2|0</c:v>
                </c:pt>
                <c:pt idx="65">
                  <c:v>3D7|PFD0630c|DBLa0.1|CIDRa3.1|0</c:v>
                </c:pt>
                <c:pt idx="66">
                  <c:v>3D7|PFD0630c|DBLd1|CIDRg2|0</c:v>
                </c:pt>
                <c:pt idx="67">
                  <c:v>3D7|PFD0635c|DBLa0.1|CIDRa3.1|0</c:v>
                </c:pt>
                <c:pt idx="68">
                  <c:v>3D7|PFD0995c|DBLa0.1|CIDRa3.2|0</c:v>
                </c:pt>
                <c:pt idx="69">
                  <c:v>3D7|PFD0995c|DBLd1|CIDRg6|0</c:v>
                </c:pt>
                <c:pt idx="70">
                  <c:v>3D7|PFD1005c|DBLa0.8|CIDRa4|0</c:v>
                </c:pt>
                <c:pt idx="71">
                  <c:v>3D7|PFD1005c|DBLd1|CIDRg11|0</c:v>
                </c:pt>
                <c:pt idx="72">
                  <c:v>3D7|PFD1015c|DBLa0.24|CIDRa3.4|0</c:v>
                </c:pt>
                <c:pt idx="73">
                  <c:v>3D7|PFD1015c|DBLd1|CIDRb1|0</c:v>
                </c:pt>
                <c:pt idx="74">
                  <c:v>3D7|PFD1245c|DBLa0.14|CIDRa4|0</c:v>
                </c:pt>
                <c:pt idx="75">
                  <c:v>3D7|PFD1245c|DBLd1|CIDRb1|0</c:v>
                </c:pt>
                <c:pt idx="76">
                  <c:v>3D7|PFE0005w|DBLd1|CIDRb1|0</c:v>
                </c:pt>
                <c:pt idx="77">
                  <c:v>3D7|PFI0005w|DBLd1|CIDRg12|0</c:v>
                </c:pt>
                <c:pt idx="78">
                  <c:v>3D7|PFL0005w|DBLa0.9|CIDRa2.2|0</c:v>
                </c:pt>
                <c:pt idx="79">
                  <c:v>3D7|PFL0005w|DBLd1|CIDRb1|0</c:v>
                </c:pt>
                <c:pt idx="80">
                  <c:v>3D7|PFL0020w|DBLg14|DBLz5|0</c:v>
                </c:pt>
                <c:pt idx="81">
                  <c:v>3D7|PFL0020w|DBLz5|DBLe4|0</c:v>
                </c:pt>
                <c:pt idx="82">
                  <c:v>3D7|PFL0935c|DBLa0.16|CIDRa3.4|0</c:v>
                </c:pt>
                <c:pt idx="83">
                  <c:v>3D7|PFL0935c|DBLd1|CIDRg12|0</c:v>
                </c:pt>
                <c:pt idx="84">
                  <c:v>3D7|PFL1950w|DBLa0.7|CIDRa4|0</c:v>
                </c:pt>
                <c:pt idx="85">
                  <c:v>3D7|PFL1950w|DBLd1|CIDRb1|0</c:v>
                </c:pt>
                <c:pt idx="86">
                  <c:v>3D7|PFL1955w|DBLa0.16|CIDRa3.4|0</c:v>
                </c:pt>
                <c:pt idx="87">
                  <c:v>3D7|PFL1955w|DBLd1|CIDRb1|0</c:v>
                </c:pt>
                <c:pt idx="88">
                  <c:v>3D7|PFL1960w|DBLa0.20|CIDRa3.1|0</c:v>
                </c:pt>
                <c:pt idx="89">
                  <c:v>3D7|PFL1960w|DBLd1|CIDRb1|0</c:v>
                </c:pt>
                <c:pt idx="90">
                  <c:v>3D7|PFL2665c|DBLa0.19|CIDRa2.3|0</c:v>
                </c:pt>
                <c:pt idx="91">
                  <c:v>3D7|PFL2665c|DBLd1|CIDRb1|0</c:v>
                </c:pt>
                <c:pt idx="93">
                  <c:v>3D7|MAL6P1.316|DBLa2|CIDRa1.8|0</c:v>
                </c:pt>
                <c:pt idx="94">
                  <c:v>3D7|MAL6P1.316|DBLb12|DBLg4|0</c:v>
                </c:pt>
                <c:pt idx="95">
                  <c:v>3D7|MAL6P1.316|DBLz3|DBLe12|0</c:v>
                </c:pt>
                <c:pt idx="96">
                  <c:v>3D7|PF08_0140|CIDRa1.6|DBLb12|DBLg4</c:v>
                </c:pt>
                <c:pt idx="97">
                  <c:v>3D7|PF08_0140|DBLa2|CIDRa1.6|0</c:v>
                </c:pt>
                <c:pt idx="98">
                  <c:v>3D7|PF08_0140|DBLa2|CIDRa1.6|DBLb12</c:v>
                </c:pt>
                <c:pt idx="99">
                  <c:v>3D7|PF08_0140|DBLb12|DBLg4|0</c:v>
                </c:pt>
                <c:pt idx="100">
                  <c:v>3D7|PF08_0140|DBLd1|CIDRb1|0</c:v>
                </c:pt>
                <c:pt idx="101">
                  <c:v>3D7|PF08_0141|DBLa1.6|CIDRd2|0</c:v>
                </c:pt>
                <c:pt idx="102">
                  <c:v>3D7|PF08_0141|DBLg14|DBLz5|0</c:v>
                </c:pt>
                <c:pt idx="103">
                  <c:v>3D7|PF08_0141|DBLz5|DBLe4|0</c:v>
                </c:pt>
                <c:pt idx="104">
                  <c:v>3D7|PF08_0141e1s1|PfEMP1 - Extracellular - non-CD36-binding</c:v>
                </c:pt>
                <c:pt idx="105">
                  <c:v>3D7|PF08_0141e1s2|PfEMP1 - Extracellular - non-CD36-binding</c:v>
                </c:pt>
                <c:pt idx="106">
                  <c:v>3D7|PF08_0141e1s3|PfEMP1 - Extracellular - non-CD36-binding</c:v>
                </c:pt>
                <c:pt idx="107">
                  <c:v>3D7|PF11_0008|DBLa1.5|CIDRg3|0</c:v>
                </c:pt>
                <c:pt idx="108">
                  <c:v>3D7|PF11_0008|DBLg12|DBLd5|0</c:v>
                </c:pt>
                <c:pt idx="109">
                  <c:v>3D7|PF11_0008e1s1|PfEMP1 - Extracellular - non-CD36-binding</c:v>
                </c:pt>
                <c:pt idx="110">
                  <c:v>3D7|PF11_0008e1s2|PfEMP1 - Extracellular - non-CD36-binding</c:v>
                </c:pt>
                <c:pt idx="111">
                  <c:v>3D7|PF11_0008e1s3|PfEMP1 - Extracellular - non-CD36-binding</c:v>
                </c:pt>
                <c:pt idx="112">
                  <c:v>3D7|PF11_0521|DBLb3|DBLb6|0</c:v>
                </c:pt>
                <c:pt idx="113">
                  <c:v>3D7|PF11_0521|DBLb6|DBLd3|0</c:v>
                </c:pt>
                <c:pt idx="114">
                  <c:v>3D7|PF13_0003|DBLa1.6|CIDRd1|0</c:v>
                </c:pt>
                <c:pt idx="115">
                  <c:v>3D7|PF13_0003|DBLb3|DBLg12|0</c:v>
                </c:pt>
                <c:pt idx="116">
                  <c:v>3D7|PF13_0003|DBLd5|CIDRb3|0</c:v>
                </c:pt>
                <c:pt idx="117">
                  <c:v>3D7|PF13_0003|DBLg12|DBLd5|0</c:v>
                </c:pt>
                <c:pt idx="118">
                  <c:v>3D7|PFA0015c|DBLa1.3|DBLe8|0</c:v>
                </c:pt>
                <c:pt idx="119">
                  <c:v>3D7|PFD0020c|DBLa1.2|CIDRa1.1|0</c:v>
                </c:pt>
                <c:pt idx="120">
                  <c:v>3D7|PFD0020c|DBLb12|DBLg6|0</c:v>
                </c:pt>
                <c:pt idx="121">
                  <c:v>3D7|PFD0020c|DBLd1|CIDRg8|0</c:v>
                </c:pt>
                <c:pt idx="122">
                  <c:v>3D7|PFD0020c|DBLg6|DBLg11|0</c:v>
                </c:pt>
                <c:pt idx="123">
                  <c:v>3D7|PFD1235w|DBLa1.4|CIDRa1.6|0</c:v>
                </c:pt>
                <c:pt idx="124">
                  <c:v>3D7|PFD1235w|DBLb3|DBLb3|0</c:v>
                </c:pt>
                <c:pt idx="125">
                  <c:v>3D7|PFD1235w|DBLb3|DBLg13|0</c:v>
                </c:pt>
                <c:pt idx="126">
                  <c:v>3D7|PFD1235w|DBLd1|CIDRb5|0</c:v>
                </c:pt>
                <c:pt idx="127">
                  <c:v>3D7|PFD1235w|DBLg13|DBLd1|0</c:v>
                </c:pt>
                <c:pt idx="128">
                  <c:v>3D7|PFE1640w|DBLb1|DBLg15|0</c:v>
                </c:pt>
                <c:pt idx="129">
                  <c:v>3D7|PFE1640w|DBLe1|DBLg8|0</c:v>
                </c:pt>
                <c:pt idx="130">
                  <c:v>3D7|PFE1640w|DBLg15|DBLe1|0</c:v>
                </c:pt>
                <c:pt idx="131">
                  <c:v>3D7|PFE1640w|DBLg8|DBLz1|0</c:v>
                </c:pt>
                <c:pt idx="132">
                  <c:v>3D7|PFE1640w|DBLz1|DBLe5|0</c:v>
                </c:pt>
                <c:pt idx="133">
                  <c:v>3D7|PFF0020c|DBLa1.3|DBLe8|0</c:v>
                </c:pt>
                <c:pt idx="134">
                  <c:v>3D7|PFI1820w|DBLa1.3|DBLe8|0</c:v>
                </c:pt>
                <c:pt idx="135">
                  <c:v>3D7|PFL0020w|DBLa0.18|CIDRa5|0</c:v>
                </c:pt>
                <c:pt idx="136">
                  <c:v>3D7|PFL0020w|DBLb5|DBLg14|0</c:v>
                </c:pt>
                <c:pt idx="137">
                  <c:v>3D7|PFL0030c|DBLepam4|DBLepam5|0</c:v>
                </c:pt>
                <c:pt idx="138">
                  <c:v>3D7|PFL0030c|DBLepam5|DBLe10|0</c:v>
                </c:pt>
                <c:pt idx="139">
                  <c:v>3D7|PFL0030c|DBLpam1|DBLpam2|0</c:v>
                </c:pt>
                <c:pt idx="140">
                  <c:v>3D7|PFL0030c|DBLpam2|CIDRpam|0</c:v>
                </c:pt>
                <c:pt idx="141">
                  <c:v>3D7|PFL0030c|DBLpam3|DBLepam4|0</c:v>
                </c:pt>
                <c:pt idx="143">
                  <c:v>3D7|MAL6P1.252-e2|PfEMP1 - Intracellular</c:v>
                </c:pt>
                <c:pt idx="144">
                  <c:v>3D7|MAL7P1.55|ATSB13|0|0</c:v>
                </c:pt>
                <c:pt idx="145">
                  <c:v>3D7|MAL8P1.220|ATSB1|0|0</c:v>
                </c:pt>
                <c:pt idx="146">
                  <c:v>3D7|PF07_0048|ATSB7|0|0</c:v>
                </c:pt>
                <c:pt idx="147">
                  <c:v>3D7|PF07_0048e2s1|PfEMP1 - Intracellular</c:v>
                </c:pt>
                <c:pt idx="148">
                  <c:v>3D7|PF08_0107|ATSB2|0|0</c:v>
                </c:pt>
                <c:pt idx="149">
                  <c:v>3D7|PF08_0140e2s1|PfEMP1 - Intracellular</c:v>
                </c:pt>
                <c:pt idx="150">
                  <c:v>3D7|PF08_0141|ATSA3|0|0</c:v>
                </c:pt>
                <c:pt idx="151">
                  <c:v>3D7|PF08_0141e2s1|PfEMP1 - Intracellular</c:v>
                </c:pt>
                <c:pt idx="152">
                  <c:v>3D7|PF10_0001|ATSB1|0|0</c:v>
                </c:pt>
                <c:pt idx="153">
                  <c:v>3D7|PF10_0406|ATSB1|0|0</c:v>
                </c:pt>
                <c:pt idx="154">
                  <c:v>3D7|PF11_0008e2s1|PfEMP1 - Intracellular</c:v>
                </c:pt>
                <c:pt idx="155">
                  <c:v>3D7|PF11_0521|ATSA2|0|0</c:v>
                </c:pt>
                <c:pt idx="156">
                  <c:v>3D7|PF11_0521|PfEMP1 - Intracellular</c:v>
                </c:pt>
                <c:pt idx="157">
                  <c:v>3D7|PF13_0003|ATSA2|0|0</c:v>
                </c:pt>
                <c:pt idx="158">
                  <c:v>3D7|PFC0005w|ATSB1|0|0</c:v>
                </c:pt>
                <c:pt idx="159">
                  <c:v>3D7|PFD0995ce2s1|PfEMP1 - Intracellular</c:v>
                </c:pt>
                <c:pt idx="160">
                  <c:v>3D7|PFD1000c|ATSB19|0|0</c:v>
                </c:pt>
                <c:pt idx="161">
                  <c:v>3D7|PFD1235w|ATSA2|0|0</c:v>
                </c:pt>
                <c:pt idx="162">
                  <c:v>3D7|PFL1955w|ATSB7|0|0</c:v>
                </c:pt>
                <c:pt idx="164">
                  <c:v>3D7|AMA1</c:v>
                </c:pt>
                <c:pt idx="165">
                  <c:v>3D7|MSP1 - segment 1</c:v>
                </c:pt>
                <c:pt idx="166">
                  <c:v>3D7|MSP1 - segment 2</c:v>
                </c:pt>
                <c:pt idx="168">
                  <c:v>3D7|PF07_0049</c:v>
                </c:pt>
                <c:pt idx="169">
                  <c:v>3D7|PF08_0140</c:v>
                </c:pt>
                <c:pt idx="170">
                  <c:v>3D7|PF11_0007</c:v>
                </c:pt>
                <c:pt idx="171">
                  <c:v>3D7|PF11_0521PF11_0521_1|DBL|CIDR|0</c:v>
                </c:pt>
                <c:pt idx="173">
                  <c:v>3D7|rifin|||</c:v>
                </c:pt>
                <c:pt idx="174">
                  <c:v>3D7|rifin|||</c:v>
                </c:pt>
                <c:pt idx="176">
                  <c:v>3D7|stevor|||</c:v>
                </c:pt>
                <c:pt idx="177">
                  <c:v>3D7|stevor|||</c:v>
                </c:pt>
                <c:pt idx="178">
                  <c:v>3D7|stevor|||</c:v>
                </c:pt>
                <c:pt idx="179">
                  <c:v>3D7|stevor-1|||</c:v>
                </c:pt>
                <c:pt idx="180">
                  <c:v>3D7|stevor-1|||</c:v>
                </c:pt>
                <c:pt idx="181">
                  <c:v>3D7|stevor-2|||</c:v>
                </c:pt>
                <c:pt idx="182">
                  <c:v>3D7|stevor-2|||</c:v>
                </c:pt>
                <c:pt idx="184">
                  <c:v>DD2var43|ATSA4|0|0</c:v>
                </c:pt>
                <c:pt idx="185">
                  <c:v>DD2var43|CIDRa1.5|DBLg17|0</c:v>
                </c:pt>
                <c:pt idx="186">
                  <c:v>DD2var43|CIDRb3|DBLb7|0</c:v>
                </c:pt>
                <c:pt idx="187">
                  <c:v>DD2var43|DBLa1.2|CIDRa1.5|0</c:v>
                </c:pt>
                <c:pt idx="188">
                  <c:v>DD2var43|DBLb7|DBLg9|0</c:v>
                </c:pt>
                <c:pt idx="189">
                  <c:v>DD2var43|DBLd5|CIDRb3|0</c:v>
                </c:pt>
                <c:pt idx="190">
                  <c:v>DD2var43|DBLg17|DBLd5|0</c:v>
                </c:pt>
                <c:pt idx="191">
                  <c:v>DD2var49|CIDRa1.7|DBLb3|0</c:v>
                </c:pt>
                <c:pt idx="192">
                  <c:v>DD2var49|CIDRg2|DBLg17|0</c:v>
                </c:pt>
                <c:pt idx="193">
                  <c:v>DD2var49|DBLb3|DBLg11|0</c:v>
                </c:pt>
                <c:pt idx="194">
                  <c:v>DD2var49|DBLg17|DBLz4|0</c:v>
                </c:pt>
                <c:pt idx="195">
                  <c:v>DD2var49|NTSA8|DBLa1.2|CIDRa1.7</c:v>
                </c:pt>
                <c:pt idx="196">
                  <c:v>HB3var03|CIDRa1.4|DBLb3|0</c:v>
                </c:pt>
                <c:pt idx="197">
                  <c:v>HB3var03|CIDRb3|DBLb7|0</c:v>
                </c:pt>
                <c:pt idx="198">
                  <c:v>HB3var03|DBLb3|DBLg12|0</c:v>
                </c:pt>
                <c:pt idx="199">
                  <c:v>HB3var05|ATSA2|0|0</c:v>
                </c:pt>
                <c:pt idx="200">
                  <c:v>HB3var1csa|ATS|0|0</c:v>
                </c:pt>
                <c:pt idx="201">
                  <c:v>HB3var1csa|CIDRa|DBLb|0</c:v>
                </c:pt>
                <c:pt idx="202">
                  <c:v>HB3var1csa|DBLa|CIDRa|0</c:v>
                </c:pt>
                <c:pt idx="203">
                  <c:v>HB3var1csa|DBLb|DBLg|0</c:v>
                </c:pt>
                <c:pt idx="204">
                  <c:v>HB3var1csa|DBLe|DBLg|0</c:v>
                </c:pt>
                <c:pt idx="205">
                  <c:v>HB3var1csa|DBLg|DBLe|0</c:v>
                </c:pt>
                <c:pt idx="206">
                  <c:v>HB3var1csa|DBLg|DBLz|0</c:v>
                </c:pt>
                <c:pt idx="207">
                  <c:v>HB3var1csa|DBLz|DBLe|0</c:v>
                </c:pt>
                <c:pt idx="208">
                  <c:v>IGHvar14|ATS|0|0</c:v>
                </c:pt>
                <c:pt idx="209">
                  <c:v>IGHvar14|CIDRa|DBLb|0</c:v>
                </c:pt>
                <c:pt idx="210">
                  <c:v>IGHvar14|DBLa|CIDRa|0</c:v>
                </c:pt>
                <c:pt idx="211">
                  <c:v>IGHvar14|DBLb|DBLg|0</c:v>
                </c:pt>
                <c:pt idx="212">
                  <c:v>IGHvar14|DBLe|DBLe|0</c:v>
                </c:pt>
                <c:pt idx="213">
                  <c:v>IGHvar14|DBLg|DBLe|0</c:v>
                </c:pt>
                <c:pt idx="214">
                  <c:v>IGHvar23|ATS|0|0</c:v>
                </c:pt>
                <c:pt idx="215">
                  <c:v>IGHvar23|CIDRa|DBLb|0</c:v>
                </c:pt>
                <c:pt idx="216">
                  <c:v>IGHvar23|DBLa|CIDRa|0</c:v>
                </c:pt>
                <c:pt idx="217">
                  <c:v>IGHvar23|DBLb|DBLg|0</c:v>
                </c:pt>
                <c:pt idx="218">
                  <c:v>IGHvar23|DBLd|CIDRb|0</c:v>
                </c:pt>
                <c:pt idx="219">
                  <c:v>IGHvar23|DBLg|DBLd|0</c:v>
                </c:pt>
                <c:pt idx="220">
                  <c:v>IGHvar23|DBLg|DBLg|0</c:v>
                </c:pt>
                <c:pt idx="221">
                  <c:v>IT4var06|ATS|0|0</c:v>
                </c:pt>
                <c:pt idx="222">
                  <c:v>IT4var06|CIDRa|DBLb|0</c:v>
                </c:pt>
                <c:pt idx="223">
                  <c:v>IT4var06|DBLa|CIDRa|0</c:v>
                </c:pt>
                <c:pt idx="224">
                  <c:v>IT4var06|DBLb|DBLg|0</c:v>
                </c:pt>
                <c:pt idx="225">
                  <c:v>IT4var06|DBLd|0|0</c:v>
                </c:pt>
                <c:pt idx="226">
                  <c:v>IT4var06|DBLd|CIDRb|0</c:v>
                </c:pt>
                <c:pt idx="227">
                  <c:v>IT4var07|CIDRa1.4|DBLb1|0</c:v>
                </c:pt>
                <c:pt idx="228">
                  <c:v>IT4var07|DBLb1|DBLb3|0</c:v>
                </c:pt>
                <c:pt idx="229">
                  <c:v>IT4var07|DBLb3|DBLg10|0</c:v>
                </c:pt>
                <c:pt idx="230">
                  <c:v>IT4var07|DBLd1|CIDRb1|0</c:v>
                </c:pt>
                <c:pt idx="231">
                  <c:v>IT4var07|NTSA6|DBLa1.7|CIDRa1.4</c:v>
                </c:pt>
                <c:pt idx="232">
                  <c:v>IT4var19|ATSB3|0|0</c:v>
                </c:pt>
                <c:pt idx="233">
                  <c:v>IT4var19|CIDRa1.1|DBLb12|0</c:v>
                </c:pt>
                <c:pt idx="234">
                  <c:v>IT4var19|CIDRb1|DBLg9|0</c:v>
                </c:pt>
                <c:pt idx="235">
                  <c:v>IT4var19|DBLb12|DBLg6|0</c:v>
                </c:pt>
                <c:pt idx="236">
                  <c:v>IT4var19|DBLd1|CIDRb1|0</c:v>
                </c:pt>
                <c:pt idx="237">
                  <c:v>IT4var19|DBLg6|DBLd1|0</c:v>
                </c:pt>
                <c:pt idx="238">
                  <c:v>IT4var20|ATSB16|0|0</c:v>
                </c:pt>
                <c:pt idx="239">
                  <c:v>IT4var20|CIDRa1.1|DBLb12|0</c:v>
                </c:pt>
                <c:pt idx="240">
                  <c:v>IT4var20|DBLb12|DBLg6|0</c:v>
                </c:pt>
                <c:pt idx="241">
                  <c:v>IT4var20|DBLd1|CIDRb1|0</c:v>
                </c:pt>
                <c:pt idx="242">
                  <c:v>IT4var20|DBLg6|DBLd1|0</c:v>
                </c:pt>
                <c:pt idx="243">
                  <c:v>IT4var20|NTSB3|DBLa2|CIDRa1.1</c:v>
                </c:pt>
                <c:pt idx="244">
                  <c:v>IT4var22|CIDRa1.7|DBLb3|0</c:v>
                </c:pt>
                <c:pt idx="245">
                  <c:v>IT4var22|DBLa1.4|CIDRa1.7|0</c:v>
                </c:pt>
                <c:pt idx="246">
                  <c:v>IT4var22|DBLb3|DBLg10|0</c:v>
                </c:pt>
                <c:pt idx="247">
                  <c:v>IT4var22|DBLd1|CIDRb1|0</c:v>
                </c:pt>
                <c:pt idx="248">
                  <c:v>IT4var22|DBLg10|DBLg11|0</c:v>
                </c:pt>
                <c:pt idx="249">
                  <c:v>IT4var22|DBLg11|DBLd1|0</c:v>
                </c:pt>
                <c:pt idx="250">
                  <c:v>IT4var22|NTSA2|DBLa1.4|CIDRa1.7</c:v>
                </c:pt>
                <c:pt idx="251">
                  <c:v>MaliRF327|CIDRa|DBLb|0</c:v>
                </c:pt>
                <c:pt idx="252">
                  <c:v>MaliRF327|DBLa|CIDRa|0</c:v>
                </c:pt>
                <c:pt idx="253">
                  <c:v>MaliRF327|DBLb|DBLg|0</c:v>
                </c:pt>
                <c:pt idx="254">
                  <c:v>MaliRF327|DBLd|CIDRb|0</c:v>
                </c:pt>
                <c:pt idx="255">
                  <c:v>MaliRF327|DBLg|DBLd|0</c:v>
                </c:pt>
                <c:pt idx="256">
                  <c:v>MaliRF327|DBLg|DBLg|0</c:v>
                </c:pt>
                <c:pt idx="257">
                  <c:v>MaliRF398|CIDRa|DBLb|0</c:v>
                </c:pt>
                <c:pt idx="258">
                  <c:v>MaliRF398|DBLa|CIDRa|0</c:v>
                </c:pt>
                <c:pt idx="259">
                  <c:v>MaliRF398|DBLb|DBLg|0</c:v>
                </c:pt>
                <c:pt idx="260">
                  <c:v>MaliRF398|DBLg|DBLz|0</c:v>
                </c:pt>
                <c:pt idx="261">
                  <c:v>MaliRF398|DBLz|DBLe|0</c:v>
                </c:pt>
                <c:pt idx="264">
                  <c:v>Tetanus toxin_0.01</c:v>
                </c:pt>
                <c:pt idx="265">
                  <c:v>Tetanus toxin_0.03</c:v>
                </c:pt>
                <c:pt idx="266">
                  <c:v>Tetanus toxin_0.1</c:v>
                </c:pt>
              </c:strCache>
            </c:strRef>
          </c:cat>
          <c:val>
            <c:numRef>
              <c:f>'Final_Analysis1 (4)'!$BI$6:$BI$272</c:f>
              <c:numCache>
                <c:formatCode>General</c:formatCode>
                <c:ptCount val="267"/>
                <c:pt idx="0">
                  <c:v>22.222222222222221</c:v>
                </c:pt>
                <c:pt idx="1">
                  <c:v>33.333333333333336</c:v>
                </c:pt>
                <c:pt idx="2">
                  <c:v>22.222222222222221</c:v>
                </c:pt>
                <c:pt idx="3">
                  <c:v>33.333333333333336</c:v>
                </c:pt>
                <c:pt idx="4">
                  <c:v>0</c:v>
                </c:pt>
                <c:pt idx="5">
                  <c:v>22.222222222222221</c:v>
                </c:pt>
                <c:pt idx="6">
                  <c:v>33.333333333333336</c:v>
                </c:pt>
                <c:pt idx="7">
                  <c:v>22.222222222222221</c:v>
                </c:pt>
                <c:pt idx="8">
                  <c:v>22.222222222222221</c:v>
                </c:pt>
                <c:pt idx="9">
                  <c:v>11.111111111111111</c:v>
                </c:pt>
                <c:pt idx="10">
                  <c:v>33.333333333333336</c:v>
                </c:pt>
                <c:pt idx="11">
                  <c:v>11.111111111111111</c:v>
                </c:pt>
                <c:pt idx="12">
                  <c:v>11.111111111111111</c:v>
                </c:pt>
                <c:pt idx="13">
                  <c:v>22.222222222222221</c:v>
                </c:pt>
                <c:pt idx="14">
                  <c:v>0</c:v>
                </c:pt>
                <c:pt idx="15">
                  <c:v>22.222222222222221</c:v>
                </c:pt>
                <c:pt idx="16">
                  <c:v>33.333333333333336</c:v>
                </c:pt>
                <c:pt idx="17">
                  <c:v>33.333333333333336</c:v>
                </c:pt>
                <c:pt idx="18">
                  <c:v>44.444444444444443</c:v>
                </c:pt>
                <c:pt idx="19">
                  <c:v>22.222222222222221</c:v>
                </c:pt>
                <c:pt idx="20">
                  <c:v>55.555555555555557</c:v>
                </c:pt>
                <c:pt idx="21">
                  <c:v>33.333333333333336</c:v>
                </c:pt>
                <c:pt idx="22">
                  <c:v>44.444444444444443</c:v>
                </c:pt>
                <c:pt idx="23">
                  <c:v>44.444444444444443</c:v>
                </c:pt>
                <c:pt idx="24">
                  <c:v>11.111111111111111</c:v>
                </c:pt>
                <c:pt idx="25">
                  <c:v>22.222222222222221</c:v>
                </c:pt>
                <c:pt idx="26">
                  <c:v>33.333333333333336</c:v>
                </c:pt>
                <c:pt idx="27">
                  <c:v>33.333333333333336</c:v>
                </c:pt>
                <c:pt idx="28">
                  <c:v>22.222222222222221</c:v>
                </c:pt>
                <c:pt idx="29">
                  <c:v>44.444444444444443</c:v>
                </c:pt>
                <c:pt idx="30">
                  <c:v>33.333333333333336</c:v>
                </c:pt>
                <c:pt idx="31">
                  <c:v>22.222222222222221</c:v>
                </c:pt>
                <c:pt idx="32">
                  <c:v>33.333333333333336</c:v>
                </c:pt>
                <c:pt idx="33">
                  <c:v>55.555555555555557</c:v>
                </c:pt>
                <c:pt idx="34">
                  <c:v>0</c:v>
                </c:pt>
                <c:pt idx="35">
                  <c:v>55.555555555555557</c:v>
                </c:pt>
                <c:pt idx="36">
                  <c:v>33.333333333333336</c:v>
                </c:pt>
                <c:pt idx="37">
                  <c:v>33.333333333333336</c:v>
                </c:pt>
                <c:pt idx="38">
                  <c:v>33.333333333333336</c:v>
                </c:pt>
                <c:pt idx="39">
                  <c:v>33.333333333333336</c:v>
                </c:pt>
                <c:pt idx="40">
                  <c:v>11.111111111111111</c:v>
                </c:pt>
                <c:pt idx="41">
                  <c:v>55.555555555555557</c:v>
                </c:pt>
                <c:pt idx="42">
                  <c:v>55.555555555555557</c:v>
                </c:pt>
                <c:pt idx="43">
                  <c:v>0</c:v>
                </c:pt>
                <c:pt idx="44">
                  <c:v>44.444444444444443</c:v>
                </c:pt>
                <c:pt idx="45">
                  <c:v>22.222222222222221</c:v>
                </c:pt>
                <c:pt idx="46">
                  <c:v>33.333333333333336</c:v>
                </c:pt>
                <c:pt idx="47">
                  <c:v>33.333333333333336</c:v>
                </c:pt>
                <c:pt idx="48">
                  <c:v>33.333333333333336</c:v>
                </c:pt>
                <c:pt idx="49">
                  <c:v>22.222222222222221</c:v>
                </c:pt>
                <c:pt idx="50">
                  <c:v>44.444444444444443</c:v>
                </c:pt>
                <c:pt idx="51">
                  <c:v>44.444444444444443</c:v>
                </c:pt>
                <c:pt idx="52">
                  <c:v>44.444444444444443</c:v>
                </c:pt>
                <c:pt idx="53">
                  <c:v>11.111111111111111</c:v>
                </c:pt>
                <c:pt idx="54">
                  <c:v>44.444444444444443</c:v>
                </c:pt>
                <c:pt idx="55">
                  <c:v>33.333333333333336</c:v>
                </c:pt>
                <c:pt idx="56">
                  <c:v>33.333333333333336</c:v>
                </c:pt>
                <c:pt idx="57">
                  <c:v>55.555555555555557</c:v>
                </c:pt>
                <c:pt idx="58">
                  <c:v>33.333333333333336</c:v>
                </c:pt>
                <c:pt idx="59">
                  <c:v>22.222222222222221</c:v>
                </c:pt>
                <c:pt idx="60">
                  <c:v>33.333333333333336</c:v>
                </c:pt>
                <c:pt idx="61">
                  <c:v>55.555555555555557</c:v>
                </c:pt>
                <c:pt idx="62">
                  <c:v>33.333333333333336</c:v>
                </c:pt>
                <c:pt idx="63">
                  <c:v>33.333333333333336</c:v>
                </c:pt>
                <c:pt idx="64">
                  <c:v>22.222222222222221</c:v>
                </c:pt>
                <c:pt idx="65">
                  <c:v>11.111111111111111</c:v>
                </c:pt>
                <c:pt idx="66">
                  <c:v>55.555555555555557</c:v>
                </c:pt>
                <c:pt idx="67">
                  <c:v>22.222222222222221</c:v>
                </c:pt>
                <c:pt idx="68">
                  <c:v>55.555555555555557</c:v>
                </c:pt>
                <c:pt idx="69">
                  <c:v>33.333333333333336</c:v>
                </c:pt>
                <c:pt idx="70">
                  <c:v>11.111111111111111</c:v>
                </c:pt>
                <c:pt idx="71">
                  <c:v>0</c:v>
                </c:pt>
                <c:pt idx="72">
                  <c:v>22.222222222222221</c:v>
                </c:pt>
                <c:pt idx="73">
                  <c:v>55.555555555555557</c:v>
                </c:pt>
                <c:pt idx="74">
                  <c:v>33.333333333333336</c:v>
                </c:pt>
                <c:pt idx="75">
                  <c:v>33.333333333333336</c:v>
                </c:pt>
                <c:pt idx="76">
                  <c:v>55.555555555555557</c:v>
                </c:pt>
                <c:pt idx="77">
                  <c:v>22.222222222222221</c:v>
                </c:pt>
                <c:pt idx="78">
                  <c:v>0</c:v>
                </c:pt>
                <c:pt idx="79">
                  <c:v>33.333333333333336</c:v>
                </c:pt>
                <c:pt idx="80">
                  <c:v>44.444444444444443</c:v>
                </c:pt>
                <c:pt idx="81">
                  <c:v>11.111111111111111</c:v>
                </c:pt>
                <c:pt idx="82">
                  <c:v>11.111111111111111</c:v>
                </c:pt>
                <c:pt idx="83">
                  <c:v>22.222222222222221</c:v>
                </c:pt>
                <c:pt idx="84">
                  <c:v>33.333333333333336</c:v>
                </c:pt>
                <c:pt idx="85">
                  <c:v>22.222222222222221</c:v>
                </c:pt>
                <c:pt idx="86">
                  <c:v>44.444444444444443</c:v>
                </c:pt>
                <c:pt idx="87">
                  <c:v>55.555555555555557</c:v>
                </c:pt>
                <c:pt idx="88">
                  <c:v>33.333333333333336</c:v>
                </c:pt>
                <c:pt idx="89">
                  <c:v>33.333333333333336</c:v>
                </c:pt>
                <c:pt idx="90">
                  <c:v>55.555555555555557</c:v>
                </c:pt>
                <c:pt idx="91">
                  <c:v>33.333333333333336</c:v>
                </c:pt>
                <c:pt idx="92">
                  <c:v>0</c:v>
                </c:pt>
                <c:pt idx="93">
                  <c:v>33.333333333333336</c:v>
                </c:pt>
                <c:pt idx="94">
                  <c:v>44.444444444444443</c:v>
                </c:pt>
                <c:pt idx="95">
                  <c:v>44.444444444444443</c:v>
                </c:pt>
                <c:pt idx="96">
                  <c:v>44.444444444444443</c:v>
                </c:pt>
                <c:pt idx="97">
                  <c:v>22.222222222222221</c:v>
                </c:pt>
                <c:pt idx="98">
                  <c:v>33.333333333333336</c:v>
                </c:pt>
                <c:pt idx="99">
                  <c:v>66.666666666666671</c:v>
                </c:pt>
                <c:pt idx="100">
                  <c:v>55.555555555555557</c:v>
                </c:pt>
                <c:pt idx="101">
                  <c:v>44.444444444444443</c:v>
                </c:pt>
                <c:pt idx="102">
                  <c:v>44.444444444444443</c:v>
                </c:pt>
                <c:pt idx="103">
                  <c:v>33.333333333333336</c:v>
                </c:pt>
                <c:pt idx="104">
                  <c:v>44.444444444444443</c:v>
                </c:pt>
                <c:pt idx="105">
                  <c:v>55.555555555555557</c:v>
                </c:pt>
                <c:pt idx="106">
                  <c:v>44.444444444444443</c:v>
                </c:pt>
                <c:pt idx="107">
                  <c:v>33.333333333333336</c:v>
                </c:pt>
                <c:pt idx="108">
                  <c:v>44.444444444444443</c:v>
                </c:pt>
                <c:pt idx="109">
                  <c:v>66.666666666666671</c:v>
                </c:pt>
                <c:pt idx="110">
                  <c:v>55.555555555555557</c:v>
                </c:pt>
                <c:pt idx="111">
                  <c:v>55.555555555555557</c:v>
                </c:pt>
                <c:pt idx="112">
                  <c:v>44.444444444444443</c:v>
                </c:pt>
                <c:pt idx="113">
                  <c:v>44.444444444444443</c:v>
                </c:pt>
                <c:pt idx="114">
                  <c:v>44.444444444444443</c:v>
                </c:pt>
                <c:pt idx="115">
                  <c:v>11.111111111111111</c:v>
                </c:pt>
                <c:pt idx="116">
                  <c:v>55.555555555555557</c:v>
                </c:pt>
                <c:pt idx="117">
                  <c:v>55.555555555555557</c:v>
                </c:pt>
                <c:pt idx="118">
                  <c:v>55.555555555555557</c:v>
                </c:pt>
                <c:pt idx="119">
                  <c:v>44.444444444444443</c:v>
                </c:pt>
                <c:pt idx="120">
                  <c:v>55.555555555555557</c:v>
                </c:pt>
                <c:pt idx="121">
                  <c:v>44.444444444444443</c:v>
                </c:pt>
                <c:pt idx="122">
                  <c:v>66.666666666666671</c:v>
                </c:pt>
                <c:pt idx="123">
                  <c:v>44.444444444444443</c:v>
                </c:pt>
                <c:pt idx="124">
                  <c:v>55.555555555555557</c:v>
                </c:pt>
                <c:pt idx="125">
                  <c:v>55.555555555555557</c:v>
                </c:pt>
                <c:pt idx="126">
                  <c:v>55.555555555555557</c:v>
                </c:pt>
                <c:pt idx="127">
                  <c:v>33.333333333333336</c:v>
                </c:pt>
                <c:pt idx="128">
                  <c:v>22.222222222222221</c:v>
                </c:pt>
                <c:pt idx="129">
                  <c:v>33.333333333333336</c:v>
                </c:pt>
                <c:pt idx="130">
                  <c:v>22.222222222222221</c:v>
                </c:pt>
                <c:pt idx="131">
                  <c:v>11.111111111111111</c:v>
                </c:pt>
                <c:pt idx="132">
                  <c:v>22.222222222222221</c:v>
                </c:pt>
                <c:pt idx="133">
                  <c:v>33.333333333333336</c:v>
                </c:pt>
                <c:pt idx="134">
                  <c:v>33.333333333333336</c:v>
                </c:pt>
                <c:pt idx="135">
                  <c:v>33.333333333333336</c:v>
                </c:pt>
                <c:pt idx="136">
                  <c:v>55.555555555555557</c:v>
                </c:pt>
                <c:pt idx="137">
                  <c:v>33.333333333333336</c:v>
                </c:pt>
                <c:pt idx="138">
                  <c:v>33.333333333333336</c:v>
                </c:pt>
                <c:pt idx="139">
                  <c:v>22.222222222222221</c:v>
                </c:pt>
                <c:pt idx="140">
                  <c:v>22.222222222222221</c:v>
                </c:pt>
                <c:pt idx="141">
                  <c:v>22.222222222222221</c:v>
                </c:pt>
                <c:pt idx="142">
                  <c:v>0</c:v>
                </c:pt>
                <c:pt idx="143">
                  <c:v>33.333333333333336</c:v>
                </c:pt>
                <c:pt idx="144">
                  <c:v>44.444444444444443</c:v>
                </c:pt>
                <c:pt idx="145">
                  <c:v>44.444444444444443</c:v>
                </c:pt>
                <c:pt idx="146">
                  <c:v>22.222222222222221</c:v>
                </c:pt>
                <c:pt idx="147">
                  <c:v>44.444444444444443</c:v>
                </c:pt>
                <c:pt idx="148">
                  <c:v>55.555555555555557</c:v>
                </c:pt>
                <c:pt idx="149">
                  <c:v>44.444444444444443</c:v>
                </c:pt>
                <c:pt idx="150">
                  <c:v>44.444444444444443</c:v>
                </c:pt>
                <c:pt idx="151">
                  <c:v>44.444444444444443</c:v>
                </c:pt>
                <c:pt idx="152">
                  <c:v>44.444444444444443</c:v>
                </c:pt>
                <c:pt idx="153">
                  <c:v>44.444444444444443</c:v>
                </c:pt>
                <c:pt idx="154">
                  <c:v>44.444444444444443</c:v>
                </c:pt>
                <c:pt idx="155">
                  <c:v>44.444444444444443</c:v>
                </c:pt>
                <c:pt idx="156">
                  <c:v>33.333333333333336</c:v>
                </c:pt>
                <c:pt idx="157">
                  <c:v>44.444444444444443</c:v>
                </c:pt>
                <c:pt idx="158">
                  <c:v>33.333333333333336</c:v>
                </c:pt>
                <c:pt idx="159">
                  <c:v>33.333333333333336</c:v>
                </c:pt>
                <c:pt idx="160">
                  <c:v>44.444444444444443</c:v>
                </c:pt>
                <c:pt idx="161">
                  <c:v>33.333333333333336</c:v>
                </c:pt>
                <c:pt idx="162">
                  <c:v>55.555555555555557</c:v>
                </c:pt>
                <c:pt idx="163">
                  <c:v>0</c:v>
                </c:pt>
                <c:pt idx="164">
                  <c:v>44.444444444444443</c:v>
                </c:pt>
                <c:pt idx="165">
                  <c:v>33.333333333333336</c:v>
                </c:pt>
                <c:pt idx="166">
                  <c:v>44.444444444444443</c:v>
                </c:pt>
                <c:pt idx="167">
                  <c:v>0</c:v>
                </c:pt>
                <c:pt idx="168">
                  <c:v>33.333333333333336</c:v>
                </c:pt>
                <c:pt idx="169">
                  <c:v>44.444444444444443</c:v>
                </c:pt>
                <c:pt idx="170">
                  <c:v>11.111111111111111</c:v>
                </c:pt>
                <c:pt idx="171">
                  <c:v>55.555555555555557</c:v>
                </c:pt>
                <c:pt idx="172">
                  <c:v>0</c:v>
                </c:pt>
                <c:pt idx="173">
                  <c:v>44.444444444444443</c:v>
                </c:pt>
                <c:pt idx="174">
                  <c:v>66.666666666666671</c:v>
                </c:pt>
                <c:pt idx="175">
                  <c:v>0</c:v>
                </c:pt>
                <c:pt idx="176">
                  <c:v>44.444444444444443</c:v>
                </c:pt>
                <c:pt idx="177">
                  <c:v>44.444444444444443</c:v>
                </c:pt>
                <c:pt idx="178">
                  <c:v>55.555555555555557</c:v>
                </c:pt>
                <c:pt idx="179">
                  <c:v>33.333333333333336</c:v>
                </c:pt>
                <c:pt idx="180">
                  <c:v>55.555555555555557</c:v>
                </c:pt>
                <c:pt idx="181">
                  <c:v>66.666666666666671</c:v>
                </c:pt>
                <c:pt idx="182">
                  <c:v>55.555555555555557</c:v>
                </c:pt>
                <c:pt idx="183">
                  <c:v>0</c:v>
                </c:pt>
                <c:pt idx="184">
                  <c:v>44.444444444444443</c:v>
                </c:pt>
                <c:pt idx="185">
                  <c:v>55.555555555555557</c:v>
                </c:pt>
                <c:pt idx="186">
                  <c:v>44.444444444444443</c:v>
                </c:pt>
                <c:pt idx="187">
                  <c:v>55.555555555555557</c:v>
                </c:pt>
                <c:pt idx="188">
                  <c:v>44.444444444444443</c:v>
                </c:pt>
                <c:pt idx="189">
                  <c:v>33.333333333333336</c:v>
                </c:pt>
                <c:pt idx="190">
                  <c:v>33.333333333333336</c:v>
                </c:pt>
                <c:pt idx="191">
                  <c:v>77.777777777777771</c:v>
                </c:pt>
                <c:pt idx="192">
                  <c:v>66.666666666666671</c:v>
                </c:pt>
                <c:pt idx="193">
                  <c:v>55.555555555555557</c:v>
                </c:pt>
                <c:pt idx="194">
                  <c:v>22.222222222222221</c:v>
                </c:pt>
                <c:pt idx="195">
                  <c:v>55.555555555555557</c:v>
                </c:pt>
                <c:pt idx="196">
                  <c:v>33.333333333333336</c:v>
                </c:pt>
                <c:pt idx="197">
                  <c:v>22.222222222222221</c:v>
                </c:pt>
                <c:pt idx="198">
                  <c:v>33.333333333333336</c:v>
                </c:pt>
                <c:pt idx="199">
                  <c:v>55.555555555555557</c:v>
                </c:pt>
                <c:pt idx="200">
                  <c:v>55.555555555555557</c:v>
                </c:pt>
                <c:pt idx="201">
                  <c:v>33.333333333333336</c:v>
                </c:pt>
                <c:pt idx="202">
                  <c:v>44.444444444444443</c:v>
                </c:pt>
                <c:pt idx="203">
                  <c:v>55.555555555555557</c:v>
                </c:pt>
                <c:pt idx="204">
                  <c:v>33.333333333333336</c:v>
                </c:pt>
                <c:pt idx="205">
                  <c:v>44.444444444444443</c:v>
                </c:pt>
                <c:pt idx="206">
                  <c:v>44.444444444444443</c:v>
                </c:pt>
                <c:pt idx="207">
                  <c:v>33.333333333333336</c:v>
                </c:pt>
                <c:pt idx="208">
                  <c:v>44.444444444444443</c:v>
                </c:pt>
                <c:pt idx="209">
                  <c:v>55.555555555555557</c:v>
                </c:pt>
                <c:pt idx="210">
                  <c:v>11.111111111111111</c:v>
                </c:pt>
                <c:pt idx="211">
                  <c:v>55.555555555555557</c:v>
                </c:pt>
                <c:pt idx="212">
                  <c:v>44.444444444444443</c:v>
                </c:pt>
                <c:pt idx="213">
                  <c:v>55.555555555555557</c:v>
                </c:pt>
                <c:pt idx="214">
                  <c:v>66.666666666666671</c:v>
                </c:pt>
                <c:pt idx="215">
                  <c:v>55.555555555555557</c:v>
                </c:pt>
                <c:pt idx="216">
                  <c:v>22.222222222222221</c:v>
                </c:pt>
                <c:pt idx="217">
                  <c:v>55.555555555555557</c:v>
                </c:pt>
                <c:pt idx="218">
                  <c:v>44.444444444444443</c:v>
                </c:pt>
                <c:pt idx="219">
                  <c:v>55.555555555555557</c:v>
                </c:pt>
                <c:pt idx="220">
                  <c:v>44.444444444444443</c:v>
                </c:pt>
                <c:pt idx="221">
                  <c:v>33.333333333333336</c:v>
                </c:pt>
                <c:pt idx="222">
                  <c:v>44.444444444444443</c:v>
                </c:pt>
                <c:pt idx="223">
                  <c:v>11.111111111111111</c:v>
                </c:pt>
                <c:pt idx="224">
                  <c:v>55.555555555555557</c:v>
                </c:pt>
                <c:pt idx="225">
                  <c:v>22.222222222222221</c:v>
                </c:pt>
                <c:pt idx="226">
                  <c:v>33.333333333333336</c:v>
                </c:pt>
                <c:pt idx="227">
                  <c:v>55.555555555555557</c:v>
                </c:pt>
                <c:pt idx="228">
                  <c:v>33.333333333333336</c:v>
                </c:pt>
                <c:pt idx="229">
                  <c:v>55.555555555555557</c:v>
                </c:pt>
                <c:pt idx="230">
                  <c:v>55.555555555555557</c:v>
                </c:pt>
                <c:pt idx="231">
                  <c:v>55.555555555555557</c:v>
                </c:pt>
                <c:pt idx="232">
                  <c:v>22.222222222222221</c:v>
                </c:pt>
                <c:pt idx="233">
                  <c:v>44.444444444444443</c:v>
                </c:pt>
                <c:pt idx="234">
                  <c:v>33.333333333333336</c:v>
                </c:pt>
                <c:pt idx="235">
                  <c:v>33.333333333333336</c:v>
                </c:pt>
                <c:pt idx="236">
                  <c:v>55.555555555555557</c:v>
                </c:pt>
                <c:pt idx="237">
                  <c:v>55.555555555555557</c:v>
                </c:pt>
                <c:pt idx="238">
                  <c:v>44.444444444444443</c:v>
                </c:pt>
                <c:pt idx="239">
                  <c:v>44.444444444444443</c:v>
                </c:pt>
                <c:pt idx="240">
                  <c:v>44.444444444444443</c:v>
                </c:pt>
                <c:pt idx="241">
                  <c:v>55.555555555555557</c:v>
                </c:pt>
                <c:pt idx="242">
                  <c:v>33.333333333333336</c:v>
                </c:pt>
                <c:pt idx="243">
                  <c:v>11.111111111111111</c:v>
                </c:pt>
                <c:pt idx="244">
                  <c:v>33.333333333333336</c:v>
                </c:pt>
                <c:pt idx="245">
                  <c:v>55.555555555555557</c:v>
                </c:pt>
                <c:pt idx="246">
                  <c:v>66.666666666666671</c:v>
                </c:pt>
                <c:pt idx="247">
                  <c:v>33.333333333333336</c:v>
                </c:pt>
                <c:pt idx="248">
                  <c:v>66.666666666666671</c:v>
                </c:pt>
                <c:pt idx="249">
                  <c:v>55.555555555555557</c:v>
                </c:pt>
                <c:pt idx="250">
                  <c:v>77.777777777777771</c:v>
                </c:pt>
                <c:pt idx="251">
                  <c:v>55.555555555555557</c:v>
                </c:pt>
                <c:pt idx="252">
                  <c:v>44.444444444444443</c:v>
                </c:pt>
                <c:pt idx="253">
                  <c:v>55.555555555555557</c:v>
                </c:pt>
                <c:pt idx="254">
                  <c:v>33.333333333333336</c:v>
                </c:pt>
                <c:pt idx="255">
                  <c:v>44.444444444444443</c:v>
                </c:pt>
                <c:pt idx="256">
                  <c:v>55.555555555555557</c:v>
                </c:pt>
                <c:pt idx="257">
                  <c:v>55.555555555555557</c:v>
                </c:pt>
                <c:pt idx="258">
                  <c:v>11.111111111111111</c:v>
                </c:pt>
                <c:pt idx="259">
                  <c:v>33.333333333333336</c:v>
                </c:pt>
                <c:pt idx="260">
                  <c:v>66.666666666666671</c:v>
                </c:pt>
                <c:pt idx="261">
                  <c:v>44.444444444444443</c:v>
                </c:pt>
                <c:pt idx="262">
                  <c:v>0</c:v>
                </c:pt>
                <c:pt idx="263">
                  <c:v>0</c:v>
                </c:pt>
                <c:pt idx="264">
                  <c:v>0</c:v>
                </c:pt>
                <c:pt idx="265">
                  <c:v>0</c:v>
                </c:pt>
                <c:pt idx="266">
                  <c:v>11.111111111111111</c:v>
                </c:pt>
              </c:numCache>
            </c:numRef>
          </c:val>
          <c:extLst>
            <c:ext xmlns:c16="http://schemas.microsoft.com/office/drawing/2014/chart" uri="{C3380CC4-5D6E-409C-BE32-E72D297353CC}">
              <c16:uniqueId val="{00000001-3D9E-4E90-BCFC-084D4C4D651B}"/>
            </c:ext>
          </c:extLst>
        </c:ser>
        <c:dLbls>
          <c:showLegendKey val="0"/>
          <c:showVal val="0"/>
          <c:showCatName val="0"/>
          <c:showSerName val="0"/>
          <c:showPercent val="0"/>
          <c:showBubbleSize val="0"/>
        </c:dLbls>
        <c:gapWidth val="219"/>
        <c:overlap val="-27"/>
        <c:axId val="1847181536"/>
        <c:axId val="1847195936"/>
      </c:barChart>
      <c:catAx>
        <c:axId val="184718153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847195936"/>
        <c:crosses val="autoZero"/>
        <c:auto val="1"/>
        <c:lblAlgn val="ctr"/>
        <c:lblOffset val="100"/>
        <c:noMultiLvlLbl val="0"/>
      </c:catAx>
      <c:valAx>
        <c:axId val="1847195936"/>
        <c:scaling>
          <c:orientation val="minMax"/>
          <c:max val="100"/>
        </c:scaling>
        <c:delete val="0"/>
        <c:axPos val="l"/>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847181536"/>
        <c:crosses val="autoZero"/>
        <c:crossBetween val="between"/>
      </c:valAx>
      <c:spPr>
        <a:noFill/>
        <a:ln>
          <a:noFill/>
        </a:ln>
        <a:effectLst/>
      </c:spPr>
    </c:plotArea>
    <c:legend>
      <c:legendPos val="b"/>
      <c:layout>
        <c:manualLayout>
          <c:xMode val="edge"/>
          <c:yMode val="edge"/>
          <c:x val="0.9254218989464279"/>
          <c:y val="1.4772997125359328E-2"/>
          <c:w val="5.9270590039982571E-2"/>
          <c:h val="0.13322262627961237"/>
        </c:manualLayout>
      </c:layout>
      <c:overlay val="0"/>
      <c:spPr>
        <a:noFill/>
        <a:ln>
          <a:noFill/>
        </a:ln>
        <a:effectLst/>
      </c:spPr>
      <c:txPr>
        <a:bodyPr rot="0" spcFirstLastPara="1" vertOverflow="ellipsis" vert="horz" wrap="square" anchor="ctr" anchorCtr="1"/>
        <a:lstStyle/>
        <a:p>
          <a:pPr>
            <a:defRPr sz="1050" b="1"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66F5F4F-1FB3-B94F-B061-A3666DA886CC}" type="datetimeFigureOut">
              <a:rPr lang="en-US" smtClean="0"/>
              <a:t>6/5/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AEC98C-41FC-EE47-ACCF-A903C428D392}" type="slidenum">
              <a:rPr lang="en-US" smtClean="0"/>
              <a:t>‹#›</a:t>
            </a:fld>
            <a:endParaRPr lang="en-US"/>
          </a:p>
        </p:txBody>
      </p:sp>
    </p:spTree>
    <p:extLst>
      <p:ext uri="{BB962C8B-B14F-4D97-AF65-F5344CB8AC3E}">
        <p14:creationId xmlns:p14="http://schemas.microsoft.com/office/powerpoint/2010/main" val="4170464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For study design of the parent study, please refer to Thera. Et al</a:t>
            </a:r>
          </a:p>
        </p:txBody>
      </p:sp>
      <p:sp>
        <p:nvSpPr>
          <p:cNvPr id="4" name="Slide Number Placeholder 3"/>
          <p:cNvSpPr>
            <a:spLocks noGrp="1"/>
          </p:cNvSpPr>
          <p:nvPr>
            <p:ph type="sldNum" sz="quarter" idx="5"/>
          </p:nvPr>
        </p:nvSpPr>
        <p:spPr/>
        <p:txBody>
          <a:bodyPr/>
          <a:lstStyle/>
          <a:p>
            <a:fld id="{2DAEC98C-41FC-EE47-ACCF-A903C428D392}" type="slidenum">
              <a:rPr lang="en-US" smtClean="0"/>
              <a:t>3</a:t>
            </a:fld>
            <a:endParaRPr lang="en-US"/>
          </a:p>
        </p:txBody>
      </p:sp>
    </p:spTree>
    <p:extLst>
      <p:ext uri="{BB962C8B-B14F-4D97-AF65-F5344CB8AC3E}">
        <p14:creationId xmlns:p14="http://schemas.microsoft.com/office/powerpoint/2010/main" val="358364800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8826C0-0ED5-092B-B9D7-67783546125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BE9A049-BCC6-AEA7-C825-CD1EE82DC73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9C04551-1500-D84B-120C-CE622FCCAD16}"/>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5" name="Footer Placeholder 4">
            <a:extLst>
              <a:ext uri="{FF2B5EF4-FFF2-40B4-BE49-F238E27FC236}">
                <a16:creationId xmlns:a16="http://schemas.microsoft.com/office/drawing/2014/main" id="{0E60E22E-01B1-DAA1-2E48-AA30656147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E44194-22D9-D6D2-BA38-F1B5D00F5AC8}"/>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31129673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6EDA7C-26E5-0EFF-59E0-F36E3AF8BF4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8A23617-E1FF-1B64-2504-9184533206F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BD2540-C82E-48FB-8A5E-4E8061582757}"/>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5" name="Footer Placeholder 4">
            <a:extLst>
              <a:ext uri="{FF2B5EF4-FFF2-40B4-BE49-F238E27FC236}">
                <a16:creationId xmlns:a16="http://schemas.microsoft.com/office/drawing/2014/main" id="{752F3347-2E76-40FD-8474-1E74AEDC6EC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24F57D0-9C99-B040-7295-5BC1DE4BAEEF}"/>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550311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1A53D2C-1B68-1F19-81CA-DC6A245B95D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2FA13CD-AE72-4CA8-2C15-9862BF232F7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407D2DD-64EB-EA6A-332C-B2E65D8E6107}"/>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5" name="Footer Placeholder 4">
            <a:extLst>
              <a:ext uri="{FF2B5EF4-FFF2-40B4-BE49-F238E27FC236}">
                <a16:creationId xmlns:a16="http://schemas.microsoft.com/office/drawing/2014/main" id="{C94DCCB7-3FDA-B9F0-B2AF-6CF44FE0302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769A66-F206-18F4-9EBC-E532740B3282}"/>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8654513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740EAD-428B-61AD-8237-59D575BB987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3AEC1BD-D6CA-578A-35EB-70F9D59B1BB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28FD58C-4985-A713-DAA2-A02B453FA2C8}"/>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5" name="Footer Placeholder 4">
            <a:extLst>
              <a:ext uri="{FF2B5EF4-FFF2-40B4-BE49-F238E27FC236}">
                <a16:creationId xmlns:a16="http://schemas.microsoft.com/office/drawing/2014/main" id="{8B804838-AD54-2C6B-F8B4-196B02B611B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48C9FB-E087-4244-EFF8-248EA14408A3}"/>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227357471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D7635C-6717-4902-AA7A-B7B6069844B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5C26155-24B2-0978-8246-8A61AC1E57F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FFDA2EA-1680-61C3-C752-7984511272C8}"/>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5" name="Footer Placeholder 4">
            <a:extLst>
              <a:ext uri="{FF2B5EF4-FFF2-40B4-BE49-F238E27FC236}">
                <a16:creationId xmlns:a16="http://schemas.microsoft.com/office/drawing/2014/main" id="{10358F4E-C010-34D6-CB33-1C25AC7A882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96C5381-3C9A-51C7-63A1-40E3AD7F7D19}"/>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62655052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12B66A-593C-F46B-BF26-AFAAADC013B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DCB3EB9-A283-810E-8777-A00B6BE4CE6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FB728AF-3955-B8B6-24FB-6579C718867D}"/>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5" name="Footer Placeholder 4">
            <a:extLst>
              <a:ext uri="{FF2B5EF4-FFF2-40B4-BE49-F238E27FC236}">
                <a16:creationId xmlns:a16="http://schemas.microsoft.com/office/drawing/2014/main" id="{6BCD4106-A6FB-D54B-D5B4-1AEBAAE7F09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B82025-3F0B-A13D-C775-27C923202369}"/>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103438180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3E6AE9-7FC0-2217-59AF-2BF8C7A1312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BB56B2B-8B77-F2BE-548E-A2098282CD9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3649CFE-7A6E-0D25-56C8-FCA438D96A3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4E92FC4-DDA2-8590-FFCF-A89DA7CCBF58}"/>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6" name="Footer Placeholder 5">
            <a:extLst>
              <a:ext uri="{FF2B5EF4-FFF2-40B4-BE49-F238E27FC236}">
                <a16:creationId xmlns:a16="http://schemas.microsoft.com/office/drawing/2014/main" id="{212FD28A-FCE8-4BBB-0DA2-5104E873967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4834E4A-70FD-E62B-2581-BC9B31661230}"/>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181219886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D5A0E7-7F8B-0C85-F4A5-76CD15C3B9B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B6C1A43-9F73-FF14-088F-2CB89D95C3B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8AFA0DE-A96F-ED0C-4AA9-EAA034439AF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929D899-712C-5D78-E156-9D01A207B15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E290A1A-708F-1E0B-6434-9AD41271D8E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123E5BC-BFDA-9499-D0FD-D7D875B18FBB}"/>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8" name="Footer Placeholder 7">
            <a:extLst>
              <a:ext uri="{FF2B5EF4-FFF2-40B4-BE49-F238E27FC236}">
                <a16:creationId xmlns:a16="http://schemas.microsoft.com/office/drawing/2014/main" id="{E5B5B393-802E-6538-E33F-76FC59DC74E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130D248-F283-02B8-D928-03B976AE8669}"/>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199794611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6F5AF3-8669-3CF1-D273-6D599565DDC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57A77A8-1934-CB01-7270-EF4025B08E73}"/>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4" name="Footer Placeholder 3">
            <a:extLst>
              <a:ext uri="{FF2B5EF4-FFF2-40B4-BE49-F238E27FC236}">
                <a16:creationId xmlns:a16="http://schemas.microsoft.com/office/drawing/2014/main" id="{34C5E43D-9709-C63E-F02D-7A30FEA990B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122CEB1-4294-439F-E91C-777E02C91BD1}"/>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174599875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A5FA8A0-E6FB-0192-6B8B-91495915EB34}"/>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3" name="Footer Placeholder 2">
            <a:extLst>
              <a:ext uri="{FF2B5EF4-FFF2-40B4-BE49-F238E27FC236}">
                <a16:creationId xmlns:a16="http://schemas.microsoft.com/office/drawing/2014/main" id="{85152307-4E36-ACD9-5937-96C7F359A63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307F5BC-5323-613A-5EAF-D8F46E7BEE6C}"/>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414715860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7BC8F7-AB35-5B38-8F92-50BE39D3B46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2AAE490-BF91-5E03-FD8E-DECC2AEDFA9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F3032E9-BCA3-0E2A-CC22-D5F3B7E2831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3CBC3B9-032F-7CDE-1293-78342591E131}"/>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6" name="Footer Placeholder 5">
            <a:extLst>
              <a:ext uri="{FF2B5EF4-FFF2-40B4-BE49-F238E27FC236}">
                <a16:creationId xmlns:a16="http://schemas.microsoft.com/office/drawing/2014/main" id="{7D3D1DD3-E5D2-0417-5716-CB9A5B0CAAF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41DFC2D-9E36-C651-E7CE-3B3AD106CA8E}"/>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8127153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642DB8-E671-2B66-79E9-BE53DE03A95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FBC330A-4A1A-3D8B-C881-8AEF49A7C0A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234318A-9178-6F67-FE53-9E25E1656D19}"/>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5" name="Footer Placeholder 4">
            <a:extLst>
              <a:ext uri="{FF2B5EF4-FFF2-40B4-BE49-F238E27FC236}">
                <a16:creationId xmlns:a16="http://schemas.microsoft.com/office/drawing/2014/main" id="{16726021-930C-873C-542D-235C9822BAB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D2B007-FD69-DFC8-B5DE-FAAA2796B640}"/>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3203467344"/>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77B406-6D01-07C7-C4C0-F6D81C12B6A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C41DB29-8B45-29C0-70AF-B5EA73DAFBF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815B6CD-D889-AB57-620B-0564990888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AD6C1F3-DE4F-7F22-DD9E-BFEAF2C12CDE}"/>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6" name="Footer Placeholder 5">
            <a:extLst>
              <a:ext uri="{FF2B5EF4-FFF2-40B4-BE49-F238E27FC236}">
                <a16:creationId xmlns:a16="http://schemas.microsoft.com/office/drawing/2014/main" id="{CBE96A29-EF8C-7703-5324-190F2FBF436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7F94E79-43A3-CFEE-D372-F8891DD91132}"/>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224275440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03C0D4-9C76-074E-9C83-A64B22799BD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9C246A8-4AE3-2961-B312-1A19DEFB101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18E488-9633-5F83-3634-2EE740DE84FA}"/>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5" name="Footer Placeholder 4">
            <a:extLst>
              <a:ext uri="{FF2B5EF4-FFF2-40B4-BE49-F238E27FC236}">
                <a16:creationId xmlns:a16="http://schemas.microsoft.com/office/drawing/2014/main" id="{6F1B3652-2940-769D-8082-8D83187A428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A0631F2-E233-2FA1-900F-65DDF2372FA7}"/>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324599347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B27C77E-F6FE-4869-DB6B-0B6136A9606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785462D-1128-33BF-DAAB-1CDE2832E03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15F432-F04B-F3F6-C7B6-5B44A9204BE5}"/>
              </a:ext>
            </a:extLst>
          </p:cNvPr>
          <p:cNvSpPr>
            <a:spLocks noGrp="1"/>
          </p:cNvSpPr>
          <p:nvPr>
            <p:ph type="dt" sz="half" idx="10"/>
          </p:nvPr>
        </p:nvSpPr>
        <p:spPr/>
        <p:txBody>
          <a:bodyPr/>
          <a:lstStyle/>
          <a:p>
            <a:fld id="{DF6777D6-7056-400E-A559-B39E7F754B3E}" type="datetimeFigureOut">
              <a:rPr lang="en-US" smtClean="0"/>
              <a:t>6/5/23</a:t>
            </a:fld>
            <a:endParaRPr lang="en-US"/>
          </a:p>
        </p:txBody>
      </p:sp>
      <p:sp>
        <p:nvSpPr>
          <p:cNvPr id="5" name="Footer Placeholder 4">
            <a:extLst>
              <a:ext uri="{FF2B5EF4-FFF2-40B4-BE49-F238E27FC236}">
                <a16:creationId xmlns:a16="http://schemas.microsoft.com/office/drawing/2014/main" id="{B0368E20-081A-3E3D-3383-BB7ED39B6C8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876675-163F-7ECA-0010-849C8A43D911}"/>
              </a:ext>
            </a:extLst>
          </p:cNvPr>
          <p:cNvSpPr>
            <a:spLocks noGrp="1"/>
          </p:cNvSpPr>
          <p:nvPr>
            <p:ph type="sldNum" sz="quarter" idx="12"/>
          </p:nvPr>
        </p:nvSpPr>
        <p:spPr/>
        <p:txBody>
          <a:bodyPr/>
          <a:lstStyle/>
          <a:p>
            <a:fld id="{8DCB7299-E1BA-4ADA-AF52-303691E768DA}" type="slidenum">
              <a:rPr lang="en-US" smtClean="0"/>
              <a:t>‹#›</a:t>
            </a:fld>
            <a:endParaRPr lang="en-US"/>
          </a:p>
        </p:txBody>
      </p:sp>
    </p:spTree>
    <p:extLst>
      <p:ext uri="{BB962C8B-B14F-4D97-AF65-F5344CB8AC3E}">
        <p14:creationId xmlns:p14="http://schemas.microsoft.com/office/powerpoint/2010/main" val="36102857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C61596-7A53-B8DD-262D-AF0551A4E43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2963C61-7F26-CEAD-A749-2AA9942D3DE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D19AB9A-EE38-1B91-F547-BB0E941A2E37}"/>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5" name="Footer Placeholder 4">
            <a:extLst>
              <a:ext uri="{FF2B5EF4-FFF2-40B4-BE49-F238E27FC236}">
                <a16:creationId xmlns:a16="http://schemas.microsoft.com/office/drawing/2014/main" id="{DF9095CC-A383-338E-BAA0-B461D84C2DE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01A990-BFA0-3FE3-1C12-80AF09617FA5}"/>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6594100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9DA67F-3BC5-553F-62D5-088E5F10CAD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697DB39-9E19-BD55-32D4-8E83557D7AD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BEA7ABC-F074-94D7-A912-2A53DDABD54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C26635E-BF32-E471-49B2-4CDB432D257B}"/>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6" name="Footer Placeholder 5">
            <a:extLst>
              <a:ext uri="{FF2B5EF4-FFF2-40B4-BE49-F238E27FC236}">
                <a16:creationId xmlns:a16="http://schemas.microsoft.com/office/drawing/2014/main" id="{535F2788-E06C-F520-4F30-F3DB28D119C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44D673D-75F5-9EED-1E8C-3A3E7D12E05A}"/>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34529135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2ADB51-049F-1AC1-43E2-FD2D03A05A1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E43ADA1-84BE-2D65-60B8-69F83330E5F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E51E651-9706-7654-1AC8-94B609BABF9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8B2C4DB-089E-5076-0EA9-862A6D8A369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9A14A5B-3A92-B66E-D497-4E6D04EB78B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10D5116-B590-EF57-E805-5402863D6342}"/>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8" name="Footer Placeholder 7">
            <a:extLst>
              <a:ext uri="{FF2B5EF4-FFF2-40B4-BE49-F238E27FC236}">
                <a16:creationId xmlns:a16="http://schemas.microsoft.com/office/drawing/2014/main" id="{C2701F11-236B-B23B-7E31-04241D7EA19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1D05747-4AA8-FC65-8885-924A5C55BE66}"/>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14832469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614536-DDF2-BFB7-31E4-ADBB3FD9C03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7C1855D-9D3D-6847-B9C4-7C1196811076}"/>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4" name="Footer Placeholder 3">
            <a:extLst>
              <a:ext uri="{FF2B5EF4-FFF2-40B4-BE49-F238E27FC236}">
                <a16:creationId xmlns:a16="http://schemas.microsoft.com/office/drawing/2014/main" id="{ECC77524-731A-1A53-F1A9-93CF942DFF4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490CF87-C7A2-8E3C-E2F5-50C97BC6538D}"/>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3403978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DCF9A55-CA52-C393-5EAC-460506462D7B}"/>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3" name="Footer Placeholder 2">
            <a:extLst>
              <a:ext uri="{FF2B5EF4-FFF2-40B4-BE49-F238E27FC236}">
                <a16:creationId xmlns:a16="http://schemas.microsoft.com/office/drawing/2014/main" id="{2999C1D3-CB0D-6C70-978A-A848499D4E4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669EB27-75E4-F503-4BA1-31E375DA87A1}"/>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5500145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E74091-0FAA-3F85-8839-096614D4540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8661B68-2315-74B5-2C5D-DBA1604F991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A71DC65-D9B4-F55F-2440-92224974A1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84A8661-F44E-A1A8-A720-E8D21FA337D1}"/>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6" name="Footer Placeholder 5">
            <a:extLst>
              <a:ext uri="{FF2B5EF4-FFF2-40B4-BE49-F238E27FC236}">
                <a16:creationId xmlns:a16="http://schemas.microsoft.com/office/drawing/2014/main" id="{FEFB9627-4133-491C-23B7-E0912E2D833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75F52E-D702-34EC-66B6-B98B2008CE60}"/>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38950800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B64677-7E9E-BB82-526D-ED9E61A8096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EC3EAED-7AF4-7C05-A40C-1F91F81E61D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63814D9-DD68-8103-A0F6-3F2AD337070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BB4C42D-99B4-FCD6-635D-7CC2350D94B7}"/>
              </a:ext>
            </a:extLst>
          </p:cNvPr>
          <p:cNvSpPr>
            <a:spLocks noGrp="1"/>
          </p:cNvSpPr>
          <p:nvPr>
            <p:ph type="dt" sz="half" idx="10"/>
          </p:nvPr>
        </p:nvSpPr>
        <p:spPr/>
        <p:txBody>
          <a:bodyPr/>
          <a:lstStyle/>
          <a:p>
            <a:fld id="{251AF8CF-A808-DD43-8D45-AB0FA414CCC9}" type="datetimeFigureOut">
              <a:rPr lang="en-US" smtClean="0"/>
              <a:t>6/5/23</a:t>
            </a:fld>
            <a:endParaRPr lang="en-US"/>
          </a:p>
        </p:txBody>
      </p:sp>
      <p:sp>
        <p:nvSpPr>
          <p:cNvPr id="6" name="Footer Placeholder 5">
            <a:extLst>
              <a:ext uri="{FF2B5EF4-FFF2-40B4-BE49-F238E27FC236}">
                <a16:creationId xmlns:a16="http://schemas.microsoft.com/office/drawing/2014/main" id="{30F44DE8-4D84-3B50-2908-9C49F5F80EE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15CCFD0-BF98-782B-2131-E97E8687EA3C}"/>
              </a:ext>
            </a:extLst>
          </p:cNvPr>
          <p:cNvSpPr>
            <a:spLocks noGrp="1"/>
          </p:cNvSpPr>
          <p:nvPr>
            <p:ph type="sldNum" sz="quarter" idx="12"/>
          </p:nvPr>
        </p:nvSpPr>
        <p:spPr/>
        <p:txBody>
          <a:bodyPr/>
          <a:lstStyle/>
          <a:p>
            <a:fld id="{CE2317F8-0A27-CF48-9D65-76C6EEF64B40}" type="slidenum">
              <a:rPr lang="en-US" smtClean="0"/>
              <a:t>‹#›</a:t>
            </a:fld>
            <a:endParaRPr lang="en-US"/>
          </a:p>
        </p:txBody>
      </p:sp>
    </p:spTree>
    <p:extLst>
      <p:ext uri="{BB962C8B-B14F-4D97-AF65-F5344CB8AC3E}">
        <p14:creationId xmlns:p14="http://schemas.microsoft.com/office/powerpoint/2010/main" val="28148085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59F3EE6-D7C4-6314-9D07-8E642F0D580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3017CA7-DD8E-DA96-7FA1-C47DFC211D2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28CE309-9065-42F1-4409-5DF0C6032E2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51AF8CF-A808-DD43-8D45-AB0FA414CCC9}" type="datetimeFigureOut">
              <a:rPr lang="en-US" smtClean="0"/>
              <a:t>6/5/23</a:t>
            </a:fld>
            <a:endParaRPr lang="en-US"/>
          </a:p>
        </p:txBody>
      </p:sp>
      <p:sp>
        <p:nvSpPr>
          <p:cNvPr id="5" name="Footer Placeholder 4">
            <a:extLst>
              <a:ext uri="{FF2B5EF4-FFF2-40B4-BE49-F238E27FC236}">
                <a16:creationId xmlns:a16="http://schemas.microsoft.com/office/drawing/2014/main" id="{9BD31A2E-BC35-821E-DF82-926198E5F3A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4ADBA1F-0917-D8AD-3759-F096916017A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E2317F8-0A27-CF48-9D65-76C6EEF64B40}" type="slidenum">
              <a:rPr lang="en-US" smtClean="0"/>
              <a:t>‹#›</a:t>
            </a:fld>
            <a:endParaRPr lang="en-US"/>
          </a:p>
        </p:txBody>
      </p:sp>
    </p:spTree>
    <p:extLst>
      <p:ext uri="{BB962C8B-B14F-4D97-AF65-F5344CB8AC3E}">
        <p14:creationId xmlns:p14="http://schemas.microsoft.com/office/powerpoint/2010/main" val="335348728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784E3ED-C215-589B-31A6-F1E0C1A64AE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138D7BE-E48B-33C8-329C-656BDAE60A5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8D5D0F0-1E77-592F-CA8C-F440FE22298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F6777D6-7056-400E-A559-B39E7F754B3E}" type="datetimeFigureOut">
              <a:rPr lang="en-US" smtClean="0"/>
              <a:t>6/5/23</a:t>
            </a:fld>
            <a:endParaRPr lang="en-US"/>
          </a:p>
        </p:txBody>
      </p:sp>
      <p:sp>
        <p:nvSpPr>
          <p:cNvPr id="5" name="Footer Placeholder 4">
            <a:extLst>
              <a:ext uri="{FF2B5EF4-FFF2-40B4-BE49-F238E27FC236}">
                <a16:creationId xmlns:a16="http://schemas.microsoft.com/office/drawing/2014/main" id="{BC440AEF-C9E7-3A02-6FCF-A868C89D6B1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3C840A2-EEFE-59ED-67BA-0852D03093C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DCB7299-E1BA-4ADA-AF52-303691E768DA}" type="slidenum">
              <a:rPr lang="en-US" smtClean="0"/>
              <a:t>‹#›</a:t>
            </a:fld>
            <a:endParaRPr lang="en-US"/>
          </a:p>
        </p:txBody>
      </p:sp>
    </p:spTree>
    <p:extLst>
      <p:ext uri="{BB962C8B-B14F-4D97-AF65-F5344CB8AC3E}">
        <p14:creationId xmlns:p14="http://schemas.microsoft.com/office/powerpoint/2010/main" val="34158016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21.emf"/><Relationship Id="rId7" Type="http://schemas.openxmlformats.org/officeDocument/2006/relationships/image" Target="../media/image25.emf"/><Relationship Id="rId2" Type="http://schemas.openxmlformats.org/officeDocument/2006/relationships/image" Target="../media/image20.emf"/><Relationship Id="rId1" Type="http://schemas.openxmlformats.org/officeDocument/2006/relationships/slideLayout" Target="../slideLayouts/slideLayout2.xml"/><Relationship Id="rId6" Type="http://schemas.openxmlformats.org/officeDocument/2006/relationships/image" Target="../media/image24.emf"/><Relationship Id="rId5" Type="http://schemas.openxmlformats.org/officeDocument/2006/relationships/image" Target="../media/image23.emf"/><Relationship Id="rId4" Type="http://schemas.openxmlformats.org/officeDocument/2006/relationships/image" Target="../media/image22.emf"/></Relationships>
</file>

<file path=ppt/slides/_rels/slide16.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 Id="rId5" Type="http://schemas.openxmlformats.org/officeDocument/2006/relationships/image" Target="../media/image29.png"/><Relationship Id="rId4" Type="http://schemas.openxmlformats.org/officeDocument/2006/relationships/image" Target="../media/image28.png"/></Relationships>
</file>

<file path=ppt/slides/_rels/slide17.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Layout" Target="../slideLayouts/slideLayout2.xml"/><Relationship Id="rId6" Type="http://schemas.openxmlformats.org/officeDocument/2006/relationships/image" Target="../media/image34.png"/><Relationship Id="rId5" Type="http://schemas.openxmlformats.org/officeDocument/2006/relationships/image" Target="../media/image33.png"/><Relationship Id="rId4" Type="http://schemas.openxmlformats.org/officeDocument/2006/relationships/image" Target="../media/image32.png"/></Relationships>
</file>

<file path=ppt/slides/_rels/slide18.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1.png"/><Relationship Id="rId1" Type="http://schemas.openxmlformats.org/officeDocument/2006/relationships/slideLayout" Target="../slideLayouts/slideLayout2.xml"/><Relationship Id="rId6" Type="http://schemas.openxmlformats.org/officeDocument/2006/relationships/image" Target="../media/image38.png"/><Relationship Id="rId5" Type="http://schemas.openxmlformats.org/officeDocument/2006/relationships/image" Target="../media/image37.png"/><Relationship Id="rId4" Type="http://schemas.openxmlformats.org/officeDocument/2006/relationships/image" Target="../media/image36.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CF8DD6-F32A-7E6A-C504-00DDB5549C13}"/>
              </a:ext>
            </a:extLst>
          </p:cNvPr>
          <p:cNvSpPr>
            <a:spLocks noGrp="1"/>
          </p:cNvSpPr>
          <p:nvPr>
            <p:ph type="ctrTitle"/>
          </p:nvPr>
        </p:nvSpPr>
        <p:spPr>
          <a:xfrm>
            <a:off x="1000125" y="1920081"/>
            <a:ext cx="9144000" cy="1316038"/>
          </a:xfrm>
        </p:spPr>
        <p:txBody>
          <a:bodyPr>
            <a:normAutofit/>
          </a:bodyPr>
          <a:lstStyle/>
          <a:p>
            <a:r>
              <a:rPr lang="en-US" sz="4000">
                <a:latin typeface="Times New Roman"/>
                <a:cs typeface="Times New Roman"/>
              </a:rPr>
              <a:t>Supplementary Information</a:t>
            </a:r>
          </a:p>
        </p:txBody>
      </p:sp>
    </p:spTree>
    <p:extLst>
      <p:ext uri="{BB962C8B-B14F-4D97-AF65-F5344CB8AC3E}">
        <p14:creationId xmlns:p14="http://schemas.microsoft.com/office/powerpoint/2010/main" val="294559437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1784ECF-8C7A-6FC9-5EE3-EC1798A7E9C2}"/>
              </a:ext>
            </a:extLst>
          </p:cNvPr>
          <p:cNvSpPr txBox="1"/>
          <p:nvPr/>
        </p:nvSpPr>
        <p:spPr>
          <a:xfrm>
            <a:off x="374241" y="6037043"/>
            <a:ext cx="10227085" cy="830997"/>
          </a:xfrm>
          <a:prstGeom prst="rect">
            <a:avLst/>
          </a:prstGeom>
          <a:noFill/>
        </p:spPr>
        <p:txBody>
          <a:bodyPr wrap="square" lIns="91440" tIns="45720" rIns="91440" bIns="45720" rtlCol="0" anchor="t">
            <a:spAutoFit/>
          </a:bodyPr>
          <a:lstStyle/>
          <a:p>
            <a:r>
              <a:rPr lang="en-US" sz="1200" b="1">
                <a:latin typeface="Times New Roman" panose="02020603050405020304" pitchFamily="18" charset="0"/>
                <a:cs typeface="Times New Roman" panose="02020603050405020304" pitchFamily="18" charset="0"/>
              </a:rPr>
              <a:t>Supplementary Figure 5. </a:t>
            </a:r>
            <a:r>
              <a:rPr lang="en-US" sz="1200">
                <a:latin typeface="Times New Roman" panose="02020603050405020304" pitchFamily="18" charset="0"/>
                <a:cs typeface="Times New Roman" panose="02020603050405020304" pitchFamily="18" charset="0"/>
              </a:rPr>
              <a:t>Jittered scatter plot comparing the concentration of Apical Membrane Antigen 1 (AMA1) antibodies present in the serum of protected versus susceptible children at baseline, prior to malaria transmission season. Mann Whitney U test used to determine significance. </a:t>
            </a:r>
            <a:r>
              <a:rPr lang="en-US" sz="1200" b="0" i="0" u="none" strike="noStrike">
                <a:solidFill>
                  <a:srgbClr val="212121"/>
                </a:solidFill>
                <a:effectLst/>
                <a:latin typeface="Times New Roman" panose="02020603050405020304" pitchFamily="18" charset="0"/>
                <a:cs typeface="Times New Roman" panose="02020603050405020304" pitchFamily="18" charset="0"/>
              </a:rPr>
              <a:t>The antibody concentration did not differ significantly between conditions. </a:t>
            </a:r>
            <a:r>
              <a:rPr lang="en-US" sz="1200">
                <a:latin typeface="Times New Roman" panose="02020603050405020304" pitchFamily="18" charset="0"/>
                <a:cs typeface="Times New Roman" panose="02020603050405020304" pitchFamily="18" charset="0"/>
              </a:rPr>
              <a:t>The dashed lines represents the median concentration in each group. Samples used for RNA-seq are colored in dark blue while samples used for mass cytometry are colored in deep pink. </a:t>
            </a:r>
          </a:p>
        </p:txBody>
      </p:sp>
      <p:sp>
        <p:nvSpPr>
          <p:cNvPr id="8" name="Title 1">
            <a:extLst>
              <a:ext uri="{FF2B5EF4-FFF2-40B4-BE49-F238E27FC236}">
                <a16:creationId xmlns:a16="http://schemas.microsoft.com/office/drawing/2014/main" id="{FBF5D5E6-DC8B-600D-5164-E7F22FE1CF40}"/>
              </a:ext>
            </a:extLst>
          </p:cNvPr>
          <p:cNvSpPr>
            <a:spLocks noGrp="1"/>
          </p:cNvSpPr>
          <p:nvPr>
            <p:ph type="title"/>
          </p:nvPr>
        </p:nvSpPr>
        <p:spPr>
          <a:xfrm>
            <a:off x="141684" y="174626"/>
            <a:ext cx="7320148" cy="369332"/>
          </a:xfrm>
        </p:spPr>
        <p:txBody>
          <a:bodyPr>
            <a:normAutofit/>
          </a:bodyPr>
          <a:lstStyle/>
          <a:p>
            <a:r>
              <a:rPr lang="en-US" sz="1200" b="1">
                <a:latin typeface="Times New Roman"/>
                <a:cs typeface="Times New Roman"/>
              </a:rPr>
              <a:t>Supplementary Figure 5</a:t>
            </a:r>
          </a:p>
        </p:txBody>
      </p:sp>
      <p:sp>
        <p:nvSpPr>
          <p:cNvPr id="7" name="TextBox 6">
            <a:extLst>
              <a:ext uri="{FF2B5EF4-FFF2-40B4-BE49-F238E27FC236}">
                <a16:creationId xmlns:a16="http://schemas.microsoft.com/office/drawing/2014/main" id="{C99B25CD-E89D-431F-BD35-EB0B242135D6}"/>
              </a:ext>
            </a:extLst>
          </p:cNvPr>
          <p:cNvSpPr txBox="1"/>
          <p:nvPr/>
        </p:nvSpPr>
        <p:spPr>
          <a:xfrm>
            <a:off x="2822971" y="998379"/>
            <a:ext cx="2409825" cy="584775"/>
          </a:xfrm>
          <a:prstGeom prst="rect">
            <a:avLst/>
          </a:prstGeom>
          <a:noFill/>
        </p:spPr>
        <p:txBody>
          <a:bodyPr wrap="square" rtlCol="0">
            <a:spAutoFit/>
          </a:bodyPr>
          <a:lstStyle/>
          <a:p>
            <a:r>
              <a:rPr lang="en-US" sz="1400" b="1" dirty="0">
                <a:latin typeface="Helvetica" pitchFamily="2" charset="0"/>
              </a:rPr>
              <a:t>AMA1 ELISA</a:t>
            </a:r>
          </a:p>
          <a:p>
            <a:endParaRPr lang="en-US" dirty="0"/>
          </a:p>
        </p:txBody>
      </p:sp>
      <p:pic>
        <p:nvPicPr>
          <p:cNvPr id="16" name="Picture 15" descr="A picture containing text, screenshot, font, plot&#10;&#10;Description automatically generated">
            <a:extLst>
              <a:ext uri="{FF2B5EF4-FFF2-40B4-BE49-F238E27FC236}">
                <a16:creationId xmlns:a16="http://schemas.microsoft.com/office/drawing/2014/main" id="{6D2B1C26-4825-2B5B-222F-2D3CDD240122}"/>
              </a:ext>
            </a:extLst>
          </p:cNvPr>
          <p:cNvPicPr>
            <a:picLocks noChangeAspect="1"/>
          </p:cNvPicPr>
          <p:nvPr/>
        </p:nvPicPr>
        <p:blipFill>
          <a:blip r:embed="rId2"/>
          <a:stretch>
            <a:fillRect/>
          </a:stretch>
        </p:blipFill>
        <p:spPr>
          <a:xfrm>
            <a:off x="706610" y="1321544"/>
            <a:ext cx="7772400" cy="4591031"/>
          </a:xfrm>
          <a:prstGeom prst="rect">
            <a:avLst/>
          </a:prstGeom>
        </p:spPr>
      </p:pic>
    </p:spTree>
    <p:extLst>
      <p:ext uri="{BB962C8B-B14F-4D97-AF65-F5344CB8AC3E}">
        <p14:creationId xmlns:p14="http://schemas.microsoft.com/office/powerpoint/2010/main" val="106900960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Table&#10;&#10;Description automatically generated with low confidence">
            <a:extLst>
              <a:ext uri="{FF2B5EF4-FFF2-40B4-BE49-F238E27FC236}">
                <a16:creationId xmlns:a16="http://schemas.microsoft.com/office/drawing/2014/main" id="{E1964A91-1D9F-6418-4A95-45F84D2C4C25}"/>
              </a:ext>
            </a:extLst>
          </p:cNvPr>
          <p:cNvPicPr>
            <a:picLocks noChangeAspect="1"/>
          </p:cNvPicPr>
          <p:nvPr/>
        </p:nvPicPr>
        <p:blipFill>
          <a:blip r:embed="rId2"/>
          <a:stretch>
            <a:fillRect/>
          </a:stretch>
        </p:blipFill>
        <p:spPr>
          <a:xfrm>
            <a:off x="8909846" y="1159137"/>
            <a:ext cx="1196975" cy="616903"/>
          </a:xfrm>
          <a:prstGeom prst="rect">
            <a:avLst/>
          </a:prstGeom>
        </p:spPr>
      </p:pic>
      <p:sp>
        <p:nvSpPr>
          <p:cNvPr id="8" name="TextBox 7">
            <a:extLst>
              <a:ext uri="{FF2B5EF4-FFF2-40B4-BE49-F238E27FC236}">
                <a16:creationId xmlns:a16="http://schemas.microsoft.com/office/drawing/2014/main" id="{B5B048C4-976B-3457-4653-27F71052E273}"/>
              </a:ext>
            </a:extLst>
          </p:cNvPr>
          <p:cNvSpPr txBox="1"/>
          <p:nvPr/>
        </p:nvSpPr>
        <p:spPr>
          <a:xfrm>
            <a:off x="1624760" y="813865"/>
            <a:ext cx="1584325" cy="307777"/>
          </a:xfrm>
          <a:prstGeom prst="rect">
            <a:avLst/>
          </a:prstGeom>
          <a:noFill/>
        </p:spPr>
        <p:txBody>
          <a:bodyPr wrap="square" rtlCol="0">
            <a:spAutoFit/>
          </a:bodyPr>
          <a:lstStyle/>
          <a:p>
            <a:r>
              <a:rPr lang="en-US" sz="1400" b="1" dirty="0">
                <a:latin typeface="Helvetica" pitchFamily="2" charset="0"/>
              </a:rPr>
              <a:t>AMA1 PCR</a:t>
            </a:r>
          </a:p>
        </p:txBody>
      </p:sp>
      <p:sp>
        <p:nvSpPr>
          <p:cNvPr id="9" name="Title 1">
            <a:extLst>
              <a:ext uri="{FF2B5EF4-FFF2-40B4-BE49-F238E27FC236}">
                <a16:creationId xmlns:a16="http://schemas.microsoft.com/office/drawing/2014/main" id="{0EACF656-5596-DADB-C970-C64D71EE6407}"/>
              </a:ext>
            </a:extLst>
          </p:cNvPr>
          <p:cNvSpPr>
            <a:spLocks noGrp="1"/>
          </p:cNvSpPr>
          <p:nvPr>
            <p:ph type="title"/>
          </p:nvPr>
        </p:nvSpPr>
        <p:spPr>
          <a:xfrm>
            <a:off x="100012" y="138907"/>
            <a:ext cx="7320148" cy="369332"/>
          </a:xfrm>
        </p:spPr>
        <p:txBody>
          <a:bodyPr>
            <a:normAutofit/>
          </a:bodyPr>
          <a:lstStyle/>
          <a:p>
            <a:r>
              <a:rPr lang="en-US" sz="1200" b="1">
                <a:latin typeface="Times New Roman"/>
                <a:cs typeface="Times New Roman"/>
              </a:rPr>
              <a:t>Supplementary Figure 6</a:t>
            </a:r>
          </a:p>
        </p:txBody>
      </p:sp>
      <p:sp>
        <p:nvSpPr>
          <p:cNvPr id="3" name="TextBox 2">
            <a:extLst>
              <a:ext uri="{FF2B5EF4-FFF2-40B4-BE49-F238E27FC236}">
                <a16:creationId xmlns:a16="http://schemas.microsoft.com/office/drawing/2014/main" id="{71C6125A-E93E-79A8-1055-6470D226D815}"/>
              </a:ext>
            </a:extLst>
          </p:cNvPr>
          <p:cNvSpPr txBox="1"/>
          <p:nvPr/>
        </p:nvSpPr>
        <p:spPr>
          <a:xfrm>
            <a:off x="681422" y="5821276"/>
            <a:ext cx="10820016" cy="830997"/>
          </a:xfrm>
          <a:prstGeom prst="rect">
            <a:avLst/>
          </a:prstGeom>
          <a:noFill/>
        </p:spPr>
        <p:txBody>
          <a:bodyPr wrap="square" lIns="91440" tIns="45720" rIns="91440" bIns="45720" rtlCol="0" anchor="t">
            <a:spAutoFit/>
          </a:bodyPr>
          <a:lstStyle/>
          <a:p>
            <a:r>
              <a:rPr lang="en-US" sz="1200" b="1">
                <a:latin typeface="Times New Roman"/>
                <a:cs typeface="Arial"/>
              </a:rPr>
              <a:t>Supplementary Figure 6.</a:t>
            </a:r>
            <a:r>
              <a:rPr lang="en-US" sz="1200">
                <a:latin typeface="Times New Roman"/>
                <a:cs typeface="Arial"/>
              </a:rPr>
              <a:t> Heatmap showing PCR positive samples at baseline (Day 0) and across the malaria transmission season (Day 90 and Day 150) in malaria protected (grey) and malaria susceptible (hot pink) individuals. A fisher’s exact test was used to determine significance between protected and susceptible children across all three timepoints. (</a:t>
            </a:r>
            <a:r>
              <a:rPr lang="en-US" sz="1200" b="1">
                <a:latin typeface="Times New Roman"/>
                <a:cs typeface="Arial"/>
              </a:rPr>
              <a:t>A</a:t>
            </a:r>
            <a:r>
              <a:rPr lang="en-US" sz="1200">
                <a:latin typeface="Times New Roman"/>
                <a:cs typeface="Arial"/>
              </a:rPr>
              <a:t>) Heatmap for all samples processed for RNA-seq and Mass Cytometry. P-value 0.22 for day 0, P-value of 0.59 for day 90 and P-value of 1 for day 150. (</a:t>
            </a:r>
            <a:r>
              <a:rPr lang="en-US" sz="1200" b="1">
                <a:latin typeface="Times New Roman"/>
                <a:cs typeface="Arial"/>
              </a:rPr>
              <a:t>B</a:t>
            </a:r>
            <a:r>
              <a:rPr lang="en-US" sz="1200">
                <a:latin typeface="Times New Roman"/>
                <a:cs typeface="Arial"/>
              </a:rPr>
              <a:t>) Heatmap for samples processed for RNA-seq only. P-value 1 for day 0, P-value of 1 for day 90 and P-value of 0.4 for day 150.</a:t>
            </a:r>
          </a:p>
        </p:txBody>
      </p:sp>
      <p:sp>
        <p:nvSpPr>
          <p:cNvPr id="2" name="TextBox 1">
            <a:extLst>
              <a:ext uri="{FF2B5EF4-FFF2-40B4-BE49-F238E27FC236}">
                <a16:creationId xmlns:a16="http://schemas.microsoft.com/office/drawing/2014/main" id="{0CB9DC00-A33C-9E05-1D2A-D59731784AD7}"/>
              </a:ext>
            </a:extLst>
          </p:cNvPr>
          <p:cNvSpPr txBox="1"/>
          <p:nvPr/>
        </p:nvSpPr>
        <p:spPr>
          <a:xfrm>
            <a:off x="681422" y="665019"/>
            <a:ext cx="351731" cy="369332"/>
          </a:xfrm>
          <a:prstGeom prst="rect">
            <a:avLst/>
          </a:prstGeom>
          <a:noFill/>
        </p:spPr>
        <p:txBody>
          <a:bodyPr wrap="square" rtlCol="0">
            <a:spAutoFit/>
          </a:bodyPr>
          <a:lstStyle/>
          <a:p>
            <a:r>
              <a:rPr lang="en-US" b="1"/>
              <a:t>A</a:t>
            </a:r>
          </a:p>
        </p:txBody>
      </p:sp>
      <p:pic>
        <p:nvPicPr>
          <p:cNvPr id="10" name="Picture 9" descr="A picture containing text, screenshot, font, line&#10;&#10;Description automatically generated">
            <a:extLst>
              <a:ext uri="{FF2B5EF4-FFF2-40B4-BE49-F238E27FC236}">
                <a16:creationId xmlns:a16="http://schemas.microsoft.com/office/drawing/2014/main" id="{CF7BE7C6-1332-2986-2E9B-C3B06906CC46}"/>
              </a:ext>
            </a:extLst>
          </p:cNvPr>
          <p:cNvPicPr>
            <a:picLocks noChangeAspect="1"/>
          </p:cNvPicPr>
          <p:nvPr/>
        </p:nvPicPr>
        <p:blipFill>
          <a:blip r:embed="rId3"/>
          <a:stretch>
            <a:fillRect/>
          </a:stretch>
        </p:blipFill>
        <p:spPr>
          <a:xfrm>
            <a:off x="4414815" y="1153034"/>
            <a:ext cx="3289300" cy="1460500"/>
          </a:xfrm>
          <a:prstGeom prst="rect">
            <a:avLst/>
          </a:prstGeom>
        </p:spPr>
      </p:pic>
      <p:sp>
        <p:nvSpPr>
          <p:cNvPr id="11" name="TextBox 10">
            <a:extLst>
              <a:ext uri="{FF2B5EF4-FFF2-40B4-BE49-F238E27FC236}">
                <a16:creationId xmlns:a16="http://schemas.microsoft.com/office/drawing/2014/main" id="{0B4F264E-4B6F-1FF4-F7D6-BA78B48C54F4}"/>
              </a:ext>
            </a:extLst>
          </p:cNvPr>
          <p:cNvSpPr txBox="1"/>
          <p:nvPr/>
        </p:nvSpPr>
        <p:spPr>
          <a:xfrm>
            <a:off x="4130541" y="661342"/>
            <a:ext cx="351731" cy="369332"/>
          </a:xfrm>
          <a:prstGeom prst="rect">
            <a:avLst/>
          </a:prstGeom>
          <a:noFill/>
        </p:spPr>
        <p:txBody>
          <a:bodyPr wrap="square" rtlCol="0">
            <a:spAutoFit/>
          </a:bodyPr>
          <a:lstStyle/>
          <a:p>
            <a:r>
              <a:rPr lang="en-US" b="1"/>
              <a:t>B</a:t>
            </a:r>
          </a:p>
        </p:txBody>
      </p:sp>
      <p:pic>
        <p:nvPicPr>
          <p:cNvPr id="12" name="Picture 11" descr="A screenshot of a cell phone&#10;&#10;Description automatically generated with low confidence">
            <a:extLst>
              <a:ext uri="{FF2B5EF4-FFF2-40B4-BE49-F238E27FC236}">
                <a16:creationId xmlns:a16="http://schemas.microsoft.com/office/drawing/2014/main" id="{8B1469A2-0162-BD45-4A6D-79DF1C76B071}"/>
              </a:ext>
            </a:extLst>
          </p:cNvPr>
          <p:cNvPicPr>
            <a:picLocks noChangeAspect="1"/>
          </p:cNvPicPr>
          <p:nvPr/>
        </p:nvPicPr>
        <p:blipFill>
          <a:blip r:embed="rId4"/>
          <a:stretch>
            <a:fillRect/>
          </a:stretch>
        </p:blipFill>
        <p:spPr>
          <a:xfrm>
            <a:off x="1033153" y="1153034"/>
            <a:ext cx="2719232" cy="4549484"/>
          </a:xfrm>
          <a:prstGeom prst="rect">
            <a:avLst/>
          </a:prstGeom>
        </p:spPr>
      </p:pic>
      <p:sp>
        <p:nvSpPr>
          <p:cNvPr id="13" name="TextBox 12">
            <a:extLst>
              <a:ext uri="{FF2B5EF4-FFF2-40B4-BE49-F238E27FC236}">
                <a16:creationId xmlns:a16="http://schemas.microsoft.com/office/drawing/2014/main" id="{20DE4E0F-70DD-1015-F60F-F4B4B556C23A}"/>
              </a:ext>
            </a:extLst>
          </p:cNvPr>
          <p:cNvSpPr txBox="1"/>
          <p:nvPr/>
        </p:nvSpPr>
        <p:spPr>
          <a:xfrm>
            <a:off x="5688003" y="813865"/>
            <a:ext cx="1584325" cy="307777"/>
          </a:xfrm>
          <a:prstGeom prst="rect">
            <a:avLst/>
          </a:prstGeom>
          <a:noFill/>
        </p:spPr>
        <p:txBody>
          <a:bodyPr wrap="square" rtlCol="0">
            <a:spAutoFit/>
          </a:bodyPr>
          <a:lstStyle/>
          <a:p>
            <a:r>
              <a:rPr lang="en-US" sz="1400" b="1" dirty="0">
                <a:latin typeface="Helvetica" pitchFamily="2" charset="0"/>
              </a:rPr>
              <a:t>AMA1 PCR</a:t>
            </a:r>
          </a:p>
        </p:txBody>
      </p:sp>
    </p:spTree>
    <p:extLst>
      <p:ext uri="{BB962C8B-B14F-4D97-AF65-F5344CB8AC3E}">
        <p14:creationId xmlns:p14="http://schemas.microsoft.com/office/powerpoint/2010/main" val="93176180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A2A8FC-D80A-8AAF-7DF8-ABAB0ED25E13}"/>
              </a:ext>
            </a:extLst>
          </p:cNvPr>
          <p:cNvSpPr>
            <a:spLocks noGrp="1"/>
          </p:cNvSpPr>
          <p:nvPr>
            <p:ph type="title"/>
          </p:nvPr>
        </p:nvSpPr>
        <p:spPr>
          <a:xfrm>
            <a:off x="211898" y="105127"/>
            <a:ext cx="6508546" cy="303134"/>
          </a:xfrm>
        </p:spPr>
        <p:txBody>
          <a:bodyPr>
            <a:normAutofit/>
          </a:bodyPr>
          <a:lstStyle/>
          <a:p>
            <a:r>
              <a:rPr lang="en-US" sz="1200" b="1">
                <a:latin typeface="Times New Roman"/>
                <a:cs typeface="Times New Roman"/>
              </a:rPr>
              <a:t>Supplementary Figure 7A,B</a:t>
            </a:r>
          </a:p>
        </p:txBody>
      </p:sp>
      <p:sp>
        <p:nvSpPr>
          <p:cNvPr id="4" name="TextBox 3">
            <a:extLst>
              <a:ext uri="{FF2B5EF4-FFF2-40B4-BE49-F238E27FC236}">
                <a16:creationId xmlns:a16="http://schemas.microsoft.com/office/drawing/2014/main" id="{7FCA64CC-00E1-9316-352F-FE075407C270}"/>
              </a:ext>
            </a:extLst>
          </p:cNvPr>
          <p:cNvSpPr txBox="1"/>
          <p:nvPr/>
        </p:nvSpPr>
        <p:spPr>
          <a:xfrm>
            <a:off x="686195" y="6060590"/>
            <a:ext cx="9919403" cy="461665"/>
          </a:xfrm>
          <a:prstGeom prst="rect">
            <a:avLst/>
          </a:prstGeom>
          <a:noFill/>
        </p:spPr>
        <p:txBody>
          <a:bodyPr wrap="square" lIns="91440" tIns="45720" rIns="91440" bIns="45720" rtlCol="0" anchor="t">
            <a:spAutoFit/>
          </a:bodyPr>
          <a:lstStyle/>
          <a:p>
            <a:r>
              <a:rPr lang="en-US" sz="1200" b="1">
                <a:latin typeface="Times New Roman"/>
                <a:cs typeface="Arial"/>
              </a:rPr>
              <a:t>Supplementary Figure 7.</a:t>
            </a:r>
            <a:r>
              <a:rPr lang="en-US" sz="1200">
                <a:latin typeface="Times New Roman"/>
                <a:cs typeface="Arial"/>
              </a:rPr>
              <a:t> Day 0 cell type abundance. (</a:t>
            </a:r>
            <a:r>
              <a:rPr lang="en-US" sz="1200" b="1">
                <a:latin typeface="Times New Roman"/>
                <a:cs typeface="Arial"/>
              </a:rPr>
              <a:t>A</a:t>
            </a:r>
            <a:r>
              <a:rPr lang="en-US" sz="1200">
                <a:latin typeface="Times New Roman"/>
                <a:cs typeface="Arial"/>
              </a:rPr>
              <a:t>) </a:t>
            </a:r>
            <a:r>
              <a:rPr lang="en-US" sz="1200" err="1">
                <a:latin typeface="Times New Roman"/>
                <a:cs typeface="Arial"/>
              </a:rPr>
              <a:t>Barplot</a:t>
            </a:r>
            <a:r>
              <a:rPr lang="en-US" sz="1200">
                <a:latin typeface="Times New Roman"/>
                <a:cs typeface="Arial"/>
              </a:rPr>
              <a:t> showing distribution of each annotated cell type per sample. (</a:t>
            </a:r>
            <a:r>
              <a:rPr lang="en-US" sz="1200" b="1">
                <a:latin typeface="Times New Roman"/>
                <a:cs typeface="Arial"/>
              </a:rPr>
              <a:t>B</a:t>
            </a:r>
            <a:r>
              <a:rPr lang="en-US" sz="1200">
                <a:latin typeface="Times New Roman"/>
                <a:cs typeface="Arial"/>
              </a:rPr>
              <a:t>) UMAP cluster for each sample</a:t>
            </a:r>
          </a:p>
        </p:txBody>
      </p:sp>
      <p:pic>
        <p:nvPicPr>
          <p:cNvPr id="33" name="Picture 32" descr="Chart, bar chart&#10;&#10;Description automatically generated">
            <a:extLst>
              <a:ext uri="{FF2B5EF4-FFF2-40B4-BE49-F238E27FC236}">
                <a16:creationId xmlns:a16="http://schemas.microsoft.com/office/drawing/2014/main" id="{441273A2-36E8-39C3-7FDF-66AF8C4C0DF3}"/>
              </a:ext>
            </a:extLst>
          </p:cNvPr>
          <p:cNvPicPr>
            <a:picLocks noChangeAspect="1"/>
          </p:cNvPicPr>
          <p:nvPr/>
        </p:nvPicPr>
        <p:blipFill>
          <a:blip r:embed="rId2"/>
          <a:stretch>
            <a:fillRect/>
          </a:stretch>
        </p:blipFill>
        <p:spPr>
          <a:xfrm>
            <a:off x="336808" y="1036957"/>
            <a:ext cx="5002432" cy="4792330"/>
          </a:xfrm>
          <a:prstGeom prst="rect">
            <a:avLst/>
          </a:prstGeom>
        </p:spPr>
      </p:pic>
      <p:pic>
        <p:nvPicPr>
          <p:cNvPr id="35" name="Picture 34" descr="Diagram&#10;&#10;Description automatically generated with medium confidence">
            <a:extLst>
              <a:ext uri="{FF2B5EF4-FFF2-40B4-BE49-F238E27FC236}">
                <a16:creationId xmlns:a16="http://schemas.microsoft.com/office/drawing/2014/main" id="{ABD5B87A-4401-976F-6232-9B331B770E13}"/>
              </a:ext>
            </a:extLst>
          </p:cNvPr>
          <p:cNvPicPr>
            <a:picLocks noChangeAspect="1"/>
          </p:cNvPicPr>
          <p:nvPr/>
        </p:nvPicPr>
        <p:blipFill>
          <a:blip r:embed="rId3"/>
          <a:stretch>
            <a:fillRect/>
          </a:stretch>
        </p:blipFill>
        <p:spPr>
          <a:xfrm>
            <a:off x="5645896" y="974133"/>
            <a:ext cx="5969351" cy="4520585"/>
          </a:xfrm>
          <a:prstGeom prst="rect">
            <a:avLst/>
          </a:prstGeom>
        </p:spPr>
      </p:pic>
      <p:sp>
        <p:nvSpPr>
          <p:cNvPr id="38" name="TextBox 37">
            <a:extLst>
              <a:ext uri="{FF2B5EF4-FFF2-40B4-BE49-F238E27FC236}">
                <a16:creationId xmlns:a16="http://schemas.microsoft.com/office/drawing/2014/main" id="{6873A6C1-A395-B908-82F5-AAC99220DBBF}"/>
              </a:ext>
            </a:extLst>
          </p:cNvPr>
          <p:cNvSpPr txBox="1"/>
          <p:nvPr/>
        </p:nvSpPr>
        <p:spPr>
          <a:xfrm>
            <a:off x="230343" y="1169133"/>
            <a:ext cx="274989" cy="369332"/>
          </a:xfrm>
          <a:prstGeom prst="rect">
            <a:avLst/>
          </a:prstGeom>
          <a:noFill/>
        </p:spPr>
        <p:txBody>
          <a:bodyPr wrap="square" lIns="91440" tIns="45720" rIns="91440" bIns="45720" rtlCol="0" anchor="t">
            <a:spAutoFit/>
          </a:bodyPr>
          <a:lstStyle/>
          <a:p>
            <a:r>
              <a:rPr lang="en-US" b="1"/>
              <a:t>A</a:t>
            </a:r>
          </a:p>
        </p:txBody>
      </p:sp>
      <p:sp>
        <p:nvSpPr>
          <p:cNvPr id="39" name="TextBox 38">
            <a:extLst>
              <a:ext uri="{FF2B5EF4-FFF2-40B4-BE49-F238E27FC236}">
                <a16:creationId xmlns:a16="http://schemas.microsoft.com/office/drawing/2014/main" id="{227FCC57-C6CD-6E5C-01C4-B1D67A6B8B39}"/>
              </a:ext>
            </a:extLst>
          </p:cNvPr>
          <p:cNvSpPr txBox="1"/>
          <p:nvPr/>
        </p:nvSpPr>
        <p:spPr>
          <a:xfrm>
            <a:off x="5339240" y="1197193"/>
            <a:ext cx="274989" cy="369332"/>
          </a:xfrm>
          <a:prstGeom prst="rect">
            <a:avLst/>
          </a:prstGeom>
          <a:noFill/>
        </p:spPr>
        <p:txBody>
          <a:bodyPr wrap="square" lIns="91440" tIns="45720" rIns="91440" bIns="45720" rtlCol="0" anchor="t">
            <a:spAutoFit/>
          </a:bodyPr>
          <a:lstStyle/>
          <a:p>
            <a:r>
              <a:rPr lang="en-US" b="1"/>
              <a:t>B</a:t>
            </a:r>
          </a:p>
        </p:txBody>
      </p:sp>
    </p:spTree>
    <p:extLst>
      <p:ext uri="{BB962C8B-B14F-4D97-AF65-F5344CB8AC3E}">
        <p14:creationId xmlns:p14="http://schemas.microsoft.com/office/powerpoint/2010/main" val="390421721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A2A8FC-D80A-8AAF-7DF8-ABAB0ED25E13}"/>
              </a:ext>
            </a:extLst>
          </p:cNvPr>
          <p:cNvSpPr>
            <a:spLocks noGrp="1"/>
          </p:cNvSpPr>
          <p:nvPr>
            <p:ph type="title"/>
          </p:nvPr>
        </p:nvSpPr>
        <p:spPr>
          <a:xfrm>
            <a:off x="211898" y="105127"/>
            <a:ext cx="6901451" cy="380525"/>
          </a:xfrm>
        </p:spPr>
        <p:txBody>
          <a:bodyPr>
            <a:normAutofit/>
          </a:bodyPr>
          <a:lstStyle/>
          <a:p>
            <a:r>
              <a:rPr lang="en-US" sz="1200" b="1">
                <a:latin typeface="Times New Roman"/>
                <a:cs typeface="Times New Roman"/>
              </a:rPr>
              <a:t>Supplementary Figure 7C,D</a:t>
            </a:r>
          </a:p>
        </p:txBody>
      </p:sp>
      <p:sp>
        <p:nvSpPr>
          <p:cNvPr id="8" name="TextBox 7">
            <a:extLst>
              <a:ext uri="{FF2B5EF4-FFF2-40B4-BE49-F238E27FC236}">
                <a16:creationId xmlns:a16="http://schemas.microsoft.com/office/drawing/2014/main" id="{2A6FBD11-9A2A-F40F-394E-591608F42915}"/>
              </a:ext>
            </a:extLst>
          </p:cNvPr>
          <p:cNvSpPr txBox="1"/>
          <p:nvPr/>
        </p:nvSpPr>
        <p:spPr>
          <a:xfrm>
            <a:off x="419485" y="6125546"/>
            <a:ext cx="10979059" cy="276999"/>
          </a:xfrm>
          <a:prstGeom prst="rect">
            <a:avLst/>
          </a:prstGeom>
          <a:noFill/>
        </p:spPr>
        <p:txBody>
          <a:bodyPr wrap="square" lIns="91440" tIns="45720" rIns="91440" bIns="45720" rtlCol="0" anchor="t">
            <a:spAutoFit/>
          </a:bodyPr>
          <a:lstStyle/>
          <a:p>
            <a:r>
              <a:rPr lang="en-US" sz="1200" b="1">
                <a:latin typeface="Times New Roman"/>
                <a:cs typeface="Arial"/>
              </a:rPr>
              <a:t>Supplementary Figure 7.</a:t>
            </a:r>
            <a:r>
              <a:rPr lang="en-US" sz="1200">
                <a:latin typeface="Times New Roman"/>
                <a:cs typeface="Arial"/>
              </a:rPr>
              <a:t> Day 90 cell type abundance. (</a:t>
            </a:r>
            <a:r>
              <a:rPr lang="en-US" sz="1200" b="1">
                <a:latin typeface="Times New Roman"/>
                <a:cs typeface="Arial"/>
              </a:rPr>
              <a:t>C</a:t>
            </a:r>
            <a:r>
              <a:rPr lang="en-US" sz="1200">
                <a:latin typeface="Times New Roman"/>
                <a:cs typeface="Arial"/>
              </a:rPr>
              <a:t>) </a:t>
            </a:r>
            <a:r>
              <a:rPr lang="en-US" sz="1200" err="1">
                <a:latin typeface="Times New Roman"/>
                <a:cs typeface="Arial"/>
              </a:rPr>
              <a:t>Barplot</a:t>
            </a:r>
            <a:r>
              <a:rPr lang="en-US" sz="1200">
                <a:latin typeface="Times New Roman"/>
                <a:cs typeface="Arial"/>
              </a:rPr>
              <a:t> showing distribution of each annotated cell type per sample. (</a:t>
            </a:r>
            <a:r>
              <a:rPr lang="en-US" sz="1200" b="1">
                <a:latin typeface="Times New Roman"/>
                <a:cs typeface="Arial"/>
              </a:rPr>
              <a:t>D</a:t>
            </a:r>
            <a:r>
              <a:rPr lang="en-US" sz="1200">
                <a:latin typeface="Times New Roman"/>
                <a:cs typeface="Arial"/>
              </a:rPr>
              <a:t>) UMAP cluster for each sample</a:t>
            </a:r>
          </a:p>
        </p:txBody>
      </p:sp>
      <p:pic>
        <p:nvPicPr>
          <p:cNvPr id="30" name="Picture 29" descr="Chart, bar chart&#10;&#10;Description automatically generated">
            <a:extLst>
              <a:ext uri="{FF2B5EF4-FFF2-40B4-BE49-F238E27FC236}">
                <a16:creationId xmlns:a16="http://schemas.microsoft.com/office/drawing/2014/main" id="{F1008594-1D0E-7738-9242-D413A31FBCD4}"/>
              </a:ext>
            </a:extLst>
          </p:cNvPr>
          <p:cNvPicPr>
            <a:picLocks noChangeAspect="1"/>
          </p:cNvPicPr>
          <p:nvPr/>
        </p:nvPicPr>
        <p:blipFill>
          <a:blip r:embed="rId2"/>
          <a:stretch>
            <a:fillRect/>
          </a:stretch>
        </p:blipFill>
        <p:spPr>
          <a:xfrm>
            <a:off x="683594" y="1066299"/>
            <a:ext cx="5312923" cy="4819430"/>
          </a:xfrm>
          <a:prstGeom prst="rect">
            <a:avLst/>
          </a:prstGeom>
        </p:spPr>
      </p:pic>
      <p:pic>
        <p:nvPicPr>
          <p:cNvPr id="32" name="Picture 31" descr="Diagram&#10;&#10;Description automatically generated">
            <a:extLst>
              <a:ext uri="{FF2B5EF4-FFF2-40B4-BE49-F238E27FC236}">
                <a16:creationId xmlns:a16="http://schemas.microsoft.com/office/drawing/2014/main" id="{7A7998F5-4858-9A95-5018-0940688A07AF}"/>
              </a:ext>
            </a:extLst>
          </p:cNvPr>
          <p:cNvPicPr>
            <a:picLocks noChangeAspect="1"/>
          </p:cNvPicPr>
          <p:nvPr/>
        </p:nvPicPr>
        <p:blipFill>
          <a:blip r:embed="rId3"/>
          <a:stretch>
            <a:fillRect/>
          </a:stretch>
        </p:blipFill>
        <p:spPr>
          <a:xfrm>
            <a:off x="6195485" y="1302544"/>
            <a:ext cx="5543920" cy="4336437"/>
          </a:xfrm>
          <a:prstGeom prst="rect">
            <a:avLst/>
          </a:prstGeom>
        </p:spPr>
      </p:pic>
      <p:sp>
        <p:nvSpPr>
          <p:cNvPr id="35" name="TextBox 34">
            <a:extLst>
              <a:ext uri="{FF2B5EF4-FFF2-40B4-BE49-F238E27FC236}">
                <a16:creationId xmlns:a16="http://schemas.microsoft.com/office/drawing/2014/main" id="{137025D6-600F-67CA-0ECC-8B47BB25E93C}"/>
              </a:ext>
            </a:extLst>
          </p:cNvPr>
          <p:cNvSpPr txBox="1"/>
          <p:nvPr/>
        </p:nvSpPr>
        <p:spPr>
          <a:xfrm>
            <a:off x="683594" y="1302544"/>
            <a:ext cx="274989" cy="369332"/>
          </a:xfrm>
          <a:prstGeom prst="rect">
            <a:avLst/>
          </a:prstGeom>
          <a:noFill/>
        </p:spPr>
        <p:txBody>
          <a:bodyPr wrap="square" lIns="91440" tIns="45720" rIns="91440" bIns="45720" rtlCol="0" anchor="t">
            <a:spAutoFit/>
          </a:bodyPr>
          <a:lstStyle/>
          <a:p>
            <a:r>
              <a:rPr lang="en-US" b="1"/>
              <a:t>C</a:t>
            </a:r>
          </a:p>
        </p:txBody>
      </p:sp>
      <p:sp>
        <p:nvSpPr>
          <p:cNvPr id="36" name="TextBox 35">
            <a:extLst>
              <a:ext uri="{FF2B5EF4-FFF2-40B4-BE49-F238E27FC236}">
                <a16:creationId xmlns:a16="http://schemas.microsoft.com/office/drawing/2014/main" id="{119005C8-BB44-71ED-01E3-861FC0294FE2}"/>
              </a:ext>
            </a:extLst>
          </p:cNvPr>
          <p:cNvSpPr txBox="1"/>
          <p:nvPr/>
        </p:nvSpPr>
        <p:spPr>
          <a:xfrm>
            <a:off x="5806853" y="1306116"/>
            <a:ext cx="274989" cy="369332"/>
          </a:xfrm>
          <a:prstGeom prst="rect">
            <a:avLst/>
          </a:prstGeom>
          <a:noFill/>
        </p:spPr>
        <p:txBody>
          <a:bodyPr wrap="square" lIns="91440" tIns="45720" rIns="91440" bIns="45720" rtlCol="0" anchor="t">
            <a:spAutoFit/>
          </a:bodyPr>
          <a:lstStyle/>
          <a:p>
            <a:r>
              <a:rPr lang="en-US" b="1"/>
              <a:t>D</a:t>
            </a:r>
          </a:p>
        </p:txBody>
      </p:sp>
    </p:spTree>
    <p:extLst>
      <p:ext uri="{BB962C8B-B14F-4D97-AF65-F5344CB8AC3E}">
        <p14:creationId xmlns:p14="http://schemas.microsoft.com/office/powerpoint/2010/main" val="111437121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A2A8FC-D80A-8AAF-7DF8-ABAB0ED25E13}"/>
              </a:ext>
            </a:extLst>
          </p:cNvPr>
          <p:cNvSpPr>
            <a:spLocks noGrp="1"/>
          </p:cNvSpPr>
          <p:nvPr>
            <p:ph type="title"/>
          </p:nvPr>
        </p:nvSpPr>
        <p:spPr>
          <a:xfrm>
            <a:off x="211898" y="105127"/>
            <a:ext cx="6853827" cy="386478"/>
          </a:xfrm>
        </p:spPr>
        <p:txBody>
          <a:bodyPr>
            <a:normAutofit/>
          </a:bodyPr>
          <a:lstStyle/>
          <a:p>
            <a:r>
              <a:rPr lang="en-US" sz="1200" b="1">
                <a:latin typeface="Times New Roman"/>
                <a:cs typeface="Times New Roman"/>
              </a:rPr>
              <a:t>Supplementary Figure 7E,F</a:t>
            </a:r>
          </a:p>
        </p:txBody>
      </p:sp>
      <p:sp>
        <p:nvSpPr>
          <p:cNvPr id="5" name="TextBox 4">
            <a:extLst>
              <a:ext uri="{FF2B5EF4-FFF2-40B4-BE49-F238E27FC236}">
                <a16:creationId xmlns:a16="http://schemas.microsoft.com/office/drawing/2014/main" id="{13447F51-3053-540A-1984-E9504E51E8D7}"/>
              </a:ext>
            </a:extLst>
          </p:cNvPr>
          <p:cNvSpPr txBox="1"/>
          <p:nvPr/>
        </p:nvSpPr>
        <p:spPr>
          <a:xfrm>
            <a:off x="419485" y="6125546"/>
            <a:ext cx="10979059" cy="276999"/>
          </a:xfrm>
          <a:prstGeom prst="rect">
            <a:avLst/>
          </a:prstGeom>
          <a:noFill/>
        </p:spPr>
        <p:txBody>
          <a:bodyPr wrap="square" lIns="91440" tIns="45720" rIns="91440" bIns="45720" rtlCol="0" anchor="t">
            <a:spAutoFit/>
          </a:bodyPr>
          <a:lstStyle/>
          <a:p>
            <a:r>
              <a:rPr lang="en-US" sz="1200" b="1">
                <a:latin typeface="Times New Roman"/>
                <a:cs typeface="Arial"/>
              </a:rPr>
              <a:t>Supplementary Figure 7. </a:t>
            </a:r>
            <a:r>
              <a:rPr lang="en-US" sz="1200">
                <a:latin typeface="Times New Roman"/>
                <a:cs typeface="Arial"/>
              </a:rPr>
              <a:t>Day 150 cell type abundance. (</a:t>
            </a:r>
            <a:r>
              <a:rPr lang="en-US" sz="1200" b="1">
                <a:latin typeface="Times New Roman"/>
                <a:cs typeface="Arial"/>
              </a:rPr>
              <a:t>E</a:t>
            </a:r>
            <a:r>
              <a:rPr lang="en-US" sz="1200">
                <a:latin typeface="Times New Roman"/>
                <a:cs typeface="Arial"/>
              </a:rPr>
              <a:t>) </a:t>
            </a:r>
            <a:r>
              <a:rPr lang="en-US" sz="1200" err="1">
                <a:latin typeface="Times New Roman"/>
                <a:cs typeface="Arial"/>
              </a:rPr>
              <a:t>Barplot</a:t>
            </a:r>
            <a:r>
              <a:rPr lang="en-US" sz="1200">
                <a:latin typeface="Times New Roman"/>
                <a:cs typeface="Arial"/>
              </a:rPr>
              <a:t> showing distribution of each annotated cell type per sample. (</a:t>
            </a:r>
            <a:r>
              <a:rPr lang="en-US" sz="1200" b="1">
                <a:latin typeface="Times New Roman"/>
                <a:cs typeface="Arial"/>
              </a:rPr>
              <a:t>F</a:t>
            </a:r>
            <a:r>
              <a:rPr lang="en-US" sz="1200">
                <a:latin typeface="Times New Roman"/>
                <a:cs typeface="Arial"/>
              </a:rPr>
              <a:t>) UMAP cluster for each sample</a:t>
            </a:r>
          </a:p>
        </p:txBody>
      </p:sp>
      <p:pic>
        <p:nvPicPr>
          <p:cNvPr id="30" name="Picture 29" descr="Chart, bar chart&#10;&#10;Description automatically generated">
            <a:extLst>
              <a:ext uri="{FF2B5EF4-FFF2-40B4-BE49-F238E27FC236}">
                <a16:creationId xmlns:a16="http://schemas.microsoft.com/office/drawing/2014/main" id="{0A4C7A01-96C5-18CC-BB36-A99756515E05}"/>
              </a:ext>
            </a:extLst>
          </p:cNvPr>
          <p:cNvPicPr>
            <a:picLocks noChangeAspect="1"/>
          </p:cNvPicPr>
          <p:nvPr/>
        </p:nvPicPr>
        <p:blipFill>
          <a:blip r:embed="rId2"/>
          <a:stretch>
            <a:fillRect/>
          </a:stretch>
        </p:blipFill>
        <p:spPr>
          <a:xfrm>
            <a:off x="197708" y="1076651"/>
            <a:ext cx="5308600" cy="4927600"/>
          </a:xfrm>
          <a:prstGeom prst="rect">
            <a:avLst/>
          </a:prstGeom>
        </p:spPr>
      </p:pic>
      <p:pic>
        <p:nvPicPr>
          <p:cNvPr id="36" name="Picture 35" descr="Diagram&#10;&#10;Description automatically generated">
            <a:extLst>
              <a:ext uri="{FF2B5EF4-FFF2-40B4-BE49-F238E27FC236}">
                <a16:creationId xmlns:a16="http://schemas.microsoft.com/office/drawing/2014/main" id="{6D1DFC10-3E2D-13FB-E350-44C32AEE665B}"/>
              </a:ext>
            </a:extLst>
          </p:cNvPr>
          <p:cNvPicPr>
            <a:picLocks noChangeAspect="1"/>
          </p:cNvPicPr>
          <p:nvPr/>
        </p:nvPicPr>
        <p:blipFill>
          <a:blip r:embed="rId3"/>
          <a:stretch>
            <a:fillRect/>
          </a:stretch>
        </p:blipFill>
        <p:spPr>
          <a:xfrm>
            <a:off x="5459784" y="1076651"/>
            <a:ext cx="5620369" cy="4927600"/>
          </a:xfrm>
          <a:prstGeom prst="rect">
            <a:avLst/>
          </a:prstGeom>
        </p:spPr>
      </p:pic>
      <p:sp>
        <p:nvSpPr>
          <p:cNvPr id="39" name="TextBox 38">
            <a:extLst>
              <a:ext uri="{FF2B5EF4-FFF2-40B4-BE49-F238E27FC236}">
                <a16:creationId xmlns:a16="http://schemas.microsoft.com/office/drawing/2014/main" id="{5E8D1917-1225-8A00-59B2-D09F31E0C0C7}"/>
              </a:ext>
            </a:extLst>
          </p:cNvPr>
          <p:cNvSpPr txBox="1"/>
          <p:nvPr/>
        </p:nvSpPr>
        <p:spPr>
          <a:xfrm>
            <a:off x="108060" y="1251112"/>
            <a:ext cx="274989" cy="369332"/>
          </a:xfrm>
          <a:prstGeom prst="rect">
            <a:avLst/>
          </a:prstGeom>
          <a:noFill/>
        </p:spPr>
        <p:txBody>
          <a:bodyPr wrap="square" lIns="91440" tIns="45720" rIns="91440" bIns="45720" rtlCol="0" anchor="t">
            <a:spAutoFit/>
          </a:bodyPr>
          <a:lstStyle/>
          <a:p>
            <a:r>
              <a:rPr lang="en-US" b="1"/>
              <a:t>E</a:t>
            </a:r>
          </a:p>
        </p:txBody>
      </p:sp>
      <p:sp>
        <p:nvSpPr>
          <p:cNvPr id="40" name="TextBox 39">
            <a:extLst>
              <a:ext uri="{FF2B5EF4-FFF2-40B4-BE49-F238E27FC236}">
                <a16:creationId xmlns:a16="http://schemas.microsoft.com/office/drawing/2014/main" id="{F3DDBE72-0216-6975-65AB-40BDC7A0604A}"/>
              </a:ext>
            </a:extLst>
          </p:cNvPr>
          <p:cNvSpPr txBox="1"/>
          <p:nvPr/>
        </p:nvSpPr>
        <p:spPr>
          <a:xfrm>
            <a:off x="5231319" y="1254684"/>
            <a:ext cx="274989" cy="369332"/>
          </a:xfrm>
          <a:prstGeom prst="rect">
            <a:avLst/>
          </a:prstGeom>
          <a:noFill/>
        </p:spPr>
        <p:txBody>
          <a:bodyPr wrap="square" lIns="91440" tIns="45720" rIns="91440" bIns="45720" rtlCol="0" anchor="t">
            <a:spAutoFit/>
          </a:bodyPr>
          <a:lstStyle/>
          <a:p>
            <a:r>
              <a:rPr lang="en-US" b="1"/>
              <a:t>F</a:t>
            </a:r>
          </a:p>
        </p:txBody>
      </p:sp>
    </p:spTree>
    <p:extLst>
      <p:ext uri="{BB962C8B-B14F-4D97-AF65-F5344CB8AC3E}">
        <p14:creationId xmlns:p14="http://schemas.microsoft.com/office/powerpoint/2010/main" val="133478194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Content Placeholder 3">
            <a:extLst>
              <a:ext uri="{FF2B5EF4-FFF2-40B4-BE49-F238E27FC236}">
                <a16:creationId xmlns:a16="http://schemas.microsoft.com/office/drawing/2014/main" id="{9A8C3B3F-2BB3-A6A6-DEB4-E8E44B51710B}"/>
              </a:ext>
            </a:extLst>
          </p:cNvPr>
          <p:cNvPicPr>
            <a:picLocks noGrp="1" noChangeAspect="1"/>
          </p:cNvPicPr>
          <p:nvPr>
            <p:ph idx="1"/>
          </p:nvPr>
        </p:nvPicPr>
        <p:blipFill>
          <a:blip r:embed="rId2"/>
          <a:stretch>
            <a:fillRect/>
          </a:stretch>
        </p:blipFill>
        <p:spPr>
          <a:xfrm>
            <a:off x="282575" y="3342473"/>
            <a:ext cx="4826000" cy="2832100"/>
          </a:xfrm>
          <a:prstGeom prst="rect">
            <a:avLst/>
          </a:prstGeom>
        </p:spPr>
      </p:pic>
      <p:sp>
        <p:nvSpPr>
          <p:cNvPr id="15" name="TextBox 14">
            <a:extLst>
              <a:ext uri="{FF2B5EF4-FFF2-40B4-BE49-F238E27FC236}">
                <a16:creationId xmlns:a16="http://schemas.microsoft.com/office/drawing/2014/main" id="{FDE80C30-08A8-5E4C-006B-FC85E00DA56D}"/>
              </a:ext>
            </a:extLst>
          </p:cNvPr>
          <p:cNvSpPr txBox="1"/>
          <p:nvPr/>
        </p:nvSpPr>
        <p:spPr>
          <a:xfrm>
            <a:off x="3886201" y="3643305"/>
            <a:ext cx="1222374" cy="1115218"/>
          </a:xfrm>
          <a:prstGeom prst="rect">
            <a:avLst/>
          </a:prstGeom>
          <a:solidFill>
            <a:schemeClr val="bg1"/>
          </a:solidFill>
        </p:spPr>
        <p:txBody>
          <a:bodyPr wrap="square" rtlCol="0">
            <a:spAutoFit/>
          </a:bodyPr>
          <a:lstStyle/>
          <a:p>
            <a:endParaRPr lang="en-US"/>
          </a:p>
        </p:txBody>
      </p:sp>
      <p:pic>
        <p:nvPicPr>
          <p:cNvPr id="16" name="Picture 15">
            <a:extLst>
              <a:ext uri="{FF2B5EF4-FFF2-40B4-BE49-F238E27FC236}">
                <a16:creationId xmlns:a16="http://schemas.microsoft.com/office/drawing/2014/main" id="{7394E871-54B0-8BD8-857E-BF0F70364EB6}"/>
              </a:ext>
            </a:extLst>
          </p:cNvPr>
          <p:cNvPicPr>
            <a:picLocks noChangeAspect="1"/>
          </p:cNvPicPr>
          <p:nvPr/>
        </p:nvPicPr>
        <p:blipFill>
          <a:blip r:embed="rId3"/>
          <a:stretch>
            <a:fillRect/>
          </a:stretch>
        </p:blipFill>
        <p:spPr>
          <a:xfrm>
            <a:off x="3658395" y="3342473"/>
            <a:ext cx="4826000" cy="2832100"/>
          </a:xfrm>
          <a:prstGeom prst="rect">
            <a:avLst/>
          </a:prstGeom>
        </p:spPr>
      </p:pic>
      <p:sp>
        <p:nvSpPr>
          <p:cNvPr id="17" name="TextBox 16">
            <a:extLst>
              <a:ext uri="{FF2B5EF4-FFF2-40B4-BE49-F238E27FC236}">
                <a16:creationId xmlns:a16="http://schemas.microsoft.com/office/drawing/2014/main" id="{AD360D52-3B39-61E6-E62E-27B076A92788}"/>
              </a:ext>
            </a:extLst>
          </p:cNvPr>
          <p:cNvSpPr txBox="1"/>
          <p:nvPr/>
        </p:nvSpPr>
        <p:spPr>
          <a:xfrm>
            <a:off x="7319170" y="3643305"/>
            <a:ext cx="1357312" cy="1000125"/>
          </a:xfrm>
          <a:prstGeom prst="rect">
            <a:avLst/>
          </a:prstGeom>
          <a:solidFill>
            <a:schemeClr val="bg1"/>
          </a:solidFill>
        </p:spPr>
        <p:txBody>
          <a:bodyPr wrap="square" rtlCol="0">
            <a:spAutoFit/>
          </a:bodyPr>
          <a:lstStyle/>
          <a:p>
            <a:endParaRPr lang="en-US"/>
          </a:p>
        </p:txBody>
      </p:sp>
      <p:pic>
        <p:nvPicPr>
          <p:cNvPr id="18" name="Picture 17">
            <a:extLst>
              <a:ext uri="{FF2B5EF4-FFF2-40B4-BE49-F238E27FC236}">
                <a16:creationId xmlns:a16="http://schemas.microsoft.com/office/drawing/2014/main" id="{18803DB5-8069-B5FA-1C1D-B2EDD5C8F646}"/>
              </a:ext>
            </a:extLst>
          </p:cNvPr>
          <p:cNvPicPr>
            <a:picLocks noChangeAspect="1"/>
          </p:cNvPicPr>
          <p:nvPr/>
        </p:nvPicPr>
        <p:blipFill>
          <a:blip r:embed="rId4"/>
          <a:stretch>
            <a:fillRect/>
          </a:stretch>
        </p:blipFill>
        <p:spPr>
          <a:xfrm>
            <a:off x="7034215" y="3342473"/>
            <a:ext cx="4826000" cy="2832100"/>
          </a:xfrm>
          <a:prstGeom prst="rect">
            <a:avLst/>
          </a:prstGeom>
        </p:spPr>
      </p:pic>
      <p:pic>
        <p:nvPicPr>
          <p:cNvPr id="19" name="Content Placeholder 3">
            <a:extLst>
              <a:ext uri="{FF2B5EF4-FFF2-40B4-BE49-F238E27FC236}">
                <a16:creationId xmlns:a16="http://schemas.microsoft.com/office/drawing/2014/main" id="{10189A94-AE92-12DD-C520-4AE5C2F7D018}"/>
              </a:ext>
            </a:extLst>
          </p:cNvPr>
          <p:cNvPicPr>
            <a:picLocks noChangeAspect="1"/>
          </p:cNvPicPr>
          <p:nvPr/>
        </p:nvPicPr>
        <p:blipFill>
          <a:blip r:embed="rId5"/>
          <a:stretch>
            <a:fillRect/>
          </a:stretch>
        </p:blipFill>
        <p:spPr>
          <a:xfrm>
            <a:off x="282575" y="510373"/>
            <a:ext cx="4826000" cy="2832100"/>
          </a:xfrm>
          <a:prstGeom prst="rect">
            <a:avLst/>
          </a:prstGeom>
        </p:spPr>
      </p:pic>
      <p:sp>
        <p:nvSpPr>
          <p:cNvPr id="20" name="TextBox 19">
            <a:extLst>
              <a:ext uri="{FF2B5EF4-FFF2-40B4-BE49-F238E27FC236}">
                <a16:creationId xmlns:a16="http://schemas.microsoft.com/office/drawing/2014/main" id="{D112320A-F946-555E-D438-E570DDAFA6A6}"/>
              </a:ext>
            </a:extLst>
          </p:cNvPr>
          <p:cNvSpPr txBox="1"/>
          <p:nvPr/>
        </p:nvSpPr>
        <p:spPr>
          <a:xfrm>
            <a:off x="3903663" y="510373"/>
            <a:ext cx="1390649" cy="1173164"/>
          </a:xfrm>
          <a:prstGeom prst="rect">
            <a:avLst/>
          </a:prstGeom>
          <a:solidFill>
            <a:schemeClr val="bg1"/>
          </a:solidFill>
        </p:spPr>
        <p:txBody>
          <a:bodyPr wrap="square" rtlCol="0">
            <a:spAutoFit/>
          </a:bodyPr>
          <a:lstStyle/>
          <a:p>
            <a:endParaRPr lang="en-US"/>
          </a:p>
        </p:txBody>
      </p:sp>
      <p:pic>
        <p:nvPicPr>
          <p:cNvPr id="21" name="Picture 20">
            <a:extLst>
              <a:ext uri="{FF2B5EF4-FFF2-40B4-BE49-F238E27FC236}">
                <a16:creationId xmlns:a16="http://schemas.microsoft.com/office/drawing/2014/main" id="{AA10A6CE-CE7F-EC05-6315-03D3B868FA6D}"/>
              </a:ext>
            </a:extLst>
          </p:cNvPr>
          <p:cNvPicPr>
            <a:picLocks noChangeAspect="1"/>
          </p:cNvPicPr>
          <p:nvPr/>
        </p:nvPicPr>
        <p:blipFill>
          <a:blip r:embed="rId6"/>
          <a:stretch>
            <a:fillRect/>
          </a:stretch>
        </p:blipFill>
        <p:spPr>
          <a:xfrm>
            <a:off x="3962902" y="510373"/>
            <a:ext cx="4826000" cy="2832100"/>
          </a:xfrm>
          <a:prstGeom prst="rect">
            <a:avLst/>
          </a:prstGeom>
        </p:spPr>
      </p:pic>
      <p:sp>
        <p:nvSpPr>
          <p:cNvPr id="22" name="TextBox 21">
            <a:extLst>
              <a:ext uri="{FF2B5EF4-FFF2-40B4-BE49-F238E27FC236}">
                <a16:creationId xmlns:a16="http://schemas.microsoft.com/office/drawing/2014/main" id="{2AFB3728-B12E-9697-7B8D-15A9A90AA745}"/>
              </a:ext>
            </a:extLst>
          </p:cNvPr>
          <p:cNvSpPr txBox="1"/>
          <p:nvPr/>
        </p:nvSpPr>
        <p:spPr>
          <a:xfrm>
            <a:off x="7450561" y="468306"/>
            <a:ext cx="1340934" cy="1257298"/>
          </a:xfrm>
          <a:prstGeom prst="rect">
            <a:avLst/>
          </a:prstGeom>
          <a:solidFill>
            <a:schemeClr val="bg1"/>
          </a:solidFill>
        </p:spPr>
        <p:txBody>
          <a:bodyPr wrap="square" rtlCol="0">
            <a:spAutoFit/>
          </a:bodyPr>
          <a:lstStyle/>
          <a:p>
            <a:endParaRPr lang="en-US"/>
          </a:p>
        </p:txBody>
      </p:sp>
      <p:pic>
        <p:nvPicPr>
          <p:cNvPr id="23" name="Picture 22">
            <a:extLst>
              <a:ext uri="{FF2B5EF4-FFF2-40B4-BE49-F238E27FC236}">
                <a16:creationId xmlns:a16="http://schemas.microsoft.com/office/drawing/2014/main" id="{8698AF6E-F3A0-6B33-158D-4FC2028BAD95}"/>
              </a:ext>
            </a:extLst>
          </p:cNvPr>
          <p:cNvPicPr>
            <a:picLocks noChangeAspect="1"/>
          </p:cNvPicPr>
          <p:nvPr/>
        </p:nvPicPr>
        <p:blipFill>
          <a:blip r:embed="rId7"/>
          <a:stretch>
            <a:fillRect/>
          </a:stretch>
        </p:blipFill>
        <p:spPr>
          <a:xfrm>
            <a:off x="7393409" y="468306"/>
            <a:ext cx="4851400" cy="2832100"/>
          </a:xfrm>
          <a:prstGeom prst="rect">
            <a:avLst/>
          </a:prstGeom>
        </p:spPr>
      </p:pic>
      <p:sp>
        <p:nvSpPr>
          <p:cNvPr id="24" name="TextBox 23">
            <a:extLst>
              <a:ext uri="{FF2B5EF4-FFF2-40B4-BE49-F238E27FC236}">
                <a16:creationId xmlns:a16="http://schemas.microsoft.com/office/drawing/2014/main" id="{E1E41FD8-50E8-966A-8B1C-0426AFFBD036}"/>
              </a:ext>
            </a:extLst>
          </p:cNvPr>
          <p:cNvSpPr txBox="1"/>
          <p:nvPr/>
        </p:nvSpPr>
        <p:spPr>
          <a:xfrm>
            <a:off x="10932106" y="675473"/>
            <a:ext cx="1259894" cy="842963"/>
          </a:xfrm>
          <a:prstGeom prst="rect">
            <a:avLst/>
          </a:prstGeom>
          <a:solidFill>
            <a:schemeClr val="bg1"/>
          </a:solidFill>
        </p:spPr>
        <p:txBody>
          <a:bodyPr wrap="square" rtlCol="0">
            <a:spAutoFit/>
          </a:bodyPr>
          <a:lstStyle/>
          <a:p>
            <a:endParaRPr lang="en-US"/>
          </a:p>
        </p:txBody>
      </p:sp>
      <p:sp>
        <p:nvSpPr>
          <p:cNvPr id="2" name="Title 1">
            <a:extLst>
              <a:ext uri="{FF2B5EF4-FFF2-40B4-BE49-F238E27FC236}">
                <a16:creationId xmlns:a16="http://schemas.microsoft.com/office/drawing/2014/main" id="{82667F74-2893-BFE2-A5E7-2FBEB5E8B53B}"/>
              </a:ext>
            </a:extLst>
          </p:cNvPr>
          <p:cNvSpPr txBox="1">
            <a:spLocks/>
          </p:cNvSpPr>
          <p:nvPr/>
        </p:nvSpPr>
        <p:spPr>
          <a:xfrm>
            <a:off x="200024" y="44026"/>
            <a:ext cx="4776265" cy="588884"/>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a:latin typeface="Times New Roman"/>
                <a:cs typeface="Times New Roman"/>
              </a:rPr>
              <a:t>Supplementary Figure 8</a:t>
            </a:r>
          </a:p>
        </p:txBody>
      </p:sp>
      <p:sp>
        <p:nvSpPr>
          <p:cNvPr id="4" name="TextBox 3">
            <a:extLst>
              <a:ext uri="{FF2B5EF4-FFF2-40B4-BE49-F238E27FC236}">
                <a16:creationId xmlns:a16="http://schemas.microsoft.com/office/drawing/2014/main" id="{E3664156-874B-2D91-E149-1CABE8A0A5AB}"/>
              </a:ext>
            </a:extLst>
          </p:cNvPr>
          <p:cNvSpPr txBox="1"/>
          <p:nvPr/>
        </p:nvSpPr>
        <p:spPr>
          <a:xfrm>
            <a:off x="419485" y="6182698"/>
            <a:ext cx="10979059" cy="646331"/>
          </a:xfrm>
          <a:prstGeom prst="rect">
            <a:avLst/>
          </a:prstGeom>
          <a:noFill/>
        </p:spPr>
        <p:txBody>
          <a:bodyPr wrap="square" lIns="91440" tIns="45720" rIns="91440" bIns="45720" rtlCol="0" anchor="t">
            <a:spAutoFit/>
          </a:bodyPr>
          <a:lstStyle/>
          <a:p>
            <a:r>
              <a:rPr lang="en-US" sz="1200" b="1">
                <a:latin typeface="Times New Roman"/>
                <a:cs typeface="Arial"/>
              </a:rPr>
              <a:t>Supplementary Figure 8. </a:t>
            </a:r>
            <a:r>
              <a:rPr lang="en-US" sz="1200">
                <a:latin typeface="Times New Roman"/>
                <a:cs typeface="Arial"/>
              </a:rPr>
              <a:t>Intracellular cytokine data for Pfsz stimulated CD4 and CD8 T cells. (</a:t>
            </a:r>
            <a:r>
              <a:rPr lang="en-US" sz="1200" b="1">
                <a:latin typeface="Times New Roman"/>
                <a:cs typeface="Arial"/>
              </a:rPr>
              <a:t>A</a:t>
            </a:r>
            <a:r>
              <a:rPr lang="en-US" sz="1200">
                <a:latin typeface="Times New Roman"/>
                <a:cs typeface="Arial"/>
              </a:rPr>
              <a:t>) Dot plot showing CD4 cytokines at day 0. (</a:t>
            </a:r>
            <a:r>
              <a:rPr lang="en-US" sz="1200" b="1">
                <a:latin typeface="Times New Roman"/>
                <a:cs typeface="Arial"/>
              </a:rPr>
              <a:t>B</a:t>
            </a:r>
            <a:r>
              <a:rPr lang="en-US" sz="1200">
                <a:latin typeface="Times New Roman"/>
                <a:cs typeface="Arial"/>
              </a:rPr>
              <a:t>) Dot plot showing CD4 cytokines at day 90. (</a:t>
            </a:r>
            <a:r>
              <a:rPr lang="en-US" sz="1200" b="1">
                <a:latin typeface="Times New Roman"/>
                <a:cs typeface="Arial"/>
              </a:rPr>
              <a:t>C</a:t>
            </a:r>
            <a:r>
              <a:rPr lang="en-US" sz="1200">
                <a:latin typeface="Times New Roman"/>
                <a:cs typeface="Arial"/>
              </a:rPr>
              <a:t>) Dot plot showing CD4 cytokines at day 150. (</a:t>
            </a:r>
            <a:r>
              <a:rPr lang="en-US" sz="1200" b="1">
                <a:latin typeface="Times New Roman"/>
                <a:cs typeface="Arial"/>
              </a:rPr>
              <a:t>D</a:t>
            </a:r>
            <a:r>
              <a:rPr lang="en-US" sz="1200">
                <a:latin typeface="Times New Roman"/>
                <a:cs typeface="Arial"/>
              </a:rPr>
              <a:t>) Dot plot showing CD8 cytokines at day 0. (</a:t>
            </a:r>
            <a:r>
              <a:rPr lang="en-US" sz="1200" b="1">
                <a:latin typeface="Times New Roman"/>
                <a:cs typeface="Arial"/>
              </a:rPr>
              <a:t>E</a:t>
            </a:r>
            <a:r>
              <a:rPr lang="en-US" sz="1200">
                <a:latin typeface="Times New Roman"/>
                <a:cs typeface="Arial"/>
              </a:rPr>
              <a:t>) Dot plot showing CD8 cytokines at day 90. (</a:t>
            </a:r>
            <a:r>
              <a:rPr lang="en-US" sz="1200" b="1">
                <a:latin typeface="Times New Roman"/>
                <a:cs typeface="Arial"/>
              </a:rPr>
              <a:t>F</a:t>
            </a:r>
            <a:r>
              <a:rPr lang="en-US" sz="1200">
                <a:latin typeface="Times New Roman"/>
                <a:cs typeface="Arial"/>
              </a:rPr>
              <a:t>) Dot plot showing CD8 cytokines at day 150. Data for protected children is shown in blue and data in susceptible children is shown in red.</a:t>
            </a:r>
          </a:p>
        </p:txBody>
      </p:sp>
      <p:sp>
        <p:nvSpPr>
          <p:cNvPr id="8" name="TextBox 7">
            <a:extLst>
              <a:ext uri="{FF2B5EF4-FFF2-40B4-BE49-F238E27FC236}">
                <a16:creationId xmlns:a16="http://schemas.microsoft.com/office/drawing/2014/main" id="{29B103E6-E9D2-6089-7B55-E768637DA6FC}"/>
              </a:ext>
            </a:extLst>
          </p:cNvPr>
          <p:cNvSpPr txBox="1"/>
          <p:nvPr/>
        </p:nvSpPr>
        <p:spPr>
          <a:xfrm>
            <a:off x="419485" y="513719"/>
            <a:ext cx="274989" cy="369332"/>
          </a:xfrm>
          <a:prstGeom prst="rect">
            <a:avLst/>
          </a:prstGeom>
          <a:noFill/>
        </p:spPr>
        <p:txBody>
          <a:bodyPr wrap="square" lIns="91440" tIns="45720" rIns="91440" bIns="45720" rtlCol="0" anchor="t">
            <a:spAutoFit/>
          </a:bodyPr>
          <a:lstStyle/>
          <a:p>
            <a:r>
              <a:rPr lang="en-US" b="1"/>
              <a:t>A</a:t>
            </a:r>
          </a:p>
        </p:txBody>
      </p:sp>
      <p:sp>
        <p:nvSpPr>
          <p:cNvPr id="9" name="TextBox 8">
            <a:extLst>
              <a:ext uri="{FF2B5EF4-FFF2-40B4-BE49-F238E27FC236}">
                <a16:creationId xmlns:a16="http://schemas.microsoft.com/office/drawing/2014/main" id="{6668E0E3-71B6-8D49-D603-6D3E798F690A}"/>
              </a:ext>
            </a:extLst>
          </p:cNvPr>
          <p:cNvSpPr txBox="1"/>
          <p:nvPr/>
        </p:nvSpPr>
        <p:spPr>
          <a:xfrm>
            <a:off x="4079064" y="574263"/>
            <a:ext cx="274989" cy="369332"/>
          </a:xfrm>
          <a:prstGeom prst="rect">
            <a:avLst/>
          </a:prstGeom>
          <a:noFill/>
        </p:spPr>
        <p:txBody>
          <a:bodyPr wrap="square" lIns="91440" tIns="45720" rIns="91440" bIns="45720" rtlCol="0" anchor="t">
            <a:spAutoFit/>
          </a:bodyPr>
          <a:lstStyle/>
          <a:p>
            <a:r>
              <a:rPr lang="en-US" b="1"/>
              <a:t>B</a:t>
            </a:r>
          </a:p>
        </p:txBody>
      </p:sp>
      <p:sp>
        <p:nvSpPr>
          <p:cNvPr id="10" name="TextBox 9">
            <a:extLst>
              <a:ext uri="{FF2B5EF4-FFF2-40B4-BE49-F238E27FC236}">
                <a16:creationId xmlns:a16="http://schemas.microsoft.com/office/drawing/2014/main" id="{56FB164F-8D67-D8E2-9C0F-8F4C64FBD289}"/>
              </a:ext>
            </a:extLst>
          </p:cNvPr>
          <p:cNvSpPr txBox="1"/>
          <p:nvPr/>
        </p:nvSpPr>
        <p:spPr>
          <a:xfrm>
            <a:off x="7444550" y="569315"/>
            <a:ext cx="274990" cy="369332"/>
          </a:xfrm>
          <a:prstGeom prst="rect">
            <a:avLst/>
          </a:prstGeom>
          <a:noFill/>
        </p:spPr>
        <p:txBody>
          <a:bodyPr wrap="square" lIns="91440" tIns="45720" rIns="91440" bIns="45720" rtlCol="0" anchor="t">
            <a:spAutoFit/>
          </a:bodyPr>
          <a:lstStyle/>
          <a:p>
            <a:r>
              <a:rPr lang="en-US" b="1"/>
              <a:t>C</a:t>
            </a:r>
          </a:p>
        </p:txBody>
      </p:sp>
      <p:sp>
        <p:nvSpPr>
          <p:cNvPr id="11" name="TextBox 10">
            <a:extLst>
              <a:ext uri="{FF2B5EF4-FFF2-40B4-BE49-F238E27FC236}">
                <a16:creationId xmlns:a16="http://schemas.microsoft.com/office/drawing/2014/main" id="{69123EC7-43F6-AED8-DE60-F4DEE35C1004}"/>
              </a:ext>
            </a:extLst>
          </p:cNvPr>
          <p:cNvSpPr txBox="1"/>
          <p:nvPr/>
        </p:nvSpPr>
        <p:spPr>
          <a:xfrm>
            <a:off x="500630" y="3275266"/>
            <a:ext cx="274989" cy="369332"/>
          </a:xfrm>
          <a:prstGeom prst="rect">
            <a:avLst/>
          </a:prstGeom>
          <a:noFill/>
        </p:spPr>
        <p:txBody>
          <a:bodyPr wrap="square" lIns="91440" tIns="45720" rIns="91440" bIns="45720" rtlCol="0" anchor="t">
            <a:spAutoFit/>
          </a:bodyPr>
          <a:lstStyle/>
          <a:p>
            <a:r>
              <a:rPr lang="en-US" b="1"/>
              <a:t>D</a:t>
            </a:r>
          </a:p>
        </p:txBody>
      </p:sp>
      <p:sp>
        <p:nvSpPr>
          <p:cNvPr id="12" name="TextBox 11">
            <a:extLst>
              <a:ext uri="{FF2B5EF4-FFF2-40B4-BE49-F238E27FC236}">
                <a16:creationId xmlns:a16="http://schemas.microsoft.com/office/drawing/2014/main" id="{5F4077B9-9BFB-26F2-0A24-1C658BA39C20}"/>
              </a:ext>
            </a:extLst>
          </p:cNvPr>
          <p:cNvSpPr txBox="1"/>
          <p:nvPr/>
        </p:nvSpPr>
        <p:spPr>
          <a:xfrm>
            <a:off x="4160209" y="3335810"/>
            <a:ext cx="274989" cy="369332"/>
          </a:xfrm>
          <a:prstGeom prst="rect">
            <a:avLst/>
          </a:prstGeom>
          <a:noFill/>
        </p:spPr>
        <p:txBody>
          <a:bodyPr wrap="square" lIns="91440" tIns="45720" rIns="91440" bIns="45720" rtlCol="0" anchor="t">
            <a:spAutoFit/>
          </a:bodyPr>
          <a:lstStyle/>
          <a:p>
            <a:r>
              <a:rPr lang="en-US" b="1"/>
              <a:t>E</a:t>
            </a:r>
          </a:p>
        </p:txBody>
      </p:sp>
      <p:sp>
        <p:nvSpPr>
          <p:cNvPr id="13" name="TextBox 12">
            <a:extLst>
              <a:ext uri="{FF2B5EF4-FFF2-40B4-BE49-F238E27FC236}">
                <a16:creationId xmlns:a16="http://schemas.microsoft.com/office/drawing/2014/main" id="{65DAB209-E56D-1DAE-0378-3DF837C878AC}"/>
              </a:ext>
            </a:extLst>
          </p:cNvPr>
          <p:cNvSpPr txBox="1"/>
          <p:nvPr/>
        </p:nvSpPr>
        <p:spPr>
          <a:xfrm>
            <a:off x="7525695" y="3330862"/>
            <a:ext cx="274990" cy="369332"/>
          </a:xfrm>
          <a:prstGeom prst="rect">
            <a:avLst/>
          </a:prstGeom>
          <a:noFill/>
        </p:spPr>
        <p:txBody>
          <a:bodyPr wrap="square" lIns="91440" tIns="45720" rIns="91440" bIns="45720" rtlCol="0" anchor="t">
            <a:spAutoFit/>
          </a:bodyPr>
          <a:lstStyle/>
          <a:p>
            <a:r>
              <a:rPr lang="en-US" b="1"/>
              <a:t>F</a:t>
            </a:r>
          </a:p>
        </p:txBody>
      </p:sp>
    </p:spTree>
    <p:extLst>
      <p:ext uri="{BB962C8B-B14F-4D97-AF65-F5344CB8AC3E}">
        <p14:creationId xmlns:p14="http://schemas.microsoft.com/office/powerpoint/2010/main" val="48334633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7E446341-0DB1-0F87-C8FB-0BF4BAE7D571}"/>
              </a:ext>
            </a:extLst>
          </p:cNvPr>
          <p:cNvSpPr txBox="1"/>
          <p:nvPr/>
        </p:nvSpPr>
        <p:spPr>
          <a:xfrm>
            <a:off x="415636" y="5401589"/>
            <a:ext cx="10979059" cy="1384995"/>
          </a:xfrm>
          <a:prstGeom prst="rect">
            <a:avLst/>
          </a:prstGeom>
          <a:noFill/>
        </p:spPr>
        <p:txBody>
          <a:bodyPr wrap="square" lIns="91440" tIns="45720" rIns="91440" bIns="45720" rtlCol="0" anchor="t">
            <a:spAutoFit/>
          </a:bodyPr>
          <a:lstStyle/>
          <a:p>
            <a:r>
              <a:rPr lang="en-US" sz="1200" b="1">
                <a:latin typeface="Times New Roman"/>
                <a:cs typeface="Arial"/>
              </a:rPr>
              <a:t>Supplementary Figure 9. </a:t>
            </a:r>
            <a:r>
              <a:rPr lang="en-US" sz="1200">
                <a:latin typeface="Times New Roman"/>
                <a:cs typeface="Arial"/>
              </a:rPr>
              <a:t>(</a:t>
            </a:r>
            <a:r>
              <a:rPr lang="en-US" sz="1200" b="1">
                <a:latin typeface="Times New Roman"/>
                <a:cs typeface="Arial"/>
              </a:rPr>
              <a:t>A</a:t>
            </a:r>
            <a:r>
              <a:rPr lang="en-US" sz="1200">
                <a:latin typeface="Times New Roman"/>
                <a:cs typeface="Arial"/>
              </a:rPr>
              <a:t>-</a:t>
            </a:r>
            <a:r>
              <a:rPr lang="en-US" sz="1200" b="1">
                <a:latin typeface="Times New Roman"/>
                <a:cs typeface="Arial"/>
              </a:rPr>
              <a:t>C</a:t>
            </a:r>
            <a:r>
              <a:rPr lang="en-US" sz="1200">
                <a:latin typeface="Times New Roman"/>
                <a:cs typeface="Arial"/>
              </a:rPr>
              <a:t>) </a:t>
            </a:r>
            <a:r>
              <a:rPr lang="en-US" sz="1200">
                <a:effectLst/>
                <a:latin typeface="Times New Roman" panose="02020603050405020304" pitchFamily="18" charset="0"/>
                <a:ea typeface="Calibri" panose="020F0502020204030204" pitchFamily="34" charset="0"/>
                <a:cs typeface="Times New Roman" panose="02020603050405020304" pitchFamily="18" charset="0"/>
              </a:rPr>
              <a:t>Box plots displaying overall median expression of intracellular markers within T cells (CD3</a:t>
            </a:r>
            <a:r>
              <a:rPr lang="en-US" sz="1200" baseline="30000">
                <a:effectLst/>
                <a:latin typeface="Times New Roman" panose="02020603050405020304" pitchFamily="18" charset="0"/>
                <a:ea typeface="Calibri" panose="020F0502020204030204" pitchFamily="34" charset="0"/>
                <a:cs typeface="Times New Roman" panose="02020603050405020304" pitchFamily="18" charset="0"/>
              </a:rPr>
              <a:t>+</a:t>
            </a:r>
            <a:r>
              <a:rPr lang="en-US" sz="1200">
                <a:effectLst/>
                <a:latin typeface="Times New Roman" panose="02020603050405020304" pitchFamily="18" charset="0"/>
                <a:ea typeface="Calibri" panose="020F0502020204030204" pitchFamily="34" charset="0"/>
                <a:cs typeface="Times New Roman" panose="02020603050405020304" pitchFamily="18" charset="0"/>
              </a:rPr>
              <a:t>) of Pfsz stimulated-CD25 depleted PBMCs. Expression values were subjected to Z-score scaling, transforming the values to have a mean of 0 and a standard deviation of 1 across all cells. Negative expression values indicate that the average expression of a marker is lower relative to the other markers and positive expression values indicate that the average expression of a marker is higher relative to the other markers. Expression levels for protected children are indicated in red and expression levels for susceptible children are indicated in teal. Expression values from each child are indicated by a unique shape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A</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at day 0.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B</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at day 90.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C</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at day 150.</a:t>
            </a:r>
          </a:p>
          <a:p>
            <a:endParaRPr lang="en-US" sz="1200">
              <a:latin typeface="Times New Roman"/>
              <a:cs typeface="Arial"/>
            </a:endParaRPr>
          </a:p>
        </p:txBody>
      </p:sp>
      <p:sp>
        <p:nvSpPr>
          <p:cNvPr id="2" name="Title 1">
            <a:extLst>
              <a:ext uri="{FF2B5EF4-FFF2-40B4-BE49-F238E27FC236}">
                <a16:creationId xmlns:a16="http://schemas.microsoft.com/office/drawing/2014/main" id="{C54CCC29-F8A9-8426-80CD-1C39157772CA}"/>
              </a:ext>
            </a:extLst>
          </p:cNvPr>
          <p:cNvSpPr txBox="1">
            <a:spLocks/>
          </p:cNvSpPr>
          <p:nvPr/>
        </p:nvSpPr>
        <p:spPr>
          <a:xfrm>
            <a:off x="200024" y="44026"/>
            <a:ext cx="4776265" cy="588884"/>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a:latin typeface="Times New Roman"/>
                <a:cs typeface="Times New Roman"/>
              </a:rPr>
              <a:t>Supplementary Figure 9</a:t>
            </a:r>
          </a:p>
        </p:txBody>
      </p:sp>
      <p:pic>
        <p:nvPicPr>
          <p:cNvPr id="9" name="Picture 8" descr="A screenshot of a graph&#10;&#10;Description automatically generated with low confidence">
            <a:extLst>
              <a:ext uri="{FF2B5EF4-FFF2-40B4-BE49-F238E27FC236}">
                <a16:creationId xmlns:a16="http://schemas.microsoft.com/office/drawing/2014/main" id="{F5463806-9733-8824-33B0-5D481B74C1F3}"/>
              </a:ext>
            </a:extLst>
          </p:cNvPr>
          <p:cNvPicPr>
            <a:picLocks noChangeAspect="1"/>
          </p:cNvPicPr>
          <p:nvPr/>
        </p:nvPicPr>
        <p:blipFill>
          <a:blip r:embed="rId2"/>
          <a:stretch>
            <a:fillRect/>
          </a:stretch>
        </p:blipFill>
        <p:spPr>
          <a:xfrm>
            <a:off x="7479322" y="1040863"/>
            <a:ext cx="3440361" cy="4156856"/>
          </a:xfrm>
          <a:prstGeom prst="rect">
            <a:avLst/>
          </a:prstGeom>
        </p:spPr>
      </p:pic>
      <p:sp>
        <p:nvSpPr>
          <p:cNvPr id="25" name="TextBox 24">
            <a:extLst>
              <a:ext uri="{FF2B5EF4-FFF2-40B4-BE49-F238E27FC236}">
                <a16:creationId xmlns:a16="http://schemas.microsoft.com/office/drawing/2014/main" id="{91A656DC-4D78-42F8-F0DB-8602E44F306F}"/>
              </a:ext>
            </a:extLst>
          </p:cNvPr>
          <p:cNvSpPr txBox="1"/>
          <p:nvPr/>
        </p:nvSpPr>
        <p:spPr>
          <a:xfrm>
            <a:off x="1586890" y="647375"/>
            <a:ext cx="905957" cy="307777"/>
          </a:xfrm>
          <a:prstGeom prst="rect">
            <a:avLst/>
          </a:prstGeom>
          <a:noFill/>
        </p:spPr>
        <p:txBody>
          <a:bodyPr wrap="square" rtlCol="0">
            <a:spAutoFit/>
          </a:bodyPr>
          <a:lstStyle/>
          <a:p>
            <a:r>
              <a:rPr lang="en-US" sz="1400" b="1" dirty="0">
                <a:latin typeface="Helvetica" pitchFamily="2" charset="0"/>
              </a:rPr>
              <a:t>Day 0</a:t>
            </a:r>
          </a:p>
        </p:txBody>
      </p:sp>
      <p:sp>
        <p:nvSpPr>
          <p:cNvPr id="26" name="TextBox 25">
            <a:extLst>
              <a:ext uri="{FF2B5EF4-FFF2-40B4-BE49-F238E27FC236}">
                <a16:creationId xmlns:a16="http://schemas.microsoft.com/office/drawing/2014/main" id="{79B86359-5E90-1C2C-A7A7-B0545B7EB915}"/>
              </a:ext>
            </a:extLst>
          </p:cNvPr>
          <p:cNvSpPr txBox="1"/>
          <p:nvPr/>
        </p:nvSpPr>
        <p:spPr>
          <a:xfrm>
            <a:off x="5515331" y="693454"/>
            <a:ext cx="905957" cy="307777"/>
          </a:xfrm>
          <a:prstGeom prst="rect">
            <a:avLst/>
          </a:prstGeom>
          <a:noFill/>
        </p:spPr>
        <p:txBody>
          <a:bodyPr wrap="square" rtlCol="0">
            <a:spAutoFit/>
          </a:bodyPr>
          <a:lstStyle/>
          <a:p>
            <a:r>
              <a:rPr lang="en-US" sz="1400" b="1" dirty="0">
                <a:latin typeface="Helvetica" pitchFamily="2" charset="0"/>
              </a:rPr>
              <a:t>Day 90</a:t>
            </a:r>
          </a:p>
        </p:txBody>
      </p:sp>
      <p:sp>
        <p:nvSpPr>
          <p:cNvPr id="27" name="TextBox 26">
            <a:extLst>
              <a:ext uri="{FF2B5EF4-FFF2-40B4-BE49-F238E27FC236}">
                <a16:creationId xmlns:a16="http://schemas.microsoft.com/office/drawing/2014/main" id="{E3DD5883-31CB-EA39-513D-F3CAD1DD3135}"/>
              </a:ext>
            </a:extLst>
          </p:cNvPr>
          <p:cNvSpPr txBox="1"/>
          <p:nvPr/>
        </p:nvSpPr>
        <p:spPr>
          <a:xfrm>
            <a:off x="8517803" y="647375"/>
            <a:ext cx="1149604" cy="307777"/>
          </a:xfrm>
          <a:prstGeom prst="rect">
            <a:avLst/>
          </a:prstGeom>
          <a:noFill/>
        </p:spPr>
        <p:txBody>
          <a:bodyPr wrap="square" rtlCol="0">
            <a:spAutoFit/>
          </a:bodyPr>
          <a:lstStyle/>
          <a:p>
            <a:r>
              <a:rPr lang="en-US" sz="1400" b="1" dirty="0">
                <a:latin typeface="Helvetica" pitchFamily="2" charset="0"/>
              </a:rPr>
              <a:t>Day 150</a:t>
            </a:r>
          </a:p>
        </p:txBody>
      </p:sp>
      <p:sp>
        <p:nvSpPr>
          <p:cNvPr id="28" name="TextBox 27">
            <a:extLst>
              <a:ext uri="{FF2B5EF4-FFF2-40B4-BE49-F238E27FC236}">
                <a16:creationId xmlns:a16="http://schemas.microsoft.com/office/drawing/2014/main" id="{B1C4FBCC-04B4-A60C-761A-378256DD5BDC}"/>
              </a:ext>
            </a:extLst>
          </p:cNvPr>
          <p:cNvSpPr txBox="1"/>
          <p:nvPr/>
        </p:nvSpPr>
        <p:spPr>
          <a:xfrm>
            <a:off x="136244" y="693454"/>
            <a:ext cx="274989" cy="369332"/>
          </a:xfrm>
          <a:prstGeom prst="rect">
            <a:avLst/>
          </a:prstGeom>
          <a:noFill/>
        </p:spPr>
        <p:txBody>
          <a:bodyPr wrap="square" lIns="91440" tIns="45720" rIns="91440" bIns="45720" rtlCol="0" anchor="t">
            <a:spAutoFit/>
          </a:bodyPr>
          <a:lstStyle/>
          <a:p>
            <a:r>
              <a:rPr lang="en-US" b="1"/>
              <a:t>A</a:t>
            </a:r>
          </a:p>
        </p:txBody>
      </p:sp>
      <p:sp>
        <p:nvSpPr>
          <p:cNvPr id="29" name="TextBox 28">
            <a:extLst>
              <a:ext uri="{FF2B5EF4-FFF2-40B4-BE49-F238E27FC236}">
                <a16:creationId xmlns:a16="http://schemas.microsoft.com/office/drawing/2014/main" id="{E747FE25-5CF0-A7C5-15B9-86CE22D4D2CC}"/>
              </a:ext>
            </a:extLst>
          </p:cNvPr>
          <p:cNvSpPr txBox="1"/>
          <p:nvPr/>
        </p:nvSpPr>
        <p:spPr>
          <a:xfrm>
            <a:off x="3795823" y="693454"/>
            <a:ext cx="274989" cy="369332"/>
          </a:xfrm>
          <a:prstGeom prst="rect">
            <a:avLst/>
          </a:prstGeom>
          <a:noFill/>
        </p:spPr>
        <p:txBody>
          <a:bodyPr wrap="square" lIns="91440" tIns="45720" rIns="91440" bIns="45720" rtlCol="0" anchor="t">
            <a:spAutoFit/>
          </a:bodyPr>
          <a:lstStyle/>
          <a:p>
            <a:r>
              <a:rPr lang="en-US" b="1"/>
              <a:t>B</a:t>
            </a:r>
          </a:p>
        </p:txBody>
      </p:sp>
      <p:sp>
        <p:nvSpPr>
          <p:cNvPr id="30" name="TextBox 29">
            <a:extLst>
              <a:ext uri="{FF2B5EF4-FFF2-40B4-BE49-F238E27FC236}">
                <a16:creationId xmlns:a16="http://schemas.microsoft.com/office/drawing/2014/main" id="{32B884EE-5D44-327C-F5D1-F6B1520CECB2}"/>
              </a:ext>
            </a:extLst>
          </p:cNvPr>
          <p:cNvSpPr txBox="1"/>
          <p:nvPr/>
        </p:nvSpPr>
        <p:spPr>
          <a:xfrm>
            <a:off x="7140826" y="693454"/>
            <a:ext cx="274990" cy="369332"/>
          </a:xfrm>
          <a:prstGeom prst="rect">
            <a:avLst/>
          </a:prstGeom>
          <a:noFill/>
        </p:spPr>
        <p:txBody>
          <a:bodyPr wrap="square" lIns="91440" tIns="45720" rIns="91440" bIns="45720" rtlCol="0" anchor="t">
            <a:spAutoFit/>
          </a:bodyPr>
          <a:lstStyle/>
          <a:p>
            <a:r>
              <a:rPr lang="en-US" b="1"/>
              <a:t>C</a:t>
            </a:r>
          </a:p>
        </p:txBody>
      </p:sp>
      <p:pic>
        <p:nvPicPr>
          <p:cNvPr id="34" name="Picture 33" descr="A picture containing text, diagram, plan, schematic&#10;&#10;Description automatically generated">
            <a:extLst>
              <a:ext uri="{FF2B5EF4-FFF2-40B4-BE49-F238E27FC236}">
                <a16:creationId xmlns:a16="http://schemas.microsoft.com/office/drawing/2014/main" id="{A4A8A901-7D14-E8A4-30BB-57FCF0EC805E}"/>
              </a:ext>
            </a:extLst>
          </p:cNvPr>
          <p:cNvPicPr>
            <a:picLocks noChangeAspect="1"/>
          </p:cNvPicPr>
          <p:nvPr/>
        </p:nvPicPr>
        <p:blipFill>
          <a:blip r:embed="rId3"/>
          <a:stretch>
            <a:fillRect/>
          </a:stretch>
        </p:blipFill>
        <p:spPr>
          <a:xfrm>
            <a:off x="373419" y="1000329"/>
            <a:ext cx="3578558" cy="4237924"/>
          </a:xfrm>
          <a:prstGeom prst="rect">
            <a:avLst/>
          </a:prstGeom>
        </p:spPr>
      </p:pic>
      <p:pic>
        <p:nvPicPr>
          <p:cNvPr id="36" name="Picture 35" descr="A screenshot of a graph&#10;&#10;Description automatically generated with low confidence">
            <a:extLst>
              <a:ext uri="{FF2B5EF4-FFF2-40B4-BE49-F238E27FC236}">
                <a16:creationId xmlns:a16="http://schemas.microsoft.com/office/drawing/2014/main" id="{0A6199D0-0FED-2508-5B3D-4A69F64184F0}"/>
              </a:ext>
            </a:extLst>
          </p:cNvPr>
          <p:cNvPicPr>
            <a:picLocks noChangeAspect="1"/>
          </p:cNvPicPr>
          <p:nvPr/>
        </p:nvPicPr>
        <p:blipFill>
          <a:blip r:embed="rId4"/>
          <a:stretch>
            <a:fillRect/>
          </a:stretch>
        </p:blipFill>
        <p:spPr>
          <a:xfrm>
            <a:off x="3992692" y="1015857"/>
            <a:ext cx="3486630" cy="4263444"/>
          </a:xfrm>
          <a:prstGeom prst="rect">
            <a:avLst/>
          </a:prstGeom>
        </p:spPr>
      </p:pic>
      <p:pic>
        <p:nvPicPr>
          <p:cNvPr id="38" name="Picture 37" descr="A picture containing font, text, screenshot, graphics&#10;&#10;Description automatically generated">
            <a:extLst>
              <a:ext uri="{FF2B5EF4-FFF2-40B4-BE49-F238E27FC236}">
                <a16:creationId xmlns:a16="http://schemas.microsoft.com/office/drawing/2014/main" id="{4E930D0B-C98D-A216-4607-A13E508BA6EE}"/>
              </a:ext>
            </a:extLst>
          </p:cNvPr>
          <p:cNvPicPr>
            <a:picLocks noChangeAspect="1"/>
          </p:cNvPicPr>
          <p:nvPr/>
        </p:nvPicPr>
        <p:blipFill>
          <a:blip r:embed="rId5"/>
          <a:stretch>
            <a:fillRect/>
          </a:stretch>
        </p:blipFill>
        <p:spPr>
          <a:xfrm>
            <a:off x="10983189" y="3677724"/>
            <a:ext cx="998388" cy="621638"/>
          </a:xfrm>
          <a:prstGeom prst="rect">
            <a:avLst/>
          </a:prstGeom>
        </p:spPr>
      </p:pic>
    </p:spTree>
    <p:extLst>
      <p:ext uri="{BB962C8B-B14F-4D97-AF65-F5344CB8AC3E}">
        <p14:creationId xmlns:p14="http://schemas.microsoft.com/office/powerpoint/2010/main" val="110320032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94CE87A6-6D12-EC1A-B1F4-D4FCEB284F38}"/>
              </a:ext>
            </a:extLst>
          </p:cNvPr>
          <p:cNvSpPr txBox="1">
            <a:spLocks/>
          </p:cNvSpPr>
          <p:nvPr/>
        </p:nvSpPr>
        <p:spPr>
          <a:xfrm>
            <a:off x="200024" y="44026"/>
            <a:ext cx="4776265" cy="588884"/>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a:latin typeface="Times New Roman"/>
                <a:cs typeface="Times New Roman"/>
              </a:rPr>
              <a:t>Supplementary Figure 10</a:t>
            </a:r>
          </a:p>
        </p:txBody>
      </p:sp>
      <p:sp>
        <p:nvSpPr>
          <p:cNvPr id="8" name="TextBox 7">
            <a:extLst>
              <a:ext uri="{FF2B5EF4-FFF2-40B4-BE49-F238E27FC236}">
                <a16:creationId xmlns:a16="http://schemas.microsoft.com/office/drawing/2014/main" id="{D498D8F3-EA53-D7E0-4A86-94027ED98F66}"/>
              </a:ext>
            </a:extLst>
          </p:cNvPr>
          <p:cNvSpPr txBox="1"/>
          <p:nvPr/>
        </p:nvSpPr>
        <p:spPr>
          <a:xfrm>
            <a:off x="200024" y="5331023"/>
            <a:ext cx="11578341" cy="1569660"/>
          </a:xfrm>
          <a:prstGeom prst="rect">
            <a:avLst/>
          </a:prstGeom>
          <a:noFill/>
        </p:spPr>
        <p:txBody>
          <a:bodyPr wrap="square" lIns="91440" tIns="45720" rIns="91440" bIns="45720" rtlCol="0" anchor="t">
            <a:spAutoFit/>
          </a:bodyPr>
          <a:lstStyle/>
          <a:p>
            <a:r>
              <a:rPr lang="en-US" sz="1200" b="1">
                <a:latin typeface="Times New Roman"/>
                <a:cs typeface="Arial"/>
              </a:rPr>
              <a:t>Supplementary Figure 10. </a:t>
            </a:r>
            <a:r>
              <a:rPr lang="en-US" sz="1200">
                <a:latin typeface="Times New Roman"/>
                <a:cs typeface="Arial"/>
              </a:rPr>
              <a:t>(</a:t>
            </a:r>
            <a:r>
              <a:rPr lang="en-US" sz="1200" b="1">
                <a:latin typeface="Times New Roman"/>
                <a:cs typeface="Arial"/>
              </a:rPr>
              <a:t>A</a:t>
            </a:r>
            <a:r>
              <a:rPr lang="en-US" sz="1200">
                <a:latin typeface="Times New Roman"/>
                <a:cs typeface="Arial"/>
              </a:rPr>
              <a:t>-</a:t>
            </a:r>
            <a:r>
              <a:rPr lang="en-US" sz="1200" b="1">
                <a:latin typeface="Times New Roman"/>
                <a:cs typeface="Arial"/>
              </a:rPr>
              <a:t>F</a:t>
            </a:r>
            <a:r>
              <a:rPr lang="en-US" sz="1200">
                <a:latin typeface="Times New Roman"/>
                <a:cs typeface="Arial"/>
              </a:rPr>
              <a:t>) Boxplot showing median expression of intracellular markers within </a:t>
            </a:r>
            <a:r>
              <a:rPr lang="en-US" sz="1200">
                <a:effectLst/>
                <a:latin typeface="Times New Roman" panose="02020603050405020304" pitchFamily="18" charset="0"/>
                <a:ea typeface="Calibri" panose="020F0502020204030204" pitchFamily="34" charset="0"/>
                <a:cs typeface="Times New Roman" panose="02020603050405020304" pitchFamily="18" charset="0"/>
              </a:rPr>
              <a:t>T cells (CD3</a:t>
            </a:r>
            <a:r>
              <a:rPr lang="en-US" sz="1200" baseline="30000">
                <a:effectLst/>
                <a:latin typeface="Times New Roman" panose="02020603050405020304" pitchFamily="18" charset="0"/>
                <a:ea typeface="Calibri" panose="020F0502020204030204" pitchFamily="34" charset="0"/>
                <a:cs typeface="Times New Roman" panose="02020603050405020304" pitchFamily="18" charset="0"/>
              </a:rPr>
              <a:t>+</a:t>
            </a:r>
            <a:r>
              <a:rPr lang="en-US" sz="1200">
                <a:effectLst/>
                <a:latin typeface="Times New Roman" panose="02020603050405020304" pitchFamily="18" charset="0"/>
                <a:ea typeface="Calibri" panose="020F0502020204030204" pitchFamily="34" charset="0"/>
                <a:cs typeface="Times New Roman" panose="02020603050405020304" pitchFamily="18" charset="0"/>
              </a:rPr>
              <a:t>) of</a:t>
            </a:r>
            <a:r>
              <a:rPr lang="en-US" sz="1200">
                <a:latin typeface="Times New Roman"/>
                <a:cs typeface="Arial"/>
              </a:rPr>
              <a:t> </a:t>
            </a:r>
            <a:r>
              <a:rPr lang="en-US" sz="1200" i="1">
                <a:latin typeface="Times New Roman"/>
                <a:cs typeface="Arial"/>
              </a:rPr>
              <a:t>Pfsz </a:t>
            </a:r>
            <a:r>
              <a:rPr lang="en-US" sz="1200">
                <a:latin typeface="Times New Roman"/>
                <a:cs typeface="Arial"/>
              </a:rPr>
              <a:t>stimulated PBMCs before and after CD25 depletion. </a:t>
            </a:r>
            <a:r>
              <a:rPr lang="en-US" sz="1200">
                <a:effectLst/>
                <a:latin typeface="Times New Roman" panose="02020603050405020304" pitchFamily="18" charset="0"/>
                <a:ea typeface="Calibri" panose="020F0502020204030204" pitchFamily="34" charset="0"/>
                <a:cs typeface="Times New Roman" panose="02020603050405020304" pitchFamily="18" charset="0"/>
              </a:rPr>
              <a:t>Expression values were subjected to Z-score scaling, transforming the values to have a mean of 0 and a standard deviation of 1 across all cells. Negative expression values indicate that the average expression of a marker is lower relative to the other markers and positive expression values indicate that the average expression of a marker is higher relative to the other markers. Expression levels for CD25 positive cells are indicated in orange and expression levels for CD25 depleted cells are indicated in purple. Expression values from each child are indicated by a unique shape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A</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protected children at day 0.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B</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protected children at day 90.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C</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protected </a:t>
            </a:r>
            <a:r>
              <a:rPr lang="en-US" sz="1200">
                <a:latin typeface="Times New Roman" panose="02020603050405020304" pitchFamily="18" charset="0"/>
                <a:ea typeface="Calibri" panose="020F0502020204030204" pitchFamily="34" charset="0"/>
                <a:cs typeface="Times New Roman" panose="02020603050405020304" pitchFamily="18" charset="0"/>
              </a:rPr>
              <a:t>children</a:t>
            </a:r>
            <a:r>
              <a:rPr lang="en-US" sz="1200">
                <a:effectLst/>
                <a:latin typeface="Times New Roman" panose="02020603050405020304" pitchFamily="18" charset="0"/>
                <a:ea typeface="Calibri" panose="020F0502020204030204" pitchFamily="34" charset="0"/>
                <a:cs typeface="Times New Roman" panose="02020603050405020304" pitchFamily="18" charset="0"/>
              </a:rPr>
              <a:t> at day 150.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D</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susceptible children at day 0. (</a:t>
            </a:r>
            <a:r>
              <a:rPr lang="en-US" sz="1200" b="1">
                <a:latin typeface="Times New Roman" panose="02020603050405020304" pitchFamily="18" charset="0"/>
                <a:ea typeface="Calibri" panose="020F0502020204030204" pitchFamily="34" charset="0"/>
                <a:cs typeface="Times New Roman" panose="02020603050405020304" pitchFamily="18" charset="0"/>
              </a:rPr>
              <a:t>E</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susceptible children at day 90. (</a:t>
            </a:r>
            <a:r>
              <a:rPr lang="en-US" sz="1200" b="1">
                <a:latin typeface="Times New Roman" panose="02020603050405020304" pitchFamily="18" charset="0"/>
                <a:ea typeface="Calibri" panose="020F0502020204030204" pitchFamily="34" charset="0"/>
                <a:cs typeface="Times New Roman" panose="02020603050405020304" pitchFamily="18" charset="0"/>
              </a:rPr>
              <a:t>F</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susceptible </a:t>
            </a:r>
            <a:r>
              <a:rPr lang="en-US" sz="1200">
                <a:latin typeface="Times New Roman" panose="02020603050405020304" pitchFamily="18" charset="0"/>
                <a:ea typeface="Calibri" panose="020F0502020204030204" pitchFamily="34" charset="0"/>
                <a:cs typeface="Times New Roman" panose="02020603050405020304" pitchFamily="18" charset="0"/>
              </a:rPr>
              <a:t>children</a:t>
            </a:r>
            <a:r>
              <a:rPr lang="en-US" sz="1200">
                <a:effectLst/>
                <a:latin typeface="Times New Roman" panose="02020603050405020304" pitchFamily="18" charset="0"/>
                <a:ea typeface="Calibri" panose="020F0502020204030204" pitchFamily="34" charset="0"/>
                <a:cs typeface="Times New Roman" panose="02020603050405020304" pitchFamily="18" charset="0"/>
              </a:rPr>
              <a:t> at day 150.</a:t>
            </a:r>
          </a:p>
          <a:p>
            <a:r>
              <a:rPr lang="en-US" sz="1200">
                <a:latin typeface="Times New Roman"/>
                <a:cs typeface="Arial"/>
              </a:rPr>
              <a:t> </a:t>
            </a:r>
          </a:p>
        </p:txBody>
      </p:sp>
      <p:pic>
        <p:nvPicPr>
          <p:cNvPr id="4" name="Picture 3" descr="A picture containing text, font, screenshot, typography&#10;&#10;Description automatically generated">
            <a:extLst>
              <a:ext uri="{FF2B5EF4-FFF2-40B4-BE49-F238E27FC236}">
                <a16:creationId xmlns:a16="http://schemas.microsoft.com/office/drawing/2014/main" id="{FC8D1B52-A843-D9A7-B4EC-07CCDBF99C04}"/>
              </a:ext>
            </a:extLst>
          </p:cNvPr>
          <p:cNvPicPr>
            <a:picLocks noChangeAspect="1"/>
          </p:cNvPicPr>
          <p:nvPr/>
        </p:nvPicPr>
        <p:blipFill>
          <a:blip r:embed="rId2"/>
          <a:stretch>
            <a:fillRect/>
          </a:stretch>
        </p:blipFill>
        <p:spPr>
          <a:xfrm>
            <a:off x="10641158" y="1916461"/>
            <a:ext cx="1308100" cy="2146300"/>
          </a:xfrm>
          <a:prstGeom prst="rect">
            <a:avLst/>
          </a:prstGeom>
        </p:spPr>
      </p:pic>
      <p:pic>
        <p:nvPicPr>
          <p:cNvPr id="7" name="Picture 6" descr="A black text on a white background&#10;&#10;Description automatically generated with low confidence">
            <a:extLst>
              <a:ext uri="{FF2B5EF4-FFF2-40B4-BE49-F238E27FC236}">
                <a16:creationId xmlns:a16="http://schemas.microsoft.com/office/drawing/2014/main" id="{D0A84560-77B8-2368-64C0-C5071114341A}"/>
              </a:ext>
            </a:extLst>
          </p:cNvPr>
          <p:cNvPicPr>
            <a:picLocks noChangeAspect="1"/>
          </p:cNvPicPr>
          <p:nvPr/>
        </p:nvPicPr>
        <p:blipFill>
          <a:blip r:embed="rId3"/>
          <a:stretch>
            <a:fillRect/>
          </a:stretch>
        </p:blipFill>
        <p:spPr>
          <a:xfrm>
            <a:off x="10676525" y="1076928"/>
            <a:ext cx="1237365" cy="609164"/>
          </a:xfrm>
          <a:prstGeom prst="rect">
            <a:avLst/>
          </a:prstGeom>
        </p:spPr>
      </p:pic>
      <p:pic>
        <p:nvPicPr>
          <p:cNvPr id="14" name="Picture 13">
            <a:extLst>
              <a:ext uri="{FF2B5EF4-FFF2-40B4-BE49-F238E27FC236}">
                <a16:creationId xmlns:a16="http://schemas.microsoft.com/office/drawing/2014/main" id="{99743A2E-5391-3251-A00D-27014C6F1EB6}"/>
              </a:ext>
            </a:extLst>
          </p:cNvPr>
          <p:cNvPicPr>
            <a:picLocks noChangeAspect="1"/>
          </p:cNvPicPr>
          <p:nvPr/>
        </p:nvPicPr>
        <p:blipFill>
          <a:blip r:embed="rId4"/>
          <a:stretch>
            <a:fillRect/>
          </a:stretch>
        </p:blipFill>
        <p:spPr>
          <a:xfrm>
            <a:off x="404031" y="910254"/>
            <a:ext cx="3225175" cy="4028599"/>
          </a:xfrm>
          <a:prstGeom prst="rect">
            <a:avLst/>
          </a:prstGeom>
        </p:spPr>
      </p:pic>
      <p:pic>
        <p:nvPicPr>
          <p:cNvPr id="16" name="Picture 15" descr="A picture containing diagram, text, plan, line&#10;&#10;Description automatically generated">
            <a:extLst>
              <a:ext uri="{FF2B5EF4-FFF2-40B4-BE49-F238E27FC236}">
                <a16:creationId xmlns:a16="http://schemas.microsoft.com/office/drawing/2014/main" id="{5870B6F0-13C1-35E5-456E-1950BAC1A00F}"/>
              </a:ext>
            </a:extLst>
          </p:cNvPr>
          <p:cNvPicPr>
            <a:picLocks noChangeAspect="1"/>
          </p:cNvPicPr>
          <p:nvPr/>
        </p:nvPicPr>
        <p:blipFill>
          <a:blip r:embed="rId5"/>
          <a:stretch>
            <a:fillRect/>
          </a:stretch>
        </p:blipFill>
        <p:spPr>
          <a:xfrm>
            <a:off x="3745572" y="910255"/>
            <a:ext cx="3225175" cy="4028599"/>
          </a:xfrm>
          <a:prstGeom prst="rect">
            <a:avLst/>
          </a:prstGeom>
        </p:spPr>
      </p:pic>
      <p:pic>
        <p:nvPicPr>
          <p:cNvPr id="18" name="Picture 17" descr="A picture containing diagram, text, plan, line&#10;&#10;Description automatically generated">
            <a:extLst>
              <a:ext uri="{FF2B5EF4-FFF2-40B4-BE49-F238E27FC236}">
                <a16:creationId xmlns:a16="http://schemas.microsoft.com/office/drawing/2014/main" id="{52C99325-4B55-185B-7B79-4BE062A8AE41}"/>
              </a:ext>
            </a:extLst>
          </p:cNvPr>
          <p:cNvPicPr>
            <a:picLocks noChangeAspect="1"/>
          </p:cNvPicPr>
          <p:nvPr/>
        </p:nvPicPr>
        <p:blipFill>
          <a:blip r:embed="rId6"/>
          <a:stretch>
            <a:fillRect/>
          </a:stretch>
        </p:blipFill>
        <p:spPr>
          <a:xfrm>
            <a:off x="7059466" y="910254"/>
            <a:ext cx="3225175" cy="4028599"/>
          </a:xfrm>
          <a:prstGeom prst="rect">
            <a:avLst/>
          </a:prstGeom>
        </p:spPr>
      </p:pic>
      <p:sp>
        <p:nvSpPr>
          <p:cNvPr id="33" name="TextBox 32">
            <a:extLst>
              <a:ext uri="{FF2B5EF4-FFF2-40B4-BE49-F238E27FC236}">
                <a16:creationId xmlns:a16="http://schemas.microsoft.com/office/drawing/2014/main" id="{7BDA99A6-7C28-FD21-9546-CA5EC74FDD2C}"/>
              </a:ext>
            </a:extLst>
          </p:cNvPr>
          <p:cNvSpPr txBox="1"/>
          <p:nvPr/>
        </p:nvSpPr>
        <p:spPr>
          <a:xfrm rot="16200000">
            <a:off x="-672212" y="2737134"/>
            <a:ext cx="2046833" cy="307777"/>
          </a:xfrm>
          <a:prstGeom prst="rect">
            <a:avLst/>
          </a:prstGeom>
          <a:noFill/>
        </p:spPr>
        <p:txBody>
          <a:bodyPr wrap="square" rtlCol="0">
            <a:spAutoFit/>
          </a:bodyPr>
          <a:lstStyle/>
          <a:p>
            <a:r>
              <a:rPr lang="en-US" sz="1400" dirty="0">
                <a:latin typeface="Helvetica" pitchFamily="2" charset="0"/>
              </a:rPr>
              <a:t>Median Expression</a:t>
            </a:r>
          </a:p>
        </p:txBody>
      </p:sp>
      <p:sp>
        <p:nvSpPr>
          <p:cNvPr id="34" name="TextBox 33">
            <a:extLst>
              <a:ext uri="{FF2B5EF4-FFF2-40B4-BE49-F238E27FC236}">
                <a16:creationId xmlns:a16="http://schemas.microsoft.com/office/drawing/2014/main" id="{68CE9A4D-BAD6-132A-3A09-803B027563C9}"/>
              </a:ext>
            </a:extLst>
          </p:cNvPr>
          <p:cNvSpPr txBox="1"/>
          <p:nvPr/>
        </p:nvSpPr>
        <p:spPr>
          <a:xfrm>
            <a:off x="5156238" y="5080521"/>
            <a:ext cx="2046833" cy="307777"/>
          </a:xfrm>
          <a:prstGeom prst="rect">
            <a:avLst/>
          </a:prstGeom>
          <a:noFill/>
        </p:spPr>
        <p:txBody>
          <a:bodyPr wrap="square" rtlCol="0">
            <a:spAutoFit/>
          </a:bodyPr>
          <a:lstStyle/>
          <a:p>
            <a:r>
              <a:rPr lang="en-US" sz="1400" dirty="0">
                <a:latin typeface="Helvetica" pitchFamily="2" charset="0"/>
              </a:rPr>
              <a:t>Condition</a:t>
            </a:r>
          </a:p>
        </p:txBody>
      </p:sp>
      <p:sp>
        <p:nvSpPr>
          <p:cNvPr id="35" name="TextBox 34">
            <a:extLst>
              <a:ext uri="{FF2B5EF4-FFF2-40B4-BE49-F238E27FC236}">
                <a16:creationId xmlns:a16="http://schemas.microsoft.com/office/drawing/2014/main" id="{FD024F63-EB7E-0317-7DD2-C295E7CF5AED}"/>
              </a:ext>
            </a:extLst>
          </p:cNvPr>
          <p:cNvSpPr txBox="1"/>
          <p:nvPr/>
        </p:nvSpPr>
        <p:spPr>
          <a:xfrm>
            <a:off x="1079806" y="590147"/>
            <a:ext cx="2046833" cy="338554"/>
          </a:xfrm>
          <a:prstGeom prst="rect">
            <a:avLst/>
          </a:prstGeom>
          <a:noFill/>
        </p:spPr>
        <p:txBody>
          <a:bodyPr wrap="square" rtlCol="0">
            <a:spAutoFit/>
          </a:bodyPr>
          <a:lstStyle/>
          <a:p>
            <a:r>
              <a:rPr lang="en-US" sz="1600" b="1" dirty="0">
                <a:latin typeface="Helvetica" pitchFamily="2" charset="0"/>
              </a:rPr>
              <a:t>Day 0 Protected</a:t>
            </a:r>
          </a:p>
        </p:txBody>
      </p:sp>
      <p:sp>
        <p:nvSpPr>
          <p:cNvPr id="36" name="TextBox 35">
            <a:extLst>
              <a:ext uri="{FF2B5EF4-FFF2-40B4-BE49-F238E27FC236}">
                <a16:creationId xmlns:a16="http://schemas.microsoft.com/office/drawing/2014/main" id="{F45AB62A-AD18-364F-1A69-BC7CE92B9AA2}"/>
              </a:ext>
            </a:extLst>
          </p:cNvPr>
          <p:cNvSpPr txBox="1"/>
          <p:nvPr/>
        </p:nvSpPr>
        <p:spPr>
          <a:xfrm>
            <a:off x="528516" y="553896"/>
            <a:ext cx="274989" cy="369332"/>
          </a:xfrm>
          <a:prstGeom prst="rect">
            <a:avLst/>
          </a:prstGeom>
          <a:noFill/>
        </p:spPr>
        <p:txBody>
          <a:bodyPr wrap="square" lIns="91440" tIns="45720" rIns="91440" bIns="45720" rtlCol="0" anchor="t">
            <a:spAutoFit/>
          </a:bodyPr>
          <a:lstStyle/>
          <a:p>
            <a:r>
              <a:rPr lang="en-US" b="1"/>
              <a:t>A</a:t>
            </a:r>
          </a:p>
        </p:txBody>
      </p:sp>
      <p:sp>
        <p:nvSpPr>
          <p:cNvPr id="37" name="TextBox 36">
            <a:extLst>
              <a:ext uri="{FF2B5EF4-FFF2-40B4-BE49-F238E27FC236}">
                <a16:creationId xmlns:a16="http://schemas.microsoft.com/office/drawing/2014/main" id="{DDC3FA11-521B-3757-AE40-3FEB42FFC97F}"/>
              </a:ext>
            </a:extLst>
          </p:cNvPr>
          <p:cNvSpPr txBox="1"/>
          <p:nvPr/>
        </p:nvSpPr>
        <p:spPr>
          <a:xfrm>
            <a:off x="4004578" y="571576"/>
            <a:ext cx="274989" cy="369332"/>
          </a:xfrm>
          <a:prstGeom prst="rect">
            <a:avLst/>
          </a:prstGeom>
          <a:noFill/>
        </p:spPr>
        <p:txBody>
          <a:bodyPr wrap="square" lIns="91440" tIns="45720" rIns="91440" bIns="45720" rtlCol="0" anchor="t">
            <a:spAutoFit/>
          </a:bodyPr>
          <a:lstStyle/>
          <a:p>
            <a:r>
              <a:rPr lang="en-US" b="1"/>
              <a:t>B</a:t>
            </a:r>
          </a:p>
        </p:txBody>
      </p:sp>
      <p:sp>
        <p:nvSpPr>
          <p:cNvPr id="38" name="TextBox 37">
            <a:extLst>
              <a:ext uri="{FF2B5EF4-FFF2-40B4-BE49-F238E27FC236}">
                <a16:creationId xmlns:a16="http://schemas.microsoft.com/office/drawing/2014/main" id="{8C8FEBF3-8785-FBBA-7BD0-3D18CBFCBA8F}"/>
              </a:ext>
            </a:extLst>
          </p:cNvPr>
          <p:cNvSpPr txBox="1"/>
          <p:nvPr/>
        </p:nvSpPr>
        <p:spPr>
          <a:xfrm>
            <a:off x="7367669" y="614456"/>
            <a:ext cx="274990" cy="369332"/>
          </a:xfrm>
          <a:prstGeom prst="rect">
            <a:avLst/>
          </a:prstGeom>
          <a:noFill/>
        </p:spPr>
        <p:txBody>
          <a:bodyPr wrap="square" lIns="91440" tIns="45720" rIns="91440" bIns="45720" rtlCol="0" anchor="t">
            <a:spAutoFit/>
          </a:bodyPr>
          <a:lstStyle/>
          <a:p>
            <a:r>
              <a:rPr lang="en-US" b="1"/>
              <a:t>C</a:t>
            </a:r>
          </a:p>
        </p:txBody>
      </p:sp>
      <p:sp>
        <p:nvSpPr>
          <p:cNvPr id="39" name="TextBox 38">
            <a:extLst>
              <a:ext uri="{FF2B5EF4-FFF2-40B4-BE49-F238E27FC236}">
                <a16:creationId xmlns:a16="http://schemas.microsoft.com/office/drawing/2014/main" id="{A91F0F94-3BBA-6E55-881A-0A3BB6C5B58C}"/>
              </a:ext>
            </a:extLst>
          </p:cNvPr>
          <p:cNvSpPr txBox="1"/>
          <p:nvPr/>
        </p:nvSpPr>
        <p:spPr>
          <a:xfrm>
            <a:off x="4785668" y="536684"/>
            <a:ext cx="2046833" cy="338554"/>
          </a:xfrm>
          <a:prstGeom prst="rect">
            <a:avLst/>
          </a:prstGeom>
          <a:noFill/>
        </p:spPr>
        <p:txBody>
          <a:bodyPr wrap="square" rtlCol="0">
            <a:spAutoFit/>
          </a:bodyPr>
          <a:lstStyle/>
          <a:p>
            <a:r>
              <a:rPr lang="en-US" sz="1600" b="1" dirty="0">
                <a:latin typeface="Helvetica" pitchFamily="2" charset="0"/>
              </a:rPr>
              <a:t>Day 90 Protected</a:t>
            </a:r>
          </a:p>
        </p:txBody>
      </p:sp>
      <p:sp>
        <p:nvSpPr>
          <p:cNvPr id="40" name="TextBox 39">
            <a:extLst>
              <a:ext uri="{FF2B5EF4-FFF2-40B4-BE49-F238E27FC236}">
                <a16:creationId xmlns:a16="http://schemas.microsoft.com/office/drawing/2014/main" id="{0365F0F6-C0F4-6C9E-2BE9-439F8B82ED73}"/>
              </a:ext>
            </a:extLst>
          </p:cNvPr>
          <p:cNvSpPr txBox="1"/>
          <p:nvPr/>
        </p:nvSpPr>
        <p:spPr>
          <a:xfrm>
            <a:off x="8019056" y="569285"/>
            <a:ext cx="2046833" cy="338554"/>
          </a:xfrm>
          <a:prstGeom prst="rect">
            <a:avLst/>
          </a:prstGeom>
          <a:noFill/>
        </p:spPr>
        <p:txBody>
          <a:bodyPr wrap="square" rtlCol="0">
            <a:spAutoFit/>
          </a:bodyPr>
          <a:lstStyle/>
          <a:p>
            <a:r>
              <a:rPr lang="en-US" sz="1600" b="1" dirty="0">
                <a:latin typeface="Helvetica" pitchFamily="2" charset="0"/>
              </a:rPr>
              <a:t>Day 150 Protected</a:t>
            </a:r>
          </a:p>
        </p:txBody>
      </p:sp>
    </p:spTree>
    <p:extLst>
      <p:ext uri="{BB962C8B-B14F-4D97-AF65-F5344CB8AC3E}">
        <p14:creationId xmlns:p14="http://schemas.microsoft.com/office/powerpoint/2010/main" val="344702582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354B093C-BF4A-EDAA-72F2-A766BB4F86BD}"/>
              </a:ext>
            </a:extLst>
          </p:cNvPr>
          <p:cNvSpPr txBox="1">
            <a:spLocks/>
          </p:cNvSpPr>
          <p:nvPr/>
        </p:nvSpPr>
        <p:spPr>
          <a:xfrm>
            <a:off x="197315" y="-61144"/>
            <a:ext cx="4776265" cy="588884"/>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a:latin typeface="Times New Roman"/>
                <a:cs typeface="Times New Roman"/>
              </a:rPr>
              <a:t>Supplementary Figure 10</a:t>
            </a:r>
          </a:p>
        </p:txBody>
      </p:sp>
      <p:sp>
        <p:nvSpPr>
          <p:cNvPr id="7" name="TextBox 6">
            <a:extLst>
              <a:ext uri="{FF2B5EF4-FFF2-40B4-BE49-F238E27FC236}">
                <a16:creationId xmlns:a16="http://schemas.microsoft.com/office/drawing/2014/main" id="{C40FF799-6783-7CCE-2D58-F16ABE4FAC43}"/>
              </a:ext>
            </a:extLst>
          </p:cNvPr>
          <p:cNvSpPr txBox="1"/>
          <p:nvPr/>
        </p:nvSpPr>
        <p:spPr>
          <a:xfrm>
            <a:off x="200024" y="5331023"/>
            <a:ext cx="11578341" cy="1569660"/>
          </a:xfrm>
          <a:prstGeom prst="rect">
            <a:avLst/>
          </a:prstGeom>
          <a:noFill/>
        </p:spPr>
        <p:txBody>
          <a:bodyPr wrap="square" lIns="91440" tIns="45720" rIns="91440" bIns="45720" rtlCol="0" anchor="t">
            <a:spAutoFit/>
          </a:bodyPr>
          <a:lstStyle/>
          <a:p>
            <a:r>
              <a:rPr lang="en-US" sz="1200" b="1">
                <a:latin typeface="Times New Roman"/>
                <a:cs typeface="Arial"/>
              </a:rPr>
              <a:t>Supplementary Figure 10. </a:t>
            </a:r>
            <a:r>
              <a:rPr lang="en-US" sz="1200">
                <a:latin typeface="Times New Roman"/>
                <a:cs typeface="Arial"/>
              </a:rPr>
              <a:t>(</a:t>
            </a:r>
            <a:r>
              <a:rPr lang="en-US" sz="1200" b="1">
                <a:latin typeface="Times New Roman"/>
                <a:cs typeface="Arial"/>
              </a:rPr>
              <a:t>A</a:t>
            </a:r>
            <a:r>
              <a:rPr lang="en-US" sz="1200">
                <a:latin typeface="Times New Roman"/>
                <a:cs typeface="Arial"/>
              </a:rPr>
              <a:t>-</a:t>
            </a:r>
            <a:r>
              <a:rPr lang="en-US" sz="1200" b="1">
                <a:latin typeface="Times New Roman"/>
                <a:cs typeface="Arial"/>
              </a:rPr>
              <a:t>F</a:t>
            </a:r>
            <a:r>
              <a:rPr lang="en-US" sz="1200">
                <a:latin typeface="Times New Roman"/>
                <a:cs typeface="Arial"/>
              </a:rPr>
              <a:t>) Boxplot showing median expression of intracellular markers within </a:t>
            </a:r>
            <a:r>
              <a:rPr lang="en-US" sz="1200">
                <a:effectLst/>
                <a:latin typeface="Times New Roman" panose="02020603050405020304" pitchFamily="18" charset="0"/>
                <a:ea typeface="Calibri" panose="020F0502020204030204" pitchFamily="34" charset="0"/>
                <a:cs typeface="Times New Roman" panose="02020603050405020304" pitchFamily="18" charset="0"/>
              </a:rPr>
              <a:t>T cells (CD3</a:t>
            </a:r>
            <a:r>
              <a:rPr lang="en-US" sz="1200" baseline="30000">
                <a:effectLst/>
                <a:latin typeface="Times New Roman" panose="02020603050405020304" pitchFamily="18" charset="0"/>
                <a:ea typeface="Calibri" panose="020F0502020204030204" pitchFamily="34" charset="0"/>
                <a:cs typeface="Times New Roman" panose="02020603050405020304" pitchFamily="18" charset="0"/>
              </a:rPr>
              <a:t>+</a:t>
            </a:r>
            <a:r>
              <a:rPr lang="en-US" sz="1200">
                <a:effectLst/>
                <a:latin typeface="Times New Roman" panose="02020603050405020304" pitchFamily="18" charset="0"/>
                <a:ea typeface="Calibri" panose="020F0502020204030204" pitchFamily="34" charset="0"/>
                <a:cs typeface="Times New Roman" panose="02020603050405020304" pitchFamily="18" charset="0"/>
              </a:rPr>
              <a:t>) of</a:t>
            </a:r>
            <a:r>
              <a:rPr lang="en-US" sz="1200">
                <a:latin typeface="Times New Roman"/>
                <a:cs typeface="Arial"/>
              </a:rPr>
              <a:t> </a:t>
            </a:r>
            <a:r>
              <a:rPr lang="en-US" sz="1200" i="1">
                <a:latin typeface="Times New Roman"/>
                <a:cs typeface="Arial"/>
              </a:rPr>
              <a:t>Pfsz </a:t>
            </a:r>
            <a:r>
              <a:rPr lang="en-US" sz="1200">
                <a:latin typeface="Times New Roman"/>
                <a:cs typeface="Arial"/>
              </a:rPr>
              <a:t>stimulated PBMCs before and after CD25 depletion. </a:t>
            </a:r>
            <a:r>
              <a:rPr lang="en-US" sz="1200">
                <a:effectLst/>
                <a:latin typeface="Times New Roman" panose="02020603050405020304" pitchFamily="18" charset="0"/>
                <a:ea typeface="Calibri" panose="020F0502020204030204" pitchFamily="34" charset="0"/>
                <a:cs typeface="Times New Roman" panose="02020603050405020304" pitchFamily="18" charset="0"/>
              </a:rPr>
              <a:t>Expression values were subjected to Z-score scaling, transforming the values to have a mean of 0 and a standard deviation of 1 across all cells. Negative expression values indicate that the average expression of a marker is lower relative to the other markers and positive expression values indicate that the average expression of a marker is higher relative to the other markers. Expression levels for CD25 positive cells are indicated in orange and expression levels for CD25 depleted cells are indicated in purple. Expression values from each child are indicated by a unique shape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A</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protected children at day 0.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B</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protected children at day 90.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C</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protected </a:t>
            </a:r>
            <a:r>
              <a:rPr lang="en-US" sz="1200">
                <a:latin typeface="Times New Roman" panose="02020603050405020304" pitchFamily="18" charset="0"/>
                <a:ea typeface="Calibri" panose="020F0502020204030204" pitchFamily="34" charset="0"/>
                <a:cs typeface="Times New Roman" panose="02020603050405020304" pitchFamily="18" charset="0"/>
              </a:rPr>
              <a:t>children</a:t>
            </a:r>
            <a:r>
              <a:rPr lang="en-US" sz="1200">
                <a:effectLst/>
                <a:latin typeface="Times New Roman" panose="02020603050405020304" pitchFamily="18" charset="0"/>
                <a:ea typeface="Calibri" panose="020F0502020204030204" pitchFamily="34" charset="0"/>
                <a:cs typeface="Times New Roman" panose="02020603050405020304" pitchFamily="18" charset="0"/>
              </a:rPr>
              <a:t> at day 150. (</a:t>
            </a:r>
            <a:r>
              <a:rPr lang="en-US" sz="1200" b="1">
                <a:effectLst/>
                <a:latin typeface="Times New Roman" panose="02020603050405020304" pitchFamily="18" charset="0"/>
                <a:ea typeface="Calibri" panose="020F0502020204030204" pitchFamily="34" charset="0"/>
                <a:cs typeface="Times New Roman" panose="02020603050405020304" pitchFamily="18" charset="0"/>
              </a:rPr>
              <a:t>D</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susceptible children at day 0. (</a:t>
            </a:r>
            <a:r>
              <a:rPr lang="en-US" sz="1200" b="1">
                <a:latin typeface="Times New Roman" panose="02020603050405020304" pitchFamily="18" charset="0"/>
                <a:ea typeface="Calibri" panose="020F0502020204030204" pitchFamily="34" charset="0"/>
                <a:cs typeface="Times New Roman" panose="02020603050405020304" pitchFamily="18" charset="0"/>
              </a:rPr>
              <a:t>E</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susceptible children at day 90. (</a:t>
            </a:r>
            <a:r>
              <a:rPr lang="en-US" sz="1200" b="1">
                <a:latin typeface="Times New Roman" panose="02020603050405020304" pitchFamily="18" charset="0"/>
                <a:ea typeface="Calibri" panose="020F0502020204030204" pitchFamily="34" charset="0"/>
                <a:cs typeface="Times New Roman" panose="02020603050405020304" pitchFamily="18" charset="0"/>
              </a:rPr>
              <a:t>F</a:t>
            </a:r>
            <a:r>
              <a:rPr lang="en-US" sz="1200">
                <a:effectLst/>
                <a:latin typeface="Times New Roman" panose="02020603050405020304" pitchFamily="18" charset="0"/>
                <a:ea typeface="Calibri" panose="020F0502020204030204" pitchFamily="34" charset="0"/>
                <a:cs typeface="Times New Roman" panose="02020603050405020304" pitchFamily="18" charset="0"/>
              </a:rPr>
              <a:t>) Median expression for molecules in susceptible </a:t>
            </a:r>
            <a:r>
              <a:rPr lang="en-US" sz="1200">
                <a:latin typeface="Times New Roman" panose="02020603050405020304" pitchFamily="18" charset="0"/>
                <a:ea typeface="Calibri" panose="020F0502020204030204" pitchFamily="34" charset="0"/>
                <a:cs typeface="Times New Roman" panose="02020603050405020304" pitchFamily="18" charset="0"/>
              </a:rPr>
              <a:t>children</a:t>
            </a:r>
            <a:r>
              <a:rPr lang="en-US" sz="1200">
                <a:effectLst/>
                <a:latin typeface="Times New Roman" panose="02020603050405020304" pitchFamily="18" charset="0"/>
                <a:ea typeface="Calibri" panose="020F0502020204030204" pitchFamily="34" charset="0"/>
                <a:cs typeface="Times New Roman" panose="02020603050405020304" pitchFamily="18" charset="0"/>
              </a:rPr>
              <a:t> at day 150.</a:t>
            </a:r>
          </a:p>
          <a:p>
            <a:r>
              <a:rPr lang="en-US" sz="1200">
                <a:latin typeface="Times New Roman"/>
                <a:cs typeface="Arial"/>
              </a:rPr>
              <a:t> </a:t>
            </a:r>
          </a:p>
        </p:txBody>
      </p:sp>
      <p:sp>
        <p:nvSpPr>
          <p:cNvPr id="26" name="TextBox 25">
            <a:extLst>
              <a:ext uri="{FF2B5EF4-FFF2-40B4-BE49-F238E27FC236}">
                <a16:creationId xmlns:a16="http://schemas.microsoft.com/office/drawing/2014/main" id="{004820D5-3AE3-D929-4CA7-2538DB85961A}"/>
              </a:ext>
            </a:extLst>
          </p:cNvPr>
          <p:cNvSpPr txBox="1"/>
          <p:nvPr/>
        </p:nvSpPr>
        <p:spPr>
          <a:xfrm rot="16200000">
            <a:off x="-672212" y="2737134"/>
            <a:ext cx="2046833" cy="307777"/>
          </a:xfrm>
          <a:prstGeom prst="rect">
            <a:avLst/>
          </a:prstGeom>
          <a:noFill/>
        </p:spPr>
        <p:txBody>
          <a:bodyPr wrap="square" rtlCol="0">
            <a:spAutoFit/>
          </a:bodyPr>
          <a:lstStyle/>
          <a:p>
            <a:r>
              <a:rPr lang="en-US" sz="1400">
                <a:latin typeface="Helvetica" pitchFamily="2" charset="0"/>
              </a:rPr>
              <a:t>Median Expression</a:t>
            </a:r>
          </a:p>
        </p:txBody>
      </p:sp>
      <p:sp>
        <p:nvSpPr>
          <p:cNvPr id="28" name="TextBox 27">
            <a:extLst>
              <a:ext uri="{FF2B5EF4-FFF2-40B4-BE49-F238E27FC236}">
                <a16:creationId xmlns:a16="http://schemas.microsoft.com/office/drawing/2014/main" id="{BCCA7770-08D6-452B-DF83-6174C3AEB62F}"/>
              </a:ext>
            </a:extLst>
          </p:cNvPr>
          <p:cNvSpPr txBox="1"/>
          <p:nvPr/>
        </p:nvSpPr>
        <p:spPr>
          <a:xfrm>
            <a:off x="5156238" y="5080521"/>
            <a:ext cx="2046833" cy="307777"/>
          </a:xfrm>
          <a:prstGeom prst="rect">
            <a:avLst/>
          </a:prstGeom>
          <a:noFill/>
        </p:spPr>
        <p:txBody>
          <a:bodyPr wrap="square" rtlCol="0">
            <a:spAutoFit/>
          </a:bodyPr>
          <a:lstStyle/>
          <a:p>
            <a:r>
              <a:rPr lang="en-US" sz="1400">
                <a:latin typeface="Helvetica" pitchFamily="2" charset="0"/>
              </a:rPr>
              <a:t>Condition</a:t>
            </a:r>
          </a:p>
        </p:txBody>
      </p:sp>
      <p:pic>
        <p:nvPicPr>
          <p:cNvPr id="33" name="Picture 32" descr="A black text on a white background&#10;&#10;Description automatically generated with low confidence">
            <a:extLst>
              <a:ext uri="{FF2B5EF4-FFF2-40B4-BE49-F238E27FC236}">
                <a16:creationId xmlns:a16="http://schemas.microsoft.com/office/drawing/2014/main" id="{C2F120F2-61D8-60B6-7417-422BBBAA12A0}"/>
              </a:ext>
            </a:extLst>
          </p:cNvPr>
          <p:cNvPicPr>
            <a:picLocks noChangeAspect="1"/>
          </p:cNvPicPr>
          <p:nvPr/>
        </p:nvPicPr>
        <p:blipFill>
          <a:blip r:embed="rId2"/>
          <a:stretch>
            <a:fillRect/>
          </a:stretch>
        </p:blipFill>
        <p:spPr>
          <a:xfrm>
            <a:off x="10541000" y="1029302"/>
            <a:ext cx="1237365" cy="609164"/>
          </a:xfrm>
          <a:prstGeom prst="rect">
            <a:avLst/>
          </a:prstGeom>
        </p:spPr>
      </p:pic>
      <p:pic>
        <p:nvPicPr>
          <p:cNvPr id="35" name="Picture 34" descr="A picture containing text, font, screenshot, typography&#10;&#10;Description automatically generated">
            <a:extLst>
              <a:ext uri="{FF2B5EF4-FFF2-40B4-BE49-F238E27FC236}">
                <a16:creationId xmlns:a16="http://schemas.microsoft.com/office/drawing/2014/main" id="{1BBD7CB2-C430-8743-FA53-260E99FCFE09}"/>
              </a:ext>
            </a:extLst>
          </p:cNvPr>
          <p:cNvPicPr>
            <a:picLocks noChangeAspect="1"/>
          </p:cNvPicPr>
          <p:nvPr/>
        </p:nvPicPr>
        <p:blipFill>
          <a:blip r:embed="rId3"/>
          <a:stretch>
            <a:fillRect/>
          </a:stretch>
        </p:blipFill>
        <p:spPr>
          <a:xfrm>
            <a:off x="10541000" y="1930233"/>
            <a:ext cx="1293638" cy="2266630"/>
          </a:xfrm>
          <a:prstGeom prst="rect">
            <a:avLst/>
          </a:prstGeom>
        </p:spPr>
      </p:pic>
      <p:pic>
        <p:nvPicPr>
          <p:cNvPr id="37" name="Picture 36" descr="A picture containing diagram, text, plan, line&#10;&#10;Description automatically generated">
            <a:extLst>
              <a:ext uri="{FF2B5EF4-FFF2-40B4-BE49-F238E27FC236}">
                <a16:creationId xmlns:a16="http://schemas.microsoft.com/office/drawing/2014/main" id="{2A856C26-1D00-C127-14B0-7E31DA8B6D76}"/>
              </a:ext>
            </a:extLst>
          </p:cNvPr>
          <p:cNvPicPr>
            <a:picLocks noChangeAspect="1"/>
          </p:cNvPicPr>
          <p:nvPr/>
        </p:nvPicPr>
        <p:blipFill>
          <a:blip r:embed="rId4"/>
          <a:stretch>
            <a:fillRect/>
          </a:stretch>
        </p:blipFill>
        <p:spPr>
          <a:xfrm>
            <a:off x="464166" y="905353"/>
            <a:ext cx="3315284" cy="4141155"/>
          </a:xfrm>
          <a:prstGeom prst="rect">
            <a:avLst/>
          </a:prstGeom>
        </p:spPr>
      </p:pic>
      <p:pic>
        <p:nvPicPr>
          <p:cNvPr id="38" name="Picture 37" descr="A picture containing text, diagram, line, plot&#10;&#10;Description automatically generated">
            <a:extLst>
              <a:ext uri="{FF2B5EF4-FFF2-40B4-BE49-F238E27FC236}">
                <a16:creationId xmlns:a16="http://schemas.microsoft.com/office/drawing/2014/main" id="{167D054B-9149-5F97-B558-6419BD860765}"/>
              </a:ext>
            </a:extLst>
          </p:cNvPr>
          <p:cNvPicPr>
            <a:picLocks noChangeAspect="1"/>
          </p:cNvPicPr>
          <p:nvPr/>
        </p:nvPicPr>
        <p:blipFill>
          <a:blip r:embed="rId5"/>
          <a:stretch>
            <a:fillRect/>
          </a:stretch>
        </p:blipFill>
        <p:spPr>
          <a:xfrm>
            <a:off x="3825833" y="908063"/>
            <a:ext cx="3315284" cy="4141155"/>
          </a:xfrm>
          <a:prstGeom prst="rect">
            <a:avLst/>
          </a:prstGeom>
        </p:spPr>
      </p:pic>
      <p:pic>
        <p:nvPicPr>
          <p:cNvPr id="40" name="Picture 39" descr="A picture containing diagram, text, plan, line&#10;&#10;Description automatically generated">
            <a:extLst>
              <a:ext uri="{FF2B5EF4-FFF2-40B4-BE49-F238E27FC236}">
                <a16:creationId xmlns:a16="http://schemas.microsoft.com/office/drawing/2014/main" id="{82907A3E-3432-6F27-D236-1E0629C2B927}"/>
              </a:ext>
            </a:extLst>
          </p:cNvPr>
          <p:cNvPicPr>
            <a:picLocks noChangeAspect="1"/>
          </p:cNvPicPr>
          <p:nvPr/>
        </p:nvPicPr>
        <p:blipFill>
          <a:blip r:embed="rId6"/>
          <a:stretch>
            <a:fillRect/>
          </a:stretch>
        </p:blipFill>
        <p:spPr>
          <a:xfrm>
            <a:off x="7153138" y="908062"/>
            <a:ext cx="3315284" cy="4141155"/>
          </a:xfrm>
          <a:prstGeom prst="rect">
            <a:avLst/>
          </a:prstGeom>
        </p:spPr>
      </p:pic>
      <p:sp>
        <p:nvSpPr>
          <p:cNvPr id="41" name="TextBox 40">
            <a:extLst>
              <a:ext uri="{FF2B5EF4-FFF2-40B4-BE49-F238E27FC236}">
                <a16:creationId xmlns:a16="http://schemas.microsoft.com/office/drawing/2014/main" id="{4498E95E-8740-36DC-7386-03E628B14FA7}"/>
              </a:ext>
            </a:extLst>
          </p:cNvPr>
          <p:cNvSpPr txBox="1"/>
          <p:nvPr/>
        </p:nvSpPr>
        <p:spPr>
          <a:xfrm>
            <a:off x="1079806" y="590147"/>
            <a:ext cx="2046833" cy="338554"/>
          </a:xfrm>
          <a:prstGeom prst="rect">
            <a:avLst/>
          </a:prstGeom>
          <a:noFill/>
        </p:spPr>
        <p:txBody>
          <a:bodyPr wrap="square" rtlCol="0">
            <a:spAutoFit/>
          </a:bodyPr>
          <a:lstStyle/>
          <a:p>
            <a:r>
              <a:rPr lang="en-US" sz="1600" b="1" dirty="0">
                <a:latin typeface="Helvetica" pitchFamily="2" charset="0"/>
              </a:rPr>
              <a:t>Day 0 Susceptible</a:t>
            </a:r>
          </a:p>
        </p:txBody>
      </p:sp>
      <p:sp>
        <p:nvSpPr>
          <p:cNvPr id="42" name="TextBox 41">
            <a:extLst>
              <a:ext uri="{FF2B5EF4-FFF2-40B4-BE49-F238E27FC236}">
                <a16:creationId xmlns:a16="http://schemas.microsoft.com/office/drawing/2014/main" id="{7EFFFCFE-0B2D-3540-A17F-7C9026979709}"/>
              </a:ext>
            </a:extLst>
          </p:cNvPr>
          <p:cNvSpPr txBox="1"/>
          <p:nvPr/>
        </p:nvSpPr>
        <p:spPr>
          <a:xfrm>
            <a:off x="528516" y="553896"/>
            <a:ext cx="274989" cy="369332"/>
          </a:xfrm>
          <a:prstGeom prst="rect">
            <a:avLst/>
          </a:prstGeom>
          <a:noFill/>
        </p:spPr>
        <p:txBody>
          <a:bodyPr wrap="square" lIns="91440" tIns="45720" rIns="91440" bIns="45720" rtlCol="0" anchor="t">
            <a:spAutoFit/>
          </a:bodyPr>
          <a:lstStyle/>
          <a:p>
            <a:r>
              <a:rPr lang="en-US" b="1" dirty="0"/>
              <a:t>D</a:t>
            </a:r>
          </a:p>
        </p:txBody>
      </p:sp>
      <p:sp>
        <p:nvSpPr>
          <p:cNvPr id="43" name="TextBox 42">
            <a:extLst>
              <a:ext uri="{FF2B5EF4-FFF2-40B4-BE49-F238E27FC236}">
                <a16:creationId xmlns:a16="http://schemas.microsoft.com/office/drawing/2014/main" id="{93D5ACC8-1AA0-46E3-DA1D-C5F54AB73E2C}"/>
              </a:ext>
            </a:extLst>
          </p:cNvPr>
          <p:cNvSpPr txBox="1"/>
          <p:nvPr/>
        </p:nvSpPr>
        <p:spPr>
          <a:xfrm>
            <a:off x="4004578" y="571576"/>
            <a:ext cx="274989" cy="369332"/>
          </a:xfrm>
          <a:prstGeom prst="rect">
            <a:avLst/>
          </a:prstGeom>
          <a:noFill/>
        </p:spPr>
        <p:txBody>
          <a:bodyPr wrap="square" lIns="91440" tIns="45720" rIns="91440" bIns="45720" rtlCol="0" anchor="t">
            <a:spAutoFit/>
          </a:bodyPr>
          <a:lstStyle/>
          <a:p>
            <a:r>
              <a:rPr lang="en-US" b="1"/>
              <a:t>E</a:t>
            </a:r>
          </a:p>
        </p:txBody>
      </p:sp>
      <p:sp>
        <p:nvSpPr>
          <p:cNvPr id="44" name="TextBox 43">
            <a:extLst>
              <a:ext uri="{FF2B5EF4-FFF2-40B4-BE49-F238E27FC236}">
                <a16:creationId xmlns:a16="http://schemas.microsoft.com/office/drawing/2014/main" id="{FD9F1C3F-0FA5-603B-8470-F7EDB4AC5DBD}"/>
              </a:ext>
            </a:extLst>
          </p:cNvPr>
          <p:cNvSpPr txBox="1"/>
          <p:nvPr/>
        </p:nvSpPr>
        <p:spPr>
          <a:xfrm>
            <a:off x="7367669" y="614456"/>
            <a:ext cx="274990" cy="369332"/>
          </a:xfrm>
          <a:prstGeom prst="rect">
            <a:avLst/>
          </a:prstGeom>
          <a:noFill/>
        </p:spPr>
        <p:txBody>
          <a:bodyPr wrap="square" lIns="91440" tIns="45720" rIns="91440" bIns="45720" rtlCol="0" anchor="t">
            <a:spAutoFit/>
          </a:bodyPr>
          <a:lstStyle/>
          <a:p>
            <a:r>
              <a:rPr lang="en-US" b="1"/>
              <a:t>F</a:t>
            </a:r>
          </a:p>
        </p:txBody>
      </p:sp>
      <p:sp>
        <p:nvSpPr>
          <p:cNvPr id="45" name="TextBox 44">
            <a:extLst>
              <a:ext uri="{FF2B5EF4-FFF2-40B4-BE49-F238E27FC236}">
                <a16:creationId xmlns:a16="http://schemas.microsoft.com/office/drawing/2014/main" id="{46924A1E-AC79-E776-87B7-273A47B24978}"/>
              </a:ext>
            </a:extLst>
          </p:cNvPr>
          <p:cNvSpPr txBox="1"/>
          <p:nvPr/>
        </p:nvSpPr>
        <p:spPr>
          <a:xfrm>
            <a:off x="4785668" y="536684"/>
            <a:ext cx="2046833" cy="338554"/>
          </a:xfrm>
          <a:prstGeom prst="rect">
            <a:avLst/>
          </a:prstGeom>
          <a:noFill/>
        </p:spPr>
        <p:txBody>
          <a:bodyPr wrap="square" rtlCol="0">
            <a:spAutoFit/>
          </a:bodyPr>
          <a:lstStyle/>
          <a:p>
            <a:r>
              <a:rPr lang="en-US" sz="1600" b="1" dirty="0">
                <a:latin typeface="Helvetica" pitchFamily="2" charset="0"/>
              </a:rPr>
              <a:t>Day 90 Susceptible</a:t>
            </a:r>
          </a:p>
        </p:txBody>
      </p:sp>
      <p:sp>
        <p:nvSpPr>
          <p:cNvPr id="46" name="TextBox 45">
            <a:extLst>
              <a:ext uri="{FF2B5EF4-FFF2-40B4-BE49-F238E27FC236}">
                <a16:creationId xmlns:a16="http://schemas.microsoft.com/office/drawing/2014/main" id="{5D29A370-C027-841B-9A78-9C4013A456AB}"/>
              </a:ext>
            </a:extLst>
          </p:cNvPr>
          <p:cNvSpPr txBox="1"/>
          <p:nvPr/>
        </p:nvSpPr>
        <p:spPr>
          <a:xfrm>
            <a:off x="8019056" y="569285"/>
            <a:ext cx="2046833" cy="584775"/>
          </a:xfrm>
          <a:prstGeom prst="rect">
            <a:avLst/>
          </a:prstGeom>
          <a:noFill/>
        </p:spPr>
        <p:txBody>
          <a:bodyPr wrap="square" rtlCol="0">
            <a:spAutoFit/>
          </a:bodyPr>
          <a:lstStyle/>
          <a:p>
            <a:r>
              <a:rPr lang="en-US" sz="1600" b="1" dirty="0">
                <a:latin typeface="Helvetica" pitchFamily="2" charset="0"/>
              </a:rPr>
              <a:t>Day 150 Susceptible</a:t>
            </a:r>
          </a:p>
        </p:txBody>
      </p:sp>
    </p:spTree>
    <p:extLst>
      <p:ext uri="{BB962C8B-B14F-4D97-AF65-F5344CB8AC3E}">
        <p14:creationId xmlns:p14="http://schemas.microsoft.com/office/powerpoint/2010/main" val="36415703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2A7765-C903-3402-1F55-048D7506BE4D}"/>
              </a:ext>
            </a:extLst>
          </p:cNvPr>
          <p:cNvSpPr>
            <a:spLocks noGrp="1"/>
          </p:cNvSpPr>
          <p:nvPr>
            <p:ph type="title"/>
          </p:nvPr>
        </p:nvSpPr>
        <p:spPr>
          <a:xfrm>
            <a:off x="582216" y="341313"/>
            <a:ext cx="2547938" cy="304006"/>
          </a:xfrm>
        </p:spPr>
        <p:txBody>
          <a:bodyPr>
            <a:noAutofit/>
          </a:bodyPr>
          <a:lstStyle/>
          <a:p>
            <a:r>
              <a:rPr lang="en-US" sz="1200" b="1">
                <a:latin typeface="Times New Roman"/>
                <a:cs typeface="Arial"/>
              </a:rPr>
              <a:t>Supplementary tables</a:t>
            </a:r>
          </a:p>
        </p:txBody>
      </p:sp>
      <p:sp>
        <p:nvSpPr>
          <p:cNvPr id="5" name="TextBox 4">
            <a:extLst>
              <a:ext uri="{FF2B5EF4-FFF2-40B4-BE49-F238E27FC236}">
                <a16:creationId xmlns:a16="http://schemas.microsoft.com/office/drawing/2014/main" id="{B8D80A98-FB77-032E-1D4C-20971115B607}"/>
              </a:ext>
            </a:extLst>
          </p:cNvPr>
          <p:cNvSpPr txBox="1"/>
          <p:nvPr/>
        </p:nvSpPr>
        <p:spPr>
          <a:xfrm>
            <a:off x="581488" y="2371942"/>
            <a:ext cx="11162805" cy="276999"/>
          </a:xfrm>
          <a:prstGeom prst="rect">
            <a:avLst/>
          </a:prstGeom>
          <a:noFill/>
        </p:spPr>
        <p:txBody>
          <a:bodyPr wrap="square" lIns="91440" tIns="45720" rIns="91440" bIns="45720" rtlCol="0" anchor="t">
            <a:spAutoFit/>
          </a:bodyPr>
          <a:lstStyle/>
          <a:p>
            <a:r>
              <a:rPr lang="en-US" sz="1200" b="1">
                <a:latin typeface="Times New Roman"/>
                <a:cs typeface="Arial"/>
              </a:rPr>
              <a:t>Supplementary Table 4</a:t>
            </a:r>
            <a:r>
              <a:rPr lang="en-US" sz="1200">
                <a:latin typeface="Times New Roman"/>
                <a:cs typeface="Arial"/>
              </a:rPr>
              <a:t>. RNA integrity numbers and concentration for samples processed for RNA sequencing</a:t>
            </a:r>
          </a:p>
        </p:txBody>
      </p:sp>
      <p:sp>
        <p:nvSpPr>
          <p:cNvPr id="8" name="TextBox 7">
            <a:extLst>
              <a:ext uri="{FF2B5EF4-FFF2-40B4-BE49-F238E27FC236}">
                <a16:creationId xmlns:a16="http://schemas.microsoft.com/office/drawing/2014/main" id="{164D787A-1F90-283F-C1E8-9684A8657403}"/>
              </a:ext>
            </a:extLst>
          </p:cNvPr>
          <p:cNvSpPr txBox="1"/>
          <p:nvPr/>
        </p:nvSpPr>
        <p:spPr>
          <a:xfrm>
            <a:off x="581486" y="2681503"/>
            <a:ext cx="11162805" cy="276999"/>
          </a:xfrm>
          <a:prstGeom prst="rect">
            <a:avLst/>
          </a:prstGeom>
          <a:noFill/>
        </p:spPr>
        <p:txBody>
          <a:bodyPr wrap="square" lIns="91440" tIns="45720" rIns="91440" bIns="45720" rtlCol="0" anchor="t">
            <a:spAutoFit/>
          </a:bodyPr>
          <a:lstStyle/>
          <a:p>
            <a:r>
              <a:rPr lang="en-US" sz="1200" b="1">
                <a:latin typeface="Times New Roman"/>
                <a:cs typeface="Arial"/>
              </a:rPr>
              <a:t>Supplementary Table 5</a:t>
            </a:r>
            <a:r>
              <a:rPr lang="en-US" sz="1200">
                <a:latin typeface="Times New Roman"/>
                <a:cs typeface="Arial"/>
              </a:rPr>
              <a:t>. Summary table of total Illumina reads mapped to the reference genome</a:t>
            </a:r>
          </a:p>
        </p:txBody>
      </p:sp>
      <p:sp>
        <p:nvSpPr>
          <p:cNvPr id="4" name="TextBox 1">
            <a:extLst>
              <a:ext uri="{FF2B5EF4-FFF2-40B4-BE49-F238E27FC236}">
                <a16:creationId xmlns:a16="http://schemas.microsoft.com/office/drawing/2014/main" id="{370BBE70-B005-07CE-8F07-112200FFAF72}"/>
              </a:ext>
            </a:extLst>
          </p:cNvPr>
          <p:cNvSpPr txBox="1"/>
          <p:nvPr/>
        </p:nvSpPr>
        <p:spPr>
          <a:xfrm>
            <a:off x="581487" y="1740911"/>
            <a:ext cx="11162805" cy="276999"/>
          </a:xfrm>
          <a:prstGeom prst="rect">
            <a:avLst/>
          </a:prstGeom>
          <a:noFill/>
        </p:spPr>
        <p:txBody>
          <a:bodyPr wrap="square" lIns="91440" tIns="45720" rIns="91440" bIns="4572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a:latin typeface="Times New Roman"/>
                <a:cs typeface="Arial"/>
              </a:rPr>
              <a:t>Supplementary Table 2</a:t>
            </a:r>
            <a:r>
              <a:rPr lang="en-US" sz="1200">
                <a:latin typeface="Times New Roman"/>
                <a:cs typeface="Arial"/>
              </a:rPr>
              <a:t>. Table of antibody staining panel used to assess effector function of T cells</a:t>
            </a:r>
          </a:p>
        </p:txBody>
      </p:sp>
      <p:sp>
        <p:nvSpPr>
          <p:cNvPr id="9" name="TextBox 2">
            <a:extLst>
              <a:ext uri="{FF2B5EF4-FFF2-40B4-BE49-F238E27FC236}">
                <a16:creationId xmlns:a16="http://schemas.microsoft.com/office/drawing/2014/main" id="{9F2B83CC-013D-0F09-E3B9-97C30067C1EA}"/>
              </a:ext>
            </a:extLst>
          </p:cNvPr>
          <p:cNvSpPr txBox="1"/>
          <p:nvPr/>
        </p:nvSpPr>
        <p:spPr>
          <a:xfrm>
            <a:off x="569580" y="2050472"/>
            <a:ext cx="11162805" cy="276999"/>
          </a:xfrm>
          <a:prstGeom prst="rect">
            <a:avLst/>
          </a:prstGeom>
          <a:noFill/>
        </p:spPr>
        <p:txBody>
          <a:bodyPr wrap="square" lIns="91440" tIns="45720" rIns="91440" bIns="4572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a:latin typeface="Times New Roman"/>
                <a:cs typeface="Arial"/>
              </a:rPr>
              <a:t>Supplementary Table 3</a:t>
            </a:r>
            <a:r>
              <a:rPr lang="en-US" sz="1200">
                <a:latin typeface="Times New Roman"/>
                <a:cs typeface="Arial"/>
              </a:rPr>
              <a:t>. Table of antibody staining panel used to assess regulatory function of T cells</a:t>
            </a:r>
          </a:p>
        </p:txBody>
      </p:sp>
    </p:spTree>
    <p:extLst>
      <p:ext uri="{BB962C8B-B14F-4D97-AF65-F5344CB8AC3E}">
        <p14:creationId xmlns:p14="http://schemas.microsoft.com/office/powerpoint/2010/main" val="17999490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A0FA2C-408D-794F-9B92-81C103CEC3CB}"/>
              </a:ext>
            </a:extLst>
          </p:cNvPr>
          <p:cNvSpPr>
            <a:spLocks noGrp="1"/>
          </p:cNvSpPr>
          <p:nvPr>
            <p:ph type="title"/>
          </p:nvPr>
        </p:nvSpPr>
        <p:spPr>
          <a:xfrm>
            <a:off x="327453" y="55141"/>
            <a:ext cx="2919412" cy="481690"/>
          </a:xfrm>
        </p:spPr>
        <p:txBody>
          <a:bodyPr>
            <a:normAutofit/>
          </a:bodyPr>
          <a:lstStyle/>
          <a:p>
            <a:r>
              <a:rPr lang="en-US" sz="1200" b="1">
                <a:latin typeface="Times New Roman"/>
                <a:cs typeface="Arial"/>
              </a:rPr>
              <a:t>Supplementary Figure 1</a:t>
            </a:r>
          </a:p>
        </p:txBody>
      </p:sp>
      <p:sp>
        <p:nvSpPr>
          <p:cNvPr id="3" name="TextBox 2">
            <a:extLst>
              <a:ext uri="{FF2B5EF4-FFF2-40B4-BE49-F238E27FC236}">
                <a16:creationId xmlns:a16="http://schemas.microsoft.com/office/drawing/2014/main" id="{2061C523-55C1-671F-647A-230B07659C74}"/>
              </a:ext>
            </a:extLst>
          </p:cNvPr>
          <p:cNvSpPr txBox="1"/>
          <p:nvPr/>
        </p:nvSpPr>
        <p:spPr>
          <a:xfrm>
            <a:off x="4461510" y="3625628"/>
            <a:ext cx="3541258" cy="646331"/>
          </a:xfrm>
          <a:prstGeom prst="rect">
            <a:avLst/>
          </a:prstGeom>
          <a:noFill/>
          <a:ln w="15875">
            <a:solidFill>
              <a:schemeClr val="tx1"/>
            </a:solidFill>
          </a:ln>
        </p:spPr>
        <p:txBody>
          <a:bodyPr wrap="square" rtlCol="0">
            <a:spAutoFit/>
          </a:bodyPr>
          <a:lstStyle/>
          <a:p>
            <a:pPr algn="ctr"/>
            <a:r>
              <a:rPr lang="en-US"/>
              <a:t>Allocation to susceptible or protected group</a:t>
            </a:r>
          </a:p>
        </p:txBody>
      </p:sp>
      <p:cxnSp>
        <p:nvCxnSpPr>
          <p:cNvPr id="6" name="Straight Arrow Connector 5">
            <a:extLst>
              <a:ext uri="{FF2B5EF4-FFF2-40B4-BE49-F238E27FC236}">
                <a16:creationId xmlns:a16="http://schemas.microsoft.com/office/drawing/2014/main" id="{66360664-8CBF-8015-EDA2-E3A1C1E7B0C7}"/>
              </a:ext>
            </a:extLst>
          </p:cNvPr>
          <p:cNvCxnSpPr>
            <a:cxnSpLocks/>
          </p:cNvCxnSpPr>
          <p:nvPr/>
        </p:nvCxnSpPr>
        <p:spPr>
          <a:xfrm>
            <a:off x="2654593" y="1690925"/>
            <a:ext cx="7797231"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DA6F901F-0846-6C41-6FE6-2C4ED3C553CD}"/>
              </a:ext>
            </a:extLst>
          </p:cNvPr>
          <p:cNvSpPr txBox="1"/>
          <p:nvPr/>
        </p:nvSpPr>
        <p:spPr>
          <a:xfrm>
            <a:off x="6561890" y="4880367"/>
            <a:ext cx="3541258" cy="646331"/>
          </a:xfrm>
          <a:prstGeom prst="rect">
            <a:avLst/>
          </a:prstGeom>
          <a:noFill/>
          <a:ln w="15875">
            <a:solidFill>
              <a:schemeClr val="tx1"/>
            </a:solidFill>
          </a:ln>
        </p:spPr>
        <p:txBody>
          <a:bodyPr wrap="square" lIns="91440" tIns="45720" rIns="91440" bIns="45720" rtlCol="0" anchor="t">
            <a:spAutoFit/>
          </a:bodyPr>
          <a:lstStyle/>
          <a:p>
            <a:pPr algn="ctr"/>
            <a:r>
              <a:rPr lang="en-US"/>
              <a:t>Susceptible: &gt;= 2 clinical malaria episodes</a:t>
            </a:r>
          </a:p>
        </p:txBody>
      </p:sp>
      <p:sp>
        <p:nvSpPr>
          <p:cNvPr id="10" name="TextBox 9">
            <a:extLst>
              <a:ext uri="{FF2B5EF4-FFF2-40B4-BE49-F238E27FC236}">
                <a16:creationId xmlns:a16="http://schemas.microsoft.com/office/drawing/2014/main" id="{9092F6FD-6FB9-7E06-FCCF-C0DF104AB7CA}"/>
              </a:ext>
            </a:extLst>
          </p:cNvPr>
          <p:cNvSpPr txBox="1"/>
          <p:nvPr/>
        </p:nvSpPr>
        <p:spPr>
          <a:xfrm>
            <a:off x="2433703" y="4880367"/>
            <a:ext cx="3541258" cy="646331"/>
          </a:xfrm>
          <a:prstGeom prst="rect">
            <a:avLst/>
          </a:prstGeom>
          <a:noFill/>
          <a:ln w="15875">
            <a:solidFill>
              <a:schemeClr val="tx1"/>
            </a:solidFill>
          </a:ln>
        </p:spPr>
        <p:txBody>
          <a:bodyPr wrap="square" rtlCol="0">
            <a:spAutoFit/>
          </a:bodyPr>
          <a:lstStyle/>
          <a:p>
            <a:pPr algn="ctr"/>
            <a:r>
              <a:rPr lang="en-US"/>
              <a:t>Protected: no clinical malaria episodes</a:t>
            </a:r>
          </a:p>
        </p:txBody>
      </p:sp>
      <p:cxnSp>
        <p:nvCxnSpPr>
          <p:cNvPr id="12" name="Straight Connector 11">
            <a:extLst>
              <a:ext uri="{FF2B5EF4-FFF2-40B4-BE49-F238E27FC236}">
                <a16:creationId xmlns:a16="http://schemas.microsoft.com/office/drawing/2014/main" id="{F0A88F1F-9A39-9C94-25B8-E6ACF8F877D4}"/>
              </a:ext>
            </a:extLst>
          </p:cNvPr>
          <p:cNvCxnSpPr>
            <a:cxnSpLocks/>
            <a:stCxn id="3" idx="2"/>
          </p:cNvCxnSpPr>
          <p:nvPr/>
        </p:nvCxnSpPr>
        <p:spPr>
          <a:xfrm>
            <a:off x="6232139" y="4271959"/>
            <a:ext cx="0" cy="2888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C7401AC4-DD4D-70DF-DBE4-A4660780FE06}"/>
              </a:ext>
            </a:extLst>
          </p:cNvPr>
          <p:cNvCxnSpPr>
            <a:cxnSpLocks/>
          </p:cNvCxnSpPr>
          <p:nvPr/>
        </p:nvCxnSpPr>
        <p:spPr>
          <a:xfrm>
            <a:off x="6232139" y="4560799"/>
            <a:ext cx="177062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Diamond 19">
            <a:extLst>
              <a:ext uri="{FF2B5EF4-FFF2-40B4-BE49-F238E27FC236}">
                <a16:creationId xmlns:a16="http://schemas.microsoft.com/office/drawing/2014/main" id="{523CA850-6170-65E2-DA61-42B88B73CE7D}"/>
              </a:ext>
            </a:extLst>
          </p:cNvPr>
          <p:cNvSpPr/>
          <p:nvPr/>
        </p:nvSpPr>
        <p:spPr>
          <a:xfrm>
            <a:off x="3217053" y="476503"/>
            <a:ext cx="1140173" cy="1183348"/>
          </a:xfrm>
          <a:prstGeom prst="diamond">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TextBox 20">
            <a:extLst>
              <a:ext uri="{FF2B5EF4-FFF2-40B4-BE49-F238E27FC236}">
                <a16:creationId xmlns:a16="http://schemas.microsoft.com/office/drawing/2014/main" id="{74BA66AA-0EDC-D82E-5A91-00C6176DDE61}"/>
              </a:ext>
            </a:extLst>
          </p:cNvPr>
          <p:cNvSpPr txBox="1"/>
          <p:nvPr/>
        </p:nvSpPr>
        <p:spPr>
          <a:xfrm>
            <a:off x="3320670" y="825143"/>
            <a:ext cx="932938" cy="369332"/>
          </a:xfrm>
          <a:prstGeom prst="rect">
            <a:avLst/>
          </a:prstGeom>
          <a:noFill/>
          <a:ln w="15875">
            <a:noFill/>
          </a:ln>
        </p:spPr>
        <p:txBody>
          <a:bodyPr wrap="square" rtlCol="0">
            <a:spAutoFit/>
          </a:bodyPr>
          <a:lstStyle/>
          <a:p>
            <a:pPr algn="ctr"/>
            <a:r>
              <a:rPr lang="en-US"/>
              <a:t>Day 0</a:t>
            </a:r>
          </a:p>
        </p:txBody>
      </p:sp>
      <p:sp>
        <p:nvSpPr>
          <p:cNvPr id="23" name="Diamond 22">
            <a:extLst>
              <a:ext uri="{FF2B5EF4-FFF2-40B4-BE49-F238E27FC236}">
                <a16:creationId xmlns:a16="http://schemas.microsoft.com/office/drawing/2014/main" id="{60E77140-CE05-7221-FDE6-E7759F5AA39C}"/>
              </a:ext>
            </a:extLst>
          </p:cNvPr>
          <p:cNvSpPr/>
          <p:nvPr/>
        </p:nvSpPr>
        <p:spPr>
          <a:xfrm>
            <a:off x="5903460" y="489887"/>
            <a:ext cx="1140173" cy="1183348"/>
          </a:xfrm>
          <a:prstGeom prst="diamond">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a:extLst>
              <a:ext uri="{FF2B5EF4-FFF2-40B4-BE49-F238E27FC236}">
                <a16:creationId xmlns:a16="http://schemas.microsoft.com/office/drawing/2014/main" id="{E08D4DF6-6EBF-7B2F-F223-0577CD9D137B}"/>
              </a:ext>
            </a:extLst>
          </p:cNvPr>
          <p:cNvSpPr txBox="1"/>
          <p:nvPr/>
        </p:nvSpPr>
        <p:spPr>
          <a:xfrm>
            <a:off x="6007077" y="852815"/>
            <a:ext cx="932938" cy="369332"/>
          </a:xfrm>
          <a:prstGeom prst="rect">
            <a:avLst/>
          </a:prstGeom>
          <a:noFill/>
          <a:ln w="15875">
            <a:noFill/>
          </a:ln>
        </p:spPr>
        <p:txBody>
          <a:bodyPr wrap="square" rtlCol="0">
            <a:spAutoFit/>
          </a:bodyPr>
          <a:lstStyle/>
          <a:p>
            <a:pPr algn="ctr"/>
            <a:r>
              <a:rPr lang="en-US"/>
              <a:t>Day 90</a:t>
            </a:r>
          </a:p>
        </p:txBody>
      </p:sp>
      <p:sp>
        <p:nvSpPr>
          <p:cNvPr id="25" name="Diamond 24">
            <a:extLst>
              <a:ext uri="{FF2B5EF4-FFF2-40B4-BE49-F238E27FC236}">
                <a16:creationId xmlns:a16="http://schemas.microsoft.com/office/drawing/2014/main" id="{A25E5A74-1151-00D1-7075-7B116CB35759}"/>
              </a:ext>
            </a:extLst>
          </p:cNvPr>
          <p:cNvSpPr/>
          <p:nvPr/>
        </p:nvSpPr>
        <p:spPr>
          <a:xfrm>
            <a:off x="8487488" y="488215"/>
            <a:ext cx="1140173" cy="1183348"/>
          </a:xfrm>
          <a:prstGeom prst="diamond">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TextBox 25">
            <a:extLst>
              <a:ext uri="{FF2B5EF4-FFF2-40B4-BE49-F238E27FC236}">
                <a16:creationId xmlns:a16="http://schemas.microsoft.com/office/drawing/2014/main" id="{60BF68DF-1752-985C-7FC7-FCE0744FCA23}"/>
              </a:ext>
            </a:extLst>
          </p:cNvPr>
          <p:cNvSpPr txBox="1"/>
          <p:nvPr/>
        </p:nvSpPr>
        <p:spPr>
          <a:xfrm>
            <a:off x="8548241" y="822567"/>
            <a:ext cx="1036556" cy="369332"/>
          </a:xfrm>
          <a:prstGeom prst="rect">
            <a:avLst/>
          </a:prstGeom>
          <a:noFill/>
          <a:ln w="15875">
            <a:noFill/>
          </a:ln>
        </p:spPr>
        <p:txBody>
          <a:bodyPr wrap="square" rtlCol="0">
            <a:spAutoFit/>
          </a:bodyPr>
          <a:lstStyle/>
          <a:p>
            <a:pPr algn="ctr"/>
            <a:r>
              <a:rPr lang="en-US"/>
              <a:t>Day 150</a:t>
            </a:r>
          </a:p>
        </p:txBody>
      </p:sp>
      <p:graphicFrame>
        <p:nvGraphicFramePr>
          <p:cNvPr id="27" name="Table 27">
            <a:extLst>
              <a:ext uri="{FF2B5EF4-FFF2-40B4-BE49-F238E27FC236}">
                <a16:creationId xmlns:a16="http://schemas.microsoft.com/office/drawing/2014/main" id="{6AB445C7-29F2-1632-7FFF-F3B00FA9D7B6}"/>
              </a:ext>
            </a:extLst>
          </p:cNvPr>
          <p:cNvGraphicFramePr>
            <a:graphicFrameLocks noGrp="1"/>
          </p:cNvGraphicFramePr>
          <p:nvPr>
            <p:extLst>
              <p:ext uri="{D42A27DB-BD31-4B8C-83A1-F6EECF244321}">
                <p14:modId xmlns:p14="http://schemas.microsoft.com/office/powerpoint/2010/main" val="503115524"/>
              </p:ext>
            </p:extLst>
          </p:nvPr>
        </p:nvGraphicFramePr>
        <p:xfrm>
          <a:off x="2425254" y="1929149"/>
          <a:ext cx="8127999" cy="1112520"/>
        </p:xfrm>
        <a:graphic>
          <a:graphicData uri="http://schemas.openxmlformats.org/drawingml/2006/table">
            <a:tbl>
              <a:tblPr firstRow="1" bandRow="1">
                <a:tableStyleId>{616DA210-FB5B-4158-B5E0-FEB733F419BA}</a:tableStyleId>
              </a:tblPr>
              <a:tblGrid>
                <a:gridCol w="2709333">
                  <a:extLst>
                    <a:ext uri="{9D8B030D-6E8A-4147-A177-3AD203B41FA5}">
                      <a16:colId xmlns:a16="http://schemas.microsoft.com/office/drawing/2014/main" val="3193565110"/>
                    </a:ext>
                  </a:extLst>
                </a:gridCol>
                <a:gridCol w="2709333">
                  <a:extLst>
                    <a:ext uri="{9D8B030D-6E8A-4147-A177-3AD203B41FA5}">
                      <a16:colId xmlns:a16="http://schemas.microsoft.com/office/drawing/2014/main" val="317503158"/>
                    </a:ext>
                  </a:extLst>
                </a:gridCol>
                <a:gridCol w="2709333">
                  <a:extLst>
                    <a:ext uri="{9D8B030D-6E8A-4147-A177-3AD203B41FA5}">
                      <a16:colId xmlns:a16="http://schemas.microsoft.com/office/drawing/2014/main" val="709216647"/>
                    </a:ext>
                  </a:extLst>
                </a:gridCol>
              </a:tblGrid>
              <a:tr h="370840">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10586194"/>
                  </a:ext>
                </a:extLst>
              </a:tr>
              <a:tr h="370840">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2243360823"/>
                  </a:ext>
                </a:extLst>
              </a:tr>
              <a:tr h="370840">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2492414048"/>
                  </a:ext>
                </a:extLst>
              </a:tr>
            </a:tbl>
          </a:graphicData>
        </a:graphic>
      </p:graphicFrame>
      <p:sp>
        <p:nvSpPr>
          <p:cNvPr id="28" name="TextBox 27">
            <a:extLst>
              <a:ext uri="{FF2B5EF4-FFF2-40B4-BE49-F238E27FC236}">
                <a16:creationId xmlns:a16="http://schemas.microsoft.com/office/drawing/2014/main" id="{57B956F4-3E75-8795-6DDA-7230CA22ED11}"/>
              </a:ext>
            </a:extLst>
          </p:cNvPr>
          <p:cNvSpPr txBox="1"/>
          <p:nvPr/>
        </p:nvSpPr>
        <p:spPr>
          <a:xfrm>
            <a:off x="1110219" y="1941520"/>
            <a:ext cx="1274876" cy="382543"/>
          </a:xfrm>
          <a:prstGeom prst="rect">
            <a:avLst/>
          </a:prstGeom>
          <a:noFill/>
          <a:ln w="15875">
            <a:noFill/>
          </a:ln>
        </p:spPr>
        <p:txBody>
          <a:bodyPr wrap="square" rtlCol="0">
            <a:spAutoFit/>
          </a:bodyPr>
          <a:lstStyle/>
          <a:p>
            <a:pPr algn="r"/>
            <a:r>
              <a:rPr lang="en-US"/>
              <a:t>RNA-seq</a:t>
            </a:r>
          </a:p>
        </p:txBody>
      </p:sp>
      <p:sp>
        <p:nvSpPr>
          <p:cNvPr id="29" name="TextBox 28">
            <a:extLst>
              <a:ext uri="{FF2B5EF4-FFF2-40B4-BE49-F238E27FC236}">
                <a16:creationId xmlns:a16="http://schemas.microsoft.com/office/drawing/2014/main" id="{06F03243-8DEE-AE80-7CF7-7AAAE71000EF}"/>
              </a:ext>
            </a:extLst>
          </p:cNvPr>
          <p:cNvSpPr txBox="1"/>
          <p:nvPr/>
        </p:nvSpPr>
        <p:spPr>
          <a:xfrm>
            <a:off x="589745" y="2336434"/>
            <a:ext cx="1855646" cy="369332"/>
          </a:xfrm>
          <a:prstGeom prst="rect">
            <a:avLst/>
          </a:prstGeom>
          <a:noFill/>
          <a:ln w="15875">
            <a:noFill/>
          </a:ln>
        </p:spPr>
        <p:txBody>
          <a:bodyPr wrap="square" rtlCol="0">
            <a:spAutoFit/>
          </a:bodyPr>
          <a:lstStyle/>
          <a:p>
            <a:pPr algn="r"/>
            <a:r>
              <a:rPr lang="en-US"/>
              <a:t>Mass Cytometry</a:t>
            </a:r>
          </a:p>
        </p:txBody>
      </p:sp>
      <p:sp>
        <p:nvSpPr>
          <p:cNvPr id="30" name="Oval 29">
            <a:extLst>
              <a:ext uri="{FF2B5EF4-FFF2-40B4-BE49-F238E27FC236}">
                <a16:creationId xmlns:a16="http://schemas.microsoft.com/office/drawing/2014/main" id="{F32F784D-527E-BDF7-909D-6520B5285CE6}"/>
              </a:ext>
            </a:extLst>
          </p:cNvPr>
          <p:cNvSpPr/>
          <p:nvPr/>
        </p:nvSpPr>
        <p:spPr>
          <a:xfrm>
            <a:off x="3700463" y="2043453"/>
            <a:ext cx="91440" cy="9144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Oval 30">
            <a:extLst>
              <a:ext uri="{FF2B5EF4-FFF2-40B4-BE49-F238E27FC236}">
                <a16:creationId xmlns:a16="http://schemas.microsoft.com/office/drawing/2014/main" id="{2AC12AA2-438D-276A-9492-F4DB4776D3EE}"/>
              </a:ext>
            </a:extLst>
          </p:cNvPr>
          <p:cNvSpPr/>
          <p:nvPr/>
        </p:nvSpPr>
        <p:spPr>
          <a:xfrm>
            <a:off x="9048050" y="2046309"/>
            <a:ext cx="91440" cy="9144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Oval 31">
            <a:extLst>
              <a:ext uri="{FF2B5EF4-FFF2-40B4-BE49-F238E27FC236}">
                <a16:creationId xmlns:a16="http://schemas.microsoft.com/office/drawing/2014/main" id="{2103EBC6-0CFC-6FD6-A001-1950B40D3A43}"/>
              </a:ext>
            </a:extLst>
          </p:cNvPr>
          <p:cNvSpPr/>
          <p:nvPr/>
        </p:nvSpPr>
        <p:spPr>
          <a:xfrm>
            <a:off x="6422640" y="2043453"/>
            <a:ext cx="91440" cy="9144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Oval 32">
            <a:extLst>
              <a:ext uri="{FF2B5EF4-FFF2-40B4-BE49-F238E27FC236}">
                <a16:creationId xmlns:a16="http://schemas.microsoft.com/office/drawing/2014/main" id="{42462042-95D2-BBAD-710A-69B00AB4E1D7}"/>
              </a:ext>
            </a:extLst>
          </p:cNvPr>
          <p:cNvSpPr/>
          <p:nvPr/>
        </p:nvSpPr>
        <p:spPr>
          <a:xfrm>
            <a:off x="3695700" y="2410167"/>
            <a:ext cx="91440" cy="9144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Oval 33">
            <a:extLst>
              <a:ext uri="{FF2B5EF4-FFF2-40B4-BE49-F238E27FC236}">
                <a16:creationId xmlns:a16="http://schemas.microsoft.com/office/drawing/2014/main" id="{91583C43-0007-B5A5-F7C1-7DFC2DBF83BE}"/>
              </a:ext>
            </a:extLst>
          </p:cNvPr>
          <p:cNvSpPr/>
          <p:nvPr/>
        </p:nvSpPr>
        <p:spPr>
          <a:xfrm>
            <a:off x="9043287" y="2413023"/>
            <a:ext cx="91440" cy="9144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Oval 34">
            <a:extLst>
              <a:ext uri="{FF2B5EF4-FFF2-40B4-BE49-F238E27FC236}">
                <a16:creationId xmlns:a16="http://schemas.microsoft.com/office/drawing/2014/main" id="{99658F24-C193-42B8-5607-A2A65AC61055}"/>
              </a:ext>
            </a:extLst>
          </p:cNvPr>
          <p:cNvSpPr/>
          <p:nvPr/>
        </p:nvSpPr>
        <p:spPr>
          <a:xfrm>
            <a:off x="6417877" y="2410167"/>
            <a:ext cx="91440" cy="9144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a:extLst>
              <a:ext uri="{FF2B5EF4-FFF2-40B4-BE49-F238E27FC236}">
                <a16:creationId xmlns:a16="http://schemas.microsoft.com/office/drawing/2014/main" id="{AC66CD19-CC85-771F-EBB1-DA9E923FCC59}"/>
              </a:ext>
            </a:extLst>
          </p:cNvPr>
          <p:cNvSpPr txBox="1"/>
          <p:nvPr/>
        </p:nvSpPr>
        <p:spPr>
          <a:xfrm>
            <a:off x="589745" y="2718100"/>
            <a:ext cx="1855646" cy="369332"/>
          </a:xfrm>
          <a:prstGeom prst="rect">
            <a:avLst/>
          </a:prstGeom>
          <a:noFill/>
          <a:ln w="15875">
            <a:noFill/>
          </a:ln>
        </p:spPr>
        <p:txBody>
          <a:bodyPr wrap="square" rtlCol="0">
            <a:spAutoFit/>
          </a:bodyPr>
          <a:lstStyle/>
          <a:p>
            <a:pPr algn="r"/>
            <a:r>
              <a:rPr lang="en-US"/>
              <a:t>Protein Array</a:t>
            </a:r>
          </a:p>
        </p:txBody>
      </p:sp>
      <p:sp>
        <p:nvSpPr>
          <p:cNvPr id="37" name="Oval 36">
            <a:extLst>
              <a:ext uri="{FF2B5EF4-FFF2-40B4-BE49-F238E27FC236}">
                <a16:creationId xmlns:a16="http://schemas.microsoft.com/office/drawing/2014/main" id="{D510343C-BFD5-8364-8FBF-689143DB1A4A}"/>
              </a:ext>
            </a:extLst>
          </p:cNvPr>
          <p:cNvSpPr/>
          <p:nvPr/>
        </p:nvSpPr>
        <p:spPr>
          <a:xfrm>
            <a:off x="3690934" y="2791169"/>
            <a:ext cx="91440" cy="9144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9" name="Straight Connector 38">
            <a:extLst>
              <a:ext uri="{FF2B5EF4-FFF2-40B4-BE49-F238E27FC236}">
                <a16:creationId xmlns:a16="http://schemas.microsoft.com/office/drawing/2014/main" id="{538CE716-A411-DF48-25D3-AC1EE62FAC0B}"/>
              </a:ext>
            </a:extLst>
          </p:cNvPr>
          <p:cNvCxnSpPr>
            <a:cxnSpLocks/>
          </p:cNvCxnSpPr>
          <p:nvPr/>
        </p:nvCxnSpPr>
        <p:spPr>
          <a:xfrm>
            <a:off x="8002768" y="4558694"/>
            <a:ext cx="0" cy="2888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AC1303C9-76B4-AE4C-E66E-E003E63B6C2A}"/>
              </a:ext>
            </a:extLst>
          </p:cNvPr>
          <p:cNvCxnSpPr>
            <a:cxnSpLocks/>
          </p:cNvCxnSpPr>
          <p:nvPr/>
        </p:nvCxnSpPr>
        <p:spPr>
          <a:xfrm>
            <a:off x="4461510" y="4558694"/>
            <a:ext cx="177062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6DE5DA54-A458-3D55-23FD-83DAD0D0BA7D}"/>
              </a:ext>
            </a:extLst>
          </p:cNvPr>
          <p:cNvCxnSpPr>
            <a:cxnSpLocks/>
          </p:cNvCxnSpPr>
          <p:nvPr/>
        </p:nvCxnSpPr>
        <p:spPr>
          <a:xfrm>
            <a:off x="4461510" y="4558694"/>
            <a:ext cx="0" cy="2888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A08A52BD-B551-5BF6-91E4-93D35149BE3C}"/>
              </a:ext>
            </a:extLst>
          </p:cNvPr>
          <p:cNvSpPr txBox="1"/>
          <p:nvPr/>
        </p:nvSpPr>
        <p:spPr>
          <a:xfrm>
            <a:off x="569119" y="555975"/>
            <a:ext cx="274989" cy="369332"/>
          </a:xfrm>
          <a:prstGeom prst="rect">
            <a:avLst/>
          </a:prstGeom>
          <a:noFill/>
        </p:spPr>
        <p:txBody>
          <a:bodyPr wrap="square" lIns="91440" tIns="45720" rIns="91440" bIns="45720" rtlCol="0" anchor="t">
            <a:spAutoFit/>
          </a:bodyPr>
          <a:lstStyle/>
          <a:p>
            <a:r>
              <a:rPr lang="en-US" b="1"/>
              <a:t>A</a:t>
            </a:r>
          </a:p>
        </p:txBody>
      </p:sp>
      <p:sp>
        <p:nvSpPr>
          <p:cNvPr id="11" name="TextBox 10">
            <a:extLst>
              <a:ext uri="{FF2B5EF4-FFF2-40B4-BE49-F238E27FC236}">
                <a16:creationId xmlns:a16="http://schemas.microsoft.com/office/drawing/2014/main" id="{A4F97F60-973D-81BF-82BF-28F8F09BC1BC}"/>
              </a:ext>
            </a:extLst>
          </p:cNvPr>
          <p:cNvSpPr txBox="1"/>
          <p:nvPr/>
        </p:nvSpPr>
        <p:spPr>
          <a:xfrm>
            <a:off x="590550" y="3678765"/>
            <a:ext cx="274989" cy="369332"/>
          </a:xfrm>
          <a:prstGeom prst="rect">
            <a:avLst/>
          </a:prstGeom>
          <a:noFill/>
        </p:spPr>
        <p:txBody>
          <a:bodyPr wrap="square" lIns="91440" tIns="45720" rIns="91440" bIns="45720" rtlCol="0" anchor="t">
            <a:spAutoFit/>
          </a:bodyPr>
          <a:lstStyle/>
          <a:p>
            <a:r>
              <a:rPr lang="en-US" b="1"/>
              <a:t>B</a:t>
            </a:r>
          </a:p>
        </p:txBody>
      </p:sp>
    </p:spTree>
    <p:extLst>
      <p:ext uri="{BB962C8B-B14F-4D97-AF65-F5344CB8AC3E}">
        <p14:creationId xmlns:p14="http://schemas.microsoft.com/office/powerpoint/2010/main" val="10496197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CB49DE12-9150-E1A7-5904-48AFAD98CDAD}"/>
              </a:ext>
            </a:extLst>
          </p:cNvPr>
          <p:cNvSpPr>
            <a:spLocks noGrp="1"/>
          </p:cNvSpPr>
          <p:nvPr>
            <p:ph type="title"/>
          </p:nvPr>
        </p:nvSpPr>
        <p:spPr>
          <a:xfrm>
            <a:off x="327453" y="0"/>
            <a:ext cx="2919412" cy="667457"/>
          </a:xfrm>
        </p:spPr>
        <p:txBody>
          <a:bodyPr>
            <a:normAutofit/>
          </a:bodyPr>
          <a:lstStyle/>
          <a:p>
            <a:r>
              <a:rPr lang="en-US" sz="1200" b="1" dirty="0">
                <a:latin typeface="Times New Roman"/>
                <a:cs typeface="Arial"/>
              </a:rPr>
              <a:t>Supplementary Figure 1</a:t>
            </a:r>
          </a:p>
        </p:txBody>
      </p:sp>
      <p:sp>
        <p:nvSpPr>
          <p:cNvPr id="5" name="TextBox 4">
            <a:extLst>
              <a:ext uri="{FF2B5EF4-FFF2-40B4-BE49-F238E27FC236}">
                <a16:creationId xmlns:a16="http://schemas.microsoft.com/office/drawing/2014/main" id="{A6B9EA57-7F74-5D11-BEB0-FD607F966B41}"/>
              </a:ext>
            </a:extLst>
          </p:cNvPr>
          <p:cNvSpPr txBox="1"/>
          <p:nvPr/>
        </p:nvSpPr>
        <p:spPr>
          <a:xfrm>
            <a:off x="464947" y="5610952"/>
            <a:ext cx="11589558" cy="1200329"/>
          </a:xfrm>
          <a:prstGeom prst="rect">
            <a:avLst/>
          </a:prstGeom>
          <a:noFill/>
        </p:spPr>
        <p:txBody>
          <a:bodyPr wrap="square" lIns="91440" tIns="45720" rIns="91440" bIns="45720" rtlCol="0" anchor="t">
            <a:spAutoFit/>
          </a:bodyPr>
          <a:lstStyle/>
          <a:p>
            <a:r>
              <a:rPr lang="en-US" sz="1200" b="1" dirty="0">
                <a:latin typeface="Times New Roman" panose="02020603050405020304" pitchFamily="18" charset="0"/>
                <a:cs typeface="Times New Roman" panose="02020603050405020304" pitchFamily="18" charset="0"/>
              </a:rPr>
              <a:t>Supplementary Figure 1.</a:t>
            </a:r>
            <a:r>
              <a:rPr lang="en-US" sz="1200" dirty="0">
                <a:latin typeface="Times New Roman" panose="02020603050405020304" pitchFamily="18" charset="0"/>
                <a:cs typeface="Times New Roman" panose="02020603050405020304" pitchFamily="18" charset="0"/>
              </a:rPr>
              <a:t> Study design indicating sample collection, assays performed, allocation criteria and timing of clinical malaria episode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PBMC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ere collected from Malian children between the ages of 1-6 years at day 0, day 90, and day 150. Children were monitored for malaria symptoms and thick blood smears were used for parasite detection. </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r>
              <a:rPr lang="en-US" sz="1200" b="1" dirty="0">
                <a:latin typeface="Times New Roman" panose="02020603050405020304" pitchFamily="18" charset="0"/>
                <a:ea typeface="Calibri" panose="020F0502020204030204" pitchFamily="34" charset="0"/>
                <a:cs typeface="Times New Roman" panose="02020603050405020304" pitchFamily="18" charset="0"/>
              </a:rPr>
              <a:t>B</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hildren with greater than 2 clinical malaria episodes were classified as susceptible while children with no clinical malaria episodes were classified as protected. (</a:t>
            </a:r>
            <a:r>
              <a:rPr lang="en-US" sz="1200" b="1" dirty="0">
                <a:latin typeface="Times New Roman" panose="02020603050405020304" pitchFamily="18" charset="0"/>
                <a:ea typeface="Calibri" panose="020F0502020204030204" pitchFamily="34" charset="0"/>
                <a:cs typeface="Times New Roman" panose="02020603050405020304" pitchFamily="18" charset="0"/>
              </a:rPr>
              <a:t>C) </a:t>
            </a:r>
            <a:r>
              <a:rPr lang="en-US" sz="1200" dirty="0">
                <a:latin typeface="Times New Roman" panose="02020603050405020304" pitchFamily="18" charset="0"/>
                <a:ea typeface="Calibri" panose="020F0502020204030204" pitchFamily="34" charset="0"/>
                <a:cs typeface="Times New Roman" panose="02020603050405020304" pitchFamily="18" charset="0"/>
              </a:rPr>
              <a:t>Timing of clinical malaria episodes experienced by children in the “susceptible” group showing the time clinical illness was diagnosed on the x-axis and the intensity of each episode (Parasitemia/mm3 of blood) on the y-axis. 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ch child is represented by a unique shape. Episode counts are denoted by different colors: cyan for the first episode, magenta for the second episode, green for the third episode, and orange for the fourth episode.</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103F65B4-F691-5482-3889-8F68751F0F47}"/>
              </a:ext>
            </a:extLst>
          </p:cNvPr>
          <p:cNvSpPr txBox="1"/>
          <p:nvPr/>
        </p:nvSpPr>
        <p:spPr>
          <a:xfrm>
            <a:off x="327453" y="481707"/>
            <a:ext cx="274989" cy="369332"/>
          </a:xfrm>
          <a:prstGeom prst="rect">
            <a:avLst/>
          </a:prstGeom>
          <a:noFill/>
        </p:spPr>
        <p:txBody>
          <a:bodyPr wrap="square" lIns="91440" tIns="45720" rIns="91440" bIns="45720" rtlCol="0" anchor="t">
            <a:spAutoFit/>
          </a:bodyPr>
          <a:lstStyle/>
          <a:p>
            <a:r>
              <a:rPr lang="en-US" b="1"/>
              <a:t>C</a:t>
            </a:r>
          </a:p>
        </p:txBody>
      </p:sp>
      <p:pic>
        <p:nvPicPr>
          <p:cNvPr id="2" name="Picture 1">
            <a:extLst>
              <a:ext uri="{FF2B5EF4-FFF2-40B4-BE49-F238E27FC236}">
                <a16:creationId xmlns:a16="http://schemas.microsoft.com/office/drawing/2014/main" id="{5CF7881F-B4E6-596C-AB86-08CF6E3456FE}"/>
              </a:ext>
            </a:extLst>
          </p:cNvPr>
          <p:cNvPicPr>
            <a:picLocks noChangeAspect="1"/>
          </p:cNvPicPr>
          <p:nvPr/>
        </p:nvPicPr>
        <p:blipFill>
          <a:blip r:embed="rId2"/>
          <a:stretch>
            <a:fillRect/>
          </a:stretch>
        </p:blipFill>
        <p:spPr>
          <a:xfrm>
            <a:off x="7051221" y="427650"/>
            <a:ext cx="1081704" cy="3702757"/>
          </a:xfrm>
          <a:prstGeom prst="rect">
            <a:avLst/>
          </a:prstGeom>
        </p:spPr>
      </p:pic>
      <p:sp>
        <p:nvSpPr>
          <p:cNvPr id="13" name="TextBox 12">
            <a:extLst>
              <a:ext uri="{FF2B5EF4-FFF2-40B4-BE49-F238E27FC236}">
                <a16:creationId xmlns:a16="http://schemas.microsoft.com/office/drawing/2014/main" id="{960EA638-2666-6617-F419-EE85AEA4858A}"/>
              </a:ext>
            </a:extLst>
          </p:cNvPr>
          <p:cNvSpPr txBox="1"/>
          <p:nvPr/>
        </p:nvSpPr>
        <p:spPr>
          <a:xfrm>
            <a:off x="3336966" y="5431133"/>
            <a:ext cx="1353787" cy="215444"/>
          </a:xfrm>
          <a:prstGeom prst="rect">
            <a:avLst/>
          </a:prstGeom>
          <a:noFill/>
        </p:spPr>
        <p:txBody>
          <a:bodyPr wrap="square" rtlCol="0">
            <a:spAutoFit/>
          </a:bodyPr>
          <a:lstStyle/>
          <a:p>
            <a:r>
              <a:rPr lang="en-US" sz="800">
                <a:latin typeface="Helvetica" pitchFamily="2" charset="0"/>
              </a:rPr>
              <a:t>Time (days)</a:t>
            </a:r>
          </a:p>
        </p:txBody>
      </p:sp>
      <p:pic>
        <p:nvPicPr>
          <p:cNvPr id="3" name="Picture 2">
            <a:extLst>
              <a:ext uri="{FF2B5EF4-FFF2-40B4-BE49-F238E27FC236}">
                <a16:creationId xmlns:a16="http://schemas.microsoft.com/office/drawing/2014/main" id="{BADEF415-5465-411E-CF0B-7EACFE30D9FF}"/>
              </a:ext>
            </a:extLst>
          </p:cNvPr>
          <p:cNvPicPr>
            <a:picLocks noChangeAspect="1"/>
          </p:cNvPicPr>
          <p:nvPr/>
        </p:nvPicPr>
        <p:blipFill>
          <a:blip r:embed="rId3"/>
          <a:stretch>
            <a:fillRect/>
          </a:stretch>
        </p:blipFill>
        <p:spPr>
          <a:xfrm>
            <a:off x="8907116" y="481707"/>
            <a:ext cx="1246287" cy="1429849"/>
          </a:xfrm>
          <a:prstGeom prst="rect">
            <a:avLst/>
          </a:prstGeom>
        </p:spPr>
      </p:pic>
      <p:pic>
        <p:nvPicPr>
          <p:cNvPr id="8" name="Picture 7" descr="A picture containing screenshot, diagram, text, plot&#10;&#10;Description automatically generated">
            <a:extLst>
              <a:ext uri="{FF2B5EF4-FFF2-40B4-BE49-F238E27FC236}">
                <a16:creationId xmlns:a16="http://schemas.microsoft.com/office/drawing/2014/main" id="{6D28DEB2-C50D-7E33-8A10-C7481E2450A2}"/>
              </a:ext>
            </a:extLst>
          </p:cNvPr>
          <p:cNvPicPr>
            <a:picLocks noChangeAspect="1"/>
          </p:cNvPicPr>
          <p:nvPr/>
        </p:nvPicPr>
        <p:blipFill>
          <a:blip r:embed="rId4"/>
          <a:stretch>
            <a:fillRect/>
          </a:stretch>
        </p:blipFill>
        <p:spPr>
          <a:xfrm>
            <a:off x="926665" y="476972"/>
            <a:ext cx="5010996" cy="4953646"/>
          </a:xfrm>
          <a:prstGeom prst="rect">
            <a:avLst/>
          </a:prstGeom>
        </p:spPr>
      </p:pic>
    </p:spTree>
    <p:extLst>
      <p:ext uri="{BB962C8B-B14F-4D97-AF65-F5344CB8AC3E}">
        <p14:creationId xmlns:p14="http://schemas.microsoft.com/office/powerpoint/2010/main" val="26993230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0D56CB0-8795-C618-A0E6-9E45A11BE6CA}"/>
              </a:ext>
            </a:extLst>
          </p:cNvPr>
          <p:cNvSpPr txBox="1"/>
          <p:nvPr/>
        </p:nvSpPr>
        <p:spPr>
          <a:xfrm>
            <a:off x="688645" y="5604689"/>
            <a:ext cx="11162805" cy="461665"/>
          </a:xfrm>
          <a:prstGeom prst="rect">
            <a:avLst/>
          </a:prstGeom>
          <a:noFill/>
        </p:spPr>
        <p:txBody>
          <a:bodyPr wrap="square" lIns="91440" tIns="45720" rIns="91440" bIns="45720" rtlCol="0" anchor="t">
            <a:spAutoFit/>
          </a:bodyPr>
          <a:lstStyle/>
          <a:p>
            <a:r>
              <a:rPr lang="en-US" sz="1200" b="1">
                <a:latin typeface="Times New Roman"/>
                <a:cs typeface="Arial"/>
              </a:rPr>
              <a:t>Supplementary Figure 2</a:t>
            </a:r>
            <a:r>
              <a:rPr lang="en-US" sz="1200">
                <a:latin typeface="Times New Roman"/>
                <a:cs typeface="Arial"/>
              </a:rPr>
              <a:t>. Venn Diagram of genes upregulated in susceptible individuals (</a:t>
            </a:r>
            <a:r>
              <a:rPr lang="en-US" sz="1200" b="1">
                <a:latin typeface="Times New Roman"/>
                <a:cs typeface="Arial"/>
              </a:rPr>
              <a:t>A</a:t>
            </a:r>
            <a:r>
              <a:rPr lang="en-US" sz="1200">
                <a:latin typeface="Times New Roman"/>
                <a:cs typeface="Arial"/>
              </a:rPr>
              <a:t>) and protected individuals (</a:t>
            </a:r>
            <a:r>
              <a:rPr lang="en-US" sz="1200" b="1">
                <a:latin typeface="Times New Roman"/>
                <a:cs typeface="Arial"/>
              </a:rPr>
              <a:t>B</a:t>
            </a:r>
            <a:r>
              <a:rPr lang="en-US" sz="1200">
                <a:latin typeface="Times New Roman"/>
                <a:cs typeface="Arial"/>
              </a:rPr>
              <a:t>) before and after antigen stimulation with </a:t>
            </a:r>
            <a:r>
              <a:rPr lang="en-US" sz="1200" i="1">
                <a:latin typeface="Times New Roman"/>
                <a:cs typeface="Arial"/>
              </a:rPr>
              <a:t>Plasmodium falciparum schizonts (</a:t>
            </a:r>
            <a:r>
              <a:rPr lang="en-US" sz="1200" i="1" err="1">
                <a:latin typeface="Times New Roman"/>
                <a:cs typeface="Arial"/>
              </a:rPr>
              <a:t>Pfsz</a:t>
            </a:r>
            <a:r>
              <a:rPr lang="en-US" sz="1200" i="1">
                <a:latin typeface="Times New Roman"/>
                <a:cs typeface="Arial"/>
              </a:rPr>
              <a:t>). </a:t>
            </a:r>
            <a:r>
              <a:rPr lang="en-US" sz="1200">
                <a:latin typeface="Times New Roman"/>
                <a:cs typeface="Arial"/>
              </a:rPr>
              <a:t>Venn diagram was generated with Venny 2.0 web interactive tool</a:t>
            </a:r>
          </a:p>
        </p:txBody>
      </p:sp>
      <p:sp>
        <p:nvSpPr>
          <p:cNvPr id="4" name="Title 1">
            <a:extLst>
              <a:ext uri="{FF2B5EF4-FFF2-40B4-BE49-F238E27FC236}">
                <a16:creationId xmlns:a16="http://schemas.microsoft.com/office/drawing/2014/main" id="{D5182E22-90FD-12AF-7CDC-1FA9305D48B2}"/>
              </a:ext>
            </a:extLst>
          </p:cNvPr>
          <p:cNvSpPr>
            <a:spLocks noGrp="1"/>
          </p:cNvSpPr>
          <p:nvPr>
            <p:ph type="title"/>
          </p:nvPr>
        </p:nvSpPr>
        <p:spPr>
          <a:xfrm>
            <a:off x="838200" y="365126"/>
            <a:ext cx="4362450" cy="528580"/>
          </a:xfrm>
        </p:spPr>
        <p:txBody>
          <a:bodyPr>
            <a:normAutofit/>
          </a:bodyPr>
          <a:lstStyle/>
          <a:p>
            <a:r>
              <a:rPr lang="en-US" sz="1200" b="1">
                <a:latin typeface="Times New Roman"/>
                <a:ea typeface="Calibri" panose="020F0502020204030204" pitchFamily="34" charset="0"/>
                <a:cs typeface="Times New Roman"/>
              </a:rPr>
              <a:t>Supplementary Figure</a:t>
            </a:r>
            <a:r>
              <a:rPr lang="en-US" sz="1200" b="1">
                <a:effectLst/>
                <a:latin typeface="Times New Roman"/>
                <a:ea typeface="Calibri" panose="020F0502020204030204" pitchFamily="34" charset="0"/>
                <a:cs typeface="Times New Roman"/>
              </a:rPr>
              <a:t> </a:t>
            </a:r>
            <a:r>
              <a:rPr lang="en-US" sz="1200" b="1">
                <a:latin typeface="Times New Roman"/>
                <a:ea typeface="Calibri" panose="020F0502020204030204" pitchFamily="34" charset="0"/>
                <a:cs typeface="Times New Roman"/>
              </a:rPr>
              <a:t>2</a:t>
            </a:r>
            <a:endParaRPr lang="en-US" sz="1200" b="1">
              <a:latin typeface="Times New Roman"/>
              <a:cs typeface="Times New Roman"/>
            </a:endParaRPr>
          </a:p>
        </p:txBody>
      </p:sp>
      <p:pic>
        <p:nvPicPr>
          <p:cNvPr id="11" name="Picture 12" descr="Diagram, venn diagram&#10;&#10;Description automatically generated">
            <a:extLst>
              <a:ext uri="{FF2B5EF4-FFF2-40B4-BE49-F238E27FC236}">
                <a16:creationId xmlns:a16="http://schemas.microsoft.com/office/drawing/2014/main" id="{FC082300-9A42-B599-CB5D-6C956BCEA85D}"/>
              </a:ext>
            </a:extLst>
          </p:cNvPr>
          <p:cNvPicPr>
            <a:picLocks noGrp="1" noChangeAspect="1"/>
          </p:cNvPicPr>
          <p:nvPr>
            <p:ph idx="1"/>
          </p:nvPr>
        </p:nvPicPr>
        <p:blipFill>
          <a:blip r:embed="rId2"/>
          <a:stretch>
            <a:fillRect/>
          </a:stretch>
        </p:blipFill>
        <p:spPr>
          <a:xfrm>
            <a:off x="1102368" y="1423058"/>
            <a:ext cx="3862507" cy="3862507"/>
          </a:xfrm>
        </p:spPr>
      </p:pic>
      <p:pic>
        <p:nvPicPr>
          <p:cNvPr id="13" name="Picture 13" descr="Diagram, venn diagram&#10;&#10;Description automatically generated">
            <a:extLst>
              <a:ext uri="{FF2B5EF4-FFF2-40B4-BE49-F238E27FC236}">
                <a16:creationId xmlns:a16="http://schemas.microsoft.com/office/drawing/2014/main" id="{DF5EB178-AEE2-A5C0-5FC3-2ED07A589334}"/>
              </a:ext>
            </a:extLst>
          </p:cNvPr>
          <p:cNvPicPr>
            <a:picLocks noChangeAspect="1"/>
          </p:cNvPicPr>
          <p:nvPr/>
        </p:nvPicPr>
        <p:blipFill>
          <a:blip r:embed="rId3"/>
          <a:stretch>
            <a:fillRect/>
          </a:stretch>
        </p:blipFill>
        <p:spPr>
          <a:xfrm>
            <a:off x="6334665" y="1525439"/>
            <a:ext cx="3620217" cy="3648972"/>
          </a:xfrm>
          <a:prstGeom prst="rect">
            <a:avLst/>
          </a:prstGeom>
        </p:spPr>
      </p:pic>
      <p:sp>
        <p:nvSpPr>
          <p:cNvPr id="15" name="TextBox 14">
            <a:extLst>
              <a:ext uri="{FF2B5EF4-FFF2-40B4-BE49-F238E27FC236}">
                <a16:creationId xmlns:a16="http://schemas.microsoft.com/office/drawing/2014/main" id="{A1800718-A158-16D6-4845-5B5E9DD47A7E}"/>
              </a:ext>
            </a:extLst>
          </p:cNvPr>
          <p:cNvSpPr txBox="1"/>
          <p:nvPr/>
        </p:nvSpPr>
        <p:spPr>
          <a:xfrm>
            <a:off x="2115719" y="1525573"/>
            <a:ext cx="1828800" cy="369332"/>
          </a:xfrm>
          <a:prstGeom prst="rect">
            <a:avLst/>
          </a:prstGeom>
          <a:noFill/>
        </p:spPr>
        <p:txBody>
          <a:bodyPr wrap="square" lIns="91440" tIns="45720" rIns="91440" bIns="45720" rtlCol="0" anchor="t">
            <a:spAutoFit/>
          </a:bodyPr>
          <a:lstStyle/>
          <a:p>
            <a:r>
              <a:rPr lang="en-US" b="1" u="sng"/>
              <a:t>Up in susceptible</a:t>
            </a:r>
            <a:endParaRPr lang="en-US" b="1" u="sng">
              <a:cs typeface="Calibri"/>
            </a:endParaRPr>
          </a:p>
        </p:txBody>
      </p:sp>
      <p:sp>
        <p:nvSpPr>
          <p:cNvPr id="16" name="TextBox 15">
            <a:extLst>
              <a:ext uri="{FF2B5EF4-FFF2-40B4-BE49-F238E27FC236}">
                <a16:creationId xmlns:a16="http://schemas.microsoft.com/office/drawing/2014/main" id="{96ED90D7-9B11-84D4-F9E5-08B19B32B33F}"/>
              </a:ext>
            </a:extLst>
          </p:cNvPr>
          <p:cNvSpPr txBox="1"/>
          <p:nvPr/>
        </p:nvSpPr>
        <p:spPr>
          <a:xfrm>
            <a:off x="836897" y="1523632"/>
            <a:ext cx="274989" cy="369332"/>
          </a:xfrm>
          <a:prstGeom prst="rect">
            <a:avLst/>
          </a:prstGeom>
          <a:noFill/>
        </p:spPr>
        <p:txBody>
          <a:bodyPr wrap="square" lIns="91440" tIns="45720" rIns="91440" bIns="45720" rtlCol="0" anchor="t">
            <a:spAutoFit/>
          </a:bodyPr>
          <a:lstStyle/>
          <a:p>
            <a:r>
              <a:rPr lang="en-US" b="1"/>
              <a:t>A</a:t>
            </a:r>
          </a:p>
        </p:txBody>
      </p:sp>
      <p:sp>
        <p:nvSpPr>
          <p:cNvPr id="17" name="TextBox 16">
            <a:extLst>
              <a:ext uri="{FF2B5EF4-FFF2-40B4-BE49-F238E27FC236}">
                <a16:creationId xmlns:a16="http://schemas.microsoft.com/office/drawing/2014/main" id="{AD22C071-21A6-BFDD-7B45-2D667F22671B}"/>
              </a:ext>
            </a:extLst>
          </p:cNvPr>
          <p:cNvSpPr txBox="1"/>
          <p:nvPr/>
        </p:nvSpPr>
        <p:spPr>
          <a:xfrm>
            <a:off x="7228217" y="1564209"/>
            <a:ext cx="1828800" cy="369332"/>
          </a:xfrm>
          <a:prstGeom prst="rect">
            <a:avLst/>
          </a:prstGeom>
          <a:noFill/>
        </p:spPr>
        <p:txBody>
          <a:bodyPr wrap="square" lIns="91440" tIns="45720" rIns="91440" bIns="45720" rtlCol="0" anchor="t">
            <a:spAutoFit/>
          </a:bodyPr>
          <a:lstStyle/>
          <a:p>
            <a:r>
              <a:rPr lang="en-US" b="1" u="sng"/>
              <a:t>Up in protected</a:t>
            </a:r>
            <a:endParaRPr lang="en-US" b="1" u="sng">
              <a:cs typeface="Calibri"/>
            </a:endParaRPr>
          </a:p>
        </p:txBody>
      </p:sp>
      <p:sp>
        <p:nvSpPr>
          <p:cNvPr id="18" name="TextBox 17">
            <a:extLst>
              <a:ext uri="{FF2B5EF4-FFF2-40B4-BE49-F238E27FC236}">
                <a16:creationId xmlns:a16="http://schemas.microsoft.com/office/drawing/2014/main" id="{1F9B3BAB-8127-03F5-B4F6-AD5B5A41A299}"/>
              </a:ext>
            </a:extLst>
          </p:cNvPr>
          <p:cNvSpPr txBox="1"/>
          <p:nvPr/>
        </p:nvSpPr>
        <p:spPr>
          <a:xfrm>
            <a:off x="5904667" y="1553937"/>
            <a:ext cx="274989" cy="369332"/>
          </a:xfrm>
          <a:prstGeom prst="rect">
            <a:avLst/>
          </a:prstGeom>
          <a:noFill/>
        </p:spPr>
        <p:txBody>
          <a:bodyPr wrap="square" lIns="91440" tIns="45720" rIns="91440" bIns="45720" rtlCol="0" anchor="t">
            <a:spAutoFit/>
          </a:bodyPr>
          <a:lstStyle/>
          <a:p>
            <a:r>
              <a:rPr lang="en-US" b="1"/>
              <a:t>B</a:t>
            </a:r>
          </a:p>
        </p:txBody>
      </p:sp>
    </p:spTree>
    <p:extLst>
      <p:ext uri="{BB962C8B-B14F-4D97-AF65-F5344CB8AC3E}">
        <p14:creationId xmlns:p14="http://schemas.microsoft.com/office/powerpoint/2010/main" val="19911041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00E68E-5E60-8FB8-3174-3375C257C5CE}"/>
              </a:ext>
            </a:extLst>
          </p:cNvPr>
          <p:cNvSpPr>
            <a:spLocks noGrp="1"/>
          </p:cNvSpPr>
          <p:nvPr>
            <p:ph type="title"/>
          </p:nvPr>
        </p:nvSpPr>
        <p:spPr>
          <a:xfrm>
            <a:off x="242887" y="269876"/>
            <a:ext cx="4362450" cy="528580"/>
          </a:xfrm>
        </p:spPr>
        <p:txBody>
          <a:bodyPr>
            <a:normAutofit/>
          </a:bodyPr>
          <a:lstStyle/>
          <a:p>
            <a:r>
              <a:rPr lang="en-US" sz="1200" b="1">
                <a:latin typeface="Times New Roman"/>
                <a:ea typeface="Calibri" panose="020F0502020204030204" pitchFamily="34" charset="0"/>
                <a:cs typeface="Times New Roman"/>
              </a:rPr>
              <a:t>Supplementary</a:t>
            </a:r>
            <a:r>
              <a:rPr lang="en-US" sz="1200" b="1">
                <a:effectLst/>
                <a:latin typeface="Times New Roman"/>
                <a:ea typeface="Calibri" panose="020F0502020204030204" pitchFamily="34" charset="0"/>
                <a:cs typeface="Times New Roman"/>
              </a:rPr>
              <a:t> Figure 3</a:t>
            </a:r>
            <a:endParaRPr lang="en-US" sz="1200" b="1">
              <a:latin typeface="Times New Roman"/>
              <a:cs typeface="Times New Roman"/>
            </a:endParaRPr>
          </a:p>
        </p:txBody>
      </p:sp>
      <p:pic>
        <p:nvPicPr>
          <p:cNvPr id="4" name="Picture 3">
            <a:extLst>
              <a:ext uri="{FF2B5EF4-FFF2-40B4-BE49-F238E27FC236}">
                <a16:creationId xmlns:a16="http://schemas.microsoft.com/office/drawing/2014/main" id="{BF7AD93F-A5DE-38F7-9301-AF3F1A9AD729}"/>
              </a:ext>
            </a:extLst>
          </p:cNvPr>
          <p:cNvPicPr>
            <a:picLocks noChangeAspect="1"/>
          </p:cNvPicPr>
          <p:nvPr/>
        </p:nvPicPr>
        <p:blipFill>
          <a:blip r:embed="rId2"/>
          <a:stretch>
            <a:fillRect/>
          </a:stretch>
        </p:blipFill>
        <p:spPr>
          <a:xfrm>
            <a:off x="4284169" y="1241906"/>
            <a:ext cx="3149600" cy="3162300"/>
          </a:xfrm>
          <a:prstGeom prst="rect">
            <a:avLst/>
          </a:prstGeom>
        </p:spPr>
      </p:pic>
      <p:sp>
        <p:nvSpPr>
          <p:cNvPr id="6" name="Text Box 17">
            <a:extLst>
              <a:ext uri="{FF2B5EF4-FFF2-40B4-BE49-F238E27FC236}">
                <a16:creationId xmlns:a16="http://schemas.microsoft.com/office/drawing/2014/main" id="{EC332DDA-D866-DABD-82CA-F4DD1119C2FA}"/>
              </a:ext>
            </a:extLst>
          </p:cNvPr>
          <p:cNvSpPr txBox="1"/>
          <p:nvPr/>
        </p:nvSpPr>
        <p:spPr>
          <a:xfrm>
            <a:off x="661720" y="4778379"/>
            <a:ext cx="8292275" cy="747395"/>
          </a:xfrm>
          <a:prstGeom prst="rect">
            <a:avLst/>
          </a:prstGeom>
          <a:solidFill>
            <a:schemeClr val="lt1"/>
          </a:solidFill>
          <a:ln w="6350">
            <a:noFill/>
          </a:ln>
        </p:spPr>
        <p:txBody>
          <a:bodyPr rot="0" spcFirstLastPara="0" vert="horz" wrap="square" lIns="0" tIns="0" rIns="0" bIns="0" numCol="1" spcCol="0" rtlCol="0" fromWordArt="0" anchor="t" anchorCtr="0" forceAA="0" compatLnSpc="1">
            <a:prstTxWarp prst="textNoShape">
              <a:avLst/>
            </a:prstTxWarp>
            <a:noAutofit/>
          </a:bodyPr>
          <a:lstStyle/>
          <a:p>
            <a:pPr algn="just"/>
            <a:r>
              <a:rPr lang="en-US" sz="1200" b="1">
                <a:effectLst/>
                <a:latin typeface="Times New Roman"/>
                <a:ea typeface="Calibri" panose="020F0502020204030204" pitchFamily="34" charset="0"/>
                <a:cs typeface="Arial"/>
              </a:rPr>
              <a:t>Supplementary Figure </a:t>
            </a:r>
            <a:r>
              <a:rPr lang="en-US" sz="1200" b="1">
                <a:latin typeface="Times New Roman"/>
                <a:ea typeface="Calibri" panose="020F0502020204030204" pitchFamily="34" charset="0"/>
                <a:cs typeface="Arial"/>
              </a:rPr>
              <a:t>3. </a:t>
            </a:r>
            <a:r>
              <a:rPr lang="en-US" sz="1200">
                <a:effectLst/>
                <a:latin typeface="Times New Roman"/>
                <a:ea typeface="Calibri" panose="020F0502020204030204" pitchFamily="34" charset="0"/>
                <a:cs typeface="Arial"/>
              </a:rPr>
              <a:t>Gene set enrichment analysis of transcripts from malaria-protected children compared to malaria-susceptible children. GSEA results show that canonical IFNG and Apoptotic pathways are enriched in susceptible children.</a:t>
            </a:r>
          </a:p>
          <a:p>
            <a:pPr marL="0" marR="0">
              <a:spcBef>
                <a:spcPts val="0"/>
              </a:spcBef>
              <a:spcAft>
                <a:spcPts val="0"/>
              </a:spcAft>
            </a:pPr>
            <a:endParaRPr lang="en-US" sz="120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3" name="Picture 6" descr="Chart&#10;&#10;Description automatically generated">
            <a:extLst>
              <a:ext uri="{FF2B5EF4-FFF2-40B4-BE49-F238E27FC236}">
                <a16:creationId xmlns:a16="http://schemas.microsoft.com/office/drawing/2014/main" id="{6EA82A93-BB53-954C-EA9B-00EE352FD89D}"/>
              </a:ext>
            </a:extLst>
          </p:cNvPr>
          <p:cNvPicPr>
            <a:picLocks noChangeAspect="1"/>
          </p:cNvPicPr>
          <p:nvPr/>
        </p:nvPicPr>
        <p:blipFill>
          <a:blip r:embed="rId3"/>
          <a:stretch>
            <a:fillRect/>
          </a:stretch>
        </p:blipFill>
        <p:spPr>
          <a:xfrm>
            <a:off x="1091265" y="1240417"/>
            <a:ext cx="3192904" cy="3175664"/>
          </a:xfrm>
          <a:prstGeom prst="rect">
            <a:avLst/>
          </a:prstGeom>
        </p:spPr>
      </p:pic>
    </p:spTree>
    <p:extLst>
      <p:ext uri="{BB962C8B-B14F-4D97-AF65-F5344CB8AC3E}">
        <p14:creationId xmlns:p14="http://schemas.microsoft.com/office/powerpoint/2010/main" val="197052150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3E60CF59-E7BF-FFDC-AF88-CE99CD0BF17F}"/>
              </a:ext>
            </a:extLst>
          </p:cNvPr>
          <p:cNvPicPr>
            <a:picLocks noChangeAspect="1"/>
          </p:cNvPicPr>
          <p:nvPr/>
        </p:nvPicPr>
        <p:blipFill>
          <a:blip r:embed="rId2"/>
          <a:stretch>
            <a:fillRect/>
          </a:stretch>
        </p:blipFill>
        <p:spPr>
          <a:xfrm>
            <a:off x="4536823" y="634888"/>
            <a:ext cx="3480397" cy="6211822"/>
          </a:xfrm>
          <a:prstGeom prst="rect">
            <a:avLst/>
          </a:prstGeom>
        </p:spPr>
      </p:pic>
      <p:pic>
        <p:nvPicPr>
          <p:cNvPr id="5" name="Picture 4">
            <a:extLst>
              <a:ext uri="{FF2B5EF4-FFF2-40B4-BE49-F238E27FC236}">
                <a16:creationId xmlns:a16="http://schemas.microsoft.com/office/drawing/2014/main" id="{DF0F7BF9-AF81-143F-CFAB-CC328DC50505}"/>
              </a:ext>
            </a:extLst>
          </p:cNvPr>
          <p:cNvPicPr>
            <a:picLocks noChangeAspect="1"/>
          </p:cNvPicPr>
          <p:nvPr/>
        </p:nvPicPr>
        <p:blipFill>
          <a:blip r:embed="rId3"/>
          <a:stretch>
            <a:fillRect/>
          </a:stretch>
        </p:blipFill>
        <p:spPr>
          <a:xfrm>
            <a:off x="8403772" y="6439446"/>
            <a:ext cx="1920240" cy="31007"/>
          </a:xfrm>
          <a:prstGeom prst="rect">
            <a:avLst/>
          </a:prstGeom>
        </p:spPr>
      </p:pic>
      <p:sp>
        <p:nvSpPr>
          <p:cNvPr id="6" name="TextBox 5">
            <a:extLst>
              <a:ext uri="{FF2B5EF4-FFF2-40B4-BE49-F238E27FC236}">
                <a16:creationId xmlns:a16="http://schemas.microsoft.com/office/drawing/2014/main" id="{068A65DE-EC4E-0676-831E-BD44CCE7BF65}"/>
              </a:ext>
            </a:extLst>
          </p:cNvPr>
          <p:cNvSpPr txBox="1"/>
          <p:nvPr/>
        </p:nvSpPr>
        <p:spPr>
          <a:xfrm>
            <a:off x="8403772" y="6443157"/>
            <a:ext cx="2230098" cy="184666"/>
          </a:xfrm>
          <a:prstGeom prst="rect">
            <a:avLst/>
          </a:prstGeom>
          <a:noFill/>
        </p:spPr>
        <p:txBody>
          <a:bodyPr wrap="none" rtlCol="0">
            <a:spAutoFit/>
          </a:bodyPr>
          <a:lstStyle/>
          <a:p>
            <a:r>
              <a:rPr lang="en-US" sz="600" b="1" dirty="0"/>
              <a:t>0                                            5,000                                          10,000      </a:t>
            </a:r>
          </a:p>
        </p:txBody>
      </p:sp>
      <p:sp>
        <p:nvSpPr>
          <p:cNvPr id="8" name="TextBox 7">
            <a:extLst>
              <a:ext uri="{FF2B5EF4-FFF2-40B4-BE49-F238E27FC236}">
                <a16:creationId xmlns:a16="http://schemas.microsoft.com/office/drawing/2014/main" id="{A5DE4A7D-BE6F-ADD6-5AD3-8ADDED372D61}"/>
              </a:ext>
            </a:extLst>
          </p:cNvPr>
          <p:cNvSpPr txBox="1"/>
          <p:nvPr/>
        </p:nvSpPr>
        <p:spPr>
          <a:xfrm>
            <a:off x="5938734" y="443510"/>
            <a:ext cx="281741" cy="369332"/>
          </a:xfrm>
          <a:prstGeom prst="rect">
            <a:avLst/>
          </a:prstGeom>
          <a:noFill/>
        </p:spPr>
        <p:txBody>
          <a:bodyPr wrap="square" rtlCol="0">
            <a:spAutoFit/>
          </a:bodyPr>
          <a:lstStyle/>
          <a:p>
            <a:r>
              <a:rPr lang="en-US" b="1" dirty="0"/>
              <a:t>*</a:t>
            </a:r>
          </a:p>
        </p:txBody>
      </p:sp>
      <p:sp>
        <p:nvSpPr>
          <p:cNvPr id="9" name="TextBox 8">
            <a:extLst>
              <a:ext uri="{FF2B5EF4-FFF2-40B4-BE49-F238E27FC236}">
                <a16:creationId xmlns:a16="http://schemas.microsoft.com/office/drawing/2014/main" id="{E0804241-31CC-77E2-4BF0-100392FA770F}"/>
              </a:ext>
            </a:extLst>
          </p:cNvPr>
          <p:cNvSpPr txBox="1"/>
          <p:nvPr/>
        </p:nvSpPr>
        <p:spPr>
          <a:xfrm>
            <a:off x="7369747" y="443510"/>
            <a:ext cx="281741" cy="369332"/>
          </a:xfrm>
          <a:prstGeom prst="rect">
            <a:avLst/>
          </a:prstGeom>
          <a:noFill/>
        </p:spPr>
        <p:txBody>
          <a:bodyPr wrap="square" rtlCol="0">
            <a:spAutoFit/>
          </a:bodyPr>
          <a:lstStyle/>
          <a:p>
            <a:r>
              <a:rPr lang="en-US" b="1" dirty="0"/>
              <a:t>*</a:t>
            </a:r>
          </a:p>
        </p:txBody>
      </p:sp>
      <p:sp>
        <p:nvSpPr>
          <p:cNvPr id="10" name="TextBox 9">
            <a:extLst>
              <a:ext uri="{FF2B5EF4-FFF2-40B4-BE49-F238E27FC236}">
                <a16:creationId xmlns:a16="http://schemas.microsoft.com/office/drawing/2014/main" id="{BFB9F627-A09C-EF81-4586-06E2D3EC1F36}"/>
              </a:ext>
            </a:extLst>
          </p:cNvPr>
          <p:cNvSpPr txBox="1"/>
          <p:nvPr/>
        </p:nvSpPr>
        <p:spPr>
          <a:xfrm>
            <a:off x="7654454" y="443510"/>
            <a:ext cx="281741" cy="369332"/>
          </a:xfrm>
          <a:prstGeom prst="rect">
            <a:avLst/>
          </a:prstGeom>
          <a:noFill/>
        </p:spPr>
        <p:txBody>
          <a:bodyPr wrap="square" rtlCol="0">
            <a:spAutoFit/>
          </a:bodyPr>
          <a:lstStyle/>
          <a:p>
            <a:r>
              <a:rPr lang="en-US" b="1" dirty="0"/>
              <a:t>*</a:t>
            </a:r>
          </a:p>
        </p:txBody>
      </p:sp>
      <p:sp>
        <p:nvSpPr>
          <p:cNvPr id="2" name="TextBox 1">
            <a:extLst>
              <a:ext uri="{FF2B5EF4-FFF2-40B4-BE49-F238E27FC236}">
                <a16:creationId xmlns:a16="http://schemas.microsoft.com/office/drawing/2014/main" id="{12D181FD-18EA-0077-2DC6-51B59BE05A0F}"/>
              </a:ext>
            </a:extLst>
          </p:cNvPr>
          <p:cNvSpPr txBox="1"/>
          <p:nvPr/>
        </p:nvSpPr>
        <p:spPr>
          <a:xfrm>
            <a:off x="4091586" y="40307"/>
            <a:ext cx="274989" cy="369332"/>
          </a:xfrm>
          <a:prstGeom prst="rect">
            <a:avLst/>
          </a:prstGeom>
          <a:noFill/>
        </p:spPr>
        <p:txBody>
          <a:bodyPr wrap="square" lIns="91440" tIns="45720" rIns="91440" bIns="45720" rtlCol="0" anchor="t">
            <a:spAutoFit/>
          </a:bodyPr>
          <a:lstStyle/>
          <a:p>
            <a:r>
              <a:rPr lang="en-US" b="1"/>
              <a:t>A</a:t>
            </a:r>
          </a:p>
        </p:txBody>
      </p:sp>
      <p:sp>
        <p:nvSpPr>
          <p:cNvPr id="3" name="Title 1">
            <a:extLst>
              <a:ext uri="{FF2B5EF4-FFF2-40B4-BE49-F238E27FC236}">
                <a16:creationId xmlns:a16="http://schemas.microsoft.com/office/drawing/2014/main" id="{F9ED38C2-1692-0A2F-6485-1AAB96664794}"/>
              </a:ext>
            </a:extLst>
          </p:cNvPr>
          <p:cNvSpPr>
            <a:spLocks noGrp="1"/>
          </p:cNvSpPr>
          <p:nvPr/>
        </p:nvSpPr>
        <p:spPr>
          <a:xfrm>
            <a:off x="301347" y="107615"/>
            <a:ext cx="2155712" cy="377064"/>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a:latin typeface="Times New Roman"/>
                <a:cs typeface="Times New Roman"/>
              </a:rPr>
              <a:t>Supplementary Figure 4</a:t>
            </a:r>
          </a:p>
        </p:txBody>
      </p:sp>
      <p:sp>
        <p:nvSpPr>
          <p:cNvPr id="4" name="Left Brace 3">
            <a:extLst>
              <a:ext uri="{FF2B5EF4-FFF2-40B4-BE49-F238E27FC236}">
                <a16:creationId xmlns:a16="http://schemas.microsoft.com/office/drawing/2014/main" id="{E66006AE-8F9E-2383-CB78-2788D1B2897F}"/>
              </a:ext>
            </a:extLst>
          </p:cNvPr>
          <p:cNvSpPr/>
          <p:nvPr/>
        </p:nvSpPr>
        <p:spPr>
          <a:xfrm rot="5400000">
            <a:off x="5752107" y="-197845"/>
            <a:ext cx="268117" cy="1461074"/>
          </a:xfrm>
          <a:prstGeom prst="lef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11" name="TextBox 10">
            <a:extLst>
              <a:ext uri="{FF2B5EF4-FFF2-40B4-BE49-F238E27FC236}">
                <a16:creationId xmlns:a16="http://schemas.microsoft.com/office/drawing/2014/main" id="{7F723A58-A182-3FEF-89B1-F1BAC8657166}"/>
              </a:ext>
            </a:extLst>
          </p:cNvPr>
          <p:cNvSpPr txBox="1"/>
          <p:nvPr/>
        </p:nvSpPr>
        <p:spPr>
          <a:xfrm>
            <a:off x="5261130" y="132751"/>
            <a:ext cx="1620205" cy="307777"/>
          </a:xfrm>
          <a:prstGeom prst="rect">
            <a:avLst/>
          </a:prstGeom>
          <a:noFill/>
        </p:spPr>
        <p:txBody>
          <a:bodyPr wrap="square" rtlCol="0">
            <a:spAutoFit/>
          </a:bodyPr>
          <a:lstStyle/>
          <a:p>
            <a:r>
              <a:rPr lang="en-US" sz="1400" b="1" dirty="0">
                <a:latin typeface="Helvetica" pitchFamily="2" charset="0"/>
                <a:cs typeface="Arial" panose="020B0604020202020204" pitchFamily="34" charset="0"/>
              </a:rPr>
              <a:t>Susceptible</a:t>
            </a:r>
          </a:p>
        </p:txBody>
      </p:sp>
      <p:sp>
        <p:nvSpPr>
          <p:cNvPr id="12" name="Left Brace 11">
            <a:extLst>
              <a:ext uri="{FF2B5EF4-FFF2-40B4-BE49-F238E27FC236}">
                <a16:creationId xmlns:a16="http://schemas.microsoft.com/office/drawing/2014/main" id="{C7190826-3686-F638-E663-C601D373913F}"/>
              </a:ext>
            </a:extLst>
          </p:cNvPr>
          <p:cNvSpPr/>
          <p:nvPr/>
        </p:nvSpPr>
        <p:spPr>
          <a:xfrm rot="5400000">
            <a:off x="7257972" y="-117636"/>
            <a:ext cx="268118" cy="1250378"/>
          </a:xfrm>
          <a:prstGeom prst="lef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13" name="TextBox 12">
            <a:extLst>
              <a:ext uri="{FF2B5EF4-FFF2-40B4-BE49-F238E27FC236}">
                <a16:creationId xmlns:a16="http://schemas.microsoft.com/office/drawing/2014/main" id="{B01E6BFE-7330-6BA6-9A2B-3E0E09CABD3A}"/>
              </a:ext>
            </a:extLst>
          </p:cNvPr>
          <p:cNvSpPr txBox="1"/>
          <p:nvPr/>
        </p:nvSpPr>
        <p:spPr>
          <a:xfrm>
            <a:off x="6899443" y="127985"/>
            <a:ext cx="1620205" cy="307777"/>
          </a:xfrm>
          <a:prstGeom prst="rect">
            <a:avLst/>
          </a:prstGeom>
          <a:noFill/>
        </p:spPr>
        <p:txBody>
          <a:bodyPr wrap="square" rtlCol="0">
            <a:spAutoFit/>
          </a:bodyPr>
          <a:lstStyle/>
          <a:p>
            <a:r>
              <a:rPr lang="en-US" sz="1400" b="1" dirty="0">
                <a:latin typeface="Helvetica" pitchFamily="2" charset="0"/>
                <a:cs typeface="Arial" panose="020B0604020202020204" pitchFamily="34" charset="0"/>
              </a:rPr>
              <a:t>Protected</a:t>
            </a:r>
          </a:p>
        </p:txBody>
      </p:sp>
    </p:spTree>
    <p:extLst>
      <p:ext uri="{BB962C8B-B14F-4D97-AF65-F5344CB8AC3E}">
        <p14:creationId xmlns:p14="http://schemas.microsoft.com/office/powerpoint/2010/main" val="156489150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5" name="Chart 4">
            <a:extLst>
              <a:ext uri="{FF2B5EF4-FFF2-40B4-BE49-F238E27FC236}">
                <a16:creationId xmlns:a16="http://schemas.microsoft.com/office/drawing/2014/main" id="{7F4C1D01-49FB-48E3-ADD3-E17CAD6B0AC7}"/>
              </a:ext>
            </a:extLst>
          </p:cNvPr>
          <p:cNvGraphicFramePr>
            <a:graphicFrameLocks/>
          </p:cNvGraphicFramePr>
          <p:nvPr>
            <p:extLst>
              <p:ext uri="{D42A27DB-BD31-4B8C-83A1-F6EECF244321}">
                <p14:modId xmlns:p14="http://schemas.microsoft.com/office/powerpoint/2010/main" val="4144092456"/>
              </p:ext>
            </p:extLst>
          </p:nvPr>
        </p:nvGraphicFramePr>
        <p:xfrm>
          <a:off x="643467" y="643466"/>
          <a:ext cx="10905066" cy="5571067"/>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a:extLst>
              <a:ext uri="{FF2B5EF4-FFF2-40B4-BE49-F238E27FC236}">
                <a16:creationId xmlns:a16="http://schemas.microsoft.com/office/drawing/2014/main" id="{723F3CC8-37F5-F505-22A3-F3332B2DFA61}"/>
              </a:ext>
            </a:extLst>
          </p:cNvPr>
          <p:cNvSpPr txBox="1"/>
          <p:nvPr/>
        </p:nvSpPr>
        <p:spPr>
          <a:xfrm rot="16200000">
            <a:off x="-693368" y="2316777"/>
            <a:ext cx="2121093" cy="307777"/>
          </a:xfrm>
          <a:prstGeom prst="rect">
            <a:avLst/>
          </a:prstGeom>
          <a:noFill/>
        </p:spPr>
        <p:txBody>
          <a:bodyPr wrap="none" rtlCol="0">
            <a:spAutoFit/>
          </a:bodyPr>
          <a:lstStyle/>
          <a:p>
            <a:r>
              <a:rPr lang="en-US" sz="1400" b="1" dirty="0">
                <a:latin typeface="Helvetica" pitchFamily="2" charset="0"/>
              </a:rPr>
              <a:t>Fluorescence intensity</a:t>
            </a:r>
          </a:p>
        </p:txBody>
      </p:sp>
      <p:sp>
        <p:nvSpPr>
          <p:cNvPr id="7" name="TextBox 6">
            <a:extLst>
              <a:ext uri="{FF2B5EF4-FFF2-40B4-BE49-F238E27FC236}">
                <a16:creationId xmlns:a16="http://schemas.microsoft.com/office/drawing/2014/main" id="{8F28BB0A-D9E9-5AAE-44CC-1C7F252513D4}"/>
              </a:ext>
            </a:extLst>
          </p:cNvPr>
          <p:cNvSpPr txBox="1"/>
          <p:nvPr/>
        </p:nvSpPr>
        <p:spPr>
          <a:xfrm rot="5400000">
            <a:off x="11138004" y="2316777"/>
            <a:ext cx="821059" cy="307777"/>
          </a:xfrm>
          <a:prstGeom prst="rect">
            <a:avLst/>
          </a:prstGeom>
          <a:noFill/>
        </p:spPr>
        <p:txBody>
          <a:bodyPr wrap="none" rtlCol="0">
            <a:spAutoFit/>
          </a:bodyPr>
          <a:lstStyle/>
          <a:p>
            <a:r>
              <a:rPr lang="en-US" sz="1400" b="1" dirty="0">
                <a:latin typeface="Helvetica" pitchFamily="2" charset="0"/>
              </a:rPr>
              <a:t>P-value</a:t>
            </a:r>
          </a:p>
        </p:txBody>
      </p:sp>
      <p:sp>
        <p:nvSpPr>
          <p:cNvPr id="3" name="TextBox 2">
            <a:extLst>
              <a:ext uri="{FF2B5EF4-FFF2-40B4-BE49-F238E27FC236}">
                <a16:creationId xmlns:a16="http://schemas.microsoft.com/office/drawing/2014/main" id="{C40FABF0-F246-3037-BF54-E7EE5D5A1578}"/>
              </a:ext>
            </a:extLst>
          </p:cNvPr>
          <p:cNvSpPr txBox="1"/>
          <p:nvPr/>
        </p:nvSpPr>
        <p:spPr>
          <a:xfrm>
            <a:off x="46792" y="149000"/>
            <a:ext cx="274989" cy="369332"/>
          </a:xfrm>
          <a:prstGeom prst="rect">
            <a:avLst/>
          </a:prstGeom>
          <a:noFill/>
        </p:spPr>
        <p:txBody>
          <a:bodyPr wrap="square" lIns="91440" tIns="45720" rIns="91440" bIns="45720" rtlCol="0" anchor="t">
            <a:spAutoFit/>
          </a:bodyPr>
          <a:lstStyle/>
          <a:p>
            <a:r>
              <a:rPr lang="en-US" b="1"/>
              <a:t>B</a:t>
            </a:r>
          </a:p>
        </p:txBody>
      </p:sp>
      <p:sp>
        <p:nvSpPr>
          <p:cNvPr id="8" name="TextBox 7">
            <a:extLst>
              <a:ext uri="{FF2B5EF4-FFF2-40B4-BE49-F238E27FC236}">
                <a16:creationId xmlns:a16="http://schemas.microsoft.com/office/drawing/2014/main" id="{08AD758F-8DC8-ADDA-C8D0-04AE0D651C24}"/>
              </a:ext>
            </a:extLst>
          </p:cNvPr>
          <p:cNvSpPr txBox="1"/>
          <p:nvPr/>
        </p:nvSpPr>
        <p:spPr>
          <a:xfrm>
            <a:off x="46793" y="5702637"/>
            <a:ext cx="12145208" cy="1200329"/>
          </a:xfrm>
          <a:prstGeom prst="rect">
            <a:avLst/>
          </a:prstGeom>
          <a:noFill/>
        </p:spPr>
        <p:txBody>
          <a:bodyPr wrap="square" lIns="91440" tIns="45720" rIns="91440" bIns="45720" rtlCol="0" anchor="t">
            <a:spAutoFit/>
          </a:bodyPr>
          <a:lstStyle/>
          <a:p>
            <a:r>
              <a:rPr lang="en-US" sz="1200" b="1" dirty="0">
                <a:latin typeface="Times New Roman"/>
                <a:cs typeface="Arial"/>
              </a:rPr>
              <a:t>Supplementary Figure 4.</a:t>
            </a:r>
            <a:r>
              <a:rPr lang="en-US" sz="1200" dirty="0">
                <a:latin typeface="Times New Roman"/>
                <a:cs typeface="Arial"/>
              </a:rPr>
              <a:t> (</a:t>
            </a:r>
            <a:r>
              <a:rPr lang="en-US" sz="1200" b="1" dirty="0">
                <a:latin typeface="Times New Roman"/>
                <a:cs typeface="Arial"/>
              </a:rPr>
              <a:t>A</a:t>
            </a:r>
            <a:r>
              <a:rPr lang="en-US" sz="1200" dirty="0">
                <a:latin typeface="Times New Roman"/>
                <a:cs typeface="Arial"/>
              </a:rPr>
              <a:t>) Heatmap of </a:t>
            </a:r>
            <a:r>
              <a:rPr lang="en-US" sz="1200" dirty="0" err="1">
                <a:latin typeface="Times New Roman"/>
                <a:cs typeface="Arial"/>
              </a:rPr>
              <a:t>seroreactivity</a:t>
            </a:r>
            <a:r>
              <a:rPr lang="en-US" sz="1200" dirty="0">
                <a:latin typeface="Times New Roman"/>
                <a:cs typeface="Arial"/>
              </a:rPr>
              <a:t> to </a:t>
            </a:r>
            <a:r>
              <a:rPr lang="en-US" sz="1200" i="1" dirty="0">
                <a:latin typeface="Times New Roman"/>
                <a:cs typeface="Arial"/>
              </a:rPr>
              <a:t>Plasmodium falciparum </a:t>
            </a:r>
            <a:r>
              <a:rPr lang="en-US" sz="1200" dirty="0">
                <a:latin typeface="Times New Roman"/>
                <a:cs typeface="Arial"/>
              </a:rPr>
              <a:t>fragments. Each column represents serum from one child and each row represents a peptide fragment. Red corresponds to high reactivity, black is moderate and grey indicates no reactivity. Wilcoxon rank sum test was used to test for significance (</a:t>
            </a:r>
            <a:r>
              <a:rPr lang="en-US" sz="1200" b="1" dirty="0">
                <a:latin typeface="Times New Roman"/>
                <a:cs typeface="Arial"/>
              </a:rPr>
              <a:t>B</a:t>
            </a:r>
            <a:r>
              <a:rPr lang="en-US" sz="1200" dirty="0">
                <a:latin typeface="Times New Roman"/>
                <a:cs typeface="Arial"/>
              </a:rPr>
              <a:t>) Fluorescence intensity peaks for each protein fragment. Blue peaks correspond to susceptible and orange peaks correspond to protected. No significant differences observed between protected and susceptible individuals. (</a:t>
            </a:r>
            <a:r>
              <a:rPr lang="en-US" sz="1200" b="1" dirty="0">
                <a:latin typeface="Times New Roman"/>
                <a:cs typeface="Arial"/>
              </a:rPr>
              <a:t>C</a:t>
            </a:r>
            <a:r>
              <a:rPr lang="en-US" sz="1200" dirty="0">
                <a:latin typeface="Times New Roman"/>
                <a:cs typeface="Arial"/>
              </a:rPr>
              <a:t>) The </a:t>
            </a:r>
            <a:r>
              <a:rPr lang="en-US" sz="1200" dirty="0">
                <a:solidFill>
                  <a:srgbClr val="212121"/>
                </a:solidFill>
                <a:effectLst/>
                <a:latin typeface="Times New Roman" panose="02020603050405020304" pitchFamily="18" charset="0"/>
                <a:ea typeface="MS Mincho" panose="02020609040205080304" pitchFamily="49" charset="-128"/>
                <a:cs typeface="Times New Roman" panose="02020603050405020304" pitchFamily="18" charset="0"/>
              </a:rPr>
              <a:t>proportion of individuals within each group with </a:t>
            </a:r>
            <a:r>
              <a:rPr lang="en-US" sz="1200" dirty="0" err="1">
                <a:solidFill>
                  <a:srgbClr val="212121"/>
                </a:solidFill>
                <a:effectLst/>
                <a:latin typeface="Times New Roman" panose="02020603050405020304" pitchFamily="18" charset="0"/>
                <a:ea typeface="MS Mincho" panose="02020609040205080304" pitchFamily="49" charset="-128"/>
                <a:cs typeface="Times New Roman" panose="02020603050405020304" pitchFamily="18" charset="0"/>
              </a:rPr>
              <a:t>serorecognition</a:t>
            </a:r>
            <a:r>
              <a:rPr lang="en-US" sz="1200" dirty="0">
                <a:solidFill>
                  <a:srgbClr val="212121"/>
                </a:solidFill>
                <a:effectLst/>
                <a:latin typeface="Times New Roman" panose="02020603050405020304" pitchFamily="18" charset="0"/>
                <a:ea typeface="MS Mincho" panose="02020609040205080304" pitchFamily="49" charset="-128"/>
                <a:cs typeface="Times New Roman" panose="02020603050405020304" pitchFamily="18" charset="0"/>
              </a:rPr>
              <a:t> of each protein fragment (defined as a fluorescence intensity greater than the mean plus two standard deviations for a serum panel from 10 malaria-naïve North American adults probed on the microarray)</a:t>
            </a:r>
            <a:r>
              <a:rPr lang="en-US" sz="1200" dirty="0">
                <a:solidFill>
                  <a:srgbClr val="212121"/>
                </a:solidFill>
                <a:latin typeface="Times New Roman" panose="02020603050405020304" pitchFamily="18" charset="0"/>
                <a:ea typeface="MS Mincho" panose="02020609040205080304" pitchFamily="49" charset="-128"/>
                <a:cs typeface="Times New Roman" panose="02020603050405020304" pitchFamily="18" charset="0"/>
              </a:rPr>
              <a:t>. The </a:t>
            </a:r>
            <a:r>
              <a:rPr lang="en-US" sz="1200" dirty="0">
                <a:solidFill>
                  <a:srgbClr val="212121"/>
                </a:solidFill>
                <a:latin typeface="Times New Roman"/>
                <a:ea typeface="MS Mincho" panose="02020609040205080304" pitchFamily="49" charset="-128"/>
                <a:cs typeface="Arial"/>
              </a:rPr>
              <a:t>x</a:t>
            </a:r>
            <a:r>
              <a:rPr lang="en-US" sz="1200" dirty="0">
                <a:latin typeface="Times New Roman"/>
                <a:cs typeface="Arial"/>
              </a:rPr>
              <a:t>-axis represents the protein fragments that were recognized, while the y-axis represents the proportion of individuals from each group who recognized these fragments. Blue peaks correspond to susceptible and orange peaks correspond to protected.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5875872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23F3CC8-37F5-F505-22A3-F3332B2DFA61}"/>
              </a:ext>
            </a:extLst>
          </p:cNvPr>
          <p:cNvSpPr txBox="1"/>
          <p:nvPr/>
        </p:nvSpPr>
        <p:spPr>
          <a:xfrm rot="16200000">
            <a:off x="-1176634" y="1943151"/>
            <a:ext cx="2908168" cy="307777"/>
          </a:xfrm>
          <a:prstGeom prst="rect">
            <a:avLst/>
          </a:prstGeom>
          <a:noFill/>
        </p:spPr>
        <p:txBody>
          <a:bodyPr wrap="none" rtlCol="0">
            <a:spAutoFit/>
          </a:bodyPr>
          <a:lstStyle/>
          <a:p>
            <a:r>
              <a:rPr lang="en-US" sz="1400" b="1" dirty="0">
                <a:latin typeface="Helvetica" pitchFamily="2" charset="0"/>
              </a:rPr>
              <a:t>Proportion with serorecognition</a:t>
            </a:r>
          </a:p>
        </p:txBody>
      </p:sp>
      <p:graphicFrame>
        <p:nvGraphicFramePr>
          <p:cNvPr id="2" name="Chart 1">
            <a:extLst>
              <a:ext uri="{FF2B5EF4-FFF2-40B4-BE49-F238E27FC236}">
                <a16:creationId xmlns:a16="http://schemas.microsoft.com/office/drawing/2014/main" id="{22913172-094B-BBE1-5329-B5283F6584AA}"/>
              </a:ext>
            </a:extLst>
          </p:cNvPr>
          <p:cNvGraphicFramePr>
            <a:graphicFrameLocks/>
          </p:cNvGraphicFramePr>
          <p:nvPr/>
        </p:nvGraphicFramePr>
        <p:xfrm>
          <a:off x="462117" y="373626"/>
          <a:ext cx="11316928" cy="6400800"/>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a:extLst>
              <a:ext uri="{FF2B5EF4-FFF2-40B4-BE49-F238E27FC236}">
                <a16:creationId xmlns:a16="http://schemas.microsoft.com/office/drawing/2014/main" id="{C5E12104-2AE9-A772-E03F-1CC7647F094F}"/>
              </a:ext>
            </a:extLst>
          </p:cNvPr>
          <p:cNvSpPr txBox="1"/>
          <p:nvPr/>
        </p:nvSpPr>
        <p:spPr>
          <a:xfrm>
            <a:off x="46792" y="149000"/>
            <a:ext cx="274989" cy="369332"/>
          </a:xfrm>
          <a:prstGeom prst="rect">
            <a:avLst/>
          </a:prstGeom>
          <a:noFill/>
        </p:spPr>
        <p:txBody>
          <a:bodyPr wrap="square" lIns="91440" tIns="45720" rIns="91440" bIns="45720" rtlCol="0" anchor="t">
            <a:spAutoFit/>
          </a:bodyPr>
          <a:lstStyle/>
          <a:p>
            <a:r>
              <a:rPr lang="en-US" b="1" dirty="0"/>
              <a:t>C</a:t>
            </a:r>
          </a:p>
        </p:txBody>
      </p:sp>
    </p:spTree>
    <p:extLst>
      <p:ext uri="{BB962C8B-B14F-4D97-AF65-F5344CB8AC3E}">
        <p14:creationId xmlns:p14="http://schemas.microsoft.com/office/powerpoint/2010/main" val="42830333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BB457B78BEFA0747B41BCD4158FCA791" ma:contentTypeVersion="4" ma:contentTypeDescription="Create a new document." ma:contentTypeScope="" ma:versionID="714ba68547451763dd324f4d4de89ca7">
  <xsd:schema xmlns:xsd="http://www.w3.org/2001/XMLSchema" xmlns:xs="http://www.w3.org/2001/XMLSchema" xmlns:p="http://schemas.microsoft.com/office/2006/metadata/properties" xmlns:ns2="1ba95bb6-11ea-41cd-a8fc-26065a7eb9fb" xmlns:ns3="1b963ef6-8263-48d1-a263-69fcccc9a7e3" targetNamespace="http://schemas.microsoft.com/office/2006/metadata/properties" ma:root="true" ma:fieldsID="29cfaaf5ba538c8c047870bf6072db1c" ns2:_="" ns3:_="">
    <xsd:import namespace="1ba95bb6-11ea-41cd-a8fc-26065a7eb9fb"/>
    <xsd:import namespace="1b963ef6-8263-48d1-a263-69fcccc9a7e3"/>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ba95bb6-11ea-41cd-a8fc-26065a7eb9fb"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1b963ef6-8263-48d1-a263-69fcccc9a7e3"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1C4E2BBD-B9F9-4658-A260-7BF872E45B43}">
  <ds:schemaRefs>
    <ds:schemaRef ds:uri="1b963ef6-8263-48d1-a263-69fcccc9a7e3"/>
    <ds:schemaRef ds:uri="1ba95bb6-11ea-41cd-a8fc-26065a7eb9fb"/>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1EC970E8-F3E0-4E26-BE74-715881BA4405}">
  <ds:schemaRefs>
    <ds:schemaRef ds:uri="http://schemas.microsoft.com/sharepoint/v3/contenttype/forms"/>
  </ds:schemaRefs>
</ds:datastoreItem>
</file>

<file path=customXml/itemProps3.xml><?xml version="1.0" encoding="utf-8"?>
<ds:datastoreItem xmlns:ds="http://schemas.openxmlformats.org/officeDocument/2006/customXml" ds:itemID="{3DC997DD-AF6C-4650-B405-6994BA29A29A}">
  <ds:schemaRefs>
    <ds:schemaRef ds:uri="http://schemas.microsoft.com/office/infopath/2007/PartnerControls"/>
    <ds:schemaRef ds:uri="http://schemas.openxmlformats.org/package/2006/metadata/core-properties"/>
    <ds:schemaRef ds:uri="http://purl.org/dc/dcmitype/"/>
    <ds:schemaRef ds:uri="http://schemas.microsoft.com/office/2006/documentManagement/types"/>
    <ds:schemaRef ds:uri="http://www.w3.org/XML/1998/namespace"/>
    <ds:schemaRef ds:uri="1ba95bb6-11ea-41cd-a8fc-26065a7eb9fb"/>
    <ds:schemaRef ds:uri="http://purl.org/dc/elements/1.1/"/>
    <ds:schemaRef ds:uri="1b963ef6-8263-48d1-a263-69fcccc9a7e3"/>
    <ds:schemaRef ds:uri="http://schemas.microsoft.com/office/2006/metadata/properties"/>
    <ds:schemaRef ds:uri="http://purl.org/dc/terms/"/>
  </ds:schemaRefs>
</ds:datastoreItem>
</file>

<file path=docProps/app.xml><?xml version="1.0" encoding="utf-8"?>
<Properties xmlns="http://schemas.openxmlformats.org/officeDocument/2006/extended-properties" xmlns:vt="http://schemas.openxmlformats.org/officeDocument/2006/docPropsVTypes">
  <TotalTime>2</TotalTime>
  <Words>1677</Words>
  <Application>Microsoft Macintosh PowerPoint</Application>
  <PresentationFormat>Widescreen</PresentationFormat>
  <Paragraphs>105</Paragraphs>
  <Slides>18</Slides>
  <Notes>1</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18</vt:i4>
      </vt:variant>
    </vt:vector>
  </HeadingPairs>
  <TitlesOfParts>
    <vt:vector size="25" baseType="lpstr">
      <vt:lpstr>Arial</vt:lpstr>
      <vt:lpstr>Calibri</vt:lpstr>
      <vt:lpstr>Calibri Light</vt:lpstr>
      <vt:lpstr>Helvetica</vt:lpstr>
      <vt:lpstr>Times New Roman</vt:lpstr>
      <vt:lpstr>Office Theme</vt:lpstr>
      <vt:lpstr>Office Theme</vt:lpstr>
      <vt:lpstr>Supplementary Information</vt:lpstr>
      <vt:lpstr>Supplementary tables</vt:lpstr>
      <vt:lpstr>Supplementary Figure 1</vt:lpstr>
      <vt:lpstr>Supplementary Figure 1</vt:lpstr>
      <vt:lpstr>Supplementary Figure 2</vt:lpstr>
      <vt:lpstr>Supplementary Figure 3</vt:lpstr>
      <vt:lpstr>PowerPoint Presentation</vt:lpstr>
      <vt:lpstr>PowerPoint Presentation</vt:lpstr>
      <vt:lpstr>PowerPoint Presentation</vt:lpstr>
      <vt:lpstr>Supplementary Figure 5</vt:lpstr>
      <vt:lpstr>Supplementary Figure 6</vt:lpstr>
      <vt:lpstr>Supplementary Figure 7A,B</vt:lpstr>
      <vt:lpstr>Supplementary Figure 7C,D</vt:lpstr>
      <vt:lpstr>Supplementary Figure 7E,F</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bambo, Gillian</dc:creator>
  <cp:lastModifiedBy>Mbambo, Gillian</cp:lastModifiedBy>
  <cp:revision>1</cp:revision>
  <dcterms:created xsi:type="dcterms:W3CDTF">2022-08-16T18:31:25Z</dcterms:created>
  <dcterms:modified xsi:type="dcterms:W3CDTF">2023-06-05T13:08:2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B457B78BEFA0747B41BCD4158FCA791</vt:lpwstr>
  </property>
</Properties>
</file>